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tmp" ContentType="image/p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5"/>
  </p:notesMasterIdLst>
  <p:sldIdLst>
    <p:sldId id="436" r:id="rId2"/>
    <p:sldId id="437" r:id="rId3"/>
    <p:sldId id="447" r:id="rId4"/>
  </p:sldIdLst>
  <p:sldSz cx="6858000" cy="9906000" type="A4"/>
  <p:notesSz cx="6888163" cy="100218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ho Yong-Joon" initials="CY" lastIdx="17" clrIdx="0">
    <p:extLst>
      <p:ext uri="{19B8F6BF-5375-455C-9EA6-DF929625EA0E}">
        <p15:presenceInfo xmlns:p15="http://schemas.microsoft.com/office/powerpoint/2012/main" userId="e9718cb7b1bd9c63" providerId="Windows Live"/>
      </p:ext>
    </p:extLst>
  </p:cmAuthor>
  <p:cmAuthor id="2" name="user" initials="u" lastIdx="2" clrIdx="1">
    <p:extLst>
      <p:ext uri="{19B8F6BF-5375-455C-9EA6-DF929625EA0E}">
        <p15:presenceInfo xmlns:p15="http://schemas.microsoft.com/office/powerpoint/2012/main" userId="user" providerId="None"/>
      </p:ext>
    </p:extLst>
  </p:cmAuthor>
  <p:cmAuthor id="3" name="오 준수" initials="오준" lastIdx="14" clrIdx="2">
    <p:extLst>
      <p:ext uri="{19B8F6BF-5375-455C-9EA6-DF929625EA0E}">
        <p15:presenceInfo xmlns:p15="http://schemas.microsoft.com/office/powerpoint/2012/main" userId="c8bda171d3bee8c3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E75B6"/>
    <a:srgbClr val="98B486"/>
    <a:srgbClr val="44546A"/>
    <a:srgbClr val="63A0D7"/>
    <a:srgbClr val="800000"/>
    <a:srgbClr val="FE9900"/>
    <a:srgbClr val="65FF00"/>
    <a:srgbClr val="009865"/>
    <a:srgbClr val="2900FF"/>
    <a:srgbClr val="4B014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293" autoAdjust="0"/>
    <p:restoredTop sz="95843" autoAdjust="0"/>
  </p:normalViewPr>
  <p:slideViewPr>
    <p:cSldViewPr snapToGrid="0">
      <p:cViewPr>
        <p:scale>
          <a:sx n="125" d="100"/>
          <a:sy n="125" d="100"/>
        </p:scale>
        <p:origin x="1962" y="-36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C:\Users\JUNSOO\Desktop\Set1%20ChIPseq%20&#51221;&#47532;\sacCer3_quantified%20Set1%20in%20-100%20TSS%20+300.txt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altLang="ko-KR" sz="1100" b="1" dirty="0">
                <a:solidFill>
                  <a:sysClr val="windowText" lastClr="000000"/>
                </a:solidFill>
              </a:rPr>
              <a:t>Normalized</a:t>
            </a:r>
            <a:r>
              <a:rPr lang="en-US" altLang="ko-KR" sz="1100" b="1" baseline="0" dirty="0">
                <a:solidFill>
                  <a:sysClr val="windowText" lastClr="000000"/>
                </a:solidFill>
              </a:rPr>
              <a:t> Set1 occupancy in promoters</a:t>
            </a:r>
          </a:p>
          <a:p>
            <a:pPr>
              <a:defRPr sz="1100" b="1">
                <a:solidFill>
                  <a:sysClr val="windowText" lastClr="000000"/>
                </a:solidFill>
              </a:defRPr>
            </a:pPr>
            <a:r>
              <a:rPr lang="en-US" altLang="ko-KR" sz="1100" b="1" baseline="0" dirty="0">
                <a:solidFill>
                  <a:sysClr val="windowText" lastClr="000000"/>
                </a:solidFill>
              </a:rPr>
              <a:t>WT vs </a:t>
            </a:r>
            <a:r>
              <a:rPr lang="en-US" altLang="ko-KR" sz="1100" b="1" i="0" baseline="0" dirty="0">
                <a:solidFill>
                  <a:sysClr val="windowText" lastClr="000000"/>
                </a:solidFill>
              </a:rPr>
              <a:t>Δ</a:t>
            </a:r>
            <a:r>
              <a:rPr lang="en-US" altLang="ko-KR" sz="1100" b="1" i="1" baseline="0" dirty="0">
                <a:solidFill>
                  <a:sysClr val="windowText" lastClr="000000"/>
                </a:solidFill>
              </a:rPr>
              <a:t>rad6</a:t>
            </a:r>
            <a:endParaRPr lang="en-US" altLang="ko-KR" sz="1100" b="1" i="1" dirty="0">
              <a:solidFill>
                <a:sysClr val="windowText" lastClr="000000"/>
              </a:solidFill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ko-KR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sacCer3_quantified Set1 in -100'!$Y$1</c:f>
              <c:strCache>
                <c:ptCount val="1"/>
                <c:pt idx="0">
                  <c:v>Normdrad6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1"/>
            <c:trendlineLbl>
              <c:layout>
                <c:manualLayout>
                  <c:x val="0.14066268220084302"/>
                  <c:y val="-6.4387239387683065E-2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sz="900" b="0" i="0" u="none" strike="noStrike" kern="1200" baseline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altLang="ko-KR" baseline="0" dirty="0">
                        <a:solidFill>
                          <a:schemeClr val="tx1"/>
                        </a:solidFill>
                      </a:rPr>
                      <a:t>y = 0.306x - 2.7184</a:t>
                    </a:r>
                    <a:endParaRPr lang="en-US" altLang="ko-KR" dirty="0">
                      <a:solidFill>
                        <a:schemeClr val="tx1"/>
                      </a:solidFill>
                    </a:endParaRPr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ko-KR"/>
                </a:p>
              </c:txPr>
            </c:trendlineLbl>
          </c:trendline>
          <c:xVal>
            <c:numRef>
              <c:f>'sacCer3_quantified Set1 in -100'!$X$2:$X$6019</c:f>
              <c:numCache>
                <c:formatCode>General</c:formatCode>
                <c:ptCount val="6018"/>
                <c:pt idx="0">
                  <c:v>233.4571503448484</c:v>
                </c:pt>
                <c:pt idx="1">
                  <c:v>378.65479812622067</c:v>
                </c:pt>
                <c:pt idx="2">
                  <c:v>101.43249928474475</c:v>
                </c:pt>
                <c:pt idx="3">
                  <c:v>93.446050429344609</c:v>
                </c:pt>
                <c:pt idx="4">
                  <c:v>106.47430090904231</c:v>
                </c:pt>
                <c:pt idx="5">
                  <c:v>361.59260004043574</c:v>
                </c:pt>
                <c:pt idx="6">
                  <c:v>84.504750443100733</c:v>
                </c:pt>
                <c:pt idx="7">
                  <c:v>441.9566496372222</c:v>
                </c:pt>
                <c:pt idx="8">
                  <c:v>93.994649882315997</c:v>
                </c:pt>
                <c:pt idx="9">
                  <c:v>436.66944959640512</c:v>
                </c:pt>
                <c:pt idx="10">
                  <c:v>354.80829984188063</c:v>
                </c:pt>
                <c:pt idx="11">
                  <c:v>382.6110492801667</c:v>
                </c:pt>
                <c:pt idx="12">
                  <c:v>398.19565090179429</c:v>
                </c:pt>
                <c:pt idx="13">
                  <c:v>319.49744990825633</c:v>
                </c:pt>
                <c:pt idx="14">
                  <c:v>151.29779991149911</c:v>
                </c:pt>
                <c:pt idx="15">
                  <c:v>281.82284942626939</c:v>
                </c:pt>
                <c:pt idx="16">
                  <c:v>150.34495014190679</c:v>
                </c:pt>
                <c:pt idx="17">
                  <c:v>330.75310045242264</c:v>
                </c:pt>
                <c:pt idx="18">
                  <c:v>333.91249953269914</c:v>
                </c:pt>
                <c:pt idx="19">
                  <c:v>249.12259952068368</c:v>
                </c:pt>
                <c:pt idx="20">
                  <c:v>354.25945096969593</c:v>
                </c:pt>
                <c:pt idx="21">
                  <c:v>129.54339996337876</c:v>
                </c:pt>
                <c:pt idx="22">
                  <c:v>389.52640086174017</c:v>
                </c:pt>
                <c:pt idx="23">
                  <c:v>-5.0542500495910474</c:v>
                </c:pt>
                <c:pt idx="24">
                  <c:v>273.19110047340376</c:v>
                </c:pt>
                <c:pt idx="25">
                  <c:v>274.07449892997738</c:v>
                </c:pt>
                <c:pt idx="26">
                  <c:v>224.56479987144473</c:v>
                </c:pt>
                <c:pt idx="27">
                  <c:v>300.00384919643403</c:v>
                </c:pt>
                <c:pt idx="28">
                  <c:v>206.87084900379196</c:v>
                </c:pt>
                <c:pt idx="29">
                  <c:v>224.97779958724962</c:v>
                </c:pt>
                <c:pt idx="30">
                  <c:v>283.3197002315523</c:v>
                </c:pt>
                <c:pt idx="31">
                  <c:v>268.88744914054877</c:v>
                </c:pt>
                <c:pt idx="32">
                  <c:v>296.20820043563822</c:v>
                </c:pt>
                <c:pt idx="33">
                  <c:v>254.10080069541948</c:v>
                </c:pt>
                <c:pt idx="34">
                  <c:v>272.22544977664967</c:v>
                </c:pt>
                <c:pt idx="35">
                  <c:v>271.03409965038264</c:v>
                </c:pt>
                <c:pt idx="36">
                  <c:v>238.65910058021507</c:v>
                </c:pt>
                <c:pt idx="37">
                  <c:v>231.31714999198886</c:v>
                </c:pt>
                <c:pt idx="38">
                  <c:v>269.68949931144681</c:v>
                </c:pt>
                <c:pt idx="39">
                  <c:v>253.69419960975637</c:v>
                </c:pt>
                <c:pt idx="40">
                  <c:v>228.87600015640271</c:v>
                </c:pt>
                <c:pt idx="41">
                  <c:v>225.04314962387085</c:v>
                </c:pt>
                <c:pt idx="42">
                  <c:v>235.3591499471666</c:v>
                </c:pt>
                <c:pt idx="43">
                  <c:v>271.17250014305114</c:v>
                </c:pt>
                <c:pt idx="44">
                  <c:v>257.8032507324221</c:v>
                </c:pt>
                <c:pt idx="45">
                  <c:v>235.89334961891188</c:v>
                </c:pt>
                <c:pt idx="46">
                  <c:v>114.66595001220715</c:v>
                </c:pt>
                <c:pt idx="47">
                  <c:v>215.70830011367784</c:v>
                </c:pt>
                <c:pt idx="48">
                  <c:v>216.3944502258301</c:v>
                </c:pt>
                <c:pt idx="49">
                  <c:v>139.1680503654481</c:v>
                </c:pt>
                <c:pt idx="50">
                  <c:v>289.34165011405963</c:v>
                </c:pt>
                <c:pt idx="51">
                  <c:v>253.97509959697689</c:v>
                </c:pt>
                <c:pt idx="52">
                  <c:v>259.35294933319085</c:v>
                </c:pt>
                <c:pt idx="53">
                  <c:v>213.01409963607807</c:v>
                </c:pt>
                <c:pt idx="54">
                  <c:v>191.63369970798493</c:v>
                </c:pt>
                <c:pt idx="55">
                  <c:v>222.74420021057145</c:v>
                </c:pt>
                <c:pt idx="56">
                  <c:v>247.7889997577665</c:v>
                </c:pt>
                <c:pt idx="57">
                  <c:v>232.54320058822637</c:v>
                </c:pt>
                <c:pt idx="58">
                  <c:v>200.58024927139297</c:v>
                </c:pt>
                <c:pt idx="59">
                  <c:v>211.22350023269655</c:v>
                </c:pt>
                <c:pt idx="60">
                  <c:v>256.51835104942302</c:v>
                </c:pt>
                <c:pt idx="61">
                  <c:v>111.67065024375924</c:v>
                </c:pt>
                <c:pt idx="62">
                  <c:v>187.97719992160819</c:v>
                </c:pt>
                <c:pt idx="63">
                  <c:v>220.28064992904643</c:v>
                </c:pt>
                <c:pt idx="64">
                  <c:v>173.20685022354135</c:v>
                </c:pt>
                <c:pt idx="65">
                  <c:v>159.38614986896516</c:v>
                </c:pt>
                <c:pt idx="66">
                  <c:v>165.22859983444181</c:v>
                </c:pt>
                <c:pt idx="67">
                  <c:v>187.59090063095076</c:v>
                </c:pt>
                <c:pt idx="68">
                  <c:v>194.36949866294862</c:v>
                </c:pt>
                <c:pt idx="69">
                  <c:v>255.04120068073235</c:v>
                </c:pt>
                <c:pt idx="70">
                  <c:v>216.01389901161193</c:v>
                </c:pt>
                <c:pt idx="71">
                  <c:v>187.33660009384167</c:v>
                </c:pt>
                <c:pt idx="72">
                  <c:v>205.44509951591459</c:v>
                </c:pt>
                <c:pt idx="73">
                  <c:v>190.27805077552824</c:v>
                </c:pt>
                <c:pt idx="74">
                  <c:v>251.05179951667748</c:v>
                </c:pt>
                <c:pt idx="75">
                  <c:v>199.14720030784565</c:v>
                </c:pt>
                <c:pt idx="76">
                  <c:v>227.75399942874895</c:v>
                </c:pt>
                <c:pt idx="77">
                  <c:v>175.8830998325349</c:v>
                </c:pt>
                <c:pt idx="78">
                  <c:v>232.75239971160872</c:v>
                </c:pt>
                <c:pt idx="79">
                  <c:v>209.45330070495618</c:v>
                </c:pt>
                <c:pt idx="80">
                  <c:v>175.34975049018848</c:v>
                </c:pt>
                <c:pt idx="81">
                  <c:v>221.47819975852985</c:v>
                </c:pt>
                <c:pt idx="82">
                  <c:v>212.02775047779062</c:v>
                </c:pt>
                <c:pt idx="83">
                  <c:v>164.96715007305147</c:v>
                </c:pt>
                <c:pt idx="84">
                  <c:v>82.682099914550804</c:v>
                </c:pt>
                <c:pt idx="85">
                  <c:v>143.99320048332206</c:v>
                </c:pt>
                <c:pt idx="86">
                  <c:v>188.09129985332521</c:v>
                </c:pt>
                <c:pt idx="87">
                  <c:v>175.39369945526084</c:v>
                </c:pt>
                <c:pt idx="88">
                  <c:v>185.81699999332454</c:v>
                </c:pt>
                <c:pt idx="89">
                  <c:v>173.62945005416873</c:v>
                </c:pt>
                <c:pt idx="90">
                  <c:v>164.97939994811978</c:v>
                </c:pt>
                <c:pt idx="91">
                  <c:v>176.22750010967241</c:v>
                </c:pt>
                <c:pt idx="92">
                  <c:v>216.52975060462967</c:v>
                </c:pt>
                <c:pt idx="93">
                  <c:v>207.58604993820185</c:v>
                </c:pt>
                <c:pt idx="94">
                  <c:v>123.43759993076314</c:v>
                </c:pt>
                <c:pt idx="95">
                  <c:v>179.55824954032926</c:v>
                </c:pt>
                <c:pt idx="96">
                  <c:v>195.15475029945409</c:v>
                </c:pt>
                <c:pt idx="97">
                  <c:v>183.31680088996853</c:v>
                </c:pt>
                <c:pt idx="98">
                  <c:v>139.72044948101055</c:v>
                </c:pt>
                <c:pt idx="99">
                  <c:v>120.54894968509686</c:v>
                </c:pt>
                <c:pt idx="100">
                  <c:v>187.86405027389497</c:v>
                </c:pt>
                <c:pt idx="101">
                  <c:v>123.73245032310501</c:v>
                </c:pt>
                <c:pt idx="102">
                  <c:v>88.100800056457842</c:v>
                </c:pt>
                <c:pt idx="103">
                  <c:v>175.83829970359776</c:v>
                </c:pt>
                <c:pt idx="104">
                  <c:v>59.497549767494199</c:v>
                </c:pt>
                <c:pt idx="105">
                  <c:v>166.77124989509602</c:v>
                </c:pt>
                <c:pt idx="106">
                  <c:v>161.01020013809224</c:v>
                </c:pt>
                <c:pt idx="107">
                  <c:v>158.6691999101638</c:v>
                </c:pt>
                <c:pt idx="108">
                  <c:v>186.93539952754981</c:v>
                </c:pt>
                <c:pt idx="109">
                  <c:v>123.42360019683838</c:v>
                </c:pt>
                <c:pt idx="110">
                  <c:v>196.31450024604777</c:v>
                </c:pt>
                <c:pt idx="111">
                  <c:v>168.43689944267254</c:v>
                </c:pt>
                <c:pt idx="112">
                  <c:v>193.66779878616333</c:v>
                </c:pt>
                <c:pt idx="113">
                  <c:v>153.72299986839312</c:v>
                </c:pt>
                <c:pt idx="114">
                  <c:v>105.88599999427771</c:v>
                </c:pt>
                <c:pt idx="115">
                  <c:v>153.86639918327336</c:v>
                </c:pt>
                <c:pt idx="116">
                  <c:v>188.59890044689172</c:v>
                </c:pt>
                <c:pt idx="117">
                  <c:v>147.98559989929171</c:v>
                </c:pt>
                <c:pt idx="118">
                  <c:v>179.92590060234059</c:v>
                </c:pt>
                <c:pt idx="119">
                  <c:v>174.24555038929009</c:v>
                </c:pt>
                <c:pt idx="120">
                  <c:v>170.06749973773998</c:v>
                </c:pt>
                <c:pt idx="121">
                  <c:v>163.64790014266964</c:v>
                </c:pt>
                <c:pt idx="122">
                  <c:v>178.18949994564053</c:v>
                </c:pt>
                <c:pt idx="123">
                  <c:v>169.15844929695146</c:v>
                </c:pt>
                <c:pt idx="124">
                  <c:v>161.61359984874724</c:v>
                </c:pt>
                <c:pt idx="125">
                  <c:v>171.6555006790162</c:v>
                </c:pt>
                <c:pt idx="126">
                  <c:v>156.39810017585737</c:v>
                </c:pt>
                <c:pt idx="127">
                  <c:v>145.04294985771193</c:v>
                </c:pt>
                <c:pt idx="128">
                  <c:v>156.74719971179999</c:v>
                </c:pt>
                <c:pt idx="129">
                  <c:v>164.17604954719584</c:v>
                </c:pt>
                <c:pt idx="130">
                  <c:v>173.04345069885241</c:v>
                </c:pt>
                <c:pt idx="131">
                  <c:v>170.93259915828705</c:v>
                </c:pt>
                <c:pt idx="132">
                  <c:v>186.1028994560244</c:v>
                </c:pt>
                <c:pt idx="133">
                  <c:v>145.19444980144522</c:v>
                </c:pt>
                <c:pt idx="134">
                  <c:v>156.63724976062781</c:v>
                </c:pt>
                <c:pt idx="135">
                  <c:v>175.11534976959211</c:v>
                </c:pt>
                <c:pt idx="136">
                  <c:v>152.00410026073456</c:v>
                </c:pt>
                <c:pt idx="137">
                  <c:v>130.68655001640306</c:v>
                </c:pt>
                <c:pt idx="138">
                  <c:v>168.74085047721849</c:v>
                </c:pt>
                <c:pt idx="139">
                  <c:v>162.53255001068112</c:v>
                </c:pt>
                <c:pt idx="140">
                  <c:v>154.99219985485067</c:v>
                </c:pt>
                <c:pt idx="141">
                  <c:v>176.83190045356775</c:v>
                </c:pt>
                <c:pt idx="142">
                  <c:v>123.589499759674</c:v>
                </c:pt>
                <c:pt idx="143">
                  <c:v>161.60644993782034</c:v>
                </c:pt>
                <c:pt idx="144">
                  <c:v>177.72525034904481</c:v>
                </c:pt>
                <c:pt idx="145">
                  <c:v>173.24284977436091</c:v>
                </c:pt>
                <c:pt idx="146">
                  <c:v>147.14239948272731</c:v>
                </c:pt>
                <c:pt idx="147">
                  <c:v>135.72090005874617</c:v>
                </c:pt>
                <c:pt idx="148">
                  <c:v>178.03999988555927</c:v>
                </c:pt>
                <c:pt idx="149">
                  <c:v>182.65244958877597</c:v>
                </c:pt>
                <c:pt idx="150">
                  <c:v>146.45920044898992</c:v>
                </c:pt>
                <c:pt idx="151">
                  <c:v>147.51599986076377</c:v>
                </c:pt>
                <c:pt idx="152">
                  <c:v>68.69474995136261</c:v>
                </c:pt>
                <c:pt idx="153">
                  <c:v>145.51904945373508</c:v>
                </c:pt>
                <c:pt idx="154">
                  <c:v>71.408549995422561</c:v>
                </c:pt>
                <c:pt idx="155">
                  <c:v>168.15664997577665</c:v>
                </c:pt>
                <c:pt idx="156">
                  <c:v>170.76959944725056</c:v>
                </c:pt>
                <c:pt idx="157">
                  <c:v>152.99750033378589</c:v>
                </c:pt>
                <c:pt idx="158">
                  <c:v>179.09774977684029</c:v>
                </c:pt>
                <c:pt idx="159">
                  <c:v>88.76670046806322</c:v>
                </c:pt>
                <c:pt idx="160">
                  <c:v>119.0788999271392</c:v>
                </c:pt>
                <c:pt idx="161">
                  <c:v>132.68294933319063</c:v>
                </c:pt>
                <c:pt idx="162">
                  <c:v>159.47359972000089</c:v>
                </c:pt>
                <c:pt idx="163">
                  <c:v>148.8502999925615</c:v>
                </c:pt>
                <c:pt idx="164">
                  <c:v>122.76130013942733</c:v>
                </c:pt>
                <c:pt idx="165">
                  <c:v>155.60894990444208</c:v>
                </c:pt>
                <c:pt idx="166">
                  <c:v>129.46094951629613</c:v>
                </c:pt>
                <c:pt idx="167">
                  <c:v>101.00074985504111</c:v>
                </c:pt>
                <c:pt idx="168">
                  <c:v>148.17274958610525</c:v>
                </c:pt>
                <c:pt idx="169">
                  <c:v>123.77990006446815</c:v>
                </c:pt>
                <c:pt idx="170">
                  <c:v>151.76549982070915</c:v>
                </c:pt>
                <c:pt idx="171">
                  <c:v>132.00200000762919</c:v>
                </c:pt>
                <c:pt idx="172">
                  <c:v>129.4835500621796</c:v>
                </c:pt>
                <c:pt idx="173">
                  <c:v>114.62549986839275</c:v>
                </c:pt>
                <c:pt idx="174">
                  <c:v>138.6541002845762</c:v>
                </c:pt>
                <c:pt idx="175">
                  <c:v>173.3407003593442</c:v>
                </c:pt>
                <c:pt idx="176">
                  <c:v>129.19708727822152</c:v>
                </c:pt>
                <c:pt idx="177">
                  <c:v>108.44485012054466</c:v>
                </c:pt>
                <c:pt idx="178">
                  <c:v>90.287099766731345</c:v>
                </c:pt>
                <c:pt idx="179">
                  <c:v>90.527499895096014</c:v>
                </c:pt>
                <c:pt idx="180">
                  <c:v>153.62459971189483</c:v>
                </c:pt>
                <c:pt idx="181">
                  <c:v>153.90860039234161</c:v>
                </c:pt>
                <c:pt idx="182">
                  <c:v>165.50149970531473</c:v>
                </c:pt>
                <c:pt idx="183">
                  <c:v>150.08354962348949</c:v>
                </c:pt>
                <c:pt idx="184">
                  <c:v>147.62044990539567</c:v>
                </c:pt>
                <c:pt idx="185">
                  <c:v>113.17540010452261</c:v>
                </c:pt>
                <c:pt idx="186">
                  <c:v>164.13740047454846</c:v>
                </c:pt>
                <c:pt idx="187">
                  <c:v>85.976550121307341</c:v>
                </c:pt>
                <c:pt idx="188">
                  <c:v>136.96714995384215</c:v>
                </c:pt>
                <c:pt idx="189">
                  <c:v>160.27909978389735</c:v>
                </c:pt>
                <c:pt idx="190">
                  <c:v>143.01619936943058</c:v>
                </c:pt>
                <c:pt idx="191">
                  <c:v>144.68745030879964</c:v>
                </c:pt>
                <c:pt idx="192">
                  <c:v>148.92890022754708</c:v>
                </c:pt>
                <c:pt idx="193">
                  <c:v>155.70949993133564</c:v>
                </c:pt>
                <c:pt idx="194">
                  <c:v>157.17995007038161</c:v>
                </c:pt>
                <c:pt idx="195">
                  <c:v>139.56719979763039</c:v>
                </c:pt>
                <c:pt idx="196">
                  <c:v>129.17684990406048</c:v>
                </c:pt>
                <c:pt idx="197">
                  <c:v>135.6906502342226</c:v>
                </c:pt>
                <c:pt idx="198">
                  <c:v>109.431900634766</c:v>
                </c:pt>
                <c:pt idx="199">
                  <c:v>103.12080014228829</c:v>
                </c:pt>
                <c:pt idx="200">
                  <c:v>153.19435028553031</c:v>
                </c:pt>
                <c:pt idx="201">
                  <c:v>134.51575068473824</c:v>
                </c:pt>
                <c:pt idx="202">
                  <c:v>144.53434956550615</c:v>
                </c:pt>
                <c:pt idx="203">
                  <c:v>120.58939999103553</c:v>
                </c:pt>
                <c:pt idx="204">
                  <c:v>125.36254965305285</c:v>
                </c:pt>
                <c:pt idx="205">
                  <c:v>138.77939970016499</c:v>
                </c:pt>
                <c:pt idx="206">
                  <c:v>76.448050184250008</c:v>
                </c:pt>
                <c:pt idx="207">
                  <c:v>154.40145017623919</c:v>
                </c:pt>
                <c:pt idx="208">
                  <c:v>134.03349981307974</c:v>
                </c:pt>
                <c:pt idx="209">
                  <c:v>85.980200486183335</c:v>
                </c:pt>
                <c:pt idx="210">
                  <c:v>139.6958497047423</c:v>
                </c:pt>
                <c:pt idx="211">
                  <c:v>110.4692501544954</c:v>
                </c:pt>
                <c:pt idx="212">
                  <c:v>102.09584967136354</c:v>
                </c:pt>
                <c:pt idx="213">
                  <c:v>101.59780003547677</c:v>
                </c:pt>
                <c:pt idx="214">
                  <c:v>111.55180005073584</c:v>
                </c:pt>
                <c:pt idx="215">
                  <c:v>98.798650031089508</c:v>
                </c:pt>
                <c:pt idx="216">
                  <c:v>79.77455036640184</c:v>
                </c:pt>
                <c:pt idx="217">
                  <c:v>57.411500120162955</c:v>
                </c:pt>
                <c:pt idx="218">
                  <c:v>143.5180995273588</c:v>
                </c:pt>
                <c:pt idx="219">
                  <c:v>127.20300019264235</c:v>
                </c:pt>
                <c:pt idx="220">
                  <c:v>102.32759954929355</c:v>
                </c:pt>
                <c:pt idx="221">
                  <c:v>121.4304002332685</c:v>
                </c:pt>
                <c:pt idx="222">
                  <c:v>136.28090021133423</c:v>
                </c:pt>
                <c:pt idx="223">
                  <c:v>59.453699693679852</c:v>
                </c:pt>
                <c:pt idx="224">
                  <c:v>139.77855009078982</c:v>
                </c:pt>
                <c:pt idx="225">
                  <c:v>91.172200064659052</c:v>
                </c:pt>
                <c:pt idx="226">
                  <c:v>52.912349934577946</c:v>
                </c:pt>
                <c:pt idx="227">
                  <c:v>138.29839982032763</c:v>
                </c:pt>
                <c:pt idx="228">
                  <c:v>69.784950051307646</c:v>
                </c:pt>
                <c:pt idx="229">
                  <c:v>161.73874989509571</c:v>
                </c:pt>
                <c:pt idx="230">
                  <c:v>62.182349691390996</c:v>
                </c:pt>
                <c:pt idx="231">
                  <c:v>118.20699990272551</c:v>
                </c:pt>
                <c:pt idx="232">
                  <c:v>69.301749982833698</c:v>
                </c:pt>
                <c:pt idx="233">
                  <c:v>53.399699611663863</c:v>
                </c:pt>
                <c:pt idx="234">
                  <c:v>91.081899938583504</c:v>
                </c:pt>
                <c:pt idx="235">
                  <c:v>101.91429973602276</c:v>
                </c:pt>
                <c:pt idx="236">
                  <c:v>87.455750288963344</c:v>
                </c:pt>
                <c:pt idx="237">
                  <c:v>113.47414985179924</c:v>
                </c:pt>
                <c:pt idx="238">
                  <c:v>104.32665055274926</c:v>
                </c:pt>
                <c:pt idx="239">
                  <c:v>86.645949964523211</c:v>
                </c:pt>
                <c:pt idx="240">
                  <c:v>96.437150034904292</c:v>
                </c:pt>
                <c:pt idx="241">
                  <c:v>73.119799494743248</c:v>
                </c:pt>
                <c:pt idx="242">
                  <c:v>112.93349995136296</c:v>
                </c:pt>
                <c:pt idx="243">
                  <c:v>154.00969972610457</c:v>
                </c:pt>
                <c:pt idx="244">
                  <c:v>112.05824992656704</c:v>
                </c:pt>
                <c:pt idx="245">
                  <c:v>96.145700044632065</c:v>
                </c:pt>
                <c:pt idx="246">
                  <c:v>123.59430015564007</c:v>
                </c:pt>
                <c:pt idx="247">
                  <c:v>93.751150031089551</c:v>
                </c:pt>
                <c:pt idx="248">
                  <c:v>70.836050009727458</c:v>
                </c:pt>
                <c:pt idx="249">
                  <c:v>139.78495013236949</c:v>
                </c:pt>
                <c:pt idx="250">
                  <c:v>115.4792001438144</c:v>
                </c:pt>
                <c:pt idx="251">
                  <c:v>86.397599987983455</c:v>
                </c:pt>
                <c:pt idx="252">
                  <c:v>64.582549915313692</c:v>
                </c:pt>
                <c:pt idx="253">
                  <c:v>81.631400017738287</c:v>
                </c:pt>
                <c:pt idx="254">
                  <c:v>98.376199817657749</c:v>
                </c:pt>
                <c:pt idx="255">
                  <c:v>114.93849982261665</c:v>
                </c:pt>
                <c:pt idx="256">
                  <c:v>33.875950040817258</c:v>
                </c:pt>
                <c:pt idx="257">
                  <c:v>114.20104954719534</c:v>
                </c:pt>
                <c:pt idx="258">
                  <c:v>82.484350051880099</c:v>
                </c:pt>
                <c:pt idx="259">
                  <c:v>84.985250201225199</c:v>
                </c:pt>
                <c:pt idx="260">
                  <c:v>121.06449973106379</c:v>
                </c:pt>
                <c:pt idx="261">
                  <c:v>79.2435995817182</c:v>
                </c:pt>
                <c:pt idx="262">
                  <c:v>89.445800042152058</c:v>
                </c:pt>
                <c:pt idx="263">
                  <c:v>97.741850366592416</c:v>
                </c:pt>
                <c:pt idx="264">
                  <c:v>78.729050025939756</c:v>
                </c:pt>
                <c:pt idx="265">
                  <c:v>98.004749922752197</c:v>
                </c:pt>
                <c:pt idx="266">
                  <c:v>85.962350096702593</c:v>
                </c:pt>
                <c:pt idx="267">
                  <c:v>100.86064989566836</c:v>
                </c:pt>
                <c:pt idx="268">
                  <c:v>128.98650007247923</c:v>
                </c:pt>
                <c:pt idx="269">
                  <c:v>92.98519993782061</c:v>
                </c:pt>
                <c:pt idx="270">
                  <c:v>80.998400259017956</c:v>
                </c:pt>
                <c:pt idx="271">
                  <c:v>131.53610029220584</c:v>
                </c:pt>
                <c:pt idx="272">
                  <c:v>77.898000254630801</c:v>
                </c:pt>
                <c:pt idx="273">
                  <c:v>97.726350145340206</c:v>
                </c:pt>
                <c:pt idx="274">
                  <c:v>62.08634995937345</c:v>
                </c:pt>
                <c:pt idx="275">
                  <c:v>69.304500131607114</c:v>
                </c:pt>
                <c:pt idx="276">
                  <c:v>109.96184971809356</c:v>
                </c:pt>
                <c:pt idx="277">
                  <c:v>28.243599987030052</c:v>
                </c:pt>
                <c:pt idx="278">
                  <c:v>79.532350120544265</c:v>
                </c:pt>
                <c:pt idx="279">
                  <c:v>105.87479979515044</c:v>
                </c:pt>
                <c:pt idx="280">
                  <c:v>73.921250338554358</c:v>
                </c:pt>
                <c:pt idx="281">
                  <c:v>133.62299968242618</c:v>
                </c:pt>
                <c:pt idx="282">
                  <c:v>93.033850207328655</c:v>
                </c:pt>
                <c:pt idx="283">
                  <c:v>56.314099898338291</c:v>
                </c:pt>
                <c:pt idx="284">
                  <c:v>100.00165018558505</c:v>
                </c:pt>
                <c:pt idx="285">
                  <c:v>98.460150079727157</c:v>
                </c:pt>
                <c:pt idx="286">
                  <c:v>90.484599962234512</c:v>
                </c:pt>
                <c:pt idx="287">
                  <c:v>55.428950099945041</c:v>
                </c:pt>
                <c:pt idx="288">
                  <c:v>133.84370018959061</c:v>
                </c:pt>
                <c:pt idx="289">
                  <c:v>85.362850036620841</c:v>
                </c:pt>
                <c:pt idx="290">
                  <c:v>75.563400044441039</c:v>
                </c:pt>
                <c:pt idx="291">
                  <c:v>92.189249629974142</c:v>
                </c:pt>
                <c:pt idx="292">
                  <c:v>88.135600519180556</c:v>
                </c:pt>
                <c:pt idx="293">
                  <c:v>113.1374498748778</c:v>
                </c:pt>
                <c:pt idx="294">
                  <c:v>55.801400051116993</c:v>
                </c:pt>
                <c:pt idx="295">
                  <c:v>64.645549917221047</c:v>
                </c:pt>
                <c:pt idx="296">
                  <c:v>51.356299886703496</c:v>
                </c:pt>
                <c:pt idx="297">
                  <c:v>51.204999780654937</c:v>
                </c:pt>
                <c:pt idx="298">
                  <c:v>58.060800089836093</c:v>
                </c:pt>
                <c:pt idx="299">
                  <c:v>85.526649799346842</c:v>
                </c:pt>
                <c:pt idx="300">
                  <c:v>55.899999780654895</c:v>
                </c:pt>
                <c:pt idx="301">
                  <c:v>73.986149692535406</c:v>
                </c:pt>
                <c:pt idx="302">
                  <c:v>82.603549971580549</c:v>
                </c:pt>
                <c:pt idx="303">
                  <c:v>90.798449811935399</c:v>
                </c:pt>
                <c:pt idx="304">
                  <c:v>49.774549751281754</c:v>
                </c:pt>
                <c:pt idx="305">
                  <c:v>104.94679959297204</c:v>
                </c:pt>
                <c:pt idx="306">
                  <c:v>67.313049678802457</c:v>
                </c:pt>
                <c:pt idx="307">
                  <c:v>92.63629968643194</c:v>
                </c:pt>
                <c:pt idx="308">
                  <c:v>55.735549941062942</c:v>
                </c:pt>
                <c:pt idx="309">
                  <c:v>62.074149856567402</c:v>
                </c:pt>
                <c:pt idx="310">
                  <c:v>79.662250084877201</c:v>
                </c:pt>
                <c:pt idx="311">
                  <c:v>117.55015015602112</c:v>
                </c:pt>
                <c:pt idx="312">
                  <c:v>80.127450275421197</c:v>
                </c:pt>
                <c:pt idx="313">
                  <c:v>76.428449997901708</c:v>
                </c:pt>
                <c:pt idx="314">
                  <c:v>79.24579993724825</c:v>
                </c:pt>
                <c:pt idx="315">
                  <c:v>80.040600013732785</c:v>
                </c:pt>
                <c:pt idx="316">
                  <c:v>52.869550089836089</c:v>
                </c:pt>
                <c:pt idx="317">
                  <c:v>75.094349822998169</c:v>
                </c:pt>
                <c:pt idx="318">
                  <c:v>68.479100081920706</c:v>
                </c:pt>
                <c:pt idx="319">
                  <c:v>52.834050059318542</c:v>
                </c:pt>
                <c:pt idx="320">
                  <c:v>58.776149711608902</c:v>
                </c:pt>
                <c:pt idx="321">
                  <c:v>66.025049614906308</c:v>
                </c:pt>
                <c:pt idx="322">
                  <c:v>55.863399930000355</c:v>
                </c:pt>
                <c:pt idx="323">
                  <c:v>76.149150042533932</c:v>
                </c:pt>
                <c:pt idx="324">
                  <c:v>83.702149791717659</c:v>
                </c:pt>
                <c:pt idx="325">
                  <c:v>51.074049510955852</c:v>
                </c:pt>
                <c:pt idx="326">
                  <c:v>67.540499663353003</c:v>
                </c:pt>
                <c:pt idx="327">
                  <c:v>67.464700038433051</c:v>
                </c:pt>
                <c:pt idx="328">
                  <c:v>58.3796000480652</c:v>
                </c:pt>
                <c:pt idx="329">
                  <c:v>65.117200012206979</c:v>
                </c:pt>
                <c:pt idx="330">
                  <c:v>70.440499835014236</c:v>
                </c:pt>
                <c:pt idx="331">
                  <c:v>96.83174999713863</c:v>
                </c:pt>
                <c:pt idx="332">
                  <c:v>69.9293000888824</c:v>
                </c:pt>
                <c:pt idx="333">
                  <c:v>28.583800134658802</c:v>
                </c:pt>
                <c:pt idx="334">
                  <c:v>28.583800134658802</c:v>
                </c:pt>
                <c:pt idx="335">
                  <c:v>97.204699945449804</c:v>
                </c:pt>
                <c:pt idx="336">
                  <c:v>67.351649951934803</c:v>
                </c:pt>
                <c:pt idx="337">
                  <c:v>71.954999785423041</c:v>
                </c:pt>
                <c:pt idx="338">
                  <c:v>29.211549873352045</c:v>
                </c:pt>
                <c:pt idx="339">
                  <c:v>74.937449994087089</c:v>
                </c:pt>
                <c:pt idx="340">
                  <c:v>111.79909980297074</c:v>
                </c:pt>
                <c:pt idx="341">
                  <c:v>41.464499864578208</c:v>
                </c:pt>
                <c:pt idx="342">
                  <c:v>52.474750046730051</c:v>
                </c:pt>
                <c:pt idx="343">
                  <c:v>28.838300065994254</c:v>
                </c:pt>
                <c:pt idx="344">
                  <c:v>62.393349990844698</c:v>
                </c:pt>
                <c:pt idx="345">
                  <c:v>82.56290018081657</c:v>
                </c:pt>
                <c:pt idx="346">
                  <c:v>63.330449805259747</c:v>
                </c:pt>
                <c:pt idx="347">
                  <c:v>77.951800003051801</c:v>
                </c:pt>
                <c:pt idx="348">
                  <c:v>61.950300364494296</c:v>
                </c:pt>
                <c:pt idx="349">
                  <c:v>53.095550136566203</c:v>
                </c:pt>
                <c:pt idx="350">
                  <c:v>80.493199901580766</c:v>
                </c:pt>
                <c:pt idx="351">
                  <c:v>44.063200416564896</c:v>
                </c:pt>
                <c:pt idx="352">
                  <c:v>72.883450069427255</c:v>
                </c:pt>
                <c:pt idx="353">
                  <c:v>98.741549458503528</c:v>
                </c:pt>
                <c:pt idx="354">
                  <c:v>76.146400208472954</c:v>
                </c:pt>
                <c:pt idx="355">
                  <c:v>100.7724998664859</c:v>
                </c:pt>
                <c:pt idx="356">
                  <c:v>87.650799698829644</c:v>
                </c:pt>
                <c:pt idx="357">
                  <c:v>48.561199889183051</c:v>
                </c:pt>
                <c:pt idx="358">
                  <c:v>91.891299824714395</c:v>
                </c:pt>
                <c:pt idx="359">
                  <c:v>77.960450029373163</c:v>
                </c:pt>
                <c:pt idx="360">
                  <c:v>83.372200136184759</c:v>
                </c:pt>
                <c:pt idx="361">
                  <c:v>60.331600127220156</c:v>
                </c:pt>
                <c:pt idx="362">
                  <c:v>77.497549767494192</c:v>
                </c:pt>
                <c:pt idx="363">
                  <c:v>112.06435011386851</c:v>
                </c:pt>
                <c:pt idx="364">
                  <c:v>101.3639995765688</c:v>
                </c:pt>
                <c:pt idx="365">
                  <c:v>60.143299813270552</c:v>
                </c:pt>
                <c:pt idx="366">
                  <c:v>31.757399740219149</c:v>
                </c:pt>
                <c:pt idx="367">
                  <c:v>51.557299914359994</c:v>
                </c:pt>
                <c:pt idx="368">
                  <c:v>64.813049955368001</c:v>
                </c:pt>
                <c:pt idx="369">
                  <c:v>66.126050090789704</c:v>
                </c:pt>
                <c:pt idx="370">
                  <c:v>27.3420999383927</c:v>
                </c:pt>
                <c:pt idx="371">
                  <c:v>45.691699867248495</c:v>
                </c:pt>
                <c:pt idx="372">
                  <c:v>26.529550046920754</c:v>
                </c:pt>
                <c:pt idx="373">
                  <c:v>42.618449850082399</c:v>
                </c:pt>
                <c:pt idx="374">
                  <c:v>51.461449899673461</c:v>
                </c:pt>
                <c:pt idx="375">
                  <c:v>83.601300034523149</c:v>
                </c:pt>
                <c:pt idx="376">
                  <c:v>57.340950069427549</c:v>
                </c:pt>
                <c:pt idx="377">
                  <c:v>90.532850127220343</c:v>
                </c:pt>
                <c:pt idx="378">
                  <c:v>65.826900095939649</c:v>
                </c:pt>
                <c:pt idx="379">
                  <c:v>92.2394498538969</c:v>
                </c:pt>
                <c:pt idx="380">
                  <c:v>76.19050035476684</c:v>
                </c:pt>
                <c:pt idx="381">
                  <c:v>110.1751508283615</c:v>
                </c:pt>
                <c:pt idx="382">
                  <c:v>42.142249555587753</c:v>
                </c:pt>
                <c:pt idx="383">
                  <c:v>73.320999631881762</c:v>
                </c:pt>
                <c:pt idx="384">
                  <c:v>80.756999683380045</c:v>
                </c:pt>
                <c:pt idx="385">
                  <c:v>68.954949736595154</c:v>
                </c:pt>
                <c:pt idx="386">
                  <c:v>55.175049743652302</c:v>
                </c:pt>
                <c:pt idx="387">
                  <c:v>62.09079995155335</c:v>
                </c:pt>
                <c:pt idx="388">
                  <c:v>80.132799973488105</c:v>
                </c:pt>
                <c:pt idx="389">
                  <c:v>35.944699792861954</c:v>
                </c:pt>
                <c:pt idx="390">
                  <c:v>92.954749965667816</c:v>
                </c:pt>
                <c:pt idx="391">
                  <c:v>49.598449764251697</c:v>
                </c:pt>
                <c:pt idx="392">
                  <c:v>44.476549568176296</c:v>
                </c:pt>
                <c:pt idx="393">
                  <c:v>82.862249889373658</c:v>
                </c:pt>
                <c:pt idx="394">
                  <c:v>71.763649864196793</c:v>
                </c:pt>
                <c:pt idx="395">
                  <c:v>28.701899766922004</c:v>
                </c:pt>
                <c:pt idx="396">
                  <c:v>73.392999801635739</c:v>
                </c:pt>
                <c:pt idx="397">
                  <c:v>45.385850005149905</c:v>
                </c:pt>
                <c:pt idx="398">
                  <c:v>94.812049827575962</c:v>
                </c:pt>
                <c:pt idx="399">
                  <c:v>45.366749658584595</c:v>
                </c:pt>
                <c:pt idx="400">
                  <c:v>48.015749540328954</c:v>
                </c:pt>
                <c:pt idx="401">
                  <c:v>72.009599690437156</c:v>
                </c:pt>
                <c:pt idx="402">
                  <c:v>76.736749911308394</c:v>
                </c:pt>
                <c:pt idx="403">
                  <c:v>74.828800396919249</c:v>
                </c:pt>
                <c:pt idx="404">
                  <c:v>66.56869987964636</c:v>
                </c:pt>
                <c:pt idx="405">
                  <c:v>77.618500018119818</c:v>
                </c:pt>
                <c:pt idx="406">
                  <c:v>66.528200345039352</c:v>
                </c:pt>
                <c:pt idx="407">
                  <c:v>52.095299649238598</c:v>
                </c:pt>
                <c:pt idx="408">
                  <c:v>44.446999893188504</c:v>
                </c:pt>
                <c:pt idx="409">
                  <c:v>83.761049771308791</c:v>
                </c:pt>
                <c:pt idx="410">
                  <c:v>66.852150011062662</c:v>
                </c:pt>
                <c:pt idx="411">
                  <c:v>52.551399736404349</c:v>
                </c:pt>
                <c:pt idx="412">
                  <c:v>45.867050008773802</c:v>
                </c:pt>
                <c:pt idx="413">
                  <c:v>23.267599868774354</c:v>
                </c:pt>
                <c:pt idx="414">
                  <c:v>23.267599868774354</c:v>
                </c:pt>
                <c:pt idx="415">
                  <c:v>43.827749729156501</c:v>
                </c:pt>
                <c:pt idx="416">
                  <c:v>54.537599582672158</c:v>
                </c:pt>
                <c:pt idx="417">
                  <c:v>50.015999836921694</c:v>
                </c:pt>
                <c:pt idx="418">
                  <c:v>50.922999548912045</c:v>
                </c:pt>
                <c:pt idx="419">
                  <c:v>73.4910499811173</c:v>
                </c:pt>
                <c:pt idx="420">
                  <c:v>64.421200132370018</c:v>
                </c:pt>
                <c:pt idx="421">
                  <c:v>50.2159499692917</c:v>
                </c:pt>
                <c:pt idx="422">
                  <c:v>55.013249735832247</c:v>
                </c:pt>
                <c:pt idx="423">
                  <c:v>48.536799807548505</c:v>
                </c:pt>
                <c:pt idx="424">
                  <c:v>56.70425021171571</c:v>
                </c:pt>
                <c:pt idx="425">
                  <c:v>51.246799693107604</c:v>
                </c:pt>
                <c:pt idx="426">
                  <c:v>59.658050007820101</c:v>
                </c:pt>
                <c:pt idx="427">
                  <c:v>64.901849851608304</c:v>
                </c:pt>
                <c:pt idx="428">
                  <c:v>50.600799999237047</c:v>
                </c:pt>
                <c:pt idx="429">
                  <c:v>60.639649653434802</c:v>
                </c:pt>
                <c:pt idx="430">
                  <c:v>48.382249665260353</c:v>
                </c:pt>
                <c:pt idx="431">
                  <c:v>71.578049998283547</c:v>
                </c:pt>
                <c:pt idx="432">
                  <c:v>81.219449768066312</c:v>
                </c:pt>
                <c:pt idx="433">
                  <c:v>46.44839986801145</c:v>
                </c:pt>
                <c:pt idx="434">
                  <c:v>53.669649791717553</c:v>
                </c:pt>
                <c:pt idx="435">
                  <c:v>62.655750226974462</c:v>
                </c:pt>
                <c:pt idx="436">
                  <c:v>41.524499435424801</c:v>
                </c:pt>
                <c:pt idx="437">
                  <c:v>58.429100189209002</c:v>
                </c:pt>
                <c:pt idx="438">
                  <c:v>40.785550079345761</c:v>
                </c:pt>
                <c:pt idx="439">
                  <c:v>40.34074976444245</c:v>
                </c:pt>
                <c:pt idx="440">
                  <c:v>63.178649997711254</c:v>
                </c:pt>
                <c:pt idx="441">
                  <c:v>62.489949731826847</c:v>
                </c:pt>
                <c:pt idx="442">
                  <c:v>57.940000338554341</c:v>
                </c:pt>
                <c:pt idx="443">
                  <c:v>60.722999949455243</c:v>
                </c:pt>
                <c:pt idx="444">
                  <c:v>48.084950094223004</c:v>
                </c:pt>
                <c:pt idx="445">
                  <c:v>59.932749900817804</c:v>
                </c:pt>
                <c:pt idx="446">
                  <c:v>54.481899666786205</c:v>
                </c:pt>
                <c:pt idx="447">
                  <c:v>50.764800448417645</c:v>
                </c:pt>
                <c:pt idx="448">
                  <c:v>54.67755008220675</c:v>
                </c:pt>
                <c:pt idx="449">
                  <c:v>63.938350019454951</c:v>
                </c:pt>
                <c:pt idx="450">
                  <c:v>87.107600269317402</c:v>
                </c:pt>
                <c:pt idx="451">
                  <c:v>40.119700074195848</c:v>
                </c:pt>
                <c:pt idx="452">
                  <c:v>67.944849886894261</c:v>
                </c:pt>
                <c:pt idx="453">
                  <c:v>72.187349958419816</c:v>
                </c:pt>
                <c:pt idx="454">
                  <c:v>58.341199803352396</c:v>
                </c:pt>
                <c:pt idx="455">
                  <c:v>44.227550029754653</c:v>
                </c:pt>
                <c:pt idx="456">
                  <c:v>86.130800075530942</c:v>
                </c:pt>
                <c:pt idx="457">
                  <c:v>70.442299976349105</c:v>
                </c:pt>
                <c:pt idx="458">
                  <c:v>53.101500191688544</c:v>
                </c:pt>
                <c:pt idx="459">
                  <c:v>56.298250246047999</c:v>
                </c:pt>
                <c:pt idx="460">
                  <c:v>51.864200062751749</c:v>
                </c:pt>
                <c:pt idx="461">
                  <c:v>65.77935004234314</c:v>
                </c:pt>
                <c:pt idx="462">
                  <c:v>37.358199906349149</c:v>
                </c:pt>
                <c:pt idx="463">
                  <c:v>71.368299655914399</c:v>
                </c:pt>
                <c:pt idx="464">
                  <c:v>53.457900280952444</c:v>
                </c:pt>
                <c:pt idx="465">
                  <c:v>65.736099982261663</c:v>
                </c:pt>
                <c:pt idx="466">
                  <c:v>41.915800142288198</c:v>
                </c:pt>
                <c:pt idx="467">
                  <c:v>43.679449849128709</c:v>
                </c:pt>
                <c:pt idx="468">
                  <c:v>69.079299678802499</c:v>
                </c:pt>
                <c:pt idx="469">
                  <c:v>67.384049634933461</c:v>
                </c:pt>
                <c:pt idx="470">
                  <c:v>47.526199769973751</c:v>
                </c:pt>
                <c:pt idx="471">
                  <c:v>65.395000081062349</c:v>
                </c:pt>
                <c:pt idx="472">
                  <c:v>64.198349933624257</c:v>
                </c:pt>
                <c:pt idx="473">
                  <c:v>45.880949845314042</c:v>
                </c:pt>
                <c:pt idx="474">
                  <c:v>50.003550057411196</c:v>
                </c:pt>
                <c:pt idx="475">
                  <c:v>60.363300042152396</c:v>
                </c:pt>
                <c:pt idx="476">
                  <c:v>38.285199942588804</c:v>
                </c:pt>
                <c:pt idx="477">
                  <c:v>31.903849878311153</c:v>
                </c:pt>
                <c:pt idx="478">
                  <c:v>47.390749993324256</c:v>
                </c:pt>
                <c:pt idx="479">
                  <c:v>74.037850141525297</c:v>
                </c:pt>
                <c:pt idx="480">
                  <c:v>42.256099920272817</c:v>
                </c:pt>
                <c:pt idx="481">
                  <c:v>51.433200440406793</c:v>
                </c:pt>
                <c:pt idx="482">
                  <c:v>25.512899827957192</c:v>
                </c:pt>
                <c:pt idx="483">
                  <c:v>28.364549970626797</c:v>
                </c:pt>
                <c:pt idx="484">
                  <c:v>28.364549970626797</c:v>
                </c:pt>
                <c:pt idx="485">
                  <c:v>58.153649921417255</c:v>
                </c:pt>
                <c:pt idx="486">
                  <c:v>43.872599778175406</c:v>
                </c:pt>
                <c:pt idx="487">
                  <c:v>47.265549974441491</c:v>
                </c:pt>
                <c:pt idx="488">
                  <c:v>43.733199987411496</c:v>
                </c:pt>
                <c:pt idx="489">
                  <c:v>59.91900006771084</c:v>
                </c:pt>
                <c:pt idx="490">
                  <c:v>77.195250077247692</c:v>
                </c:pt>
                <c:pt idx="491">
                  <c:v>51.986399612426794</c:v>
                </c:pt>
                <c:pt idx="492">
                  <c:v>49.755499787330642</c:v>
                </c:pt>
                <c:pt idx="493">
                  <c:v>53.322499823570197</c:v>
                </c:pt>
                <c:pt idx="494">
                  <c:v>53.616549873352049</c:v>
                </c:pt>
                <c:pt idx="495">
                  <c:v>62.675300087928747</c:v>
                </c:pt>
                <c:pt idx="496">
                  <c:v>43.219449892044047</c:v>
                </c:pt>
                <c:pt idx="497">
                  <c:v>76.246750059127791</c:v>
                </c:pt>
                <c:pt idx="498">
                  <c:v>57.27959961891171</c:v>
                </c:pt>
                <c:pt idx="499">
                  <c:v>48.022399978637651</c:v>
                </c:pt>
                <c:pt idx="500">
                  <c:v>50.2087997817993</c:v>
                </c:pt>
                <c:pt idx="501">
                  <c:v>50.08579988479611</c:v>
                </c:pt>
                <c:pt idx="502">
                  <c:v>36.947699847221351</c:v>
                </c:pt>
                <c:pt idx="503">
                  <c:v>63.639050168991105</c:v>
                </c:pt>
                <c:pt idx="504">
                  <c:v>24.789600038528402</c:v>
                </c:pt>
                <c:pt idx="505">
                  <c:v>44.30250006675719</c:v>
                </c:pt>
                <c:pt idx="506">
                  <c:v>55.839949913024952</c:v>
                </c:pt>
                <c:pt idx="507">
                  <c:v>49.64579978942875</c:v>
                </c:pt>
                <c:pt idx="508">
                  <c:v>56.416600027084357</c:v>
                </c:pt>
                <c:pt idx="509">
                  <c:v>48.954049763679507</c:v>
                </c:pt>
                <c:pt idx="510">
                  <c:v>45.798649711608846</c:v>
                </c:pt>
                <c:pt idx="511">
                  <c:v>68.731150164604202</c:v>
                </c:pt>
                <c:pt idx="512">
                  <c:v>69.373599915504442</c:v>
                </c:pt>
                <c:pt idx="513">
                  <c:v>42.342799758911156</c:v>
                </c:pt>
                <c:pt idx="514">
                  <c:v>58.476199784278833</c:v>
                </c:pt>
                <c:pt idx="515">
                  <c:v>38.941650037765555</c:v>
                </c:pt>
                <c:pt idx="516">
                  <c:v>46.0398495578766</c:v>
                </c:pt>
                <c:pt idx="517">
                  <c:v>24.255149974822999</c:v>
                </c:pt>
                <c:pt idx="518">
                  <c:v>24.255149974822999</c:v>
                </c:pt>
                <c:pt idx="519">
                  <c:v>66.732149534225456</c:v>
                </c:pt>
                <c:pt idx="520">
                  <c:v>64.426349844932503</c:v>
                </c:pt>
                <c:pt idx="521">
                  <c:v>66.658049912452697</c:v>
                </c:pt>
                <c:pt idx="522">
                  <c:v>62.428049645423897</c:v>
                </c:pt>
                <c:pt idx="523">
                  <c:v>48.003099727630605</c:v>
                </c:pt>
                <c:pt idx="524">
                  <c:v>46.150350313186649</c:v>
                </c:pt>
                <c:pt idx="525">
                  <c:v>69.029249835014298</c:v>
                </c:pt>
                <c:pt idx="526">
                  <c:v>40.608499760627744</c:v>
                </c:pt>
                <c:pt idx="527">
                  <c:v>56.201850171089198</c:v>
                </c:pt>
                <c:pt idx="528">
                  <c:v>69.23255012035365</c:v>
                </c:pt>
                <c:pt idx="529">
                  <c:v>21.550249843597395</c:v>
                </c:pt>
                <c:pt idx="530">
                  <c:v>37.908200159072848</c:v>
                </c:pt>
                <c:pt idx="531">
                  <c:v>38.777750020027142</c:v>
                </c:pt>
                <c:pt idx="532">
                  <c:v>24.528699874877901</c:v>
                </c:pt>
                <c:pt idx="533">
                  <c:v>45.224100198745752</c:v>
                </c:pt>
                <c:pt idx="534">
                  <c:v>38.663799958229049</c:v>
                </c:pt>
                <c:pt idx="535">
                  <c:v>42.724449648857103</c:v>
                </c:pt>
                <c:pt idx="536">
                  <c:v>73.49884997844714</c:v>
                </c:pt>
                <c:pt idx="537">
                  <c:v>54.838349800109839</c:v>
                </c:pt>
                <c:pt idx="538">
                  <c:v>68.495599923133909</c:v>
                </c:pt>
                <c:pt idx="539">
                  <c:v>71.796500382423503</c:v>
                </c:pt>
                <c:pt idx="540">
                  <c:v>44.418149571418752</c:v>
                </c:pt>
                <c:pt idx="541">
                  <c:v>70.238100128173784</c:v>
                </c:pt>
                <c:pt idx="542">
                  <c:v>37.97049985885625</c:v>
                </c:pt>
                <c:pt idx="543">
                  <c:v>44.141999907493549</c:v>
                </c:pt>
                <c:pt idx="544">
                  <c:v>101.79875013828294</c:v>
                </c:pt>
                <c:pt idx="545">
                  <c:v>36.178599853515607</c:v>
                </c:pt>
                <c:pt idx="546">
                  <c:v>60.119799828529395</c:v>
                </c:pt>
                <c:pt idx="547">
                  <c:v>36.819449787139902</c:v>
                </c:pt>
                <c:pt idx="548">
                  <c:v>39.742649650573753</c:v>
                </c:pt>
                <c:pt idx="549">
                  <c:v>52.009649877548199</c:v>
                </c:pt>
                <c:pt idx="550">
                  <c:v>44.409250006675741</c:v>
                </c:pt>
                <c:pt idx="551">
                  <c:v>53.05530002593995</c:v>
                </c:pt>
                <c:pt idx="552">
                  <c:v>56.537250018119849</c:v>
                </c:pt>
                <c:pt idx="553">
                  <c:v>71.248349947929356</c:v>
                </c:pt>
                <c:pt idx="554">
                  <c:v>48.769549636840807</c:v>
                </c:pt>
                <c:pt idx="555">
                  <c:v>50.796199822425905</c:v>
                </c:pt>
                <c:pt idx="556">
                  <c:v>24.123249969482401</c:v>
                </c:pt>
                <c:pt idx="557">
                  <c:v>24.123249969482401</c:v>
                </c:pt>
                <c:pt idx="558">
                  <c:v>37.525399746894848</c:v>
                </c:pt>
                <c:pt idx="559">
                  <c:v>44.981249923706102</c:v>
                </c:pt>
                <c:pt idx="560">
                  <c:v>40.280300030708304</c:v>
                </c:pt>
                <c:pt idx="561">
                  <c:v>43.816649880409258</c:v>
                </c:pt>
                <c:pt idx="562">
                  <c:v>54.518499975204449</c:v>
                </c:pt>
                <c:pt idx="563">
                  <c:v>51.257499904632596</c:v>
                </c:pt>
                <c:pt idx="564">
                  <c:v>38.074849786758399</c:v>
                </c:pt>
                <c:pt idx="565">
                  <c:v>27.660500054359453</c:v>
                </c:pt>
                <c:pt idx="566">
                  <c:v>50.513199882507308</c:v>
                </c:pt>
                <c:pt idx="567">
                  <c:v>77.842799758911056</c:v>
                </c:pt>
                <c:pt idx="568">
                  <c:v>77.726299834251307</c:v>
                </c:pt>
                <c:pt idx="569">
                  <c:v>48.221799993514992</c:v>
                </c:pt>
                <c:pt idx="570">
                  <c:v>43.348850135803204</c:v>
                </c:pt>
                <c:pt idx="571">
                  <c:v>47.74030017852786</c:v>
                </c:pt>
                <c:pt idx="572">
                  <c:v>36.144249782562298</c:v>
                </c:pt>
                <c:pt idx="573">
                  <c:v>47.54804967403409</c:v>
                </c:pt>
                <c:pt idx="574">
                  <c:v>31.834899911880555</c:v>
                </c:pt>
                <c:pt idx="575">
                  <c:v>47.214349746704102</c:v>
                </c:pt>
                <c:pt idx="576">
                  <c:v>51.773349614143299</c:v>
                </c:pt>
                <c:pt idx="577">
                  <c:v>52.710749835968002</c:v>
                </c:pt>
                <c:pt idx="578">
                  <c:v>46.488749566078205</c:v>
                </c:pt>
                <c:pt idx="579">
                  <c:v>43.401949675083095</c:v>
                </c:pt>
                <c:pt idx="580">
                  <c:v>87.007700419425902</c:v>
                </c:pt>
                <c:pt idx="581">
                  <c:v>36.227800045013453</c:v>
                </c:pt>
                <c:pt idx="582">
                  <c:v>71.603500208854854</c:v>
                </c:pt>
                <c:pt idx="583">
                  <c:v>53.108949961662248</c:v>
                </c:pt>
                <c:pt idx="584">
                  <c:v>34.349950227737445</c:v>
                </c:pt>
                <c:pt idx="585">
                  <c:v>36.340249986648544</c:v>
                </c:pt>
                <c:pt idx="586">
                  <c:v>68.73775038719171</c:v>
                </c:pt>
                <c:pt idx="587">
                  <c:v>43.708349804878196</c:v>
                </c:pt>
                <c:pt idx="588">
                  <c:v>50.227150273323105</c:v>
                </c:pt>
                <c:pt idx="589">
                  <c:v>40.601549701690651</c:v>
                </c:pt>
                <c:pt idx="590">
                  <c:v>47.48754993438726</c:v>
                </c:pt>
                <c:pt idx="591">
                  <c:v>54.458150024414053</c:v>
                </c:pt>
                <c:pt idx="592">
                  <c:v>55.686999940872155</c:v>
                </c:pt>
                <c:pt idx="593">
                  <c:v>46.692199835777359</c:v>
                </c:pt>
                <c:pt idx="594">
                  <c:v>37.463499836921642</c:v>
                </c:pt>
                <c:pt idx="595">
                  <c:v>46.132899751663196</c:v>
                </c:pt>
                <c:pt idx="596">
                  <c:v>53.695500020980845</c:v>
                </c:pt>
                <c:pt idx="597">
                  <c:v>34.830249719619744</c:v>
                </c:pt>
                <c:pt idx="598">
                  <c:v>66.445049762725901</c:v>
                </c:pt>
                <c:pt idx="599">
                  <c:v>71.746499667167754</c:v>
                </c:pt>
                <c:pt idx="600">
                  <c:v>42.802550101280247</c:v>
                </c:pt>
                <c:pt idx="601">
                  <c:v>56.489299921989463</c:v>
                </c:pt>
                <c:pt idx="602">
                  <c:v>50.55215045452114</c:v>
                </c:pt>
                <c:pt idx="603">
                  <c:v>49.170150017738358</c:v>
                </c:pt>
                <c:pt idx="604">
                  <c:v>54.336400251388497</c:v>
                </c:pt>
                <c:pt idx="605">
                  <c:v>47.571549863815342</c:v>
                </c:pt>
                <c:pt idx="606">
                  <c:v>52.121299605369593</c:v>
                </c:pt>
                <c:pt idx="607">
                  <c:v>23.32474984169005</c:v>
                </c:pt>
                <c:pt idx="608">
                  <c:v>76.013199934959204</c:v>
                </c:pt>
                <c:pt idx="609">
                  <c:v>47.914600028991643</c:v>
                </c:pt>
                <c:pt idx="610">
                  <c:v>70.088650403022797</c:v>
                </c:pt>
                <c:pt idx="611">
                  <c:v>49.568100004196211</c:v>
                </c:pt>
                <c:pt idx="612">
                  <c:v>62.665649862289399</c:v>
                </c:pt>
                <c:pt idx="613">
                  <c:v>57.060450067520144</c:v>
                </c:pt>
                <c:pt idx="614">
                  <c:v>51.912350077629107</c:v>
                </c:pt>
                <c:pt idx="615">
                  <c:v>58.865250244140604</c:v>
                </c:pt>
                <c:pt idx="616">
                  <c:v>34.338300113677953</c:v>
                </c:pt>
                <c:pt idx="617">
                  <c:v>42.286099581718403</c:v>
                </c:pt>
                <c:pt idx="618">
                  <c:v>69.493199892044103</c:v>
                </c:pt>
                <c:pt idx="619">
                  <c:v>35.458900008201596</c:v>
                </c:pt>
                <c:pt idx="620">
                  <c:v>35.9830000400543</c:v>
                </c:pt>
                <c:pt idx="621">
                  <c:v>66.821199789047242</c:v>
                </c:pt>
                <c:pt idx="622">
                  <c:v>36.6057001161575</c:v>
                </c:pt>
                <c:pt idx="623">
                  <c:v>44.879199981689403</c:v>
                </c:pt>
                <c:pt idx="624">
                  <c:v>38.43814976215365</c:v>
                </c:pt>
                <c:pt idx="625">
                  <c:v>41.684000172615001</c:v>
                </c:pt>
                <c:pt idx="626">
                  <c:v>21.275999712944049</c:v>
                </c:pt>
                <c:pt idx="627">
                  <c:v>39.29029998302461</c:v>
                </c:pt>
                <c:pt idx="628">
                  <c:v>50.487749624252345</c:v>
                </c:pt>
                <c:pt idx="629">
                  <c:v>40.714749736785848</c:v>
                </c:pt>
                <c:pt idx="630">
                  <c:v>45.344100036621093</c:v>
                </c:pt>
                <c:pt idx="631">
                  <c:v>65.894199829101552</c:v>
                </c:pt>
                <c:pt idx="632">
                  <c:v>56.98770022869104</c:v>
                </c:pt>
                <c:pt idx="633">
                  <c:v>40.763200144767801</c:v>
                </c:pt>
                <c:pt idx="634">
                  <c:v>41.759299964904841</c:v>
                </c:pt>
                <c:pt idx="635">
                  <c:v>59.628049950599646</c:v>
                </c:pt>
                <c:pt idx="636">
                  <c:v>45.153799948692352</c:v>
                </c:pt>
                <c:pt idx="637">
                  <c:v>41.446849870681802</c:v>
                </c:pt>
                <c:pt idx="638">
                  <c:v>50.765099635124152</c:v>
                </c:pt>
                <c:pt idx="639">
                  <c:v>47.193299970626811</c:v>
                </c:pt>
                <c:pt idx="640">
                  <c:v>45.332199935913046</c:v>
                </c:pt>
                <c:pt idx="641">
                  <c:v>30.1437999916077</c:v>
                </c:pt>
                <c:pt idx="642">
                  <c:v>31.690250005722049</c:v>
                </c:pt>
                <c:pt idx="643">
                  <c:v>53.695799865722648</c:v>
                </c:pt>
                <c:pt idx="644">
                  <c:v>19.786399974822999</c:v>
                </c:pt>
                <c:pt idx="645">
                  <c:v>19.786399974822999</c:v>
                </c:pt>
                <c:pt idx="646">
                  <c:v>61.502149872779889</c:v>
                </c:pt>
                <c:pt idx="647">
                  <c:v>33.438599839210497</c:v>
                </c:pt>
                <c:pt idx="648">
                  <c:v>45.743149929046652</c:v>
                </c:pt>
                <c:pt idx="649">
                  <c:v>30.732500014305099</c:v>
                </c:pt>
                <c:pt idx="650">
                  <c:v>40.540999727249144</c:v>
                </c:pt>
                <c:pt idx="651">
                  <c:v>35.169199862480198</c:v>
                </c:pt>
                <c:pt idx="652">
                  <c:v>42.980050044059709</c:v>
                </c:pt>
                <c:pt idx="653">
                  <c:v>32.53044988155365</c:v>
                </c:pt>
                <c:pt idx="654">
                  <c:v>39.433700060844451</c:v>
                </c:pt>
                <c:pt idx="655">
                  <c:v>66.116199951171851</c:v>
                </c:pt>
                <c:pt idx="656">
                  <c:v>46.849099860191352</c:v>
                </c:pt>
                <c:pt idx="657">
                  <c:v>70.329350242614751</c:v>
                </c:pt>
                <c:pt idx="658">
                  <c:v>27.711099882125851</c:v>
                </c:pt>
                <c:pt idx="659">
                  <c:v>36.860850028991706</c:v>
                </c:pt>
                <c:pt idx="660">
                  <c:v>41.751949934959448</c:v>
                </c:pt>
                <c:pt idx="661">
                  <c:v>37.972199745178244</c:v>
                </c:pt>
                <c:pt idx="662">
                  <c:v>19.856500084400203</c:v>
                </c:pt>
                <c:pt idx="663">
                  <c:v>41.959599986076348</c:v>
                </c:pt>
                <c:pt idx="664">
                  <c:v>35.892100052833598</c:v>
                </c:pt>
                <c:pt idx="665">
                  <c:v>46.837549719810539</c:v>
                </c:pt>
                <c:pt idx="666">
                  <c:v>42.611349978446995</c:v>
                </c:pt>
                <c:pt idx="667">
                  <c:v>59.049750099182148</c:v>
                </c:pt>
                <c:pt idx="668">
                  <c:v>48.628949446678206</c:v>
                </c:pt>
                <c:pt idx="669">
                  <c:v>33.222700107097602</c:v>
                </c:pt>
                <c:pt idx="670">
                  <c:v>49.980250091552648</c:v>
                </c:pt>
                <c:pt idx="671">
                  <c:v>34.465299735069294</c:v>
                </c:pt>
                <c:pt idx="672">
                  <c:v>22.940899991989149</c:v>
                </c:pt>
                <c:pt idx="673">
                  <c:v>22.940899991989149</c:v>
                </c:pt>
                <c:pt idx="674">
                  <c:v>60.1426500916481</c:v>
                </c:pt>
                <c:pt idx="675">
                  <c:v>39.047300043106048</c:v>
                </c:pt>
                <c:pt idx="676">
                  <c:v>45.832500352859498</c:v>
                </c:pt>
                <c:pt idx="677">
                  <c:v>43.974949660301249</c:v>
                </c:pt>
                <c:pt idx="678">
                  <c:v>30.855599727630644</c:v>
                </c:pt>
                <c:pt idx="679">
                  <c:v>37.926650090217599</c:v>
                </c:pt>
                <c:pt idx="680">
                  <c:v>56.680700125694244</c:v>
                </c:pt>
                <c:pt idx="681">
                  <c:v>42.845849800109853</c:v>
                </c:pt>
                <c:pt idx="682">
                  <c:v>42.072550339698807</c:v>
                </c:pt>
                <c:pt idx="683">
                  <c:v>39.367950062751802</c:v>
                </c:pt>
                <c:pt idx="684">
                  <c:v>42.021750135421797</c:v>
                </c:pt>
                <c:pt idx="685">
                  <c:v>30.601649880409198</c:v>
                </c:pt>
                <c:pt idx="686">
                  <c:v>30.601649880409198</c:v>
                </c:pt>
                <c:pt idx="687">
                  <c:v>45.961499781608588</c:v>
                </c:pt>
                <c:pt idx="688">
                  <c:v>23.233699903488152</c:v>
                </c:pt>
                <c:pt idx="689">
                  <c:v>23.233699903488152</c:v>
                </c:pt>
                <c:pt idx="690">
                  <c:v>52.3629501247406</c:v>
                </c:pt>
                <c:pt idx="691">
                  <c:v>50.345749816894497</c:v>
                </c:pt>
                <c:pt idx="692">
                  <c:v>75.435199933052147</c:v>
                </c:pt>
                <c:pt idx="693">
                  <c:v>47.537599797248902</c:v>
                </c:pt>
                <c:pt idx="694">
                  <c:v>52.80790005207065</c:v>
                </c:pt>
                <c:pt idx="695">
                  <c:v>54.208199787139847</c:v>
                </c:pt>
                <c:pt idx="696">
                  <c:v>49.422249927520802</c:v>
                </c:pt>
                <c:pt idx="697">
                  <c:v>78.087650055885149</c:v>
                </c:pt>
                <c:pt idx="698">
                  <c:v>36.414249753952042</c:v>
                </c:pt>
                <c:pt idx="699">
                  <c:v>40.22169958114619</c:v>
                </c:pt>
                <c:pt idx="700">
                  <c:v>58.976299943923948</c:v>
                </c:pt>
                <c:pt idx="701">
                  <c:v>38.724100046157858</c:v>
                </c:pt>
                <c:pt idx="702">
                  <c:v>44.830949831008951</c:v>
                </c:pt>
                <c:pt idx="703">
                  <c:v>68.338199925422643</c:v>
                </c:pt>
                <c:pt idx="704">
                  <c:v>37.400600066185007</c:v>
                </c:pt>
                <c:pt idx="705">
                  <c:v>37.917700281143254</c:v>
                </c:pt>
                <c:pt idx="706">
                  <c:v>48.729149761199899</c:v>
                </c:pt>
                <c:pt idx="707">
                  <c:v>36.262250008583152</c:v>
                </c:pt>
                <c:pt idx="708">
                  <c:v>44.624600143432652</c:v>
                </c:pt>
                <c:pt idx="709">
                  <c:v>39.2043999624252</c:v>
                </c:pt>
                <c:pt idx="710">
                  <c:v>38.138199925422647</c:v>
                </c:pt>
                <c:pt idx="711">
                  <c:v>39.922299885749851</c:v>
                </c:pt>
                <c:pt idx="712">
                  <c:v>33.100849733352653</c:v>
                </c:pt>
                <c:pt idx="713">
                  <c:v>29.567749671936049</c:v>
                </c:pt>
                <c:pt idx="714">
                  <c:v>39.534699711799647</c:v>
                </c:pt>
                <c:pt idx="715">
                  <c:v>34.7102497386932</c:v>
                </c:pt>
                <c:pt idx="716">
                  <c:v>31.875400061607404</c:v>
                </c:pt>
                <c:pt idx="717">
                  <c:v>53.940799555778511</c:v>
                </c:pt>
                <c:pt idx="718">
                  <c:v>55.743549942970297</c:v>
                </c:pt>
                <c:pt idx="719">
                  <c:v>42.987949728965745</c:v>
                </c:pt>
                <c:pt idx="720">
                  <c:v>44.456300044059702</c:v>
                </c:pt>
                <c:pt idx="721">
                  <c:v>56.61869994640351</c:v>
                </c:pt>
                <c:pt idx="722">
                  <c:v>33.250549931526194</c:v>
                </c:pt>
                <c:pt idx="723">
                  <c:v>69.754449658393895</c:v>
                </c:pt>
                <c:pt idx="724">
                  <c:v>43.962599911689736</c:v>
                </c:pt>
                <c:pt idx="725">
                  <c:v>42.455249962806704</c:v>
                </c:pt>
                <c:pt idx="726">
                  <c:v>29.162999806404095</c:v>
                </c:pt>
                <c:pt idx="727">
                  <c:v>53.212699847221344</c:v>
                </c:pt>
                <c:pt idx="728">
                  <c:v>52.246800127029445</c:v>
                </c:pt>
                <c:pt idx="729">
                  <c:v>43.562099914550807</c:v>
                </c:pt>
                <c:pt idx="730">
                  <c:v>71.362750039100604</c:v>
                </c:pt>
                <c:pt idx="731">
                  <c:v>42.629150099754362</c:v>
                </c:pt>
                <c:pt idx="732">
                  <c:v>46.934600071907056</c:v>
                </c:pt>
                <c:pt idx="733">
                  <c:v>8.3435498428344985</c:v>
                </c:pt>
                <c:pt idx="734">
                  <c:v>38.252199892997702</c:v>
                </c:pt>
                <c:pt idx="735">
                  <c:v>40.737449760437002</c:v>
                </c:pt>
                <c:pt idx="736">
                  <c:v>44.999449834823658</c:v>
                </c:pt>
                <c:pt idx="737">
                  <c:v>65.495699825286849</c:v>
                </c:pt>
                <c:pt idx="738">
                  <c:v>39.595849733352651</c:v>
                </c:pt>
                <c:pt idx="739">
                  <c:v>59.273900127410847</c:v>
                </c:pt>
                <c:pt idx="740">
                  <c:v>65.602799983024539</c:v>
                </c:pt>
                <c:pt idx="741">
                  <c:v>33.090699644088701</c:v>
                </c:pt>
                <c:pt idx="742">
                  <c:v>51.865799698829647</c:v>
                </c:pt>
                <c:pt idx="743">
                  <c:v>32.627900042533852</c:v>
                </c:pt>
                <c:pt idx="744">
                  <c:v>67.513900175094605</c:v>
                </c:pt>
                <c:pt idx="745">
                  <c:v>36.709799728393556</c:v>
                </c:pt>
                <c:pt idx="746">
                  <c:v>73.137049651146057</c:v>
                </c:pt>
                <c:pt idx="747">
                  <c:v>33.880449752807607</c:v>
                </c:pt>
                <c:pt idx="748">
                  <c:v>43.071450181007343</c:v>
                </c:pt>
                <c:pt idx="749">
                  <c:v>41.765900349616999</c:v>
                </c:pt>
                <c:pt idx="750">
                  <c:v>49.829799776077252</c:v>
                </c:pt>
                <c:pt idx="751">
                  <c:v>46.597849798202503</c:v>
                </c:pt>
                <c:pt idx="752">
                  <c:v>33.56545022487645</c:v>
                </c:pt>
                <c:pt idx="753">
                  <c:v>47.412400088310193</c:v>
                </c:pt>
                <c:pt idx="754">
                  <c:v>33.111400017738347</c:v>
                </c:pt>
                <c:pt idx="755">
                  <c:v>54.373250060081496</c:v>
                </c:pt>
                <c:pt idx="756">
                  <c:v>45.640099921226543</c:v>
                </c:pt>
                <c:pt idx="757">
                  <c:v>43.849550185203555</c:v>
                </c:pt>
                <c:pt idx="758">
                  <c:v>74.078450369834897</c:v>
                </c:pt>
                <c:pt idx="759">
                  <c:v>59.954799928665153</c:v>
                </c:pt>
                <c:pt idx="760">
                  <c:v>67.426100172996541</c:v>
                </c:pt>
                <c:pt idx="761">
                  <c:v>40.459299831390346</c:v>
                </c:pt>
                <c:pt idx="762">
                  <c:v>51.03685002326965</c:v>
                </c:pt>
                <c:pt idx="763">
                  <c:v>37.775249986648603</c:v>
                </c:pt>
                <c:pt idx="764">
                  <c:v>45.746849794387849</c:v>
                </c:pt>
                <c:pt idx="765">
                  <c:v>56.151499881744357</c:v>
                </c:pt>
                <c:pt idx="766">
                  <c:v>44.657349634170544</c:v>
                </c:pt>
                <c:pt idx="767">
                  <c:v>40.952650122642503</c:v>
                </c:pt>
                <c:pt idx="768">
                  <c:v>35.577999529838543</c:v>
                </c:pt>
                <c:pt idx="769">
                  <c:v>55.736350083351141</c:v>
                </c:pt>
                <c:pt idx="770">
                  <c:v>35.536799750328051</c:v>
                </c:pt>
                <c:pt idx="771">
                  <c:v>40.832299680709852</c:v>
                </c:pt>
                <c:pt idx="772">
                  <c:v>28.669149990081802</c:v>
                </c:pt>
                <c:pt idx="773">
                  <c:v>33.076999764442448</c:v>
                </c:pt>
                <c:pt idx="774">
                  <c:v>59.804999856948854</c:v>
                </c:pt>
                <c:pt idx="775">
                  <c:v>41.858899965286241</c:v>
                </c:pt>
                <c:pt idx="776">
                  <c:v>34.659749770164503</c:v>
                </c:pt>
                <c:pt idx="777">
                  <c:v>38.547749843597401</c:v>
                </c:pt>
                <c:pt idx="778">
                  <c:v>32.954349851608306</c:v>
                </c:pt>
                <c:pt idx="779">
                  <c:v>58.354199609756499</c:v>
                </c:pt>
                <c:pt idx="780">
                  <c:v>37.567100005149854</c:v>
                </c:pt>
                <c:pt idx="781">
                  <c:v>37.780650091171296</c:v>
                </c:pt>
                <c:pt idx="782">
                  <c:v>45.181899676322956</c:v>
                </c:pt>
                <c:pt idx="783">
                  <c:v>40.207050032615641</c:v>
                </c:pt>
                <c:pt idx="784">
                  <c:v>23.071900138855007</c:v>
                </c:pt>
                <c:pt idx="785">
                  <c:v>36.286899547576901</c:v>
                </c:pt>
                <c:pt idx="786">
                  <c:v>22.539349722862248</c:v>
                </c:pt>
                <c:pt idx="787">
                  <c:v>35.73544991016395</c:v>
                </c:pt>
                <c:pt idx="788">
                  <c:v>55.303100204467697</c:v>
                </c:pt>
                <c:pt idx="789">
                  <c:v>39.669600090980552</c:v>
                </c:pt>
                <c:pt idx="790">
                  <c:v>41.20929998874665</c:v>
                </c:pt>
                <c:pt idx="791">
                  <c:v>68.485399928092932</c:v>
                </c:pt>
                <c:pt idx="792">
                  <c:v>62.899949865341199</c:v>
                </c:pt>
                <c:pt idx="793">
                  <c:v>52.524949636459354</c:v>
                </c:pt>
                <c:pt idx="794">
                  <c:v>33.483899803161648</c:v>
                </c:pt>
                <c:pt idx="795">
                  <c:v>45.496250157356258</c:v>
                </c:pt>
                <c:pt idx="796">
                  <c:v>26.1561998271942</c:v>
                </c:pt>
                <c:pt idx="797">
                  <c:v>53.246149907112148</c:v>
                </c:pt>
                <c:pt idx="798">
                  <c:v>19.961400027275104</c:v>
                </c:pt>
                <c:pt idx="799">
                  <c:v>25.958949899673453</c:v>
                </c:pt>
                <c:pt idx="800">
                  <c:v>25.958949899673453</c:v>
                </c:pt>
                <c:pt idx="801">
                  <c:v>41.205050082206753</c:v>
                </c:pt>
                <c:pt idx="802">
                  <c:v>38.360599770545953</c:v>
                </c:pt>
                <c:pt idx="803">
                  <c:v>22.285099844932549</c:v>
                </c:pt>
                <c:pt idx="804">
                  <c:v>42.474499921798703</c:v>
                </c:pt>
                <c:pt idx="805">
                  <c:v>51.809049987793003</c:v>
                </c:pt>
                <c:pt idx="806">
                  <c:v>38.645599832534799</c:v>
                </c:pt>
                <c:pt idx="807">
                  <c:v>55.889849910736096</c:v>
                </c:pt>
                <c:pt idx="808">
                  <c:v>34.610399947166499</c:v>
                </c:pt>
                <c:pt idx="809">
                  <c:v>50.915199995040851</c:v>
                </c:pt>
                <c:pt idx="810">
                  <c:v>34.24249993801115</c:v>
                </c:pt>
                <c:pt idx="811">
                  <c:v>39.396650199890203</c:v>
                </c:pt>
                <c:pt idx="812">
                  <c:v>46.258499865531896</c:v>
                </c:pt>
                <c:pt idx="813">
                  <c:v>27.7405999612808</c:v>
                </c:pt>
                <c:pt idx="814">
                  <c:v>54.278399958610535</c:v>
                </c:pt>
                <c:pt idx="815">
                  <c:v>12.017850246429447</c:v>
                </c:pt>
                <c:pt idx="816">
                  <c:v>58.442400121688799</c:v>
                </c:pt>
                <c:pt idx="817">
                  <c:v>40.756549715995803</c:v>
                </c:pt>
                <c:pt idx="818">
                  <c:v>45.214999976158154</c:v>
                </c:pt>
                <c:pt idx="819">
                  <c:v>45.031899800300607</c:v>
                </c:pt>
                <c:pt idx="820">
                  <c:v>36.859349884986855</c:v>
                </c:pt>
                <c:pt idx="821">
                  <c:v>76.102250022887944</c:v>
                </c:pt>
                <c:pt idx="822">
                  <c:v>20.7054000759125</c:v>
                </c:pt>
                <c:pt idx="823">
                  <c:v>31.982149634361249</c:v>
                </c:pt>
                <c:pt idx="824">
                  <c:v>40.797199583053555</c:v>
                </c:pt>
                <c:pt idx="825">
                  <c:v>44.6700496816635</c:v>
                </c:pt>
                <c:pt idx="826">
                  <c:v>29.713700203895549</c:v>
                </c:pt>
                <c:pt idx="827">
                  <c:v>29.713700203895549</c:v>
                </c:pt>
                <c:pt idx="828">
                  <c:v>44.515599622726455</c:v>
                </c:pt>
                <c:pt idx="829">
                  <c:v>39.410100111961398</c:v>
                </c:pt>
                <c:pt idx="830">
                  <c:v>19.136400089263894</c:v>
                </c:pt>
                <c:pt idx="831">
                  <c:v>2.9148497152328474</c:v>
                </c:pt>
                <c:pt idx="832">
                  <c:v>37.1336497926712</c:v>
                </c:pt>
                <c:pt idx="833">
                  <c:v>36.393900027275095</c:v>
                </c:pt>
                <c:pt idx="834">
                  <c:v>48.464800090789794</c:v>
                </c:pt>
                <c:pt idx="835">
                  <c:v>46.578299894332901</c:v>
                </c:pt>
                <c:pt idx="836">
                  <c:v>50.438849921226492</c:v>
                </c:pt>
                <c:pt idx="837">
                  <c:v>36.918249630928052</c:v>
                </c:pt>
                <c:pt idx="838">
                  <c:v>52.400700230598396</c:v>
                </c:pt>
                <c:pt idx="839">
                  <c:v>36.006499967575095</c:v>
                </c:pt>
                <c:pt idx="840">
                  <c:v>37.538849906921399</c:v>
                </c:pt>
                <c:pt idx="841">
                  <c:v>45.955149834156011</c:v>
                </c:pt>
                <c:pt idx="842">
                  <c:v>29.176100072860706</c:v>
                </c:pt>
                <c:pt idx="843">
                  <c:v>30.750549840927103</c:v>
                </c:pt>
                <c:pt idx="844">
                  <c:v>50.030199904441858</c:v>
                </c:pt>
                <c:pt idx="845">
                  <c:v>32.934249973297156</c:v>
                </c:pt>
                <c:pt idx="846">
                  <c:v>47.213399949073803</c:v>
                </c:pt>
                <c:pt idx="847">
                  <c:v>41.770899844169598</c:v>
                </c:pt>
                <c:pt idx="848">
                  <c:v>35.438649706840501</c:v>
                </c:pt>
                <c:pt idx="849">
                  <c:v>25.45689994335175</c:v>
                </c:pt>
                <c:pt idx="850">
                  <c:v>32.2529498624802</c:v>
                </c:pt>
                <c:pt idx="851">
                  <c:v>29.127999734878546</c:v>
                </c:pt>
                <c:pt idx="852">
                  <c:v>35.040450024604795</c:v>
                </c:pt>
                <c:pt idx="853">
                  <c:v>42.840449895858747</c:v>
                </c:pt>
                <c:pt idx="854">
                  <c:v>23.707549772262553</c:v>
                </c:pt>
                <c:pt idx="855">
                  <c:v>45.423799829483002</c:v>
                </c:pt>
                <c:pt idx="856">
                  <c:v>36.105200076103202</c:v>
                </c:pt>
                <c:pt idx="857">
                  <c:v>33.956549901962305</c:v>
                </c:pt>
                <c:pt idx="858">
                  <c:v>38.750299911498999</c:v>
                </c:pt>
                <c:pt idx="859">
                  <c:v>23.124949979782151</c:v>
                </c:pt>
                <c:pt idx="860">
                  <c:v>45.419699978828454</c:v>
                </c:pt>
                <c:pt idx="861">
                  <c:v>38.650049948692299</c:v>
                </c:pt>
                <c:pt idx="862">
                  <c:v>49.007599892616241</c:v>
                </c:pt>
                <c:pt idx="863">
                  <c:v>49.314050269126852</c:v>
                </c:pt>
                <c:pt idx="864">
                  <c:v>43.955300130844101</c:v>
                </c:pt>
                <c:pt idx="865">
                  <c:v>36.717399549484249</c:v>
                </c:pt>
                <c:pt idx="866">
                  <c:v>39.593449974060007</c:v>
                </c:pt>
                <c:pt idx="867">
                  <c:v>34.337899956703254</c:v>
                </c:pt>
                <c:pt idx="868">
                  <c:v>40.299000091552756</c:v>
                </c:pt>
                <c:pt idx="869">
                  <c:v>24.810800218582145</c:v>
                </c:pt>
                <c:pt idx="870">
                  <c:v>47.043450036048903</c:v>
                </c:pt>
                <c:pt idx="871">
                  <c:v>32.507699666023242</c:v>
                </c:pt>
                <c:pt idx="872">
                  <c:v>47.722699780464204</c:v>
                </c:pt>
                <c:pt idx="873">
                  <c:v>42.512599864006056</c:v>
                </c:pt>
                <c:pt idx="874">
                  <c:v>23.944350042343153</c:v>
                </c:pt>
                <c:pt idx="875">
                  <c:v>38.71954967021945</c:v>
                </c:pt>
                <c:pt idx="876">
                  <c:v>35.255199532508847</c:v>
                </c:pt>
                <c:pt idx="877">
                  <c:v>32.647299909591709</c:v>
                </c:pt>
                <c:pt idx="878">
                  <c:v>35.154699764251703</c:v>
                </c:pt>
                <c:pt idx="879">
                  <c:v>23.595699844360347</c:v>
                </c:pt>
                <c:pt idx="880">
                  <c:v>23.595699844360347</c:v>
                </c:pt>
                <c:pt idx="881">
                  <c:v>39.113850069046002</c:v>
                </c:pt>
                <c:pt idx="882">
                  <c:v>43.645150022506705</c:v>
                </c:pt>
                <c:pt idx="883">
                  <c:v>35.115249896049548</c:v>
                </c:pt>
                <c:pt idx="884">
                  <c:v>50.51529972553255</c:v>
                </c:pt>
                <c:pt idx="885">
                  <c:v>46.921249532699548</c:v>
                </c:pt>
                <c:pt idx="886">
                  <c:v>46.209299869537304</c:v>
                </c:pt>
                <c:pt idx="887">
                  <c:v>54.968849849700902</c:v>
                </c:pt>
                <c:pt idx="888">
                  <c:v>32.281549777984601</c:v>
                </c:pt>
                <c:pt idx="889">
                  <c:v>32.026499991416948</c:v>
                </c:pt>
                <c:pt idx="890">
                  <c:v>43.619199905395448</c:v>
                </c:pt>
                <c:pt idx="891">
                  <c:v>46.037899851799047</c:v>
                </c:pt>
                <c:pt idx="892">
                  <c:v>36.475149941444357</c:v>
                </c:pt>
                <c:pt idx="893">
                  <c:v>42.043999915122946</c:v>
                </c:pt>
                <c:pt idx="894">
                  <c:v>47.617099914550806</c:v>
                </c:pt>
                <c:pt idx="895">
                  <c:v>29.335200080871601</c:v>
                </c:pt>
                <c:pt idx="896">
                  <c:v>40.072749772071802</c:v>
                </c:pt>
                <c:pt idx="897">
                  <c:v>41.391899757385254</c:v>
                </c:pt>
                <c:pt idx="898">
                  <c:v>44.765399913787803</c:v>
                </c:pt>
                <c:pt idx="899">
                  <c:v>39.701749911308298</c:v>
                </c:pt>
                <c:pt idx="900">
                  <c:v>53.838499855995153</c:v>
                </c:pt>
                <c:pt idx="901">
                  <c:v>34.344799957275399</c:v>
                </c:pt>
                <c:pt idx="902">
                  <c:v>43.633399930000252</c:v>
                </c:pt>
                <c:pt idx="903">
                  <c:v>54.4345499134064</c:v>
                </c:pt>
                <c:pt idx="904">
                  <c:v>36.016600074768057</c:v>
                </c:pt>
                <c:pt idx="905">
                  <c:v>39.661449866294845</c:v>
                </c:pt>
                <c:pt idx="906">
                  <c:v>40.15479983806604</c:v>
                </c:pt>
                <c:pt idx="907">
                  <c:v>53.275000014305093</c:v>
                </c:pt>
                <c:pt idx="908">
                  <c:v>35.034650001525947</c:v>
                </c:pt>
                <c:pt idx="909">
                  <c:v>42.636499652862504</c:v>
                </c:pt>
                <c:pt idx="910">
                  <c:v>27.2101501369476</c:v>
                </c:pt>
                <c:pt idx="911">
                  <c:v>35.429149951934804</c:v>
                </c:pt>
                <c:pt idx="912">
                  <c:v>44.003749938011197</c:v>
                </c:pt>
                <c:pt idx="913">
                  <c:v>45.647349748611454</c:v>
                </c:pt>
                <c:pt idx="914">
                  <c:v>37.440300006866451</c:v>
                </c:pt>
                <c:pt idx="915">
                  <c:v>54.273499507904035</c:v>
                </c:pt>
                <c:pt idx="916">
                  <c:v>26.125499801635755</c:v>
                </c:pt>
                <c:pt idx="917">
                  <c:v>17.781450018882708</c:v>
                </c:pt>
                <c:pt idx="918">
                  <c:v>31.710150194168154</c:v>
                </c:pt>
                <c:pt idx="919">
                  <c:v>38.128450150489755</c:v>
                </c:pt>
                <c:pt idx="920">
                  <c:v>43.528749723434395</c:v>
                </c:pt>
                <c:pt idx="921">
                  <c:v>55.546750130653351</c:v>
                </c:pt>
                <c:pt idx="922">
                  <c:v>37.790799837112395</c:v>
                </c:pt>
                <c:pt idx="923">
                  <c:v>42.0427003240586</c:v>
                </c:pt>
                <c:pt idx="924">
                  <c:v>56.683149795532245</c:v>
                </c:pt>
                <c:pt idx="925">
                  <c:v>46.8696997785568</c:v>
                </c:pt>
                <c:pt idx="926">
                  <c:v>32.941549534797701</c:v>
                </c:pt>
                <c:pt idx="927">
                  <c:v>40.721049733161898</c:v>
                </c:pt>
                <c:pt idx="928">
                  <c:v>40.159499955177303</c:v>
                </c:pt>
                <c:pt idx="929">
                  <c:v>40.111400070190442</c:v>
                </c:pt>
                <c:pt idx="930">
                  <c:v>44.804049630165096</c:v>
                </c:pt>
                <c:pt idx="931">
                  <c:v>45.137799949645995</c:v>
                </c:pt>
                <c:pt idx="932">
                  <c:v>38.611100163459803</c:v>
                </c:pt>
                <c:pt idx="933">
                  <c:v>58.001649765968246</c:v>
                </c:pt>
                <c:pt idx="934">
                  <c:v>36.750299773216256</c:v>
                </c:pt>
                <c:pt idx="935">
                  <c:v>31.537750167846646</c:v>
                </c:pt>
                <c:pt idx="936">
                  <c:v>41.755550050735494</c:v>
                </c:pt>
                <c:pt idx="937">
                  <c:v>36.626599822044348</c:v>
                </c:pt>
                <c:pt idx="938">
                  <c:v>32.956999912261999</c:v>
                </c:pt>
                <c:pt idx="939">
                  <c:v>40.778800168037449</c:v>
                </c:pt>
                <c:pt idx="940">
                  <c:v>29.011499848365744</c:v>
                </c:pt>
                <c:pt idx="941">
                  <c:v>43.217749862670907</c:v>
                </c:pt>
                <c:pt idx="942">
                  <c:v>40.323699722290044</c:v>
                </c:pt>
                <c:pt idx="943">
                  <c:v>19.626500244140654</c:v>
                </c:pt>
                <c:pt idx="944">
                  <c:v>30.717550053596501</c:v>
                </c:pt>
                <c:pt idx="945">
                  <c:v>27.784149904251095</c:v>
                </c:pt>
                <c:pt idx="946">
                  <c:v>32.28194981098175</c:v>
                </c:pt>
                <c:pt idx="947">
                  <c:v>31.776399788856502</c:v>
                </c:pt>
                <c:pt idx="948">
                  <c:v>33.788699936866749</c:v>
                </c:pt>
                <c:pt idx="949">
                  <c:v>28.975299842357657</c:v>
                </c:pt>
                <c:pt idx="950">
                  <c:v>36.387099499702501</c:v>
                </c:pt>
                <c:pt idx="951">
                  <c:v>24.987850089073198</c:v>
                </c:pt>
                <c:pt idx="952">
                  <c:v>24.987850089073198</c:v>
                </c:pt>
                <c:pt idx="953">
                  <c:v>23.403849921226445</c:v>
                </c:pt>
                <c:pt idx="954">
                  <c:v>47.64164988994596</c:v>
                </c:pt>
                <c:pt idx="955">
                  <c:v>46.978449769020102</c:v>
                </c:pt>
                <c:pt idx="956">
                  <c:v>24.559700102806048</c:v>
                </c:pt>
                <c:pt idx="957">
                  <c:v>32.935099806785601</c:v>
                </c:pt>
                <c:pt idx="958">
                  <c:v>41.184099798202496</c:v>
                </c:pt>
                <c:pt idx="959">
                  <c:v>37.941950206756601</c:v>
                </c:pt>
                <c:pt idx="960">
                  <c:v>29.952600035667452</c:v>
                </c:pt>
                <c:pt idx="961">
                  <c:v>43.262649717330945</c:v>
                </c:pt>
                <c:pt idx="962">
                  <c:v>36.304749965667753</c:v>
                </c:pt>
                <c:pt idx="963">
                  <c:v>34.836099910736102</c:v>
                </c:pt>
                <c:pt idx="964">
                  <c:v>28.046649723052948</c:v>
                </c:pt>
                <c:pt idx="965">
                  <c:v>26.018349914550754</c:v>
                </c:pt>
                <c:pt idx="966">
                  <c:v>44.114400153160162</c:v>
                </c:pt>
                <c:pt idx="967">
                  <c:v>18.560649938583403</c:v>
                </c:pt>
                <c:pt idx="968">
                  <c:v>57.376399846077007</c:v>
                </c:pt>
                <c:pt idx="969">
                  <c:v>31.164649991989105</c:v>
                </c:pt>
                <c:pt idx="970">
                  <c:v>31.130000195503246</c:v>
                </c:pt>
                <c:pt idx="971">
                  <c:v>27.711199870109599</c:v>
                </c:pt>
                <c:pt idx="972">
                  <c:v>27.711199870109599</c:v>
                </c:pt>
                <c:pt idx="973">
                  <c:v>35.971349935531599</c:v>
                </c:pt>
                <c:pt idx="974">
                  <c:v>41.167749466896048</c:v>
                </c:pt>
                <c:pt idx="975">
                  <c:v>59.479149804115352</c:v>
                </c:pt>
                <c:pt idx="976">
                  <c:v>30.117449817657452</c:v>
                </c:pt>
                <c:pt idx="977">
                  <c:v>43.184599914550759</c:v>
                </c:pt>
                <c:pt idx="978">
                  <c:v>45.605749702453643</c:v>
                </c:pt>
                <c:pt idx="979">
                  <c:v>36.852200102806052</c:v>
                </c:pt>
                <c:pt idx="980">
                  <c:v>52.181899843215902</c:v>
                </c:pt>
                <c:pt idx="981">
                  <c:v>34.805150060653645</c:v>
                </c:pt>
                <c:pt idx="982">
                  <c:v>55.510949864387506</c:v>
                </c:pt>
                <c:pt idx="983">
                  <c:v>41.264999914169302</c:v>
                </c:pt>
                <c:pt idx="984">
                  <c:v>29.37465010166175</c:v>
                </c:pt>
                <c:pt idx="985">
                  <c:v>21.437200131416347</c:v>
                </c:pt>
                <c:pt idx="986">
                  <c:v>34.567699823379499</c:v>
                </c:pt>
                <c:pt idx="987">
                  <c:v>36.200799980163602</c:v>
                </c:pt>
                <c:pt idx="988">
                  <c:v>21.456699972152748</c:v>
                </c:pt>
                <c:pt idx="989">
                  <c:v>21.456699972152748</c:v>
                </c:pt>
                <c:pt idx="990">
                  <c:v>25.161800088882455</c:v>
                </c:pt>
                <c:pt idx="991">
                  <c:v>20.955350027084346</c:v>
                </c:pt>
                <c:pt idx="992">
                  <c:v>33.269299793243398</c:v>
                </c:pt>
                <c:pt idx="993">
                  <c:v>42.871949601173398</c:v>
                </c:pt>
                <c:pt idx="994">
                  <c:v>23.652550377845749</c:v>
                </c:pt>
                <c:pt idx="995">
                  <c:v>27.593799920082098</c:v>
                </c:pt>
                <c:pt idx="996">
                  <c:v>63.247450275421144</c:v>
                </c:pt>
                <c:pt idx="997">
                  <c:v>34.130999889373754</c:v>
                </c:pt>
                <c:pt idx="998">
                  <c:v>49.793849868774402</c:v>
                </c:pt>
                <c:pt idx="999">
                  <c:v>52.256499710083006</c:v>
                </c:pt>
                <c:pt idx="1000">
                  <c:v>33.522449812889093</c:v>
                </c:pt>
                <c:pt idx="1001">
                  <c:v>25.207899880409251</c:v>
                </c:pt>
                <c:pt idx="1002">
                  <c:v>37.699649825096145</c:v>
                </c:pt>
                <c:pt idx="1003">
                  <c:v>48.709249596595754</c:v>
                </c:pt>
                <c:pt idx="1004">
                  <c:v>38.702499938011144</c:v>
                </c:pt>
                <c:pt idx="1005">
                  <c:v>18.565000064373052</c:v>
                </c:pt>
                <c:pt idx="1006">
                  <c:v>39.255499911308249</c:v>
                </c:pt>
                <c:pt idx="1007">
                  <c:v>34.398949971199045</c:v>
                </c:pt>
                <c:pt idx="1008">
                  <c:v>42.903700017929054</c:v>
                </c:pt>
                <c:pt idx="1009">
                  <c:v>27.462700037956196</c:v>
                </c:pt>
                <c:pt idx="1010">
                  <c:v>47.185849852561944</c:v>
                </c:pt>
                <c:pt idx="1011">
                  <c:v>32.783300085067751</c:v>
                </c:pt>
                <c:pt idx="1012">
                  <c:v>24.388700060844442</c:v>
                </c:pt>
                <c:pt idx="1013">
                  <c:v>42.016799950599648</c:v>
                </c:pt>
                <c:pt idx="1014">
                  <c:v>36.297299757003806</c:v>
                </c:pt>
                <c:pt idx="1015">
                  <c:v>64.415150089263889</c:v>
                </c:pt>
                <c:pt idx="1016">
                  <c:v>33.066399879455545</c:v>
                </c:pt>
                <c:pt idx="1017">
                  <c:v>37.968799815177903</c:v>
                </c:pt>
                <c:pt idx="1018">
                  <c:v>28.501900148391698</c:v>
                </c:pt>
                <c:pt idx="1019">
                  <c:v>31.015250024795549</c:v>
                </c:pt>
                <c:pt idx="1020">
                  <c:v>46.708799877166797</c:v>
                </c:pt>
                <c:pt idx="1021">
                  <c:v>32.587599945068348</c:v>
                </c:pt>
                <c:pt idx="1022">
                  <c:v>58.083649997711206</c:v>
                </c:pt>
                <c:pt idx="1023">
                  <c:v>29.250199751853998</c:v>
                </c:pt>
                <c:pt idx="1024">
                  <c:v>52.468299689292891</c:v>
                </c:pt>
                <c:pt idx="1025">
                  <c:v>31.854100079536401</c:v>
                </c:pt>
                <c:pt idx="1026">
                  <c:v>49.538549671173101</c:v>
                </c:pt>
                <c:pt idx="1027">
                  <c:v>57.279300093650789</c:v>
                </c:pt>
                <c:pt idx="1028">
                  <c:v>45.539949970245353</c:v>
                </c:pt>
                <c:pt idx="1029">
                  <c:v>30.663350033760047</c:v>
                </c:pt>
                <c:pt idx="1030">
                  <c:v>35.514649934768698</c:v>
                </c:pt>
                <c:pt idx="1031">
                  <c:v>21.600249872207648</c:v>
                </c:pt>
                <c:pt idx="1032">
                  <c:v>27.787249960899352</c:v>
                </c:pt>
                <c:pt idx="1033">
                  <c:v>28.128550205230706</c:v>
                </c:pt>
                <c:pt idx="1034">
                  <c:v>31.917149968147299</c:v>
                </c:pt>
                <c:pt idx="1035">
                  <c:v>32.235849947929353</c:v>
                </c:pt>
                <c:pt idx="1036">
                  <c:v>41.244199862480144</c:v>
                </c:pt>
                <c:pt idx="1037">
                  <c:v>28.106149892806954</c:v>
                </c:pt>
                <c:pt idx="1038">
                  <c:v>28.478949384689351</c:v>
                </c:pt>
                <c:pt idx="1039">
                  <c:v>35.314199748039243</c:v>
                </c:pt>
                <c:pt idx="1040">
                  <c:v>45.908850054740846</c:v>
                </c:pt>
                <c:pt idx="1041">
                  <c:v>26.999699640274049</c:v>
                </c:pt>
                <c:pt idx="1042">
                  <c:v>28.687049722671553</c:v>
                </c:pt>
                <c:pt idx="1043">
                  <c:v>44.941099796295248</c:v>
                </c:pt>
                <c:pt idx="1044">
                  <c:v>39.363100309371951</c:v>
                </c:pt>
                <c:pt idx="1045">
                  <c:v>23.897049994468695</c:v>
                </c:pt>
                <c:pt idx="1046">
                  <c:v>26.970149860382101</c:v>
                </c:pt>
                <c:pt idx="1047">
                  <c:v>29.28429996967315</c:v>
                </c:pt>
                <c:pt idx="1048">
                  <c:v>36.5356999540329</c:v>
                </c:pt>
                <c:pt idx="1049">
                  <c:v>32.147299785614052</c:v>
                </c:pt>
                <c:pt idx="1050">
                  <c:v>36.261600041389499</c:v>
                </c:pt>
                <c:pt idx="1051">
                  <c:v>24.377199773788455</c:v>
                </c:pt>
                <c:pt idx="1052">
                  <c:v>31.222099785804801</c:v>
                </c:pt>
                <c:pt idx="1053">
                  <c:v>37.623699650764458</c:v>
                </c:pt>
                <c:pt idx="1054">
                  <c:v>41.735450067520098</c:v>
                </c:pt>
                <c:pt idx="1055">
                  <c:v>23.125100154876748</c:v>
                </c:pt>
                <c:pt idx="1056">
                  <c:v>30.315500187873852</c:v>
                </c:pt>
                <c:pt idx="1057">
                  <c:v>18.594349994659396</c:v>
                </c:pt>
                <c:pt idx="1058">
                  <c:v>28.6781499147415</c:v>
                </c:pt>
                <c:pt idx="1059">
                  <c:v>29.514249830246001</c:v>
                </c:pt>
                <c:pt idx="1060">
                  <c:v>26.40905007362365</c:v>
                </c:pt>
                <c:pt idx="1061">
                  <c:v>23.604199721813199</c:v>
                </c:pt>
                <c:pt idx="1062">
                  <c:v>23.604199721813199</c:v>
                </c:pt>
                <c:pt idx="1063">
                  <c:v>38.6418499040604</c:v>
                </c:pt>
                <c:pt idx="1064">
                  <c:v>29.847599740028407</c:v>
                </c:pt>
                <c:pt idx="1065">
                  <c:v>30.118449912071256</c:v>
                </c:pt>
                <c:pt idx="1066">
                  <c:v>21.390949897766141</c:v>
                </c:pt>
                <c:pt idx="1067">
                  <c:v>37.604499816894553</c:v>
                </c:pt>
                <c:pt idx="1068">
                  <c:v>41.649100027084351</c:v>
                </c:pt>
                <c:pt idx="1069">
                  <c:v>21.494449977874702</c:v>
                </c:pt>
                <c:pt idx="1070">
                  <c:v>21.494449977874702</c:v>
                </c:pt>
                <c:pt idx="1071">
                  <c:v>30.488049979209848</c:v>
                </c:pt>
                <c:pt idx="1072">
                  <c:v>37.382299737930296</c:v>
                </c:pt>
                <c:pt idx="1073">
                  <c:v>46.673349423408496</c:v>
                </c:pt>
                <c:pt idx="1074">
                  <c:v>30.084299983978248</c:v>
                </c:pt>
                <c:pt idx="1075">
                  <c:v>25.518000149726845</c:v>
                </c:pt>
                <c:pt idx="1076">
                  <c:v>12.788199791908248</c:v>
                </c:pt>
                <c:pt idx="1077">
                  <c:v>38.208949933052054</c:v>
                </c:pt>
                <c:pt idx="1078">
                  <c:v>36.721500029563899</c:v>
                </c:pt>
                <c:pt idx="1079">
                  <c:v>36.840749964714099</c:v>
                </c:pt>
                <c:pt idx="1080">
                  <c:v>29.3859998035431</c:v>
                </c:pt>
                <c:pt idx="1081">
                  <c:v>32.7522000026703</c:v>
                </c:pt>
                <c:pt idx="1082">
                  <c:v>44.571749854087855</c:v>
                </c:pt>
                <c:pt idx="1083">
                  <c:v>50.228799667358402</c:v>
                </c:pt>
                <c:pt idx="1084">
                  <c:v>32.828350124359105</c:v>
                </c:pt>
                <c:pt idx="1085">
                  <c:v>37.889899740219107</c:v>
                </c:pt>
                <c:pt idx="1086">
                  <c:v>29.822649784088149</c:v>
                </c:pt>
                <c:pt idx="1087">
                  <c:v>36.068450031280491</c:v>
                </c:pt>
                <c:pt idx="1088">
                  <c:v>43.309199724197398</c:v>
                </c:pt>
                <c:pt idx="1089">
                  <c:v>25.706649937629699</c:v>
                </c:pt>
                <c:pt idx="1090">
                  <c:v>12.600200138092049</c:v>
                </c:pt>
                <c:pt idx="1091">
                  <c:v>30.598399887084952</c:v>
                </c:pt>
                <c:pt idx="1092">
                  <c:v>28.221800155639652</c:v>
                </c:pt>
                <c:pt idx="1093">
                  <c:v>37.7341001224518</c:v>
                </c:pt>
                <c:pt idx="1094">
                  <c:v>39.618849945068348</c:v>
                </c:pt>
                <c:pt idx="1095">
                  <c:v>46.959699630737362</c:v>
                </c:pt>
                <c:pt idx="1096">
                  <c:v>40.040099949836701</c:v>
                </c:pt>
                <c:pt idx="1097">
                  <c:v>32.150049734115598</c:v>
                </c:pt>
                <c:pt idx="1098">
                  <c:v>24.5132499408722</c:v>
                </c:pt>
                <c:pt idx="1099">
                  <c:v>24.5132499408722</c:v>
                </c:pt>
                <c:pt idx="1100">
                  <c:v>45.188750038146992</c:v>
                </c:pt>
                <c:pt idx="1101">
                  <c:v>39.592499799728401</c:v>
                </c:pt>
                <c:pt idx="1102">
                  <c:v>25.782749800682051</c:v>
                </c:pt>
                <c:pt idx="1103">
                  <c:v>29.923699688911451</c:v>
                </c:pt>
                <c:pt idx="1104">
                  <c:v>25.714800238609246</c:v>
                </c:pt>
                <c:pt idx="1105">
                  <c:v>46.287499938011194</c:v>
                </c:pt>
                <c:pt idx="1106">
                  <c:v>34.078000054359457</c:v>
                </c:pt>
                <c:pt idx="1107">
                  <c:v>27.914199891090455</c:v>
                </c:pt>
                <c:pt idx="1108">
                  <c:v>25.066499896049496</c:v>
                </c:pt>
                <c:pt idx="1109">
                  <c:v>24.307800006866451</c:v>
                </c:pt>
                <c:pt idx="1110">
                  <c:v>34.399150090217645</c:v>
                </c:pt>
                <c:pt idx="1111">
                  <c:v>29.646949858665501</c:v>
                </c:pt>
                <c:pt idx="1112">
                  <c:v>25.198449831008901</c:v>
                </c:pt>
                <c:pt idx="1113">
                  <c:v>31.977849798202499</c:v>
                </c:pt>
                <c:pt idx="1114">
                  <c:v>16.536549968719505</c:v>
                </c:pt>
                <c:pt idx="1115">
                  <c:v>30.993099932670599</c:v>
                </c:pt>
                <c:pt idx="1116">
                  <c:v>32.002449717521657</c:v>
                </c:pt>
                <c:pt idx="1117">
                  <c:v>31.396549921035749</c:v>
                </c:pt>
                <c:pt idx="1118">
                  <c:v>36.252949538230851</c:v>
                </c:pt>
                <c:pt idx="1119">
                  <c:v>33.41374986171725</c:v>
                </c:pt>
                <c:pt idx="1120">
                  <c:v>28.490449852943399</c:v>
                </c:pt>
                <c:pt idx="1121">
                  <c:v>30.1286998271942</c:v>
                </c:pt>
                <c:pt idx="1122">
                  <c:v>24.220299758911104</c:v>
                </c:pt>
                <c:pt idx="1123">
                  <c:v>24.220299758911104</c:v>
                </c:pt>
                <c:pt idx="1124">
                  <c:v>43.111400151252752</c:v>
                </c:pt>
                <c:pt idx="1125">
                  <c:v>38.611100087165802</c:v>
                </c:pt>
                <c:pt idx="1126">
                  <c:v>41.411399660110504</c:v>
                </c:pt>
                <c:pt idx="1127">
                  <c:v>23.853799896240254</c:v>
                </c:pt>
                <c:pt idx="1128">
                  <c:v>25.439049782753003</c:v>
                </c:pt>
                <c:pt idx="1129">
                  <c:v>47.130699820518444</c:v>
                </c:pt>
                <c:pt idx="1130">
                  <c:v>42.613749861717196</c:v>
                </c:pt>
                <c:pt idx="1131">
                  <c:v>15.585750265121451</c:v>
                </c:pt>
                <c:pt idx="1132">
                  <c:v>17.671950082778899</c:v>
                </c:pt>
                <c:pt idx="1133">
                  <c:v>30.120800094604505</c:v>
                </c:pt>
                <c:pt idx="1134">
                  <c:v>35.202700014114399</c:v>
                </c:pt>
                <c:pt idx="1135">
                  <c:v>46.438550066947904</c:v>
                </c:pt>
                <c:pt idx="1136">
                  <c:v>36.183899827003444</c:v>
                </c:pt>
                <c:pt idx="1137">
                  <c:v>40.419799900054947</c:v>
                </c:pt>
                <c:pt idx="1138">
                  <c:v>33.631849880218496</c:v>
                </c:pt>
                <c:pt idx="1139">
                  <c:v>24.208649697303755</c:v>
                </c:pt>
                <c:pt idx="1140">
                  <c:v>28.578550038337752</c:v>
                </c:pt>
                <c:pt idx="1141">
                  <c:v>24.929999899864249</c:v>
                </c:pt>
                <c:pt idx="1142">
                  <c:v>19.976449918747001</c:v>
                </c:pt>
                <c:pt idx="1143">
                  <c:v>18.072000236511254</c:v>
                </c:pt>
                <c:pt idx="1144">
                  <c:v>33.676399912834199</c:v>
                </c:pt>
                <c:pt idx="1145">
                  <c:v>37.800499792099004</c:v>
                </c:pt>
                <c:pt idx="1146">
                  <c:v>29.820050382614099</c:v>
                </c:pt>
                <c:pt idx="1147">
                  <c:v>29.433899850845254</c:v>
                </c:pt>
                <c:pt idx="1148">
                  <c:v>37.693799662590102</c:v>
                </c:pt>
                <c:pt idx="1149">
                  <c:v>35.234099926948552</c:v>
                </c:pt>
                <c:pt idx="1150">
                  <c:v>38.32865025520325</c:v>
                </c:pt>
                <c:pt idx="1151">
                  <c:v>43.676649894714345</c:v>
                </c:pt>
                <c:pt idx="1152">
                  <c:v>30.66884971618655</c:v>
                </c:pt>
                <c:pt idx="1153">
                  <c:v>24.459999899864201</c:v>
                </c:pt>
                <c:pt idx="1154">
                  <c:v>40.143849911689799</c:v>
                </c:pt>
                <c:pt idx="1155">
                  <c:v>40.292650027275052</c:v>
                </c:pt>
                <c:pt idx="1156">
                  <c:v>46.233449797630307</c:v>
                </c:pt>
                <c:pt idx="1157">
                  <c:v>51.359300174713148</c:v>
                </c:pt>
                <c:pt idx="1158">
                  <c:v>29.441199946403497</c:v>
                </c:pt>
                <c:pt idx="1159">
                  <c:v>33.551049795150753</c:v>
                </c:pt>
                <c:pt idx="1160">
                  <c:v>43.911449952125551</c:v>
                </c:pt>
                <c:pt idx="1161">
                  <c:v>29.53714984893795</c:v>
                </c:pt>
                <c:pt idx="1162">
                  <c:v>25.219250140190105</c:v>
                </c:pt>
                <c:pt idx="1163">
                  <c:v>23.018999910354601</c:v>
                </c:pt>
                <c:pt idx="1164">
                  <c:v>27.923100037574798</c:v>
                </c:pt>
                <c:pt idx="1165">
                  <c:v>41.720199627876305</c:v>
                </c:pt>
                <c:pt idx="1166">
                  <c:v>21.024750347137449</c:v>
                </c:pt>
                <c:pt idx="1167">
                  <c:v>26.946449804306049</c:v>
                </c:pt>
                <c:pt idx="1168">
                  <c:v>37.393199830055252</c:v>
                </c:pt>
                <c:pt idx="1169">
                  <c:v>49.063649802207948</c:v>
                </c:pt>
                <c:pt idx="1170">
                  <c:v>32.748549761772203</c:v>
                </c:pt>
                <c:pt idx="1171">
                  <c:v>26.764599952697797</c:v>
                </c:pt>
                <c:pt idx="1172">
                  <c:v>26.764599952697797</c:v>
                </c:pt>
                <c:pt idx="1173">
                  <c:v>26.991799907684346</c:v>
                </c:pt>
                <c:pt idx="1174">
                  <c:v>32.183399972915652</c:v>
                </c:pt>
                <c:pt idx="1175">
                  <c:v>29.919049744606049</c:v>
                </c:pt>
                <c:pt idx="1176">
                  <c:v>63.936750273704554</c:v>
                </c:pt>
                <c:pt idx="1177">
                  <c:v>24.076899905204797</c:v>
                </c:pt>
                <c:pt idx="1178">
                  <c:v>37.114400014877305</c:v>
                </c:pt>
                <c:pt idx="1179">
                  <c:v>24.128049874305745</c:v>
                </c:pt>
                <c:pt idx="1180">
                  <c:v>24.128049874305745</c:v>
                </c:pt>
                <c:pt idx="1181">
                  <c:v>43.417550129890394</c:v>
                </c:pt>
                <c:pt idx="1182">
                  <c:v>25.126049823761008</c:v>
                </c:pt>
                <c:pt idx="1183">
                  <c:v>44.293900008201604</c:v>
                </c:pt>
                <c:pt idx="1184">
                  <c:v>26.473599796295154</c:v>
                </c:pt>
                <c:pt idx="1185">
                  <c:v>26.473599796295154</c:v>
                </c:pt>
                <c:pt idx="1186">
                  <c:v>7.2565999889374453</c:v>
                </c:pt>
                <c:pt idx="1187">
                  <c:v>35.168599600791943</c:v>
                </c:pt>
                <c:pt idx="1188">
                  <c:v>51.866249933242806</c:v>
                </c:pt>
                <c:pt idx="1189">
                  <c:v>42.939299898147553</c:v>
                </c:pt>
                <c:pt idx="1190">
                  <c:v>31.961199917793248</c:v>
                </c:pt>
                <c:pt idx="1191">
                  <c:v>28.612249908447193</c:v>
                </c:pt>
                <c:pt idx="1192">
                  <c:v>33.709199795722903</c:v>
                </c:pt>
                <c:pt idx="1193">
                  <c:v>22.639250016212458</c:v>
                </c:pt>
                <c:pt idx="1194">
                  <c:v>26.946749973297106</c:v>
                </c:pt>
                <c:pt idx="1195">
                  <c:v>30.566299767494151</c:v>
                </c:pt>
                <c:pt idx="1196">
                  <c:v>27.849950027465802</c:v>
                </c:pt>
                <c:pt idx="1197">
                  <c:v>39.607899994850143</c:v>
                </c:pt>
                <c:pt idx="1198">
                  <c:v>27.412450022697445</c:v>
                </c:pt>
                <c:pt idx="1199">
                  <c:v>27.1447503423691</c:v>
                </c:pt>
                <c:pt idx="1200">
                  <c:v>27.896750068664602</c:v>
                </c:pt>
                <c:pt idx="1201">
                  <c:v>27.364999961853052</c:v>
                </c:pt>
                <c:pt idx="1202">
                  <c:v>37.496949915885999</c:v>
                </c:pt>
                <c:pt idx="1203">
                  <c:v>23.559000196456903</c:v>
                </c:pt>
                <c:pt idx="1204">
                  <c:v>29.641950097084056</c:v>
                </c:pt>
                <c:pt idx="1205">
                  <c:v>32.7683002090454</c:v>
                </c:pt>
                <c:pt idx="1206">
                  <c:v>29.036699972152753</c:v>
                </c:pt>
                <c:pt idx="1207">
                  <c:v>30.555549860000596</c:v>
                </c:pt>
                <c:pt idx="1208">
                  <c:v>34.676949968337993</c:v>
                </c:pt>
                <c:pt idx="1209">
                  <c:v>29.956099843978897</c:v>
                </c:pt>
                <c:pt idx="1210">
                  <c:v>43.55974985599515</c:v>
                </c:pt>
                <c:pt idx="1211">
                  <c:v>30.371599864959645</c:v>
                </c:pt>
                <c:pt idx="1212">
                  <c:v>24.099049749374359</c:v>
                </c:pt>
                <c:pt idx="1213">
                  <c:v>23.241400070190448</c:v>
                </c:pt>
                <c:pt idx="1214">
                  <c:v>35.497349948883056</c:v>
                </c:pt>
                <c:pt idx="1215">
                  <c:v>26.6550999879837</c:v>
                </c:pt>
                <c:pt idx="1216">
                  <c:v>32.524249925613397</c:v>
                </c:pt>
                <c:pt idx="1217">
                  <c:v>22.784750366210947</c:v>
                </c:pt>
                <c:pt idx="1218">
                  <c:v>43.029549756050095</c:v>
                </c:pt>
                <c:pt idx="1219">
                  <c:v>61.261799869537406</c:v>
                </c:pt>
                <c:pt idx="1220">
                  <c:v>23.966599674224849</c:v>
                </c:pt>
                <c:pt idx="1221">
                  <c:v>22.315700349807699</c:v>
                </c:pt>
                <c:pt idx="1222">
                  <c:v>32.914849987030003</c:v>
                </c:pt>
                <c:pt idx="1223">
                  <c:v>38.22924973487855</c:v>
                </c:pt>
                <c:pt idx="1224">
                  <c:v>36.545750036239603</c:v>
                </c:pt>
                <c:pt idx="1225">
                  <c:v>34.112699975967402</c:v>
                </c:pt>
                <c:pt idx="1226">
                  <c:v>30.150500121116654</c:v>
                </c:pt>
                <c:pt idx="1227">
                  <c:v>30.150500121116654</c:v>
                </c:pt>
                <c:pt idx="1228">
                  <c:v>23.60640002727515</c:v>
                </c:pt>
                <c:pt idx="1229">
                  <c:v>37.601049866676298</c:v>
                </c:pt>
                <c:pt idx="1230">
                  <c:v>30.793649902343752</c:v>
                </c:pt>
                <c:pt idx="1231">
                  <c:v>21.722299718856792</c:v>
                </c:pt>
                <c:pt idx="1232">
                  <c:v>37.784049706459051</c:v>
                </c:pt>
                <c:pt idx="1233">
                  <c:v>31.409600133895907</c:v>
                </c:pt>
                <c:pt idx="1234">
                  <c:v>29.356299695968556</c:v>
                </c:pt>
                <c:pt idx="1235">
                  <c:v>42.874500021934509</c:v>
                </c:pt>
                <c:pt idx="1236">
                  <c:v>38.890949902534459</c:v>
                </c:pt>
                <c:pt idx="1237">
                  <c:v>31.323200035095255</c:v>
                </c:pt>
                <c:pt idx="1238">
                  <c:v>33.156699938774096</c:v>
                </c:pt>
                <c:pt idx="1239">
                  <c:v>39.156799716949443</c:v>
                </c:pt>
                <c:pt idx="1240">
                  <c:v>39.497850103378298</c:v>
                </c:pt>
                <c:pt idx="1241">
                  <c:v>16.503500213623052</c:v>
                </c:pt>
                <c:pt idx="1242">
                  <c:v>44.230900096893293</c:v>
                </c:pt>
                <c:pt idx="1243">
                  <c:v>33.514849820137059</c:v>
                </c:pt>
                <c:pt idx="1244">
                  <c:v>3.6699910163846994E-2</c:v>
                </c:pt>
                <c:pt idx="1245">
                  <c:v>24.183100175857597</c:v>
                </c:pt>
                <c:pt idx="1246">
                  <c:v>39.08055016994475</c:v>
                </c:pt>
                <c:pt idx="1247">
                  <c:v>42.893099670410194</c:v>
                </c:pt>
                <c:pt idx="1248">
                  <c:v>28.955549697875995</c:v>
                </c:pt>
                <c:pt idx="1249">
                  <c:v>31.2597498750687</c:v>
                </c:pt>
                <c:pt idx="1250">
                  <c:v>39.685149693489052</c:v>
                </c:pt>
                <c:pt idx="1251">
                  <c:v>42.7102496147156</c:v>
                </c:pt>
                <c:pt idx="1252">
                  <c:v>24.866300005912798</c:v>
                </c:pt>
                <c:pt idx="1253">
                  <c:v>31.71694970130925</c:v>
                </c:pt>
                <c:pt idx="1254">
                  <c:v>25.116399855613743</c:v>
                </c:pt>
                <c:pt idx="1255">
                  <c:v>24.906749858856248</c:v>
                </c:pt>
                <c:pt idx="1256">
                  <c:v>25.270949773788402</c:v>
                </c:pt>
                <c:pt idx="1257">
                  <c:v>29.461599817275996</c:v>
                </c:pt>
                <c:pt idx="1258">
                  <c:v>28.3685998392105</c:v>
                </c:pt>
                <c:pt idx="1259">
                  <c:v>61.484649825096156</c:v>
                </c:pt>
                <c:pt idx="1260">
                  <c:v>21.740050258636451</c:v>
                </c:pt>
                <c:pt idx="1261">
                  <c:v>36.686299848556551</c:v>
                </c:pt>
                <c:pt idx="1262">
                  <c:v>27.754949913024952</c:v>
                </c:pt>
                <c:pt idx="1263">
                  <c:v>32.817599940299999</c:v>
                </c:pt>
                <c:pt idx="1264">
                  <c:v>25.983350100517249</c:v>
                </c:pt>
                <c:pt idx="1265">
                  <c:v>24.807699851989753</c:v>
                </c:pt>
                <c:pt idx="1266">
                  <c:v>42.134649765491503</c:v>
                </c:pt>
                <c:pt idx="1267">
                  <c:v>43.232549867629992</c:v>
                </c:pt>
                <c:pt idx="1268">
                  <c:v>33.521849756240798</c:v>
                </c:pt>
                <c:pt idx="1269">
                  <c:v>41.513299713134799</c:v>
                </c:pt>
                <c:pt idx="1270">
                  <c:v>46.223699769973791</c:v>
                </c:pt>
                <c:pt idx="1271">
                  <c:v>51.571399769783064</c:v>
                </c:pt>
                <c:pt idx="1272">
                  <c:v>40.02059980869295</c:v>
                </c:pt>
                <c:pt idx="1273">
                  <c:v>29.556100087165795</c:v>
                </c:pt>
                <c:pt idx="1274">
                  <c:v>29.609999990463304</c:v>
                </c:pt>
                <c:pt idx="1275">
                  <c:v>34.093299551010148</c:v>
                </c:pt>
                <c:pt idx="1276">
                  <c:v>28.704300003051753</c:v>
                </c:pt>
                <c:pt idx="1277">
                  <c:v>29.834049963951152</c:v>
                </c:pt>
                <c:pt idx="1278">
                  <c:v>33.924299945831251</c:v>
                </c:pt>
                <c:pt idx="1279">
                  <c:v>46.536649847030645</c:v>
                </c:pt>
                <c:pt idx="1280">
                  <c:v>31.6934997701645</c:v>
                </c:pt>
                <c:pt idx="1281">
                  <c:v>42.956249737739554</c:v>
                </c:pt>
                <c:pt idx="1282">
                  <c:v>33.667649717330953</c:v>
                </c:pt>
                <c:pt idx="1283">
                  <c:v>30.756700015068006</c:v>
                </c:pt>
                <c:pt idx="1284">
                  <c:v>39.665550117492643</c:v>
                </c:pt>
                <c:pt idx="1285">
                  <c:v>24.067350015640251</c:v>
                </c:pt>
                <c:pt idx="1286">
                  <c:v>50.0130503606796</c:v>
                </c:pt>
                <c:pt idx="1287">
                  <c:v>27.171099920272852</c:v>
                </c:pt>
                <c:pt idx="1288">
                  <c:v>33.31574994564059</c:v>
                </c:pt>
                <c:pt idx="1289">
                  <c:v>26.901799764633196</c:v>
                </c:pt>
                <c:pt idx="1290">
                  <c:v>33.044449982643144</c:v>
                </c:pt>
                <c:pt idx="1291">
                  <c:v>48.173500218391453</c:v>
                </c:pt>
                <c:pt idx="1292">
                  <c:v>37.078299794197051</c:v>
                </c:pt>
                <c:pt idx="1293">
                  <c:v>20.486349887847894</c:v>
                </c:pt>
                <c:pt idx="1294">
                  <c:v>20.486349887847894</c:v>
                </c:pt>
                <c:pt idx="1295">
                  <c:v>35.891849765777593</c:v>
                </c:pt>
                <c:pt idx="1296">
                  <c:v>24.622399845123301</c:v>
                </c:pt>
                <c:pt idx="1297">
                  <c:v>35.146800031662004</c:v>
                </c:pt>
                <c:pt idx="1298">
                  <c:v>31.134700088500949</c:v>
                </c:pt>
                <c:pt idx="1299">
                  <c:v>26.3685001373291</c:v>
                </c:pt>
                <c:pt idx="1300">
                  <c:v>41.936499919891347</c:v>
                </c:pt>
                <c:pt idx="1301">
                  <c:v>35.639399766921997</c:v>
                </c:pt>
                <c:pt idx="1302">
                  <c:v>42.133650045394901</c:v>
                </c:pt>
                <c:pt idx="1303">
                  <c:v>39.460549840927094</c:v>
                </c:pt>
                <c:pt idx="1304">
                  <c:v>21.521499958038302</c:v>
                </c:pt>
                <c:pt idx="1305">
                  <c:v>21.521499958038302</c:v>
                </c:pt>
                <c:pt idx="1306">
                  <c:v>28.6498497200012</c:v>
                </c:pt>
                <c:pt idx="1307">
                  <c:v>50.33314985752105</c:v>
                </c:pt>
                <c:pt idx="1308">
                  <c:v>30.71180001735685</c:v>
                </c:pt>
                <c:pt idx="1309">
                  <c:v>40.1695998239517</c:v>
                </c:pt>
                <c:pt idx="1310">
                  <c:v>42.492049913406348</c:v>
                </c:pt>
                <c:pt idx="1311">
                  <c:v>26.751599845886197</c:v>
                </c:pt>
                <c:pt idx="1312">
                  <c:v>32.801299786567647</c:v>
                </c:pt>
                <c:pt idx="1313">
                  <c:v>38.146299772262594</c:v>
                </c:pt>
                <c:pt idx="1314">
                  <c:v>49.02709992885589</c:v>
                </c:pt>
                <c:pt idx="1315">
                  <c:v>32.61099987506865</c:v>
                </c:pt>
                <c:pt idx="1316">
                  <c:v>27.326699934005745</c:v>
                </c:pt>
                <c:pt idx="1317">
                  <c:v>20.560700058937094</c:v>
                </c:pt>
                <c:pt idx="1318">
                  <c:v>30.136349935531598</c:v>
                </c:pt>
                <c:pt idx="1319">
                  <c:v>31.317049870491047</c:v>
                </c:pt>
                <c:pt idx="1320">
                  <c:v>42.53874996185305</c:v>
                </c:pt>
                <c:pt idx="1321">
                  <c:v>28.004049754142748</c:v>
                </c:pt>
                <c:pt idx="1322">
                  <c:v>26.926499791145353</c:v>
                </c:pt>
                <c:pt idx="1323">
                  <c:v>38.179899902343749</c:v>
                </c:pt>
                <c:pt idx="1324">
                  <c:v>28.396299505233802</c:v>
                </c:pt>
                <c:pt idx="1325">
                  <c:v>30.504849977493308</c:v>
                </c:pt>
                <c:pt idx="1326">
                  <c:v>25.599999818801898</c:v>
                </c:pt>
                <c:pt idx="1327">
                  <c:v>28.792100086212145</c:v>
                </c:pt>
                <c:pt idx="1328">
                  <c:v>46.004199790954601</c:v>
                </c:pt>
                <c:pt idx="1329">
                  <c:v>31.640699810981751</c:v>
                </c:pt>
                <c:pt idx="1330">
                  <c:v>16.279100084304844</c:v>
                </c:pt>
                <c:pt idx="1331">
                  <c:v>30.936999797821052</c:v>
                </c:pt>
                <c:pt idx="1332">
                  <c:v>40.125800008773808</c:v>
                </c:pt>
                <c:pt idx="1333">
                  <c:v>42.092550020217843</c:v>
                </c:pt>
                <c:pt idx="1334">
                  <c:v>26.467700037956249</c:v>
                </c:pt>
                <c:pt idx="1335">
                  <c:v>35.207149581909192</c:v>
                </c:pt>
                <c:pt idx="1336">
                  <c:v>31.065949797630299</c:v>
                </c:pt>
                <c:pt idx="1337">
                  <c:v>37.221249818801901</c:v>
                </c:pt>
                <c:pt idx="1338">
                  <c:v>24.23125005722045</c:v>
                </c:pt>
                <c:pt idx="1339">
                  <c:v>31.620549869537349</c:v>
                </c:pt>
                <c:pt idx="1340">
                  <c:v>32.300299811363253</c:v>
                </c:pt>
                <c:pt idx="1341">
                  <c:v>36.764400205612247</c:v>
                </c:pt>
                <c:pt idx="1342">
                  <c:v>27.62885006427765</c:v>
                </c:pt>
                <c:pt idx="1343">
                  <c:v>29.1499499797821</c:v>
                </c:pt>
                <c:pt idx="1344">
                  <c:v>32.384499673843401</c:v>
                </c:pt>
                <c:pt idx="1345">
                  <c:v>31.206149616241497</c:v>
                </c:pt>
                <c:pt idx="1346">
                  <c:v>39.736199684143095</c:v>
                </c:pt>
                <c:pt idx="1347">
                  <c:v>28.997949848175047</c:v>
                </c:pt>
                <c:pt idx="1348">
                  <c:v>30.101400108337444</c:v>
                </c:pt>
                <c:pt idx="1349">
                  <c:v>25.949799847602801</c:v>
                </c:pt>
                <c:pt idx="1350">
                  <c:v>29.429949913024899</c:v>
                </c:pt>
                <c:pt idx="1351">
                  <c:v>35.452349643707244</c:v>
                </c:pt>
                <c:pt idx="1352">
                  <c:v>33.795599632263198</c:v>
                </c:pt>
                <c:pt idx="1353">
                  <c:v>34.52004992961875</c:v>
                </c:pt>
                <c:pt idx="1354">
                  <c:v>27.147649750709551</c:v>
                </c:pt>
                <c:pt idx="1355">
                  <c:v>36.168899607658354</c:v>
                </c:pt>
                <c:pt idx="1356">
                  <c:v>27.154549999237055</c:v>
                </c:pt>
                <c:pt idx="1357">
                  <c:v>52.555900044441209</c:v>
                </c:pt>
                <c:pt idx="1358">
                  <c:v>33.539149894714299</c:v>
                </c:pt>
                <c:pt idx="1359">
                  <c:v>30.890749859809901</c:v>
                </c:pt>
                <c:pt idx="1360">
                  <c:v>29.150049915313751</c:v>
                </c:pt>
                <c:pt idx="1361">
                  <c:v>36.8759502124786</c:v>
                </c:pt>
                <c:pt idx="1362">
                  <c:v>46.481699657440146</c:v>
                </c:pt>
                <c:pt idx="1363">
                  <c:v>20.124200100898747</c:v>
                </c:pt>
                <c:pt idx="1364">
                  <c:v>32.291800017356849</c:v>
                </c:pt>
                <c:pt idx="1365">
                  <c:v>26.625749835968001</c:v>
                </c:pt>
                <c:pt idx="1366">
                  <c:v>32.756949853897098</c:v>
                </c:pt>
                <c:pt idx="1367">
                  <c:v>31.748449983596849</c:v>
                </c:pt>
                <c:pt idx="1368">
                  <c:v>26.40120003700255</c:v>
                </c:pt>
                <c:pt idx="1369">
                  <c:v>35.339450016021743</c:v>
                </c:pt>
                <c:pt idx="1370">
                  <c:v>46.987449741363498</c:v>
                </c:pt>
                <c:pt idx="1371">
                  <c:v>54.183449759483352</c:v>
                </c:pt>
                <c:pt idx="1372">
                  <c:v>29.518099927902249</c:v>
                </c:pt>
                <c:pt idx="1373">
                  <c:v>46.410099973678598</c:v>
                </c:pt>
                <c:pt idx="1374">
                  <c:v>33.405599832534804</c:v>
                </c:pt>
                <c:pt idx="1375">
                  <c:v>31.086200008392403</c:v>
                </c:pt>
                <c:pt idx="1376">
                  <c:v>22.374300079345694</c:v>
                </c:pt>
                <c:pt idx="1377">
                  <c:v>36.179349455833396</c:v>
                </c:pt>
                <c:pt idx="1378">
                  <c:v>29.716199855804447</c:v>
                </c:pt>
                <c:pt idx="1379">
                  <c:v>32.067749781608605</c:v>
                </c:pt>
                <c:pt idx="1380">
                  <c:v>22.518000044822649</c:v>
                </c:pt>
                <c:pt idx="1381">
                  <c:v>39.444649949073849</c:v>
                </c:pt>
                <c:pt idx="1382">
                  <c:v>36.354699797630346</c:v>
                </c:pt>
                <c:pt idx="1383">
                  <c:v>33.873450069427491</c:v>
                </c:pt>
                <c:pt idx="1384">
                  <c:v>31.349099974632246</c:v>
                </c:pt>
                <c:pt idx="1385">
                  <c:v>31.537449951171897</c:v>
                </c:pt>
                <c:pt idx="1386">
                  <c:v>10.691100177764895</c:v>
                </c:pt>
                <c:pt idx="1387">
                  <c:v>40.161849608421349</c:v>
                </c:pt>
                <c:pt idx="1388">
                  <c:v>36.805199704170207</c:v>
                </c:pt>
                <c:pt idx="1389">
                  <c:v>28.995449957847597</c:v>
                </c:pt>
                <c:pt idx="1390">
                  <c:v>33.071400122642501</c:v>
                </c:pt>
                <c:pt idx="1391">
                  <c:v>26.758399691581701</c:v>
                </c:pt>
                <c:pt idx="1392">
                  <c:v>23.714749827384949</c:v>
                </c:pt>
                <c:pt idx="1393">
                  <c:v>33.9553998756409</c:v>
                </c:pt>
                <c:pt idx="1394">
                  <c:v>25.893049950599647</c:v>
                </c:pt>
                <c:pt idx="1395">
                  <c:v>26.702949876785247</c:v>
                </c:pt>
                <c:pt idx="1396">
                  <c:v>40.036449542045595</c:v>
                </c:pt>
                <c:pt idx="1397">
                  <c:v>28.460999879836997</c:v>
                </c:pt>
                <c:pt idx="1398">
                  <c:v>33.231649851799048</c:v>
                </c:pt>
                <c:pt idx="1399">
                  <c:v>26.690349678993201</c:v>
                </c:pt>
                <c:pt idx="1400">
                  <c:v>29.918749761581402</c:v>
                </c:pt>
                <c:pt idx="1401">
                  <c:v>23.4727500343323</c:v>
                </c:pt>
                <c:pt idx="1402">
                  <c:v>32.016350078582747</c:v>
                </c:pt>
                <c:pt idx="1403">
                  <c:v>37.039649868011495</c:v>
                </c:pt>
                <c:pt idx="1404">
                  <c:v>28.603699898719803</c:v>
                </c:pt>
                <c:pt idx="1405">
                  <c:v>45.131350207328794</c:v>
                </c:pt>
                <c:pt idx="1406">
                  <c:v>56.142499799728355</c:v>
                </c:pt>
                <c:pt idx="1407">
                  <c:v>35.980649790763849</c:v>
                </c:pt>
                <c:pt idx="1408">
                  <c:v>20.944499917030303</c:v>
                </c:pt>
                <c:pt idx="1409">
                  <c:v>35.836150088310248</c:v>
                </c:pt>
                <c:pt idx="1410">
                  <c:v>23.138400001525845</c:v>
                </c:pt>
                <c:pt idx="1411">
                  <c:v>26.658099946975749</c:v>
                </c:pt>
                <c:pt idx="1412">
                  <c:v>25.345649576187149</c:v>
                </c:pt>
                <c:pt idx="1413">
                  <c:v>41.230699744224502</c:v>
                </c:pt>
                <c:pt idx="1414">
                  <c:v>26.694449863433846</c:v>
                </c:pt>
                <c:pt idx="1415">
                  <c:v>33.269099912643448</c:v>
                </c:pt>
                <c:pt idx="1416">
                  <c:v>38.605449948310856</c:v>
                </c:pt>
                <c:pt idx="1417">
                  <c:v>45.5041999149323</c:v>
                </c:pt>
                <c:pt idx="1418">
                  <c:v>25.008750066757251</c:v>
                </c:pt>
                <c:pt idx="1419">
                  <c:v>30.245900049209602</c:v>
                </c:pt>
                <c:pt idx="1420">
                  <c:v>37.632499775886501</c:v>
                </c:pt>
                <c:pt idx="1421">
                  <c:v>41.822299957275398</c:v>
                </c:pt>
                <c:pt idx="1422">
                  <c:v>35.038149991035453</c:v>
                </c:pt>
                <c:pt idx="1423">
                  <c:v>33.434999704361005</c:v>
                </c:pt>
                <c:pt idx="1424">
                  <c:v>21.90774958610535</c:v>
                </c:pt>
                <c:pt idx="1425">
                  <c:v>29.732599740028348</c:v>
                </c:pt>
                <c:pt idx="1426">
                  <c:v>36.132399806976295</c:v>
                </c:pt>
                <c:pt idx="1427">
                  <c:v>37.132599816322298</c:v>
                </c:pt>
                <c:pt idx="1428">
                  <c:v>56.094799814224196</c:v>
                </c:pt>
                <c:pt idx="1429">
                  <c:v>43.348999872207649</c:v>
                </c:pt>
                <c:pt idx="1430">
                  <c:v>37.678599648475654</c:v>
                </c:pt>
                <c:pt idx="1431">
                  <c:v>22.719649858474753</c:v>
                </c:pt>
                <c:pt idx="1432">
                  <c:v>23.459549970626796</c:v>
                </c:pt>
                <c:pt idx="1433">
                  <c:v>42.613649888038594</c:v>
                </c:pt>
                <c:pt idx="1434">
                  <c:v>41.623399829864496</c:v>
                </c:pt>
                <c:pt idx="1435">
                  <c:v>25.612850036621101</c:v>
                </c:pt>
                <c:pt idx="1436">
                  <c:v>23.271549916267404</c:v>
                </c:pt>
                <c:pt idx="1437">
                  <c:v>42.418749718666106</c:v>
                </c:pt>
                <c:pt idx="1438">
                  <c:v>33.954399766922002</c:v>
                </c:pt>
                <c:pt idx="1439">
                  <c:v>20.244450035095255</c:v>
                </c:pt>
                <c:pt idx="1440">
                  <c:v>26.117450084686254</c:v>
                </c:pt>
                <c:pt idx="1441">
                  <c:v>28.256449723243698</c:v>
                </c:pt>
                <c:pt idx="1442">
                  <c:v>33.612049703598053</c:v>
                </c:pt>
                <c:pt idx="1443">
                  <c:v>39.954499945640599</c:v>
                </c:pt>
                <c:pt idx="1444">
                  <c:v>26.413099822998056</c:v>
                </c:pt>
                <c:pt idx="1445">
                  <c:v>29.815799727439952</c:v>
                </c:pt>
                <c:pt idx="1446">
                  <c:v>38.390599861145006</c:v>
                </c:pt>
                <c:pt idx="1447">
                  <c:v>23.766549911499052</c:v>
                </c:pt>
                <c:pt idx="1448">
                  <c:v>34.728699741363549</c:v>
                </c:pt>
                <c:pt idx="1449">
                  <c:v>27.025749950408898</c:v>
                </c:pt>
                <c:pt idx="1450">
                  <c:v>29.410949892997756</c:v>
                </c:pt>
                <c:pt idx="1451">
                  <c:v>29.534399895668006</c:v>
                </c:pt>
                <c:pt idx="1452">
                  <c:v>30.068899893760694</c:v>
                </c:pt>
                <c:pt idx="1453">
                  <c:v>20.139650020599355</c:v>
                </c:pt>
                <c:pt idx="1454">
                  <c:v>29.586199846267697</c:v>
                </c:pt>
                <c:pt idx="1455">
                  <c:v>32.925000085830703</c:v>
                </c:pt>
                <c:pt idx="1456">
                  <c:v>31.295299878120403</c:v>
                </c:pt>
                <c:pt idx="1457">
                  <c:v>27.912650094032252</c:v>
                </c:pt>
                <c:pt idx="1458">
                  <c:v>45.067399878501845</c:v>
                </c:pt>
                <c:pt idx="1459">
                  <c:v>34.403749876022403</c:v>
                </c:pt>
                <c:pt idx="1460">
                  <c:v>34.231099524497949</c:v>
                </c:pt>
                <c:pt idx="1461">
                  <c:v>28.825399808883652</c:v>
                </c:pt>
                <c:pt idx="1462">
                  <c:v>52.368549718856848</c:v>
                </c:pt>
                <c:pt idx="1463">
                  <c:v>38.324499697685198</c:v>
                </c:pt>
                <c:pt idx="1464">
                  <c:v>32.903550109863303</c:v>
                </c:pt>
                <c:pt idx="1465">
                  <c:v>23.616350059509255</c:v>
                </c:pt>
                <c:pt idx="1466">
                  <c:v>19.989099802970905</c:v>
                </c:pt>
                <c:pt idx="1467">
                  <c:v>25.133099937439003</c:v>
                </c:pt>
                <c:pt idx="1468">
                  <c:v>48.463100080490101</c:v>
                </c:pt>
                <c:pt idx="1469">
                  <c:v>26.855200033187852</c:v>
                </c:pt>
                <c:pt idx="1470">
                  <c:v>23.249499692916849</c:v>
                </c:pt>
                <c:pt idx="1471">
                  <c:v>32.1144999408722</c:v>
                </c:pt>
                <c:pt idx="1472">
                  <c:v>27.194800076484704</c:v>
                </c:pt>
                <c:pt idx="1473">
                  <c:v>26.1081000185013</c:v>
                </c:pt>
                <c:pt idx="1474">
                  <c:v>26.552549901008597</c:v>
                </c:pt>
                <c:pt idx="1475">
                  <c:v>27.312250194549598</c:v>
                </c:pt>
                <c:pt idx="1476">
                  <c:v>25.948949999809251</c:v>
                </c:pt>
                <c:pt idx="1477">
                  <c:v>25.948949999809251</c:v>
                </c:pt>
                <c:pt idx="1478">
                  <c:v>23.58865028381345</c:v>
                </c:pt>
                <c:pt idx="1479">
                  <c:v>26.015699820518499</c:v>
                </c:pt>
                <c:pt idx="1480">
                  <c:v>28.468799757957445</c:v>
                </c:pt>
                <c:pt idx="1481">
                  <c:v>28.848950033187847</c:v>
                </c:pt>
                <c:pt idx="1482">
                  <c:v>28.779799966812149</c:v>
                </c:pt>
                <c:pt idx="1483">
                  <c:v>37.839000129699699</c:v>
                </c:pt>
                <c:pt idx="1484">
                  <c:v>33.938799967765846</c:v>
                </c:pt>
                <c:pt idx="1485">
                  <c:v>37.113750023841845</c:v>
                </c:pt>
                <c:pt idx="1486">
                  <c:v>23.175249996185304</c:v>
                </c:pt>
                <c:pt idx="1487">
                  <c:v>27.647699923515404</c:v>
                </c:pt>
                <c:pt idx="1488">
                  <c:v>17.525050106048596</c:v>
                </c:pt>
                <c:pt idx="1489">
                  <c:v>47.460099778175397</c:v>
                </c:pt>
                <c:pt idx="1490">
                  <c:v>30.332349762916547</c:v>
                </c:pt>
                <c:pt idx="1491">
                  <c:v>28.880950102806096</c:v>
                </c:pt>
                <c:pt idx="1492">
                  <c:v>30.111049838066155</c:v>
                </c:pt>
                <c:pt idx="1493">
                  <c:v>54.065499701499895</c:v>
                </c:pt>
                <c:pt idx="1494">
                  <c:v>47.739699883461</c:v>
                </c:pt>
                <c:pt idx="1495">
                  <c:v>15.669000186920147</c:v>
                </c:pt>
                <c:pt idx="1496">
                  <c:v>22.443400044441248</c:v>
                </c:pt>
                <c:pt idx="1497">
                  <c:v>32.81104988098145</c:v>
                </c:pt>
                <c:pt idx="1498">
                  <c:v>38.760700078010558</c:v>
                </c:pt>
                <c:pt idx="1499">
                  <c:v>18.093750171661355</c:v>
                </c:pt>
                <c:pt idx="1500">
                  <c:v>30.846599764823953</c:v>
                </c:pt>
                <c:pt idx="1501">
                  <c:v>34.242749633789003</c:v>
                </c:pt>
                <c:pt idx="1502">
                  <c:v>27.785849933624242</c:v>
                </c:pt>
                <c:pt idx="1503">
                  <c:v>32.918049712181102</c:v>
                </c:pt>
                <c:pt idx="1504">
                  <c:v>20.068600044250449</c:v>
                </c:pt>
                <c:pt idx="1505">
                  <c:v>27.910099730491606</c:v>
                </c:pt>
                <c:pt idx="1506">
                  <c:v>26.100499978065447</c:v>
                </c:pt>
                <c:pt idx="1507">
                  <c:v>25.171799850463856</c:v>
                </c:pt>
                <c:pt idx="1508">
                  <c:v>27.752549958229046</c:v>
                </c:pt>
                <c:pt idx="1509">
                  <c:v>27.163300142288193</c:v>
                </c:pt>
                <c:pt idx="1510">
                  <c:v>33.665849947929402</c:v>
                </c:pt>
                <c:pt idx="1511">
                  <c:v>21.831549921035752</c:v>
                </c:pt>
                <c:pt idx="1512">
                  <c:v>41.058149976730348</c:v>
                </c:pt>
                <c:pt idx="1513">
                  <c:v>36.284899830818198</c:v>
                </c:pt>
                <c:pt idx="1514">
                  <c:v>36.778350052833545</c:v>
                </c:pt>
                <c:pt idx="1515">
                  <c:v>26.128549814224254</c:v>
                </c:pt>
                <c:pt idx="1516">
                  <c:v>34.240949602127102</c:v>
                </c:pt>
                <c:pt idx="1517">
                  <c:v>52.768399538993847</c:v>
                </c:pt>
                <c:pt idx="1518">
                  <c:v>28.285599966049197</c:v>
                </c:pt>
                <c:pt idx="1519">
                  <c:v>27.97209980964665</c:v>
                </c:pt>
                <c:pt idx="1520">
                  <c:v>28.487000026702901</c:v>
                </c:pt>
                <c:pt idx="1521">
                  <c:v>30.233549833297808</c:v>
                </c:pt>
                <c:pt idx="1522">
                  <c:v>26.870599818229646</c:v>
                </c:pt>
                <c:pt idx="1523">
                  <c:v>27.3920997810364</c:v>
                </c:pt>
                <c:pt idx="1524">
                  <c:v>28.1872496843338</c:v>
                </c:pt>
                <c:pt idx="1525">
                  <c:v>28.452049913406345</c:v>
                </c:pt>
                <c:pt idx="1526">
                  <c:v>40.799049968719501</c:v>
                </c:pt>
                <c:pt idx="1527">
                  <c:v>35.926649880409194</c:v>
                </c:pt>
                <c:pt idx="1528">
                  <c:v>29.975349712371894</c:v>
                </c:pt>
                <c:pt idx="1529">
                  <c:v>22.772699623107904</c:v>
                </c:pt>
                <c:pt idx="1530">
                  <c:v>26.132999730110207</c:v>
                </c:pt>
                <c:pt idx="1531">
                  <c:v>24.076549906730648</c:v>
                </c:pt>
                <c:pt idx="1532">
                  <c:v>38.930599684715254</c:v>
                </c:pt>
                <c:pt idx="1533">
                  <c:v>32.355549569129906</c:v>
                </c:pt>
                <c:pt idx="1534">
                  <c:v>37.557149858474752</c:v>
                </c:pt>
                <c:pt idx="1535">
                  <c:v>23.406899805069003</c:v>
                </c:pt>
                <c:pt idx="1536">
                  <c:v>33.598899707794196</c:v>
                </c:pt>
                <c:pt idx="1537">
                  <c:v>19.517400012016303</c:v>
                </c:pt>
                <c:pt idx="1538">
                  <c:v>25.939249925613403</c:v>
                </c:pt>
                <c:pt idx="1539">
                  <c:v>32.449650216102597</c:v>
                </c:pt>
                <c:pt idx="1540">
                  <c:v>27.600799798965454</c:v>
                </c:pt>
                <c:pt idx="1541">
                  <c:v>26.985850119590804</c:v>
                </c:pt>
                <c:pt idx="1542">
                  <c:v>28.8997001886368</c:v>
                </c:pt>
                <c:pt idx="1543">
                  <c:v>20.7639503383636</c:v>
                </c:pt>
                <c:pt idx="1544">
                  <c:v>14.2655003547669</c:v>
                </c:pt>
                <c:pt idx="1545">
                  <c:v>17.220500092506356</c:v>
                </c:pt>
                <c:pt idx="1546">
                  <c:v>29.385049915313751</c:v>
                </c:pt>
                <c:pt idx="1547">
                  <c:v>27.495799870491048</c:v>
                </c:pt>
                <c:pt idx="1548">
                  <c:v>35.924099755287152</c:v>
                </c:pt>
                <c:pt idx="1549">
                  <c:v>28.362749748230002</c:v>
                </c:pt>
                <c:pt idx="1550">
                  <c:v>16.744399890899651</c:v>
                </c:pt>
                <c:pt idx="1551">
                  <c:v>27.612999958991999</c:v>
                </c:pt>
                <c:pt idx="1552">
                  <c:v>23.251650152206448</c:v>
                </c:pt>
                <c:pt idx="1553">
                  <c:v>25.453450107574504</c:v>
                </c:pt>
                <c:pt idx="1554">
                  <c:v>32.980649995803844</c:v>
                </c:pt>
                <c:pt idx="1555">
                  <c:v>30.510399975776647</c:v>
                </c:pt>
                <c:pt idx="1556">
                  <c:v>43.181449861526488</c:v>
                </c:pt>
                <c:pt idx="1557">
                  <c:v>54.815500288009702</c:v>
                </c:pt>
                <c:pt idx="1558">
                  <c:v>31.310349898338352</c:v>
                </c:pt>
                <c:pt idx="1559">
                  <c:v>27.671250076293951</c:v>
                </c:pt>
                <c:pt idx="1560">
                  <c:v>20.9523500728607</c:v>
                </c:pt>
                <c:pt idx="1561">
                  <c:v>20.9523500728607</c:v>
                </c:pt>
                <c:pt idx="1562">
                  <c:v>28.310700001716597</c:v>
                </c:pt>
                <c:pt idx="1563">
                  <c:v>26.999999933242751</c:v>
                </c:pt>
                <c:pt idx="1564">
                  <c:v>24.412449879646246</c:v>
                </c:pt>
                <c:pt idx="1565">
                  <c:v>31.357099905014</c:v>
                </c:pt>
                <c:pt idx="1566">
                  <c:v>36.265749917030348</c:v>
                </c:pt>
                <c:pt idx="1567">
                  <c:v>26.859649820327753</c:v>
                </c:pt>
                <c:pt idx="1568">
                  <c:v>31.218999977111849</c:v>
                </c:pt>
                <c:pt idx="1569">
                  <c:v>28.473750057220499</c:v>
                </c:pt>
                <c:pt idx="1570">
                  <c:v>42.762249789238012</c:v>
                </c:pt>
                <c:pt idx="1571">
                  <c:v>47.636850128173847</c:v>
                </c:pt>
                <c:pt idx="1572">
                  <c:v>32.774199814796503</c:v>
                </c:pt>
                <c:pt idx="1573">
                  <c:v>31.29784969329835</c:v>
                </c:pt>
                <c:pt idx="1574">
                  <c:v>27.219249973297053</c:v>
                </c:pt>
                <c:pt idx="1575">
                  <c:v>26.815799655914304</c:v>
                </c:pt>
                <c:pt idx="1576">
                  <c:v>26.071000113487248</c:v>
                </c:pt>
                <c:pt idx="1577">
                  <c:v>25.240199832916243</c:v>
                </c:pt>
                <c:pt idx="1578">
                  <c:v>31.425449867248552</c:v>
                </c:pt>
                <c:pt idx="1579">
                  <c:v>36.187899923324551</c:v>
                </c:pt>
                <c:pt idx="1580">
                  <c:v>31.469349942207351</c:v>
                </c:pt>
                <c:pt idx="1581">
                  <c:v>35.554850025176997</c:v>
                </c:pt>
                <c:pt idx="1582">
                  <c:v>30.338599958419803</c:v>
                </c:pt>
                <c:pt idx="1583">
                  <c:v>24.579250164031951</c:v>
                </c:pt>
                <c:pt idx="1584">
                  <c:v>38.584349732398955</c:v>
                </c:pt>
                <c:pt idx="1585">
                  <c:v>32.538399786949157</c:v>
                </c:pt>
                <c:pt idx="1586">
                  <c:v>27.989599814414948</c:v>
                </c:pt>
                <c:pt idx="1587">
                  <c:v>21.628100070953348</c:v>
                </c:pt>
                <c:pt idx="1588">
                  <c:v>18.429599695205646</c:v>
                </c:pt>
                <c:pt idx="1589">
                  <c:v>26.232699813842807</c:v>
                </c:pt>
                <c:pt idx="1590">
                  <c:v>25.791299848556491</c:v>
                </c:pt>
                <c:pt idx="1591">
                  <c:v>31.897250084876948</c:v>
                </c:pt>
                <c:pt idx="1592">
                  <c:v>28.532300052642803</c:v>
                </c:pt>
                <c:pt idx="1593">
                  <c:v>22.976400227546751</c:v>
                </c:pt>
                <c:pt idx="1594">
                  <c:v>14.129600191116346</c:v>
                </c:pt>
                <c:pt idx="1595">
                  <c:v>19.220599975585952</c:v>
                </c:pt>
                <c:pt idx="1596">
                  <c:v>33.186900138854952</c:v>
                </c:pt>
                <c:pt idx="1597">
                  <c:v>34.364199895858746</c:v>
                </c:pt>
                <c:pt idx="1598">
                  <c:v>31.205199799537645</c:v>
                </c:pt>
                <c:pt idx="1599">
                  <c:v>24.135349898338298</c:v>
                </c:pt>
                <c:pt idx="1600">
                  <c:v>28.7914999437332</c:v>
                </c:pt>
                <c:pt idx="1601">
                  <c:v>28.095750150680551</c:v>
                </c:pt>
                <c:pt idx="1602">
                  <c:v>28.095750150680551</c:v>
                </c:pt>
                <c:pt idx="1603">
                  <c:v>31.160800180435153</c:v>
                </c:pt>
                <c:pt idx="1604">
                  <c:v>21.275400056839004</c:v>
                </c:pt>
                <c:pt idx="1605">
                  <c:v>39.229999551773048</c:v>
                </c:pt>
                <c:pt idx="1606">
                  <c:v>34.781749944686901</c:v>
                </c:pt>
                <c:pt idx="1607">
                  <c:v>28.726550016403205</c:v>
                </c:pt>
                <c:pt idx="1608">
                  <c:v>29.968299875259401</c:v>
                </c:pt>
                <c:pt idx="1609">
                  <c:v>44.078549914360046</c:v>
                </c:pt>
                <c:pt idx="1610">
                  <c:v>20.132600049972499</c:v>
                </c:pt>
                <c:pt idx="1611">
                  <c:v>10.732850069999742</c:v>
                </c:pt>
                <c:pt idx="1612">
                  <c:v>20.514650039672851</c:v>
                </c:pt>
                <c:pt idx="1613">
                  <c:v>27.032099742889397</c:v>
                </c:pt>
                <c:pt idx="1614">
                  <c:v>41.680099787712102</c:v>
                </c:pt>
                <c:pt idx="1615">
                  <c:v>34.256450085639898</c:v>
                </c:pt>
                <c:pt idx="1616">
                  <c:v>26.707250018119851</c:v>
                </c:pt>
                <c:pt idx="1617">
                  <c:v>44.695899887084948</c:v>
                </c:pt>
                <c:pt idx="1618">
                  <c:v>33.723299984931948</c:v>
                </c:pt>
                <c:pt idx="1619">
                  <c:v>24.239399652481097</c:v>
                </c:pt>
                <c:pt idx="1620">
                  <c:v>28.82775023937225</c:v>
                </c:pt>
                <c:pt idx="1621">
                  <c:v>62.632450060844441</c:v>
                </c:pt>
                <c:pt idx="1622">
                  <c:v>32.202349772453303</c:v>
                </c:pt>
                <c:pt idx="1623">
                  <c:v>28.033349862098646</c:v>
                </c:pt>
                <c:pt idx="1624">
                  <c:v>20.786699924468998</c:v>
                </c:pt>
                <c:pt idx="1625">
                  <c:v>36.26535008430475</c:v>
                </c:pt>
                <c:pt idx="1626">
                  <c:v>27.0023999834061</c:v>
                </c:pt>
                <c:pt idx="1627">
                  <c:v>37.337199807167096</c:v>
                </c:pt>
                <c:pt idx="1628">
                  <c:v>23.087299919128348</c:v>
                </c:pt>
                <c:pt idx="1629">
                  <c:v>26.207399902343752</c:v>
                </c:pt>
                <c:pt idx="1630">
                  <c:v>41.234200124740603</c:v>
                </c:pt>
                <c:pt idx="1631">
                  <c:v>22.464749932289095</c:v>
                </c:pt>
                <c:pt idx="1632">
                  <c:v>27.482149834632899</c:v>
                </c:pt>
                <c:pt idx="1633">
                  <c:v>23.534599995613053</c:v>
                </c:pt>
                <c:pt idx="1634">
                  <c:v>30.123699841499345</c:v>
                </c:pt>
                <c:pt idx="1635">
                  <c:v>24.1407999563217</c:v>
                </c:pt>
                <c:pt idx="1636">
                  <c:v>25.691699948310848</c:v>
                </c:pt>
                <c:pt idx="1637">
                  <c:v>16.555800113677996</c:v>
                </c:pt>
                <c:pt idx="1638">
                  <c:v>23.402150373458852</c:v>
                </c:pt>
                <c:pt idx="1639">
                  <c:v>36.324299879074054</c:v>
                </c:pt>
                <c:pt idx="1640">
                  <c:v>25.005000128746047</c:v>
                </c:pt>
                <c:pt idx="1641">
                  <c:v>26.100449810028106</c:v>
                </c:pt>
                <c:pt idx="1642">
                  <c:v>15.526150050163302</c:v>
                </c:pt>
                <c:pt idx="1643">
                  <c:v>22.73360006809235</c:v>
                </c:pt>
                <c:pt idx="1644">
                  <c:v>26.632099866867051</c:v>
                </c:pt>
                <c:pt idx="1645">
                  <c:v>31.464849739074701</c:v>
                </c:pt>
                <c:pt idx="1646">
                  <c:v>33.889849710464453</c:v>
                </c:pt>
                <c:pt idx="1647">
                  <c:v>27.057900104522648</c:v>
                </c:pt>
                <c:pt idx="1648">
                  <c:v>35.013949856758096</c:v>
                </c:pt>
                <c:pt idx="1649">
                  <c:v>24.179399933814999</c:v>
                </c:pt>
                <c:pt idx="1650">
                  <c:v>25.3562499952316</c:v>
                </c:pt>
                <c:pt idx="1651">
                  <c:v>23.648949756622347</c:v>
                </c:pt>
                <c:pt idx="1652">
                  <c:v>17.842849855422998</c:v>
                </c:pt>
                <c:pt idx="1653">
                  <c:v>43.518400006294243</c:v>
                </c:pt>
                <c:pt idx="1654">
                  <c:v>34.714899525642451</c:v>
                </c:pt>
                <c:pt idx="1655">
                  <c:v>28.191549911498996</c:v>
                </c:pt>
                <c:pt idx="1656">
                  <c:v>18.97829993247985</c:v>
                </c:pt>
                <c:pt idx="1657">
                  <c:v>19.28709993839265</c:v>
                </c:pt>
                <c:pt idx="1658">
                  <c:v>36.258199930191054</c:v>
                </c:pt>
                <c:pt idx="1659">
                  <c:v>29.032049756050093</c:v>
                </c:pt>
                <c:pt idx="1660">
                  <c:v>26.924249882698046</c:v>
                </c:pt>
                <c:pt idx="1661">
                  <c:v>32.139349689483652</c:v>
                </c:pt>
                <c:pt idx="1662">
                  <c:v>29.365049719810443</c:v>
                </c:pt>
                <c:pt idx="1663">
                  <c:v>20.21354990005495</c:v>
                </c:pt>
                <c:pt idx="1664">
                  <c:v>27.928800067901598</c:v>
                </c:pt>
                <c:pt idx="1665">
                  <c:v>20.254750013351398</c:v>
                </c:pt>
                <c:pt idx="1666">
                  <c:v>23.643499736785898</c:v>
                </c:pt>
                <c:pt idx="1667">
                  <c:v>22.257249841690097</c:v>
                </c:pt>
                <c:pt idx="1668">
                  <c:v>29.4472000837326</c:v>
                </c:pt>
                <c:pt idx="1669">
                  <c:v>19.459149870872501</c:v>
                </c:pt>
                <c:pt idx="1670">
                  <c:v>27.123300194740295</c:v>
                </c:pt>
                <c:pt idx="1671">
                  <c:v>29.614949769973752</c:v>
                </c:pt>
                <c:pt idx="1672">
                  <c:v>40.245799913406401</c:v>
                </c:pt>
                <c:pt idx="1673">
                  <c:v>14.912499842643754</c:v>
                </c:pt>
                <c:pt idx="1674">
                  <c:v>19.168899793624906</c:v>
                </c:pt>
                <c:pt idx="1675">
                  <c:v>34.276799936294594</c:v>
                </c:pt>
                <c:pt idx="1676">
                  <c:v>24.637899661064196</c:v>
                </c:pt>
                <c:pt idx="1677">
                  <c:v>21.496849803924597</c:v>
                </c:pt>
                <c:pt idx="1678">
                  <c:v>24.802999825477606</c:v>
                </c:pt>
                <c:pt idx="1679">
                  <c:v>27.566649742126497</c:v>
                </c:pt>
                <c:pt idx="1680">
                  <c:v>35.819000167846646</c:v>
                </c:pt>
                <c:pt idx="1681">
                  <c:v>33.728450002670257</c:v>
                </c:pt>
                <c:pt idx="1682">
                  <c:v>27.159649910926802</c:v>
                </c:pt>
                <c:pt idx="1683">
                  <c:v>31.130650038719153</c:v>
                </c:pt>
                <c:pt idx="1684">
                  <c:v>34.795449924468997</c:v>
                </c:pt>
                <c:pt idx="1685">
                  <c:v>43.482749876976008</c:v>
                </c:pt>
                <c:pt idx="1686">
                  <c:v>29.99825021743775</c:v>
                </c:pt>
                <c:pt idx="1687">
                  <c:v>33.008849737644255</c:v>
                </c:pt>
                <c:pt idx="1688">
                  <c:v>34.109699730873103</c:v>
                </c:pt>
                <c:pt idx="1689">
                  <c:v>31.171799893379202</c:v>
                </c:pt>
                <c:pt idx="1690">
                  <c:v>38.153099875450103</c:v>
                </c:pt>
                <c:pt idx="1691">
                  <c:v>6.2452000331878423</c:v>
                </c:pt>
                <c:pt idx="1692">
                  <c:v>34.933699617385798</c:v>
                </c:pt>
                <c:pt idx="1693">
                  <c:v>25.945100054740955</c:v>
                </c:pt>
                <c:pt idx="1694">
                  <c:v>26.488899948000892</c:v>
                </c:pt>
                <c:pt idx="1695">
                  <c:v>32.111849884986803</c:v>
                </c:pt>
                <c:pt idx="1696">
                  <c:v>29.776149673461898</c:v>
                </c:pt>
                <c:pt idx="1697">
                  <c:v>40.530849857330296</c:v>
                </c:pt>
                <c:pt idx="1698">
                  <c:v>36.399449906349147</c:v>
                </c:pt>
                <c:pt idx="1699">
                  <c:v>29.24269981861115</c:v>
                </c:pt>
                <c:pt idx="1700">
                  <c:v>34.339149789810151</c:v>
                </c:pt>
                <c:pt idx="1701">
                  <c:v>20.795449857711798</c:v>
                </c:pt>
                <c:pt idx="1702">
                  <c:v>26.125550012588498</c:v>
                </c:pt>
                <c:pt idx="1703">
                  <c:v>36.509499630928055</c:v>
                </c:pt>
                <c:pt idx="1704">
                  <c:v>28.271600079536448</c:v>
                </c:pt>
                <c:pt idx="1705">
                  <c:v>25.697299914360052</c:v>
                </c:pt>
                <c:pt idx="1706">
                  <c:v>22.0133499932289</c:v>
                </c:pt>
                <c:pt idx="1707">
                  <c:v>40.055200033187901</c:v>
                </c:pt>
                <c:pt idx="1708">
                  <c:v>36.171799764633249</c:v>
                </c:pt>
                <c:pt idx="1709">
                  <c:v>39.268199934959405</c:v>
                </c:pt>
                <c:pt idx="1710">
                  <c:v>23.602899889945999</c:v>
                </c:pt>
                <c:pt idx="1711">
                  <c:v>28.948500123024001</c:v>
                </c:pt>
                <c:pt idx="1712">
                  <c:v>34.126349902152995</c:v>
                </c:pt>
                <c:pt idx="1713">
                  <c:v>36.631549797058106</c:v>
                </c:pt>
                <c:pt idx="1714">
                  <c:v>32.868249971866597</c:v>
                </c:pt>
                <c:pt idx="1715">
                  <c:v>28.28924983024595</c:v>
                </c:pt>
                <c:pt idx="1716">
                  <c:v>32.201200070381148</c:v>
                </c:pt>
                <c:pt idx="1717">
                  <c:v>28.117849903106652</c:v>
                </c:pt>
                <c:pt idx="1718">
                  <c:v>27.876949944496154</c:v>
                </c:pt>
                <c:pt idx="1719">
                  <c:v>20.83404983520505</c:v>
                </c:pt>
                <c:pt idx="1720">
                  <c:v>29.572500152587899</c:v>
                </c:pt>
                <c:pt idx="1721">
                  <c:v>23.879200086593599</c:v>
                </c:pt>
                <c:pt idx="1722">
                  <c:v>40.288999943733252</c:v>
                </c:pt>
                <c:pt idx="1723">
                  <c:v>24.643650150299045</c:v>
                </c:pt>
                <c:pt idx="1724">
                  <c:v>32.670700116157505</c:v>
                </c:pt>
                <c:pt idx="1725">
                  <c:v>18.580400133132947</c:v>
                </c:pt>
                <c:pt idx="1726">
                  <c:v>25.149799852371199</c:v>
                </c:pt>
                <c:pt idx="1727">
                  <c:v>27.022749814987201</c:v>
                </c:pt>
                <c:pt idx="1728">
                  <c:v>21.789050045013454</c:v>
                </c:pt>
                <c:pt idx="1729">
                  <c:v>13.785700182914695</c:v>
                </c:pt>
                <c:pt idx="1730">
                  <c:v>24.524300003051799</c:v>
                </c:pt>
                <c:pt idx="1731">
                  <c:v>48.308799643516551</c:v>
                </c:pt>
                <c:pt idx="1732">
                  <c:v>37.906099877357455</c:v>
                </c:pt>
                <c:pt idx="1733">
                  <c:v>32.528449883460951</c:v>
                </c:pt>
                <c:pt idx="1734">
                  <c:v>34.10424969673155</c:v>
                </c:pt>
                <c:pt idx="1735">
                  <c:v>29.290199766159049</c:v>
                </c:pt>
                <c:pt idx="1736">
                  <c:v>40.827600049972503</c:v>
                </c:pt>
                <c:pt idx="1737">
                  <c:v>17.077599973678598</c:v>
                </c:pt>
                <c:pt idx="1738">
                  <c:v>32.903499999046296</c:v>
                </c:pt>
                <c:pt idx="1739">
                  <c:v>20.416949915885894</c:v>
                </c:pt>
                <c:pt idx="1740">
                  <c:v>44.037299814224205</c:v>
                </c:pt>
                <c:pt idx="1741">
                  <c:v>34.469899711608896</c:v>
                </c:pt>
                <c:pt idx="1742">
                  <c:v>19.8275000858307</c:v>
                </c:pt>
                <c:pt idx="1743">
                  <c:v>25.417900109291104</c:v>
                </c:pt>
                <c:pt idx="1744">
                  <c:v>38.063799772262556</c:v>
                </c:pt>
                <c:pt idx="1745">
                  <c:v>23.806550025939949</c:v>
                </c:pt>
                <c:pt idx="1746">
                  <c:v>22.254799933433553</c:v>
                </c:pt>
                <c:pt idx="1747">
                  <c:v>33.316849999427795</c:v>
                </c:pt>
                <c:pt idx="1748">
                  <c:v>21.81689968109135</c:v>
                </c:pt>
                <c:pt idx="1749">
                  <c:v>21.247700152397151</c:v>
                </c:pt>
                <c:pt idx="1750">
                  <c:v>26.52874989032745</c:v>
                </c:pt>
                <c:pt idx="1751">
                  <c:v>28.111550068855252</c:v>
                </c:pt>
                <c:pt idx="1752">
                  <c:v>22.708899741172754</c:v>
                </c:pt>
                <c:pt idx="1753">
                  <c:v>37.003200030326852</c:v>
                </c:pt>
                <c:pt idx="1754">
                  <c:v>25.280549988746699</c:v>
                </c:pt>
                <c:pt idx="1755">
                  <c:v>37.512699794769304</c:v>
                </c:pt>
                <c:pt idx="1756">
                  <c:v>24.671849827766401</c:v>
                </c:pt>
                <c:pt idx="1757">
                  <c:v>19.907000246048</c:v>
                </c:pt>
                <c:pt idx="1758">
                  <c:v>21.646049952507006</c:v>
                </c:pt>
                <c:pt idx="1759">
                  <c:v>17.9298501443863</c:v>
                </c:pt>
                <c:pt idx="1760">
                  <c:v>32.410499873161356</c:v>
                </c:pt>
                <c:pt idx="1761">
                  <c:v>25.070549931526195</c:v>
                </c:pt>
                <c:pt idx="1762">
                  <c:v>35.44584992885585</c:v>
                </c:pt>
                <c:pt idx="1763">
                  <c:v>22.657500233650254</c:v>
                </c:pt>
                <c:pt idx="1764">
                  <c:v>22.574450054168647</c:v>
                </c:pt>
                <c:pt idx="1765">
                  <c:v>28.168249568939245</c:v>
                </c:pt>
                <c:pt idx="1766">
                  <c:v>32.638050069808997</c:v>
                </c:pt>
                <c:pt idx="1767">
                  <c:v>37.865049986839296</c:v>
                </c:pt>
                <c:pt idx="1768">
                  <c:v>16.678550257682801</c:v>
                </c:pt>
                <c:pt idx="1769">
                  <c:v>39.459049859046956</c:v>
                </c:pt>
                <c:pt idx="1770">
                  <c:v>24.521149964332551</c:v>
                </c:pt>
                <c:pt idx="1771">
                  <c:v>32.531499919891402</c:v>
                </c:pt>
                <c:pt idx="1772">
                  <c:v>25.448150196075453</c:v>
                </c:pt>
                <c:pt idx="1773">
                  <c:v>42.4222998094559</c:v>
                </c:pt>
                <c:pt idx="1774">
                  <c:v>24.254599819183298</c:v>
                </c:pt>
                <c:pt idx="1775">
                  <c:v>22.840600051879846</c:v>
                </c:pt>
                <c:pt idx="1776">
                  <c:v>31.151299791336093</c:v>
                </c:pt>
                <c:pt idx="1777">
                  <c:v>22.29285006046295</c:v>
                </c:pt>
                <c:pt idx="1778">
                  <c:v>31.651249794960002</c:v>
                </c:pt>
                <c:pt idx="1779">
                  <c:v>23.176999998092704</c:v>
                </c:pt>
                <c:pt idx="1780">
                  <c:v>24.762499766349798</c:v>
                </c:pt>
                <c:pt idx="1781">
                  <c:v>32.283900055885297</c:v>
                </c:pt>
                <c:pt idx="1782">
                  <c:v>19.287850260734551</c:v>
                </c:pt>
                <c:pt idx="1783">
                  <c:v>30.089999799728403</c:v>
                </c:pt>
                <c:pt idx="1784">
                  <c:v>29.081300010681097</c:v>
                </c:pt>
                <c:pt idx="1785">
                  <c:v>36.113700146675143</c:v>
                </c:pt>
                <c:pt idx="1786">
                  <c:v>32.884149732589698</c:v>
                </c:pt>
                <c:pt idx="1787">
                  <c:v>28.981750011444102</c:v>
                </c:pt>
                <c:pt idx="1788">
                  <c:v>18.961000170707749</c:v>
                </c:pt>
                <c:pt idx="1789">
                  <c:v>25.208800256252253</c:v>
                </c:pt>
                <c:pt idx="1790">
                  <c:v>20.767049798965445</c:v>
                </c:pt>
                <c:pt idx="1791">
                  <c:v>50.048099899291941</c:v>
                </c:pt>
                <c:pt idx="1792">
                  <c:v>44.992150077819907</c:v>
                </c:pt>
                <c:pt idx="1793">
                  <c:v>31.587900128364652</c:v>
                </c:pt>
                <c:pt idx="1794">
                  <c:v>37.835899868011452</c:v>
                </c:pt>
                <c:pt idx="1795">
                  <c:v>28.9475998878479</c:v>
                </c:pt>
                <c:pt idx="1796">
                  <c:v>20.981249828338647</c:v>
                </c:pt>
                <c:pt idx="1797">
                  <c:v>28.328449959754945</c:v>
                </c:pt>
                <c:pt idx="1798">
                  <c:v>24.491449866294801</c:v>
                </c:pt>
                <c:pt idx="1799">
                  <c:v>26.796649961471548</c:v>
                </c:pt>
                <c:pt idx="1800">
                  <c:v>43.312450060844355</c:v>
                </c:pt>
                <c:pt idx="1801">
                  <c:v>35.885550017356849</c:v>
                </c:pt>
                <c:pt idx="1802">
                  <c:v>32.761999979019208</c:v>
                </c:pt>
                <c:pt idx="1803">
                  <c:v>23.895649943351742</c:v>
                </c:pt>
                <c:pt idx="1804">
                  <c:v>20.707100067138654</c:v>
                </c:pt>
                <c:pt idx="1805">
                  <c:v>22.095199813842751</c:v>
                </c:pt>
                <c:pt idx="1806">
                  <c:v>24.709900078773451</c:v>
                </c:pt>
                <c:pt idx="1807">
                  <c:v>39.536149916648853</c:v>
                </c:pt>
                <c:pt idx="1808">
                  <c:v>21.937049965858446</c:v>
                </c:pt>
                <c:pt idx="1809">
                  <c:v>18.716100049018898</c:v>
                </c:pt>
                <c:pt idx="1810">
                  <c:v>32.289450020790099</c:v>
                </c:pt>
                <c:pt idx="1811">
                  <c:v>28.2860500526428</c:v>
                </c:pt>
                <c:pt idx="1812">
                  <c:v>23.875600275993346</c:v>
                </c:pt>
                <c:pt idx="1813">
                  <c:v>25.8582501935959</c:v>
                </c:pt>
                <c:pt idx="1814">
                  <c:v>31.498699841499295</c:v>
                </c:pt>
                <c:pt idx="1815">
                  <c:v>23.59170002937315</c:v>
                </c:pt>
                <c:pt idx="1816">
                  <c:v>48.079200134277301</c:v>
                </c:pt>
                <c:pt idx="1817">
                  <c:v>37.218449783325156</c:v>
                </c:pt>
                <c:pt idx="1818">
                  <c:v>30.595849566459702</c:v>
                </c:pt>
                <c:pt idx="1819">
                  <c:v>26.331549711227446</c:v>
                </c:pt>
                <c:pt idx="1820">
                  <c:v>40.711299719810505</c:v>
                </c:pt>
                <c:pt idx="1821">
                  <c:v>16.046799860000597</c:v>
                </c:pt>
                <c:pt idx="1822">
                  <c:v>49.843299906253847</c:v>
                </c:pt>
                <c:pt idx="1823">
                  <c:v>31.503549900054949</c:v>
                </c:pt>
                <c:pt idx="1824">
                  <c:v>34.500899791717551</c:v>
                </c:pt>
                <c:pt idx="1825">
                  <c:v>29.52759971618655</c:v>
                </c:pt>
                <c:pt idx="1826">
                  <c:v>14.686250100135805</c:v>
                </c:pt>
                <c:pt idx="1827">
                  <c:v>36.516599559783899</c:v>
                </c:pt>
                <c:pt idx="1828">
                  <c:v>20.5386499595642</c:v>
                </c:pt>
                <c:pt idx="1829">
                  <c:v>21.315550127029447</c:v>
                </c:pt>
                <c:pt idx="1830">
                  <c:v>24.499249973297097</c:v>
                </c:pt>
                <c:pt idx="1831">
                  <c:v>28.479800167083745</c:v>
                </c:pt>
                <c:pt idx="1832">
                  <c:v>26.560250210762003</c:v>
                </c:pt>
                <c:pt idx="1833">
                  <c:v>24.018950104713454</c:v>
                </c:pt>
                <c:pt idx="1834">
                  <c:v>15.681600260734552</c:v>
                </c:pt>
                <c:pt idx="1835">
                  <c:v>17.335950231552154</c:v>
                </c:pt>
                <c:pt idx="1836">
                  <c:v>27.920000038147002</c:v>
                </c:pt>
                <c:pt idx="1837">
                  <c:v>22.336799993515051</c:v>
                </c:pt>
                <c:pt idx="1838">
                  <c:v>14.348600034713698</c:v>
                </c:pt>
                <c:pt idx="1839">
                  <c:v>26.920999712944049</c:v>
                </c:pt>
                <c:pt idx="1840">
                  <c:v>34.429199724197403</c:v>
                </c:pt>
                <c:pt idx="1841">
                  <c:v>32.3875496673584</c:v>
                </c:pt>
                <c:pt idx="1842">
                  <c:v>37.629950175285352</c:v>
                </c:pt>
                <c:pt idx="1843">
                  <c:v>21.100599966049202</c:v>
                </c:pt>
                <c:pt idx="1844">
                  <c:v>25.442799744606049</c:v>
                </c:pt>
                <c:pt idx="1845">
                  <c:v>22.090999736785896</c:v>
                </c:pt>
                <c:pt idx="1846">
                  <c:v>24.15159994125365</c:v>
                </c:pt>
                <c:pt idx="1847">
                  <c:v>25.997950043678301</c:v>
                </c:pt>
                <c:pt idx="1848">
                  <c:v>20.280450110435453</c:v>
                </c:pt>
                <c:pt idx="1849">
                  <c:v>51.6336998414993</c:v>
                </c:pt>
                <c:pt idx="1850">
                  <c:v>15.890649809837356</c:v>
                </c:pt>
                <c:pt idx="1851">
                  <c:v>32.001450085640002</c:v>
                </c:pt>
                <c:pt idx="1852">
                  <c:v>41.839549746513399</c:v>
                </c:pt>
                <c:pt idx="1853">
                  <c:v>29.534099874496402</c:v>
                </c:pt>
                <c:pt idx="1854">
                  <c:v>24.644799861907948</c:v>
                </c:pt>
                <c:pt idx="1855">
                  <c:v>16.113350162506045</c:v>
                </c:pt>
                <c:pt idx="1856">
                  <c:v>11.809700131416299</c:v>
                </c:pt>
                <c:pt idx="1857">
                  <c:v>31.53369989395145</c:v>
                </c:pt>
                <c:pt idx="1858">
                  <c:v>26.860549798011803</c:v>
                </c:pt>
                <c:pt idx="1859">
                  <c:v>28.661800055503853</c:v>
                </c:pt>
                <c:pt idx="1860">
                  <c:v>36.018350048065201</c:v>
                </c:pt>
                <c:pt idx="1861">
                  <c:v>31.734899892807007</c:v>
                </c:pt>
                <c:pt idx="1862">
                  <c:v>33.310199527740508</c:v>
                </c:pt>
                <c:pt idx="1863">
                  <c:v>29.065949797630296</c:v>
                </c:pt>
                <c:pt idx="1864">
                  <c:v>32.651200017929106</c:v>
                </c:pt>
                <c:pt idx="1865">
                  <c:v>42.903899803161593</c:v>
                </c:pt>
                <c:pt idx="1866">
                  <c:v>19.2802998876572</c:v>
                </c:pt>
                <c:pt idx="1867">
                  <c:v>24.391600079536449</c:v>
                </c:pt>
                <c:pt idx="1868">
                  <c:v>19.128600163459794</c:v>
                </c:pt>
                <c:pt idx="1869">
                  <c:v>34.12889981269835</c:v>
                </c:pt>
                <c:pt idx="1870">
                  <c:v>46.133299899101246</c:v>
                </c:pt>
                <c:pt idx="1871">
                  <c:v>21.779249734878547</c:v>
                </c:pt>
                <c:pt idx="1872">
                  <c:v>27.632640103571298</c:v>
                </c:pt>
                <c:pt idx="1873">
                  <c:v>20.36325000762935</c:v>
                </c:pt>
                <c:pt idx="1874">
                  <c:v>33.488499650955205</c:v>
                </c:pt>
                <c:pt idx="1875">
                  <c:v>23.630100083351149</c:v>
                </c:pt>
                <c:pt idx="1876">
                  <c:v>35.439399995803853</c:v>
                </c:pt>
                <c:pt idx="1877">
                  <c:v>36.421200003623952</c:v>
                </c:pt>
                <c:pt idx="1878">
                  <c:v>25.938449964523357</c:v>
                </c:pt>
                <c:pt idx="1879">
                  <c:v>24.786399984359697</c:v>
                </c:pt>
                <c:pt idx="1880">
                  <c:v>18.7706001710892</c:v>
                </c:pt>
                <c:pt idx="1881">
                  <c:v>30.742850136756843</c:v>
                </c:pt>
                <c:pt idx="1882">
                  <c:v>24.904949908256498</c:v>
                </c:pt>
                <c:pt idx="1883">
                  <c:v>14.058099827766455</c:v>
                </c:pt>
                <c:pt idx="1884">
                  <c:v>32.5351999616623</c:v>
                </c:pt>
                <c:pt idx="1885">
                  <c:v>31.824399890899645</c:v>
                </c:pt>
                <c:pt idx="1886">
                  <c:v>23.218150000572152</c:v>
                </c:pt>
                <c:pt idx="1887">
                  <c:v>28.052199859619151</c:v>
                </c:pt>
                <c:pt idx="1888">
                  <c:v>21.911550054550151</c:v>
                </c:pt>
                <c:pt idx="1889">
                  <c:v>20.552550058364897</c:v>
                </c:pt>
                <c:pt idx="1890">
                  <c:v>35.247600126266505</c:v>
                </c:pt>
                <c:pt idx="1891">
                  <c:v>22.216299929618852</c:v>
                </c:pt>
                <c:pt idx="1892">
                  <c:v>51.819700083732549</c:v>
                </c:pt>
                <c:pt idx="1893">
                  <c:v>20.319250135421747</c:v>
                </c:pt>
                <c:pt idx="1894">
                  <c:v>21.585150194168101</c:v>
                </c:pt>
                <c:pt idx="1895">
                  <c:v>38.014250082969653</c:v>
                </c:pt>
                <c:pt idx="1896">
                  <c:v>32.8614999055862</c:v>
                </c:pt>
                <c:pt idx="1897">
                  <c:v>21.94609988212585</c:v>
                </c:pt>
                <c:pt idx="1898">
                  <c:v>16.181550078392</c:v>
                </c:pt>
                <c:pt idx="1899">
                  <c:v>26.377599787712096</c:v>
                </c:pt>
                <c:pt idx="1900">
                  <c:v>16.044550004005444</c:v>
                </c:pt>
                <c:pt idx="1901">
                  <c:v>18.615900106430047</c:v>
                </c:pt>
                <c:pt idx="1902">
                  <c:v>22.308700065612847</c:v>
                </c:pt>
                <c:pt idx="1903">
                  <c:v>28.868649678230248</c:v>
                </c:pt>
                <c:pt idx="1904">
                  <c:v>15.321249909400947</c:v>
                </c:pt>
                <c:pt idx="1905">
                  <c:v>23.384649705886851</c:v>
                </c:pt>
                <c:pt idx="1906">
                  <c:v>20.42874986171725</c:v>
                </c:pt>
                <c:pt idx="1907">
                  <c:v>22.983149991035454</c:v>
                </c:pt>
                <c:pt idx="1908">
                  <c:v>14.943100156784048</c:v>
                </c:pt>
                <c:pt idx="1909">
                  <c:v>32.35604999065395</c:v>
                </c:pt>
                <c:pt idx="1910">
                  <c:v>31.987899670600896</c:v>
                </c:pt>
                <c:pt idx="1911">
                  <c:v>37.763299803733801</c:v>
                </c:pt>
                <c:pt idx="1912">
                  <c:v>18.319150152206401</c:v>
                </c:pt>
                <c:pt idx="1913">
                  <c:v>30.645299887657195</c:v>
                </c:pt>
                <c:pt idx="1914">
                  <c:v>24.338200011253399</c:v>
                </c:pt>
                <c:pt idx="1915">
                  <c:v>32.2584998607636</c:v>
                </c:pt>
                <c:pt idx="1916">
                  <c:v>29.099249782562254</c:v>
                </c:pt>
                <c:pt idx="1917">
                  <c:v>16.7608498954773</c:v>
                </c:pt>
                <c:pt idx="1918">
                  <c:v>37.659499983787597</c:v>
                </c:pt>
                <c:pt idx="1919">
                  <c:v>19.781299605369604</c:v>
                </c:pt>
                <c:pt idx="1920">
                  <c:v>27.336949825286897</c:v>
                </c:pt>
                <c:pt idx="1921">
                  <c:v>35.875450010299595</c:v>
                </c:pt>
                <c:pt idx="1922">
                  <c:v>26.484299716949504</c:v>
                </c:pt>
                <c:pt idx="1923">
                  <c:v>27.630450000762949</c:v>
                </c:pt>
                <c:pt idx="1924">
                  <c:v>31.192649936676048</c:v>
                </c:pt>
                <c:pt idx="1925">
                  <c:v>25.1517000627518</c:v>
                </c:pt>
                <c:pt idx="1926">
                  <c:v>20.425549902916003</c:v>
                </c:pt>
                <c:pt idx="1927">
                  <c:v>21.594100027084302</c:v>
                </c:pt>
                <c:pt idx="1928">
                  <c:v>19.581400122642549</c:v>
                </c:pt>
                <c:pt idx="1929">
                  <c:v>23.958699893951405</c:v>
                </c:pt>
                <c:pt idx="1930">
                  <c:v>28.4475999689102</c:v>
                </c:pt>
                <c:pt idx="1931">
                  <c:v>24.230299777984644</c:v>
                </c:pt>
                <c:pt idx="1932">
                  <c:v>33.244400014877293</c:v>
                </c:pt>
                <c:pt idx="1933">
                  <c:v>30.387350020408697</c:v>
                </c:pt>
                <c:pt idx="1934">
                  <c:v>28.758649725913997</c:v>
                </c:pt>
                <c:pt idx="1935">
                  <c:v>22.766299777030952</c:v>
                </c:pt>
                <c:pt idx="1936">
                  <c:v>32.612399992942755</c:v>
                </c:pt>
                <c:pt idx="1937">
                  <c:v>29.737599844932546</c:v>
                </c:pt>
                <c:pt idx="1938">
                  <c:v>31.2929499387741</c:v>
                </c:pt>
                <c:pt idx="1939">
                  <c:v>32.028899683952304</c:v>
                </c:pt>
                <c:pt idx="1940">
                  <c:v>23.0380999565125</c:v>
                </c:pt>
                <c:pt idx="1941">
                  <c:v>42.64165008544925</c:v>
                </c:pt>
                <c:pt idx="1942">
                  <c:v>27.609349770545897</c:v>
                </c:pt>
                <c:pt idx="1943">
                  <c:v>20.258800039291394</c:v>
                </c:pt>
                <c:pt idx="1944">
                  <c:v>27.186600098609951</c:v>
                </c:pt>
                <c:pt idx="1945">
                  <c:v>9.886449809074449</c:v>
                </c:pt>
                <c:pt idx="1946">
                  <c:v>22.334350047111553</c:v>
                </c:pt>
                <c:pt idx="1947">
                  <c:v>38.387899665832506</c:v>
                </c:pt>
                <c:pt idx="1948">
                  <c:v>17.452000131607051</c:v>
                </c:pt>
                <c:pt idx="1949">
                  <c:v>20.143550181388846</c:v>
                </c:pt>
                <c:pt idx="1950">
                  <c:v>26.368200025558451</c:v>
                </c:pt>
                <c:pt idx="1951">
                  <c:v>26.434800124168405</c:v>
                </c:pt>
                <c:pt idx="1952">
                  <c:v>26.819849882125851</c:v>
                </c:pt>
                <c:pt idx="1953">
                  <c:v>18.907449893951451</c:v>
                </c:pt>
                <c:pt idx="1954">
                  <c:v>26.932200098037701</c:v>
                </c:pt>
                <c:pt idx="1955">
                  <c:v>33.649049983024554</c:v>
                </c:pt>
                <c:pt idx="1956">
                  <c:v>28.651400213241551</c:v>
                </c:pt>
                <c:pt idx="1957">
                  <c:v>26.887799868583649</c:v>
                </c:pt>
                <c:pt idx="1958">
                  <c:v>19.472800116539005</c:v>
                </c:pt>
                <c:pt idx="1959">
                  <c:v>19.2677998781204</c:v>
                </c:pt>
                <c:pt idx="1960">
                  <c:v>24.936749877929696</c:v>
                </c:pt>
                <c:pt idx="1961">
                  <c:v>31.373900032043451</c:v>
                </c:pt>
                <c:pt idx="1962">
                  <c:v>26.648850131034848</c:v>
                </c:pt>
                <c:pt idx="1963">
                  <c:v>33.326399888992256</c:v>
                </c:pt>
                <c:pt idx="1964">
                  <c:v>18.207000026702904</c:v>
                </c:pt>
                <c:pt idx="1965">
                  <c:v>26.595350394249003</c:v>
                </c:pt>
                <c:pt idx="1966">
                  <c:v>31.683199958801197</c:v>
                </c:pt>
                <c:pt idx="1967">
                  <c:v>33.881049799919097</c:v>
                </c:pt>
                <c:pt idx="1968">
                  <c:v>28.391350164413502</c:v>
                </c:pt>
                <c:pt idx="1969">
                  <c:v>38.955799770355249</c:v>
                </c:pt>
                <c:pt idx="1970">
                  <c:v>35.288649873733554</c:v>
                </c:pt>
                <c:pt idx="1971">
                  <c:v>19.281300106048601</c:v>
                </c:pt>
                <c:pt idx="1972">
                  <c:v>32.476999711990345</c:v>
                </c:pt>
                <c:pt idx="1973">
                  <c:v>24.812449932098403</c:v>
                </c:pt>
                <c:pt idx="1974">
                  <c:v>27.404799604415899</c:v>
                </c:pt>
                <c:pt idx="1975">
                  <c:v>22.835500097274803</c:v>
                </c:pt>
                <c:pt idx="1976">
                  <c:v>18.76354992389685</c:v>
                </c:pt>
                <c:pt idx="1977">
                  <c:v>26.95160010814665</c:v>
                </c:pt>
                <c:pt idx="1978">
                  <c:v>27.698049898147548</c:v>
                </c:pt>
                <c:pt idx="1979">
                  <c:v>24.231188545082503</c:v>
                </c:pt>
                <c:pt idx="1980">
                  <c:v>15.159750075340298</c:v>
                </c:pt>
                <c:pt idx="1981">
                  <c:v>23.824949812889145</c:v>
                </c:pt>
                <c:pt idx="1982">
                  <c:v>27.8247998523712</c:v>
                </c:pt>
                <c:pt idx="1983">
                  <c:v>29.77624992370605</c:v>
                </c:pt>
                <c:pt idx="1984">
                  <c:v>19.942599873542754</c:v>
                </c:pt>
                <c:pt idx="1985">
                  <c:v>21.646250014305103</c:v>
                </c:pt>
                <c:pt idx="1986">
                  <c:v>33.787499761581451</c:v>
                </c:pt>
                <c:pt idx="1987">
                  <c:v>27.839949669838006</c:v>
                </c:pt>
                <c:pt idx="1988">
                  <c:v>22.313449940681451</c:v>
                </c:pt>
                <c:pt idx="1989">
                  <c:v>29.188649897575395</c:v>
                </c:pt>
                <c:pt idx="1990">
                  <c:v>23.191600050926194</c:v>
                </c:pt>
                <c:pt idx="1991">
                  <c:v>21.313299798965446</c:v>
                </c:pt>
                <c:pt idx="1992">
                  <c:v>23.768799943923948</c:v>
                </c:pt>
                <c:pt idx="1993">
                  <c:v>26.832000198364248</c:v>
                </c:pt>
                <c:pt idx="1994">
                  <c:v>20.312099962234498</c:v>
                </c:pt>
                <c:pt idx="1995">
                  <c:v>28.663300161361747</c:v>
                </c:pt>
                <c:pt idx="1996">
                  <c:v>26.378599848747303</c:v>
                </c:pt>
                <c:pt idx="1997">
                  <c:v>27.041650052070651</c:v>
                </c:pt>
                <c:pt idx="1998">
                  <c:v>23.516900110244748</c:v>
                </c:pt>
                <c:pt idx="1999">
                  <c:v>35.068849844932551</c:v>
                </c:pt>
                <c:pt idx="2000">
                  <c:v>22.608049788475054</c:v>
                </c:pt>
                <c:pt idx="2001">
                  <c:v>32.384749708175647</c:v>
                </c:pt>
                <c:pt idx="2002">
                  <c:v>27.808300089836148</c:v>
                </c:pt>
                <c:pt idx="2003">
                  <c:v>23.888249993324301</c:v>
                </c:pt>
                <c:pt idx="2004">
                  <c:v>15.691399970054704</c:v>
                </c:pt>
                <c:pt idx="2005">
                  <c:v>32.679500079154955</c:v>
                </c:pt>
                <c:pt idx="2006">
                  <c:v>23.859449810981754</c:v>
                </c:pt>
                <c:pt idx="2007">
                  <c:v>28.524099888801544</c:v>
                </c:pt>
                <c:pt idx="2008">
                  <c:v>35.668749947547902</c:v>
                </c:pt>
                <c:pt idx="2009">
                  <c:v>25.698149771690403</c:v>
                </c:pt>
                <c:pt idx="2010">
                  <c:v>24.187549905776997</c:v>
                </c:pt>
                <c:pt idx="2011">
                  <c:v>25.325149595737454</c:v>
                </c:pt>
                <c:pt idx="2012">
                  <c:v>30.361099743843052</c:v>
                </c:pt>
                <c:pt idx="2013">
                  <c:v>19.422600145339949</c:v>
                </c:pt>
                <c:pt idx="2014">
                  <c:v>24.36844988822935</c:v>
                </c:pt>
                <c:pt idx="2015">
                  <c:v>15.889500246048001</c:v>
                </c:pt>
                <c:pt idx="2016">
                  <c:v>42.5850497341156</c:v>
                </c:pt>
                <c:pt idx="2017">
                  <c:v>41.188299965858455</c:v>
                </c:pt>
                <c:pt idx="2018">
                  <c:v>20.380350179672199</c:v>
                </c:pt>
                <c:pt idx="2019">
                  <c:v>26.122549867629999</c:v>
                </c:pt>
                <c:pt idx="2020">
                  <c:v>25.197149724960294</c:v>
                </c:pt>
                <c:pt idx="2021">
                  <c:v>21.072250084877048</c:v>
                </c:pt>
                <c:pt idx="2022">
                  <c:v>8.8706997346877969</c:v>
                </c:pt>
                <c:pt idx="2023">
                  <c:v>36.044049849510202</c:v>
                </c:pt>
                <c:pt idx="2024">
                  <c:v>29.583049893379204</c:v>
                </c:pt>
                <c:pt idx="2025">
                  <c:v>35.395549788475051</c:v>
                </c:pt>
                <c:pt idx="2026">
                  <c:v>49.272549915313746</c:v>
                </c:pt>
                <c:pt idx="2027">
                  <c:v>20.487900061607299</c:v>
                </c:pt>
                <c:pt idx="2028">
                  <c:v>35.810049872398352</c:v>
                </c:pt>
                <c:pt idx="2029">
                  <c:v>23.433249998092645</c:v>
                </c:pt>
                <c:pt idx="2030">
                  <c:v>35.348299670219397</c:v>
                </c:pt>
                <c:pt idx="2031">
                  <c:v>38.824999980926499</c:v>
                </c:pt>
                <c:pt idx="2032">
                  <c:v>27.035699834823646</c:v>
                </c:pt>
                <c:pt idx="2033">
                  <c:v>24.260749936103849</c:v>
                </c:pt>
                <c:pt idx="2034">
                  <c:v>25.72949979305265</c:v>
                </c:pt>
                <c:pt idx="2035">
                  <c:v>19.206300368308998</c:v>
                </c:pt>
                <c:pt idx="2036">
                  <c:v>12.423449983596743</c:v>
                </c:pt>
                <c:pt idx="2037">
                  <c:v>31.473300008773851</c:v>
                </c:pt>
                <c:pt idx="2038">
                  <c:v>21.297650275230399</c:v>
                </c:pt>
                <c:pt idx="2039">
                  <c:v>29.327200069427448</c:v>
                </c:pt>
                <c:pt idx="2040">
                  <c:v>20.988349719047498</c:v>
                </c:pt>
                <c:pt idx="2041">
                  <c:v>29.445099639892597</c:v>
                </c:pt>
                <c:pt idx="2042">
                  <c:v>34.889399585723908</c:v>
                </c:pt>
                <c:pt idx="2043">
                  <c:v>25.252350001335145</c:v>
                </c:pt>
                <c:pt idx="2044">
                  <c:v>26.700000038146953</c:v>
                </c:pt>
                <c:pt idx="2045">
                  <c:v>22.706299729347201</c:v>
                </c:pt>
                <c:pt idx="2046">
                  <c:v>25.278099946975704</c:v>
                </c:pt>
                <c:pt idx="2047">
                  <c:v>22.455350184440604</c:v>
                </c:pt>
                <c:pt idx="2048">
                  <c:v>26.89259971141815</c:v>
                </c:pt>
                <c:pt idx="2049">
                  <c:v>16.878750195503205</c:v>
                </c:pt>
                <c:pt idx="2050">
                  <c:v>19.148649988174448</c:v>
                </c:pt>
                <c:pt idx="2051">
                  <c:v>18.782450175285298</c:v>
                </c:pt>
                <c:pt idx="2052">
                  <c:v>18.453599739074697</c:v>
                </c:pt>
                <c:pt idx="2053">
                  <c:v>26.671599850654601</c:v>
                </c:pt>
                <c:pt idx="2054">
                  <c:v>19.163699865341194</c:v>
                </c:pt>
                <c:pt idx="2055">
                  <c:v>34.5128999423981</c:v>
                </c:pt>
                <c:pt idx="2056">
                  <c:v>19.726050128936752</c:v>
                </c:pt>
                <c:pt idx="2057">
                  <c:v>46.096449804306054</c:v>
                </c:pt>
                <c:pt idx="2058">
                  <c:v>31.47294977664945</c:v>
                </c:pt>
                <c:pt idx="2059">
                  <c:v>36.217850131988556</c:v>
                </c:pt>
                <c:pt idx="2060">
                  <c:v>20.169200315475454</c:v>
                </c:pt>
                <c:pt idx="2061">
                  <c:v>36.658949656486499</c:v>
                </c:pt>
                <c:pt idx="2062">
                  <c:v>21.514199919700602</c:v>
                </c:pt>
                <c:pt idx="2063">
                  <c:v>35.361950039863551</c:v>
                </c:pt>
                <c:pt idx="2064">
                  <c:v>29.575499978065501</c:v>
                </c:pt>
                <c:pt idx="2065">
                  <c:v>14.487600116729702</c:v>
                </c:pt>
                <c:pt idx="2066">
                  <c:v>25.272099738121</c:v>
                </c:pt>
                <c:pt idx="2067">
                  <c:v>39.274649705886844</c:v>
                </c:pt>
                <c:pt idx="2068">
                  <c:v>21.856900105476399</c:v>
                </c:pt>
                <c:pt idx="2069">
                  <c:v>-26.421799914240815</c:v>
                </c:pt>
                <c:pt idx="2070">
                  <c:v>24.510650038719202</c:v>
                </c:pt>
                <c:pt idx="2071">
                  <c:v>33.441849751472446</c:v>
                </c:pt>
                <c:pt idx="2072">
                  <c:v>29.284849789142648</c:v>
                </c:pt>
                <c:pt idx="2073">
                  <c:v>13.986300024986249</c:v>
                </c:pt>
                <c:pt idx="2074">
                  <c:v>16.519099950790398</c:v>
                </c:pt>
                <c:pt idx="2075">
                  <c:v>19.925949835777306</c:v>
                </c:pt>
                <c:pt idx="2076">
                  <c:v>28.798450045585646</c:v>
                </c:pt>
                <c:pt idx="2077">
                  <c:v>52.128949885368357</c:v>
                </c:pt>
                <c:pt idx="2078">
                  <c:v>15.881650142669656</c:v>
                </c:pt>
                <c:pt idx="2079">
                  <c:v>20.862849855422951</c:v>
                </c:pt>
                <c:pt idx="2080">
                  <c:v>18.333150167465195</c:v>
                </c:pt>
                <c:pt idx="2081">
                  <c:v>34.837450213432348</c:v>
                </c:pt>
                <c:pt idx="2082">
                  <c:v>29.212950077056952</c:v>
                </c:pt>
                <c:pt idx="2083">
                  <c:v>25.899950118064851</c:v>
                </c:pt>
                <c:pt idx="2084">
                  <c:v>30.808350143432598</c:v>
                </c:pt>
                <c:pt idx="2085">
                  <c:v>26.352349872589208</c:v>
                </c:pt>
                <c:pt idx="2086">
                  <c:v>27.906799831390401</c:v>
                </c:pt>
                <c:pt idx="2087">
                  <c:v>21.179099936485301</c:v>
                </c:pt>
                <c:pt idx="2088">
                  <c:v>11.157049980163549</c:v>
                </c:pt>
                <c:pt idx="2089">
                  <c:v>32.517399847507505</c:v>
                </c:pt>
                <c:pt idx="2090">
                  <c:v>24.677049860954298</c:v>
                </c:pt>
                <c:pt idx="2091">
                  <c:v>26.273449864387494</c:v>
                </c:pt>
                <c:pt idx="2092">
                  <c:v>14.316150083541899</c:v>
                </c:pt>
                <c:pt idx="2093">
                  <c:v>27.847349882125847</c:v>
                </c:pt>
                <c:pt idx="2094">
                  <c:v>30.944999961853</c:v>
                </c:pt>
                <c:pt idx="2095">
                  <c:v>15.254500131607053</c:v>
                </c:pt>
                <c:pt idx="2096">
                  <c:v>25.50544985294345</c:v>
                </c:pt>
                <c:pt idx="2097">
                  <c:v>23.995549955368052</c:v>
                </c:pt>
                <c:pt idx="2098">
                  <c:v>32.437549920082098</c:v>
                </c:pt>
                <c:pt idx="2099">
                  <c:v>19.977850136756899</c:v>
                </c:pt>
                <c:pt idx="2100">
                  <c:v>24.632100329399101</c:v>
                </c:pt>
                <c:pt idx="2101">
                  <c:v>21.877000093460055</c:v>
                </c:pt>
                <c:pt idx="2102">
                  <c:v>26.219949908256545</c:v>
                </c:pt>
                <c:pt idx="2103">
                  <c:v>44.36159978866575</c:v>
                </c:pt>
                <c:pt idx="2104">
                  <c:v>33.895049934387202</c:v>
                </c:pt>
                <c:pt idx="2105">
                  <c:v>19.554499955177249</c:v>
                </c:pt>
                <c:pt idx="2106">
                  <c:v>25.184749917984004</c:v>
                </c:pt>
                <c:pt idx="2107">
                  <c:v>24.825849876403797</c:v>
                </c:pt>
                <c:pt idx="2108">
                  <c:v>38.433600330352803</c:v>
                </c:pt>
                <c:pt idx="2109">
                  <c:v>22.927899932861301</c:v>
                </c:pt>
                <c:pt idx="2110">
                  <c:v>17.572599802017251</c:v>
                </c:pt>
                <c:pt idx="2111">
                  <c:v>30.65654982566835</c:v>
                </c:pt>
                <c:pt idx="2112">
                  <c:v>34.137249794006294</c:v>
                </c:pt>
                <c:pt idx="2113">
                  <c:v>24.200949974060048</c:v>
                </c:pt>
                <c:pt idx="2114">
                  <c:v>29.53639966487885</c:v>
                </c:pt>
                <c:pt idx="2115">
                  <c:v>22.622349896430954</c:v>
                </c:pt>
                <c:pt idx="2116">
                  <c:v>24.805149927139301</c:v>
                </c:pt>
                <c:pt idx="2117">
                  <c:v>21.287899990081797</c:v>
                </c:pt>
                <c:pt idx="2118">
                  <c:v>23.095400037765508</c:v>
                </c:pt>
                <c:pt idx="2119">
                  <c:v>25.0782500076294</c:v>
                </c:pt>
                <c:pt idx="2120">
                  <c:v>26.295150279998801</c:v>
                </c:pt>
                <c:pt idx="2121">
                  <c:v>18.462700290679905</c:v>
                </c:pt>
                <c:pt idx="2122">
                  <c:v>12.372799987792952</c:v>
                </c:pt>
                <c:pt idx="2123">
                  <c:v>24.328700098991348</c:v>
                </c:pt>
                <c:pt idx="2124">
                  <c:v>17.176900033950808</c:v>
                </c:pt>
                <c:pt idx="2125">
                  <c:v>25.5744998645782</c:v>
                </c:pt>
                <c:pt idx="2126">
                  <c:v>37.6658498430252</c:v>
                </c:pt>
                <c:pt idx="2127">
                  <c:v>18.276300063133299</c:v>
                </c:pt>
                <c:pt idx="2128">
                  <c:v>39.891949763298044</c:v>
                </c:pt>
                <c:pt idx="2129">
                  <c:v>19.491449770927495</c:v>
                </c:pt>
                <c:pt idx="2130">
                  <c:v>36.559149641990643</c:v>
                </c:pt>
                <c:pt idx="2131">
                  <c:v>23.36604994297025</c:v>
                </c:pt>
                <c:pt idx="2132">
                  <c:v>16.717799892425504</c:v>
                </c:pt>
                <c:pt idx="2133">
                  <c:v>22.614699892997749</c:v>
                </c:pt>
                <c:pt idx="2134">
                  <c:v>36.245749731063846</c:v>
                </c:pt>
                <c:pt idx="2135">
                  <c:v>21.908149671554551</c:v>
                </c:pt>
                <c:pt idx="2136">
                  <c:v>22.0423003005981</c:v>
                </c:pt>
                <c:pt idx="2137">
                  <c:v>34.477499704360952</c:v>
                </c:pt>
                <c:pt idx="2138">
                  <c:v>35.325049762725754</c:v>
                </c:pt>
                <c:pt idx="2139">
                  <c:v>23.312100176811249</c:v>
                </c:pt>
                <c:pt idx="2140">
                  <c:v>27.663749828338602</c:v>
                </c:pt>
                <c:pt idx="2141">
                  <c:v>21.446400051116999</c:v>
                </c:pt>
                <c:pt idx="2142">
                  <c:v>17.827850027084303</c:v>
                </c:pt>
                <c:pt idx="2143">
                  <c:v>27.140049805641151</c:v>
                </c:pt>
                <c:pt idx="2144">
                  <c:v>22.331000308990497</c:v>
                </c:pt>
                <c:pt idx="2145">
                  <c:v>32.638049759864749</c:v>
                </c:pt>
                <c:pt idx="2146">
                  <c:v>27.885099906921397</c:v>
                </c:pt>
                <c:pt idx="2147">
                  <c:v>20.847649941444352</c:v>
                </c:pt>
                <c:pt idx="2148">
                  <c:v>29.560699658393901</c:v>
                </c:pt>
                <c:pt idx="2149">
                  <c:v>20.759899959564255</c:v>
                </c:pt>
                <c:pt idx="2150">
                  <c:v>29.498749794960048</c:v>
                </c:pt>
                <c:pt idx="2151">
                  <c:v>19.684299921989446</c:v>
                </c:pt>
                <c:pt idx="2152">
                  <c:v>21.415499973297099</c:v>
                </c:pt>
                <c:pt idx="2153">
                  <c:v>21.061349883079497</c:v>
                </c:pt>
                <c:pt idx="2154">
                  <c:v>28.612749853134151</c:v>
                </c:pt>
                <c:pt idx="2155">
                  <c:v>28.139949955940303</c:v>
                </c:pt>
                <c:pt idx="2156">
                  <c:v>18.600550098419149</c:v>
                </c:pt>
                <c:pt idx="2157">
                  <c:v>12.825799956321696</c:v>
                </c:pt>
                <c:pt idx="2158">
                  <c:v>20.222700080871547</c:v>
                </c:pt>
                <c:pt idx="2159">
                  <c:v>19.895150074958849</c:v>
                </c:pt>
                <c:pt idx="2160">
                  <c:v>42.969199752807597</c:v>
                </c:pt>
                <c:pt idx="2161">
                  <c:v>24.316300177574099</c:v>
                </c:pt>
                <c:pt idx="2162">
                  <c:v>20.858649983406103</c:v>
                </c:pt>
                <c:pt idx="2163">
                  <c:v>29.755350127220147</c:v>
                </c:pt>
                <c:pt idx="2164">
                  <c:v>15.087099871635449</c:v>
                </c:pt>
                <c:pt idx="2165">
                  <c:v>18.709749984741254</c:v>
                </c:pt>
                <c:pt idx="2166">
                  <c:v>23.08404973506925</c:v>
                </c:pt>
                <c:pt idx="2167">
                  <c:v>27.965599784851094</c:v>
                </c:pt>
                <c:pt idx="2168">
                  <c:v>13.518950076103202</c:v>
                </c:pt>
                <c:pt idx="2169">
                  <c:v>20.925700106620802</c:v>
                </c:pt>
                <c:pt idx="2170">
                  <c:v>22.294300203323399</c:v>
                </c:pt>
                <c:pt idx="2171">
                  <c:v>21.521899647712704</c:v>
                </c:pt>
                <c:pt idx="2172">
                  <c:v>24.821799707412698</c:v>
                </c:pt>
                <c:pt idx="2173">
                  <c:v>12.211900029182402</c:v>
                </c:pt>
                <c:pt idx="2174">
                  <c:v>21.023300375938401</c:v>
                </c:pt>
                <c:pt idx="2175">
                  <c:v>26.140500082969648</c:v>
                </c:pt>
                <c:pt idx="2176">
                  <c:v>29.597149868011499</c:v>
                </c:pt>
                <c:pt idx="2177">
                  <c:v>44.577299809455901</c:v>
                </c:pt>
                <c:pt idx="2178">
                  <c:v>26.364650165438601</c:v>
                </c:pt>
                <c:pt idx="2179">
                  <c:v>26.364650165438601</c:v>
                </c:pt>
                <c:pt idx="2180">
                  <c:v>35.966099815368651</c:v>
                </c:pt>
                <c:pt idx="2181">
                  <c:v>37.370149617195153</c:v>
                </c:pt>
                <c:pt idx="2182">
                  <c:v>30.311399750709452</c:v>
                </c:pt>
                <c:pt idx="2183">
                  <c:v>21.078949961662303</c:v>
                </c:pt>
                <c:pt idx="2184">
                  <c:v>18.9397501325607</c:v>
                </c:pt>
                <c:pt idx="2185">
                  <c:v>33.5043500328064</c:v>
                </c:pt>
                <c:pt idx="2186">
                  <c:v>29.629650006294256</c:v>
                </c:pt>
                <c:pt idx="2187">
                  <c:v>23.24475005149845</c:v>
                </c:pt>
                <c:pt idx="2188">
                  <c:v>16.471949810981805</c:v>
                </c:pt>
                <c:pt idx="2189">
                  <c:v>25.854149909019455</c:v>
                </c:pt>
                <c:pt idx="2190">
                  <c:v>16.655699982643149</c:v>
                </c:pt>
                <c:pt idx="2191">
                  <c:v>19.304049844741847</c:v>
                </c:pt>
                <c:pt idx="2192">
                  <c:v>24.041600074768049</c:v>
                </c:pt>
                <c:pt idx="2193">
                  <c:v>18.479050035476696</c:v>
                </c:pt>
                <c:pt idx="2194">
                  <c:v>23.753899869918794</c:v>
                </c:pt>
                <c:pt idx="2195">
                  <c:v>24.951499967575053</c:v>
                </c:pt>
                <c:pt idx="2196">
                  <c:v>37.333549809455896</c:v>
                </c:pt>
                <c:pt idx="2197">
                  <c:v>18.449000210762001</c:v>
                </c:pt>
                <c:pt idx="2198">
                  <c:v>18.053849916458098</c:v>
                </c:pt>
                <c:pt idx="2199">
                  <c:v>15.349600005149849</c:v>
                </c:pt>
                <c:pt idx="2200">
                  <c:v>23.049899973869302</c:v>
                </c:pt>
                <c:pt idx="2201">
                  <c:v>30.530050058364846</c:v>
                </c:pt>
                <c:pt idx="2202">
                  <c:v>21.461449794769294</c:v>
                </c:pt>
                <c:pt idx="2203">
                  <c:v>27.61124995231625</c:v>
                </c:pt>
                <c:pt idx="2204">
                  <c:v>24.690449910163899</c:v>
                </c:pt>
                <c:pt idx="2205">
                  <c:v>36.727549903392791</c:v>
                </c:pt>
                <c:pt idx="2206">
                  <c:v>32.112149715423598</c:v>
                </c:pt>
                <c:pt idx="2207">
                  <c:v>16.111600031852657</c:v>
                </c:pt>
                <c:pt idx="2208">
                  <c:v>32.549150037765507</c:v>
                </c:pt>
                <c:pt idx="2209">
                  <c:v>22.356199736595151</c:v>
                </c:pt>
                <c:pt idx="2210">
                  <c:v>19.356850042343105</c:v>
                </c:pt>
                <c:pt idx="2211">
                  <c:v>32.258949971199051</c:v>
                </c:pt>
                <c:pt idx="2212">
                  <c:v>22.673700118064893</c:v>
                </c:pt>
                <c:pt idx="2213">
                  <c:v>26.195299830436703</c:v>
                </c:pt>
                <c:pt idx="2214">
                  <c:v>29.722550029754654</c:v>
                </c:pt>
                <c:pt idx="2215">
                  <c:v>28.716749882698053</c:v>
                </c:pt>
                <c:pt idx="2216">
                  <c:v>22.366650104522751</c:v>
                </c:pt>
                <c:pt idx="2217">
                  <c:v>19.278050179481546</c:v>
                </c:pt>
                <c:pt idx="2218">
                  <c:v>30.2323497343063</c:v>
                </c:pt>
                <c:pt idx="2219">
                  <c:v>32.557849702835107</c:v>
                </c:pt>
                <c:pt idx="2220">
                  <c:v>22.210550212860099</c:v>
                </c:pt>
                <c:pt idx="2221">
                  <c:v>29.397049775123556</c:v>
                </c:pt>
                <c:pt idx="2222">
                  <c:v>23.0422997999191</c:v>
                </c:pt>
                <c:pt idx="2223">
                  <c:v>21.623400182723994</c:v>
                </c:pt>
                <c:pt idx="2224">
                  <c:v>21.122699851989751</c:v>
                </c:pt>
                <c:pt idx="2225">
                  <c:v>22.024049897193947</c:v>
                </c:pt>
                <c:pt idx="2226">
                  <c:v>28.3675498056412</c:v>
                </c:pt>
                <c:pt idx="2227">
                  <c:v>26.435899939537045</c:v>
                </c:pt>
                <c:pt idx="2228">
                  <c:v>23.103249874115001</c:v>
                </c:pt>
                <c:pt idx="2229">
                  <c:v>19.451800265312201</c:v>
                </c:pt>
                <c:pt idx="2230">
                  <c:v>23.471449837684599</c:v>
                </c:pt>
                <c:pt idx="2231">
                  <c:v>31.218849749565152</c:v>
                </c:pt>
                <c:pt idx="2232">
                  <c:v>20.093050012588456</c:v>
                </c:pt>
                <c:pt idx="2233">
                  <c:v>18.648500161171</c:v>
                </c:pt>
                <c:pt idx="2234">
                  <c:v>16.981500091552746</c:v>
                </c:pt>
                <c:pt idx="2235">
                  <c:v>19.830900349616943</c:v>
                </c:pt>
                <c:pt idx="2236">
                  <c:v>7.4365498113632</c:v>
                </c:pt>
                <c:pt idx="2237">
                  <c:v>19.599100022315952</c:v>
                </c:pt>
                <c:pt idx="2238">
                  <c:v>21.868900070190403</c:v>
                </c:pt>
                <c:pt idx="2239">
                  <c:v>34.523949594497651</c:v>
                </c:pt>
                <c:pt idx="2240">
                  <c:v>18.228549990654052</c:v>
                </c:pt>
                <c:pt idx="2241">
                  <c:v>33.78529980659485</c:v>
                </c:pt>
                <c:pt idx="2242">
                  <c:v>27.834849667549143</c:v>
                </c:pt>
                <c:pt idx="2243">
                  <c:v>24.76625011444095</c:v>
                </c:pt>
                <c:pt idx="2244">
                  <c:v>35.685900144577055</c:v>
                </c:pt>
                <c:pt idx="2245">
                  <c:v>18.940500054359408</c:v>
                </c:pt>
                <c:pt idx="2246">
                  <c:v>28.24724978685375</c:v>
                </c:pt>
                <c:pt idx="2247">
                  <c:v>24.119500031471254</c:v>
                </c:pt>
                <c:pt idx="2248">
                  <c:v>29.687249979972847</c:v>
                </c:pt>
                <c:pt idx="2249">
                  <c:v>30.985849761962854</c:v>
                </c:pt>
                <c:pt idx="2250">
                  <c:v>27.279900093078602</c:v>
                </c:pt>
                <c:pt idx="2251">
                  <c:v>27.228149995803847</c:v>
                </c:pt>
                <c:pt idx="2252">
                  <c:v>23.878849906921396</c:v>
                </c:pt>
                <c:pt idx="2253">
                  <c:v>28.989899778366098</c:v>
                </c:pt>
                <c:pt idx="2254">
                  <c:v>27.976949844360401</c:v>
                </c:pt>
                <c:pt idx="2255">
                  <c:v>31.20864970684055</c:v>
                </c:pt>
                <c:pt idx="2256">
                  <c:v>18.706650099754349</c:v>
                </c:pt>
                <c:pt idx="2257">
                  <c:v>27.138199982643151</c:v>
                </c:pt>
                <c:pt idx="2258">
                  <c:v>12.182950029373153</c:v>
                </c:pt>
                <c:pt idx="2259">
                  <c:v>25.689349994659445</c:v>
                </c:pt>
                <c:pt idx="2260">
                  <c:v>24.710799875259401</c:v>
                </c:pt>
                <c:pt idx="2261">
                  <c:v>20.847749915122954</c:v>
                </c:pt>
                <c:pt idx="2262">
                  <c:v>25.384999785423297</c:v>
                </c:pt>
                <c:pt idx="2263">
                  <c:v>27.151899738311748</c:v>
                </c:pt>
                <c:pt idx="2264">
                  <c:v>33.598899884223897</c:v>
                </c:pt>
                <c:pt idx="2265">
                  <c:v>33.953299822807303</c:v>
                </c:pt>
                <c:pt idx="2266">
                  <c:v>21.217250056266799</c:v>
                </c:pt>
                <c:pt idx="2267">
                  <c:v>30.078799982070905</c:v>
                </c:pt>
                <c:pt idx="2268">
                  <c:v>22.083849797248845</c:v>
                </c:pt>
                <c:pt idx="2269">
                  <c:v>22.623849992752096</c:v>
                </c:pt>
                <c:pt idx="2270">
                  <c:v>27.504249715805049</c:v>
                </c:pt>
                <c:pt idx="2271">
                  <c:v>23.633200097084046</c:v>
                </c:pt>
                <c:pt idx="2272">
                  <c:v>17.514950060844399</c:v>
                </c:pt>
                <c:pt idx="2273">
                  <c:v>33.737000169754047</c:v>
                </c:pt>
                <c:pt idx="2274">
                  <c:v>31.148349847793554</c:v>
                </c:pt>
                <c:pt idx="2275">
                  <c:v>20.223299856185953</c:v>
                </c:pt>
                <c:pt idx="2276">
                  <c:v>20.113250102996897</c:v>
                </c:pt>
                <c:pt idx="2277">
                  <c:v>31.547299766540547</c:v>
                </c:pt>
                <c:pt idx="2278">
                  <c:v>14.330949993133498</c:v>
                </c:pt>
                <c:pt idx="2279">
                  <c:v>37.619849700927752</c:v>
                </c:pt>
                <c:pt idx="2280">
                  <c:v>30.625649785995503</c:v>
                </c:pt>
                <c:pt idx="2281">
                  <c:v>20.7356499767304</c:v>
                </c:pt>
                <c:pt idx="2282">
                  <c:v>19.304200110435502</c:v>
                </c:pt>
                <c:pt idx="2283">
                  <c:v>20.636250195503251</c:v>
                </c:pt>
                <c:pt idx="2284">
                  <c:v>19.268900051116947</c:v>
                </c:pt>
                <c:pt idx="2285">
                  <c:v>14.172149887084899</c:v>
                </c:pt>
                <c:pt idx="2286">
                  <c:v>20.393399868011453</c:v>
                </c:pt>
                <c:pt idx="2287">
                  <c:v>16.336499910354593</c:v>
                </c:pt>
                <c:pt idx="2288">
                  <c:v>25.448500080108602</c:v>
                </c:pt>
                <c:pt idx="2289">
                  <c:v>26.396399879455604</c:v>
                </c:pt>
                <c:pt idx="2290">
                  <c:v>35.488649635314999</c:v>
                </c:pt>
                <c:pt idx="2291">
                  <c:v>28.011699719429004</c:v>
                </c:pt>
                <c:pt idx="2292">
                  <c:v>25.759650139808649</c:v>
                </c:pt>
                <c:pt idx="2293">
                  <c:v>36.036399893760702</c:v>
                </c:pt>
                <c:pt idx="2294">
                  <c:v>25.670199899673502</c:v>
                </c:pt>
                <c:pt idx="2295">
                  <c:v>19.2238500738144</c:v>
                </c:pt>
                <c:pt idx="2296">
                  <c:v>25.070199999809251</c:v>
                </c:pt>
                <c:pt idx="2297">
                  <c:v>26.523400130271902</c:v>
                </c:pt>
                <c:pt idx="2298">
                  <c:v>27.548600091934198</c:v>
                </c:pt>
                <c:pt idx="2299">
                  <c:v>20.098749933242797</c:v>
                </c:pt>
                <c:pt idx="2300">
                  <c:v>23.99065001487735</c:v>
                </c:pt>
                <c:pt idx="2301">
                  <c:v>31.829399762153656</c:v>
                </c:pt>
                <c:pt idx="2302">
                  <c:v>21.953450098037699</c:v>
                </c:pt>
                <c:pt idx="2303">
                  <c:v>23.072299818992647</c:v>
                </c:pt>
                <c:pt idx="2304">
                  <c:v>31.8517997407913</c:v>
                </c:pt>
                <c:pt idx="2305">
                  <c:v>15.047899999618547</c:v>
                </c:pt>
                <c:pt idx="2306">
                  <c:v>48.533650012016253</c:v>
                </c:pt>
                <c:pt idx="2307">
                  <c:v>28.592150087356551</c:v>
                </c:pt>
                <c:pt idx="2308">
                  <c:v>20.807650156021104</c:v>
                </c:pt>
                <c:pt idx="2309">
                  <c:v>30.769349722862255</c:v>
                </c:pt>
                <c:pt idx="2310">
                  <c:v>21.393799796104449</c:v>
                </c:pt>
                <c:pt idx="2311">
                  <c:v>16.197300238609351</c:v>
                </c:pt>
                <c:pt idx="2312">
                  <c:v>20.478500103950502</c:v>
                </c:pt>
                <c:pt idx="2313">
                  <c:v>25.142099819183297</c:v>
                </c:pt>
                <c:pt idx="2314">
                  <c:v>27.8687500143051</c:v>
                </c:pt>
                <c:pt idx="2315">
                  <c:v>25.730200076103195</c:v>
                </c:pt>
                <c:pt idx="2316">
                  <c:v>17.93180001258845</c:v>
                </c:pt>
                <c:pt idx="2317">
                  <c:v>8.0055000972748047</c:v>
                </c:pt>
                <c:pt idx="2318">
                  <c:v>22.072399916648898</c:v>
                </c:pt>
                <c:pt idx="2319">
                  <c:v>30.652399840354953</c:v>
                </c:pt>
                <c:pt idx="2320">
                  <c:v>33.586499967575051</c:v>
                </c:pt>
                <c:pt idx="2321">
                  <c:v>32.171100115776056</c:v>
                </c:pt>
                <c:pt idx="2322">
                  <c:v>24.953749871253954</c:v>
                </c:pt>
                <c:pt idx="2323">
                  <c:v>29.986749806404102</c:v>
                </c:pt>
                <c:pt idx="2324">
                  <c:v>29.729949851036103</c:v>
                </c:pt>
                <c:pt idx="2325">
                  <c:v>18.797649941444405</c:v>
                </c:pt>
                <c:pt idx="2326">
                  <c:v>21.740999922752348</c:v>
                </c:pt>
                <c:pt idx="2327">
                  <c:v>25.850299983024648</c:v>
                </c:pt>
                <c:pt idx="2328">
                  <c:v>24.58769967079165</c:v>
                </c:pt>
                <c:pt idx="2329">
                  <c:v>15.432400317192098</c:v>
                </c:pt>
                <c:pt idx="2330">
                  <c:v>28.438849725723301</c:v>
                </c:pt>
                <c:pt idx="2331">
                  <c:v>31.274650034904504</c:v>
                </c:pt>
                <c:pt idx="2332">
                  <c:v>38.29814987659455</c:v>
                </c:pt>
                <c:pt idx="2333">
                  <c:v>18.395000123977699</c:v>
                </c:pt>
                <c:pt idx="2334">
                  <c:v>24.633599996566744</c:v>
                </c:pt>
                <c:pt idx="2335">
                  <c:v>27.465999546051052</c:v>
                </c:pt>
                <c:pt idx="2336">
                  <c:v>8.7780500221253028</c:v>
                </c:pt>
                <c:pt idx="2337">
                  <c:v>30.599999938011145</c:v>
                </c:pt>
                <c:pt idx="2338">
                  <c:v>21.317099881172201</c:v>
                </c:pt>
                <c:pt idx="2339">
                  <c:v>22.5769000530243</c:v>
                </c:pt>
                <c:pt idx="2340">
                  <c:v>24.368649969100943</c:v>
                </c:pt>
                <c:pt idx="2341">
                  <c:v>21.783399958610605</c:v>
                </c:pt>
                <c:pt idx="2342">
                  <c:v>19.441550102233847</c:v>
                </c:pt>
                <c:pt idx="2343">
                  <c:v>15.24045002937315</c:v>
                </c:pt>
                <c:pt idx="2344">
                  <c:v>19.948700017929053</c:v>
                </c:pt>
                <c:pt idx="2345">
                  <c:v>25.244099826812697</c:v>
                </c:pt>
                <c:pt idx="2346">
                  <c:v>22.496649813652052</c:v>
                </c:pt>
                <c:pt idx="2347">
                  <c:v>20.346700010299649</c:v>
                </c:pt>
                <c:pt idx="2348">
                  <c:v>11.627849845886203</c:v>
                </c:pt>
                <c:pt idx="2349">
                  <c:v>20.699450006484952</c:v>
                </c:pt>
                <c:pt idx="2350">
                  <c:v>23.052899808883698</c:v>
                </c:pt>
                <c:pt idx="2351">
                  <c:v>21.252949757576001</c:v>
                </c:pt>
                <c:pt idx="2352">
                  <c:v>17.130500011444148</c:v>
                </c:pt>
                <c:pt idx="2353">
                  <c:v>26.523850145339949</c:v>
                </c:pt>
                <c:pt idx="2354">
                  <c:v>20.180199761390654</c:v>
                </c:pt>
                <c:pt idx="2355">
                  <c:v>19.3628000497818</c:v>
                </c:pt>
                <c:pt idx="2356">
                  <c:v>30.15030022144315</c:v>
                </c:pt>
                <c:pt idx="2357">
                  <c:v>22.123899998664857</c:v>
                </c:pt>
                <c:pt idx="2358">
                  <c:v>35.035000228881799</c:v>
                </c:pt>
                <c:pt idx="2359">
                  <c:v>20.1826499605179</c:v>
                </c:pt>
                <c:pt idx="2360">
                  <c:v>32.407699971199008</c:v>
                </c:pt>
                <c:pt idx="2361">
                  <c:v>33.931599574089049</c:v>
                </c:pt>
                <c:pt idx="2362">
                  <c:v>18.305949878692651</c:v>
                </c:pt>
                <c:pt idx="2363">
                  <c:v>23.38890004158015</c:v>
                </c:pt>
                <c:pt idx="2364">
                  <c:v>19.234850082397401</c:v>
                </c:pt>
                <c:pt idx="2365">
                  <c:v>19.068549876213051</c:v>
                </c:pt>
                <c:pt idx="2366">
                  <c:v>24.063149790763795</c:v>
                </c:pt>
                <c:pt idx="2367">
                  <c:v>17.404050035476651</c:v>
                </c:pt>
                <c:pt idx="2368">
                  <c:v>23.829750180244453</c:v>
                </c:pt>
                <c:pt idx="2369">
                  <c:v>30.973799648284906</c:v>
                </c:pt>
                <c:pt idx="2370">
                  <c:v>22.665949969291752</c:v>
                </c:pt>
                <c:pt idx="2371">
                  <c:v>27.934999747276301</c:v>
                </c:pt>
                <c:pt idx="2372">
                  <c:v>24.731250429153498</c:v>
                </c:pt>
                <c:pt idx="2373">
                  <c:v>11.638599972724901</c:v>
                </c:pt>
                <c:pt idx="2374">
                  <c:v>25.581449942588801</c:v>
                </c:pt>
                <c:pt idx="2375">
                  <c:v>33.64349992752075</c:v>
                </c:pt>
                <c:pt idx="2376">
                  <c:v>22.874049992561297</c:v>
                </c:pt>
                <c:pt idx="2377">
                  <c:v>17.550850081443798</c:v>
                </c:pt>
                <c:pt idx="2378">
                  <c:v>13.126600136756899</c:v>
                </c:pt>
                <c:pt idx="2379">
                  <c:v>24.766849794387799</c:v>
                </c:pt>
                <c:pt idx="2380">
                  <c:v>16.520750041007958</c:v>
                </c:pt>
                <c:pt idx="2381">
                  <c:v>26.766499857902499</c:v>
                </c:pt>
                <c:pt idx="2382">
                  <c:v>17.945849809646596</c:v>
                </c:pt>
                <c:pt idx="2383">
                  <c:v>23.154750280380252</c:v>
                </c:pt>
                <c:pt idx="2384">
                  <c:v>19.752150077819849</c:v>
                </c:pt>
                <c:pt idx="2385">
                  <c:v>27.245849685668947</c:v>
                </c:pt>
                <c:pt idx="2386">
                  <c:v>19.595850076675504</c:v>
                </c:pt>
                <c:pt idx="2387">
                  <c:v>25.751750116348255</c:v>
                </c:pt>
                <c:pt idx="2388">
                  <c:v>18.003350152969404</c:v>
                </c:pt>
                <c:pt idx="2389">
                  <c:v>32.325399823188754</c:v>
                </c:pt>
                <c:pt idx="2390">
                  <c:v>23.452300167083749</c:v>
                </c:pt>
                <c:pt idx="2391">
                  <c:v>26.303099970817602</c:v>
                </c:pt>
                <c:pt idx="2392">
                  <c:v>13.479899883270249</c:v>
                </c:pt>
                <c:pt idx="2393">
                  <c:v>17.70449985980985</c:v>
                </c:pt>
                <c:pt idx="2394">
                  <c:v>10.298699970245352</c:v>
                </c:pt>
                <c:pt idx="2395">
                  <c:v>22.744299974441496</c:v>
                </c:pt>
                <c:pt idx="2396">
                  <c:v>20.560800104141297</c:v>
                </c:pt>
                <c:pt idx="2397">
                  <c:v>19.95185014247895</c:v>
                </c:pt>
                <c:pt idx="2398">
                  <c:v>17.225499897003196</c:v>
                </c:pt>
                <c:pt idx="2399">
                  <c:v>29.0669001054764</c:v>
                </c:pt>
                <c:pt idx="2400">
                  <c:v>29.675349726676952</c:v>
                </c:pt>
                <c:pt idx="2401">
                  <c:v>27.997949929237354</c:v>
                </c:pt>
                <c:pt idx="2402">
                  <c:v>25.03815004825595</c:v>
                </c:pt>
                <c:pt idx="2403">
                  <c:v>31.846349782943705</c:v>
                </c:pt>
                <c:pt idx="2404">
                  <c:v>23.070900149345402</c:v>
                </c:pt>
                <c:pt idx="2405">
                  <c:v>19.387449917793305</c:v>
                </c:pt>
                <c:pt idx="2406">
                  <c:v>20.50425006866455</c:v>
                </c:pt>
                <c:pt idx="2407">
                  <c:v>24.01864984512325</c:v>
                </c:pt>
                <c:pt idx="2408">
                  <c:v>30.2718496608734</c:v>
                </c:pt>
                <c:pt idx="2409">
                  <c:v>18.438850059509306</c:v>
                </c:pt>
                <c:pt idx="2410">
                  <c:v>42.24945028305055</c:v>
                </c:pt>
                <c:pt idx="2411">
                  <c:v>34.117049808502195</c:v>
                </c:pt>
                <c:pt idx="2412">
                  <c:v>28.067749996185299</c:v>
                </c:pt>
                <c:pt idx="2413">
                  <c:v>13.259299874305754</c:v>
                </c:pt>
                <c:pt idx="2414">
                  <c:v>18.330799946785</c:v>
                </c:pt>
                <c:pt idx="2415">
                  <c:v>28.852249789237952</c:v>
                </c:pt>
                <c:pt idx="2416">
                  <c:v>20.974400343894896</c:v>
                </c:pt>
                <c:pt idx="2417">
                  <c:v>25.162899889945948</c:v>
                </c:pt>
                <c:pt idx="2418">
                  <c:v>24.21329998493195</c:v>
                </c:pt>
                <c:pt idx="2419">
                  <c:v>37.740549702644351</c:v>
                </c:pt>
                <c:pt idx="2420">
                  <c:v>26.024899945259104</c:v>
                </c:pt>
                <c:pt idx="2421">
                  <c:v>28.235400166511546</c:v>
                </c:pt>
                <c:pt idx="2422">
                  <c:v>22.98214983463285</c:v>
                </c:pt>
                <c:pt idx="2423">
                  <c:v>28.550049910545347</c:v>
                </c:pt>
                <c:pt idx="2424">
                  <c:v>28.203899984359701</c:v>
                </c:pt>
                <c:pt idx="2425">
                  <c:v>25.591999912262001</c:v>
                </c:pt>
                <c:pt idx="2426">
                  <c:v>18.500950064659154</c:v>
                </c:pt>
                <c:pt idx="2427">
                  <c:v>12.313800077438401</c:v>
                </c:pt>
                <c:pt idx="2428">
                  <c:v>23.451299967765848</c:v>
                </c:pt>
                <c:pt idx="2429">
                  <c:v>17.737300105094903</c:v>
                </c:pt>
                <c:pt idx="2430">
                  <c:v>24.662849836349501</c:v>
                </c:pt>
                <c:pt idx="2431">
                  <c:v>25.160499997138899</c:v>
                </c:pt>
                <c:pt idx="2432">
                  <c:v>21.9076997566223</c:v>
                </c:pt>
                <c:pt idx="2433">
                  <c:v>26.027800207138043</c:v>
                </c:pt>
                <c:pt idx="2434">
                  <c:v>19.826199750900301</c:v>
                </c:pt>
                <c:pt idx="2435">
                  <c:v>23.667850155830351</c:v>
                </c:pt>
                <c:pt idx="2436">
                  <c:v>26.767449936866701</c:v>
                </c:pt>
                <c:pt idx="2437">
                  <c:v>26.609150085449198</c:v>
                </c:pt>
                <c:pt idx="2438">
                  <c:v>16.147000045776398</c:v>
                </c:pt>
                <c:pt idx="2439">
                  <c:v>21.64850030899045</c:v>
                </c:pt>
                <c:pt idx="2440">
                  <c:v>33.085650095939648</c:v>
                </c:pt>
                <c:pt idx="2441">
                  <c:v>20.834800133705151</c:v>
                </c:pt>
                <c:pt idx="2442">
                  <c:v>27.781849899291952</c:v>
                </c:pt>
                <c:pt idx="2443">
                  <c:v>25.422550063133251</c:v>
                </c:pt>
                <c:pt idx="2444">
                  <c:v>23.432599678039551</c:v>
                </c:pt>
                <c:pt idx="2445">
                  <c:v>11.694049844741798</c:v>
                </c:pt>
                <c:pt idx="2446">
                  <c:v>27.552699961662306</c:v>
                </c:pt>
                <c:pt idx="2447">
                  <c:v>23.253050103187597</c:v>
                </c:pt>
                <c:pt idx="2448">
                  <c:v>18.794200172424297</c:v>
                </c:pt>
                <c:pt idx="2449">
                  <c:v>21.373650212287899</c:v>
                </c:pt>
                <c:pt idx="2450">
                  <c:v>24.618700056076001</c:v>
                </c:pt>
                <c:pt idx="2451">
                  <c:v>14.549100165367051</c:v>
                </c:pt>
                <c:pt idx="2452">
                  <c:v>22.705849895477304</c:v>
                </c:pt>
                <c:pt idx="2453">
                  <c:v>18.637650208473197</c:v>
                </c:pt>
                <c:pt idx="2454">
                  <c:v>27.25719997406005</c:v>
                </c:pt>
                <c:pt idx="2455">
                  <c:v>21.861649956703204</c:v>
                </c:pt>
                <c:pt idx="2456">
                  <c:v>12.596599764823907</c:v>
                </c:pt>
                <c:pt idx="2457">
                  <c:v>23.036699914932246</c:v>
                </c:pt>
                <c:pt idx="2458">
                  <c:v>22.878899803161652</c:v>
                </c:pt>
                <c:pt idx="2459">
                  <c:v>18.327000021934495</c:v>
                </c:pt>
                <c:pt idx="2460">
                  <c:v>24.729799704551652</c:v>
                </c:pt>
                <c:pt idx="2461">
                  <c:v>27.634849944114698</c:v>
                </c:pt>
                <c:pt idx="2462">
                  <c:v>16.148899893760696</c:v>
                </c:pt>
                <c:pt idx="2463">
                  <c:v>20.353950128555297</c:v>
                </c:pt>
                <c:pt idx="2464">
                  <c:v>24.317399964332605</c:v>
                </c:pt>
                <c:pt idx="2465">
                  <c:v>29.762800078392054</c:v>
                </c:pt>
                <c:pt idx="2466">
                  <c:v>28.862500004768407</c:v>
                </c:pt>
                <c:pt idx="2467">
                  <c:v>21.784850196838406</c:v>
                </c:pt>
                <c:pt idx="2468">
                  <c:v>32.713549766540552</c:v>
                </c:pt>
                <c:pt idx="2469">
                  <c:v>26.742399835586554</c:v>
                </c:pt>
                <c:pt idx="2470">
                  <c:v>27.092149915695202</c:v>
                </c:pt>
                <c:pt idx="2471">
                  <c:v>23.375499944686855</c:v>
                </c:pt>
                <c:pt idx="2472">
                  <c:v>15.230900235176104</c:v>
                </c:pt>
                <c:pt idx="2473">
                  <c:v>34.432399919033053</c:v>
                </c:pt>
                <c:pt idx="2474">
                  <c:v>15.467650175094601</c:v>
                </c:pt>
                <c:pt idx="2475">
                  <c:v>24.886949801444999</c:v>
                </c:pt>
                <c:pt idx="2476">
                  <c:v>32.426399827003507</c:v>
                </c:pt>
                <c:pt idx="2477">
                  <c:v>13.315899996757501</c:v>
                </c:pt>
                <c:pt idx="2478">
                  <c:v>17.840699677467349</c:v>
                </c:pt>
                <c:pt idx="2479">
                  <c:v>30.2686000156402</c:v>
                </c:pt>
                <c:pt idx="2480">
                  <c:v>22.644599933624256</c:v>
                </c:pt>
                <c:pt idx="2481">
                  <c:v>32.34254965782165</c:v>
                </c:pt>
                <c:pt idx="2482">
                  <c:v>29.6897002029419</c:v>
                </c:pt>
                <c:pt idx="2483">
                  <c:v>12.414099912643451</c:v>
                </c:pt>
                <c:pt idx="2484">
                  <c:v>17.801499900817902</c:v>
                </c:pt>
                <c:pt idx="2485">
                  <c:v>21.739249930381803</c:v>
                </c:pt>
                <c:pt idx="2486">
                  <c:v>22.3454501104355</c:v>
                </c:pt>
                <c:pt idx="2487">
                  <c:v>33.590999922752346</c:v>
                </c:pt>
                <c:pt idx="2488">
                  <c:v>42.431449689865097</c:v>
                </c:pt>
                <c:pt idx="2489">
                  <c:v>34.796649703979497</c:v>
                </c:pt>
                <c:pt idx="2490">
                  <c:v>17.169449906349143</c:v>
                </c:pt>
                <c:pt idx="2491">
                  <c:v>25.894549856185947</c:v>
                </c:pt>
                <c:pt idx="2492">
                  <c:v>19.748700118064857</c:v>
                </c:pt>
                <c:pt idx="2493">
                  <c:v>21.306949977874751</c:v>
                </c:pt>
                <c:pt idx="2494">
                  <c:v>17.6619500875473</c:v>
                </c:pt>
                <c:pt idx="2495">
                  <c:v>20.660250029563898</c:v>
                </c:pt>
                <c:pt idx="2496">
                  <c:v>22.973049912452701</c:v>
                </c:pt>
                <c:pt idx="2497">
                  <c:v>16.221500110626252</c:v>
                </c:pt>
                <c:pt idx="2498">
                  <c:v>34.184849905967702</c:v>
                </c:pt>
                <c:pt idx="2499">
                  <c:v>22.135349960327147</c:v>
                </c:pt>
                <c:pt idx="2500">
                  <c:v>26.690000047683704</c:v>
                </c:pt>
                <c:pt idx="2501">
                  <c:v>31.525699815750151</c:v>
                </c:pt>
                <c:pt idx="2502">
                  <c:v>17.324749975204504</c:v>
                </c:pt>
                <c:pt idx="2503">
                  <c:v>30.247599887847898</c:v>
                </c:pt>
                <c:pt idx="2504">
                  <c:v>20.389400053024254</c:v>
                </c:pt>
                <c:pt idx="2505">
                  <c:v>22.065800037384044</c:v>
                </c:pt>
                <c:pt idx="2506">
                  <c:v>20.818199758529655</c:v>
                </c:pt>
                <c:pt idx="2507">
                  <c:v>25.980699872970597</c:v>
                </c:pt>
                <c:pt idx="2508">
                  <c:v>9.0313500881194528</c:v>
                </c:pt>
                <c:pt idx="2509">
                  <c:v>21.170600013732955</c:v>
                </c:pt>
                <c:pt idx="2510">
                  <c:v>24.278799996376051</c:v>
                </c:pt>
                <c:pt idx="2511">
                  <c:v>20.154300055503846</c:v>
                </c:pt>
                <c:pt idx="2512">
                  <c:v>28.644449901580799</c:v>
                </c:pt>
                <c:pt idx="2513">
                  <c:v>27.158999905586242</c:v>
                </c:pt>
                <c:pt idx="2514">
                  <c:v>25.779800033569298</c:v>
                </c:pt>
                <c:pt idx="2515">
                  <c:v>23.468550071716294</c:v>
                </c:pt>
                <c:pt idx="2516">
                  <c:v>22.3510498189926</c:v>
                </c:pt>
                <c:pt idx="2517">
                  <c:v>29.885750036239649</c:v>
                </c:pt>
                <c:pt idx="2518">
                  <c:v>15.489550218582153</c:v>
                </c:pt>
                <c:pt idx="2519">
                  <c:v>20.270500216484052</c:v>
                </c:pt>
                <c:pt idx="2520">
                  <c:v>12.909650087356603</c:v>
                </c:pt>
                <c:pt idx="2521">
                  <c:v>16.306750168800303</c:v>
                </c:pt>
                <c:pt idx="2522">
                  <c:v>29.6449501657486</c:v>
                </c:pt>
                <c:pt idx="2523">
                  <c:v>20.175950021743748</c:v>
                </c:pt>
                <c:pt idx="2524">
                  <c:v>25.385549974441599</c:v>
                </c:pt>
                <c:pt idx="2525">
                  <c:v>35.602849946022047</c:v>
                </c:pt>
                <c:pt idx="2526">
                  <c:v>25.793599944114703</c:v>
                </c:pt>
                <c:pt idx="2527">
                  <c:v>24.977100176811202</c:v>
                </c:pt>
                <c:pt idx="2528">
                  <c:v>13.659250092506401</c:v>
                </c:pt>
                <c:pt idx="2529">
                  <c:v>21.889949893951403</c:v>
                </c:pt>
                <c:pt idx="2530">
                  <c:v>11.774650158882149</c:v>
                </c:pt>
                <c:pt idx="2531">
                  <c:v>22.427550029754656</c:v>
                </c:pt>
                <c:pt idx="2532">
                  <c:v>29.008049850463845</c:v>
                </c:pt>
                <c:pt idx="2533">
                  <c:v>16.841899819374099</c:v>
                </c:pt>
                <c:pt idx="2534">
                  <c:v>14.669399876594547</c:v>
                </c:pt>
                <c:pt idx="2535">
                  <c:v>26.445899791717551</c:v>
                </c:pt>
                <c:pt idx="2536">
                  <c:v>15.393850083351104</c:v>
                </c:pt>
                <c:pt idx="2537">
                  <c:v>13.392250132560751</c:v>
                </c:pt>
                <c:pt idx="2538">
                  <c:v>16.305549907684352</c:v>
                </c:pt>
                <c:pt idx="2539">
                  <c:v>25.950350012779246</c:v>
                </c:pt>
                <c:pt idx="2540">
                  <c:v>21.06749979496</c:v>
                </c:pt>
                <c:pt idx="2541">
                  <c:v>26.0186001110077</c:v>
                </c:pt>
                <c:pt idx="2542">
                  <c:v>35.375099773407001</c:v>
                </c:pt>
                <c:pt idx="2543">
                  <c:v>78.992749791145656</c:v>
                </c:pt>
                <c:pt idx="2544">
                  <c:v>26.805899877548256</c:v>
                </c:pt>
                <c:pt idx="2545">
                  <c:v>33.467600002288847</c:v>
                </c:pt>
                <c:pt idx="2546">
                  <c:v>15.326200251579252</c:v>
                </c:pt>
                <c:pt idx="2547">
                  <c:v>28.912650232315102</c:v>
                </c:pt>
                <c:pt idx="2548">
                  <c:v>19.080850067138652</c:v>
                </c:pt>
                <c:pt idx="2549">
                  <c:v>39.4587499332428</c:v>
                </c:pt>
                <c:pt idx="2550">
                  <c:v>16.378750247955352</c:v>
                </c:pt>
                <c:pt idx="2551">
                  <c:v>23.841149678230295</c:v>
                </c:pt>
                <c:pt idx="2552">
                  <c:v>14.361349973678646</c:v>
                </c:pt>
                <c:pt idx="2553">
                  <c:v>-23.54564990997315</c:v>
                </c:pt>
                <c:pt idx="2554">
                  <c:v>23.52800016880035</c:v>
                </c:pt>
                <c:pt idx="2555">
                  <c:v>18.550500068664498</c:v>
                </c:pt>
                <c:pt idx="2556">
                  <c:v>21.278649773597699</c:v>
                </c:pt>
                <c:pt idx="2557">
                  <c:v>22.188499832153401</c:v>
                </c:pt>
                <c:pt idx="2558">
                  <c:v>19.488249883651751</c:v>
                </c:pt>
                <c:pt idx="2559">
                  <c:v>25.219800095558153</c:v>
                </c:pt>
                <c:pt idx="2560">
                  <c:v>14.389900150299106</c:v>
                </c:pt>
                <c:pt idx="2561">
                  <c:v>21.501300058364901</c:v>
                </c:pt>
                <c:pt idx="2562">
                  <c:v>22.983050189018197</c:v>
                </c:pt>
                <c:pt idx="2563">
                  <c:v>25.295499725341745</c:v>
                </c:pt>
                <c:pt idx="2564">
                  <c:v>14.665800046920751</c:v>
                </c:pt>
                <c:pt idx="2565">
                  <c:v>23.555050001144451</c:v>
                </c:pt>
                <c:pt idx="2566">
                  <c:v>49.218299770355195</c:v>
                </c:pt>
                <c:pt idx="2567">
                  <c:v>12.867899799346851</c:v>
                </c:pt>
                <c:pt idx="2568">
                  <c:v>19.157049927711448</c:v>
                </c:pt>
                <c:pt idx="2569">
                  <c:v>32.08415017604824</c:v>
                </c:pt>
                <c:pt idx="2570">
                  <c:v>15.458399777412396</c:v>
                </c:pt>
                <c:pt idx="2571">
                  <c:v>22.756450161933898</c:v>
                </c:pt>
                <c:pt idx="2572">
                  <c:v>20.477199978828448</c:v>
                </c:pt>
                <c:pt idx="2573">
                  <c:v>25.581949787139898</c:v>
                </c:pt>
                <c:pt idx="2574">
                  <c:v>19.24640001296995</c:v>
                </c:pt>
                <c:pt idx="2575">
                  <c:v>27.0268498134613</c:v>
                </c:pt>
                <c:pt idx="2576">
                  <c:v>31.39864965438845</c:v>
                </c:pt>
                <c:pt idx="2577">
                  <c:v>30.956649909019454</c:v>
                </c:pt>
                <c:pt idx="2578">
                  <c:v>22.056850008964599</c:v>
                </c:pt>
                <c:pt idx="2579">
                  <c:v>25.18044997692105</c:v>
                </c:pt>
                <c:pt idx="2580">
                  <c:v>19.699649930000305</c:v>
                </c:pt>
                <c:pt idx="2581">
                  <c:v>33.959999799728408</c:v>
                </c:pt>
                <c:pt idx="2582">
                  <c:v>18.508549914360049</c:v>
                </c:pt>
                <c:pt idx="2583">
                  <c:v>30.819399952888496</c:v>
                </c:pt>
                <c:pt idx="2584">
                  <c:v>18.071300053596445</c:v>
                </c:pt>
                <c:pt idx="2585">
                  <c:v>18.737650175094597</c:v>
                </c:pt>
                <c:pt idx="2586">
                  <c:v>37.572549710273748</c:v>
                </c:pt>
                <c:pt idx="2587">
                  <c:v>31.236299529075595</c:v>
                </c:pt>
                <c:pt idx="2588">
                  <c:v>10.190550217628498</c:v>
                </c:pt>
                <c:pt idx="2589">
                  <c:v>24.303499979972848</c:v>
                </c:pt>
                <c:pt idx="2590">
                  <c:v>24.456799926757753</c:v>
                </c:pt>
                <c:pt idx="2591">
                  <c:v>15.408200130462646</c:v>
                </c:pt>
                <c:pt idx="2592">
                  <c:v>36.7463998889923</c:v>
                </c:pt>
                <c:pt idx="2593">
                  <c:v>24.206849923133852</c:v>
                </c:pt>
                <c:pt idx="2594">
                  <c:v>18.243400278091396</c:v>
                </c:pt>
                <c:pt idx="2595">
                  <c:v>21.712749915122998</c:v>
                </c:pt>
                <c:pt idx="2596">
                  <c:v>36.844699892997752</c:v>
                </c:pt>
                <c:pt idx="2597">
                  <c:v>22.98124985694885</c:v>
                </c:pt>
                <c:pt idx="2598">
                  <c:v>24.064250240325897</c:v>
                </c:pt>
                <c:pt idx="2599">
                  <c:v>23.439300022125252</c:v>
                </c:pt>
                <c:pt idx="2600">
                  <c:v>24.542649912834097</c:v>
                </c:pt>
                <c:pt idx="2601">
                  <c:v>28.824499812126152</c:v>
                </c:pt>
                <c:pt idx="2602">
                  <c:v>18.349700040817204</c:v>
                </c:pt>
                <c:pt idx="2603">
                  <c:v>21.467599992752049</c:v>
                </c:pt>
                <c:pt idx="2604">
                  <c:v>25.362599778175351</c:v>
                </c:pt>
                <c:pt idx="2605">
                  <c:v>16.9166498374939</c:v>
                </c:pt>
                <c:pt idx="2606">
                  <c:v>21.180900130271958</c:v>
                </c:pt>
                <c:pt idx="2607">
                  <c:v>23.865850048065198</c:v>
                </c:pt>
                <c:pt idx="2608">
                  <c:v>17.929199771881045</c:v>
                </c:pt>
                <c:pt idx="2609">
                  <c:v>32.3989498806</c:v>
                </c:pt>
                <c:pt idx="2610">
                  <c:v>16.858699836730953</c:v>
                </c:pt>
                <c:pt idx="2611">
                  <c:v>22.212849984169001</c:v>
                </c:pt>
                <c:pt idx="2612">
                  <c:v>18.916399831771898</c:v>
                </c:pt>
                <c:pt idx="2613">
                  <c:v>14.629149956703195</c:v>
                </c:pt>
                <c:pt idx="2614">
                  <c:v>11.369199876785302</c:v>
                </c:pt>
                <c:pt idx="2615">
                  <c:v>7.1192498302460017</c:v>
                </c:pt>
                <c:pt idx="2616">
                  <c:v>25.250999922752399</c:v>
                </c:pt>
                <c:pt idx="2617">
                  <c:v>8.4552999162673501</c:v>
                </c:pt>
                <c:pt idx="2618">
                  <c:v>13.722350025177008</c:v>
                </c:pt>
                <c:pt idx="2619">
                  <c:v>22.587949991226196</c:v>
                </c:pt>
                <c:pt idx="2620">
                  <c:v>15.415299925804149</c:v>
                </c:pt>
                <c:pt idx="2621">
                  <c:v>18.957200145721401</c:v>
                </c:pt>
                <c:pt idx="2622">
                  <c:v>14.154750165939348</c:v>
                </c:pt>
                <c:pt idx="2623">
                  <c:v>24.201649971008248</c:v>
                </c:pt>
                <c:pt idx="2624">
                  <c:v>14.588250198364243</c:v>
                </c:pt>
                <c:pt idx="2625">
                  <c:v>19.081799998283401</c:v>
                </c:pt>
                <c:pt idx="2626">
                  <c:v>19.54400011062625</c:v>
                </c:pt>
                <c:pt idx="2627">
                  <c:v>16.916999959945656</c:v>
                </c:pt>
                <c:pt idx="2628">
                  <c:v>22.120350050926248</c:v>
                </c:pt>
                <c:pt idx="2629">
                  <c:v>27.685949816703804</c:v>
                </c:pt>
                <c:pt idx="2630">
                  <c:v>20.177600154876693</c:v>
                </c:pt>
                <c:pt idx="2631">
                  <c:v>21.882650189399705</c:v>
                </c:pt>
                <c:pt idx="2632">
                  <c:v>19.672050013542204</c:v>
                </c:pt>
                <c:pt idx="2633">
                  <c:v>20.590950021743751</c:v>
                </c:pt>
                <c:pt idx="2634">
                  <c:v>20.85335006237025</c:v>
                </c:pt>
                <c:pt idx="2635">
                  <c:v>20.996400060653698</c:v>
                </c:pt>
                <c:pt idx="2636">
                  <c:v>13.90530011177065</c:v>
                </c:pt>
                <c:pt idx="2637">
                  <c:v>20.893749966621449</c:v>
                </c:pt>
                <c:pt idx="2638">
                  <c:v>31.738749995231601</c:v>
                </c:pt>
                <c:pt idx="2639">
                  <c:v>33.222249798774747</c:v>
                </c:pt>
                <c:pt idx="2640">
                  <c:v>14.836750025749204</c:v>
                </c:pt>
                <c:pt idx="2641">
                  <c:v>25.839950041770948</c:v>
                </c:pt>
                <c:pt idx="2642">
                  <c:v>13.165700001716552</c:v>
                </c:pt>
                <c:pt idx="2643">
                  <c:v>31.363099918365446</c:v>
                </c:pt>
                <c:pt idx="2644">
                  <c:v>24.25334989070895</c:v>
                </c:pt>
                <c:pt idx="2645">
                  <c:v>19.604300189018243</c:v>
                </c:pt>
                <c:pt idx="2646">
                  <c:v>17.126200156211901</c:v>
                </c:pt>
                <c:pt idx="2647">
                  <c:v>26.037150068283047</c:v>
                </c:pt>
                <c:pt idx="2648">
                  <c:v>27.209400119781506</c:v>
                </c:pt>
                <c:pt idx="2649">
                  <c:v>20.19810004234315</c:v>
                </c:pt>
                <c:pt idx="2650">
                  <c:v>20.055799736976653</c:v>
                </c:pt>
                <c:pt idx="2651">
                  <c:v>19.683750138282754</c:v>
                </c:pt>
                <c:pt idx="2652">
                  <c:v>21.051250004768399</c:v>
                </c:pt>
                <c:pt idx="2653">
                  <c:v>36.797699890136748</c:v>
                </c:pt>
                <c:pt idx="2654">
                  <c:v>63.718099985122691</c:v>
                </c:pt>
                <c:pt idx="2655">
                  <c:v>16.84359986782075</c:v>
                </c:pt>
                <c:pt idx="2656">
                  <c:v>33.537599925994854</c:v>
                </c:pt>
                <c:pt idx="2657">
                  <c:v>24.380000114440897</c:v>
                </c:pt>
                <c:pt idx="2658">
                  <c:v>25.506049799919147</c:v>
                </c:pt>
                <c:pt idx="2659">
                  <c:v>35.697900109291098</c:v>
                </c:pt>
                <c:pt idx="2660">
                  <c:v>21.880999975204446</c:v>
                </c:pt>
                <c:pt idx="2661">
                  <c:v>12.909600105285651</c:v>
                </c:pt>
                <c:pt idx="2662">
                  <c:v>25.503700056076049</c:v>
                </c:pt>
                <c:pt idx="2663">
                  <c:v>19.567649769782996</c:v>
                </c:pt>
                <c:pt idx="2664">
                  <c:v>15.323649802207953</c:v>
                </c:pt>
                <c:pt idx="2665">
                  <c:v>11.996150245666506</c:v>
                </c:pt>
                <c:pt idx="2666">
                  <c:v>18.083150157928451</c:v>
                </c:pt>
                <c:pt idx="2667">
                  <c:v>64.393500146865861</c:v>
                </c:pt>
                <c:pt idx="2668">
                  <c:v>15.356000237464951</c:v>
                </c:pt>
                <c:pt idx="2669">
                  <c:v>24.877799897193899</c:v>
                </c:pt>
                <c:pt idx="2670">
                  <c:v>14.180500092506399</c:v>
                </c:pt>
                <c:pt idx="2671">
                  <c:v>35.862749752998347</c:v>
                </c:pt>
                <c:pt idx="2672">
                  <c:v>18.11414984226225</c:v>
                </c:pt>
                <c:pt idx="2673">
                  <c:v>22.869450078010551</c:v>
                </c:pt>
                <c:pt idx="2674">
                  <c:v>20.690200037956245</c:v>
                </c:pt>
                <c:pt idx="2675">
                  <c:v>15.819899964332599</c:v>
                </c:pt>
                <c:pt idx="2676">
                  <c:v>18.11380009174345</c:v>
                </c:pt>
                <c:pt idx="2677">
                  <c:v>26.676500020027149</c:v>
                </c:pt>
                <c:pt idx="2678">
                  <c:v>36.841049857139602</c:v>
                </c:pt>
                <c:pt idx="2679">
                  <c:v>23.885800166130046</c:v>
                </c:pt>
                <c:pt idx="2680">
                  <c:v>26.59079991340635</c:v>
                </c:pt>
                <c:pt idx="2681">
                  <c:v>14.378550233840947</c:v>
                </c:pt>
                <c:pt idx="2682">
                  <c:v>16.460900111198395</c:v>
                </c:pt>
                <c:pt idx="2683">
                  <c:v>22.821550087928802</c:v>
                </c:pt>
                <c:pt idx="2684">
                  <c:v>14.213050069808993</c:v>
                </c:pt>
                <c:pt idx="2685">
                  <c:v>27.943049802780152</c:v>
                </c:pt>
                <c:pt idx="2686">
                  <c:v>22.997450089454649</c:v>
                </c:pt>
                <c:pt idx="2687">
                  <c:v>29.432049846649154</c:v>
                </c:pt>
                <c:pt idx="2688">
                  <c:v>15.629050054550149</c:v>
                </c:pt>
                <c:pt idx="2689">
                  <c:v>11.03274996757505</c:v>
                </c:pt>
                <c:pt idx="2690">
                  <c:v>18.788800044059755</c:v>
                </c:pt>
                <c:pt idx="2691">
                  <c:v>26.02634998798375</c:v>
                </c:pt>
                <c:pt idx="2692">
                  <c:v>34.041649804115295</c:v>
                </c:pt>
                <c:pt idx="2693">
                  <c:v>8.0126502227783512</c:v>
                </c:pt>
                <c:pt idx="2694">
                  <c:v>22.146999850273147</c:v>
                </c:pt>
                <c:pt idx="2695">
                  <c:v>23.179550070762652</c:v>
                </c:pt>
                <c:pt idx="2696">
                  <c:v>24.001250081062409</c:v>
                </c:pt>
                <c:pt idx="2697">
                  <c:v>26.319649939537051</c:v>
                </c:pt>
                <c:pt idx="2698">
                  <c:v>19.491500158309957</c:v>
                </c:pt>
                <c:pt idx="2699">
                  <c:v>24.969849762916546</c:v>
                </c:pt>
                <c:pt idx="2700">
                  <c:v>18.002150230407644</c:v>
                </c:pt>
                <c:pt idx="2701">
                  <c:v>28.090249876976049</c:v>
                </c:pt>
                <c:pt idx="2702">
                  <c:v>22.070849881172201</c:v>
                </c:pt>
                <c:pt idx="2703">
                  <c:v>24.272449703216594</c:v>
                </c:pt>
                <c:pt idx="2704">
                  <c:v>16.666250271797203</c:v>
                </c:pt>
                <c:pt idx="2705">
                  <c:v>37.857149968147297</c:v>
                </c:pt>
                <c:pt idx="2706">
                  <c:v>23.419799785613954</c:v>
                </c:pt>
                <c:pt idx="2707">
                  <c:v>26.497999858856197</c:v>
                </c:pt>
                <c:pt idx="2708">
                  <c:v>30.334949831962597</c:v>
                </c:pt>
                <c:pt idx="2709">
                  <c:v>14.910650000572154</c:v>
                </c:pt>
                <c:pt idx="2710">
                  <c:v>18.659049820899952</c:v>
                </c:pt>
                <c:pt idx="2711">
                  <c:v>17.207350139617901</c:v>
                </c:pt>
                <c:pt idx="2712">
                  <c:v>24.433950071334852</c:v>
                </c:pt>
                <c:pt idx="2713">
                  <c:v>31.677999987602202</c:v>
                </c:pt>
                <c:pt idx="2714">
                  <c:v>16.633650021553102</c:v>
                </c:pt>
                <c:pt idx="2715">
                  <c:v>31.385849967002848</c:v>
                </c:pt>
                <c:pt idx="2716">
                  <c:v>18.513999972343449</c:v>
                </c:pt>
                <c:pt idx="2717">
                  <c:v>23.679100079536397</c:v>
                </c:pt>
                <c:pt idx="2718">
                  <c:v>12.108299999237047</c:v>
                </c:pt>
                <c:pt idx="2719">
                  <c:v>19.208250160217251</c:v>
                </c:pt>
                <c:pt idx="2720">
                  <c:v>24.135749959945649</c:v>
                </c:pt>
                <c:pt idx="2721">
                  <c:v>17.751649932861355</c:v>
                </c:pt>
                <c:pt idx="2722">
                  <c:v>27.580600080490157</c:v>
                </c:pt>
                <c:pt idx="2723">
                  <c:v>18.097750163078302</c:v>
                </c:pt>
                <c:pt idx="2724">
                  <c:v>17.45445001125335</c:v>
                </c:pt>
                <c:pt idx="2725">
                  <c:v>23.883499908447302</c:v>
                </c:pt>
                <c:pt idx="2726">
                  <c:v>34.081349611282405</c:v>
                </c:pt>
                <c:pt idx="2727">
                  <c:v>26.299800076484701</c:v>
                </c:pt>
                <c:pt idx="2728">
                  <c:v>12.907250018119846</c:v>
                </c:pt>
                <c:pt idx="2729">
                  <c:v>22.289399785995503</c:v>
                </c:pt>
                <c:pt idx="2730">
                  <c:v>17.415300126075756</c:v>
                </c:pt>
                <c:pt idx="2731">
                  <c:v>23.167550106048552</c:v>
                </c:pt>
                <c:pt idx="2732">
                  <c:v>28.534949889183054</c:v>
                </c:pt>
                <c:pt idx="2733">
                  <c:v>21.693850126266497</c:v>
                </c:pt>
                <c:pt idx="2734">
                  <c:v>13.304550161361757</c:v>
                </c:pt>
                <c:pt idx="2735">
                  <c:v>17.860550036430354</c:v>
                </c:pt>
                <c:pt idx="2736">
                  <c:v>22.52339993953705</c:v>
                </c:pt>
                <c:pt idx="2737">
                  <c:v>29.657649664878853</c:v>
                </c:pt>
                <c:pt idx="2738">
                  <c:v>18.620850112438248</c:v>
                </c:pt>
                <c:pt idx="2739">
                  <c:v>20.001950178146398</c:v>
                </c:pt>
                <c:pt idx="2740">
                  <c:v>26.526649746894805</c:v>
                </c:pt>
                <c:pt idx="2741">
                  <c:v>15.481150078773496</c:v>
                </c:pt>
                <c:pt idx="2742">
                  <c:v>20.818349990844752</c:v>
                </c:pt>
                <c:pt idx="2743">
                  <c:v>16.932400193214452</c:v>
                </c:pt>
                <c:pt idx="2744">
                  <c:v>30.655249648094149</c:v>
                </c:pt>
                <c:pt idx="2745">
                  <c:v>26.858750038147001</c:v>
                </c:pt>
                <c:pt idx="2746">
                  <c:v>21.444850244522094</c:v>
                </c:pt>
                <c:pt idx="2747">
                  <c:v>20.26399996280675</c:v>
                </c:pt>
                <c:pt idx="2748">
                  <c:v>16.830199999809302</c:v>
                </c:pt>
                <c:pt idx="2749">
                  <c:v>23.993699884414653</c:v>
                </c:pt>
                <c:pt idx="2750">
                  <c:v>23.877500147819493</c:v>
                </c:pt>
                <c:pt idx="2751">
                  <c:v>34.7080998086929</c:v>
                </c:pt>
                <c:pt idx="2752">
                  <c:v>25.900950164794899</c:v>
                </c:pt>
                <c:pt idx="2753">
                  <c:v>15.852999992370599</c:v>
                </c:pt>
                <c:pt idx="2754">
                  <c:v>16.921449880599994</c:v>
                </c:pt>
                <c:pt idx="2755">
                  <c:v>16.684749941825849</c:v>
                </c:pt>
                <c:pt idx="2756">
                  <c:v>19.912650022506746</c:v>
                </c:pt>
                <c:pt idx="2757">
                  <c:v>20.390050024986301</c:v>
                </c:pt>
                <c:pt idx="2758">
                  <c:v>23.954600114822405</c:v>
                </c:pt>
                <c:pt idx="2759">
                  <c:v>34.552099809646606</c:v>
                </c:pt>
                <c:pt idx="2760">
                  <c:v>13.605500044822698</c:v>
                </c:pt>
                <c:pt idx="2761">
                  <c:v>22.902350244522097</c:v>
                </c:pt>
                <c:pt idx="2762">
                  <c:v>19.057749867439298</c:v>
                </c:pt>
                <c:pt idx="2763">
                  <c:v>19.481850156784052</c:v>
                </c:pt>
                <c:pt idx="2764">
                  <c:v>21.022949924468953</c:v>
                </c:pt>
                <c:pt idx="2765">
                  <c:v>21.426349806785552</c:v>
                </c:pt>
                <c:pt idx="2766">
                  <c:v>17.617400054931593</c:v>
                </c:pt>
                <c:pt idx="2767">
                  <c:v>23.304200005531296</c:v>
                </c:pt>
                <c:pt idx="2768">
                  <c:v>27.2427999019623</c:v>
                </c:pt>
                <c:pt idx="2769">
                  <c:v>16.598850069046051</c:v>
                </c:pt>
                <c:pt idx="2770">
                  <c:v>14.076749897003197</c:v>
                </c:pt>
                <c:pt idx="2771">
                  <c:v>28.401350030899049</c:v>
                </c:pt>
                <c:pt idx="2772">
                  <c:v>19.131149930954003</c:v>
                </c:pt>
                <c:pt idx="2773">
                  <c:v>15.812900018692048</c:v>
                </c:pt>
                <c:pt idx="2774">
                  <c:v>18.498550207614898</c:v>
                </c:pt>
                <c:pt idx="2775">
                  <c:v>18.143099880218504</c:v>
                </c:pt>
                <c:pt idx="2776">
                  <c:v>28.081799693107548</c:v>
                </c:pt>
                <c:pt idx="2777">
                  <c:v>17.508450202941901</c:v>
                </c:pt>
                <c:pt idx="2778">
                  <c:v>15.94025004386905</c:v>
                </c:pt>
                <c:pt idx="2779">
                  <c:v>21.926700115203897</c:v>
                </c:pt>
                <c:pt idx="2780">
                  <c:v>24.558599772453249</c:v>
                </c:pt>
                <c:pt idx="2781">
                  <c:v>10.666400113105752</c:v>
                </c:pt>
                <c:pt idx="2782">
                  <c:v>36.1244998311996</c:v>
                </c:pt>
                <c:pt idx="2783">
                  <c:v>34.392799797058146</c:v>
                </c:pt>
                <c:pt idx="2784">
                  <c:v>17.8756999731064</c:v>
                </c:pt>
                <c:pt idx="2785">
                  <c:v>11.600749979019149</c:v>
                </c:pt>
                <c:pt idx="2786">
                  <c:v>21.700000004768356</c:v>
                </c:pt>
                <c:pt idx="2787">
                  <c:v>20.795300092697097</c:v>
                </c:pt>
                <c:pt idx="2788">
                  <c:v>37.671799941062901</c:v>
                </c:pt>
                <c:pt idx="2789">
                  <c:v>15.035400176048249</c:v>
                </c:pt>
                <c:pt idx="2790">
                  <c:v>20.261899895668051</c:v>
                </c:pt>
                <c:pt idx="2791">
                  <c:v>9.9121000432968493</c:v>
                </c:pt>
                <c:pt idx="2792">
                  <c:v>29.123400058746348</c:v>
                </c:pt>
                <c:pt idx="2793">
                  <c:v>22.327200222015403</c:v>
                </c:pt>
                <c:pt idx="2794">
                  <c:v>35.725049877166697</c:v>
                </c:pt>
                <c:pt idx="2795">
                  <c:v>25.978850059509249</c:v>
                </c:pt>
                <c:pt idx="2796">
                  <c:v>17.945100274086052</c:v>
                </c:pt>
                <c:pt idx="2797">
                  <c:v>10.911649789810156</c:v>
                </c:pt>
                <c:pt idx="2798">
                  <c:v>13.25094996452335</c:v>
                </c:pt>
                <c:pt idx="2799">
                  <c:v>22.069999847412049</c:v>
                </c:pt>
                <c:pt idx="2800">
                  <c:v>17.443999996185354</c:v>
                </c:pt>
                <c:pt idx="2801">
                  <c:v>19.834399995803857</c:v>
                </c:pt>
                <c:pt idx="2802">
                  <c:v>39.642600178718595</c:v>
                </c:pt>
                <c:pt idx="2803">
                  <c:v>29.037049870491053</c:v>
                </c:pt>
                <c:pt idx="2804">
                  <c:v>35.276999835967949</c:v>
                </c:pt>
                <c:pt idx="2805">
                  <c:v>17.849850158691446</c:v>
                </c:pt>
                <c:pt idx="2806">
                  <c:v>22.210249934196455</c:v>
                </c:pt>
                <c:pt idx="2807">
                  <c:v>11.938899970054599</c:v>
                </c:pt>
                <c:pt idx="2808">
                  <c:v>14.615900115966799</c:v>
                </c:pt>
                <c:pt idx="2809">
                  <c:v>24.687000107765201</c:v>
                </c:pt>
                <c:pt idx="2810">
                  <c:v>16.601549901962294</c:v>
                </c:pt>
                <c:pt idx="2811">
                  <c:v>12.289649977683997</c:v>
                </c:pt>
                <c:pt idx="2812">
                  <c:v>21.945699815750096</c:v>
                </c:pt>
                <c:pt idx="2813">
                  <c:v>22.448299841880793</c:v>
                </c:pt>
                <c:pt idx="2814">
                  <c:v>22.908650140762354</c:v>
                </c:pt>
                <c:pt idx="2815">
                  <c:v>22.956300148963951</c:v>
                </c:pt>
                <c:pt idx="2816">
                  <c:v>16.428950266838044</c:v>
                </c:pt>
                <c:pt idx="2817">
                  <c:v>10.552899880409246</c:v>
                </c:pt>
                <c:pt idx="2818">
                  <c:v>17.226099939346298</c:v>
                </c:pt>
                <c:pt idx="2819">
                  <c:v>26.2124500179291</c:v>
                </c:pt>
                <c:pt idx="2820">
                  <c:v>16.759350237846352</c:v>
                </c:pt>
                <c:pt idx="2821">
                  <c:v>16.561200089454704</c:v>
                </c:pt>
                <c:pt idx="2822">
                  <c:v>17.581249933242745</c:v>
                </c:pt>
                <c:pt idx="2823">
                  <c:v>23.972499895095801</c:v>
                </c:pt>
                <c:pt idx="2824">
                  <c:v>20.068050103187602</c:v>
                </c:pt>
                <c:pt idx="2825">
                  <c:v>18.264200038909898</c:v>
                </c:pt>
                <c:pt idx="2826">
                  <c:v>28.2438498544693</c:v>
                </c:pt>
                <c:pt idx="2827">
                  <c:v>26.513799924850503</c:v>
                </c:pt>
                <c:pt idx="2828">
                  <c:v>21.770349845886251</c:v>
                </c:pt>
                <c:pt idx="2829">
                  <c:v>14.851500144004902</c:v>
                </c:pt>
                <c:pt idx="2830">
                  <c:v>20.651449828147904</c:v>
                </c:pt>
                <c:pt idx="2831">
                  <c:v>31.612549700737002</c:v>
                </c:pt>
                <c:pt idx="2832">
                  <c:v>19.264599990844747</c:v>
                </c:pt>
                <c:pt idx="2833">
                  <c:v>18.551350092887894</c:v>
                </c:pt>
                <c:pt idx="2834">
                  <c:v>29.192350044250553</c:v>
                </c:pt>
                <c:pt idx="2835">
                  <c:v>27.952099938392649</c:v>
                </c:pt>
                <c:pt idx="2836">
                  <c:v>17.653099861145002</c:v>
                </c:pt>
                <c:pt idx="2837">
                  <c:v>30.864550008773801</c:v>
                </c:pt>
                <c:pt idx="2838">
                  <c:v>16.771299991607648</c:v>
                </c:pt>
                <c:pt idx="2839">
                  <c:v>21.259500169754048</c:v>
                </c:pt>
                <c:pt idx="2840">
                  <c:v>19.485049853324899</c:v>
                </c:pt>
                <c:pt idx="2841">
                  <c:v>19.75800013065335</c:v>
                </c:pt>
                <c:pt idx="2842">
                  <c:v>22.619750022888198</c:v>
                </c:pt>
                <c:pt idx="2843">
                  <c:v>20.618699636459301</c:v>
                </c:pt>
                <c:pt idx="2844">
                  <c:v>23.102199912071196</c:v>
                </c:pt>
                <c:pt idx="2845">
                  <c:v>31.003049802780154</c:v>
                </c:pt>
                <c:pt idx="2846">
                  <c:v>29.002649941444407</c:v>
                </c:pt>
                <c:pt idx="2847">
                  <c:v>14.378399949073803</c:v>
                </c:pt>
                <c:pt idx="2848">
                  <c:v>20.432099709510751</c:v>
                </c:pt>
                <c:pt idx="2849">
                  <c:v>15.334500164985648</c:v>
                </c:pt>
                <c:pt idx="2850">
                  <c:v>21.371750106811497</c:v>
                </c:pt>
                <c:pt idx="2851">
                  <c:v>30.575299978256204</c:v>
                </c:pt>
                <c:pt idx="2852">
                  <c:v>13.318600003719347</c:v>
                </c:pt>
                <c:pt idx="2853">
                  <c:v>11.146450018882746</c:v>
                </c:pt>
                <c:pt idx="2854">
                  <c:v>26.641600084304855</c:v>
                </c:pt>
                <c:pt idx="2855">
                  <c:v>16.023399839401257</c:v>
                </c:pt>
                <c:pt idx="2856">
                  <c:v>20.831199860572802</c:v>
                </c:pt>
                <c:pt idx="2857">
                  <c:v>12.4148499011993</c:v>
                </c:pt>
                <c:pt idx="2858">
                  <c:v>29.885099706649751</c:v>
                </c:pt>
                <c:pt idx="2859">
                  <c:v>29.369799890518149</c:v>
                </c:pt>
                <c:pt idx="2860">
                  <c:v>16.446800160408003</c:v>
                </c:pt>
                <c:pt idx="2861">
                  <c:v>26.829449853897096</c:v>
                </c:pt>
                <c:pt idx="2862">
                  <c:v>18.107250099182103</c:v>
                </c:pt>
                <c:pt idx="2863">
                  <c:v>15.885150218009954</c:v>
                </c:pt>
                <c:pt idx="2864">
                  <c:v>26.6677503585815</c:v>
                </c:pt>
                <c:pt idx="2865">
                  <c:v>16.594350085258498</c:v>
                </c:pt>
                <c:pt idx="2866">
                  <c:v>17.948549799919199</c:v>
                </c:pt>
                <c:pt idx="2867">
                  <c:v>24.158900165557796</c:v>
                </c:pt>
                <c:pt idx="2868">
                  <c:v>28.451999945640551</c:v>
                </c:pt>
                <c:pt idx="2869">
                  <c:v>21.417750010490451</c:v>
                </c:pt>
                <c:pt idx="2870">
                  <c:v>29.25335005283355</c:v>
                </c:pt>
                <c:pt idx="2871">
                  <c:v>16.65594989299775</c:v>
                </c:pt>
                <c:pt idx="2872">
                  <c:v>16.998550124168403</c:v>
                </c:pt>
                <c:pt idx="2873">
                  <c:v>15.841199669837955</c:v>
                </c:pt>
                <c:pt idx="2874">
                  <c:v>19.093549938201896</c:v>
                </c:pt>
                <c:pt idx="2875">
                  <c:v>18.265050082206749</c:v>
                </c:pt>
                <c:pt idx="2876">
                  <c:v>19.492500314712601</c:v>
                </c:pt>
                <c:pt idx="2877">
                  <c:v>22.064650106430101</c:v>
                </c:pt>
                <c:pt idx="2878">
                  <c:v>26.196799993515</c:v>
                </c:pt>
                <c:pt idx="2879">
                  <c:v>18.080600008964549</c:v>
                </c:pt>
                <c:pt idx="2880">
                  <c:v>17.688949952125547</c:v>
                </c:pt>
                <c:pt idx="2881">
                  <c:v>26.753200144767753</c:v>
                </c:pt>
                <c:pt idx="2882">
                  <c:v>34.929449753761347</c:v>
                </c:pt>
                <c:pt idx="2883">
                  <c:v>6.710400075912446</c:v>
                </c:pt>
                <c:pt idx="2884">
                  <c:v>14.955999889373746</c:v>
                </c:pt>
                <c:pt idx="2885">
                  <c:v>19.413650236129801</c:v>
                </c:pt>
                <c:pt idx="2886">
                  <c:v>23.6532000732422</c:v>
                </c:pt>
                <c:pt idx="2887">
                  <c:v>30.016499886512747</c:v>
                </c:pt>
                <c:pt idx="2888">
                  <c:v>26.92160002231595</c:v>
                </c:pt>
                <c:pt idx="2889">
                  <c:v>18.087100195884755</c:v>
                </c:pt>
                <c:pt idx="2890">
                  <c:v>18.555000147819552</c:v>
                </c:pt>
                <c:pt idx="2891">
                  <c:v>33.887749800682101</c:v>
                </c:pt>
                <c:pt idx="2892">
                  <c:v>14.57684986114505</c:v>
                </c:pt>
                <c:pt idx="2893">
                  <c:v>10.435950007438649</c:v>
                </c:pt>
                <c:pt idx="2894">
                  <c:v>21.302400217056249</c:v>
                </c:pt>
                <c:pt idx="2895">
                  <c:v>20.124549975395198</c:v>
                </c:pt>
                <c:pt idx="2896">
                  <c:v>22.803649859428404</c:v>
                </c:pt>
                <c:pt idx="2897">
                  <c:v>21.396049809455853</c:v>
                </c:pt>
                <c:pt idx="2898">
                  <c:v>16.543499789237902</c:v>
                </c:pt>
                <c:pt idx="2899">
                  <c:v>15.528300027847301</c:v>
                </c:pt>
                <c:pt idx="2900">
                  <c:v>24.47635014534</c:v>
                </c:pt>
                <c:pt idx="2901">
                  <c:v>16.482650165557796</c:v>
                </c:pt>
                <c:pt idx="2902">
                  <c:v>36.3502502250671</c:v>
                </c:pt>
                <c:pt idx="2903">
                  <c:v>14.157599983215299</c:v>
                </c:pt>
                <c:pt idx="2904">
                  <c:v>21.053149905204805</c:v>
                </c:pt>
                <c:pt idx="2905">
                  <c:v>23.992949948310851</c:v>
                </c:pt>
                <c:pt idx="2906">
                  <c:v>19.62034977912905</c:v>
                </c:pt>
                <c:pt idx="2907">
                  <c:v>20.825600242614698</c:v>
                </c:pt>
                <c:pt idx="2908">
                  <c:v>13.392899994850204</c:v>
                </c:pt>
                <c:pt idx="2909">
                  <c:v>17.038350028991701</c:v>
                </c:pt>
                <c:pt idx="2910">
                  <c:v>12.837199902534451</c:v>
                </c:pt>
                <c:pt idx="2911">
                  <c:v>15.788600111007646</c:v>
                </c:pt>
                <c:pt idx="2912">
                  <c:v>24.470900135040246</c:v>
                </c:pt>
                <c:pt idx="2913">
                  <c:v>12.996149964332602</c:v>
                </c:pt>
                <c:pt idx="2914">
                  <c:v>19.608750076293958</c:v>
                </c:pt>
                <c:pt idx="2915">
                  <c:v>9.0458999109268028</c:v>
                </c:pt>
                <c:pt idx="2916">
                  <c:v>25.390949897766099</c:v>
                </c:pt>
                <c:pt idx="2917">
                  <c:v>19.294099984168998</c:v>
                </c:pt>
                <c:pt idx="2918">
                  <c:v>11.328700060844398</c:v>
                </c:pt>
                <c:pt idx="2919">
                  <c:v>18.846050162315393</c:v>
                </c:pt>
                <c:pt idx="2920">
                  <c:v>18.837150015830996</c:v>
                </c:pt>
                <c:pt idx="2921">
                  <c:v>13.7029503440857</c:v>
                </c:pt>
                <c:pt idx="2922">
                  <c:v>10.997150015830996</c:v>
                </c:pt>
                <c:pt idx="2923">
                  <c:v>22.703800168037397</c:v>
                </c:pt>
                <c:pt idx="2924">
                  <c:v>17.862449769973797</c:v>
                </c:pt>
                <c:pt idx="2925">
                  <c:v>20.828850088119502</c:v>
                </c:pt>
                <c:pt idx="2926">
                  <c:v>17.348750019073499</c:v>
                </c:pt>
                <c:pt idx="2927">
                  <c:v>15.698649897575454</c:v>
                </c:pt>
                <c:pt idx="2928">
                  <c:v>20.884150090217553</c:v>
                </c:pt>
                <c:pt idx="2929">
                  <c:v>17.105699825286898</c:v>
                </c:pt>
                <c:pt idx="2930">
                  <c:v>21.968799967765797</c:v>
                </c:pt>
                <c:pt idx="2931">
                  <c:v>18.176600031852747</c:v>
                </c:pt>
                <c:pt idx="2932">
                  <c:v>18.846549925804194</c:v>
                </c:pt>
                <c:pt idx="2933">
                  <c:v>26.415350055694553</c:v>
                </c:pt>
                <c:pt idx="2934">
                  <c:v>20.157249970436101</c:v>
                </c:pt>
                <c:pt idx="2935">
                  <c:v>25.432950053215002</c:v>
                </c:pt>
                <c:pt idx="2936">
                  <c:v>7.78389986038205</c:v>
                </c:pt>
                <c:pt idx="2937">
                  <c:v>15.939800081253047</c:v>
                </c:pt>
                <c:pt idx="2938">
                  <c:v>19.654549989700307</c:v>
                </c:pt>
                <c:pt idx="2939">
                  <c:v>16.965000247955246</c:v>
                </c:pt>
                <c:pt idx="2940">
                  <c:v>22.604150209426905</c:v>
                </c:pt>
                <c:pt idx="2941">
                  <c:v>22.019450035095247</c:v>
                </c:pt>
                <c:pt idx="2942">
                  <c:v>23.098250064849857</c:v>
                </c:pt>
                <c:pt idx="2943">
                  <c:v>18.8571501111985</c:v>
                </c:pt>
                <c:pt idx="2944">
                  <c:v>20.812049903869603</c:v>
                </c:pt>
                <c:pt idx="2945">
                  <c:v>14.589749999046301</c:v>
                </c:pt>
                <c:pt idx="2946">
                  <c:v>18.449300017356848</c:v>
                </c:pt>
                <c:pt idx="2947">
                  <c:v>29.286199998855547</c:v>
                </c:pt>
                <c:pt idx="2948">
                  <c:v>18.721050238609305</c:v>
                </c:pt>
                <c:pt idx="2949">
                  <c:v>17.506700110435503</c:v>
                </c:pt>
                <c:pt idx="2950">
                  <c:v>17.348399891853298</c:v>
                </c:pt>
                <c:pt idx="2951">
                  <c:v>20.405899896621648</c:v>
                </c:pt>
                <c:pt idx="2952">
                  <c:v>15.885799946784946</c:v>
                </c:pt>
                <c:pt idx="2953">
                  <c:v>25.86104988574985</c:v>
                </c:pt>
                <c:pt idx="2954">
                  <c:v>29.271649823188799</c:v>
                </c:pt>
                <c:pt idx="2955">
                  <c:v>19.629600315094002</c:v>
                </c:pt>
                <c:pt idx="2956">
                  <c:v>30.63559978008265</c:v>
                </c:pt>
                <c:pt idx="2957">
                  <c:v>29.129300041198803</c:v>
                </c:pt>
                <c:pt idx="2958">
                  <c:v>20.585999975204444</c:v>
                </c:pt>
                <c:pt idx="2959">
                  <c:v>13.169199905395505</c:v>
                </c:pt>
                <c:pt idx="2960">
                  <c:v>18.089950203895601</c:v>
                </c:pt>
                <c:pt idx="2961">
                  <c:v>20.169800276756305</c:v>
                </c:pt>
                <c:pt idx="2962">
                  <c:v>21.848599987030049</c:v>
                </c:pt>
                <c:pt idx="2963">
                  <c:v>17.280700078010604</c:v>
                </c:pt>
                <c:pt idx="2964">
                  <c:v>19.442000050544699</c:v>
                </c:pt>
                <c:pt idx="2965">
                  <c:v>19.3406498432159</c:v>
                </c:pt>
                <c:pt idx="2966">
                  <c:v>22.475150070190445</c:v>
                </c:pt>
                <c:pt idx="2967">
                  <c:v>22.979449934959405</c:v>
                </c:pt>
                <c:pt idx="2968">
                  <c:v>20.274700160026498</c:v>
                </c:pt>
                <c:pt idx="2969">
                  <c:v>13.034199771881152</c:v>
                </c:pt>
                <c:pt idx="2970">
                  <c:v>16.959000182151748</c:v>
                </c:pt>
                <c:pt idx="2971">
                  <c:v>11.140499982833898</c:v>
                </c:pt>
                <c:pt idx="2972">
                  <c:v>22.967850136756901</c:v>
                </c:pt>
                <c:pt idx="2973">
                  <c:v>25.031949782371498</c:v>
                </c:pt>
                <c:pt idx="2974">
                  <c:v>27.907199811935399</c:v>
                </c:pt>
                <c:pt idx="2975">
                  <c:v>26.78844981193545</c:v>
                </c:pt>
                <c:pt idx="2976">
                  <c:v>18.666099839210499</c:v>
                </c:pt>
                <c:pt idx="2977">
                  <c:v>21.168950042724603</c:v>
                </c:pt>
                <c:pt idx="2978">
                  <c:v>29.146950187683096</c:v>
                </c:pt>
                <c:pt idx="2979">
                  <c:v>22.309249830245953</c:v>
                </c:pt>
                <c:pt idx="2980">
                  <c:v>23.010449843406651</c:v>
                </c:pt>
                <c:pt idx="2981">
                  <c:v>17.662949991226199</c:v>
                </c:pt>
                <c:pt idx="2982">
                  <c:v>12.6025499868393</c:v>
                </c:pt>
                <c:pt idx="2983">
                  <c:v>21.5111500835418</c:v>
                </c:pt>
                <c:pt idx="2984">
                  <c:v>16.267250089645401</c:v>
                </c:pt>
                <c:pt idx="2985">
                  <c:v>19.298950152397151</c:v>
                </c:pt>
                <c:pt idx="2986">
                  <c:v>23.39339970588685</c:v>
                </c:pt>
                <c:pt idx="2987">
                  <c:v>23.7452001476288</c:v>
                </c:pt>
                <c:pt idx="2988">
                  <c:v>18.250700044631998</c:v>
                </c:pt>
                <c:pt idx="2989">
                  <c:v>21.570000205039999</c:v>
                </c:pt>
                <c:pt idx="2990">
                  <c:v>17.854100074768049</c:v>
                </c:pt>
                <c:pt idx="2991">
                  <c:v>24.819249734878554</c:v>
                </c:pt>
                <c:pt idx="2992">
                  <c:v>15.794649877548252</c:v>
                </c:pt>
                <c:pt idx="2993">
                  <c:v>20.461900029182402</c:v>
                </c:pt>
                <c:pt idx="2994">
                  <c:v>29.490549874305703</c:v>
                </c:pt>
                <c:pt idx="2995">
                  <c:v>15.978500084877002</c:v>
                </c:pt>
                <c:pt idx="2996">
                  <c:v>20.325299925804146</c:v>
                </c:pt>
                <c:pt idx="2997">
                  <c:v>26.423649897575348</c:v>
                </c:pt>
                <c:pt idx="2998">
                  <c:v>17.320200052261406</c:v>
                </c:pt>
                <c:pt idx="2999">
                  <c:v>20.83135016441345</c:v>
                </c:pt>
                <c:pt idx="3000">
                  <c:v>23.377000002860953</c:v>
                </c:pt>
                <c:pt idx="3001">
                  <c:v>18.338349995613104</c:v>
                </c:pt>
                <c:pt idx="3002">
                  <c:v>15.056649913787854</c:v>
                </c:pt>
                <c:pt idx="3003">
                  <c:v>21.862600040435801</c:v>
                </c:pt>
                <c:pt idx="3004">
                  <c:v>13.732749972343399</c:v>
                </c:pt>
                <c:pt idx="3005">
                  <c:v>23.378050079345702</c:v>
                </c:pt>
                <c:pt idx="3006">
                  <c:v>20.690000009536703</c:v>
                </c:pt>
                <c:pt idx="3007">
                  <c:v>17.658499927520751</c:v>
                </c:pt>
                <c:pt idx="3008">
                  <c:v>20.148450160026496</c:v>
                </c:pt>
                <c:pt idx="3009">
                  <c:v>25.446099672317544</c:v>
                </c:pt>
                <c:pt idx="3010">
                  <c:v>18.933150124549897</c:v>
                </c:pt>
                <c:pt idx="3011">
                  <c:v>23.564949879646349</c:v>
                </c:pt>
                <c:pt idx="3012">
                  <c:v>17.730800147056652</c:v>
                </c:pt>
                <c:pt idx="3013">
                  <c:v>19.740049886703453</c:v>
                </c:pt>
                <c:pt idx="3014">
                  <c:v>14.243799867629996</c:v>
                </c:pt>
                <c:pt idx="3015">
                  <c:v>21.297499947547898</c:v>
                </c:pt>
                <c:pt idx="3016">
                  <c:v>17.808650188446052</c:v>
                </c:pt>
                <c:pt idx="3017">
                  <c:v>21.667799925804097</c:v>
                </c:pt>
                <c:pt idx="3018">
                  <c:v>18.166299862861649</c:v>
                </c:pt>
                <c:pt idx="3019">
                  <c:v>40.330700168609596</c:v>
                </c:pt>
                <c:pt idx="3020">
                  <c:v>25.672449955940255</c:v>
                </c:pt>
                <c:pt idx="3021">
                  <c:v>22.172199988365147</c:v>
                </c:pt>
                <c:pt idx="3022">
                  <c:v>22.778349957466098</c:v>
                </c:pt>
                <c:pt idx="3023">
                  <c:v>21.007650079727142</c:v>
                </c:pt>
                <c:pt idx="3024">
                  <c:v>30.114149951934799</c:v>
                </c:pt>
                <c:pt idx="3025">
                  <c:v>18.767400026321447</c:v>
                </c:pt>
                <c:pt idx="3026">
                  <c:v>20.371650114059449</c:v>
                </c:pt>
                <c:pt idx="3027">
                  <c:v>4.9173500061035504</c:v>
                </c:pt>
                <c:pt idx="3028">
                  <c:v>16.609550147056602</c:v>
                </c:pt>
                <c:pt idx="3029">
                  <c:v>26.691599960327153</c:v>
                </c:pt>
                <c:pt idx="3030">
                  <c:v>16.180400009155246</c:v>
                </c:pt>
                <c:pt idx="3031">
                  <c:v>15.536650066375699</c:v>
                </c:pt>
                <c:pt idx="3032">
                  <c:v>14.914550027847248</c:v>
                </c:pt>
                <c:pt idx="3033">
                  <c:v>18.263550233840949</c:v>
                </c:pt>
                <c:pt idx="3034">
                  <c:v>25.541499910354595</c:v>
                </c:pt>
                <c:pt idx="3035">
                  <c:v>34.072349696159407</c:v>
                </c:pt>
                <c:pt idx="3036">
                  <c:v>20.497899951934848</c:v>
                </c:pt>
                <c:pt idx="3037">
                  <c:v>30.104249820709246</c:v>
                </c:pt>
                <c:pt idx="3038">
                  <c:v>33.063350019454944</c:v>
                </c:pt>
                <c:pt idx="3039">
                  <c:v>31.161300065517398</c:v>
                </c:pt>
                <c:pt idx="3040">
                  <c:v>22.474399790763847</c:v>
                </c:pt>
                <c:pt idx="3041">
                  <c:v>9.8489999198913516</c:v>
                </c:pt>
                <c:pt idx="3042">
                  <c:v>22.024299898147596</c:v>
                </c:pt>
                <c:pt idx="3043">
                  <c:v>19.664549860954345</c:v>
                </c:pt>
                <c:pt idx="3044">
                  <c:v>26.020499892234795</c:v>
                </c:pt>
                <c:pt idx="3045">
                  <c:v>26.670449690818806</c:v>
                </c:pt>
                <c:pt idx="3046">
                  <c:v>27.645150094032303</c:v>
                </c:pt>
                <c:pt idx="3047">
                  <c:v>30.783449850082402</c:v>
                </c:pt>
                <c:pt idx="3048">
                  <c:v>13.59550002098085</c:v>
                </c:pt>
                <c:pt idx="3049">
                  <c:v>11.195799965858448</c:v>
                </c:pt>
                <c:pt idx="3050">
                  <c:v>6.6850000667572473</c:v>
                </c:pt>
                <c:pt idx="3051">
                  <c:v>18.684350066185051</c:v>
                </c:pt>
                <c:pt idx="3052">
                  <c:v>19.262800107002249</c:v>
                </c:pt>
                <c:pt idx="3053">
                  <c:v>19.9784001111984</c:v>
                </c:pt>
                <c:pt idx="3054">
                  <c:v>21.71159977436065</c:v>
                </c:pt>
                <c:pt idx="3055">
                  <c:v>20.123700022697498</c:v>
                </c:pt>
                <c:pt idx="3056">
                  <c:v>19.8869998884201</c:v>
                </c:pt>
                <c:pt idx="3057">
                  <c:v>22.476750302314748</c:v>
                </c:pt>
                <c:pt idx="3058">
                  <c:v>24.054149885177598</c:v>
                </c:pt>
                <c:pt idx="3059">
                  <c:v>15.838450231552102</c:v>
                </c:pt>
                <c:pt idx="3060">
                  <c:v>17.867250280380247</c:v>
                </c:pt>
                <c:pt idx="3061">
                  <c:v>22.471649823188748</c:v>
                </c:pt>
                <c:pt idx="3062">
                  <c:v>25.577300028800991</c:v>
                </c:pt>
                <c:pt idx="3063">
                  <c:v>24.901750030517551</c:v>
                </c:pt>
                <c:pt idx="3064">
                  <c:v>15.728549976348802</c:v>
                </c:pt>
                <c:pt idx="3065">
                  <c:v>23.314449977874801</c:v>
                </c:pt>
                <c:pt idx="3066">
                  <c:v>11.458449869155849</c:v>
                </c:pt>
                <c:pt idx="3067">
                  <c:v>19.617550086975051</c:v>
                </c:pt>
                <c:pt idx="3068">
                  <c:v>17.2634001350403</c:v>
                </c:pt>
                <c:pt idx="3069">
                  <c:v>16.020599989891053</c:v>
                </c:pt>
                <c:pt idx="3070">
                  <c:v>17.688800210952749</c:v>
                </c:pt>
                <c:pt idx="3071">
                  <c:v>20.765949597358748</c:v>
                </c:pt>
                <c:pt idx="3072">
                  <c:v>21.246550097465544</c:v>
                </c:pt>
                <c:pt idx="3073">
                  <c:v>19.3268997526169</c:v>
                </c:pt>
                <c:pt idx="3074">
                  <c:v>18.660249924659698</c:v>
                </c:pt>
                <c:pt idx="3075">
                  <c:v>18.857449879646303</c:v>
                </c:pt>
                <c:pt idx="3076">
                  <c:v>21.4190498018265</c:v>
                </c:pt>
                <c:pt idx="3077">
                  <c:v>16.159799861907995</c:v>
                </c:pt>
                <c:pt idx="3078">
                  <c:v>20.469149761199901</c:v>
                </c:pt>
                <c:pt idx="3079">
                  <c:v>13.605999917984001</c:v>
                </c:pt>
                <c:pt idx="3080">
                  <c:v>27.276800031661953</c:v>
                </c:pt>
                <c:pt idx="3081">
                  <c:v>24.235299811363198</c:v>
                </c:pt>
                <c:pt idx="3082">
                  <c:v>18.02535005092615</c:v>
                </c:pt>
                <c:pt idx="3083">
                  <c:v>23.654249892234752</c:v>
                </c:pt>
                <c:pt idx="3084">
                  <c:v>93.270299983024543</c:v>
                </c:pt>
                <c:pt idx="3085">
                  <c:v>21.044850192070001</c:v>
                </c:pt>
                <c:pt idx="3086">
                  <c:v>16.859649882316603</c:v>
                </c:pt>
                <c:pt idx="3087">
                  <c:v>14.068750214576752</c:v>
                </c:pt>
                <c:pt idx="3088">
                  <c:v>11.998150072097797</c:v>
                </c:pt>
                <c:pt idx="3089">
                  <c:v>12.536050081253052</c:v>
                </c:pt>
                <c:pt idx="3090">
                  <c:v>20.482599864006097</c:v>
                </c:pt>
                <c:pt idx="3091">
                  <c:v>14.250400075912502</c:v>
                </c:pt>
                <c:pt idx="3092">
                  <c:v>16.622400069236804</c:v>
                </c:pt>
                <c:pt idx="3093">
                  <c:v>20.71539992809295</c:v>
                </c:pt>
                <c:pt idx="3094">
                  <c:v>33.330049715042101</c:v>
                </c:pt>
                <c:pt idx="3095">
                  <c:v>20.7290499544143</c:v>
                </c:pt>
                <c:pt idx="3096">
                  <c:v>24.577899837493902</c:v>
                </c:pt>
                <c:pt idx="3097">
                  <c:v>13.962650017738348</c:v>
                </c:pt>
                <c:pt idx="3098">
                  <c:v>11.474299941062949</c:v>
                </c:pt>
                <c:pt idx="3099">
                  <c:v>15.017300024032551</c:v>
                </c:pt>
                <c:pt idx="3100">
                  <c:v>19.829900143146503</c:v>
                </c:pt>
                <c:pt idx="3101">
                  <c:v>15.230050172805797</c:v>
                </c:pt>
                <c:pt idx="3102">
                  <c:v>23.344399867057795</c:v>
                </c:pt>
                <c:pt idx="3103">
                  <c:v>15.317249984741252</c:v>
                </c:pt>
                <c:pt idx="3104">
                  <c:v>23.541050014495845</c:v>
                </c:pt>
                <c:pt idx="3105">
                  <c:v>26.372649807929996</c:v>
                </c:pt>
                <c:pt idx="3106">
                  <c:v>24.205449881553655</c:v>
                </c:pt>
                <c:pt idx="3107">
                  <c:v>28.468599476814298</c:v>
                </c:pt>
                <c:pt idx="3108">
                  <c:v>15.760050134658805</c:v>
                </c:pt>
                <c:pt idx="3109">
                  <c:v>16.553600134849503</c:v>
                </c:pt>
                <c:pt idx="3110">
                  <c:v>17.509249973297102</c:v>
                </c:pt>
                <c:pt idx="3111">
                  <c:v>25.298449778556851</c:v>
                </c:pt>
                <c:pt idx="3112">
                  <c:v>25.66149998664855</c:v>
                </c:pt>
                <c:pt idx="3113">
                  <c:v>19.042999682426448</c:v>
                </c:pt>
                <c:pt idx="3114">
                  <c:v>13.200950093269299</c:v>
                </c:pt>
                <c:pt idx="3115">
                  <c:v>25.527650079727152</c:v>
                </c:pt>
                <c:pt idx="3116">
                  <c:v>19.8465001058578</c:v>
                </c:pt>
                <c:pt idx="3117">
                  <c:v>18.165349955558803</c:v>
                </c:pt>
                <c:pt idx="3118">
                  <c:v>29.259899859428401</c:v>
                </c:pt>
                <c:pt idx="3119">
                  <c:v>15.462899885177649</c:v>
                </c:pt>
                <c:pt idx="3120">
                  <c:v>15.891349925994895</c:v>
                </c:pt>
                <c:pt idx="3121">
                  <c:v>16.392849969863903</c:v>
                </c:pt>
                <c:pt idx="3122">
                  <c:v>17.707900180816651</c:v>
                </c:pt>
                <c:pt idx="3123">
                  <c:v>13.736849966049249</c:v>
                </c:pt>
                <c:pt idx="3124">
                  <c:v>18.369700055122344</c:v>
                </c:pt>
                <c:pt idx="3125">
                  <c:v>19.390050282478299</c:v>
                </c:pt>
                <c:pt idx="3126">
                  <c:v>19.747600059509303</c:v>
                </c:pt>
                <c:pt idx="3127">
                  <c:v>17.925300111770653</c:v>
                </c:pt>
                <c:pt idx="3128">
                  <c:v>23.037000141143846</c:v>
                </c:pt>
                <c:pt idx="3129">
                  <c:v>10.434050049781749</c:v>
                </c:pt>
                <c:pt idx="3130">
                  <c:v>17.185750145912198</c:v>
                </c:pt>
                <c:pt idx="3131">
                  <c:v>23.595549974441496</c:v>
                </c:pt>
                <c:pt idx="3132">
                  <c:v>20.522700209617653</c:v>
                </c:pt>
                <c:pt idx="3133">
                  <c:v>19.490750203132649</c:v>
                </c:pt>
                <c:pt idx="3134">
                  <c:v>33.410799770355197</c:v>
                </c:pt>
                <c:pt idx="3135">
                  <c:v>17.668649978637752</c:v>
                </c:pt>
                <c:pt idx="3136">
                  <c:v>19.324999811649249</c:v>
                </c:pt>
                <c:pt idx="3137">
                  <c:v>32.332499866485605</c:v>
                </c:pt>
                <c:pt idx="3138">
                  <c:v>21.675550227165196</c:v>
                </c:pt>
                <c:pt idx="3139">
                  <c:v>12.016199951171856</c:v>
                </c:pt>
                <c:pt idx="3140">
                  <c:v>19.72839995384215</c:v>
                </c:pt>
                <c:pt idx="3141">
                  <c:v>19.527100086212201</c:v>
                </c:pt>
                <c:pt idx="3142">
                  <c:v>11.620900077819847</c:v>
                </c:pt>
                <c:pt idx="3143">
                  <c:v>21.824000129699652</c:v>
                </c:pt>
                <c:pt idx="3144">
                  <c:v>9.0574000215530006</c:v>
                </c:pt>
                <c:pt idx="3145">
                  <c:v>23.006099882125845</c:v>
                </c:pt>
                <c:pt idx="3146">
                  <c:v>17.138149957656797</c:v>
                </c:pt>
                <c:pt idx="3147">
                  <c:v>14.129750003814696</c:v>
                </c:pt>
                <c:pt idx="3148">
                  <c:v>12.150749869346654</c:v>
                </c:pt>
                <c:pt idx="3149">
                  <c:v>21.713549966812153</c:v>
                </c:pt>
                <c:pt idx="3150">
                  <c:v>14.302349896430904</c:v>
                </c:pt>
                <c:pt idx="3151">
                  <c:v>17.305049891471899</c:v>
                </c:pt>
                <c:pt idx="3152">
                  <c:v>17.044749841690049</c:v>
                </c:pt>
                <c:pt idx="3153">
                  <c:v>22.019600005149851</c:v>
                </c:pt>
                <c:pt idx="3154">
                  <c:v>20.751249947547905</c:v>
                </c:pt>
                <c:pt idx="3155">
                  <c:v>15.517199869155899</c:v>
                </c:pt>
                <c:pt idx="3156">
                  <c:v>25.902699728012053</c:v>
                </c:pt>
                <c:pt idx="3157">
                  <c:v>18.447899932861347</c:v>
                </c:pt>
                <c:pt idx="3158">
                  <c:v>13.943200082778901</c:v>
                </c:pt>
                <c:pt idx="3159">
                  <c:v>25.292099900245645</c:v>
                </c:pt>
                <c:pt idx="3160">
                  <c:v>20.2139497661591</c:v>
                </c:pt>
                <c:pt idx="3161">
                  <c:v>20.802949762344298</c:v>
                </c:pt>
                <c:pt idx="3162">
                  <c:v>12.798899955749455</c:v>
                </c:pt>
                <c:pt idx="3163">
                  <c:v>22.119400053024254</c:v>
                </c:pt>
                <c:pt idx="3164">
                  <c:v>27.039349999427749</c:v>
                </c:pt>
                <c:pt idx="3165">
                  <c:v>26.433450207710202</c:v>
                </c:pt>
                <c:pt idx="3166">
                  <c:v>14.669649915695203</c:v>
                </c:pt>
                <c:pt idx="3167">
                  <c:v>14.633249921798701</c:v>
                </c:pt>
                <c:pt idx="3168">
                  <c:v>33.311999845504801</c:v>
                </c:pt>
                <c:pt idx="3169">
                  <c:v>13.846550178527899</c:v>
                </c:pt>
                <c:pt idx="3170">
                  <c:v>20.9172000551224</c:v>
                </c:pt>
                <c:pt idx="3171">
                  <c:v>22.434599986076304</c:v>
                </c:pt>
                <c:pt idx="3172">
                  <c:v>14.8370000219345</c:v>
                </c:pt>
                <c:pt idx="3173">
                  <c:v>22.13025004863735</c:v>
                </c:pt>
                <c:pt idx="3174">
                  <c:v>18.098700151443502</c:v>
                </c:pt>
                <c:pt idx="3175">
                  <c:v>16.052499938011152</c:v>
                </c:pt>
                <c:pt idx="3176">
                  <c:v>12.5085000801086</c:v>
                </c:pt>
                <c:pt idx="3177">
                  <c:v>7.4533499145508024</c:v>
                </c:pt>
                <c:pt idx="3178">
                  <c:v>8.9396499061584507</c:v>
                </c:pt>
                <c:pt idx="3179">
                  <c:v>19.223749938011252</c:v>
                </c:pt>
                <c:pt idx="3180">
                  <c:v>10.607149925231951</c:v>
                </c:pt>
                <c:pt idx="3181">
                  <c:v>17.647400031089752</c:v>
                </c:pt>
                <c:pt idx="3182">
                  <c:v>14.44520004272465</c:v>
                </c:pt>
                <c:pt idx="3183">
                  <c:v>11.413299822807296</c:v>
                </c:pt>
                <c:pt idx="3184">
                  <c:v>19.575499916076652</c:v>
                </c:pt>
                <c:pt idx="3185">
                  <c:v>13.926250047683702</c:v>
                </c:pt>
                <c:pt idx="3186">
                  <c:v>10.750899925231906</c:v>
                </c:pt>
                <c:pt idx="3187">
                  <c:v>24.7544499158859</c:v>
                </c:pt>
                <c:pt idx="3188">
                  <c:v>18.9706503391266</c:v>
                </c:pt>
                <c:pt idx="3189">
                  <c:v>15.255649824142452</c:v>
                </c:pt>
                <c:pt idx="3190">
                  <c:v>11.9788498067856</c:v>
                </c:pt>
                <c:pt idx="3191">
                  <c:v>11.758300056457447</c:v>
                </c:pt>
                <c:pt idx="3192">
                  <c:v>20.392049894332906</c:v>
                </c:pt>
                <c:pt idx="3193">
                  <c:v>11.744999938011148</c:v>
                </c:pt>
                <c:pt idx="3194">
                  <c:v>24.9542999792099</c:v>
                </c:pt>
                <c:pt idx="3195">
                  <c:v>11.373199958801251</c:v>
                </c:pt>
                <c:pt idx="3196">
                  <c:v>21.65049999713905</c:v>
                </c:pt>
                <c:pt idx="3197">
                  <c:v>15.382799940109251</c:v>
                </c:pt>
                <c:pt idx="3198">
                  <c:v>25.760099787712097</c:v>
                </c:pt>
                <c:pt idx="3199">
                  <c:v>21.282700042724645</c:v>
                </c:pt>
                <c:pt idx="3200">
                  <c:v>12.53744967460635</c:v>
                </c:pt>
                <c:pt idx="3201">
                  <c:v>29.93974989414215</c:v>
                </c:pt>
                <c:pt idx="3202">
                  <c:v>22.5356000709534</c:v>
                </c:pt>
                <c:pt idx="3203">
                  <c:v>14.814199943542448</c:v>
                </c:pt>
                <c:pt idx="3204">
                  <c:v>18.693450012207045</c:v>
                </c:pt>
                <c:pt idx="3205">
                  <c:v>16.047100238800049</c:v>
                </c:pt>
                <c:pt idx="3206">
                  <c:v>24.404199748039296</c:v>
                </c:pt>
                <c:pt idx="3207">
                  <c:v>20.370450010299699</c:v>
                </c:pt>
                <c:pt idx="3208">
                  <c:v>20.93785009860995</c:v>
                </c:pt>
                <c:pt idx="3209">
                  <c:v>29.374199790954549</c:v>
                </c:pt>
                <c:pt idx="3210">
                  <c:v>17.36400002717965</c:v>
                </c:pt>
                <c:pt idx="3211">
                  <c:v>17.309450006484951</c:v>
                </c:pt>
                <c:pt idx="3212">
                  <c:v>16.342649950981201</c:v>
                </c:pt>
                <c:pt idx="3213">
                  <c:v>16.992399883270256</c:v>
                </c:pt>
                <c:pt idx="3214">
                  <c:v>26.037649765014656</c:v>
                </c:pt>
                <c:pt idx="3215">
                  <c:v>21.989749979972849</c:v>
                </c:pt>
                <c:pt idx="3216">
                  <c:v>17.452700166702197</c:v>
                </c:pt>
                <c:pt idx="3217">
                  <c:v>20.730450129508945</c:v>
                </c:pt>
                <c:pt idx="3218">
                  <c:v>16.290849862098646</c:v>
                </c:pt>
                <c:pt idx="3219">
                  <c:v>20.58099992752075</c:v>
                </c:pt>
                <c:pt idx="3220">
                  <c:v>25.28120008945465</c:v>
                </c:pt>
                <c:pt idx="3221">
                  <c:v>17.140299878120402</c:v>
                </c:pt>
                <c:pt idx="3222">
                  <c:v>13.648899998664852</c:v>
                </c:pt>
                <c:pt idx="3223">
                  <c:v>18.541450028419447</c:v>
                </c:pt>
                <c:pt idx="3224">
                  <c:v>28.650249814987198</c:v>
                </c:pt>
                <c:pt idx="3225">
                  <c:v>21.469700121879598</c:v>
                </c:pt>
                <c:pt idx="3226">
                  <c:v>8.8208999681473017</c:v>
                </c:pt>
                <c:pt idx="3227">
                  <c:v>18.546200232505804</c:v>
                </c:pt>
                <c:pt idx="3228">
                  <c:v>11.315349898338351</c:v>
                </c:pt>
                <c:pt idx="3229">
                  <c:v>22.620450057983444</c:v>
                </c:pt>
                <c:pt idx="3230">
                  <c:v>15.973249940872194</c:v>
                </c:pt>
                <c:pt idx="3231">
                  <c:v>11.756199960708649</c:v>
                </c:pt>
                <c:pt idx="3232">
                  <c:v>24.888049826622002</c:v>
                </c:pt>
                <c:pt idx="3233">
                  <c:v>28.323299670219448</c:v>
                </c:pt>
                <c:pt idx="3234">
                  <c:v>19.779000282287647</c:v>
                </c:pt>
                <c:pt idx="3235">
                  <c:v>20.449649946689547</c:v>
                </c:pt>
                <c:pt idx="3236">
                  <c:v>20.710800127983099</c:v>
                </c:pt>
                <c:pt idx="3237">
                  <c:v>18.105850033760049</c:v>
                </c:pt>
                <c:pt idx="3238">
                  <c:v>15.540849919319157</c:v>
                </c:pt>
                <c:pt idx="3239">
                  <c:v>36.492950181961049</c:v>
                </c:pt>
                <c:pt idx="3240">
                  <c:v>28.091550045013406</c:v>
                </c:pt>
                <c:pt idx="3241">
                  <c:v>14.372950215339646</c:v>
                </c:pt>
                <c:pt idx="3242">
                  <c:v>22.784600024223302</c:v>
                </c:pt>
                <c:pt idx="3243">
                  <c:v>11.250750021934504</c:v>
                </c:pt>
                <c:pt idx="3244">
                  <c:v>28.246799778938296</c:v>
                </c:pt>
                <c:pt idx="3245">
                  <c:v>19.321449933052051</c:v>
                </c:pt>
                <c:pt idx="3246">
                  <c:v>18.219800019264198</c:v>
                </c:pt>
                <c:pt idx="3247">
                  <c:v>18.85160003662115</c:v>
                </c:pt>
                <c:pt idx="3248">
                  <c:v>21.699300036430351</c:v>
                </c:pt>
                <c:pt idx="3249">
                  <c:v>15.7654002332687</c:v>
                </c:pt>
                <c:pt idx="3250">
                  <c:v>16.125150036811853</c:v>
                </c:pt>
                <c:pt idx="3251">
                  <c:v>12.694050021171606</c:v>
                </c:pt>
                <c:pt idx="3252">
                  <c:v>17.2024000406265</c:v>
                </c:pt>
                <c:pt idx="3253">
                  <c:v>24.285150117874196</c:v>
                </c:pt>
                <c:pt idx="3254">
                  <c:v>20.715599999427798</c:v>
                </c:pt>
                <c:pt idx="3255">
                  <c:v>8.2555000162124514</c:v>
                </c:pt>
                <c:pt idx="3256">
                  <c:v>21.133949909210195</c:v>
                </c:pt>
                <c:pt idx="3257">
                  <c:v>25.333599748611398</c:v>
                </c:pt>
                <c:pt idx="3258">
                  <c:v>13.78230000972745</c:v>
                </c:pt>
                <c:pt idx="3259">
                  <c:v>18.600299968719455</c:v>
                </c:pt>
                <c:pt idx="3260">
                  <c:v>13.06895015239715</c:v>
                </c:pt>
                <c:pt idx="3261">
                  <c:v>39.961349849700945</c:v>
                </c:pt>
                <c:pt idx="3262">
                  <c:v>16.304549956321704</c:v>
                </c:pt>
                <c:pt idx="3263">
                  <c:v>12.393750176429748</c:v>
                </c:pt>
                <c:pt idx="3264">
                  <c:v>21.8309998512268</c:v>
                </c:pt>
                <c:pt idx="3265">
                  <c:v>16.877450027465798</c:v>
                </c:pt>
                <c:pt idx="3266">
                  <c:v>31.245899791717548</c:v>
                </c:pt>
                <c:pt idx="3267">
                  <c:v>21.035149779319745</c:v>
                </c:pt>
                <c:pt idx="3268">
                  <c:v>21.249050035476699</c:v>
                </c:pt>
                <c:pt idx="3269">
                  <c:v>28.240950136184651</c:v>
                </c:pt>
                <c:pt idx="3270">
                  <c:v>20.468349723815905</c:v>
                </c:pt>
                <c:pt idx="3271">
                  <c:v>31.058499984741246</c:v>
                </c:pt>
                <c:pt idx="3272">
                  <c:v>19.163949861526497</c:v>
                </c:pt>
                <c:pt idx="3273">
                  <c:v>19.361050138473495</c:v>
                </c:pt>
                <c:pt idx="3274">
                  <c:v>18.012850146293701</c:v>
                </c:pt>
                <c:pt idx="3275">
                  <c:v>17.950099806785602</c:v>
                </c:pt>
                <c:pt idx="3276">
                  <c:v>13.725500106811548</c:v>
                </c:pt>
                <c:pt idx="3277">
                  <c:v>13.994199814796453</c:v>
                </c:pt>
                <c:pt idx="3278">
                  <c:v>25.207899837493848</c:v>
                </c:pt>
                <c:pt idx="3279">
                  <c:v>26.628699989318847</c:v>
                </c:pt>
                <c:pt idx="3280">
                  <c:v>17.251600117683445</c:v>
                </c:pt>
                <c:pt idx="3281">
                  <c:v>17.062050065994296</c:v>
                </c:pt>
                <c:pt idx="3282">
                  <c:v>8.0088001394271942</c:v>
                </c:pt>
                <c:pt idx="3283">
                  <c:v>10.461449933052101</c:v>
                </c:pt>
                <c:pt idx="3284">
                  <c:v>24.270199971199055</c:v>
                </c:pt>
                <c:pt idx="3285">
                  <c:v>8.4487498903274521</c:v>
                </c:pt>
                <c:pt idx="3286">
                  <c:v>21.017250018119803</c:v>
                </c:pt>
                <c:pt idx="3287">
                  <c:v>13.357449975013701</c:v>
                </c:pt>
                <c:pt idx="3288">
                  <c:v>10.5146999597549</c:v>
                </c:pt>
                <c:pt idx="3289">
                  <c:v>15.671399984359699</c:v>
                </c:pt>
                <c:pt idx="3290">
                  <c:v>22.024800000190751</c:v>
                </c:pt>
                <c:pt idx="3291">
                  <c:v>27.252250082492807</c:v>
                </c:pt>
                <c:pt idx="3292">
                  <c:v>21.6637500429154</c:v>
                </c:pt>
                <c:pt idx="3293">
                  <c:v>21.383450140953002</c:v>
                </c:pt>
                <c:pt idx="3294">
                  <c:v>14.746499862670849</c:v>
                </c:pt>
                <c:pt idx="3295">
                  <c:v>16.547899794578555</c:v>
                </c:pt>
                <c:pt idx="3296">
                  <c:v>13.471499824523903</c:v>
                </c:pt>
                <c:pt idx="3297">
                  <c:v>20.839300222396897</c:v>
                </c:pt>
                <c:pt idx="3298">
                  <c:v>14.710800032615651</c:v>
                </c:pt>
                <c:pt idx="3299">
                  <c:v>21.261850161552399</c:v>
                </c:pt>
                <c:pt idx="3300">
                  <c:v>17.014700107574448</c:v>
                </c:pt>
                <c:pt idx="3301">
                  <c:v>36.026050047874449</c:v>
                </c:pt>
                <c:pt idx="3302">
                  <c:v>15.632950100898697</c:v>
                </c:pt>
                <c:pt idx="3303">
                  <c:v>18.73350020885465</c:v>
                </c:pt>
                <c:pt idx="3304">
                  <c:v>20.970550098419203</c:v>
                </c:pt>
                <c:pt idx="3305">
                  <c:v>11.112149772644049</c:v>
                </c:pt>
                <c:pt idx="3306">
                  <c:v>15.235549950599648</c:v>
                </c:pt>
                <c:pt idx="3307">
                  <c:v>26.218449907302855</c:v>
                </c:pt>
                <c:pt idx="3308">
                  <c:v>12.601349911689752</c:v>
                </c:pt>
                <c:pt idx="3309">
                  <c:v>16.736699953079249</c:v>
                </c:pt>
                <c:pt idx="3310">
                  <c:v>17.960999875068651</c:v>
                </c:pt>
                <c:pt idx="3311">
                  <c:v>19.028299918174703</c:v>
                </c:pt>
                <c:pt idx="3312">
                  <c:v>17.700700049400304</c:v>
                </c:pt>
                <c:pt idx="3313">
                  <c:v>18.657299952507003</c:v>
                </c:pt>
                <c:pt idx="3314">
                  <c:v>18.657299952507003</c:v>
                </c:pt>
                <c:pt idx="3315">
                  <c:v>9.3341998624801512</c:v>
                </c:pt>
                <c:pt idx="3316">
                  <c:v>20.965600180625895</c:v>
                </c:pt>
                <c:pt idx="3317">
                  <c:v>18.346249861717201</c:v>
                </c:pt>
                <c:pt idx="3318">
                  <c:v>22.52080001354215</c:v>
                </c:pt>
                <c:pt idx="3319">
                  <c:v>31.977849912643446</c:v>
                </c:pt>
                <c:pt idx="3320">
                  <c:v>20.4777498722076</c:v>
                </c:pt>
                <c:pt idx="3321">
                  <c:v>17.042250099182098</c:v>
                </c:pt>
                <c:pt idx="3322">
                  <c:v>18.920050029754648</c:v>
                </c:pt>
                <c:pt idx="3323">
                  <c:v>18.8421498727798</c:v>
                </c:pt>
                <c:pt idx="3324">
                  <c:v>15.219849925041196</c:v>
                </c:pt>
                <c:pt idx="3325">
                  <c:v>25.047700033187894</c:v>
                </c:pt>
                <c:pt idx="3326">
                  <c:v>25.478300032615646</c:v>
                </c:pt>
                <c:pt idx="3327">
                  <c:v>17.057399830818149</c:v>
                </c:pt>
                <c:pt idx="3328">
                  <c:v>23.053600077629099</c:v>
                </c:pt>
                <c:pt idx="3329">
                  <c:v>31.933299865722599</c:v>
                </c:pt>
                <c:pt idx="3330">
                  <c:v>19.73239974498745</c:v>
                </c:pt>
                <c:pt idx="3331">
                  <c:v>24.135249996185351</c:v>
                </c:pt>
                <c:pt idx="3332">
                  <c:v>14.568700089454648</c:v>
                </c:pt>
                <c:pt idx="3333">
                  <c:v>16.899199762344349</c:v>
                </c:pt>
                <c:pt idx="3334">
                  <c:v>21.5475498247147</c:v>
                </c:pt>
                <c:pt idx="3335">
                  <c:v>17.353000235557495</c:v>
                </c:pt>
                <c:pt idx="3336">
                  <c:v>20.576400198936447</c:v>
                </c:pt>
                <c:pt idx="3337">
                  <c:v>18.823399720191954</c:v>
                </c:pt>
                <c:pt idx="3338">
                  <c:v>20.338300099372852</c:v>
                </c:pt>
                <c:pt idx="3339">
                  <c:v>23.503099956512401</c:v>
                </c:pt>
                <c:pt idx="3340">
                  <c:v>11.560249943733155</c:v>
                </c:pt>
                <c:pt idx="3341">
                  <c:v>26.844699826240554</c:v>
                </c:pt>
                <c:pt idx="3342">
                  <c:v>15.478949956893949</c:v>
                </c:pt>
                <c:pt idx="3343">
                  <c:v>28.981100053787245</c:v>
                </c:pt>
                <c:pt idx="3344">
                  <c:v>17.583899998664847</c:v>
                </c:pt>
                <c:pt idx="3345">
                  <c:v>16.685499925613453</c:v>
                </c:pt>
                <c:pt idx="3346">
                  <c:v>11.343749842643749</c:v>
                </c:pt>
                <c:pt idx="3347">
                  <c:v>17.874349880218507</c:v>
                </c:pt>
                <c:pt idx="3348">
                  <c:v>13.218400106430053</c:v>
                </c:pt>
                <c:pt idx="3349">
                  <c:v>21.493199977874752</c:v>
                </c:pt>
                <c:pt idx="3350">
                  <c:v>28.896199779510447</c:v>
                </c:pt>
                <c:pt idx="3351">
                  <c:v>17.882099995613153</c:v>
                </c:pt>
                <c:pt idx="3352">
                  <c:v>25.305199835300456</c:v>
                </c:pt>
                <c:pt idx="3353">
                  <c:v>20.808050312995896</c:v>
                </c:pt>
                <c:pt idx="3354">
                  <c:v>14.584599905014052</c:v>
                </c:pt>
                <c:pt idx="3355">
                  <c:v>21.179149961471548</c:v>
                </c:pt>
                <c:pt idx="3356">
                  <c:v>18.846199851036054</c:v>
                </c:pt>
                <c:pt idx="3357">
                  <c:v>20.281550073623656</c:v>
                </c:pt>
                <c:pt idx="3358">
                  <c:v>17.012249708175702</c:v>
                </c:pt>
                <c:pt idx="3359">
                  <c:v>23.953300065994295</c:v>
                </c:pt>
                <c:pt idx="3360">
                  <c:v>15.645100011825605</c:v>
                </c:pt>
                <c:pt idx="3361">
                  <c:v>20.348600015640251</c:v>
                </c:pt>
                <c:pt idx="3362">
                  <c:v>14.355099911689749</c:v>
                </c:pt>
                <c:pt idx="3363">
                  <c:v>17.817999877929747</c:v>
                </c:pt>
                <c:pt idx="3364">
                  <c:v>20.902100028991754</c:v>
                </c:pt>
                <c:pt idx="3365">
                  <c:v>8.0033997821808001</c:v>
                </c:pt>
                <c:pt idx="3366">
                  <c:v>29.052299983501452</c:v>
                </c:pt>
                <c:pt idx="3367">
                  <c:v>24.617549710273753</c:v>
                </c:pt>
                <c:pt idx="3368">
                  <c:v>16.637800269126853</c:v>
                </c:pt>
                <c:pt idx="3369">
                  <c:v>12.082149791717548</c:v>
                </c:pt>
                <c:pt idx="3370">
                  <c:v>13.244900093078595</c:v>
                </c:pt>
                <c:pt idx="3371">
                  <c:v>23.784649693965896</c:v>
                </c:pt>
                <c:pt idx="3372">
                  <c:v>20.7138003015518</c:v>
                </c:pt>
                <c:pt idx="3373">
                  <c:v>17.687899899482748</c:v>
                </c:pt>
                <c:pt idx="3374">
                  <c:v>12.601350016593955</c:v>
                </c:pt>
                <c:pt idx="3375">
                  <c:v>13.32219996452335</c:v>
                </c:pt>
                <c:pt idx="3376">
                  <c:v>16.373149895668046</c:v>
                </c:pt>
                <c:pt idx="3377">
                  <c:v>15.273449673652649</c:v>
                </c:pt>
                <c:pt idx="3378">
                  <c:v>14.432400150299053</c:v>
                </c:pt>
                <c:pt idx="3379">
                  <c:v>26.950200014114397</c:v>
                </c:pt>
                <c:pt idx="3380">
                  <c:v>18.708900036811901</c:v>
                </c:pt>
                <c:pt idx="3381">
                  <c:v>16.715150084495505</c:v>
                </c:pt>
                <c:pt idx="3382">
                  <c:v>20.222649788856494</c:v>
                </c:pt>
                <c:pt idx="3383">
                  <c:v>26.377550153732304</c:v>
                </c:pt>
                <c:pt idx="3384">
                  <c:v>16.130350069999697</c:v>
                </c:pt>
                <c:pt idx="3385">
                  <c:v>12.347799820900001</c:v>
                </c:pt>
                <c:pt idx="3386">
                  <c:v>11.214350061416603</c:v>
                </c:pt>
                <c:pt idx="3387">
                  <c:v>35.227050151824955</c:v>
                </c:pt>
                <c:pt idx="3388">
                  <c:v>23.85464984416965</c:v>
                </c:pt>
                <c:pt idx="3389">
                  <c:v>18.216250052452146</c:v>
                </c:pt>
                <c:pt idx="3390">
                  <c:v>27.057099747657801</c:v>
                </c:pt>
                <c:pt idx="3391">
                  <c:v>19.993750066757201</c:v>
                </c:pt>
                <c:pt idx="3392">
                  <c:v>20.062549991607703</c:v>
                </c:pt>
                <c:pt idx="3393">
                  <c:v>13.501649746894845</c:v>
                </c:pt>
                <c:pt idx="3394">
                  <c:v>15.480099935531598</c:v>
                </c:pt>
                <c:pt idx="3395">
                  <c:v>9.9171498727798486</c:v>
                </c:pt>
                <c:pt idx="3396">
                  <c:v>19.640000057220501</c:v>
                </c:pt>
                <c:pt idx="3397">
                  <c:v>13.574449906349201</c:v>
                </c:pt>
                <c:pt idx="3398">
                  <c:v>19.870500159263607</c:v>
                </c:pt>
                <c:pt idx="3399">
                  <c:v>22.522199816703797</c:v>
                </c:pt>
                <c:pt idx="3400">
                  <c:v>14.1994001245499</c:v>
                </c:pt>
                <c:pt idx="3401">
                  <c:v>26.534449653625501</c:v>
                </c:pt>
                <c:pt idx="3402">
                  <c:v>12.8329500341416</c:v>
                </c:pt>
                <c:pt idx="3403">
                  <c:v>13.8352501630783</c:v>
                </c:pt>
                <c:pt idx="3404">
                  <c:v>18.832700147628806</c:v>
                </c:pt>
                <c:pt idx="3405">
                  <c:v>17.558749971389751</c:v>
                </c:pt>
                <c:pt idx="3406">
                  <c:v>21.854050183296248</c:v>
                </c:pt>
                <c:pt idx="3407">
                  <c:v>17.025650086402901</c:v>
                </c:pt>
                <c:pt idx="3408">
                  <c:v>23.659350061416653</c:v>
                </c:pt>
                <c:pt idx="3409">
                  <c:v>26.088500142097502</c:v>
                </c:pt>
                <c:pt idx="3410">
                  <c:v>16.728899955749547</c:v>
                </c:pt>
                <c:pt idx="3411">
                  <c:v>21.043150157928501</c:v>
                </c:pt>
                <c:pt idx="3412">
                  <c:v>12.603650074005103</c:v>
                </c:pt>
                <c:pt idx="3413">
                  <c:v>22.397849793434148</c:v>
                </c:pt>
                <c:pt idx="3414">
                  <c:v>11.654749946594201</c:v>
                </c:pt>
                <c:pt idx="3415">
                  <c:v>13.480600042343099</c:v>
                </c:pt>
                <c:pt idx="3416">
                  <c:v>15.567300076484653</c:v>
                </c:pt>
                <c:pt idx="3417">
                  <c:v>17.405250034332305</c:v>
                </c:pt>
                <c:pt idx="3418">
                  <c:v>22.309699964523293</c:v>
                </c:pt>
                <c:pt idx="3419">
                  <c:v>15.716850085258454</c:v>
                </c:pt>
                <c:pt idx="3420">
                  <c:v>9.3202499628066988</c:v>
                </c:pt>
                <c:pt idx="3421">
                  <c:v>19.716949710845956</c:v>
                </c:pt>
                <c:pt idx="3422">
                  <c:v>16.854400138854999</c:v>
                </c:pt>
                <c:pt idx="3423">
                  <c:v>20.562400097847004</c:v>
                </c:pt>
                <c:pt idx="3424">
                  <c:v>33.192700057029754</c:v>
                </c:pt>
                <c:pt idx="3425">
                  <c:v>14.003150148391697</c:v>
                </c:pt>
                <c:pt idx="3426">
                  <c:v>22.715900015830901</c:v>
                </c:pt>
                <c:pt idx="3427">
                  <c:v>13.812200164794902</c:v>
                </c:pt>
                <c:pt idx="3428">
                  <c:v>19.014950156211796</c:v>
                </c:pt>
                <c:pt idx="3429">
                  <c:v>21.900199980735749</c:v>
                </c:pt>
                <c:pt idx="3430">
                  <c:v>12.836399955749496</c:v>
                </c:pt>
                <c:pt idx="3431">
                  <c:v>18.741799864769</c:v>
                </c:pt>
                <c:pt idx="3432">
                  <c:v>32.260450091362003</c:v>
                </c:pt>
                <c:pt idx="3433">
                  <c:v>9.1520000028610013</c:v>
                </c:pt>
                <c:pt idx="3434">
                  <c:v>19.405400347709698</c:v>
                </c:pt>
                <c:pt idx="3435">
                  <c:v>10.4312998199463</c:v>
                </c:pt>
                <c:pt idx="3436">
                  <c:v>19.062649955749496</c:v>
                </c:pt>
                <c:pt idx="3437">
                  <c:v>19.545950026512102</c:v>
                </c:pt>
                <c:pt idx="3438">
                  <c:v>22.666850032806451</c:v>
                </c:pt>
                <c:pt idx="3439">
                  <c:v>27.223550019264199</c:v>
                </c:pt>
                <c:pt idx="3440">
                  <c:v>22.281449732780452</c:v>
                </c:pt>
                <c:pt idx="3441">
                  <c:v>30.5474999141693</c:v>
                </c:pt>
                <c:pt idx="3442">
                  <c:v>27.612749972343401</c:v>
                </c:pt>
                <c:pt idx="3443">
                  <c:v>15.112299857139604</c:v>
                </c:pt>
                <c:pt idx="3444">
                  <c:v>30.039299988746599</c:v>
                </c:pt>
                <c:pt idx="3445">
                  <c:v>10.602849826812694</c:v>
                </c:pt>
                <c:pt idx="3446">
                  <c:v>12.807800087928747</c:v>
                </c:pt>
                <c:pt idx="3447">
                  <c:v>14.294699954986605</c:v>
                </c:pt>
                <c:pt idx="3448">
                  <c:v>19.403249869346595</c:v>
                </c:pt>
                <c:pt idx="3449">
                  <c:v>25.251050062179544</c:v>
                </c:pt>
                <c:pt idx="3450">
                  <c:v>10.743899846076946</c:v>
                </c:pt>
                <c:pt idx="3451">
                  <c:v>18.923950080871595</c:v>
                </c:pt>
                <c:pt idx="3452">
                  <c:v>13.9554500722885</c:v>
                </c:pt>
                <c:pt idx="3453">
                  <c:v>18.045050072669994</c:v>
                </c:pt>
                <c:pt idx="3454">
                  <c:v>10.879650077819747</c:v>
                </c:pt>
                <c:pt idx="3455">
                  <c:v>25.8630999326706</c:v>
                </c:pt>
                <c:pt idx="3456">
                  <c:v>17.837900047302195</c:v>
                </c:pt>
                <c:pt idx="3457">
                  <c:v>19.426599841117849</c:v>
                </c:pt>
                <c:pt idx="3458">
                  <c:v>7.5426998853683003</c:v>
                </c:pt>
                <c:pt idx="3459">
                  <c:v>25.398649744987452</c:v>
                </c:pt>
                <c:pt idx="3460">
                  <c:v>16.728949985504151</c:v>
                </c:pt>
                <c:pt idx="3461">
                  <c:v>4.2346996927261529</c:v>
                </c:pt>
                <c:pt idx="3462">
                  <c:v>17.330949988365198</c:v>
                </c:pt>
                <c:pt idx="3463">
                  <c:v>11.535549883842442</c:v>
                </c:pt>
                <c:pt idx="3464">
                  <c:v>12.498449850082402</c:v>
                </c:pt>
                <c:pt idx="3465">
                  <c:v>19.889950165748594</c:v>
                </c:pt>
                <c:pt idx="3466">
                  <c:v>11.342049956321702</c:v>
                </c:pt>
                <c:pt idx="3467">
                  <c:v>33.734700040817245</c:v>
                </c:pt>
                <c:pt idx="3468">
                  <c:v>7.5240999078750512</c:v>
                </c:pt>
                <c:pt idx="3469">
                  <c:v>23.635350055694552</c:v>
                </c:pt>
                <c:pt idx="3470">
                  <c:v>25.062099604606601</c:v>
                </c:pt>
                <c:pt idx="3471">
                  <c:v>10.753699994087199</c:v>
                </c:pt>
                <c:pt idx="3472">
                  <c:v>15.575049958229044</c:v>
                </c:pt>
                <c:pt idx="3473">
                  <c:v>12.640899863243099</c:v>
                </c:pt>
                <c:pt idx="3474">
                  <c:v>19.830699930191045</c:v>
                </c:pt>
                <c:pt idx="3475">
                  <c:v>12.625349960327153</c:v>
                </c:pt>
                <c:pt idx="3476">
                  <c:v>21.746249899864196</c:v>
                </c:pt>
                <c:pt idx="3477">
                  <c:v>12.34639986038205</c:v>
                </c:pt>
                <c:pt idx="3478">
                  <c:v>26.528600168228152</c:v>
                </c:pt>
                <c:pt idx="3479">
                  <c:v>9.2146000146865994</c:v>
                </c:pt>
                <c:pt idx="3480">
                  <c:v>22.609349942207295</c:v>
                </c:pt>
                <c:pt idx="3481">
                  <c:v>17.618500142097449</c:v>
                </c:pt>
                <c:pt idx="3482">
                  <c:v>12.401049838066104</c:v>
                </c:pt>
                <c:pt idx="3483">
                  <c:v>20.875349998474142</c:v>
                </c:pt>
                <c:pt idx="3484">
                  <c:v>17.524250111579896</c:v>
                </c:pt>
                <c:pt idx="3485">
                  <c:v>16.579000096321103</c:v>
                </c:pt>
                <c:pt idx="3486">
                  <c:v>13.70485009670255</c:v>
                </c:pt>
                <c:pt idx="3487">
                  <c:v>9.0998500871658017</c:v>
                </c:pt>
                <c:pt idx="3488">
                  <c:v>17.765100140571548</c:v>
                </c:pt>
                <c:pt idx="3489">
                  <c:v>22.032449798583951</c:v>
                </c:pt>
                <c:pt idx="3490">
                  <c:v>10.994849877357453</c:v>
                </c:pt>
                <c:pt idx="3491">
                  <c:v>21.60824976921085</c:v>
                </c:pt>
                <c:pt idx="3492">
                  <c:v>18.036950039863555</c:v>
                </c:pt>
                <c:pt idx="3493">
                  <c:v>15.996550073623705</c:v>
                </c:pt>
                <c:pt idx="3494">
                  <c:v>28.077349920272852</c:v>
                </c:pt>
                <c:pt idx="3495">
                  <c:v>19.419800167083753</c:v>
                </c:pt>
                <c:pt idx="3496">
                  <c:v>12.56275005340575</c:v>
                </c:pt>
                <c:pt idx="3497">
                  <c:v>13.612700133323649</c:v>
                </c:pt>
                <c:pt idx="3498">
                  <c:v>23.078399844169603</c:v>
                </c:pt>
                <c:pt idx="3499">
                  <c:v>18.831449918746952</c:v>
                </c:pt>
                <c:pt idx="3500">
                  <c:v>17.740200033187847</c:v>
                </c:pt>
                <c:pt idx="3501">
                  <c:v>16.815350098609951</c:v>
                </c:pt>
                <c:pt idx="3502">
                  <c:v>6.983599987030054</c:v>
                </c:pt>
                <c:pt idx="3503">
                  <c:v>20.585350189208999</c:v>
                </c:pt>
                <c:pt idx="3504">
                  <c:v>27.912099823951699</c:v>
                </c:pt>
                <c:pt idx="3505">
                  <c:v>28.745900039672851</c:v>
                </c:pt>
                <c:pt idx="3506">
                  <c:v>19.812250132560756</c:v>
                </c:pt>
                <c:pt idx="3507">
                  <c:v>15.978850078582752</c:v>
                </c:pt>
                <c:pt idx="3508">
                  <c:v>26.91744988918305</c:v>
                </c:pt>
                <c:pt idx="3509">
                  <c:v>39.429249868392901</c:v>
                </c:pt>
                <c:pt idx="3510">
                  <c:v>17.081999931335446</c:v>
                </c:pt>
                <c:pt idx="3511">
                  <c:v>23.006100273132347</c:v>
                </c:pt>
                <c:pt idx="3512">
                  <c:v>26.948949847221343</c:v>
                </c:pt>
                <c:pt idx="3513">
                  <c:v>9.7810498046875054</c:v>
                </c:pt>
                <c:pt idx="3514">
                  <c:v>32.779599719047546</c:v>
                </c:pt>
                <c:pt idx="3515">
                  <c:v>11.28604992866515</c:v>
                </c:pt>
                <c:pt idx="3516">
                  <c:v>12.109799728393547</c:v>
                </c:pt>
                <c:pt idx="3517">
                  <c:v>33.988299779891953</c:v>
                </c:pt>
                <c:pt idx="3518">
                  <c:v>21.4207498550415</c:v>
                </c:pt>
                <c:pt idx="3519">
                  <c:v>22.795650005340548</c:v>
                </c:pt>
                <c:pt idx="3520">
                  <c:v>14.253750047683706</c:v>
                </c:pt>
                <c:pt idx="3521">
                  <c:v>17.802899961471553</c:v>
                </c:pt>
                <c:pt idx="3522">
                  <c:v>8.9384498310089526</c:v>
                </c:pt>
                <c:pt idx="3523">
                  <c:v>18.642400159835844</c:v>
                </c:pt>
                <c:pt idx="3524">
                  <c:v>19.307850098609904</c:v>
                </c:pt>
                <c:pt idx="3525">
                  <c:v>19.790049724578846</c:v>
                </c:pt>
                <c:pt idx="3526">
                  <c:v>23.482850279807998</c:v>
                </c:pt>
                <c:pt idx="3527">
                  <c:v>26.060299949645994</c:v>
                </c:pt>
                <c:pt idx="3528">
                  <c:v>16.169200043678252</c:v>
                </c:pt>
                <c:pt idx="3529">
                  <c:v>19.400799756050098</c:v>
                </c:pt>
                <c:pt idx="3530">
                  <c:v>27.56914989471435</c:v>
                </c:pt>
                <c:pt idx="3531">
                  <c:v>20.724049892425555</c:v>
                </c:pt>
                <c:pt idx="3532">
                  <c:v>6.1274497509003041</c:v>
                </c:pt>
                <c:pt idx="3533">
                  <c:v>13.809350042343148</c:v>
                </c:pt>
                <c:pt idx="3534">
                  <c:v>15.369500064849852</c:v>
                </c:pt>
                <c:pt idx="3535">
                  <c:v>15.538799877166753</c:v>
                </c:pt>
                <c:pt idx="3536">
                  <c:v>8.7292500019073529</c:v>
                </c:pt>
                <c:pt idx="3537">
                  <c:v>19.915549907684301</c:v>
                </c:pt>
                <c:pt idx="3538">
                  <c:v>15.707749958038306</c:v>
                </c:pt>
                <c:pt idx="3539">
                  <c:v>21.903449921607951</c:v>
                </c:pt>
                <c:pt idx="3540">
                  <c:v>21.156099972724903</c:v>
                </c:pt>
                <c:pt idx="3541">
                  <c:v>13.668549914360053</c:v>
                </c:pt>
                <c:pt idx="3542">
                  <c:v>24.49694981575005</c:v>
                </c:pt>
                <c:pt idx="3543">
                  <c:v>18.252049932479849</c:v>
                </c:pt>
                <c:pt idx="3544">
                  <c:v>14.283049974441546</c:v>
                </c:pt>
                <c:pt idx="3545">
                  <c:v>29.650199713707003</c:v>
                </c:pt>
                <c:pt idx="3546">
                  <c:v>19.514700155258197</c:v>
                </c:pt>
                <c:pt idx="3547">
                  <c:v>12.715350012779197</c:v>
                </c:pt>
                <c:pt idx="3548">
                  <c:v>25.740599846839899</c:v>
                </c:pt>
                <c:pt idx="3549">
                  <c:v>15.78200004100805</c:v>
                </c:pt>
                <c:pt idx="3550">
                  <c:v>30.619849705696101</c:v>
                </c:pt>
                <c:pt idx="3551">
                  <c:v>11.648599820137051</c:v>
                </c:pt>
                <c:pt idx="3552">
                  <c:v>17.880950059890697</c:v>
                </c:pt>
                <c:pt idx="3553">
                  <c:v>18.341349864006055</c:v>
                </c:pt>
                <c:pt idx="3554">
                  <c:v>20.853100051879899</c:v>
                </c:pt>
                <c:pt idx="3555">
                  <c:v>16.195599756240849</c:v>
                </c:pt>
                <c:pt idx="3556">
                  <c:v>29.040399942398103</c:v>
                </c:pt>
                <c:pt idx="3557">
                  <c:v>11.12174976825715</c:v>
                </c:pt>
                <c:pt idx="3558">
                  <c:v>18.243000183105451</c:v>
                </c:pt>
                <c:pt idx="3559">
                  <c:v>14.024600038528497</c:v>
                </c:pt>
                <c:pt idx="3560">
                  <c:v>19.46385015010835</c:v>
                </c:pt>
                <c:pt idx="3561">
                  <c:v>8.933649983406049</c:v>
                </c:pt>
                <c:pt idx="3562">
                  <c:v>27.509899897575355</c:v>
                </c:pt>
                <c:pt idx="3563">
                  <c:v>18.035700192451458</c:v>
                </c:pt>
                <c:pt idx="3564">
                  <c:v>14.746300172805753</c:v>
                </c:pt>
                <c:pt idx="3565">
                  <c:v>17.290900268554708</c:v>
                </c:pt>
                <c:pt idx="3566">
                  <c:v>17.443750023841844</c:v>
                </c:pt>
                <c:pt idx="3567">
                  <c:v>20.9661001396179</c:v>
                </c:pt>
                <c:pt idx="3568">
                  <c:v>20.681650071144098</c:v>
                </c:pt>
                <c:pt idx="3569">
                  <c:v>19.672400035858196</c:v>
                </c:pt>
                <c:pt idx="3570">
                  <c:v>9.3152998065949006</c:v>
                </c:pt>
                <c:pt idx="3571">
                  <c:v>20.609949965477</c:v>
                </c:pt>
                <c:pt idx="3572">
                  <c:v>17.334999933242742</c:v>
                </c:pt>
                <c:pt idx="3573">
                  <c:v>28.511599988937348</c:v>
                </c:pt>
                <c:pt idx="3574">
                  <c:v>12.262199978828406</c:v>
                </c:pt>
                <c:pt idx="3575">
                  <c:v>18.34704988002775</c:v>
                </c:pt>
                <c:pt idx="3576">
                  <c:v>25.542500057220501</c:v>
                </c:pt>
                <c:pt idx="3577">
                  <c:v>21.178949952125546</c:v>
                </c:pt>
                <c:pt idx="3578">
                  <c:v>15.308449954986607</c:v>
                </c:pt>
                <c:pt idx="3579">
                  <c:v>13.987200069427502</c:v>
                </c:pt>
                <c:pt idx="3580">
                  <c:v>22.823499741554251</c:v>
                </c:pt>
                <c:pt idx="3581">
                  <c:v>17.603249945640549</c:v>
                </c:pt>
                <c:pt idx="3582">
                  <c:v>11.258199825286852</c:v>
                </c:pt>
                <c:pt idx="3583">
                  <c:v>21.114649920463556</c:v>
                </c:pt>
                <c:pt idx="3584">
                  <c:v>6.8515497732162487</c:v>
                </c:pt>
                <c:pt idx="3585">
                  <c:v>13.77710009098055</c:v>
                </c:pt>
                <c:pt idx="3586">
                  <c:v>15.7730499649048</c:v>
                </c:pt>
                <c:pt idx="3587">
                  <c:v>21.699400010108945</c:v>
                </c:pt>
                <c:pt idx="3588">
                  <c:v>16.465950193405146</c:v>
                </c:pt>
                <c:pt idx="3589">
                  <c:v>3.7153499031066985</c:v>
                </c:pt>
                <c:pt idx="3590">
                  <c:v>39.596299829483051</c:v>
                </c:pt>
                <c:pt idx="3591">
                  <c:v>11.780100030899053</c:v>
                </c:pt>
                <c:pt idx="3592">
                  <c:v>13.182949686050453</c:v>
                </c:pt>
                <c:pt idx="3593">
                  <c:v>14.739399733543401</c:v>
                </c:pt>
                <c:pt idx="3594">
                  <c:v>15.844799990653996</c:v>
                </c:pt>
                <c:pt idx="3595">
                  <c:v>14.895450210571248</c:v>
                </c:pt>
                <c:pt idx="3596">
                  <c:v>25.403949866294852</c:v>
                </c:pt>
                <c:pt idx="3597">
                  <c:v>22.355199885368297</c:v>
                </c:pt>
                <c:pt idx="3598">
                  <c:v>23.573549871444701</c:v>
                </c:pt>
                <c:pt idx="3599">
                  <c:v>9.8124498271942002</c:v>
                </c:pt>
                <c:pt idx="3600">
                  <c:v>21.422699856758101</c:v>
                </c:pt>
                <c:pt idx="3601">
                  <c:v>5.3860499525069976</c:v>
                </c:pt>
                <c:pt idx="3602">
                  <c:v>28.355049767494201</c:v>
                </c:pt>
                <c:pt idx="3603">
                  <c:v>12.205550065040605</c:v>
                </c:pt>
                <c:pt idx="3604">
                  <c:v>19.263899765014649</c:v>
                </c:pt>
                <c:pt idx="3605">
                  <c:v>21.932049970626849</c:v>
                </c:pt>
                <c:pt idx="3606">
                  <c:v>18.702799892425549</c:v>
                </c:pt>
                <c:pt idx="3607">
                  <c:v>7.3613500022888019</c:v>
                </c:pt>
                <c:pt idx="3608">
                  <c:v>7.1278998756408498</c:v>
                </c:pt>
                <c:pt idx="3609">
                  <c:v>14.439250001907403</c:v>
                </c:pt>
                <c:pt idx="3610">
                  <c:v>7.3438999557495563</c:v>
                </c:pt>
                <c:pt idx="3611">
                  <c:v>23.379500017166098</c:v>
                </c:pt>
                <c:pt idx="3612">
                  <c:v>14.807049970626803</c:v>
                </c:pt>
                <c:pt idx="3613">
                  <c:v>16.230999956130951</c:v>
                </c:pt>
                <c:pt idx="3614">
                  <c:v>22.589949879646301</c:v>
                </c:pt>
                <c:pt idx="3615">
                  <c:v>22.415750331878698</c:v>
                </c:pt>
                <c:pt idx="3616">
                  <c:v>23.879150104522701</c:v>
                </c:pt>
                <c:pt idx="3617">
                  <c:v>21.512399907112098</c:v>
                </c:pt>
                <c:pt idx="3618">
                  <c:v>19.202849931716901</c:v>
                </c:pt>
                <c:pt idx="3619">
                  <c:v>26.555149912834203</c:v>
                </c:pt>
                <c:pt idx="3620">
                  <c:v>14.878700156211853</c:v>
                </c:pt>
                <c:pt idx="3621">
                  <c:v>26.431700153350896</c:v>
                </c:pt>
                <c:pt idx="3622">
                  <c:v>12.566949987411451</c:v>
                </c:pt>
                <c:pt idx="3623">
                  <c:v>18.744200029373197</c:v>
                </c:pt>
                <c:pt idx="3624">
                  <c:v>19.314499993324301</c:v>
                </c:pt>
                <c:pt idx="3625">
                  <c:v>10.952549910545343</c:v>
                </c:pt>
                <c:pt idx="3626">
                  <c:v>21.345849881172207</c:v>
                </c:pt>
                <c:pt idx="3627">
                  <c:v>19.135450096130349</c:v>
                </c:pt>
                <c:pt idx="3628">
                  <c:v>21.5824500846863</c:v>
                </c:pt>
                <c:pt idx="3629">
                  <c:v>14.449099977016502</c:v>
                </c:pt>
                <c:pt idx="3630">
                  <c:v>15.865150265693654</c:v>
                </c:pt>
                <c:pt idx="3631">
                  <c:v>14.355000119209297</c:v>
                </c:pt>
                <c:pt idx="3632">
                  <c:v>17.222100152969354</c:v>
                </c:pt>
                <c:pt idx="3633">
                  <c:v>19.413149819374055</c:v>
                </c:pt>
                <c:pt idx="3634">
                  <c:v>23.8712498807907</c:v>
                </c:pt>
                <c:pt idx="3635">
                  <c:v>15.685450177192699</c:v>
                </c:pt>
                <c:pt idx="3636">
                  <c:v>8.7501999330520484</c:v>
                </c:pt>
                <c:pt idx="3637">
                  <c:v>21.7152000236511</c:v>
                </c:pt>
                <c:pt idx="3638">
                  <c:v>7.9778497314452999</c:v>
                </c:pt>
                <c:pt idx="3639">
                  <c:v>24.705950117111193</c:v>
                </c:pt>
                <c:pt idx="3640">
                  <c:v>22.032200036048906</c:v>
                </c:pt>
                <c:pt idx="3641">
                  <c:v>10.603149909973151</c:v>
                </c:pt>
                <c:pt idx="3642">
                  <c:v>15.942149949073798</c:v>
                </c:pt>
                <c:pt idx="3643">
                  <c:v>15.282400064468348</c:v>
                </c:pt>
                <c:pt idx="3644">
                  <c:v>6.4714496898650999</c:v>
                </c:pt>
                <c:pt idx="3645">
                  <c:v>15.837100028991706</c:v>
                </c:pt>
                <c:pt idx="3646">
                  <c:v>16.618000199794757</c:v>
                </c:pt>
                <c:pt idx="3647">
                  <c:v>16.618000199794757</c:v>
                </c:pt>
                <c:pt idx="3648">
                  <c:v>16.904850082397452</c:v>
                </c:pt>
                <c:pt idx="3649">
                  <c:v>13.896300010681152</c:v>
                </c:pt>
                <c:pt idx="3650">
                  <c:v>18.741700062751804</c:v>
                </c:pt>
                <c:pt idx="3651">
                  <c:v>20.102500166892995</c:v>
                </c:pt>
                <c:pt idx="3652">
                  <c:v>14.446650118827801</c:v>
                </c:pt>
                <c:pt idx="3653">
                  <c:v>19.221850094795201</c:v>
                </c:pt>
                <c:pt idx="3654">
                  <c:v>28.564800186157253</c:v>
                </c:pt>
                <c:pt idx="3655">
                  <c:v>15.321400241851848</c:v>
                </c:pt>
                <c:pt idx="3656">
                  <c:v>16.781550111770649</c:v>
                </c:pt>
                <c:pt idx="3657">
                  <c:v>10.303899850845347</c:v>
                </c:pt>
                <c:pt idx="3658">
                  <c:v>9.6751498937606968</c:v>
                </c:pt>
                <c:pt idx="3659">
                  <c:v>17.779450116157498</c:v>
                </c:pt>
                <c:pt idx="3660">
                  <c:v>21.952999949455297</c:v>
                </c:pt>
                <c:pt idx="3661">
                  <c:v>15.650750188827498</c:v>
                </c:pt>
                <c:pt idx="3662">
                  <c:v>15.875699954032953</c:v>
                </c:pt>
                <c:pt idx="3663">
                  <c:v>20.0022499513626</c:v>
                </c:pt>
                <c:pt idx="3664">
                  <c:v>11.091999740600656</c:v>
                </c:pt>
                <c:pt idx="3665">
                  <c:v>25.719649839401253</c:v>
                </c:pt>
                <c:pt idx="3666">
                  <c:v>16.417900114059456</c:v>
                </c:pt>
                <c:pt idx="3667">
                  <c:v>28.436949925422653</c:v>
                </c:pt>
                <c:pt idx="3668">
                  <c:v>19.025250024795596</c:v>
                </c:pt>
                <c:pt idx="3669">
                  <c:v>15.647449970245404</c:v>
                </c:pt>
                <c:pt idx="3670">
                  <c:v>14.644350090026855</c:v>
                </c:pt>
                <c:pt idx="3671">
                  <c:v>20.444999933242748</c:v>
                </c:pt>
                <c:pt idx="3672">
                  <c:v>26.842149934768656</c:v>
                </c:pt>
                <c:pt idx="3673">
                  <c:v>19.1540998315811</c:v>
                </c:pt>
                <c:pt idx="3674">
                  <c:v>17.542649846076948</c:v>
                </c:pt>
                <c:pt idx="3675">
                  <c:v>6.1732998752593495</c:v>
                </c:pt>
                <c:pt idx="3676">
                  <c:v>17.747949686050401</c:v>
                </c:pt>
                <c:pt idx="3677">
                  <c:v>14.384999890327457</c:v>
                </c:pt>
                <c:pt idx="3678">
                  <c:v>12.624399895667999</c:v>
                </c:pt>
                <c:pt idx="3679">
                  <c:v>10.0681999063492</c:v>
                </c:pt>
                <c:pt idx="3680">
                  <c:v>24.767649998664893</c:v>
                </c:pt>
                <c:pt idx="3681">
                  <c:v>14.463799829483001</c:v>
                </c:pt>
                <c:pt idx="3682">
                  <c:v>14.463799829483001</c:v>
                </c:pt>
                <c:pt idx="3683">
                  <c:v>22.873049702644352</c:v>
                </c:pt>
                <c:pt idx="3684">
                  <c:v>15.984150147438054</c:v>
                </c:pt>
                <c:pt idx="3685">
                  <c:v>27.437049827575748</c:v>
                </c:pt>
                <c:pt idx="3686">
                  <c:v>8.5450999212265017</c:v>
                </c:pt>
                <c:pt idx="3687">
                  <c:v>20.111450142860448</c:v>
                </c:pt>
                <c:pt idx="3688">
                  <c:v>14.615300011634801</c:v>
                </c:pt>
                <c:pt idx="3689">
                  <c:v>21.120399780273445</c:v>
                </c:pt>
                <c:pt idx="3690">
                  <c:v>8.8483499288559457</c:v>
                </c:pt>
                <c:pt idx="3691">
                  <c:v>20.316550083160408</c:v>
                </c:pt>
                <c:pt idx="3692">
                  <c:v>17.69455000400545</c:v>
                </c:pt>
                <c:pt idx="3693">
                  <c:v>21.846900019645698</c:v>
                </c:pt>
                <c:pt idx="3694">
                  <c:v>10.900099701881402</c:v>
                </c:pt>
                <c:pt idx="3695">
                  <c:v>36.778099818229698</c:v>
                </c:pt>
                <c:pt idx="3696">
                  <c:v>20.602299919128455</c:v>
                </c:pt>
                <c:pt idx="3697">
                  <c:v>19.203849868774398</c:v>
                </c:pt>
                <c:pt idx="3698">
                  <c:v>26.678749794960101</c:v>
                </c:pt>
                <c:pt idx="3699">
                  <c:v>17.623999981880203</c:v>
                </c:pt>
                <c:pt idx="3700">
                  <c:v>20.638749985694901</c:v>
                </c:pt>
                <c:pt idx="3701">
                  <c:v>4.6166499662398977</c:v>
                </c:pt>
                <c:pt idx="3702">
                  <c:v>12.949250164031994</c:v>
                </c:pt>
                <c:pt idx="3703">
                  <c:v>17.801249942779549</c:v>
                </c:pt>
                <c:pt idx="3704">
                  <c:v>17.579550209045401</c:v>
                </c:pt>
                <c:pt idx="3705">
                  <c:v>16.580099935531603</c:v>
                </c:pt>
                <c:pt idx="3706">
                  <c:v>14.3910998439789</c:v>
                </c:pt>
                <c:pt idx="3707">
                  <c:v>16.787550129890406</c:v>
                </c:pt>
                <c:pt idx="3708">
                  <c:v>17.592499899864201</c:v>
                </c:pt>
                <c:pt idx="3709">
                  <c:v>20.404099922180201</c:v>
                </c:pt>
                <c:pt idx="3710">
                  <c:v>12.1406999349594</c:v>
                </c:pt>
                <c:pt idx="3711">
                  <c:v>18.575550093650804</c:v>
                </c:pt>
                <c:pt idx="3712">
                  <c:v>19.848000178337152</c:v>
                </c:pt>
                <c:pt idx="3713">
                  <c:v>15.212300219535802</c:v>
                </c:pt>
                <c:pt idx="3714">
                  <c:v>26.246500015258796</c:v>
                </c:pt>
                <c:pt idx="3715">
                  <c:v>17.8175500750541</c:v>
                </c:pt>
                <c:pt idx="3716">
                  <c:v>13.014999899864144</c:v>
                </c:pt>
                <c:pt idx="3717">
                  <c:v>26.266449670791655</c:v>
                </c:pt>
                <c:pt idx="3718">
                  <c:v>13.521899809837404</c:v>
                </c:pt>
                <c:pt idx="3719">
                  <c:v>10.2558498811722</c:v>
                </c:pt>
                <c:pt idx="3720">
                  <c:v>26.645499987602246</c:v>
                </c:pt>
                <c:pt idx="3721">
                  <c:v>25.590750007629406</c:v>
                </c:pt>
                <c:pt idx="3722">
                  <c:v>29.512500100135853</c:v>
                </c:pt>
                <c:pt idx="3723">
                  <c:v>21.627049517631598</c:v>
                </c:pt>
                <c:pt idx="3724">
                  <c:v>17.46579985141755</c:v>
                </c:pt>
                <c:pt idx="3725">
                  <c:v>22.178099884986842</c:v>
                </c:pt>
                <c:pt idx="3726">
                  <c:v>19.017500176429806</c:v>
                </c:pt>
                <c:pt idx="3727">
                  <c:v>13.348200025558498</c:v>
                </c:pt>
                <c:pt idx="3728">
                  <c:v>18.654650239944502</c:v>
                </c:pt>
                <c:pt idx="3729">
                  <c:v>24.219349946975701</c:v>
                </c:pt>
                <c:pt idx="3730">
                  <c:v>15.084749832153307</c:v>
                </c:pt>
                <c:pt idx="3731">
                  <c:v>8.2682498311996468</c:v>
                </c:pt>
                <c:pt idx="3732">
                  <c:v>23.718100023269646</c:v>
                </c:pt>
                <c:pt idx="3733">
                  <c:v>14.797850079536452</c:v>
                </c:pt>
                <c:pt idx="3734">
                  <c:v>15.409900026321452</c:v>
                </c:pt>
                <c:pt idx="3735">
                  <c:v>10.478449988365199</c:v>
                </c:pt>
                <c:pt idx="3736">
                  <c:v>18.002600040435802</c:v>
                </c:pt>
                <c:pt idx="3737">
                  <c:v>14.244099912643399</c:v>
                </c:pt>
                <c:pt idx="3738">
                  <c:v>6.6437497806549004</c:v>
                </c:pt>
                <c:pt idx="3739">
                  <c:v>23.07124987602235</c:v>
                </c:pt>
                <c:pt idx="3740">
                  <c:v>15.735749974250801</c:v>
                </c:pt>
                <c:pt idx="3741">
                  <c:v>14.120500097274746</c:v>
                </c:pt>
                <c:pt idx="3742">
                  <c:v>15.38494995594025</c:v>
                </c:pt>
                <c:pt idx="3743">
                  <c:v>22.607899665832505</c:v>
                </c:pt>
                <c:pt idx="3744">
                  <c:v>14.46389996051785</c:v>
                </c:pt>
                <c:pt idx="3745">
                  <c:v>8.1120998668671049</c:v>
                </c:pt>
                <c:pt idx="3746">
                  <c:v>19.4671500492096</c:v>
                </c:pt>
                <c:pt idx="3747">
                  <c:v>19.773100209236144</c:v>
                </c:pt>
                <c:pt idx="3748">
                  <c:v>14.048649840354948</c:v>
                </c:pt>
                <c:pt idx="3749">
                  <c:v>13.75195024967195</c:v>
                </c:pt>
                <c:pt idx="3750">
                  <c:v>13.6505000209808</c:v>
                </c:pt>
                <c:pt idx="3751">
                  <c:v>18.993800067901645</c:v>
                </c:pt>
                <c:pt idx="3752">
                  <c:v>21.717200050354045</c:v>
                </c:pt>
                <c:pt idx="3753">
                  <c:v>15.8240001153946</c:v>
                </c:pt>
                <c:pt idx="3754">
                  <c:v>16.100649809837343</c:v>
                </c:pt>
                <c:pt idx="3755">
                  <c:v>22.578399972915648</c:v>
                </c:pt>
                <c:pt idx="3756">
                  <c:v>18.391850018501305</c:v>
                </c:pt>
                <c:pt idx="3757">
                  <c:v>11.364250025749197</c:v>
                </c:pt>
                <c:pt idx="3758">
                  <c:v>34.910049595832852</c:v>
                </c:pt>
                <c:pt idx="3759">
                  <c:v>13.705299906730652</c:v>
                </c:pt>
                <c:pt idx="3760">
                  <c:v>25.949250054359403</c:v>
                </c:pt>
                <c:pt idx="3761">
                  <c:v>20.5792499065399</c:v>
                </c:pt>
                <c:pt idx="3762">
                  <c:v>5.7695998620987012</c:v>
                </c:pt>
                <c:pt idx="3763">
                  <c:v>16.299100208282503</c:v>
                </c:pt>
                <c:pt idx="3764">
                  <c:v>18.537799987793001</c:v>
                </c:pt>
                <c:pt idx="3765">
                  <c:v>27.578950033187894</c:v>
                </c:pt>
                <c:pt idx="3766">
                  <c:v>16.790299854278501</c:v>
                </c:pt>
                <c:pt idx="3767">
                  <c:v>27.204049987792956</c:v>
                </c:pt>
                <c:pt idx="3768">
                  <c:v>25.505400152206452</c:v>
                </c:pt>
                <c:pt idx="3769">
                  <c:v>15.534549803733853</c:v>
                </c:pt>
                <c:pt idx="3770">
                  <c:v>19.8491998720169</c:v>
                </c:pt>
                <c:pt idx="3771">
                  <c:v>18.742050194740298</c:v>
                </c:pt>
                <c:pt idx="3772">
                  <c:v>21.431649961471493</c:v>
                </c:pt>
                <c:pt idx="3773">
                  <c:v>29.575399913787852</c:v>
                </c:pt>
                <c:pt idx="3774">
                  <c:v>17.365850167274452</c:v>
                </c:pt>
                <c:pt idx="3775">
                  <c:v>25.728799657821654</c:v>
                </c:pt>
                <c:pt idx="3776">
                  <c:v>15.335599989891101</c:v>
                </c:pt>
                <c:pt idx="3777">
                  <c:v>15.003050065040597</c:v>
                </c:pt>
                <c:pt idx="3778">
                  <c:v>26.752099909782395</c:v>
                </c:pt>
                <c:pt idx="3779">
                  <c:v>10.050000109672546</c:v>
                </c:pt>
                <c:pt idx="3780">
                  <c:v>15.365350017547602</c:v>
                </c:pt>
                <c:pt idx="3781">
                  <c:v>19.230249772071851</c:v>
                </c:pt>
                <c:pt idx="3782">
                  <c:v>12.739699916839598</c:v>
                </c:pt>
                <c:pt idx="3783">
                  <c:v>18.558500094413748</c:v>
                </c:pt>
                <c:pt idx="3784">
                  <c:v>20.337950062751752</c:v>
                </c:pt>
                <c:pt idx="3785">
                  <c:v>21.872500004768405</c:v>
                </c:pt>
                <c:pt idx="3786">
                  <c:v>16.265049805641155</c:v>
                </c:pt>
                <c:pt idx="3787">
                  <c:v>17.65429995536805</c:v>
                </c:pt>
                <c:pt idx="3788">
                  <c:v>26.121199975013752</c:v>
                </c:pt>
                <c:pt idx="3789">
                  <c:v>16.972350254058803</c:v>
                </c:pt>
                <c:pt idx="3790">
                  <c:v>21.687349953651456</c:v>
                </c:pt>
                <c:pt idx="3791">
                  <c:v>20.668650226593048</c:v>
                </c:pt>
                <c:pt idx="3792">
                  <c:v>10.989701646058951</c:v>
                </c:pt>
                <c:pt idx="3793">
                  <c:v>7.5651996994018518</c:v>
                </c:pt>
                <c:pt idx="3794">
                  <c:v>11.700649743080152</c:v>
                </c:pt>
                <c:pt idx="3795">
                  <c:v>12.12405001163485</c:v>
                </c:pt>
                <c:pt idx="3796">
                  <c:v>18.016099891662652</c:v>
                </c:pt>
                <c:pt idx="3797">
                  <c:v>27.481100049018849</c:v>
                </c:pt>
                <c:pt idx="3798">
                  <c:v>24.377799806594851</c:v>
                </c:pt>
                <c:pt idx="3799">
                  <c:v>26.920549979209898</c:v>
                </c:pt>
                <c:pt idx="3800">
                  <c:v>11.834750046730054</c:v>
                </c:pt>
                <c:pt idx="3801">
                  <c:v>17.678200097084051</c:v>
                </c:pt>
                <c:pt idx="3802">
                  <c:v>11.383099813461349</c:v>
                </c:pt>
                <c:pt idx="3803">
                  <c:v>11.932100224494903</c:v>
                </c:pt>
                <c:pt idx="3804">
                  <c:v>17.977050032615651</c:v>
                </c:pt>
                <c:pt idx="3805">
                  <c:v>20.447450094223051</c:v>
                </c:pt>
                <c:pt idx="3806">
                  <c:v>13.100399985313452</c:v>
                </c:pt>
                <c:pt idx="3807">
                  <c:v>21.2719000720978</c:v>
                </c:pt>
                <c:pt idx="3808">
                  <c:v>16.767450027465848</c:v>
                </c:pt>
                <c:pt idx="3809">
                  <c:v>17.392100095748901</c:v>
                </c:pt>
                <c:pt idx="3810">
                  <c:v>16.260250086784399</c:v>
                </c:pt>
                <c:pt idx="3811">
                  <c:v>17.242999815940848</c:v>
                </c:pt>
                <c:pt idx="3812">
                  <c:v>13.162049803733797</c:v>
                </c:pt>
                <c:pt idx="3813">
                  <c:v>11.442499942779548</c:v>
                </c:pt>
                <c:pt idx="3814">
                  <c:v>23.921050086021449</c:v>
                </c:pt>
                <c:pt idx="3815">
                  <c:v>23.442099642753597</c:v>
                </c:pt>
                <c:pt idx="3816">
                  <c:v>13.996999897956851</c:v>
                </c:pt>
                <c:pt idx="3817">
                  <c:v>14.890999960899297</c:v>
                </c:pt>
                <c:pt idx="3818">
                  <c:v>19.742650089263904</c:v>
                </c:pt>
                <c:pt idx="3819">
                  <c:v>21.77889988422395</c:v>
                </c:pt>
                <c:pt idx="3820">
                  <c:v>16.608599953651407</c:v>
                </c:pt>
                <c:pt idx="3821">
                  <c:v>11.564850134849596</c:v>
                </c:pt>
                <c:pt idx="3822">
                  <c:v>21.759600071907052</c:v>
                </c:pt>
                <c:pt idx="3823">
                  <c:v>9.1419498634338012</c:v>
                </c:pt>
                <c:pt idx="3824">
                  <c:v>15.473499956131</c:v>
                </c:pt>
                <c:pt idx="3825">
                  <c:v>19.897550272941601</c:v>
                </c:pt>
                <c:pt idx="3826">
                  <c:v>10.491699972152752</c:v>
                </c:pt>
                <c:pt idx="3827">
                  <c:v>31.248699998855599</c:v>
                </c:pt>
                <c:pt idx="3828">
                  <c:v>19.830149960517904</c:v>
                </c:pt>
                <c:pt idx="3829">
                  <c:v>23.4698999929428</c:v>
                </c:pt>
                <c:pt idx="3830">
                  <c:v>18.035350155830397</c:v>
                </c:pt>
                <c:pt idx="3831">
                  <c:v>5.4279497194289981</c:v>
                </c:pt>
                <c:pt idx="3832">
                  <c:v>15.592749857902554</c:v>
                </c:pt>
                <c:pt idx="3833">
                  <c:v>23.103200130462653</c:v>
                </c:pt>
                <c:pt idx="3834">
                  <c:v>19.924000082016047</c:v>
                </c:pt>
                <c:pt idx="3835">
                  <c:v>20.159149999618553</c:v>
                </c:pt>
                <c:pt idx="3836">
                  <c:v>6.872849783897351</c:v>
                </c:pt>
                <c:pt idx="3837">
                  <c:v>8.231599817275999</c:v>
                </c:pt>
                <c:pt idx="3838">
                  <c:v>16.168800215721152</c:v>
                </c:pt>
                <c:pt idx="3839">
                  <c:v>22.958849906921355</c:v>
                </c:pt>
                <c:pt idx="3840">
                  <c:v>12.773349900245599</c:v>
                </c:pt>
                <c:pt idx="3841">
                  <c:v>22.505100054740854</c:v>
                </c:pt>
                <c:pt idx="3842">
                  <c:v>10.24539987087255</c:v>
                </c:pt>
                <c:pt idx="3843">
                  <c:v>14.335949935913099</c:v>
                </c:pt>
                <c:pt idx="3844">
                  <c:v>14.985900020599452</c:v>
                </c:pt>
                <c:pt idx="3845">
                  <c:v>22.192549834251405</c:v>
                </c:pt>
                <c:pt idx="3846">
                  <c:v>30.95054997920985</c:v>
                </c:pt>
                <c:pt idx="3847">
                  <c:v>16.706300010681147</c:v>
                </c:pt>
                <c:pt idx="3848">
                  <c:v>18.859249882698002</c:v>
                </c:pt>
                <c:pt idx="3849">
                  <c:v>17.467000112533551</c:v>
                </c:pt>
                <c:pt idx="3850">
                  <c:v>22.555749888420152</c:v>
                </c:pt>
                <c:pt idx="3851">
                  <c:v>17.527300214767447</c:v>
                </c:pt>
                <c:pt idx="3852">
                  <c:v>6.1553499269485528</c:v>
                </c:pt>
                <c:pt idx="3853">
                  <c:v>20.585000143051097</c:v>
                </c:pt>
                <c:pt idx="3854">
                  <c:v>15.883799991607649</c:v>
                </c:pt>
                <c:pt idx="3855">
                  <c:v>16.279500026702898</c:v>
                </c:pt>
                <c:pt idx="3856">
                  <c:v>34.158049926757847</c:v>
                </c:pt>
                <c:pt idx="3857">
                  <c:v>17.568149919509949</c:v>
                </c:pt>
                <c:pt idx="3858">
                  <c:v>25.141099934577952</c:v>
                </c:pt>
                <c:pt idx="3859">
                  <c:v>14.978150067329398</c:v>
                </c:pt>
                <c:pt idx="3860">
                  <c:v>17.047899842262254</c:v>
                </c:pt>
                <c:pt idx="3861">
                  <c:v>22.018849740028397</c:v>
                </c:pt>
                <c:pt idx="3862">
                  <c:v>16.655299844741798</c:v>
                </c:pt>
                <c:pt idx="3863">
                  <c:v>6.9895997047423997</c:v>
                </c:pt>
                <c:pt idx="3864">
                  <c:v>22.895999865531898</c:v>
                </c:pt>
                <c:pt idx="3865">
                  <c:v>26.873949861526498</c:v>
                </c:pt>
                <c:pt idx="3866">
                  <c:v>14.163900122642502</c:v>
                </c:pt>
                <c:pt idx="3867">
                  <c:v>12.935649843215899</c:v>
                </c:pt>
                <c:pt idx="3868">
                  <c:v>11.831799769401496</c:v>
                </c:pt>
                <c:pt idx="3869">
                  <c:v>13.017349839210453</c:v>
                </c:pt>
                <c:pt idx="3870">
                  <c:v>18.254700045585647</c:v>
                </c:pt>
                <c:pt idx="3871">
                  <c:v>17.240100116729707</c:v>
                </c:pt>
                <c:pt idx="3872">
                  <c:v>17.262900128364549</c:v>
                </c:pt>
                <c:pt idx="3873">
                  <c:v>19.333550286293054</c:v>
                </c:pt>
                <c:pt idx="3874">
                  <c:v>10.0270999288559</c:v>
                </c:pt>
                <c:pt idx="3875">
                  <c:v>22.192800073623694</c:v>
                </c:pt>
                <c:pt idx="3876">
                  <c:v>15.500450134277354</c:v>
                </c:pt>
                <c:pt idx="3877">
                  <c:v>20.864450073242146</c:v>
                </c:pt>
                <c:pt idx="3878">
                  <c:v>11.835649757385198</c:v>
                </c:pt>
                <c:pt idx="3879">
                  <c:v>25.780581736420153</c:v>
                </c:pt>
                <c:pt idx="3880">
                  <c:v>12.125149788856504</c:v>
                </c:pt>
                <c:pt idx="3881">
                  <c:v>13.547099838256855</c:v>
                </c:pt>
                <c:pt idx="3882">
                  <c:v>20.948500237464906</c:v>
                </c:pt>
                <c:pt idx="3883">
                  <c:v>19.899249958991994</c:v>
                </c:pt>
                <c:pt idx="3884">
                  <c:v>16.371850175857553</c:v>
                </c:pt>
                <c:pt idx="3885">
                  <c:v>28.648599920272797</c:v>
                </c:pt>
                <c:pt idx="3886">
                  <c:v>25.6690998697281</c:v>
                </c:pt>
                <c:pt idx="3887">
                  <c:v>14.432450060844396</c:v>
                </c:pt>
                <c:pt idx="3888">
                  <c:v>16.425450019836454</c:v>
                </c:pt>
                <c:pt idx="3889">
                  <c:v>21.270649905204806</c:v>
                </c:pt>
                <c:pt idx="3890">
                  <c:v>14.021649808883701</c:v>
                </c:pt>
                <c:pt idx="3891">
                  <c:v>10.286699805259698</c:v>
                </c:pt>
                <c:pt idx="3892">
                  <c:v>12.692250008583052</c:v>
                </c:pt>
                <c:pt idx="3893">
                  <c:v>22.3964000034332</c:v>
                </c:pt>
                <c:pt idx="3894">
                  <c:v>21.886600136756847</c:v>
                </c:pt>
                <c:pt idx="3895">
                  <c:v>12.115899801254244</c:v>
                </c:pt>
                <c:pt idx="3896">
                  <c:v>19.0411001586914</c:v>
                </c:pt>
                <c:pt idx="3897">
                  <c:v>17.438850045204155</c:v>
                </c:pt>
                <c:pt idx="3898">
                  <c:v>15.328299860954296</c:v>
                </c:pt>
                <c:pt idx="3899">
                  <c:v>24.111499915123002</c:v>
                </c:pt>
                <c:pt idx="3900">
                  <c:v>17.666900129318247</c:v>
                </c:pt>
                <c:pt idx="3901">
                  <c:v>17.387199921607952</c:v>
                </c:pt>
                <c:pt idx="3902">
                  <c:v>14.923400001525899</c:v>
                </c:pt>
                <c:pt idx="3903">
                  <c:v>10.294600014686544</c:v>
                </c:pt>
                <c:pt idx="3904">
                  <c:v>14.860799870491007</c:v>
                </c:pt>
                <c:pt idx="3905">
                  <c:v>15.328150119781505</c:v>
                </c:pt>
                <c:pt idx="3906">
                  <c:v>14.94895004272465</c:v>
                </c:pt>
                <c:pt idx="3907">
                  <c:v>17.583099741935701</c:v>
                </c:pt>
                <c:pt idx="3908">
                  <c:v>15.917600126266457</c:v>
                </c:pt>
                <c:pt idx="3909">
                  <c:v>13.975550041198751</c:v>
                </c:pt>
                <c:pt idx="3910">
                  <c:v>24.951849989890999</c:v>
                </c:pt>
                <c:pt idx="3911">
                  <c:v>28.360100049972502</c:v>
                </c:pt>
                <c:pt idx="3912">
                  <c:v>28.2693498945236</c:v>
                </c:pt>
                <c:pt idx="3913">
                  <c:v>14.8921000242233</c:v>
                </c:pt>
                <c:pt idx="3914">
                  <c:v>12.336200037002548</c:v>
                </c:pt>
                <c:pt idx="3915">
                  <c:v>19.2790500354767</c:v>
                </c:pt>
                <c:pt idx="3916">
                  <c:v>23.000599722862248</c:v>
                </c:pt>
                <c:pt idx="3917">
                  <c:v>28.281599793434154</c:v>
                </c:pt>
                <c:pt idx="3918">
                  <c:v>23.294599761962843</c:v>
                </c:pt>
                <c:pt idx="3919">
                  <c:v>13.460500242710154</c:v>
                </c:pt>
                <c:pt idx="3920">
                  <c:v>18.912549939155546</c:v>
                </c:pt>
                <c:pt idx="3921">
                  <c:v>19.45320029735565</c:v>
                </c:pt>
                <c:pt idx="3922">
                  <c:v>14.534500069618254</c:v>
                </c:pt>
                <c:pt idx="3923">
                  <c:v>21.530499806404144</c:v>
                </c:pt>
                <c:pt idx="3924">
                  <c:v>15.214050235748299</c:v>
                </c:pt>
                <c:pt idx="3925">
                  <c:v>20.517999725341799</c:v>
                </c:pt>
                <c:pt idx="3926">
                  <c:v>9.8379788297595532</c:v>
                </c:pt>
                <c:pt idx="3927">
                  <c:v>21.253099803924549</c:v>
                </c:pt>
                <c:pt idx="3928">
                  <c:v>21.575400156974801</c:v>
                </c:pt>
                <c:pt idx="3929">
                  <c:v>20.128549966812095</c:v>
                </c:pt>
                <c:pt idx="3930">
                  <c:v>14.875500063896148</c:v>
                </c:pt>
                <c:pt idx="3931">
                  <c:v>13.60365005016325</c:v>
                </c:pt>
                <c:pt idx="3932">
                  <c:v>13.425350022315953</c:v>
                </c:pt>
                <c:pt idx="3933">
                  <c:v>11.427549972534148</c:v>
                </c:pt>
                <c:pt idx="3934">
                  <c:v>13.153149886131303</c:v>
                </c:pt>
                <c:pt idx="3935">
                  <c:v>18.296050095558147</c:v>
                </c:pt>
                <c:pt idx="3936">
                  <c:v>18.704599800109797</c:v>
                </c:pt>
                <c:pt idx="3937">
                  <c:v>21.922750029563854</c:v>
                </c:pt>
                <c:pt idx="3938">
                  <c:v>16.467499904632604</c:v>
                </c:pt>
                <c:pt idx="3939">
                  <c:v>24.138500108718905</c:v>
                </c:pt>
                <c:pt idx="3940">
                  <c:v>13.514950075149503</c:v>
                </c:pt>
                <c:pt idx="3941">
                  <c:v>16.649150032997149</c:v>
                </c:pt>
                <c:pt idx="3942">
                  <c:v>14.245250010490452</c:v>
                </c:pt>
                <c:pt idx="3943">
                  <c:v>26.2481498527527</c:v>
                </c:pt>
                <c:pt idx="3944">
                  <c:v>22.901050019264197</c:v>
                </c:pt>
                <c:pt idx="3945">
                  <c:v>7.3462500286102497</c:v>
                </c:pt>
                <c:pt idx="3946">
                  <c:v>15.941249980926543</c:v>
                </c:pt>
                <c:pt idx="3947">
                  <c:v>7.4943497323989483</c:v>
                </c:pt>
                <c:pt idx="3948">
                  <c:v>21.631550006866455</c:v>
                </c:pt>
                <c:pt idx="3949">
                  <c:v>10.568949751853999</c:v>
                </c:pt>
                <c:pt idx="3950">
                  <c:v>12.916499853134152</c:v>
                </c:pt>
                <c:pt idx="3951">
                  <c:v>14.616099886894254</c:v>
                </c:pt>
                <c:pt idx="3952">
                  <c:v>21.377600140571602</c:v>
                </c:pt>
                <c:pt idx="3953">
                  <c:v>14.011199946403444</c:v>
                </c:pt>
                <c:pt idx="3954">
                  <c:v>13.827950057983401</c:v>
                </c:pt>
                <c:pt idx="3955">
                  <c:v>7.4861999607085963</c:v>
                </c:pt>
                <c:pt idx="3956">
                  <c:v>18.958650197982799</c:v>
                </c:pt>
                <c:pt idx="3957">
                  <c:v>24.227650003433251</c:v>
                </c:pt>
                <c:pt idx="3958">
                  <c:v>41.284749841690051</c:v>
                </c:pt>
                <c:pt idx="3959">
                  <c:v>15.879099707603451</c:v>
                </c:pt>
                <c:pt idx="3960">
                  <c:v>14.936699900627154</c:v>
                </c:pt>
                <c:pt idx="3961">
                  <c:v>9.9443999099731499</c:v>
                </c:pt>
                <c:pt idx="3962">
                  <c:v>13.168150010108953</c:v>
                </c:pt>
                <c:pt idx="3963">
                  <c:v>23.471350016593956</c:v>
                </c:pt>
                <c:pt idx="3964">
                  <c:v>22.732000150680502</c:v>
                </c:pt>
                <c:pt idx="3965">
                  <c:v>19.782950253486646</c:v>
                </c:pt>
                <c:pt idx="3966">
                  <c:v>20.046800136566205</c:v>
                </c:pt>
                <c:pt idx="3967">
                  <c:v>20.708649725914007</c:v>
                </c:pt>
                <c:pt idx="3968">
                  <c:v>15.560549902916001</c:v>
                </c:pt>
                <c:pt idx="3969">
                  <c:v>17.005800237655649</c:v>
                </c:pt>
                <c:pt idx="3970">
                  <c:v>18.329049868583645</c:v>
                </c:pt>
                <c:pt idx="3971">
                  <c:v>11.801400256156906</c:v>
                </c:pt>
                <c:pt idx="3972">
                  <c:v>31.769949927329996</c:v>
                </c:pt>
                <c:pt idx="3973">
                  <c:v>14.050600018501299</c:v>
                </c:pt>
                <c:pt idx="3974">
                  <c:v>13.247949995994546</c:v>
                </c:pt>
                <c:pt idx="3975">
                  <c:v>19.5896499252319</c:v>
                </c:pt>
                <c:pt idx="3976">
                  <c:v>23.334399847984301</c:v>
                </c:pt>
                <c:pt idx="3977">
                  <c:v>18.072349815368646</c:v>
                </c:pt>
                <c:pt idx="3978">
                  <c:v>13.791000051498397</c:v>
                </c:pt>
                <c:pt idx="3979">
                  <c:v>14.971350159645048</c:v>
                </c:pt>
                <c:pt idx="3980">
                  <c:v>15.029300065040598</c:v>
                </c:pt>
                <c:pt idx="3981">
                  <c:v>14.061449851989703</c:v>
                </c:pt>
                <c:pt idx="3982">
                  <c:v>10.420949835777346</c:v>
                </c:pt>
                <c:pt idx="3983">
                  <c:v>20.946349735259957</c:v>
                </c:pt>
                <c:pt idx="3984">
                  <c:v>23.993949708938548</c:v>
                </c:pt>
                <c:pt idx="3985">
                  <c:v>13.821950173378049</c:v>
                </c:pt>
                <c:pt idx="3986">
                  <c:v>13.200749845504802</c:v>
                </c:pt>
                <c:pt idx="3987">
                  <c:v>23.684700036048852</c:v>
                </c:pt>
                <c:pt idx="3988">
                  <c:v>27.113600068092296</c:v>
                </c:pt>
                <c:pt idx="3989">
                  <c:v>21.795199775695799</c:v>
                </c:pt>
                <c:pt idx="3990">
                  <c:v>16.298600077629104</c:v>
                </c:pt>
                <c:pt idx="3991">
                  <c:v>19.612750082016007</c:v>
                </c:pt>
                <c:pt idx="3992">
                  <c:v>11.212199850082452</c:v>
                </c:pt>
                <c:pt idx="3993">
                  <c:v>6.1179998922347991</c:v>
                </c:pt>
                <c:pt idx="3994">
                  <c:v>28.097299866676394</c:v>
                </c:pt>
                <c:pt idx="3995">
                  <c:v>17.233199996948251</c:v>
                </c:pt>
                <c:pt idx="3996">
                  <c:v>20.709450111389149</c:v>
                </c:pt>
                <c:pt idx="3997">
                  <c:v>20.186800060272201</c:v>
                </c:pt>
                <c:pt idx="3998">
                  <c:v>19.979349756240847</c:v>
                </c:pt>
                <c:pt idx="3999">
                  <c:v>32.442549762725804</c:v>
                </c:pt>
                <c:pt idx="4000">
                  <c:v>4.4835498523712012</c:v>
                </c:pt>
                <c:pt idx="4001">
                  <c:v>18.215750007629403</c:v>
                </c:pt>
                <c:pt idx="4002">
                  <c:v>18.986350035667449</c:v>
                </c:pt>
                <c:pt idx="4003">
                  <c:v>13.747749934196499</c:v>
                </c:pt>
                <c:pt idx="4004">
                  <c:v>8.1498998355865488</c:v>
                </c:pt>
                <c:pt idx="4005">
                  <c:v>21.396549768447851</c:v>
                </c:pt>
                <c:pt idx="4006">
                  <c:v>23.46709986209865</c:v>
                </c:pt>
                <c:pt idx="4007">
                  <c:v>19.373750157356199</c:v>
                </c:pt>
                <c:pt idx="4008">
                  <c:v>17.632650046348548</c:v>
                </c:pt>
                <c:pt idx="4009">
                  <c:v>12.699699854850753</c:v>
                </c:pt>
                <c:pt idx="4010">
                  <c:v>12.610150079727156</c:v>
                </c:pt>
                <c:pt idx="4011">
                  <c:v>18.037650036811801</c:v>
                </c:pt>
                <c:pt idx="4012">
                  <c:v>17.451650176048304</c:v>
                </c:pt>
                <c:pt idx="4013">
                  <c:v>13.853450117111194</c:v>
                </c:pt>
                <c:pt idx="4014">
                  <c:v>13.2900498867035</c:v>
                </c:pt>
                <c:pt idx="4015">
                  <c:v>21.464549908637998</c:v>
                </c:pt>
                <c:pt idx="4016">
                  <c:v>22.436300206184352</c:v>
                </c:pt>
                <c:pt idx="4017">
                  <c:v>11.889950032234204</c:v>
                </c:pt>
                <c:pt idx="4018">
                  <c:v>18.603600072860701</c:v>
                </c:pt>
                <c:pt idx="4019">
                  <c:v>7.0224498653412475</c:v>
                </c:pt>
                <c:pt idx="4020">
                  <c:v>18.700799884796197</c:v>
                </c:pt>
                <c:pt idx="4021">
                  <c:v>27.528849987983698</c:v>
                </c:pt>
                <c:pt idx="4022">
                  <c:v>11.690650043487594</c:v>
                </c:pt>
                <c:pt idx="4023">
                  <c:v>23.349149899482747</c:v>
                </c:pt>
                <c:pt idx="4024">
                  <c:v>18.764300179481502</c:v>
                </c:pt>
                <c:pt idx="4025">
                  <c:v>26.395749640464807</c:v>
                </c:pt>
                <c:pt idx="4026">
                  <c:v>7.7466998910903477</c:v>
                </c:pt>
                <c:pt idx="4027">
                  <c:v>13.047399930953993</c:v>
                </c:pt>
                <c:pt idx="4028">
                  <c:v>7.9875499773025531</c:v>
                </c:pt>
                <c:pt idx="4029">
                  <c:v>21.259700164794907</c:v>
                </c:pt>
                <c:pt idx="4030">
                  <c:v>15.404199938774092</c:v>
                </c:pt>
                <c:pt idx="4031">
                  <c:v>25.070099749565045</c:v>
                </c:pt>
                <c:pt idx="4032">
                  <c:v>13.616299581527699</c:v>
                </c:pt>
                <c:pt idx="4033">
                  <c:v>18.87095011234285</c:v>
                </c:pt>
                <c:pt idx="4034">
                  <c:v>19.347400112152052</c:v>
                </c:pt>
                <c:pt idx="4035">
                  <c:v>12.165449943542495</c:v>
                </c:pt>
                <c:pt idx="4036">
                  <c:v>16.411499800682094</c:v>
                </c:pt>
                <c:pt idx="4037">
                  <c:v>25.29984994888305</c:v>
                </c:pt>
                <c:pt idx="4038">
                  <c:v>10.282949905395448</c:v>
                </c:pt>
                <c:pt idx="4039">
                  <c:v>10.282949905395448</c:v>
                </c:pt>
                <c:pt idx="4040">
                  <c:v>16.474249830245949</c:v>
                </c:pt>
                <c:pt idx="4041">
                  <c:v>23.454149832725498</c:v>
                </c:pt>
                <c:pt idx="4042">
                  <c:v>22.05685010433195</c:v>
                </c:pt>
                <c:pt idx="4043">
                  <c:v>7.451649885177595</c:v>
                </c:pt>
                <c:pt idx="4044">
                  <c:v>12.889949836730953</c:v>
                </c:pt>
                <c:pt idx="4045">
                  <c:v>7.6603498458862482</c:v>
                </c:pt>
                <c:pt idx="4046">
                  <c:v>8.3789997911453504</c:v>
                </c:pt>
                <c:pt idx="4047">
                  <c:v>14.405600042343153</c:v>
                </c:pt>
                <c:pt idx="4048">
                  <c:v>15.529599990844751</c:v>
                </c:pt>
                <c:pt idx="4049">
                  <c:v>15.898450117111199</c:v>
                </c:pt>
                <c:pt idx="4050">
                  <c:v>26.394550094604501</c:v>
                </c:pt>
                <c:pt idx="4051">
                  <c:v>23.835050163269052</c:v>
                </c:pt>
                <c:pt idx="4052">
                  <c:v>11.63539985179905</c:v>
                </c:pt>
                <c:pt idx="4053">
                  <c:v>13.053649978637701</c:v>
                </c:pt>
                <c:pt idx="4054">
                  <c:v>10.953049817085301</c:v>
                </c:pt>
                <c:pt idx="4055">
                  <c:v>11.809199948310848</c:v>
                </c:pt>
                <c:pt idx="4056">
                  <c:v>15.550900025367703</c:v>
                </c:pt>
                <c:pt idx="4057">
                  <c:v>13.511800131797802</c:v>
                </c:pt>
                <c:pt idx="4058">
                  <c:v>19.971650042533902</c:v>
                </c:pt>
                <c:pt idx="4059">
                  <c:v>14.771850333213855</c:v>
                </c:pt>
                <c:pt idx="4060">
                  <c:v>19.303600144386305</c:v>
                </c:pt>
                <c:pt idx="4061">
                  <c:v>17.406350100040449</c:v>
                </c:pt>
                <c:pt idx="4062">
                  <c:v>21.496700067520152</c:v>
                </c:pt>
                <c:pt idx="4063">
                  <c:v>14.669500136375451</c:v>
                </c:pt>
                <c:pt idx="4064">
                  <c:v>8.2466500473022037</c:v>
                </c:pt>
                <c:pt idx="4065">
                  <c:v>17.154199938774148</c:v>
                </c:pt>
                <c:pt idx="4066">
                  <c:v>29.35114981651305</c:v>
                </c:pt>
                <c:pt idx="4067">
                  <c:v>11.336199998855552</c:v>
                </c:pt>
                <c:pt idx="4068">
                  <c:v>11.481749796867344</c:v>
                </c:pt>
                <c:pt idx="4069">
                  <c:v>18.183100066184998</c:v>
                </c:pt>
                <c:pt idx="4070">
                  <c:v>15.631000065803544</c:v>
                </c:pt>
                <c:pt idx="4071">
                  <c:v>7.3544498205185036</c:v>
                </c:pt>
                <c:pt idx="4072">
                  <c:v>16.504699959754944</c:v>
                </c:pt>
                <c:pt idx="4073">
                  <c:v>9.9328500032425495</c:v>
                </c:pt>
                <c:pt idx="4074">
                  <c:v>14.503350038528453</c:v>
                </c:pt>
                <c:pt idx="4075">
                  <c:v>15.3183000898361</c:v>
                </c:pt>
                <c:pt idx="4076">
                  <c:v>27.089649987220753</c:v>
                </c:pt>
                <c:pt idx="4077">
                  <c:v>12.480950102806048</c:v>
                </c:pt>
                <c:pt idx="4078">
                  <c:v>15.724999728202803</c:v>
                </c:pt>
                <c:pt idx="4079">
                  <c:v>23.38309977054595</c:v>
                </c:pt>
                <c:pt idx="4080">
                  <c:v>13.284350156784051</c:v>
                </c:pt>
                <c:pt idx="4081">
                  <c:v>14.232899942398102</c:v>
                </c:pt>
                <c:pt idx="4082">
                  <c:v>16.436150054931595</c:v>
                </c:pt>
                <c:pt idx="4083">
                  <c:v>17.504400053024249</c:v>
                </c:pt>
                <c:pt idx="4084">
                  <c:v>20.688100113868749</c:v>
                </c:pt>
                <c:pt idx="4085">
                  <c:v>18.953000206947305</c:v>
                </c:pt>
                <c:pt idx="4086">
                  <c:v>18.433450069427501</c:v>
                </c:pt>
                <c:pt idx="4087">
                  <c:v>20.4121998214722</c:v>
                </c:pt>
                <c:pt idx="4088">
                  <c:v>13.926899995803851</c:v>
                </c:pt>
                <c:pt idx="4089">
                  <c:v>14.903100028038047</c:v>
                </c:pt>
                <c:pt idx="4090">
                  <c:v>14.493200106620797</c:v>
                </c:pt>
                <c:pt idx="4091">
                  <c:v>19.284950189590447</c:v>
                </c:pt>
                <c:pt idx="4092">
                  <c:v>22.180099749565095</c:v>
                </c:pt>
                <c:pt idx="4093">
                  <c:v>16.509250063896147</c:v>
                </c:pt>
                <c:pt idx="4094">
                  <c:v>16.854450054168701</c:v>
                </c:pt>
                <c:pt idx="4095">
                  <c:v>14.078999938964849</c:v>
                </c:pt>
                <c:pt idx="4096">
                  <c:v>27.203149976730344</c:v>
                </c:pt>
                <c:pt idx="4097">
                  <c:v>27.935649819374049</c:v>
                </c:pt>
                <c:pt idx="4098">
                  <c:v>13.564749975204506</c:v>
                </c:pt>
                <c:pt idx="4099">
                  <c:v>18.800300025939947</c:v>
                </c:pt>
                <c:pt idx="4100">
                  <c:v>20.030800166130049</c:v>
                </c:pt>
                <c:pt idx="4101">
                  <c:v>29.60394987106325</c:v>
                </c:pt>
                <c:pt idx="4102">
                  <c:v>24.709450020790101</c:v>
                </c:pt>
                <c:pt idx="4103">
                  <c:v>18.100600090026845</c:v>
                </c:pt>
                <c:pt idx="4104">
                  <c:v>18.042699804306046</c:v>
                </c:pt>
                <c:pt idx="4105">
                  <c:v>17.913149957656898</c:v>
                </c:pt>
                <c:pt idx="4106">
                  <c:v>11.730507525049099</c:v>
                </c:pt>
                <c:pt idx="4107">
                  <c:v>26.821700253486647</c:v>
                </c:pt>
                <c:pt idx="4108">
                  <c:v>12.314649758338952</c:v>
                </c:pt>
                <c:pt idx="4109">
                  <c:v>17.826550006866448</c:v>
                </c:pt>
                <c:pt idx="4110">
                  <c:v>10.193099894523652</c:v>
                </c:pt>
                <c:pt idx="4111">
                  <c:v>14.455150108337349</c:v>
                </c:pt>
                <c:pt idx="4112">
                  <c:v>20.183949708938648</c:v>
                </c:pt>
                <c:pt idx="4113">
                  <c:v>9.6307497930527006</c:v>
                </c:pt>
                <c:pt idx="4114">
                  <c:v>16.4914499902725</c:v>
                </c:pt>
                <c:pt idx="4115">
                  <c:v>5.1169998645782506</c:v>
                </c:pt>
                <c:pt idx="4116">
                  <c:v>20.828699889183049</c:v>
                </c:pt>
                <c:pt idx="4117">
                  <c:v>32.957599890232103</c:v>
                </c:pt>
                <c:pt idx="4118">
                  <c:v>15.95020021915435</c:v>
                </c:pt>
                <c:pt idx="4119">
                  <c:v>13.148599891662599</c:v>
                </c:pt>
                <c:pt idx="4120">
                  <c:v>10.251050200462299</c:v>
                </c:pt>
                <c:pt idx="4121">
                  <c:v>6.3679997730254989</c:v>
                </c:pt>
                <c:pt idx="4122">
                  <c:v>9.9637498712539454</c:v>
                </c:pt>
                <c:pt idx="4123">
                  <c:v>12.891950039863602</c:v>
                </c:pt>
                <c:pt idx="4124">
                  <c:v>12.409349837303154</c:v>
                </c:pt>
                <c:pt idx="4125">
                  <c:v>16.846100120544449</c:v>
                </c:pt>
                <c:pt idx="4126">
                  <c:v>16.846100120544449</c:v>
                </c:pt>
                <c:pt idx="4127">
                  <c:v>12.447549991607701</c:v>
                </c:pt>
                <c:pt idx="4128">
                  <c:v>11.323699917793199</c:v>
                </c:pt>
                <c:pt idx="4129">
                  <c:v>13.759299931526151</c:v>
                </c:pt>
                <c:pt idx="4130">
                  <c:v>9.5781499719619525</c:v>
                </c:pt>
                <c:pt idx="4131">
                  <c:v>21.291750087738052</c:v>
                </c:pt>
                <c:pt idx="4132">
                  <c:v>12.166599965095504</c:v>
                </c:pt>
                <c:pt idx="4133">
                  <c:v>7.2974001073837513</c:v>
                </c:pt>
                <c:pt idx="4134">
                  <c:v>17.118399839401249</c:v>
                </c:pt>
                <c:pt idx="4135">
                  <c:v>20.815549879074148</c:v>
                </c:pt>
                <c:pt idx="4136">
                  <c:v>21.480000066757199</c:v>
                </c:pt>
                <c:pt idx="4137">
                  <c:v>26.422400012016301</c:v>
                </c:pt>
                <c:pt idx="4138">
                  <c:v>16.187500214576751</c:v>
                </c:pt>
                <c:pt idx="4139">
                  <c:v>8.0577498149872007</c:v>
                </c:pt>
                <c:pt idx="4140">
                  <c:v>15.795000133514407</c:v>
                </c:pt>
                <c:pt idx="4141">
                  <c:v>25.571150012016346</c:v>
                </c:pt>
                <c:pt idx="4142">
                  <c:v>14.655549969673153</c:v>
                </c:pt>
                <c:pt idx="4143">
                  <c:v>12.157300133705156</c:v>
                </c:pt>
                <c:pt idx="4144">
                  <c:v>3.6695498323440034</c:v>
                </c:pt>
                <c:pt idx="4145">
                  <c:v>14.086599898338307</c:v>
                </c:pt>
                <c:pt idx="4146">
                  <c:v>11.02309985637665</c:v>
                </c:pt>
                <c:pt idx="4147">
                  <c:v>11.280299854278546</c:v>
                </c:pt>
                <c:pt idx="4148">
                  <c:v>20.135649819374098</c:v>
                </c:pt>
                <c:pt idx="4149">
                  <c:v>14.288399882316597</c:v>
                </c:pt>
                <c:pt idx="4150">
                  <c:v>19.442399950027507</c:v>
                </c:pt>
                <c:pt idx="4151">
                  <c:v>24.247849950790396</c:v>
                </c:pt>
                <c:pt idx="4152">
                  <c:v>13.731800079345696</c:v>
                </c:pt>
                <c:pt idx="4153">
                  <c:v>17.746750011444103</c:v>
                </c:pt>
                <c:pt idx="4154">
                  <c:v>20.930799984931944</c:v>
                </c:pt>
                <c:pt idx="4155">
                  <c:v>10.174699888229398</c:v>
                </c:pt>
                <c:pt idx="4156">
                  <c:v>13.122499933242747</c:v>
                </c:pt>
                <c:pt idx="4157">
                  <c:v>26.264449710845952</c:v>
                </c:pt>
                <c:pt idx="4158">
                  <c:v>14.074100046157803</c:v>
                </c:pt>
                <c:pt idx="4159">
                  <c:v>27.311150045394854</c:v>
                </c:pt>
                <c:pt idx="4160">
                  <c:v>16.6490500402451</c:v>
                </c:pt>
                <c:pt idx="4161">
                  <c:v>15.038499941825854</c:v>
                </c:pt>
                <c:pt idx="4162">
                  <c:v>20.5115501117706</c:v>
                </c:pt>
                <c:pt idx="4163">
                  <c:v>13.654549632072452</c:v>
                </c:pt>
                <c:pt idx="4164">
                  <c:v>11.733999862670899</c:v>
                </c:pt>
                <c:pt idx="4165">
                  <c:v>20.232699947357148</c:v>
                </c:pt>
                <c:pt idx="4166">
                  <c:v>14.760700216293351</c:v>
                </c:pt>
                <c:pt idx="4167">
                  <c:v>22.691249995231651</c:v>
                </c:pt>
                <c:pt idx="4168">
                  <c:v>12.041449975967396</c:v>
                </c:pt>
                <c:pt idx="4169">
                  <c:v>16.13069984436035</c:v>
                </c:pt>
                <c:pt idx="4170">
                  <c:v>13.460099930763299</c:v>
                </c:pt>
                <c:pt idx="4171">
                  <c:v>22.642050061225898</c:v>
                </c:pt>
                <c:pt idx="4172">
                  <c:v>3.6257497739791518</c:v>
                </c:pt>
                <c:pt idx="4173">
                  <c:v>18.401499934196451</c:v>
                </c:pt>
                <c:pt idx="4174">
                  <c:v>21.607200007438657</c:v>
                </c:pt>
                <c:pt idx="4175">
                  <c:v>23.8575499820709</c:v>
                </c:pt>
                <c:pt idx="4176">
                  <c:v>23.753099849224046</c:v>
                </c:pt>
                <c:pt idx="4177">
                  <c:v>13.973599872589094</c:v>
                </c:pt>
                <c:pt idx="4178">
                  <c:v>13.973599872589094</c:v>
                </c:pt>
                <c:pt idx="4179">
                  <c:v>18.687000064849851</c:v>
                </c:pt>
                <c:pt idx="4180">
                  <c:v>18.456850123405495</c:v>
                </c:pt>
                <c:pt idx="4181">
                  <c:v>27.044099826812797</c:v>
                </c:pt>
                <c:pt idx="4182">
                  <c:v>20.333150062560996</c:v>
                </c:pt>
                <c:pt idx="4183">
                  <c:v>26.036399979591398</c:v>
                </c:pt>
                <c:pt idx="4184">
                  <c:v>22.354849996566749</c:v>
                </c:pt>
                <c:pt idx="4185">
                  <c:v>17.211399948596949</c:v>
                </c:pt>
                <c:pt idx="4186">
                  <c:v>5.9554496431350508</c:v>
                </c:pt>
                <c:pt idx="4187">
                  <c:v>5.9554496431350508</c:v>
                </c:pt>
                <c:pt idx="4188">
                  <c:v>7.8160498762131034</c:v>
                </c:pt>
                <c:pt idx="4189">
                  <c:v>24.904549775123549</c:v>
                </c:pt>
                <c:pt idx="4190">
                  <c:v>11.816050195694004</c:v>
                </c:pt>
                <c:pt idx="4191">
                  <c:v>17.034500122070352</c:v>
                </c:pt>
                <c:pt idx="4192">
                  <c:v>17.165349717140202</c:v>
                </c:pt>
                <c:pt idx="4193">
                  <c:v>20.766249947547898</c:v>
                </c:pt>
                <c:pt idx="4194">
                  <c:v>13.419199905395551</c:v>
                </c:pt>
                <c:pt idx="4195">
                  <c:v>13.371450047492996</c:v>
                </c:pt>
                <c:pt idx="4196">
                  <c:v>12.489599952697748</c:v>
                </c:pt>
                <c:pt idx="4197">
                  <c:v>27.016250119209303</c:v>
                </c:pt>
                <c:pt idx="4198">
                  <c:v>20.381550188064601</c:v>
                </c:pt>
                <c:pt idx="4199">
                  <c:v>12.519950070381199</c:v>
                </c:pt>
                <c:pt idx="4200">
                  <c:v>14.0537998723984</c:v>
                </c:pt>
                <c:pt idx="4201">
                  <c:v>20.493750133514396</c:v>
                </c:pt>
                <c:pt idx="4202">
                  <c:v>13.290700201988201</c:v>
                </c:pt>
                <c:pt idx="4203">
                  <c:v>10.064599714279151</c:v>
                </c:pt>
                <c:pt idx="4204">
                  <c:v>18.125150089263904</c:v>
                </c:pt>
                <c:pt idx="4205">
                  <c:v>21.2676502466202</c:v>
                </c:pt>
                <c:pt idx="4206">
                  <c:v>14.673350095748894</c:v>
                </c:pt>
                <c:pt idx="4207">
                  <c:v>14.332250080108601</c:v>
                </c:pt>
                <c:pt idx="4208">
                  <c:v>21.330450139045698</c:v>
                </c:pt>
                <c:pt idx="4209">
                  <c:v>10.129249930381754</c:v>
                </c:pt>
                <c:pt idx="4210">
                  <c:v>14.0080498790741</c:v>
                </c:pt>
                <c:pt idx="4211">
                  <c:v>5.5487999105453483</c:v>
                </c:pt>
                <c:pt idx="4212">
                  <c:v>15.147750158309943</c:v>
                </c:pt>
                <c:pt idx="4213">
                  <c:v>7.0221998643875025</c:v>
                </c:pt>
                <c:pt idx="4214">
                  <c:v>14.397350058555553</c:v>
                </c:pt>
                <c:pt idx="4215">
                  <c:v>9.0127499437332048</c:v>
                </c:pt>
                <c:pt idx="4216">
                  <c:v>12.815549836158795</c:v>
                </c:pt>
                <c:pt idx="4217">
                  <c:v>12.815549836158795</c:v>
                </c:pt>
                <c:pt idx="4218">
                  <c:v>22.538950028419453</c:v>
                </c:pt>
                <c:pt idx="4219">
                  <c:v>10.331149811744702</c:v>
                </c:pt>
                <c:pt idx="4220">
                  <c:v>10.331149811744702</c:v>
                </c:pt>
                <c:pt idx="4221">
                  <c:v>11.135499901771556</c:v>
                </c:pt>
                <c:pt idx="4222">
                  <c:v>15.17464994430545</c:v>
                </c:pt>
                <c:pt idx="4223">
                  <c:v>13.212899751663201</c:v>
                </c:pt>
                <c:pt idx="4224">
                  <c:v>13.416599898338347</c:v>
                </c:pt>
                <c:pt idx="4225">
                  <c:v>9.5777997016906973</c:v>
                </c:pt>
                <c:pt idx="4226">
                  <c:v>6.2917999124527029</c:v>
                </c:pt>
                <c:pt idx="4227">
                  <c:v>26.764399933814946</c:v>
                </c:pt>
                <c:pt idx="4228">
                  <c:v>20.048749785423347</c:v>
                </c:pt>
                <c:pt idx="4229">
                  <c:v>22.522950158119247</c:v>
                </c:pt>
                <c:pt idx="4230">
                  <c:v>14.977350001335203</c:v>
                </c:pt>
                <c:pt idx="4231">
                  <c:v>17.169699778556847</c:v>
                </c:pt>
                <c:pt idx="4232">
                  <c:v>23.558949756622305</c:v>
                </c:pt>
                <c:pt idx="4233">
                  <c:v>4.2095499134063985</c:v>
                </c:pt>
                <c:pt idx="4234">
                  <c:v>14.486100034713758</c:v>
                </c:pt>
                <c:pt idx="4235">
                  <c:v>10.727449975013752</c:v>
                </c:pt>
                <c:pt idx="4236">
                  <c:v>12.978399844169552</c:v>
                </c:pt>
                <c:pt idx="4237">
                  <c:v>11.678699889183051</c:v>
                </c:pt>
                <c:pt idx="4238">
                  <c:v>13.148399963378896</c:v>
                </c:pt>
                <c:pt idx="4239">
                  <c:v>8.491199727058401</c:v>
                </c:pt>
                <c:pt idx="4240">
                  <c:v>16.489150104522693</c:v>
                </c:pt>
                <c:pt idx="4241">
                  <c:v>19.403550152778649</c:v>
                </c:pt>
                <c:pt idx="4242">
                  <c:v>13.379349694251999</c:v>
                </c:pt>
                <c:pt idx="4243">
                  <c:v>21.012299885749805</c:v>
                </c:pt>
                <c:pt idx="4244">
                  <c:v>12.440299973487853</c:v>
                </c:pt>
                <c:pt idx="4245">
                  <c:v>11.671400065422048</c:v>
                </c:pt>
                <c:pt idx="4246">
                  <c:v>18.508150029182445</c:v>
                </c:pt>
                <c:pt idx="4247">
                  <c:v>14.560249857902548</c:v>
                </c:pt>
                <c:pt idx="4248">
                  <c:v>18.016050004959101</c:v>
                </c:pt>
                <c:pt idx="4249">
                  <c:v>9.4137998533248464</c:v>
                </c:pt>
                <c:pt idx="4250">
                  <c:v>23.465599837303145</c:v>
                </c:pt>
                <c:pt idx="4251">
                  <c:v>15.402150073051445</c:v>
                </c:pt>
                <c:pt idx="4252">
                  <c:v>10.088399715423598</c:v>
                </c:pt>
                <c:pt idx="4253">
                  <c:v>18.268899965286195</c:v>
                </c:pt>
                <c:pt idx="4254">
                  <c:v>23.380649843215956</c:v>
                </c:pt>
                <c:pt idx="4255">
                  <c:v>17.035799899101249</c:v>
                </c:pt>
                <c:pt idx="4256">
                  <c:v>17.749950089454654</c:v>
                </c:pt>
                <c:pt idx="4257">
                  <c:v>10.252349944114698</c:v>
                </c:pt>
                <c:pt idx="4258">
                  <c:v>11.715750074386598</c:v>
                </c:pt>
                <c:pt idx="4259">
                  <c:v>10.689599962234453</c:v>
                </c:pt>
                <c:pt idx="4260">
                  <c:v>17.281400041580191</c:v>
                </c:pt>
                <c:pt idx="4261">
                  <c:v>13.853699865341152</c:v>
                </c:pt>
                <c:pt idx="4262">
                  <c:v>13.666650242805499</c:v>
                </c:pt>
                <c:pt idx="4263">
                  <c:v>13.850599889755244</c:v>
                </c:pt>
                <c:pt idx="4264">
                  <c:v>8.6129998731613497</c:v>
                </c:pt>
                <c:pt idx="4265">
                  <c:v>20.050000028610199</c:v>
                </c:pt>
                <c:pt idx="4266">
                  <c:v>14.2136502456665</c:v>
                </c:pt>
                <c:pt idx="4267">
                  <c:v>12.476449933052102</c:v>
                </c:pt>
                <c:pt idx="4268">
                  <c:v>27.968600134849506</c:v>
                </c:pt>
                <c:pt idx="4269">
                  <c:v>18.665050020217947</c:v>
                </c:pt>
                <c:pt idx="4270">
                  <c:v>21.467899727821347</c:v>
                </c:pt>
                <c:pt idx="4271">
                  <c:v>23.959700069427448</c:v>
                </c:pt>
                <c:pt idx="4272">
                  <c:v>8.5193498611449989</c:v>
                </c:pt>
                <c:pt idx="4273">
                  <c:v>17.614100046157851</c:v>
                </c:pt>
                <c:pt idx="4274">
                  <c:v>13.834899830818145</c:v>
                </c:pt>
                <c:pt idx="4275">
                  <c:v>13.418249993324302</c:v>
                </c:pt>
                <c:pt idx="4276">
                  <c:v>17.021200151443502</c:v>
                </c:pt>
                <c:pt idx="4277">
                  <c:v>13.461950211524943</c:v>
                </c:pt>
                <c:pt idx="4278">
                  <c:v>20.5063999605179</c:v>
                </c:pt>
                <c:pt idx="4279">
                  <c:v>14.317799973487844</c:v>
                </c:pt>
                <c:pt idx="4280">
                  <c:v>9.2188499784469471</c:v>
                </c:pt>
                <c:pt idx="4281">
                  <c:v>17.624550013542148</c:v>
                </c:pt>
                <c:pt idx="4282">
                  <c:v>13.927399935722349</c:v>
                </c:pt>
                <c:pt idx="4283">
                  <c:v>19.6653500127792</c:v>
                </c:pt>
                <c:pt idx="4284">
                  <c:v>26.662550067901599</c:v>
                </c:pt>
                <c:pt idx="4285">
                  <c:v>13.90065017700195</c:v>
                </c:pt>
                <c:pt idx="4286">
                  <c:v>20.130100002288856</c:v>
                </c:pt>
                <c:pt idx="4287">
                  <c:v>13.241900067329397</c:v>
                </c:pt>
                <c:pt idx="4288">
                  <c:v>13.923699975013751</c:v>
                </c:pt>
                <c:pt idx="4289">
                  <c:v>12.316350102424604</c:v>
                </c:pt>
                <c:pt idx="4290">
                  <c:v>6.8807997417449513</c:v>
                </c:pt>
                <c:pt idx="4291">
                  <c:v>15.766500039100702</c:v>
                </c:pt>
                <c:pt idx="4292">
                  <c:v>27.583549847602796</c:v>
                </c:pt>
                <c:pt idx="4293">
                  <c:v>6.4488498353957979</c:v>
                </c:pt>
                <c:pt idx="4294">
                  <c:v>21.690149807930048</c:v>
                </c:pt>
                <c:pt idx="4295">
                  <c:v>12.267049908638047</c:v>
                </c:pt>
                <c:pt idx="4296">
                  <c:v>21.083849854469303</c:v>
                </c:pt>
                <c:pt idx="4297">
                  <c:v>14.741600112915044</c:v>
                </c:pt>
                <c:pt idx="4298">
                  <c:v>18.219200310707151</c:v>
                </c:pt>
                <c:pt idx="4299">
                  <c:v>18.461649808883649</c:v>
                </c:pt>
                <c:pt idx="4300">
                  <c:v>10.186800003051751</c:v>
                </c:pt>
                <c:pt idx="4301">
                  <c:v>8.4419998502731488</c:v>
                </c:pt>
                <c:pt idx="4302">
                  <c:v>18.243600006103502</c:v>
                </c:pt>
                <c:pt idx="4303">
                  <c:v>23.549549837112451</c:v>
                </c:pt>
                <c:pt idx="4304">
                  <c:v>17.564249887466502</c:v>
                </c:pt>
                <c:pt idx="4305">
                  <c:v>16.039949774742105</c:v>
                </c:pt>
                <c:pt idx="4306">
                  <c:v>14.821149902343748</c:v>
                </c:pt>
                <c:pt idx="4307">
                  <c:v>16.982200131416352</c:v>
                </c:pt>
                <c:pt idx="4308">
                  <c:v>15.352639413698753</c:v>
                </c:pt>
                <c:pt idx="4309">
                  <c:v>15.350549964904744</c:v>
                </c:pt>
                <c:pt idx="4310">
                  <c:v>11.983549914360005</c:v>
                </c:pt>
                <c:pt idx="4311">
                  <c:v>14.160300173759502</c:v>
                </c:pt>
                <c:pt idx="4312">
                  <c:v>18.636099820137051</c:v>
                </c:pt>
                <c:pt idx="4313">
                  <c:v>16.804000124931299</c:v>
                </c:pt>
                <c:pt idx="4314">
                  <c:v>12.713700079917903</c:v>
                </c:pt>
                <c:pt idx="4315">
                  <c:v>14.448650002479603</c:v>
                </c:pt>
                <c:pt idx="4316">
                  <c:v>21.285450067520145</c:v>
                </c:pt>
                <c:pt idx="4317">
                  <c:v>6.4657498502730988</c:v>
                </c:pt>
                <c:pt idx="4318">
                  <c:v>18.508400020599403</c:v>
                </c:pt>
                <c:pt idx="4319">
                  <c:v>20.6389998435974</c:v>
                </c:pt>
                <c:pt idx="4320">
                  <c:v>15.828150110244746</c:v>
                </c:pt>
                <c:pt idx="4321">
                  <c:v>17.511899976730351</c:v>
                </c:pt>
                <c:pt idx="4322">
                  <c:v>18.624900102615349</c:v>
                </c:pt>
                <c:pt idx="4323">
                  <c:v>14.042300033569298</c:v>
                </c:pt>
                <c:pt idx="4324">
                  <c:v>29.833249859809904</c:v>
                </c:pt>
                <c:pt idx="4325">
                  <c:v>22.860149922370901</c:v>
                </c:pt>
                <c:pt idx="4326">
                  <c:v>17.86980012416835</c:v>
                </c:pt>
                <c:pt idx="4327">
                  <c:v>14.214649920463543</c:v>
                </c:pt>
                <c:pt idx="4328">
                  <c:v>8.8923498058318984</c:v>
                </c:pt>
                <c:pt idx="4329">
                  <c:v>13.7892998790741</c:v>
                </c:pt>
                <c:pt idx="4330">
                  <c:v>29.690349917411805</c:v>
                </c:pt>
                <c:pt idx="4331">
                  <c:v>10.881849780082703</c:v>
                </c:pt>
                <c:pt idx="4332">
                  <c:v>13.174400029182397</c:v>
                </c:pt>
                <c:pt idx="4333">
                  <c:v>23.018499970436146</c:v>
                </c:pt>
                <c:pt idx="4334">
                  <c:v>12.699749917984001</c:v>
                </c:pt>
                <c:pt idx="4335">
                  <c:v>19.5356500816345</c:v>
                </c:pt>
                <c:pt idx="4336">
                  <c:v>14.873199925422696</c:v>
                </c:pt>
                <c:pt idx="4337">
                  <c:v>21.787000389099148</c:v>
                </c:pt>
                <c:pt idx="4338">
                  <c:v>11.677349886894248</c:v>
                </c:pt>
                <c:pt idx="4339">
                  <c:v>21.150050148963899</c:v>
                </c:pt>
                <c:pt idx="4340">
                  <c:v>9.0499999189377007</c:v>
                </c:pt>
                <c:pt idx="4341">
                  <c:v>22.648700008392304</c:v>
                </c:pt>
                <c:pt idx="4342">
                  <c:v>14.658650116920498</c:v>
                </c:pt>
                <c:pt idx="4343">
                  <c:v>19.618199796676606</c:v>
                </c:pt>
                <c:pt idx="4344">
                  <c:v>16.126549901962299</c:v>
                </c:pt>
                <c:pt idx="4345">
                  <c:v>16.555250010490447</c:v>
                </c:pt>
                <c:pt idx="4346">
                  <c:v>26.900249843597404</c:v>
                </c:pt>
                <c:pt idx="4347">
                  <c:v>11.848849949836751</c:v>
                </c:pt>
                <c:pt idx="4348">
                  <c:v>11.791049842834447</c:v>
                </c:pt>
                <c:pt idx="4349">
                  <c:v>18.209550037383995</c:v>
                </c:pt>
                <c:pt idx="4350">
                  <c:v>12.999950056076045</c:v>
                </c:pt>
                <c:pt idx="4351">
                  <c:v>18.741950225830095</c:v>
                </c:pt>
                <c:pt idx="4352">
                  <c:v>21.476600079536453</c:v>
                </c:pt>
                <c:pt idx="4353">
                  <c:v>14.579800119400055</c:v>
                </c:pt>
                <c:pt idx="4354">
                  <c:v>20.775800075531045</c:v>
                </c:pt>
                <c:pt idx="4355">
                  <c:v>16.377850027084349</c:v>
                </c:pt>
                <c:pt idx="4356">
                  <c:v>8.256899952888503</c:v>
                </c:pt>
                <c:pt idx="4357">
                  <c:v>17.350649933815056</c:v>
                </c:pt>
                <c:pt idx="4358">
                  <c:v>19.316900086402853</c:v>
                </c:pt>
                <c:pt idx="4359">
                  <c:v>7.8067998218536481</c:v>
                </c:pt>
                <c:pt idx="4360">
                  <c:v>10.131499948501599</c:v>
                </c:pt>
                <c:pt idx="4361">
                  <c:v>14.346100010871851</c:v>
                </c:pt>
                <c:pt idx="4362">
                  <c:v>25.363950152397148</c:v>
                </c:pt>
                <c:pt idx="4363">
                  <c:v>11.273049941062951</c:v>
                </c:pt>
                <c:pt idx="4364">
                  <c:v>15.657999963760403</c:v>
                </c:pt>
                <c:pt idx="4365">
                  <c:v>24.359250226020848</c:v>
                </c:pt>
                <c:pt idx="4366">
                  <c:v>22.550849900245648</c:v>
                </c:pt>
                <c:pt idx="4367">
                  <c:v>19.322949862480151</c:v>
                </c:pt>
                <c:pt idx="4368">
                  <c:v>19.104449958801297</c:v>
                </c:pt>
                <c:pt idx="4369">
                  <c:v>19.335249981880199</c:v>
                </c:pt>
                <c:pt idx="4370">
                  <c:v>14.066899914741505</c:v>
                </c:pt>
                <c:pt idx="4371">
                  <c:v>7.1627996397017988</c:v>
                </c:pt>
                <c:pt idx="4372">
                  <c:v>17.124550027847306</c:v>
                </c:pt>
                <c:pt idx="4373">
                  <c:v>8.3027498054504001</c:v>
                </c:pt>
                <c:pt idx="4374">
                  <c:v>20.526750230789201</c:v>
                </c:pt>
                <c:pt idx="4375">
                  <c:v>20.562350273132402</c:v>
                </c:pt>
                <c:pt idx="4376">
                  <c:v>9.7225999021530463</c:v>
                </c:pt>
                <c:pt idx="4377">
                  <c:v>12.118099732399003</c:v>
                </c:pt>
                <c:pt idx="4378">
                  <c:v>19.174150147438056</c:v>
                </c:pt>
                <c:pt idx="4379">
                  <c:v>18.079050068855246</c:v>
                </c:pt>
                <c:pt idx="4380">
                  <c:v>15.083450007438699</c:v>
                </c:pt>
                <c:pt idx="4381">
                  <c:v>6.9040999412537012</c:v>
                </c:pt>
                <c:pt idx="4382">
                  <c:v>14.697500061988848</c:v>
                </c:pt>
                <c:pt idx="4383">
                  <c:v>6.4711000013351487</c:v>
                </c:pt>
                <c:pt idx="4384">
                  <c:v>16.184350147247347</c:v>
                </c:pt>
                <c:pt idx="4385">
                  <c:v>20.504600033760095</c:v>
                </c:pt>
                <c:pt idx="4386">
                  <c:v>18.5346001958847</c:v>
                </c:pt>
                <c:pt idx="4387">
                  <c:v>7.8437498426437493</c:v>
                </c:pt>
                <c:pt idx="4388">
                  <c:v>50.163849945068399</c:v>
                </c:pt>
                <c:pt idx="4389">
                  <c:v>13.610299978256251</c:v>
                </c:pt>
                <c:pt idx="4390">
                  <c:v>13.285599942207348</c:v>
                </c:pt>
                <c:pt idx="4391">
                  <c:v>17.762999868392953</c:v>
                </c:pt>
                <c:pt idx="4392">
                  <c:v>24.033950185775748</c:v>
                </c:pt>
                <c:pt idx="4393">
                  <c:v>16.326099834442104</c:v>
                </c:pt>
                <c:pt idx="4394">
                  <c:v>16.996250057220458</c:v>
                </c:pt>
                <c:pt idx="4395">
                  <c:v>16.132149968147246</c:v>
                </c:pt>
                <c:pt idx="4396">
                  <c:v>14.048249912262001</c:v>
                </c:pt>
                <c:pt idx="4397">
                  <c:v>21.288750042915353</c:v>
                </c:pt>
                <c:pt idx="4398">
                  <c:v>14.151949691772451</c:v>
                </c:pt>
                <c:pt idx="4399">
                  <c:v>18.139150114059497</c:v>
                </c:pt>
                <c:pt idx="4400">
                  <c:v>19.50385020256045</c:v>
                </c:pt>
                <c:pt idx="4401">
                  <c:v>12.974050135612497</c:v>
                </c:pt>
                <c:pt idx="4402">
                  <c:v>15.274000020027145</c:v>
                </c:pt>
                <c:pt idx="4403">
                  <c:v>15.702800168991097</c:v>
                </c:pt>
                <c:pt idx="4404">
                  <c:v>8.5564607482277992</c:v>
                </c:pt>
                <c:pt idx="4405">
                  <c:v>15.656400074958796</c:v>
                </c:pt>
                <c:pt idx="4406">
                  <c:v>20.861150012016349</c:v>
                </c:pt>
                <c:pt idx="4407">
                  <c:v>17.724399838447603</c:v>
                </c:pt>
                <c:pt idx="4408">
                  <c:v>6.7141998958587479</c:v>
                </c:pt>
                <c:pt idx="4409">
                  <c:v>18.695799913406397</c:v>
                </c:pt>
                <c:pt idx="4410">
                  <c:v>20.648700389862046</c:v>
                </c:pt>
                <c:pt idx="4411">
                  <c:v>18.886349945068304</c:v>
                </c:pt>
                <c:pt idx="4412">
                  <c:v>4.3560499477386543</c:v>
                </c:pt>
                <c:pt idx="4413">
                  <c:v>9.1090998744964509</c:v>
                </c:pt>
                <c:pt idx="4414">
                  <c:v>8.2476998376845998</c:v>
                </c:pt>
                <c:pt idx="4415">
                  <c:v>12.788449854850697</c:v>
                </c:pt>
                <c:pt idx="4416">
                  <c:v>15.577500171661399</c:v>
                </c:pt>
                <c:pt idx="4417">
                  <c:v>30.534299759864851</c:v>
                </c:pt>
                <c:pt idx="4418">
                  <c:v>6.2261498427391011</c:v>
                </c:pt>
                <c:pt idx="4419">
                  <c:v>17.489949789047298</c:v>
                </c:pt>
                <c:pt idx="4420">
                  <c:v>14.308599977493298</c:v>
                </c:pt>
                <c:pt idx="4421">
                  <c:v>15.097249784469597</c:v>
                </c:pt>
                <c:pt idx="4422">
                  <c:v>16.684699835777248</c:v>
                </c:pt>
                <c:pt idx="4423">
                  <c:v>15.5147000360489</c:v>
                </c:pt>
                <c:pt idx="4424">
                  <c:v>9.4584997415542986</c:v>
                </c:pt>
                <c:pt idx="4425">
                  <c:v>14.253399882316607</c:v>
                </c:pt>
                <c:pt idx="4426">
                  <c:v>18.917400217056301</c:v>
                </c:pt>
                <c:pt idx="4427">
                  <c:v>23.068400154113753</c:v>
                </c:pt>
                <c:pt idx="4428">
                  <c:v>15.319899892806998</c:v>
                </c:pt>
                <c:pt idx="4429">
                  <c:v>12.873700041770999</c:v>
                </c:pt>
                <c:pt idx="4430">
                  <c:v>16.869699807167045</c:v>
                </c:pt>
                <c:pt idx="4431">
                  <c:v>17.4867000484467</c:v>
                </c:pt>
                <c:pt idx="4432">
                  <c:v>11.094850015640251</c:v>
                </c:pt>
                <c:pt idx="4433">
                  <c:v>18.514850020408652</c:v>
                </c:pt>
                <c:pt idx="4434">
                  <c:v>13.181849946975696</c:v>
                </c:pt>
                <c:pt idx="4435">
                  <c:v>21.05505001068115</c:v>
                </c:pt>
                <c:pt idx="4436">
                  <c:v>13.21135002136225</c:v>
                </c:pt>
                <c:pt idx="4437">
                  <c:v>23.225399765968302</c:v>
                </c:pt>
                <c:pt idx="4438">
                  <c:v>7.2766998577118507</c:v>
                </c:pt>
                <c:pt idx="4439">
                  <c:v>17.610000143051145</c:v>
                </c:pt>
                <c:pt idx="4440">
                  <c:v>15.880649871826201</c:v>
                </c:pt>
                <c:pt idx="4441">
                  <c:v>12.498600072860654</c:v>
                </c:pt>
                <c:pt idx="4442">
                  <c:v>25.064849982261649</c:v>
                </c:pt>
                <c:pt idx="4443">
                  <c:v>16.560300216674847</c:v>
                </c:pt>
                <c:pt idx="4444">
                  <c:v>14.769149985313401</c:v>
                </c:pt>
                <c:pt idx="4445">
                  <c:v>16.4295499801636</c:v>
                </c:pt>
                <c:pt idx="4446">
                  <c:v>16.562149968147249</c:v>
                </c:pt>
                <c:pt idx="4447">
                  <c:v>16.048100023269647</c:v>
                </c:pt>
                <c:pt idx="4448">
                  <c:v>20.105250101089446</c:v>
                </c:pt>
                <c:pt idx="4449">
                  <c:v>19.198700094223</c:v>
                </c:pt>
                <c:pt idx="4450">
                  <c:v>25.088849911689749</c:v>
                </c:pt>
                <c:pt idx="4451">
                  <c:v>12.959949870109554</c:v>
                </c:pt>
                <c:pt idx="4452">
                  <c:v>10.542149949073799</c:v>
                </c:pt>
                <c:pt idx="4453">
                  <c:v>15.518549871444705</c:v>
                </c:pt>
                <c:pt idx="4454">
                  <c:v>19.274699840545651</c:v>
                </c:pt>
                <c:pt idx="4455">
                  <c:v>13.802400126457155</c:v>
                </c:pt>
                <c:pt idx="4456">
                  <c:v>16.953450007438647</c:v>
                </c:pt>
                <c:pt idx="4457">
                  <c:v>11.866299810409551</c:v>
                </c:pt>
                <c:pt idx="4458">
                  <c:v>13.036150045394905</c:v>
                </c:pt>
                <c:pt idx="4459">
                  <c:v>14.153400025367745</c:v>
                </c:pt>
                <c:pt idx="4460">
                  <c:v>13.43320009708405</c:v>
                </c:pt>
                <c:pt idx="4461">
                  <c:v>9.9887999629974473</c:v>
                </c:pt>
                <c:pt idx="4462">
                  <c:v>9.4312499046325513</c:v>
                </c:pt>
                <c:pt idx="4463">
                  <c:v>41.467249698638895</c:v>
                </c:pt>
                <c:pt idx="4464">
                  <c:v>18.915850009918248</c:v>
                </c:pt>
                <c:pt idx="4465">
                  <c:v>14.925950021743802</c:v>
                </c:pt>
                <c:pt idx="4466">
                  <c:v>6.8173498535156511</c:v>
                </c:pt>
                <c:pt idx="4467">
                  <c:v>20.173949809074397</c:v>
                </c:pt>
                <c:pt idx="4468">
                  <c:v>15.68025002956395</c:v>
                </c:pt>
                <c:pt idx="4469">
                  <c:v>13.928149909973147</c:v>
                </c:pt>
                <c:pt idx="4470">
                  <c:v>29.656950101852448</c:v>
                </c:pt>
                <c:pt idx="4471">
                  <c:v>10.011399927139301</c:v>
                </c:pt>
                <c:pt idx="4472">
                  <c:v>22.581900124549904</c:v>
                </c:pt>
                <c:pt idx="4473">
                  <c:v>17.235549955368</c:v>
                </c:pt>
                <c:pt idx="4474">
                  <c:v>15.1262001657486</c:v>
                </c:pt>
                <c:pt idx="4475">
                  <c:v>19.141400098800656</c:v>
                </c:pt>
                <c:pt idx="4476">
                  <c:v>18.695050158500642</c:v>
                </c:pt>
                <c:pt idx="4477">
                  <c:v>2.5588000392913983</c:v>
                </c:pt>
                <c:pt idx="4478">
                  <c:v>19.608850331306446</c:v>
                </c:pt>
                <c:pt idx="4479">
                  <c:v>11.615249795913748</c:v>
                </c:pt>
                <c:pt idx="4480">
                  <c:v>19.018850007057207</c:v>
                </c:pt>
                <c:pt idx="4481">
                  <c:v>15.380500063896147</c:v>
                </c:pt>
                <c:pt idx="4482">
                  <c:v>15.5812998390197</c:v>
                </c:pt>
                <c:pt idx="4483">
                  <c:v>17.018549971580502</c:v>
                </c:pt>
                <c:pt idx="4484">
                  <c:v>70.348049860000501</c:v>
                </c:pt>
                <c:pt idx="4485">
                  <c:v>10.949449892044054</c:v>
                </c:pt>
                <c:pt idx="4486">
                  <c:v>13.034799923896848</c:v>
                </c:pt>
                <c:pt idx="4487">
                  <c:v>13.871599984169002</c:v>
                </c:pt>
                <c:pt idx="4488">
                  <c:v>7.8053499555587464</c:v>
                </c:pt>
                <c:pt idx="4489">
                  <c:v>19.9841000175476</c:v>
                </c:pt>
                <c:pt idx="4490">
                  <c:v>13.10699994087215</c:v>
                </c:pt>
                <c:pt idx="4491">
                  <c:v>14.844299898147597</c:v>
                </c:pt>
                <c:pt idx="4492">
                  <c:v>13.239649777412399</c:v>
                </c:pt>
                <c:pt idx="4493">
                  <c:v>10.945299744606</c:v>
                </c:pt>
                <c:pt idx="4494">
                  <c:v>19.595049982070897</c:v>
                </c:pt>
                <c:pt idx="4495">
                  <c:v>13.229400029182401</c:v>
                </c:pt>
                <c:pt idx="4496">
                  <c:v>11.634900040626501</c:v>
                </c:pt>
                <c:pt idx="4497">
                  <c:v>10.317249765396102</c:v>
                </c:pt>
                <c:pt idx="4498">
                  <c:v>13.666850085258453</c:v>
                </c:pt>
                <c:pt idx="4499">
                  <c:v>14.813499994277947</c:v>
                </c:pt>
                <c:pt idx="4500">
                  <c:v>7.2814497470855493</c:v>
                </c:pt>
                <c:pt idx="4501">
                  <c:v>12.768449983596849</c:v>
                </c:pt>
                <c:pt idx="4502">
                  <c:v>15.036150059699999</c:v>
                </c:pt>
                <c:pt idx="4503">
                  <c:v>14.2568500185013</c:v>
                </c:pt>
                <c:pt idx="4504">
                  <c:v>13.779400138855003</c:v>
                </c:pt>
                <c:pt idx="4505">
                  <c:v>17.758049845695499</c:v>
                </c:pt>
                <c:pt idx="4506">
                  <c:v>15.974300146102902</c:v>
                </c:pt>
                <c:pt idx="4507">
                  <c:v>15.974300146102902</c:v>
                </c:pt>
                <c:pt idx="4508">
                  <c:v>8.4648497581481479</c:v>
                </c:pt>
                <c:pt idx="4509">
                  <c:v>8.1507999181747017</c:v>
                </c:pt>
                <c:pt idx="4510">
                  <c:v>6.2737498092651478</c:v>
                </c:pt>
                <c:pt idx="4511">
                  <c:v>18.37365002155305</c:v>
                </c:pt>
                <c:pt idx="4512">
                  <c:v>15.285449976921051</c:v>
                </c:pt>
                <c:pt idx="4513">
                  <c:v>17.288599929809607</c:v>
                </c:pt>
                <c:pt idx="4514">
                  <c:v>14.4645999288559</c:v>
                </c:pt>
                <c:pt idx="4515">
                  <c:v>6.528599705696152</c:v>
                </c:pt>
                <c:pt idx="4516">
                  <c:v>27.082799873352052</c:v>
                </c:pt>
                <c:pt idx="4517">
                  <c:v>13.607000064849849</c:v>
                </c:pt>
                <c:pt idx="4518">
                  <c:v>11.569149847030651</c:v>
                </c:pt>
                <c:pt idx="4519">
                  <c:v>14.534300088882503</c:v>
                </c:pt>
                <c:pt idx="4520">
                  <c:v>21.907100043296843</c:v>
                </c:pt>
                <c:pt idx="4521">
                  <c:v>11.326849904060399</c:v>
                </c:pt>
                <c:pt idx="4522">
                  <c:v>25.247700057029697</c:v>
                </c:pt>
                <c:pt idx="4523">
                  <c:v>7.8984997081756028</c:v>
                </c:pt>
                <c:pt idx="4524">
                  <c:v>17.099500112533555</c:v>
                </c:pt>
                <c:pt idx="4525">
                  <c:v>14.335049905776948</c:v>
                </c:pt>
                <c:pt idx="4526">
                  <c:v>16.458649959564205</c:v>
                </c:pt>
                <c:pt idx="4527">
                  <c:v>17.37850016593935</c:v>
                </c:pt>
                <c:pt idx="4528">
                  <c:v>16.9141001796722</c:v>
                </c:pt>
                <c:pt idx="4529">
                  <c:v>10.949899940490699</c:v>
                </c:pt>
                <c:pt idx="4530">
                  <c:v>14.192750067710897</c:v>
                </c:pt>
                <c:pt idx="4531">
                  <c:v>10.950449895858799</c:v>
                </c:pt>
                <c:pt idx="4532">
                  <c:v>3.6464999008179007</c:v>
                </c:pt>
                <c:pt idx="4533">
                  <c:v>4.5574997425079466</c:v>
                </c:pt>
                <c:pt idx="4534">
                  <c:v>15.513999915122998</c:v>
                </c:pt>
                <c:pt idx="4535">
                  <c:v>18.371049962043806</c:v>
                </c:pt>
                <c:pt idx="4536">
                  <c:v>23.269899849891651</c:v>
                </c:pt>
                <c:pt idx="4537">
                  <c:v>15.671999974250809</c:v>
                </c:pt>
                <c:pt idx="4538">
                  <c:v>14.845949988365156</c:v>
                </c:pt>
                <c:pt idx="4539">
                  <c:v>23.68360000610355</c:v>
                </c:pt>
                <c:pt idx="4540">
                  <c:v>16.789099965095502</c:v>
                </c:pt>
                <c:pt idx="4541">
                  <c:v>9.3731998014450042</c:v>
                </c:pt>
                <c:pt idx="4542">
                  <c:v>14.395600237846345</c:v>
                </c:pt>
                <c:pt idx="4543">
                  <c:v>15.657700195312451</c:v>
                </c:pt>
                <c:pt idx="4544">
                  <c:v>9.0512500381469536</c:v>
                </c:pt>
                <c:pt idx="4545">
                  <c:v>15.868150100708</c:v>
                </c:pt>
                <c:pt idx="4546">
                  <c:v>11.163999929428105</c:v>
                </c:pt>
                <c:pt idx="4547">
                  <c:v>15.482599749565104</c:v>
                </c:pt>
                <c:pt idx="4548">
                  <c:v>15.0308500146866</c:v>
                </c:pt>
                <c:pt idx="4549">
                  <c:v>17.937449970245403</c:v>
                </c:pt>
                <c:pt idx="4550">
                  <c:v>14.298699984550495</c:v>
                </c:pt>
                <c:pt idx="4551">
                  <c:v>11.973499798774746</c:v>
                </c:pt>
                <c:pt idx="4552">
                  <c:v>12.944100027084346</c:v>
                </c:pt>
                <c:pt idx="4553">
                  <c:v>12.251849980354251</c:v>
                </c:pt>
                <c:pt idx="4554">
                  <c:v>10.98209996223445</c:v>
                </c:pt>
                <c:pt idx="4555">
                  <c:v>15.759700050353949</c:v>
                </c:pt>
                <c:pt idx="4556">
                  <c:v>18.485199923515303</c:v>
                </c:pt>
                <c:pt idx="4557">
                  <c:v>16.62135002136235</c:v>
                </c:pt>
                <c:pt idx="4558">
                  <c:v>2.2863498353958533</c:v>
                </c:pt>
                <c:pt idx="4559">
                  <c:v>24.939649810790954</c:v>
                </c:pt>
                <c:pt idx="4560">
                  <c:v>13.918450088500951</c:v>
                </c:pt>
                <c:pt idx="4561">
                  <c:v>5.4736498355864995</c:v>
                </c:pt>
                <c:pt idx="4562">
                  <c:v>19.760800266265854</c:v>
                </c:pt>
                <c:pt idx="4563">
                  <c:v>21.304650034904451</c:v>
                </c:pt>
                <c:pt idx="4564">
                  <c:v>13.88209987163545</c:v>
                </c:pt>
                <c:pt idx="4565">
                  <c:v>15.463049955368049</c:v>
                </c:pt>
                <c:pt idx="4566">
                  <c:v>13.330849695205703</c:v>
                </c:pt>
                <c:pt idx="4567">
                  <c:v>15.240149765014646</c:v>
                </c:pt>
                <c:pt idx="4568">
                  <c:v>14.995049886703498</c:v>
                </c:pt>
                <c:pt idx="4569">
                  <c:v>3.9756499385833521</c:v>
                </c:pt>
                <c:pt idx="4570">
                  <c:v>9.1079998970030971</c:v>
                </c:pt>
                <c:pt idx="4571">
                  <c:v>15.293850154876697</c:v>
                </c:pt>
                <c:pt idx="4572">
                  <c:v>11.970199851989697</c:v>
                </c:pt>
                <c:pt idx="4573">
                  <c:v>9.3351998281478537</c:v>
                </c:pt>
                <c:pt idx="4574">
                  <c:v>5.8426497077941981</c:v>
                </c:pt>
                <c:pt idx="4575">
                  <c:v>11.281499967575048</c:v>
                </c:pt>
                <c:pt idx="4576">
                  <c:v>22.160099925994849</c:v>
                </c:pt>
                <c:pt idx="4577">
                  <c:v>20.699399881362904</c:v>
                </c:pt>
                <c:pt idx="4578">
                  <c:v>6.8312496757507013</c:v>
                </c:pt>
                <c:pt idx="4579">
                  <c:v>28.425549778938247</c:v>
                </c:pt>
                <c:pt idx="4580">
                  <c:v>19.562249855995155</c:v>
                </c:pt>
                <c:pt idx="4581">
                  <c:v>16.943400044441198</c:v>
                </c:pt>
                <c:pt idx="4582">
                  <c:v>13.519900012016301</c:v>
                </c:pt>
                <c:pt idx="4583">
                  <c:v>14.25949989795685</c:v>
                </c:pt>
                <c:pt idx="4584">
                  <c:v>16.501699848175051</c:v>
                </c:pt>
                <c:pt idx="4585">
                  <c:v>9.3688499546050963</c:v>
                </c:pt>
                <c:pt idx="4586">
                  <c:v>7.0571998262404989</c:v>
                </c:pt>
                <c:pt idx="4587">
                  <c:v>8.8786999320983995</c:v>
                </c:pt>
                <c:pt idx="4588">
                  <c:v>8.2763998174667002</c:v>
                </c:pt>
                <c:pt idx="4589">
                  <c:v>11.2321999454498</c:v>
                </c:pt>
                <c:pt idx="4590">
                  <c:v>19.510550236701953</c:v>
                </c:pt>
                <c:pt idx="4591">
                  <c:v>14.290499887466396</c:v>
                </c:pt>
                <c:pt idx="4592">
                  <c:v>14.466999864578202</c:v>
                </c:pt>
                <c:pt idx="4593">
                  <c:v>9.8706500053405968</c:v>
                </c:pt>
                <c:pt idx="4594">
                  <c:v>8.5105996966361488</c:v>
                </c:pt>
                <c:pt idx="4595">
                  <c:v>8.7526997900009533</c:v>
                </c:pt>
                <c:pt idx="4596">
                  <c:v>8.8413498783110995</c:v>
                </c:pt>
                <c:pt idx="4597">
                  <c:v>21.253800001144448</c:v>
                </c:pt>
                <c:pt idx="4598">
                  <c:v>4.418349862098701</c:v>
                </c:pt>
                <c:pt idx="4599">
                  <c:v>13.968650021553053</c:v>
                </c:pt>
                <c:pt idx="4600">
                  <c:v>8.8788997268676972</c:v>
                </c:pt>
                <c:pt idx="4601">
                  <c:v>13.458049969673201</c:v>
                </c:pt>
                <c:pt idx="4602">
                  <c:v>11.153799867629999</c:v>
                </c:pt>
                <c:pt idx="4603">
                  <c:v>20.293700199127201</c:v>
                </c:pt>
                <c:pt idx="4604">
                  <c:v>22.766349983215299</c:v>
                </c:pt>
                <c:pt idx="4605">
                  <c:v>13.278199939727802</c:v>
                </c:pt>
                <c:pt idx="4606">
                  <c:v>10.752149796485899</c:v>
                </c:pt>
                <c:pt idx="4607">
                  <c:v>11.508599991798405</c:v>
                </c:pt>
                <c:pt idx="4608">
                  <c:v>10.169249806404103</c:v>
                </c:pt>
                <c:pt idx="4609">
                  <c:v>17.842099900245699</c:v>
                </c:pt>
                <c:pt idx="4610">
                  <c:v>24.690750060081449</c:v>
                </c:pt>
                <c:pt idx="4611">
                  <c:v>9.2210496568679972</c:v>
                </c:pt>
                <c:pt idx="4612">
                  <c:v>15.7795000362396</c:v>
                </c:pt>
                <c:pt idx="4613">
                  <c:v>12.090049858093302</c:v>
                </c:pt>
                <c:pt idx="4614">
                  <c:v>21.6430500745773</c:v>
                </c:pt>
                <c:pt idx="4615">
                  <c:v>19.394799947738647</c:v>
                </c:pt>
                <c:pt idx="4616">
                  <c:v>4.8214499521255512</c:v>
                </c:pt>
                <c:pt idx="4617">
                  <c:v>13.572949995994598</c:v>
                </c:pt>
                <c:pt idx="4618">
                  <c:v>15.299649982452401</c:v>
                </c:pt>
                <c:pt idx="4619">
                  <c:v>21.849549932479849</c:v>
                </c:pt>
                <c:pt idx="4620">
                  <c:v>19.986050100326498</c:v>
                </c:pt>
                <c:pt idx="4621">
                  <c:v>12.51174994945525</c:v>
                </c:pt>
                <c:pt idx="4622">
                  <c:v>17.841350221633896</c:v>
                </c:pt>
                <c:pt idx="4623">
                  <c:v>22.806249942779552</c:v>
                </c:pt>
                <c:pt idx="4624">
                  <c:v>14.221749944686898</c:v>
                </c:pt>
                <c:pt idx="4625">
                  <c:v>8.592200031280548</c:v>
                </c:pt>
                <c:pt idx="4626">
                  <c:v>17.377600083351155</c:v>
                </c:pt>
                <c:pt idx="4627">
                  <c:v>13.631200060844442</c:v>
                </c:pt>
                <c:pt idx="4628">
                  <c:v>21.44569999694825</c:v>
                </c:pt>
                <c:pt idx="4629">
                  <c:v>12.392900094985951</c:v>
                </c:pt>
                <c:pt idx="4630">
                  <c:v>24.166449947357194</c:v>
                </c:pt>
                <c:pt idx="4631">
                  <c:v>14.332000026702847</c:v>
                </c:pt>
                <c:pt idx="4632">
                  <c:v>15.073049941062948</c:v>
                </c:pt>
                <c:pt idx="4633">
                  <c:v>22.991999840736398</c:v>
                </c:pt>
                <c:pt idx="4634">
                  <c:v>9.5480998516082529</c:v>
                </c:pt>
                <c:pt idx="4635">
                  <c:v>14.515549836158748</c:v>
                </c:pt>
                <c:pt idx="4636">
                  <c:v>16.753750176429751</c:v>
                </c:pt>
                <c:pt idx="4637">
                  <c:v>7.4523998475074968</c:v>
                </c:pt>
                <c:pt idx="4638">
                  <c:v>22.16030008316045</c:v>
                </c:pt>
                <c:pt idx="4639">
                  <c:v>14.205849843025199</c:v>
                </c:pt>
                <c:pt idx="4640">
                  <c:v>23.575249929428097</c:v>
                </c:pt>
                <c:pt idx="4641">
                  <c:v>15.776000046730001</c:v>
                </c:pt>
                <c:pt idx="4642">
                  <c:v>2.6217998075485021</c:v>
                </c:pt>
                <c:pt idx="4643">
                  <c:v>18.44335013866425</c:v>
                </c:pt>
                <c:pt idx="4644">
                  <c:v>16.890650000572201</c:v>
                </c:pt>
                <c:pt idx="4645">
                  <c:v>15.01619988441465</c:v>
                </c:pt>
                <c:pt idx="4646">
                  <c:v>21.7811501169205</c:v>
                </c:pt>
                <c:pt idx="4647">
                  <c:v>14.76144984722135</c:v>
                </c:pt>
                <c:pt idx="4648">
                  <c:v>11.451850013732894</c:v>
                </c:pt>
                <c:pt idx="4649">
                  <c:v>14.396599864959754</c:v>
                </c:pt>
                <c:pt idx="4650">
                  <c:v>5.9629997348784975</c:v>
                </c:pt>
                <c:pt idx="4651">
                  <c:v>13.1197501277924</c:v>
                </c:pt>
                <c:pt idx="4652">
                  <c:v>10.673350009918199</c:v>
                </c:pt>
                <c:pt idx="4653">
                  <c:v>10.91229984283445</c:v>
                </c:pt>
                <c:pt idx="4654">
                  <c:v>11.697750029563899</c:v>
                </c:pt>
                <c:pt idx="4655">
                  <c:v>10.237749938964797</c:v>
                </c:pt>
                <c:pt idx="4656">
                  <c:v>5.8088498830795494</c:v>
                </c:pt>
                <c:pt idx="4657">
                  <c:v>12.469149832725449</c:v>
                </c:pt>
                <c:pt idx="4658">
                  <c:v>10.502099909782451</c:v>
                </c:pt>
                <c:pt idx="4659">
                  <c:v>21.400249900817904</c:v>
                </c:pt>
                <c:pt idx="4660">
                  <c:v>14.9728499937058</c:v>
                </c:pt>
                <c:pt idx="4661">
                  <c:v>21.387900056838994</c:v>
                </c:pt>
                <c:pt idx="4662">
                  <c:v>9.9008499383926498</c:v>
                </c:pt>
                <c:pt idx="4663">
                  <c:v>18.850550184249897</c:v>
                </c:pt>
                <c:pt idx="4664">
                  <c:v>16.347450284957905</c:v>
                </c:pt>
                <c:pt idx="4665">
                  <c:v>14.0469001483917</c:v>
                </c:pt>
                <c:pt idx="4666">
                  <c:v>19.153450093269349</c:v>
                </c:pt>
                <c:pt idx="4667">
                  <c:v>6.1183499145508016</c:v>
                </c:pt>
                <c:pt idx="4668">
                  <c:v>12.227700037956254</c:v>
                </c:pt>
                <c:pt idx="4669">
                  <c:v>17.560749816894553</c:v>
                </c:pt>
                <c:pt idx="4670">
                  <c:v>14.958999991416903</c:v>
                </c:pt>
                <c:pt idx="4671">
                  <c:v>16.451350088119547</c:v>
                </c:pt>
                <c:pt idx="4672">
                  <c:v>4.2734498834610015</c:v>
                </c:pt>
                <c:pt idx="4673">
                  <c:v>13.094900035858103</c:v>
                </c:pt>
                <c:pt idx="4674">
                  <c:v>16.650750079154896</c:v>
                </c:pt>
                <c:pt idx="4675">
                  <c:v>12.581150021553047</c:v>
                </c:pt>
                <c:pt idx="4676">
                  <c:v>8.0065498876571475</c:v>
                </c:pt>
                <c:pt idx="4677">
                  <c:v>12.314599890708948</c:v>
                </c:pt>
                <c:pt idx="4678">
                  <c:v>9.3898999500274485</c:v>
                </c:pt>
                <c:pt idx="4679">
                  <c:v>11.251949911117503</c:v>
                </c:pt>
                <c:pt idx="4680">
                  <c:v>18.703900046348604</c:v>
                </c:pt>
                <c:pt idx="4681">
                  <c:v>16.4938499546051</c:v>
                </c:pt>
                <c:pt idx="4682">
                  <c:v>14.559450011253354</c:v>
                </c:pt>
                <c:pt idx="4683">
                  <c:v>13.302750120162955</c:v>
                </c:pt>
                <c:pt idx="4684">
                  <c:v>12.089949893951456</c:v>
                </c:pt>
                <c:pt idx="4685">
                  <c:v>13.3029999399185</c:v>
                </c:pt>
                <c:pt idx="4686">
                  <c:v>15.614850015640243</c:v>
                </c:pt>
                <c:pt idx="4687">
                  <c:v>10.795749826431301</c:v>
                </c:pt>
                <c:pt idx="4688">
                  <c:v>17.075100140571546</c:v>
                </c:pt>
                <c:pt idx="4689">
                  <c:v>16.195250029563901</c:v>
                </c:pt>
                <c:pt idx="4690">
                  <c:v>9.7591497802734004</c:v>
                </c:pt>
                <c:pt idx="4691">
                  <c:v>7.4496997594833019</c:v>
                </c:pt>
                <c:pt idx="4692">
                  <c:v>9.164000082015999</c:v>
                </c:pt>
                <c:pt idx="4693">
                  <c:v>12.2427501153946</c:v>
                </c:pt>
                <c:pt idx="4694">
                  <c:v>12.97339993953705</c:v>
                </c:pt>
                <c:pt idx="4695">
                  <c:v>15.410199885368407</c:v>
                </c:pt>
                <c:pt idx="4696">
                  <c:v>10.262649869918846</c:v>
                </c:pt>
                <c:pt idx="4697">
                  <c:v>16.545499949455255</c:v>
                </c:pt>
                <c:pt idx="4698">
                  <c:v>13.6035999584198</c:v>
                </c:pt>
                <c:pt idx="4699">
                  <c:v>15.7289001226425</c:v>
                </c:pt>
                <c:pt idx="4700">
                  <c:v>9.4953997659683012</c:v>
                </c:pt>
                <c:pt idx="4701">
                  <c:v>21.207800140380897</c:v>
                </c:pt>
                <c:pt idx="4702">
                  <c:v>14.783149914741546</c:v>
                </c:pt>
                <c:pt idx="4703">
                  <c:v>16.731650214195195</c:v>
                </c:pt>
                <c:pt idx="4704">
                  <c:v>10.71064984798425</c:v>
                </c:pt>
                <c:pt idx="4705">
                  <c:v>19.159000096321094</c:v>
                </c:pt>
                <c:pt idx="4706">
                  <c:v>33.267749898433699</c:v>
                </c:pt>
                <c:pt idx="4707">
                  <c:v>18.39910001277925</c:v>
                </c:pt>
                <c:pt idx="4708">
                  <c:v>16.568750109672504</c:v>
                </c:pt>
                <c:pt idx="4709">
                  <c:v>14.516149911880497</c:v>
                </c:pt>
                <c:pt idx="4710">
                  <c:v>8.4380499029159495</c:v>
                </c:pt>
                <c:pt idx="4711">
                  <c:v>21.177649955749498</c:v>
                </c:pt>
                <c:pt idx="4712">
                  <c:v>23.595649967193602</c:v>
                </c:pt>
                <c:pt idx="4713">
                  <c:v>20.546899890899702</c:v>
                </c:pt>
                <c:pt idx="4714">
                  <c:v>17.221649990081808</c:v>
                </c:pt>
                <c:pt idx="4715">
                  <c:v>11.112649784088099</c:v>
                </c:pt>
                <c:pt idx="4716">
                  <c:v>12.407899847030652</c:v>
                </c:pt>
                <c:pt idx="4717">
                  <c:v>13.177349848747202</c:v>
                </c:pt>
                <c:pt idx="4718">
                  <c:v>26.745150070190402</c:v>
                </c:pt>
                <c:pt idx="4719">
                  <c:v>11.050999851226749</c:v>
                </c:pt>
                <c:pt idx="4720">
                  <c:v>17.903350052833545</c:v>
                </c:pt>
                <c:pt idx="4721">
                  <c:v>8.1348998308182487</c:v>
                </c:pt>
                <c:pt idx="4722">
                  <c:v>12.166699790954553</c:v>
                </c:pt>
                <c:pt idx="4723">
                  <c:v>16.908950128555297</c:v>
                </c:pt>
                <c:pt idx="4724">
                  <c:v>8.5567998981475526</c:v>
                </c:pt>
                <c:pt idx="4725">
                  <c:v>11.259949994087201</c:v>
                </c:pt>
                <c:pt idx="4726">
                  <c:v>7.7709497785568011</c:v>
                </c:pt>
                <c:pt idx="4727">
                  <c:v>19.395600104331997</c:v>
                </c:pt>
                <c:pt idx="4728">
                  <c:v>22.369200024604844</c:v>
                </c:pt>
                <c:pt idx="4729">
                  <c:v>23.452949886321999</c:v>
                </c:pt>
                <c:pt idx="4730">
                  <c:v>11.680099835395801</c:v>
                </c:pt>
                <c:pt idx="4731">
                  <c:v>7.7705498886108018</c:v>
                </c:pt>
                <c:pt idx="4732">
                  <c:v>12.25665005683895</c:v>
                </c:pt>
                <c:pt idx="4733">
                  <c:v>13.790049953460695</c:v>
                </c:pt>
                <c:pt idx="4734">
                  <c:v>11.867599802017253</c:v>
                </c:pt>
                <c:pt idx="4735">
                  <c:v>15.005900068283047</c:v>
                </c:pt>
                <c:pt idx="4736">
                  <c:v>8.4090500164031532</c:v>
                </c:pt>
                <c:pt idx="4737">
                  <c:v>9.2190996551514033</c:v>
                </c:pt>
                <c:pt idx="4738">
                  <c:v>15.544099912643397</c:v>
                </c:pt>
                <c:pt idx="4739">
                  <c:v>7.6846997451782002</c:v>
                </c:pt>
                <c:pt idx="4740">
                  <c:v>8.3999998378753489</c:v>
                </c:pt>
                <c:pt idx="4741">
                  <c:v>13.878599839210551</c:v>
                </c:pt>
                <c:pt idx="4742">
                  <c:v>9.100649800300598</c:v>
                </c:pt>
                <c:pt idx="4743">
                  <c:v>15.894700047969799</c:v>
                </c:pt>
                <c:pt idx="4744">
                  <c:v>15.128700203895598</c:v>
                </c:pt>
                <c:pt idx="4745">
                  <c:v>6.3656497955321996</c:v>
                </c:pt>
                <c:pt idx="4746">
                  <c:v>5.8047997951507497</c:v>
                </c:pt>
                <c:pt idx="4747">
                  <c:v>16.586850056648302</c:v>
                </c:pt>
                <c:pt idx="4748">
                  <c:v>27.988799712657944</c:v>
                </c:pt>
                <c:pt idx="4749">
                  <c:v>15.312199864387544</c:v>
                </c:pt>
                <c:pt idx="4750">
                  <c:v>15.799549965858503</c:v>
                </c:pt>
                <c:pt idx="4751">
                  <c:v>30.3735498428345</c:v>
                </c:pt>
                <c:pt idx="4752">
                  <c:v>18.947250080108645</c:v>
                </c:pt>
                <c:pt idx="4753">
                  <c:v>27.38379984855645</c:v>
                </c:pt>
                <c:pt idx="4754">
                  <c:v>17.215350103378352</c:v>
                </c:pt>
                <c:pt idx="4755">
                  <c:v>17.572899961471556</c:v>
                </c:pt>
                <c:pt idx="4756">
                  <c:v>11.606849875450099</c:v>
                </c:pt>
                <c:pt idx="4757">
                  <c:v>10.830999813079799</c:v>
                </c:pt>
                <c:pt idx="4758">
                  <c:v>23.813499941825846</c:v>
                </c:pt>
                <c:pt idx="4759">
                  <c:v>7.9424998378754026</c:v>
                </c:pt>
                <c:pt idx="4760">
                  <c:v>8.7929501104354486</c:v>
                </c:pt>
                <c:pt idx="4761">
                  <c:v>19.9390501785278</c:v>
                </c:pt>
                <c:pt idx="4762">
                  <c:v>16.743549766540546</c:v>
                </c:pt>
                <c:pt idx="4763">
                  <c:v>12.217450017929103</c:v>
                </c:pt>
                <c:pt idx="4764">
                  <c:v>13.898750047683698</c:v>
                </c:pt>
                <c:pt idx="4765">
                  <c:v>18.562599835395844</c:v>
                </c:pt>
                <c:pt idx="4766">
                  <c:v>15.872099690437345</c:v>
                </c:pt>
                <c:pt idx="4767">
                  <c:v>7.6693498706817493</c:v>
                </c:pt>
                <c:pt idx="4768">
                  <c:v>9.3504998254775984</c:v>
                </c:pt>
                <c:pt idx="4769">
                  <c:v>3.9612497997283995</c:v>
                </c:pt>
                <c:pt idx="4770">
                  <c:v>10.052699906826053</c:v>
                </c:pt>
                <c:pt idx="4771">
                  <c:v>6.0548073030722485</c:v>
                </c:pt>
                <c:pt idx="4772">
                  <c:v>19.568200101852447</c:v>
                </c:pt>
                <c:pt idx="4773">
                  <c:v>7.8391497611999021</c:v>
                </c:pt>
                <c:pt idx="4774">
                  <c:v>19.815549883842497</c:v>
                </c:pt>
                <c:pt idx="4775">
                  <c:v>7.1394999647140516</c:v>
                </c:pt>
                <c:pt idx="4776">
                  <c:v>15.717649898528997</c:v>
                </c:pt>
                <c:pt idx="4777">
                  <c:v>13.664800057411252</c:v>
                </c:pt>
                <c:pt idx="4778">
                  <c:v>18.442950220108045</c:v>
                </c:pt>
                <c:pt idx="4779">
                  <c:v>9.3177499294280999</c:v>
                </c:pt>
                <c:pt idx="4780">
                  <c:v>12.217249879837002</c:v>
                </c:pt>
                <c:pt idx="4781">
                  <c:v>12.841699972152654</c:v>
                </c:pt>
                <c:pt idx="4782">
                  <c:v>9.47599986553195</c:v>
                </c:pt>
                <c:pt idx="4783">
                  <c:v>10.735699954032853</c:v>
                </c:pt>
                <c:pt idx="4784">
                  <c:v>15.345500068664553</c:v>
                </c:pt>
                <c:pt idx="4785">
                  <c:v>11.027450032234199</c:v>
                </c:pt>
                <c:pt idx="4786">
                  <c:v>19.919549980163598</c:v>
                </c:pt>
                <c:pt idx="4787">
                  <c:v>11.318249788284298</c:v>
                </c:pt>
                <c:pt idx="4788">
                  <c:v>9.8948999547958501</c:v>
                </c:pt>
                <c:pt idx="4789">
                  <c:v>9.1452999162673976</c:v>
                </c:pt>
                <c:pt idx="4790">
                  <c:v>21.386650061607348</c:v>
                </c:pt>
                <c:pt idx="4791">
                  <c:v>12.434249796867398</c:v>
                </c:pt>
                <c:pt idx="4792">
                  <c:v>7.866949710845951</c:v>
                </c:pt>
                <c:pt idx="4793">
                  <c:v>10.078649921417298</c:v>
                </c:pt>
                <c:pt idx="4794">
                  <c:v>16.8557999372482</c:v>
                </c:pt>
                <c:pt idx="4795">
                  <c:v>12.129849853515644</c:v>
                </c:pt>
                <c:pt idx="4796">
                  <c:v>13.398899817466749</c:v>
                </c:pt>
                <c:pt idx="4797">
                  <c:v>11.022099952697747</c:v>
                </c:pt>
                <c:pt idx="4798">
                  <c:v>18.323849906921399</c:v>
                </c:pt>
                <c:pt idx="4799">
                  <c:v>25.167849988937398</c:v>
                </c:pt>
                <c:pt idx="4800">
                  <c:v>17.419250025749157</c:v>
                </c:pt>
                <c:pt idx="4801">
                  <c:v>14.723300056457546</c:v>
                </c:pt>
                <c:pt idx="4802">
                  <c:v>6.8773998022080001</c:v>
                </c:pt>
                <c:pt idx="4803">
                  <c:v>18.197700004577655</c:v>
                </c:pt>
                <c:pt idx="4804">
                  <c:v>13.457699928283702</c:v>
                </c:pt>
                <c:pt idx="4805">
                  <c:v>14.531600170135498</c:v>
                </c:pt>
                <c:pt idx="4806">
                  <c:v>19.851199898719802</c:v>
                </c:pt>
                <c:pt idx="4807">
                  <c:v>11.547450079917951</c:v>
                </c:pt>
                <c:pt idx="4808">
                  <c:v>14.9258001613617</c:v>
                </c:pt>
                <c:pt idx="4809">
                  <c:v>10.428799810409501</c:v>
                </c:pt>
                <c:pt idx="4810">
                  <c:v>8.5985496902465499</c:v>
                </c:pt>
                <c:pt idx="4811">
                  <c:v>13.804399967193596</c:v>
                </c:pt>
                <c:pt idx="4812">
                  <c:v>6.4791998386383476</c:v>
                </c:pt>
                <c:pt idx="4813">
                  <c:v>8.8136497879028006</c:v>
                </c:pt>
                <c:pt idx="4814">
                  <c:v>13.274399733543397</c:v>
                </c:pt>
                <c:pt idx="4815">
                  <c:v>21.230450081825254</c:v>
                </c:pt>
                <c:pt idx="4816">
                  <c:v>9.3294498825072978</c:v>
                </c:pt>
                <c:pt idx="4817">
                  <c:v>8.5720497751235989</c:v>
                </c:pt>
                <c:pt idx="4818">
                  <c:v>15.363799791336056</c:v>
                </c:pt>
                <c:pt idx="4819">
                  <c:v>9.4065997505188506</c:v>
                </c:pt>
                <c:pt idx="4820">
                  <c:v>20.277349953651395</c:v>
                </c:pt>
                <c:pt idx="4821">
                  <c:v>15.334750018119848</c:v>
                </c:pt>
                <c:pt idx="4822">
                  <c:v>21.760249681472747</c:v>
                </c:pt>
                <c:pt idx="4823">
                  <c:v>5.9636498975753511</c:v>
                </c:pt>
                <c:pt idx="4824">
                  <c:v>16.755450010299697</c:v>
                </c:pt>
                <c:pt idx="4825">
                  <c:v>6.9832497787475489</c:v>
                </c:pt>
                <c:pt idx="4826">
                  <c:v>15.910450086593649</c:v>
                </c:pt>
                <c:pt idx="4827">
                  <c:v>20.818750233650199</c:v>
                </c:pt>
                <c:pt idx="4828">
                  <c:v>4.300099995136204</c:v>
                </c:pt>
                <c:pt idx="4829">
                  <c:v>11.623949894905103</c:v>
                </c:pt>
                <c:pt idx="4830">
                  <c:v>16.865549860000598</c:v>
                </c:pt>
                <c:pt idx="4831">
                  <c:v>16.994000148773207</c:v>
                </c:pt>
                <c:pt idx="4832">
                  <c:v>21.104199914932245</c:v>
                </c:pt>
                <c:pt idx="4833">
                  <c:v>20.9567499542236</c:v>
                </c:pt>
                <c:pt idx="4834">
                  <c:v>2.2148499917984026</c:v>
                </c:pt>
                <c:pt idx="4835">
                  <c:v>9.03884982109075</c:v>
                </c:pt>
                <c:pt idx="4836">
                  <c:v>7.5813997983932992</c:v>
                </c:pt>
                <c:pt idx="4837">
                  <c:v>17.2319499874115</c:v>
                </c:pt>
                <c:pt idx="4838">
                  <c:v>12.690349969863849</c:v>
                </c:pt>
                <c:pt idx="4839">
                  <c:v>9.4039498853683483</c:v>
                </c:pt>
                <c:pt idx="4840">
                  <c:v>17.657700037956246</c:v>
                </c:pt>
                <c:pt idx="4841">
                  <c:v>14.537500033378649</c:v>
                </c:pt>
                <c:pt idx="4842">
                  <c:v>10.859449996948246</c:v>
                </c:pt>
                <c:pt idx="4843">
                  <c:v>18.157400145530694</c:v>
                </c:pt>
                <c:pt idx="4844">
                  <c:v>11.867899756431598</c:v>
                </c:pt>
                <c:pt idx="4845">
                  <c:v>6.1830998420714991</c:v>
                </c:pt>
                <c:pt idx="4846">
                  <c:v>8.787599854469299</c:v>
                </c:pt>
                <c:pt idx="4847">
                  <c:v>15.310049943923943</c:v>
                </c:pt>
                <c:pt idx="4848">
                  <c:v>18.469300093650801</c:v>
                </c:pt>
                <c:pt idx="4849">
                  <c:v>11.769999818801853</c:v>
                </c:pt>
                <c:pt idx="4850">
                  <c:v>15.5992500638962</c:v>
                </c:pt>
                <c:pt idx="4851">
                  <c:v>18.593349938392606</c:v>
                </c:pt>
                <c:pt idx="4852">
                  <c:v>7.0517997074126981</c:v>
                </c:pt>
                <c:pt idx="4853">
                  <c:v>7.0150998115539487</c:v>
                </c:pt>
                <c:pt idx="4854">
                  <c:v>18.309900159835806</c:v>
                </c:pt>
                <c:pt idx="4855">
                  <c:v>13.085649991035499</c:v>
                </c:pt>
                <c:pt idx="4856">
                  <c:v>15.247200160026551</c:v>
                </c:pt>
                <c:pt idx="4857">
                  <c:v>10.843899869918801</c:v>
                </c:pt>
                <c:pt idx="4858">
                  <c:v>12.812499847412102</c:v>
                </c:pt>
                <c:pt idx="4859">
                  <c:v>24.836199731826802</c:v>
                </c:pt>
                <c:pt idx="4860">
                  <c:v>15.151650037765549</c:v>
                </c:pt>
                <c:pt idx="4861">
                  <c:v>10.468100061416649</c:v>
                </c:pt>
                <c:pt idx="4862">
                  <c:v>19.943900165557849</c:v>
                </c:pt>
                <c:pt idx="4863">
                  <c:v>14.808750009536702</c:v>
                </c:pt>
                <c:pt idx="4864">
                  <c:v>8.3667497777939026</c:v>
                </c:pt>
                <c:pt idx="4865">
                  <c:v>19.196350245475749</c:v>
                </c:pt>
                <c:pt idx="4866">
                  <c:v>13.236900048255904</c:v>
                </c:pt>
                <c:pt idx="4867">
                  <c:v>17.114850225448546</c:v>
                </c:pt>
                <c:pt idx="4868">
                  <c:v>14.912400093078595</c:v>
                </c:pt>
                <c:pt idx="4869">
                  <c:v>15.023399910926802</c:v>
                </c:pt>
                <c:pt idx="4870">
                  <c:v>14.503449873924247</c:v>
                </c:pt>
                <c:pt idx="4871">
                  <c:v>10.301950006484951</c:v>
                </c:pt>
                <c:pt idx="4872">
                  <c:v>9.6475999450683503</c:v>
                </c:pt>
                <c:pt idx="4873">
                  <c:v>17.488649983406049</c:v>
                </c:pt>
                <c:pt idx="4874">
                  <c:v>2.464049835205099</c:v>
                </c:pt>
                <c:pt idx="4875">
                  <c:v>18.316250057220405</c:v>
                </c:pt>
                <c:pt idx="4876">
                  <c:v>16.51124998092655</c:v>
                </c:pt>
                <c:pt idx="4877">
                  <c:v>20.988799962997398</c:v>
                </c:pt>
                <c:pt idx="4878">
                  <c:v>7.7015498495101973</c:v>
                </c:pt>
                <c:pt idx="4879">
                  <c:v>13.333650040626495</c:v>
                </c:pt>
                <c:pt idx="4880">
                  <c:v>14.271949791908249</c:v>
                </c:pt>
                <c:pt idx="4881">
                  <c:v>9.0489997768402013</c:v>
                </c:pt>
                <c:pt idx="4882">
                  <c:v>16.540950117111198</c:v>
                </c:pt>
                <c:pt idx="4883">
                  <c:v>15.735600070953403</c:v>
                </c:pt>
                <c:pt idx="4884">
                  <c:v>13.173049969673148</c:v>
                </c:pt>
                <c:pt idx="4885">
                  <c:v>7.2325500345230012</c:v>
                </c:pt>
                <c:pt idx="4886">
                  <c:v>14.585550012588506</c:v>
                </c:pt>
                <c:pt idx="4887">
                  <c:v>4.5482498979568007</c:v>
                </c:pt>
                <c:pt idx="4888">
                  <c:v>19.926150021553052</c:v>
                </c:pt>
                <c:pt idx="4889">
                  <c:v>8.4290999054909008</c:v>
                </c:pt>
                <c:pt idx="4890">
                  <c:v>17.521099910736098</c:v>
                </c:pt>
                <c:pt idx="4891">
                  <c:v>10.33894980907445</c:v>
                </c:pt>
                <c:pt idx="4892">
                  <c:v>3.0255498552322493</c:v>
                </c:pt>
                <c:pt idx="4893">
                  <c:v>15.9256500673294</c:v>
                </c:pt>
                <c:pt idx="4894">
                  <c:v>11.264649705886846</c:v>
                </c:pt>
                <c:pt idx="4895">
                  <c:v>18.927549810409552</c:v>
                </c:pt>
                <c:pt idx="4896">
                  <c:v>11.365799970626849</c:v>
                </c:pt>
                <c:pt idx="4897">
                  <c:v>16.697899909019448</c:v>
                </c:pt>
                <c:pt idx="4898">
                  <c:v>16.094849925041252</c:v>
                </c:pt>
                <c:pt idx="4899">
                  <c:v>15.492900066375697</c:v>
                </c:pt>
                <c:pt idx="4900">
                  <c:v>5.978749837875398</c:v>
                </c:pt>
                <c:pt idx="4901">
                  <c:v>6.9266497945785019</c:v>
                </c:pt>
                <c:pt idx="4902">
                  <c:v>21.865100135803246</c:v>
                </c:pt>
                <c:pt idx="4903">
                  <c:v>15.996950116157549</c:v>
                </c:pt>
                <c:pt idx="4904">
                  <c:v>12.358249940872202</c:v>
                </c:pt>
                <c:pt idx="4905">
                  <c:v>13.5846000766754</c:v>
                </c:pt>
                <c:pt idx="4906">
                  <c:v>11.39439992427825</c:v>
                </c:pt>
                <c:pt idx="4907">
                  <c:v>13.989149932861352</c:v>
                </c:pt>
                <c:pt idx="4908">
                  <c:v>15.172150259017954</c:v>
                </c:pt>
                <c:pt idx="4909">
                  <c:v>9.3370998668670531</c:v>
                </c:pt>
                <c:pt idx="4910">
                  <c:v>16.027000114917797</c:v>
                </c:pt>
                <c:pt idx="4911">
                  <c:v>9.162149939537052</c:v>
                </c:pt>
                <c:pt idx="4912">
                  <c:v>11.699550089836094</c:v>
                </c:pt>
                <c:pt idx="4913">
                  <c:v>8.2209497451782525</c:v>
                </c:pt>
                <c:pt idx="4914">
                  <c:v>5.5677998828887993</c:v>
                </c:pt>
                <c:pt idx="4915">
                  <c:v>15.193399906158501</c:v>
                </c:pt>
                <c:pt idx="4916">
                  <c:v>19.975350050926199</c:v>
                </c:pt>
                <c:pt idx="4917">
                  <c:v>12.380999982357</c:v>
                </c:pt>
                <c:pt idx="4918">
                  <c:v>9.8058999824524022</c:v>
                </c:pt>
                <c:pt idx="4919">
                  <c:v>14.507099890708901</c:v>
                </c:pt>
                <c:pt idx="4920">
                  <c:v>3.9162498235702543</c:v>
                </c:pt>
                <c:pt idx="4921">
                  <c:v>14.655999984741253</c:v>
                </c:pt>
                <c:pt idx="4922">
                  <c:v>8.322349872589097</c:v>
                </c:pt>
                <c:pt idx="4923">
                  <c:v>13.198600225448601</c:v>
                </c:pt>
                <c:pt idx="4924">
                  <c:v>14.002749924659753</c:v>
                </c:pt>
                <c:pt idx="4925">
                  <c:v>35.356199741363547</c:v>
                </c:pt>
                <c:pt idx="4926">
                  <c:v>10.2034499692917</c:v>
                </c:pt>
                <c:pt idx="4927">
                  <c:v>11.92644981861115</c:v>
                </c:pt>
                <c:pt idx="4928">
                  <c:v>8.9582496738433974</c:v>
                </c:pt>
                <c:pt idx="4929">
                  <c:v>17.39740006446835</c:v>
                </c:pt>
                <c:pt idx="4930">
                  <c:v>15.462050085067752</c:v>
                </c:pt>
                <c:pt idx="4931">
                  <c:v>11.511699943542496</c:v>
                </c:pt>
                <c:pt idx="4932">
                  <c:v>20.2677501058578</c:v>
                </c:pt>
                <c:pt idx="4933">
                  <c:v>12.244549822807301</c:v>
                </c:pt>
                <c:pt idx="4934">
                  <c:v>12.093199768066405</c:v>
                </c:pt>
                <c:pt idx="4935">
                  <c:v>14.611199984550499</c:v>
                </c:pt>
                <c:pt idx="4936">
                  <c:v>33.470399761199943</c:v>
                </c:pt>
                <c:pt idx="4937">
                  <c:v>19.814850006103555</c:v>
                </c:pt>
                <c:pt idx="4938">
                  <c:v>15.279600086212152</c:v>
                </c:pt>
                <c:pt idx="4939">
                  <c:v>8.6393499279021988</c:v>
                </c:pt>
                <c:pt idx="4940">
                  <c:v>18.397600083351147</c:v>
                </c:pt>
                <c:pt idx="4941">
                  <c:v>15.539500064849847</c:v>
                </c:pt>
                <c:pt idx="4942">
                  <c:v>14.108499937057502</c:v>
                </c:pt>
                <c:pt idx="4943">
                  <c:v>24.054500002861047</c:v>
                </c:pt>
                <c:pt idx="4944">
                  <c:v>16.420399870872551</c:v>
                </c:pt>
                <c:pt idx="4945">
                  <c:v>16.636650047302201</c:v>
                </c:pt>
                <c:pt idx="4946">
                  <c:v>19.780849986076355</c:v>
                </c:pt>
                <c:pt idx="4947">
                  <c:v>15.761100101470902</c:v>
                </c:pt>
                <c:pt idx="4948">
                  <c:v>16.955850067138698</c:v>
                </c:pt>
                <c:pt idx="4949">
                  <c:v>10.271299834251401</c:v>
                </c:pt>
                <c:pt idx="4950">
                  <c:v>6.0530497694015502</c:v>
                </c:pt>
                <c:pt idx="4951">
                  <c:v>15.318450050354002</c:v>
                </c:pt>
                <c:pt idx="4952">
                  <c:v>15.519049854278542</c:v>
                </c:pt>
                <c:pt idx="4953">
                  <c:v>13.650499911308302</c:v>
                </c:pt>
                <c:pt idx="4954">
                  <c:v>7.9258997678756984</c:v>
                </c:pt>
                <c:pt idx="4955">
                  <c:v>15.490150117874144</c:v>
                </c:pt>
                <c:pt idx="4956">
                  <c:v>30.789250035285946</c:v>
                </c:pt>
                <c:pt idx="4957">
                  <c:v>17.663700079917902</c:v>
                </c:pt>
                <c:pt idx="4958">
                  <c:v>13.840749859809897</c:v>
                </c:pt>
                <c:pt idx="4959">
                  <c:v>11.150000038146956</c:v>
                </c:pt>
                <c:pt idx="4960">
                  <c:v>8.771649694442754</c:v>
                </c:pt>
                <c:pt idx="4961">
                  <c:v>17.1007001209259</c:v>
                </c:pt>
                <c:pt idx="4962">
                  <c:v>8.8699998521804986</c:v>
                </c:pt>
                <c:pt idx="4963">
                  <c:v>8.7821496534347503</c:v>
                </c:pt>
                <c:pt idx="4964">
                  <c:v>12.754649872779797</c:v>
                </c:pt>
                <c:pt idx="4965">
                  <c:v>6.3323497629165999</c:v>
                </c:pt>
                <c:pt idx="4966">
                  <c:v>16.435599894523602</c:v>
                </c:pt>
                <c:pt idx="4967">
                  <c:v>14.381199784278898</c:v>
                </c:pt>
                <c:pt idx="4968">
                  <c:v>14.5917500209808</c:v>
                </c:pt>
                <c:pt idx="4969">
                  <c:v>8.4297498226165999</c:v>
                </c:pt>
                <c:pt idx="4970">
                  <c:v>13.328349876403855</c:v>
                </c:pt>
                <c:pt idx="4971">
                  <c:v>20.726050124168399</c:v>
                </c:pt>
                <c:pt idx="4972">
                  <c:v>13.648399844169596</c:v>
                </c:pt>
                <c:pt idx="4973">
                  <c:v>7.001349773407</c:v>
                </c:pt>
                <c:pt idx="4974">
                  <c:v>8.3457827800692996</c:v>
                </c:pt>
                <c:pt idx="4975">
                  <c:v>9.0247997331619523</c:v>
                </c:pt>
                <c:pt idx="4976">
                  <c:v>16.11815006256105</c:v>
                </c:pt>
                <c:pt idx="4977">
                  <c:v>7.8188997745513973</c:v>
                </c:pt>
                <c:pt idx="4978">
                  <c:v>9.2786498618125961</c:v>
                </c:pt>
                <c:pt idx="4979">
                  <c:v>14.421700115203848</c:v>
                </c:pt>
                <c:pt idx="4980">
                  <c:v>12.207650051116946</c:v>
                </c:pt>
                <c:pt idx="4981">
                  <c:v>20.518349981308003</c:v>
                </c:pt>
                <c:pt idx="4982">
                  <c:v>12.142199754715001</c:v>
                </c:pt>
                <c:pt idx="4983">
                  <c:v>16.357450032234201</c:v>
                </c:pt>
                <c:pt idx="4984">
                  <c:v>-9.5272499823570129</c:v>
                </c:pt>
                <c:pt idx="4985">
                  <c:v>11.700350074768096</c:v>
                </c:pt>
                <c:pt idx="4986">
                  <c:v>12.546250038146955</c:v>
                </c:pt>
                <c:pt idx="4987">
                  <c:v>8.1348998212814507</c:v>
                </c:pt>
                <c:pt idx="4988">
                  <c:v>13.204800252914445</c:v>
                </c:pt>
                <c:pt idx="4989">
                  <c:v>10.218149876594548</c:v>
                </c:pt>
                <c:pt idx="4990">
                  <c:v>15.67720002651215</c:v>
                </c:pt>
                <c:pt idx="4991">
                  <c:v>17.184600114822402</c:v>
                </c:pt>
                <c:pt idx="4992">
                  <c:v>9.4485997962951522</c:v>
                </c:pt>
                <c:pt idx="4993">
                  <c:v>13.879049878120405</c:v>
                </c:pt>
                <c:pt idx="4994">
                  <c:v>16.872299842834501</c:v>
                </c:pt>
                <c:pt idx="4995">
                  <c:v>13.77560010433205</c:v>
                </c:pt>
                <c:pt idx="4996">
                  <c:v>4.7415498733520494</c:v>
                </c:pt>
                <c:pt idx="4997">
                  <c:v>10.077549958229049</c:v>
                </c:pt>
                <c:pt idx="4998">
                  <c:v>6.9532498073577997</c:v>
                </c:pt>
                <c:pt idx="4999">
                  <c:v>17.52655015468595</c:v>
                </c:pt>
                <c:pt idx="5000">
                  <c:v>9.377999863624602</c:v>
                </c:pt>
                <c:pt idx="5001">
                  <c:v>16.439050087928749</c:v>
                </c:pt>
                <c:pt idx="5002">
                  <c:v>13.897599983215301</c:v>
                </c:pt>
                <c:pt idx="5003">
                  <c:v>14.856799869537355</c:v>
                </c:pt>
                <c:pt idx="5004">
                  <c:v>18.88330008029935</c:v>
                </c:pt>
                <c:pt idx="5005">
                  <c:v>12.647699906826055</c:v>
                </c:pt>
                <c:pt idx="5006">
                  <c:v>9.0829498863220515</c:v>
                </c:pt>
                <c:pt idx="5007">
                  <c:v>19.269650249481199</c:v>
                </c:pt>
                <c:pt idx="5008">
                  <c:v>15.286799931526204</c:v>
                </c:pt>
                <c:pt idx="5009">
                  <c:v>10.268599886894251</c:v>
                </c:pt>
                <c:pt idx="5010">
                  <c:v>14.18279997348785</c:v>
                </c:pt>
                <c:pt idx="5011">
                  <c:v>17.140299987793</c:v>
                </c:pt>
                <c:pt idx="5012">
                  <c:v>19.070200071334803</c:v>
                </c:pt>
                <c:pt idx="5013">
                  <c:v>12.826850032806398</c:v>
                </c:pt>
                <c:pt idx="5014">
                  <c:v>13.067749905586247</c:v>
                </c:pt>
                <c:pt idx="5015">
                  <c:v>11.325299973487851</c:v>
                </c:pt>
                <c:pt idx="5016">
                  <c:v>15.795100016593949</c:v>
                </c:pt>
                <c:pt idx="5017">
                  <c:v>11.851000075340252</c:v>
                </c:pt>
                <c:pt idx="5018">
                  <c:v>3.0063498735428027</c:v>
                </c:pt>
                <c:pt idx="5019">
                  <c:v>5.0829996442794965</c:v>
                </c:pt>
                <c:pt idx="5020">
                  <c:v>8.883599939346297</c:v>
                </c:pt>
                <c:pt idx="5021">
                  <c:v>14.203549876213053</c:v>
                </c:pt>
                <c:pt idx="5022">
                  <c:v>7.1678997707366996</c:v>
                </c:pt>
                <c:pt idx="5023">
                  <c:v>10.614849734306301</c:v>
                </c:pt>
                <c:pt idx="5024">
                  <c:v>17.009199943542448</c:v>
                </c:pt>
                <c:pt idx="5025">
                  <c:v>13.489699978828398</c:v>
                </c:pt>
                <c:pt idx="5026">
                  <c:v>11.710850234031646</c:v>
                </c:pt>
                <c:pt idx="5027">
                  <c:v>12.424349875450098</c:v>
                </c:pt>
                <c:pt idx="5028">
                  <c:v>10.524550027847301</c:v>
                </c:pt>
                <c:pt idx="5029">
                  <c:v>21.483499956131006</c:v>
                </c:pt>
                <c:pt idx="5030">
                  <c:v>13.5428497982025</c:v>
                </c:pt>
                <c:pt idx="5031">
                  <c:v>12.769349880218503</c:v>
                </c:pt>
                <c:pt idx="5032">
                  <c:v>12.294200162887599</c:v>
                </c:pt>
                <c:pt idx="5033">
                  <c:v>12.003749814033505</c:v>
                </c:pt>
                <c:pt idx="5034">
                  <c:v>7.8826997709274487</c:v>
                </c:pt>
                <c:pt idx="5035">
                  <c:v>20.5651499605179</c:v>
                </c:pt>
                <c:pt idx="5036">
                  <c:v>11.208149991035402</c:v>
                </c:pt>
                <c:pt idx="5037">
                  <c:v>16.363899865150451</c:v>
                </c:pt>
                <c:pt idx="5038">
                  <c:v>16.459000015258802</c:v>
                </c:pt>
                <c:pt idx="5039">
                  <c:v>18.537449755668653</c:v>
                </c:pt>
                <c:pt idx="5040">
                  <c:v>11.894099966883653</c:v>
                </c:pt>
                <c:pt idx="5041">
                  <c:v>11.894099966883653</c:v>
                </c:pt>
                <c:pt idx="5042">
                  <c:v>111.40109967231746</c:v>
                </c:pt>
                <c:pt idx="5043">
                  <c:v>14.222099928855901</c:v>
                </c:pt>
                <c:pt idx="5044">
                  <c:v>19.008100121021304</c:v>
                </c:pt>
                <c:pt idx="5045">
                  <c:v>28.628849401474</c:v>
                </c:pt>
                <c:pt idx="5046">
                  <c:v>4.9772497749329006</c:v>
                </c:pt>
                <c:pt idx="5047">
                  <c:v>12.953849883079599</c:v>
                </c:pt>
                <c:pt idx="5048">
                  <c:v>5.153949790000901</c:v>
                </c:pt>
                <c:pt idx="5049">
                  <c:v>14.97075001716615</c:v>
                </c:pt>
                <c:pt idx="5050">
                  <c:v>4.0142996835708011</c:v>
                </c:pt>
                <c:pt idx="5051">
                  <c:v>18.366850066184995</c:v>
                </c:pt>
                <c:pt idx="5052">
                  <c:v>16.301750144958454</c:v>
                </c:pt>
                <c:pt idx="5053">
                  <c:v>14.563699982166348</c:v>
                </c:pt>
                <c:pt idx="5054">
                  <c:v>5.9891997241973485</c:v>
                </c:pt>
                <c:pt idx="5055">
                  <c:v>13.453400096893301</c:v>
                </c:pt>
                <c:pt idx="5056">
                  <c:v>6.7663997936248492</c:v>
                </c:pt>
                <c:pt idx="5057">
                  <c:v>8.0484997606277489</c:v>
                </c:pt>
                <c:pt idx="5058">
                  <c:v>18.131300163268996</c:v>
                </c:pt>
                <c:pt idx="5059">
                  <c:v>21.184549870491004</c:v>
                </c:pt>
                <c:pt idx="5060">
                  <c:v>6.0671998953818971</c:v>
                </c:pt>
                <c:pt idx="5061">
                  <c:v>18.835599985122698</c:v>
                </c:pt>
                <c:pt idx="5062">
                  <c:v>11.322749872207648</c:v>
                </c:pt>
                <c:pt idx="5063">
                  <c:v>13.044349937438948</c:v>
                </c:pt>
                <c:pt idx="5064">
                  <c:v>14.546800098419201</c:v>
                </c:pt>
                <c:pt idx="5065">
                  <c:v>11.876949920654297</c:v>
                </c:pt>
                <c:pt idx="5066">
                  <c:v>11.589750080108651</c:v>
                </c:pt>
                <c:pt idx="5067">
                  <c:v>7.0793996667862515</c:v>
                </c:pt>
                <c:pt idx="5068">
                  <c:v>8.0921999073028488</c:v>
                </c:pt>
                <c:pt idx="5069">
                  <c:v>15.530299882888755</c:v>
                </c:pt>
                <c:pt idx="5070">
                  <c:v>18.7045501255989</c:v>
                </c:pt>
                <c:pt idx="5071">
                  <c:v>13.658399796485902</c:v>
                </c:pt>
                <c:pt idx="5072">
                  <c:v>16.48639998435975</c:v>
                </c:pt>
                <c:pt idx="5073">
                  <c:v>13.720149846077</c:v>
                </c:pt>
                <c:pt idx="5074">
                  <c:v>13.325400032997152</c:v>
                </c:pt>
                <c:pt idx="5075">
                  <c:v>3.8758998155594</c:v>
                </c:pt>
                <c:pt idx="5076">
                  <c:v>16.216050014495849</c:v>
                </c:pt>
                <c:pt idx="5077">
                  <c:v>13.742449917793248</c:v>
                </c:pt>
                <c:pt idx="5078">
                  <c:v>11.412949838638305</c:v>
                </c:pt>
                <c:pt idx="5079">
                  <c:v>13.390299816131598</c:v>
                </c:pt>
                <c:pt idx="5080">
                  <c:v>19.060350065231344</c:v>
                </c:pt>
                <c:pt idx="5081">
                  <c:v>8.3872497892379982</c:v>
                </c:pt>
                <c:pt idx="5082">
                  <c:v>12.62685004234315</c:v>
                </c:pt>
                <c:pt idx="5083">
                  <c:v>12.648000059127803</c:v>
                </c:pt>
                <c:pt idx="5084">
                  <c:v>20.303100094795251</c:v>
                </c:pt>
                <c:pt idx="5085">
                  <c:v>18.602749900817855</c:v>
                </c:pt>
                <c:pt idx="5086">
                  <c:v>12.396399896144899</c:v>
                </c:pt>
                <c:pt idx="5087">
                  <c:v>18.424350066184999</c:v>
                </c:pt>
                <c:pt idx="5088">
                  <c:v>6.7149997138977007</c:v>
                </c:pt>
                <c:pt idx="5089">
                  <c:v>9.0174999213218996</c:v>
                </c:pt>
                <c:pt idx="5090">
                  <c:v>17.732500181198102</c:v>
                </c:pt>
                <c:pt idx="5091">
                  <c:v>12.580449991226146</c:v>
                </c:pt>
                <c:pt idx="5092">
                  <c:v>20.317899889945995</c:v>
                </c:pt>
                <c:pt idx="5093">
                  <c:v>11.303650045394903</c:v>
                </c:pt>
                <c:pt idx="5094">
                  <c:v>9.5600997924804503</c:v>
                </c:pt>
                <c:pt idx="5095">
                  <c:v>5.2307999801635958</c:v>
                </c:pt>
                <c:pt idx="5096">
                  <c:v>15.071399712562553</c:v>
                </c:pt>
                <c:pt idx="5097">
                  <c:v>17.371100015640248</c:v>
                </c:pt>
                <c:pt idx="5098">
                  <c:v>17.946750216484052</c:v>
                </c:pt>
                <c:pt idx="5099">
                  <c:v>7.3824499130248995</c:v>
                </c:pt>
                <c:pt idx="5100">
                  <c:v>14.211099996566801</c:v>
                </c:pt>
                <c:pt idx="5101">
                  <c:v>14.275050129890449</c:v>
                </c:pt>
                <c:pt idx="5102">
                  <c:v>17.440600185394253</c:v>
                </c:pt>
                <c:pt idx="5103">
                  <c:v>6.3874998712539508</c:v>
                </c:pt>
                <c:pt idx="5104">
                  <c:v>12.500699768066401</c:v>
                </c:pt>
                <c:pt idx="5105">
                  <c:v>12.338499951362596</c:v>
                </c:pt>
                <c:pt idx="5106">
                  <c:v>4.4732497787475509</c:v>
                </c:pt>
                <c:pt idx="5107">
                  <c:v>13.694999876022301</c:v>
                </c:pt>
                <c:pt idx="5108">
                  <c:v>5.9534999465942491</c:v>
                </c:pt>
                <c:pt idx="5109">
                  <c:v>6.4782498311996513</c:v>
                </c:pt>
                <c:pt idx="5110">
                  <c:v>17.378400011062602</c:v>
                </c:pt>
                <c:pt idx="5111">
                  <c:v>8.5275999784470002</c:v>
                </c:pt>
                <c:pt idx="5112">
                  <c:v>13.683699879646252</c:v>
                </c:pt>
                <c:pt idx="5113">
                  <c:v>3.6059998464584524</c:v>
                </c:pt>
                <c:pt idx="5114">
                  <c:v>18.944050030708251</c:v>
                </c:pt>
                <c:pt idx="5115">
                  <c:v>8.9751500129700013</c:v>
                </c:pt>
                <c:pt idx="5116">
                  <c:v>18.64509994029995</c:v>
                </c:pt>
                <c:pt idx="5117">
                  <c:v>9.7337497210502484</c:v>
                </c:pt>
                <c:pt idx="5118">
                  <c:v>16.3215501642227</c:v>
                </c:pt>
                <c:pt idx="5119">
                  <c:v>7.0130497932434039</c:v>
                </c:pt>
                <c:pt idx="5120">
                  <c:v>7.8514496755600014</c:v>
                </c:pt>
                <c:pt idx="5121">
                  <c:v>8.0053999853134528</c:v>
                </c:pt>
                <c:pt idx="5122">
                  <c:v>10.376899919509849</c:v>
                </c:pt>
                <c:pt idx="5123">
                  <c:v>9.5505997467041013</c:v>
                </c:pt>
                <c:pt idx="5124">
                  <c:v>7.5101998233795442</c:v>
                </c:pt>
                <c:pt idx="5125">
                  <c:v>17.299849901199305</c:v>
                </c:pt>
                <c:pt idx="5126">
                  <c:v>9.9578497076034509</c:v>
                </c:pt>
                <c:pt idx="5127">
                  <c:v>11.344099879264849</c:v>
                </c:pt>
                <c:pt idx="5128">
                  <c:v>16.191300125122105</c:v>
                </c:pt>
                <c:pt idx="5129">
                  <c:v>15.582900061607351</c:v>
                </c:pt>
                <c:pt idx="5130">
                  <c:v>6.5683498907089479</c:v>
                </c:pt>
                <c:pt idx="5131">
                  <c:v>10.831699833869898</c:v>
                </c:pt>
                <c:pt idx="5132">
                  <c:v>12.507399916648851</c:v>
                </c:pt>
                <c:pt idx="5133">
                  <c:v>17.092400083541904</c:v>
                </c:pt>
                <c:pt idx="5134">
                  <c:v>18.14915018558505</c:v>
                </c:pt>
                <c:pt idx="5135">
                  <c:v>13.383200068473752</c:v>
                </c:pt>
                <c:pt idx="5136">
                  <c:v>15.682600188255357</c:v>
                </c:pt>
                <c:pt idx="5137">
                  <c:v>13.327000226974452</c:v>
                </c:pt>
                <c:pt idx="5138">
                  <c:v>10.610199975967397</c:v>
                </c:pt>
                <c:pt idx="5139">
                  <c:v>15.6207500886917</c:v>
                </c:pt>
                <c:pt idx="5140">
                  <c:v>16.389450039863554</c:v>
                </c:pt>
                <c:pt idx="5141">
                  <c:v>13.061649808883651</c:v>
                </c:pt>
                <c:pt idx="5142">
                  <c:v>16.827249860763548</c:v>
                </c:pt>
                <c:pt idx="5143">
                  <c:v>16.130049967765743</c:v>
                </c:pt>
                <c:pt idx="5144">
                  <c:v>5.200349891185752</c:v>
                </c:pt>
                <c:pt idx="5145">
                  <c:v>22.834599742889395</c:v>
                </c:pt>
                <c:pt idx="5146">
                  <c:v>21.351050171852098</c:v>
                </c:pt>
                <c:pt idx="5147">
                  <c:v>10.1765498209</c:v>
                </c:pt>
                <c:pt idx="5148">
                  <c:v>15.074749956130994</c:v>
                </c:pt>
                <c:pt idx="5149">
                  <c:v>4.595749626159698</c:v>
                </c:pt>
                <c:pt idx="5150">
                  <c:v>6.2009997987747489</c:v>
                </c:pt>
                <c:pt idx="5151">
                  <c:v>15.89079989910125</c:v>
                </c:pt>
                <c:pt idx="5152">
                  <c:v>11.936699919700601</c:v>
                </c:pt>
                <c:pt idx="5153">
                  <c:v>16.493399939537049</c:v>
                </c:pt>
                <c:pt idx="5154">
                  <c:v>18.6627998542786</c:v>
                </c:pt>
                <c:pt idx="5155">
                  <c:v>18.383549704551697</c:v>
                </c:pt>
                <c:pt idx="5156">
                  <c:v>13.221949820518496</c:v>
                </c:pt>
                <c:pt idx="5157">
                  <c:v>15.679100031852748</c:v>
                </c:pt>
                <c:pt idx="5158">
                  <c:v>10.0463998556137</c:v>
                </c:pt>
                <c:pt idx="5159">
                  <c:v>6.1581998109816993</c:v>
                </c:pt>
                <c:pt idx="5160">
                  <c:v>6.7623998165130494</c:v>
                </c:pt>
                <c:pt idx="5161">
                  <c:v>14.178550033569351</c:v>
                </c:pt>
                <c:pt idx="5162">
                  <c:v>19.663950133323649</c:v>
                </c:pt>
                <c:pt idx="5163">
                  <c:v>11.392549796104447</c:v>
                </c:pt>
                <c:pt idx="5164">
                  <c:v>9.3784498500824007</c:v>
                </c:pt>
                <c:pt idx="5165">
                  <c:v>16.73060009479525</c:v>
                </c:pt>
                <c:pt idx="5166">
                  <c:v>18.128300018310547</c:v>
                </c:pt>
                <c:pt idx="5167">
                  <c:v>13.456549859046898</c:v>
                </c:pt>
                <c:pt idx="5168">
                  <c:v>9.9842999029159571</c:v>
                </c:pt>
                <c:pt idx="5169">
                  <c:v>3.9909997415542513</c:v>
                </c:pt>
                <c:pt idx="5170">
                  <c:v>8.6792997837066466</c:v>
                </c:pt>
                <c:pt idx="5171">
                  <c:v>7.0003499364852999</c:v>
                </c:pt>
                <c:pt idx="5172">
                  <c:v>3.7842997550964519</c:v>
                </c:pt>
                <c:pt idx="5173">
                  <c:v>16.28864987850185</c:v>
                </c:pt>
                <c:pt idx="5174">
                  <c:v>11.507299790382351</c:v>
                </c:pt>
                <c:pt idx="5175">
                  <c:v>9.2424998378754033</c:v>
                </c:pt>
                <c:pt idx="5176">
                  <c:v>13.766649913787806</c:v>
                </c:pt>
                <c:pt idx="5177">
                  <c:v>2.7929498815536498</c:v>
                </c:pt>
                <c:pt idx="5178">
                  <c:v>10.30954987049105</c:v>
                </c:pt>
                <c:pt idx="5179">
                  <c:v>12.832499876022347</c:v>
                </c:pt>
                <c:pt idx="5180">
                  <c:v>10.463349876403754</c:v>
                </c:pt>
                <c:pt idx="5181">
                  <c:v>14.259999890327446</c:v>
                </c:pt>
                <c:pt idx="5182">
                  <c:v>6.9822998332977484</c:v>
                </c:pt>
                <c:pt idx="5183">
                  <c:v>14.115149922370904</c:v>
                </c:pt>
                <c:pt idx="5184">
                  <c:v>6.4818498373031517</c:v>
                </c:pt>
                <c:pt idx="5185">
                  <c:v>27.239149780273397</c:v>
                </c:pt>
                <c:pt idx="5186">
                  <c:v>9.4456497430801498</c:v>
                </c:pt>
                <c:pt idx="5187">
                  <c:v>7.5887998986244476</c:v>
                </c:pt>
                <c:pt idx="5188">
                  <c:v>9.4950997638702006</c:v>
                </c:pt>
                <c:pt idx="5189">
                  <c:v>15.9276499414444</c:v>
                </c:pt>
                <c:pt idx="5190">
                  <c:v>12.362549819946299</c:v>
                </c:pt>
                <c:pt idx="5191">
                  <c:v>6.4546497011185018</c:v>
                </c:pt>
                <c:pt idx="5192">
                  <c:v>14.203099946975698</c:v>
                </c:pt>
                <c:pt idx="5193">
                  <c:v>12.14964993476865</c:v>
                </c:pt>
                <c:pt idx="5194">
                  <c:v>10.326149983406101</c:v>
                </c:pt>
                <c:pt idx="5195">
                  <c:v>9.7686999034881481</c:v>
                </c:pt>
                <c:pt idx="5196">
                  <c:v>9.1063996887206997</c:v>
                </c:pt>
                <c:pt idx="5197">
                  <c:v>10.226949930191047</c:v>
                </c:pt>
                <c:pt idx="5198">
                  <c:v>14.007499856948904</c:v>
                </c:pt>
                <c:pt idx="5199">
                  <c:v>10.99169978141785</c:v>
                </c:pt>
                <c:pt idx="5200">
                  <c:v>6.2173497676849472</c:v>
                </c:pt>
                <c:pt idx="5201">
                  <c:v>6.038049802780197</c:v>
                </c:pt>
                <c:pt idx="5202">
                  <c:v>12.510450015067999</c:v>
                </c:pt>
                <c:pt idx="5203">
                  <c:v>7.8700497531891003</c:v>
                </c:pt>
                <c:pt idx="5204">
                  <c:v>12.014600024223299</c:v>
                </c:pt>
                <c:pt idx="5205">
                  <c:v>15.569449896812401</c:v>
                </c:pt>
                <c:pt idx="5206">
                  <c:v>5.7921499586105512</c:v>
                </c:pt>
                <c:pt idx="5207">
                  <c:v>6.0782497692107498</c:v>
                </c:pt>
                <c:pt idx="5208">
                  <c:v>6.9976997518539505</c:v>
                </c:pt>
                <c:pt idx="5209">
                  <c:v>7.2589497637749005</c:v>
                </c:pt>
                <c:pt idx="5210">
                  <c:v>8.4907498025894483</c:v>
                </c:pt>
                <c:pt idx="5211">
                  <c:v>1.1508000326157024</c:v>
                </c:pt>
                <c:pt idx="5212">
                  <c:v>8.2923499965667524</c:v>
                </c:pt>
                <c:pt idx="5213">
                  <c:v>5.8777997136115978</c:v>
                </c:pt>
                <c:pt idx="5214">
                  <c:v>13.15614991664885</c:v>
                </c:pt>
                <c:pt idx="5215">
                  <c:v>15.401699929237346</c:v>
                </c:pt>
                <c:pt idx="5216">
                  <c:v>9.6089499902725564</c:v>
                </c:pt>
                <c:pt idx="5217">
                  <c:v>13.307550044059752</c:v>
                </c:pt>
                <c:pt idx="5218">
                  <c:v>-7.5790999865531496</c:v>
                </c:pt>
                <c:pt idx="5219">
                  <c:v>21.915800004005455</c:v>
                </c:pt>
                <c:pt idx="5220">
                  <c:v>10.40429981231685</c:v>
                </c:pt>
                <c:pt idx="5221">
                  <c:v>14.560599989891049</c:v>
                </c:pt>
                <c:pt idx="5222">
                  <c:v>19.80250009059905</c:v>
                </c:pt>
                <c:pt idx="5223">
                  <c:v>8.2317497014999539</c:v>
                </c:pt>
                <c:pt idx="5224">
                  <c:v>9.6772996187210012</c:v>
                </c:pt>
                <c:pt idx="5225">
                  <c:v>17.953550028800944</c:v>
                </c:pt>
                <c:pt idx="5226">
                  <c:v>10.200599999427798</c:v>
                </c:pt>
                <c:pt idx="5227">
                  <c:v>9.9340998697280973</c:v>
                </c:pt>
                <c:pt idx="5228">
                  <c:v>7.965449848175048</c:v>
                </c:pt>
                <c:pt idx="5229">
                  <c:v>9.2263997602463022</c:v>
                </c:pt>
                <c:pt idx="5230">
                  <c:v>11.746349925994849</c:v>
                </c:pt>
                <c:pt idx="5231">
                  <c:v>13.9433999490738</c:v>
                </c:pt>
                <c:pt idx="5232">
                  <c:v>13.356199889182999</c:v>
                </c:pt>
                <c:pt idx="5233">
                  <c:v>8.4738499784469994</c:v>
                </c:pt>
                <c:pt idx="5234">
                  <c:v>13.393449840545653</c:v>
                </c:pt>
                <c:pt idx="5235">
                  <c:v>15.646749687194799</c:v>
                </c:pt>
                <c:pt idx="5236">
                  <c:v>15.166249938011152</c:v>
                </c:pt>
                <c:pt idx="5237">
                  <c:v>19.287499928474453</c:v>
                </c:pt>
                <c:pt idx="5238">
                  <c:v>12.287599887847904</c:v>
                </c:pt>
                <c:pt idx="5239">
                  <c:v>8.0967000055313036</c:v>
                </c:pt>
                <c:pt idx="5240">
                  <c:v>12.6335498476029</c:v>
                </c:pt>
                <c:pt idx="5241">
                  <c:v>7.0978999042510971</c:v>
                </c:pt>
                <c:pt idx="5242">
                  <c:v>7.3435998058319036</c:v>
                </c:pt>
                <c:pt idx="5243">
                  <c:v>14.217599987983746</c:v>
                </c:pt>
                <c:pt idx="5244">
                  <c:v>14.367799968719403</c:v>
                </c:pt>
                <c:pt idx="5245">
                  <c:v>12.377299885749807</c:v>
                </c:pt>
                <c:pt idx="5246">
                  <c:v>13.263899955749448</c:v>
                </c:pt>
                <c:pt idx="5247">
                  <c:v>13.547749934196499</c:v>
                </c:pt>
                <c:pt idx="5248">
                  <c:v>7.7010498857498</c:v>
                </c:pt>
                <c:pt idx="5249">
                  <c:v>6.8306999158859512</c:v>
                </c:pt>
                <c:pt idx="5250">
                  <c:v>11.896999897956796</c:v>
                </c:pt>
                <c:pt idx="5251">
                  <c:v>6.9402497816086033</c:v>
                </c:pt>
                <c:pt idx="5252">
                  <c:v>8.6721997451782009</c:v>
                </c:pt>
                <c:pt idx="5253">
                  <c:v>15.671349759101897</c:v>
                </c:pt>
                <c:pt idx="5254">
                  <c:v>12.1227498483658</c:v>
                </c:pt>
                <c:pt idx="5255">
                  <c:v>6.4700497579574474</c:v>
                </c:pt>
                <c:pt idx="5256">
                  <c:v>11.716350021362345</c:v>
                </c:pt>
                <c:pt idx="5257">
                  <c:v>6.0011997556686509</c:v>
                </c:pt>
                <c:pt idx="5258">
                  <c:v>8.281349780559502</c:v>
                </c:pt>
                <c:pt idx="5259">
                  <c:v>7.2094497346878015</c:v>
                </c:pt>
                <c:pt idx="5260">
                  <c:v>11.098299803733802</c:v>
                </c:pt>
                <c:pt idx="5261">
                  <c:v>16.438350148200996</c:v>
                </c:pt>
                <c:pt idx="5262">
                  <c:v>10.725749926567101</c:v>
                </c:pt>
                <c:pt idx="5263">
                  <c:v>11.065200157165499</c:v>
                </c:pt>
                <c:pt idx="5264">
                  <c:v>10.217149887084954</c:v>
                </c:pt>
                <c:pt idx="5265">
                  <c:v>10.98305005073545</c:v>
                </c:pt>
                <c:pt idx="5266">
                  <c:v>19.342249946594258</c:v>
                </c:pt>
                <c:pt idx="5267">
                  <c:v>19.227700304985053</c:v>
                </c:pt>
                <c:pt idx="5268">
                  <c:v>16.3022502183914</c:v>
                </c:pt>
                <c:pt idx="5269">
                  <c:v>5.930499653816252</c:v>
                </c:pt>
                <c:pt idx="5270">
                  <c:v>9.5296998929977512</c:v>
                </c:pt>
                <c:pt idx="5271">
                  <c:v>5.7705998754501024</c:v>
                </c:pt>
                <c:pt idx="5272">
                  <c:v>17.158300113677953</c:v>
                </c:pt>
                <c:pt idx="5273">
                  <c:v>18.562049918174743</c:v>
                </c:pt>
                <c:pt idx="5274">
                  <c:v>13.944249897003154</c:v>
                </c:pt>
                <c:pt idx="5275">
                  <c:v>14.378749942779542</c:v>
                </c:pt>
                <c:pt idx="5276">
                  <c:v>17.699400219917298</c:v>
                </c:pt>
                <c:pt idx="5277">
                  <c:v>18.4555000972748</c:v>
                </c:pt>
                <c:pt idx="5278">
                  <c:v>7.3432998657227024</c:v>
                </c:pt>
                <c:pt idx="5279">
                  <c:v>14.962750015258806</c:v>
                </c:pt>
                <c:pt idx="5280">
                  <c:v>14.429950075149549</c:v>
                </c:pt>
                <c:pt idx="5281">
                  <c:v>17.000949954986599</c:v>
                </c:pt>
                <c:pt idx="5282">
                  <c:v>13.343349885940551</c:v>
                </c:pt>
                <c:pt idx="5283">
                  <c:v>13.561749930381801</c:v>
                </c:pt>
                <c:pt idx="5284">
                  <c:v>8.4105998086929503</c:v>
                </c:pt>
                <c:pt idx="5285">
                  <c:v>6.4325998878478963</c:v>
                </c:pt>
                <c:pt idx="5286">
                  <c:v>7.1389498186110991</c:v>
                </c:pt>
                <c:pt idx="5287">
                  <c:v>14.914649963378949</c:v>
                </c:pt>
                <c:pt idx="5288">
                  <c:v>16.252999939918499</c:v>
                </c:pt>
                <c:pt idx="5289">
                  <c:v>9.654949631690954</c:v>
                </c:pt>
                <c:pt idx="5290">
                  <c:v>16.473750119209249</c:v>
                </c:pt>
                <c:pt idx="5291">
                  <c:v>8.7380997943878498</c:v>
                </c:pt>
                <c:pt idx="5292">
                  <c:v>18.298250207901003</c:v>
                </c:pt>
                <c:pt idx="5293">
                  <c:v>8.559349913597103</c:v>
                </c:pt>
                <c:pt idx="5294">
                  <c:v>11.93069981098175</c:v>
                </c:pt>
                <c:pt idx="5295">
                  <c:v>9.9162998104095514</c:v>
                </c:pt>
                <c:pt idx="5296">
                  <c:v>12.935550079345745</c:v>
                </c:pt>
                <c:pt idx="5297">
                  <c:v>7.4183998513221994</c:v>
                </c:pt>
                <c:pt idx="5298">
                  <c:v>19.700750126838649</c:v>
                </c:pt>
                <c:pt idx="5299">
                  <c:v>9.1085998916625996</c:v>
                </c:pt>
                <c:pt idx="5300">
                  <c:v>12.102149930000348</c:v>
                </c:pt>
                <c:pt idx="5301">
                  <c:v>18.868450212478649</c:v>
                </c:pt>
                <c:pt idx="5302">
                  <c:v>13.011800041198754</c:v>
                </c:pt>
                <c:pt idx="5303">
                  <c:v>14.479499707222004</c:v>
                </c:pt>
                <c:pt idx="5304">
                  <c:v>6.2269497823715518</c:v>
                </c:pt>
                <c:pt idx="5305">
                  <c:v>6.1402496671676481</c:v>
                </c:pt>
                <c:pt idx="5306">
                  <c:v>20.737550144195495</c:v>
                </c:pt>
                <c:pt idx="5307">
                  <c:v>13.724799866676356</c:v>
                </c:pt>
                <c:pt idx="5308">
                  <c:v>14.833250126838646</c:v>
                </c:pt>
                <c:pt idx="5309">
                  <c:v>3.8418497276306027</c:v>
                </c:pt>
                <c:pt idx="5310">
                  <c:v>10.446299929618853</c:v>
                </c:pt>
                <c:pt idx="5311">
                  <c:v>6.6342998170852496</c:v>
                </c:pt>
                <c:pt idx="5312">
                  <c:v>4.5365998077393002</c:v>
                </c:pt>
                <c:pt idx="5313">
                  <c:v>5.0305497217178008</c:v>
                </c:pt>
                <c:pt idx="5314">
                  <c:v>5.6833497333526992</c:v>
                </c:pt>
                <c:pt idx="5315">
                  <c:v>21.61160002708435</c:v>
                </c:pt>
                <c:pt idx="5316">
                  <c:v>8.4650500154495489</c:v>
                </c:pt>
                <c:pt idx="5317">
                  <c:v>7.4831499195098523</c:v>
                </c:pt>
                <c:pt idx="5318">
                  <c:v>5.0460498332977011</c:v>
                </c:pt>
                <c:pt idx="5319">
                  <c:v>153.90379999637611</c:v>
                </c:pt>
                <c:pt idx="5320">
                  <c:v>30.655599546432502</c:v>
                </c:pt>
                <c:pt idx="5321">
                  <c:v>15.777150092124998</c:v>
                </c:pt>
                <c:pt idx="5322">
                  <c:v>7.0588496923446513</c:v>
                </c:pt>
                <c:pt idx="5323">
                  <c:v>23.461449995040894</c:v>
                </c:pt>
                <c:pt idx="5324">
                  <c:v>20.601450142860401</c:v>
                </c:pt>
                <c:pt idx="5325">
                  <c:v>11.665549926757794</c:v>
                </c:pt>
                <c:pt idx="5326">
                  <c:v>20.161049976348902</c:v>
                </c:pt>
                <c:pt idx="5327">
                  <c:v>4.2470498704910469</c:v>
                </c:pt>
                <c:pt idx="5328">
                  <c:v>8.2232998275756977</c:v>
                </c:pt>
                <c:pt idx="5329">
                  <c:v>14.048949904441848</c:v>
                </c:pt>
                <c:pt idx="5330">
                  <c:v>17.396500015258802</c:v>
                </c:pt>
                <c:pt idx="5331">
                  <c:v>5.9357998895645494</c:v>
                </c:pt>
                <c:pt idx="5332">
                  <c:v>18.970250296592749</c:v>
                </c:pt>
                <c:pt idx="5333">
                  <c:v>9.9086497783660512</c:v>
                </c:pt>
                <c:pt idx="5334">
                  <c:v>5.9644997787475482</c:v>
                </c:pt>
                <c:pt idx="5335">
                  <c:v>11.901049861907897</c:v>
                </c:pt>
                <c:pt idx="5336">
                  <c:v>15.052550144195543</c:v>
                </c:pt>
                <c:pt idx="5337">
                  <c:v>17.61849997520445</c:v>
                </c:pt>
                <c:pt idx="5338">
                  <c:v>20.177600131034851</c:v>
                </c:pt>
                <c:pt idx="5339">
                  <c:v>19.137250099182101</c:v>
                </c:pt>
                <c:pt idx="5340">
                  <c:v>12.904799962043747</c:v>
                </c:pt>
                <c:pt idx="5341">
                  <c:v>16.331399965286302</c:v>
                </c:pt>
                <c:pt idx="5342">
                  <c:v>9.9100499534606961</c:v>
                </c:pt>
                <c:pt idx="5343">
                  <c:v>10.391549973487848</c:v>
                </c:pt>
                <c:pt idx="5344">
                  <c:v>5.7755497932434494</c:v>
                </c:pt>
                <c:pt idx="5345">
                  <c:v>5.4785498023033021</c:v>
                </c:pt>
                <c:pt idx="5346">
                  <c:v>14.459100060462944</c:v>
                </c:pt>
                <c:pt idx="5347">
                  <c:v>16.982450108528148</c:v>
                </c:pt>
                <c:pt idx="5348">
                  <c:v>14.867900114059452</c:v>
                </c:pt>
                <c:pt idx="5349">
                  <c:v>6.7833497714997009</c:v>
                </c:pt>
                <c:pt idx="5350">
                  <c:v>15.605950002670301</c:v>
                </c:pt>
                <c:pt idx="5351">
                  <c:v>9.6477998018265012</c:v>
                </c:pt>
                <c:pt idx="5352">
                  <c:v>15.865600070953402</c:v>
                </c:pt>
                <c:pt idx="5353">
                  <c:v>14.768349878788001</c:v>
                </c:pt>
                <c:pt idx="5354">
                  <c:v>7.2495999193191487</c:v>
                </c:pt>
                <c:pt idx="5355">
                  <c:v>17.628850045204146</c:v>
                </c:pt>
                <c:pt idx="5356">
                  <c:v>14.407449965477049</c:v>
                </c:pt>
                <c:pt idx="5357">
                  <c:v>12.515900144577046</c:v>
                </c:pt>
                <c:pt idx="5358">
                  <c:v>9.400299777984646</c:v>
                </c:pt>
                <c:pt idx="5359">
                  <c:v>20.288599905967747</c:v>
                </c:pt>
                <c:pt idx="5360">
                  <c:v>19.348949980735853</c:v>
                </c:pt>
                <c:pt idx="5361">
                  <c:v>16.143850073814402</c:v>
                </c:pt>
                <c:pt idx="5362">
                  <c:v>4.8902499008178992</c:v>
                </c:pt>
                <c:pt idx="5363">
                  <c:v>13.773149995803848</c:v>
                </c:pt>
                <c:pt idx="5364">
                  <c:v>4.5555997943878026</c:v>
                </c:pt>
                <c:pt idx="5365">
                  <c:v>14.071849975585899</c:v>
                </c:pt>
                <c:pt idx="5366">
                  <c:v>6.2087999010085504</c:v>
                </c:pt>
                <c:pt idx="5367">
                  <c:v>8.5912998199462969</c:v>
                </c:pt>
                <c:pt idx="5368">
                  <c:v>13.740350103378304</c:v>
                </c:pt>
                <c:pt idx="5369">
                  <c:v>11.431500015258798</c:v>
                </c:pt>
                <c:pt idx="5370">
                  <c:v>10.395499973297145</c:v>
                </c:pt>
                <c:pt idx="5371">
                  <c:v>4.5484997582435511</c:v>
                </c:pt>
                <c:pt idx="5372">
                  <c:v>10.191349749565148</c:v>
                </c:pt>
                <c:pt idx="5373">
                  <c:v>5.2331499290465509</c:v>
                </c:pt>
                <c:pt idx="5374">
                  <c:v>10.815749740600602</c:v>
                </c:pt>
                <c:pt idx="5375">
                  <c:v>20.883399844169595</c:v>
                </c:pt>
                <c:pt idx="5376">
                  <c:v>10.8948498868942</c:v>
                </c:pt>
                <c:pt idx="5377">
                  <c:v>1.7037500667571983</c:v>
                </c:pt>
                <c:pt idx="5378">
                  <c:v>7.1498999547958526</c:v>
                </c:pt>
                <c:pt idx="5379">
                  <c:v>13.573799819946302</c:v>
                </c:pt>
                <c:pt idx="5380">
                  <c:v>4.0155998611450485</c:v>
                </c:pt>
                <c:pt idx="5381">
                  <c:v>15.009399952888501</c:v>
                </c:pt>
                <c:pt idx="5382">
                  <c:v>12.885499987602199</c:v>
                </c:pt>
                <c:pt idx="5383">
                  <c:v>13.380849943161053</c:v>
                </c:pt>
                <c:pt idx="5384">
                  <c:v>14.540550069809001</c:v>
                </c:pt>
                <c:pt idx="5385">
                  <c:v>17.304000163078303</c:v>
                </c:pt>
                <c:pt idx="5386">
                  <c:v>8.9633998584746521</c:v>
                </c:pt>
                <c:pt idx="5387">
                  <c:v>3.3779999208450029</c:v>
                </c:pt>
                <c:pt idx="5388">
                  <c:v>10.354149904251102</c:v>
                </c:pt>
                <c:pt idx="5389">
                  <c:v>17.375799846649151</c:v>
                </c:pt>
                <c:pt idx="5390">
                  <c:v>10.402999892234796</c:v>
                </c:pt>
                <c:pt idx="5391">
                  <c:v>14.668100056648303</c:v>
                </c:pt>
                <c:pt idx="5392">
                  <c:v>14.63540003776555</c:v>
                </c:pt>
                <c:pt idx="5393">
                  <c:v>14.409400048255947</c:v>
                </c:pt>
                <c:pt idx="5394">
                  <c:v>4.8141498708724519</c:v>
                </c:pt>
                <c:pt idx="5395">
                  <c:v>3.2489497566222951</c:v>
                </c:pt>
                <c:pt idx="5396">
                  <c:v>12.660799980163599</c:v>
                </c:pt>
                <c:pt idx="5397">
                  <c:v>18.96050005435945</c:v>
                </c:pt>
                <c:pt idx="5398">
                  <c:v>12.09124984502785</c:v>
                </c:pt>
                <c:pt idx="5399">
                  <c:v>17.534250116348254</c:v>
                </c:pt>
                <c:pt idx="5400">
                  <c:v>11.256949971914295</c:v>
                </c:pt>
                <c:pt idx="5401">
                  <c:v>11.256949971914295</c:v>
                </c:pt>
                <c:pt idx="5402">
                  <c:v>6.9624499082565521</c:v>
                </c:pt>
                <c:pt idx="5403">
                  <c:v>6.9819997549057504</c:v>
                </c:pt>
                <c:pt idx="5404">
                  <c:v>11.3852000713349</c:v>
                </c:pt>
                <c:pt idx="5405">
                  <c:v>17.488250021934455</c:v>
                </c:pt>
                <c:pt idx="5406">
                  <c:v>16.373700127601658</c:v>
                </c:pt>
                <c:pt idx="5407">
                  <c:v>10.329599728584299</c:v>
                </c:pt>
                <c:pt idx="5408">
                  <c:v>12.110299954414355</c:v>
                </c:pt>
                <c:pt idx="5409">
                  <c:v>13.110800061225895</c:v>
                </c:pt>
                <c:pt idx="5410">
                  <c:v>5.0131498241425021</c:v>
                </c:pt>
                <c:pt idx="5411">
                  <c:v>6.8343995857238511</c:v>
                </c:pt>
                <c:pt idx="5412">
                  <c:v>14.199350104331948</c:v>
                </c:pt>
                <c:pt idx="5413">
                  <c:v>17.519699873924203</c:v>
                </c:pt>
                <c:pt idx="5414">
                  <c:v>16.028549938201895</c:v>
                </c:pt>
                <c:pt idx="5415">
                  <c:v>10.748199958801248</c:v>
                </c:pt>
                <c:pt idx="5416">
                  <c:v>11.603650016784698</c:v>
                </c:pt>
                <c:pt idx="5417">
                  <c:v>10.52614990234375</c:v>
                </c:pt>
                <c:pt idx="5418">
                  <c:v>9.9158999013901017</c:v>
                </c:pt>
                <c:pt idx="5419">
                  <c:v>14.70139980316165</c:v>
                </c:pt>
                <c:pt idx="5420">
                  <c:v>10.026049828529349</c:v>
                </c:pt>
                <c:pt idx="5421">
                  <c:v>5.5731997585297002</c:v>
                </c:pt>
                <c:pt idx="5422">
                  <c:v>13.846749973297143</c:v>
                </c:pt>
                <c:pt idx="5423">
                  <c:v>10.8784499168396</c:v>
                </c:pt>
                <c:pt idx="5424">
                  <c:v>10.291800045967097</c:v>
                </c:pt>
                <c:pt idx="5425">
                  <c:v>8.8428998231887981</c:v>
                </c:pt>
                <c:pt idx="5426">
                  <c:v>19.3166501712799</c:v>
                </c:pt>
                <c:pt idx="5427">
                  <c:v>12.894150094986003</c:v>
                </c:pt>
                <c:pt idx="5428">
                  <c:v>7.8419497156143017</c:v>
                </c:pt>
                <c:pt idx="5429">
                  <c:v>7.9426499080658033</c:v>
                </c:pt>
                <c:pt idx="5430">
                  <c:v>18.095700035095255</c:v>
                </c:pt>
                <c:pt idx="5431">
                  <c:v>7.567899723053003</c:v>
                </c:pt>
                <c:pt idx="5432">
                  <c:v>11.971600012779199</c:v>
                </c:pt>
                <c:pt idx="5433">
                  <c:v>15.431250009536754</c:v>
                </c:pt>
                <c:pt idx="5434">
                  <c:v>11.076699948310846</c:v>
                </c:pt>
                <c:pt idx="5435">
                  <c:v>11.282550044059747</c:v>
                </c:pt>
                <c:pt idx="5436">
                  <c:v>14.954700002670247</c:v>
                </c:pt>
                <c:pt idx="5437">
                  <c:v>12.435749664306702</c:v>
                </c:pt>
                <c:pt idx="5438">
                  <c:v>1.7435999059676988</c:v>
                </c:pt>
                <c:pt idx="5439">
                  <c:v>8.8148998165130479</c:v>
                </c:pt>
                <c:pt idx="5440">
                  <c:v>4.8493496894835992</c:v>
                </c:pt>
                <c:pt idx="5441">
                  <c:v>10.652449979782102</c:v>
                </c:pt>
                <c:pt idx="5442">
                  <c:v>10.103949937820403</c:v>
                </c:pt>
                <c:pt idx="5443">
                  <c:v>9.0309498548507463</c:v>
                </c:pt>
                <c:pt idx="5444">
                  <c:v>14.524450073242207</c:v>
                </c:pt>
                <c:pt idx="5445">
                  <c:v>14.72764996528625</c:v>
                </c:pt>
                <c:pt idx="5446">
                  <c:v>12.302899737358103</c:v>
                </c:pt>
                <c:pt idx="5447">
                  <c:v>14.922650074958803</c:v>
                </c:pt>
                <c:pt idx="5448">
                  <c:v>12.138750052452096</c:v>
                </c:pt>
                <c:pt idx="5449">
                  <c:v>13.794149990081849</c:v>
                </c:pt>
                <c:pt idx="5450">
                  <c:v>17.571050028800951</c:v>
                </c:pt>
                <c:pt idx="5451">
                  <c:v>15.4586000156403</c:v>
                </c:pt>
                <c:pt idx="5452">
                  <c:v>14.122999830246002</c:v>
                </c:pt>
                <c:pt idx="5453">
                  <c:v>10.178799757957449</c:v>
                </c:pt>
                <c:pt idx="5454">
                  <c:v>8.1425997686386005</c:v>
                </c:pt>
                <c:pt idx="5455">
                  <c:v>13.033199877738944</c:v>
                </c:pt>
                <c:pt idx="5456">
                  <c:v>4.5705998563766528</c:v>
                </c:pt>
                <c:pt idx="5457">
                  <c:v>10.384799871444702</c:v>
                </c:pt>
                <c:pt idx="5458">
                  <c:v>4.3877498388290022</c:v>
                </c:pt>
                <c:pt idx="5459">
                  <c:v>10.622549872398395</c:v>
                </c:pt>
                <c:pt idx="5460">
                  <c:v>9.0451496887207021</c:v>
                </c:pt>
                <c:pt idx="5461">
                  <c:v>12.182899718284602</c:v>
                </c:pt>
                <c:pt idx="5462">
                  <c:v>7.7888497734069979</c:v>
                </c:pt>
                <c:pt idx="5463">
                  <c:v>3.7645998477935976</c:v>
                </c:pt>
                <c:pt idx="5464">
                  <c:v>16.753350000381545</c:v>
                </c:pt>
                <c:pt idx="5465">
                  <c:v>7.0875998163223493</c:v>
                </c:pt>
                <c:pt idx="5466">
                  <c:v>4.7884499359130999</c:v>
                </c:pt>
                <c:pt idx="5467">
                  <c:v>13.206500105857849</c:v>
                </c:pt>
                <c:pt idx="5468">
                  <c:v>15.423149943351753</c:v>
                </c:pt>
                <c:pt idx="5469">
                  <c:v>8.311649842262252</c:v>
                </c:pt>
                <c:pt idx="5470">
                  <c:v>9.717299737930297</c:v>
                </c:pt>
                <c:pt idx="5471">
                  <c:v>13.655299987792947</c:v>
                </c:pt>
                <c:pt idx="5472">
                  <c:v>8.9073498296736986</c:v>
                </c:pt>
                <c:pt idx="5473">
                  <c:v>13.947249989509551</c:v>
                </c:pt>
                <c:pt idx="5474">
                  <c:v>17.055449905395502</c:v>
                </c:pt>
                <c:pt idx="5475">
                  <c:v>28.621199769973749</c:v>
                </c:pt>
                <c:pt idx="5476">
                  <c:v>9.375999646186802</c:v>
                </c:pt>
                <c:pt idx="5477">
                  <c:v>4.1041498470306017</c:v>
                </c:pt>
                <c:pt idx="5478">
                  <c:v>10.798449883461</c:v>
                </c:pt>
                <c:pt idx="5479">
                  <c:v>15.610799760818502</c:v>
                </c:pt>
                <c:pt idx="5480">
                  <c:v>15.950249986648501</c:v>
                </c:pt>
                <c:pt idx="5481">
                  <c:v>10.8691000699997</c:v>
                </c:pt>
                <c:pt idx="5482">
                  <c:v>17.737050242424001</c:v>
                </c:pt>
                <c:pt idx="5483">
                  <c:v>5.8266498851776483</c:v>
                </c:pt>
                <c:pt idx="5484">
                  <c:v>11.792649822235052</c:v>
                </c:pt>
                <c:pt idx="5485">
                  <c:v>19.75609981536865</c:v>
                </c:pt>
                <c:pt idx="5486">
                  <c:v>8.3442998838424955</c:v>
                </c:pt>
                <c:pt idx="5487">
                  <c:v>10.813550007343252</c:v>
                </c:pt>
                <c:pt idx="5488">
                  <c:v>9.9355498218536482</c:v>
                </c:pt>
                <c:pt idx="5489">
                  <c:v>20.073350200653103</c:v>
                </c:pt>
                <c:pt idx="5490">
                  <c:v>7.9847498941421513</c:v>
                </c:pt>
                <c:pt idx="5491">
                  <c:v>6.8550496101379466</c:v>
                </c:pt>
                <c:pt idx="5492">
                  <c:v>7.9456499910354488</c:v>
                </c:pt>
                <c:pt idx="5493">
                  <c:v>4.1955498027801532</c:v>
                </c:pt>
                <c:pt idx="5494">
                  <c:v>19.148000030517601</c:v>
                </c:pt>
                <c:pt idx="5495">
                  <c:v>8.5626998806000003</c:v>
                </c:pt>
                <c:pt idx="5496">
                  <c:v>7.7983498620987</c:v>
                </c:pt>
                <c:pt idx="5497">
                  <c:v>20.924499917030303</c:v>
                </c:pt>
                <c:pt idx="5498">
                  <c:v>5.6195498561859019</c:v>
                </c:pt>
                <c:pt idx="5499">
                  <c:v>9.3497497558593494</c:v>
                </c:pt>
                <c:pt idx="5500">
                  <c:v>9.7749498271942059</c:v>
                </c:pt>
                <c:pt idx="5501">
                  <c:v>9.9585497903823494</c:v>
                </c:pt>
                <c:pt idx="5502">
                  <c:v>9.9247497749328524</c:v>
                </c:pt>
                <c:pt idx="5503">
                  <c:v>9.9029500865935951</c:v>
                </c:pt>
                <c:pt idx="5504">
                  <c:v>17.012399902343798</c:v>
                </c:pt>
                <c:pt idx="5505">
                  <c:v>3.5069497442245492</c:v>
                </c:pt>
                <c:pt idx="5506">
                  <c:v>12.957649869918846</c:v>
                </c:pt>
                <c:pt idx="5507">
                  <c:v>3.6248998165130999</c:v>
                </c:pt>
                <c:pt idx="5508">
                  <c:v>20.777749972343447</c:v>
                </c:pt>
                <c:pt idx="5509">
                  <c:v>1.6695999789237987</c:v>
                </c:pt>
                <c:pt idx="5510">
                  <c:v>8.2108996343612972</c:v>
                </c:pt>
                <c:pt idx="5511">
                  <c:v>6.7671998357772978</c:v>
                </c:pt>
                <c:pt idx="5512">
                  <c:v>9.8477498769759961</c:v>
                </c:pt>
                <c:pt idx="5513">
                  <c:v>10.651049852371248</c:v>
                </c:pt>
                <c:pt idx="5514">
                  <c:v>8.0474997615814488</c:v>
                </c:pt>
                <c:pt idx="5515">
                  <c:v>11.9258236866768</c:v>
                </c:pt>
                <c:pt idx="5516">
                  <c:v>10.627299690246549</c:v>
                </c:pt>
                <c:pt idx="5517">
                  <c:v>19.874150037765499</c:v>
                </c:pt>
                <c:pt idx="5518">
                  <c:v>16.193300104141258</c:v>
                </c:pt>
                <c:pt idx="5519">
                  <c:v>11.397400150299049</c:v>
                </c:pt>
                <c:pt idx="5520">
                  <c:v>12.648699922561597</c:v>
                </c:pt>
                <c:pt idx="5521">
                  <c:v>16.920950083732599</c:v>
                </c:pt>
                <c:pt idx="5522">
                  <c:v>11.996599884033152</c:v>
                </c:pt>
                <c:pt idx="5523">
                  <c:v>11.180699830055246</c:v>
                </c:pt>
                <c:pt idx="5524">
                  <c:v>14.053450088501002</c:v>
                </c:pt>
                <c:pt idx="5525">
                  <c:v>6.0385498380661495</c:v>
                </c:pt>
                <c:pt idx="5526">
                  <c:v>14.451800084114154</c:v>
                </c:pt>
                <c:pt idx="5527">
                  <c:v>11.578649916648899</c:v>
                </c:pt>
                <c:pt idx="5528">
                  <c:v>20.534899792671201</c:v>
                </c:pt>
                <c:pt idx="5529">
                  <c:v>14.557799863815347</c:v>
                </c:pt>
                <c:pt idx="5530">
                  <c:v>13.902649965286251</c:v>
                </c:pt>
                <c:pt idx="5531">
                  <c:v>5.0271999168395993</c:v>
                </c:pt>
                <c:pt idx="5532">
                  <c:v>4.8028498291969512</c:v>
                </c:pt>
                <c:pt idx="5533">
                  <c:v>15.023149843215947</c:v>
                </c:pt>
                <c:pt idx="5534">
                  <c:v>9.632899789810196</c:v>
                </c:pt>
                <c:pt idx="5535">
                  <c:v>14.273649919033005</c:v>
                </c:pt>
                <c:pt idx="5536">
                  <c:v>8.3815998935698985</c:v>
                </c:pt>
                <c:pt idx="5537">
                  <c:v>9.3170997571945016</c:v>
                </c:pt>
                <c:pt idx="5538">
                  <c:v>11.562450008392346</c:v>
                </c:pt>
                <c:pt idx="5539">
                  <c:v>12.82929989337925</c:v>
                </c:pt>
                <c:pt idx="5540">
                  <c:v>4.881149816513048</c:v>
                </c:pt>
                <c:pt idx="5541">
                  <c:v>7.1431496953963993</c:v>
                </c:pt>
                <c:pt idx="5542">
                  <c:v>5.0842499804496519</c:v>
                </c:pt>
                <c:pt idx="5543">
                  <c:v>11.819499802589402</c:v>
                </c:pt>
                <c:pt idx="5544">
                  <c:v>5.2574998903274448</c:v>
                </c:pt>
                <c:pt idx="5545">
                  <c:v>8.8040497827530046</c:v>
                </c:pt>
                <c:pt idx="5546">
                  <c:v>5.3501000547408495</c:v>
                </c:pt>
                <c:pt idx="5547">
                  <c:v>13.883150053024302</c:v>
                </c:pt>
                <c:pt idx="5548">
                  <c:v>16.16974973678585</c:v>
                </c:pt>
                <c:pt idx="5549">
                  <c:v>9.019949855804402</c:v>
                </c:pt>
                <c:pt idx="5550">
                  <c:v>5.9905998301506003</c:v>
                </c:pt>
                <c:pt idx="5551">
                  <c:v>1.4522501134872527</c:v>
                </c:pt>
                <c:pt idx="5552">
                  <c:v>14.492100000381452</c:v>
                </c:pt>
                <c:pt idx="5553">
                  <c:v>10.742699952125555</c:v>
                </c:pt>
                <c:pt idx="5554">
                  <c:v>7.2670998096466022</c:v>
                </c:pt>
                <c:pt idx="5555">
                  <c:v>15.798699970245401</c:v>
                </c:pt>
                <c:pt idx="5556">
                  <c:v>5.2041499519348449</c:v>
                </c:pt>
                <c:pt idx="5557">
                  <c:v>6.5682499599457529</c:v>
                </c:pt>
                <c:pt idx="5558">
                  <c:v>9.5838497447967548</c:v>
                </c:pt>
                <c:pt idx="5559">
                  <c:v>12.662249879836999</c:v>
                </c:pt>
                <c:pt idx="5560">
                  <c:v>3.4677998065948508</c:v>
                </c:pt>
                <c:pt idx="5561">
                  <c:v>10.924849767684897</c:v>
                </c:pt>
                <c:pt idx="5562">
                  <c:v>8.0222997951507509</c:v>
                </c:pt>
                <c:pt idx="5563">
                  <c:v>9.6175499725341993</c:v>
                </c:pt>
                <c:pt idx="5564">
                  <c:v>7.0427998542785488</c:v>
                </c:pt>
                <c:pt idx="5565">
                  <c:v>10.264349746704152</c:v>
                </c:pt>
                <c:pt idx="5566">
                  <c:v>11.094599890708949</c:v>
                </c:pt>
                <c:pt idx="5567">
                  <c:v>12.428849873542749</c:v>
                </c:pt>
                <c:pt idx="5568">
                  <c:v>9.1528498268127514</c:v>
                </c:pt>
                <c:pt idx="5569">
                  <c:v>4.0249996948242028</c:v>
                </c:pt>
                <c:pt idx="5570">
                  <c:v>10.763699951171894</c:v>
                </c:pt>
                <c:pt idx="5571">
                  <c:v>12.2469999027252</c:v>
                </c:pt>
                <c:pt idx="5572">
                  <c:v>81.820699782371449</c:v>
                </c:pt>
                <c:pt idx="5573">
                  <c:v>12.260899980068199</c:v>
                </c:pt>
                <c:pt idx="5574">
                  <c:v>5.5482996463775507</c:v>
                </c:pt>
                <c:pt idx="5575">
                  <c:v>9.1114499235152984</c:v>
                </c:pt>
                <c:pt idx="5576">
                  <c:v>7.8320497226714991</c:v>
                </c:pt>
                <c:pt idx="5577">
                  <c:v>16.570400056838999</c:v>
                </c:pt>
                <c:pt idx="5578">
                  <c:v>12.587049889564504</c:v>
                </c:pt>
                <c:pt idx="5579">
                  <c:v>6.9133998394012011</c:v>
                </c:pt>
                <c:pt idx="5580">
                  <c:v>7.5606498765945531</c:v>
                </c:pt>
                <c:pt idx="5581">
                  <c:v>10.89109996318815</c:v>
                </c:pt>
                <c:pt idx="5582">
                  <c:v>5.6560499286651478</c:v>
                </c:pt>
                <c:pt idx="5583">
                  <c:v>10.557399730682349</c:v>
                </c:pt>
                <c:pt idx="5584">
                  <c:v>14.382249970436092</c:v>
                </c:pt>
                <c:pt idx="5585">
                  <c:v>21.9011002111435</c:v>
                </c:pt>
                <c:pt idx="5586">
                  <c:v>11.652249908447303</c:v>
                </c:pt>
                <c:pt idx="5587">
                  <c:v>9.6438999605178495</c:v>
                </c:pt>
                <c:pt idx="5588">
                  <c:v>16.6308999919891</c:v>
                </c:pt>
                <c:pt idx="5589">
                  <c:v>8.967249853611051</c:v>
                </c:pt>
                <c:pt idx="5590">
                  <c:v>13.876200089454649</c:v>
                </c:pt>
                <c:pt idx="5591">
                  <c:v>15.146649940013901</c:v>
                </c:pt>
                <c:pt idx="5592">
                  <c:v>8.6112999105453518</c:v>
                </c:pt>
                <c:pt idx="5593">
                  <c:v>12.887849836349496</c:v>
                </c:pt>
                <c:pt idx="5594">
                  <c:v>11.046849923133855</c:v>
                </c:pt>
                <c:pt idx="5595">
                  <c:v>16.546249914169302</c:v>
                </c:pt>
                <c:pt idx="5596">
                  <c:v>10.304149727821351</c:v>
                </c:pt>
                <c:pt idx="5597">
                  <c:v>2.669749898910549</c:v>
                </c:pt>
                <c:pt idx="5598">
                  <c:v>2.8515998792648034</c:v>
                </c:pt>
                <c:pt idx="5599">
                  <c:v>6.4183997488021483</c:v>
                </c:pt>
                <c:pt idx="5600">
                  <c:v>4.4702498197555478</c:v>
                </c:pt>
                <c:pt idx="5601">
                  <c:v>10.695650053024302</c:v>
                </c:pt>
                <c:pt idx="5602">
                  <c:v>4.8762498378753527</c:v>
                </c:pt>
                <c:pt idx="5603">
                  <c:v>1.3895498847961001</c:v>
                </c:pt>
                <c:pt idx="5604">
                  <c:v>4.7323998212814544</c:v>
                </c:pt>
                <c:pt idx="5605">
                  <c:v>5.5787999105453494</c:v>
                </c:pt>
                <c:pt idx="5606">
                  <c:v>28.378449840545695</c:v>
                </c:pt>
                <c:pt idx="5607">
                  <c:v>10.95749995708465</c:v>
                </c:pt>
                <c:pt idx="5608">
                  <c:v>4.6863998270034983</c:v>
                </c:pt>
                <c:pt idx="5609">
                  <c:v>3.1574999523163001</c:v>
                </c:pt>
                <c:pt idx="5610">
                  <c:v>8.4206497001648017</c:v>
                </c:pt>
                <c:pt idx="5611">
                  <c:v>5.8649997091293002</c:v>
                </c:pt>
                <c:pt idx="5612">
                  <c:v>3.0243998384475539</c:v>
                </c:pt>
                <c:pt idx="5613">
                  <c:v>14.114400072097752</c:v>
                </c:pt>
                <c:pt idx="5614">
                  <c:v>6.4881497716903489</c:v>
                </c:pt>
                <c:pt idx="5615">
                  <c:v>10.887549824714654</c:v>
                </c:pt>
                <c:pt idx="5616">
                  <c:v>18.811250028610246</c:v>
                </c:pt>
                <c:pt idx="5617">
                  <c:v>3.8351499223708991</c:v>
                </c:pt>
                <c:pt idx="5618">
                  <c:v>15.332449951171895</c:v>
                </c:pt>
                <c:pt idx="5619">
                  <c:v>5.8190497207641521</c:v>
                </c:pt>
                <c:pt idx="5620">
                  <c:v>12.746149845123302</c:v>
                </c:pt>
                <c:pt idx="5621">
                  <c:v>12.362799863815347</c:v>
                </c:pt>
                <c:pt idx="5622">
                  <c:v>6.9236498284340016</c:v>
                </c:pt>
                <c:pt idx="5623">
                  <c:v>6.5671998167037984</c:v>
                </c:pt>
                <c:pt idx="5624">
                  <c:v>-1.3547000205516504</c:v>
                </c:pt>
                <c:pt idx="5625">
                  <c:v>14.461549949645999</c:v>
                </c:pt>
                <c:pt idx="5626">
                  <c:v>20.527049984931899</c:v>
                </c:pt>
                <c:pt idx="5627">
                  <c:v>12.301749935150099</c:v>
                </c:pt>
                <c:pt idx="5628">
                  <c:v>12.88454987049105</c:v>
                </c:pt>
                <c:pt idx="5629">
                  <c:v>3.9375999879837025</c:v>
                </c:pt>
                <c:pt idx="5630">
                  <c:v>5.4383497714996523</c:v>
                </c:pt>
                <c:pt idx="5631">
                  <c:v>10.489299855232201</c:v>
                </c:pt>
                <c:pt idx="5632">
                  <c:v>11.880749893188451</c:v>
                </c:pt>
                <c:pt idx="5633">
                  <c:v>6.7444999217987522</c:v>
                </c:pt>
                <c:pt idx="5634">
                  <c:v>20.267900123596149</c:v>
                </c:pt>
                <c:pt idx="5635">
                  <c:v>13.977050023078899</c:v>
                </c:pt>
                <c:pt idx="5636">
                  <c:v>9.2677998876572047</c:v>
                </c:pt>
                <c:pt idx="5637">
                  <c:v>14.298499908447297</c:v>
                </c:pt>
                <c:pt idx="5638">
                  <c:v>3.0764999246597498</c:v>
                </c:pt>
                <c:pt idx="5639">
                  <c:v>13.749499907493551</c:v>
                </c:pt>
                <c:pt idx="5640">
                  <c:v>18.163550043106049</c:v>
                </c:pt>
                <c:pt idx="5641">
                  <c:v>12.21620000362395</c:v>
                </c:pt>
                <c:pt idx="5642">
                  <c:v>7.3470498323440978</c:v>
                </c:pt>
                <c:pt idx="5643">
                  <c:v>7.37709983825685</c:v>
                </c:pt>
                <c:pt idx="5644">
                  <c:v>3.8322997903823968</c:v>
                </c:pt>
                <c:pt idx="5645">
                  <c:v>20.460249953269898</c:v>
                </c:pt>
                <c:pt idx="5646">
                  <c:v>10.09144981384275</c:v>
                </c:pt>
                <c:pt idx="5647">
                  <c:v>16.619500021934499</c:v>
                </c:pt>
                <c:pt idx="5648">
                  <c:v>4.8961497354507486</c:v>
                </c:pt>
                <c:pt idx="5649">
                  <c:v>8.4404499292373494</c:v>
                </c:pt>
                <c:pt idx="5650">
                  <c:v>13.37964995861055</c:v>
                </c:pt>
                <c:pt idx="5651">
                  <c:v>8.1262498283386009</c:v>
                </c:pt>
                <c:pt idx="5652">
                  <c:v>9.6277999639511016</c:v>
                </c:pt>
                <c:pt idx="5653">
                  <c:v>14.272499980926501</c:v>
                </c:pt>
                <c:pt idx="5654">
                  <c:v>8.4950498151779534</c:v>
                </c:pt>
                <c:pt idx="5655">
                  <c:v>6.5225998401642045</c:v>
                </c:pt>
                <c:pt idx="5656">
                  <c:v>11.467799897193899</c:v>
                </c:pt>
                <c:pt idx="5657">
                  <c:v>9.1636999416351017</c:v>
                </c:pt>
                <c:pt idx="5658">
                  <c:v>2.5161500120163005</c:v>
                </c:pt>
                <c:pt idx="5659">
                  <c:v>2.1402498769760001</c:v>
                </c:pt>
                <c:pt idx="5660">
                  <c:v>7.6662499761580989</c:v>
                </c:pt>
                <c:pt idx="5661">
                  <c:v>9.5186999225617015</c:v>
                </c:pt>
                <c:pt idx="5662">
                  <c:v>4.8756998920441035</c:v>
                </c:pt>
                <c:pt idx="5663">
                  <c:v>6.9235499525069955</c:v>
                </c:pt>
                <c:pt idx="5664">
                  <c:v>16.637200179100049</c:v>
                </c:pt>
                <c:pt idx="5665">
                  <c:v>12.949149909019447</c:v>
                </c:pt>
                <c:pt idx="5666">
                  <c:v>7.1386500167846485</c:v>
                </c:pt>
                <c:pt idx="5667">
                  <c:v>6.6086498498916022</c:v>
                </c:pt>
                <c:pt idx="5668">
                  <c:v>4.9433498430251959</c:v>
                </c:pt>
                <c:pt idx="5669">
                  <c:v>12.818899946212799</c:v>
                </c:pt>
                <c:pt idx="5670">
                  <c:v>8.0070498561859011</c:v>
                </c:pt>
                <c:pt idx="5671">
                  <c:v>14.958600172996551</c:v>
                </c:pt>
                <c:pt idx="5672">
                  <c:v>8.7531997966766042</c:v>
                </c:pt>
                <c:pt idx="5673">
                  <c:v>7.0346000099181474</c:v>
                </c:pt>
                <c:pt idx="5674">
                  <c:v>7.7407999038696467</c:v>
                </c:pt>
                <c:pt idx="5675">
                  <c:v>6.0332498836517487</c:v>
                </c:pt>
                <c:pt idx="5676">
                  <c:v>5.9362499856948503</c:v>
                </c:pt>
                <c:pt idx="5677">
                  <c:v>18.909600167274448</c:v>
                </c:pt>
                <c:pt idx="5678">
                  <c:v>9.6215498399734969</c:v>
                </c:pt>
                <c:pt idx="5679">
                  <c:v>9.685099997520453</c:v>
                </c:pt>
                <c:pt idx="5680">
                  <c:v>4.1197496843337973</c:v>
                </c:pt>
                <c:pt idx="5681">
                  <c:v>7.922199716567949</c:v>
                </c:pt>
                <c:pt idx="5682">
                  <c:v>10.125099959373451</c:v>
                </c:pt>
                <c:pt idx="5683">
                  <c:v>16.116800074577306</c:v>
                </c:pt>
                <c:pt idx="5684">
                  <c:v>2.3899497652054009</c:v>
                </c:pt>
                <c:pt idx="5685">
                  <c:v>3.6538497304916504</c:v>
                </c:pt>
                <c:pt idx="5686">
                  <c:v>14.162799806594847</c:v>
                </c:pt>
                <c:pt idx="5687">
                  <c:v>9.3140499210357497</c:v>
                </c:pt>
                <c:pt idx="5688">
                  <c:v>10.442999916076698</c:v>
                </c:pt>
                <c:pt idx="5689">
                  <c:v>4.6767498493194992</c:v>
                </c:pt>
                <c:pt idx="5690">
                  <c:v>4.1838498449325527</c:v>
                </c:pt>
                <c:pt idx="5691">
                  <c:v>5.5960498189926007</c:v>
                </c:pt>
                <c:pt idx="5692">
                  <c:v>5.8719498109817501</c:v>
                </c:pt>
                <c:pt idx="5693">
                  <c:v>5.7187999343871994</c:v>
                </c:pt>
                <c:pt idx="5694">
                  <c:v>13.698549914360047</c:v>
                </c:pt>
                <c:pt idx="5695">
                  <c:v>11.054999952316301</c:v>
                </c:pt>
                <c:pt idx="5696">
                  <c:v>8.8219499039650024</c:v>
                </c:pt>
                <c:pt idx="5697">
                  <c:v>4.0822999238967483</c:v>
                </c:pt>
                <c:pt idx="5698">
                  <c:v>4.3987997579574518</c:v>
                </c:pt>
                <c:pt idx="5699">
                  <c:v>11.418099899291949</c:v>
                </c:pt>
                <c:pt idx="5700">
                  <c:v>16.805900030136101</c:v>
                </c:pt>
                <c:pt idx="5701">
                  <c:v>7.0509498929977497</c:v>
                </c:pt>
                <c:pt idx="5702">
                  <c:v>6.3269497776031471</c:v>
                </c:pt>
                <c:pt idx="5703">
                  <c:v>8.3498999071121531</c:v>
                </c:pt>
                <c:pt idx="5704">
                  <c:v>6.5332998132706024</c:v>
                </c:pt>
                <c:pt idx="5705">
                  <c:v>7.6174998474121516</c:v>
                </c:pt>
                <c:pt idx="5706">
                  <c:v>6.1540999317168996</c:v>
                </c:pt>
                <c:pt idx="5707">
                  <c:v>4.9991497611998987</c:v>
                </c:pt>
                <c:pt idx="5708">
                  <c:v>6.9425498628616538</c:v>
                </c:pt>
                <c:pt idx="5709">
                  <c:v>12.250799875259396</c:v>
                </c:pt>
                <c:pt idx="5710">
                  <c:v>3.069749989509603</c:v>
                </c:pt>
                <c:pt idx="5711">
                  <c:v>14.756900033950799</c:v>
                </c:pt>
                <c:pt idx="5712">
                  <c:v>19.412350153923001</c:v>
                </c:pt>
                <c:pt idx="5713">
                  <c:v>3.1694498896598979</c:v>
                </c:pt>
                <c:pt idx="5714">
                  <c:v>7.0669998931884983</c:v>
                </c:pt>
                <c:pt idx="5715">
                  <c:v>5.1488998413086016</c:v>
                </c:pt>
                <c:pt idx="5716">
                  <c:v>67.502999911308308</c:v>
                </c:pt>
                <c:pt idx="5717">
                  <c:v>16.653450222015351</c:v>
                </c:pt>
                <c:pt idx="5718">
                  <c:v>11.547049889564548</c:v>
                </c:pt>
                <c:pt idx="5719">
                  <c:v>8.7394999122619481</c:v>
                </c:pt>
                <c:pt idx="5720">
                  <c:v>16.815699748992955</c:v>
                </c:pt>
                <c:pt idx="5721">
                  <c:v>4.837549891471852</c:v>
                </c:pt>
                <c:pt idx="5722">
                  <c:v>4.3049999284744516</c:v>
                </c:pt>
                <c:pt idx="5723">
                  <c:v>14.143649854660055</c:v>
                </c:pt>
                <c:pt idx="5724">
                  <c:v>18.660800127983102</c:v>
                </c:pt>
                <c:pt idx="5725">
                  <c:v>4.54124986648565</c:v>
                </c:pt>
                <c:pt idx="5726">
                  <c:v>4.7368498420715532</c:v>
                </c:pt>
                <c:pt idx="5727">
                  <c:v>9.8087498331070506</c:v>
                </c:pt>
                <c:pt idx="5728">
                  <c:v>8.142899692058549</c:v>
                </c:pt>
                <c:pt idx="5729">
                  <c:v>15.727349891662655</c:v>
                </c:pt>
                <c:pt idx="5730">
                  <c:v>5.8802499055862008</c:v>
                </c:pt>
                <c:pt idx="5731">
                  <c:v>13.013199977874748</c:v>
                </c:pt>
                <c:pt idx="5732">
                  <c:v>11.207899794578552</c:v>
                </c:pt>
                <c:pt idx="5733">
                  <c:v>6.1637999272345994</c:v>
                </c:pt>
                <c:pt idx="5734">
                  <c:v>4.6746498441696502</c:v>
                </c:pt>
                <c:pt idx="5735">
                  <c:v>15.334849948883047</c:v>
                </c:pt>
                <c:pt idx="5736">
                  <c:v>15.497699952125551</c:v>
                </c:pt>
                <c:pt idx="5737">
                  <c:v>5.8565998935699</c:v>
                </c:pt>
                <c:pt idx="5738">
                  <c:v>11.668749856948804</c:v>
                </c:pt>
                <c:pt idx="5739">
                  <c:v>8.2557500314712513</c:v>
                </c:pt>
                <c:pt idx="5740">
                  <c:v>6.3790496444702001</c:v>
                </c:pt>
                <c:pt idx="5741">
                  <c:v>8.2566999816894509</c:v>
                </c:pt>
                <c:pt idx="5742">
                  <c:v>2.0715498542785511</c:v>
                </c:pt>
                <c:pt idx="5743">
                  <c:v>5.9348998308182033</c:v>
                </c:pt>
                <c:pt idx="5744">
                  <c:v>40.718199896812401</c:v>
                </c:pt>
                <c:pt idx="5745">
                  <c:v>9.9616497850418</c:v>
                </c:pt>
                <c:pt idx="5746">
                  <c:v>4.0196998357772458</c:v>
                </c:pt>
                <c:pt idx="5747">
                  <c:v>4.3521498680115016</c:v>
                </c:pt>
                <c:pt idx="5748">
                  <c:v>12.696299843788147</c:v>
                </c:pt>
                <c:pt idx="5749">
                  <c:v>10.239199700355552</c:v>
                </c:pt>
                <c:pt idx="5750">
                  <c:v>13.595849986076399</c:v>
                </c:pt>
                <c:pt idx="5751">
                  <c:v>6.9390498542786005</c:v>
                </c:pt>
                <c:pt idx="5752">
                  <c:v>15.471250076293998</c:v>
                </c:pt>
                <c:pt idx="5753">
                  <c:v>8.8003996658325008</c:v>
                </c:pt>
                <c:pt idx="5754">
                  <c:v>16.416299967765802</c:v>
                </c:pt>
                <c:pt idx="5755">
                  <c:v>5.09079979419705</c:v>
                </c:pt>
                <c:pt idx="5756">
                  <c:v>8.1962999629974043</c:v>
                </c:pt>
                <c:pt idx="5757">
                  <c:v>16.52815024375915</c:v>
                </c:pt>
                <c:pt idx="5758">
                  <c:v>10.293749704360952</c:v>
                </c:pt>
                <c:pt idx="5759">
                  <c:v>9.1268498516082985</c:v>
                </c:pt>
                <c:pt idx="5760">
                  <c:v>12.317599797248853</c:v>
                </c:pt>
                <c:pt idx="5761">
                  <c:v>6.7698997259140512</c:v>
                </c:pt>
                <c:pt idx="5762">
                  <c:v>5.7276499223708974</c:v>
                </c:pt>
                <c:pt idx="5763">
                  <c:v>8.3612497472763536</c:v>
                </c:pt>
                <c:pt idx="5764">
                  <c:v>8.9927997016907</c:v>
                </c:pt>
                <c:pt idx="5765">
                  <c:v>8.3761998319625519</c:v>
                </c:pt>
                <c:pt idx="5766">
                  <c:v>6.6985499238967989</c:v>
                </c:pt>
                <c:pt idx="5767">
                  <c:v>12.078000082969652</c:v>
                </c:pt>
                <c:pt idx="5768">
                  <c:v>9.1455498456955482</c:v>
                </c:pt>
                <c:pt idx="5769">
                  <c:v>9.6812999534607016</c:v>
                </c:pt>
                <c:pt idx="5770">
                  <c:v>8.3510999107360995</c:v>
                </c:pt>
                <c:pt idx="5771">
                  <c:v>4.0847498559951987</c:v>
                </c:pt>
                <c:pt idx="5772">
                  <c:v>4.4485499048232953</c:v>
                </c:pt>
                <c:pt idx="5773">
                  <c:v>10.946449966430698</c:v>
                </c:pt>
                <c:pt idx="5774">
                  <c:v>12.88039989948275</c:v>
                </c:pt>
                <c:pt idx="5775">
                  <c:v>9.2981496953963969</c:v>
                </c:pt>
                <c:pt idx="5776">
                  <c:v>5.4942997074127007</c:v>
                </c:pt>
                <c:pt idx="5777">
                  <c:v>3.9417498207092017</c:v>
                </c:pt>
                <c:pt idx="5778">
                  <c:v>10.014199738502501</c:v>
                </c:pt>
                <c:pt idx="5779">
                  <c:v>27.934899792671196</c:v>
                </c:pt>
                <c:pt idx="5780">
                  <c:v>5.5852499246596992</c:v>
                </c:pt>
                <c:pt idx="5781">
                  <c:v>11.225499806404102</c:v>
                </c:pt>
                <c:pt idx="5782">
                  <c:v>14.5528000736237</c:v>
                </c:pt>
                <c:pt idx="5783">
                  <c:v>3.8689499092101975</c:v>
                </c:pt>
                <c:pt idx="5784">
                  <c:v>5.6815499019622493</c:v>
                </c:pt>
                <c:pt idx="5785">
                  <c:v>4.5914498901366478</c:v>
                </c:pt>
                <c:pt idx="5786">
                  <c:v>8.1478499174118042</c:v>
                </c:pt>
                <c:pt idx="5787">
                  <c:v>6.4004997968673472</c:v>
                </c:pt>
                <c:pt idx="5788">
                  <c:v>5.8410499429703009</c:v>
                </c:pt>
                <c:pt idx="5789">
                  <c:v>5.2851499509811504</c:v>
                </c:pt>
                <c:pt idx="5790">
                  <c:v>19.133300085067756</c:v>
                </c:pt>
                <c:pt idx="5791">
                  <c:v>5.7805997991561995</c:v>
                </c:pt>
                <c:pt idx="5792">
                  <c:v>2.8288498449325488</c:v>
                </c:pt>
                <c:pt idx="5793">
                  <c:v>2.9751000308990498</c:v>
                </c:pt>
                <c:pt idx="5794">
                  <c:v>-0.44740009784700163</c:v>
                </c:pt>
                <c:pt idx="5795">
                  <c:v>4.3969498825073003</c:v>
                </c:pt>
                <c:pt idx="5796">
                  <c:v>11.709249906539895</c:v>
                </c:pt>
                <c:pt idx="5797">
                  <c:v>13.543099889755247</c:v>
                </c:pt>
                <c:pt idx="5798">
                  <c:v>8.6025497698783973</c:v>
                </c:pt>
                <c:pt idx="5799">
                  <c:v>8.006499757766754</c:v>
                </c:pt>
                <c:pt idx="5800">
                  <c:v>20.095450279712701</c:v>
                </c:pt>
                <c:pt idx="5801">
                  <c:v>10.388399801254295</c:v>
                </c:pt>
                <c:pt idx="5802">
                  <c:v>7.9936996412276997</c:v>
                </c:pt>
                <c:pt idx="5803">
                  <c:v>7.2180997753143501</c:v>
                </c:pt>
                <c:pt idx="5804">
                  <c:v>11.6275998258591</c:v>
                </c:pt>
                <c:pt idx="5805">
                  <c:v>13.652299952506997</c:v>
                </c:pt>
                <c:pt idx="5806">
                  <c:v>5.5906998205185019</c:v>
                </c:pt>
                <c:pt idx="5807">
                  <c:v>12.262549915313699</c:v>
                </c:pt>
                <c:pt idx="5808">
                  <c:v>5.6240999221801999</c:v>
                </c:pt>
                <c:pt idx="5809">
                  <c:v>4.015749893188449</c:v>
                </c:pt>
                <c:pt idx="5810">
                  <c:v>27.52964994907385</c:v>
                </c:pt>
                <c:pt idx="5811">
                  <c:v>6.3779999589919996</c:v>
                </c:pt>
                <c:pt idx="5812">
                  <c:v>8.4363498830795507</c:v>
                </c:pt>
                <c:pt idx="5813">
                  <c:v>4.263649835586552</c:v>
                </c:pt>
                <c:pt idx="5814">
                  <c:v>6.7100499010086487</c:v>
                </c:pt>
                <c:pt idx="5815">
                  <c:v>9.5666499304771015</c:v>
                </c:pt>
                <c:pt idx="5816">
                  <c:v>1.7698499846458517</c:v>
                </c:pt>
                <c:pt idx="5817">
                  <c:v>7.7642498826980493</c:v>
                </c:pt>
                <c:pt idx="5818">
                  <c:v>15.459249958991993</c:v>
                </c:pt>
                <c:pt idx="5819">
                  <c:v>9.1881997108459004</c:v>
                </c:pt>
                <c:pt idx="5820">
                  <c:v>11.012099885940549</c:v>
                </c:pt>
                <c:pt idx="5821">
                  <c:v>9.7017008311338984</c:v>
                </c:pt>
                <c:pt idx="5822">
                  <c:v>5.3391996479034489</c:v>
                </c:pt>
                <c:pt idx="5823">
                  <c:v>7.4902499532699487</c:v>
                </c:pt>
                <c:pt idx="5824">
                  <c:v>5.53484998703005</c:v>
                </c:pt>
                <c:pt idx="5825">
                  <c:v>6.5415498495102007</c:v>
                </c:pt>
                <c:pt idx="5826">
                  <c:v>7.5391998958587507</c:v>
                </c:pt>
                <c:pt idx="5827">
                  <c:v>16.596050009727506</c:v>
                </c:pt>
                <c:pt idx="5828">
                  <c:v>12.309550027847351</c:v>
                </c:pt>
                <c:pt idx="5829">
                  <c:v>8.9997498226165469</c:v>
                </c:pt>
                <c:pt idx="5830">
                  <c:v>9.5839997291565027</c:v>
                </c:pt>
                <c:pt idx="5831">
                  <c:v>16.686400012970001</c:v>
                </c:pt>
                <c:pt idx="5832">
                  <c:v>8.8881497430801559</c:v>
                </c:pt>
                <c:pt idx="5833">
                  <c:v>4.0565498113632046</c:v>
                </c:pt>
                <c:pt idx="5834">
                  <c:v>4.2354999113082989</c:v>
                </c:pt>
                <c:pt idx="5835">
                  <c:v>13.617099862098648</c:v>
                </c:pt>
                <c:pt idx="5836">
                  <c:v>4.5924495887756507</c:v>
                </c:pt>
                <c:pt idx="5837">
                  <c:v>7.1699498462676488</c:v>
                </c:pt>
                <c:pt idx="5838">
                  <c:v>4.8628498530387532</c:v>
                </c:pt>
                <c:pt idx="5839">
                  <c:v>2.5874498558043975</c:v>
                </c:pt>
                <c:pt idx="5840">
                  <c:v>5.0161498689651474</c:v>
                </c:pt>
                <c:pt idx="5841">
                  <c:v>5.4573997068405014</c:v>
                </c:pt>
                <c:pt idx="5842">
                  <c:v>5.998199687004103</c:v>
                </c:pt>
                <c:pt idx="5843">
                  <c:v>6.8661999273300012</c:v>
                </c:pt>
                <c:pt idx="5844">
                  <c:v>6.3614999055862462</c:v>
                </c:pt>
                <c:pt idx="5845">
                  <c:v>6.7241998004913484</c:v>
                </c:pt>
                <c:pt idx="5846">
                  <c:v>5.7442499685287487</c:v>
                </c:pt>
                <c:pt idx="5847">
                  <c:v>15.542849993705698</c:v>
                </c:pt>
                <c:pt idx="5848">
                  <c:v>14.858350052833604</c:v>
                </c:pt>
                <c:pt idx="5849">
                  <c:v>11.990599889755249</c:v>
                </c:pt>
                <c:pt idx="5850">
                  <c:v>3.686499876976054</c:v>
                </c:pt>
                <c:pt idx="5851">
                  <c:v>9.8601998710632515</c:v>
                </c:pt>
                <c:pt idx="5852">
                  <c:v>9.3647498798370492</c:v>
                </c:pt>
                <c:pt idx="5853">
                  <c:v>6.3891998386382518</c:v>
                </c:pt>
                <c:pt idx="5854">
                  <c:v>9.6145998954773013</c:v>
                </c:pt>
                <c:pt idx="5855">
                  <c:v>7.3971997404099028</c:v>
                </c:pt>
                <c:pt idx="5856">
                  <c:v>13.994000000953697</c:v>
                </c:pt>
                <c:pt idx="5857">
                  <c:v>11.179599933624303</c:v>
                </c:pt>
                <c:pt idx="5858">
                  <c:v>5.9751997709273965</c:v>
                </c:pt>
                <c:pt idx="5859">
                  <c:v>7.1429499101639031</c:v>
                </c:pt>
                <c:pt idx="5860">
                  <c:v>18.01410004615785</c:v>
                </c:pt>
                <c:pt idx="5861">
                  <c:v>4.7433997774123995</c:v>
                </c:pt>
                <c:pt idx="5862">
                  <c:v>9.0726499795914002</c:v>
                </c:pt>
                <c:pt idx="5863">
                  <c:v>6.695549826621999</c:v>
                </c:pt>
                <c:pt idx="5864">
                  <c:v>8.0442498588562046</c:v>
                </c:pt>
                <c:pt idx="5865">
                  <c:v>12.842349934577904</c:v>
                </c:pt>
                <c:pt idx="5866">
                  <c:v>5.9359498214721498</c:v>
                </c:pt>
                <c:pt idx="5867">
                  <c:v>13.48860000610355</c:v>
                </c:pt>
                <c:pt idx="5868">
                  <c:v>6.4655498361587007</c:v>
                </c:pt>
                <c:pt idx="5869">
                  <c:v>13.405599904060402</c:v>
                </c:pt>
                <c:pt idx="5870">
                  <c:v>11.210799875259401</c:v>
                </c:pt>
                <c:pt idx="5871">
                  <c:v>15.821300015449552</c:v>
                </c:pt>
                <c:pt idx="5872">
                  <c:v>8.8002999448776471</c:v>
                </c:pt>
                <c:pt idx="5873">
                  <c:v>9.8477499008178526</c:v>
                </c:pt>
                <c:pt idx="5874">
                  <c:v>6.158299965858447</c:v>
                </c:pt>
                <c:pt idx="5875">
                  <c:v>7.2797497034072975</c:v>
                </c:pt>
                <c:pt idx="5876">
                  <c:v>3.8207499647140004</c:v>
                </c:pt>
                <c:pt idx="5877">
                  <c:v>13.360699825286851</c:v>
                </c:pt>
                <c:pt idx="5878">
                  <c:v>2.2825998258590516</c:v>
                </c:pt>
                <c:pt idx="5879">
                  <c:v>7.8222499227523485</c:v>
                </c:pt>
                <c:pt idx="5880">
                  <c:v>2.5178498649597003</c:v>
                </c:pt>
                <c:pt idx="5881">
                  <c:v>7.5192999601364008</c:v>
                </c:pt>
                <c:pt idx="5882">
                  <c:v>12.534999928474502</c:v>
                </c:pt>
                <c:pt idx="5883">
                  <c:v>9.4832998341321986</c:v>
                </c:pt>
                <c:pt idx="5884">
                  <c:v>7.5767997312545461</c:v>
                </c:pt>
                <c:pt idx="5885">
                  <c:v>8.8847998571395514</c:v>
                </c:pt>
                <c:pt idx="5886">
                  <c:v>4.1342997360230029</c:v>
                </c:pt>
                <c:pt idx="5887">
                  <c:v>6.5411997461319018</c:v>
                </c:pt>
                <c:pt idx="5888">
                  <c:v>7.5748998165129997</c:v>
                </c:pt>
                <c:pt idx="5889">
                  <c:v>2.9752999448775981</c:v>
                </c:pt>
                <c:pt idx="5890">
                  <c:v>5.7863997983932514</c:v>
                </c:pt>
                <c:pt idx="5891">
                  <c:v>4.4678998565673531</c:v>
                </c:pt>
                <c:pt idx="5892">
                  <c:v>9.1970499038696012</c:v>
                </c:pt>
                <c:pt idx="5893">
                  <c:v>4.0220498609542972</c:v>
                </c:pt>
                <c:pt idx="5894">
                  <c:v>9.2486998176574495</c:v>
                </c:pt>
                <c:pt idx="5895">
                  <c:v>16.473100199699399</c:v>
                </c:pt>
                <c:pt idx="5896">
                  <c:v>5.6667997980117519</c:v>
                </c:pt>
                <c:pt idx="5897">
                  <c:v>3.7592497110366985</c:v>
                </c:pt>
                <c:pt idx="5898">
                  <c:v>6.1717998075485028</c:v>
                </c:pt>
                <c:pt idx="5899">
                  <c:v>3.0398996925353998</c:v>
                </c:pt>
                <c:pt idx="5900">
                  <c:v>4.8549997568130472</c:v>
                </c:pt>
                <c:pt idx="5901">
                  <c:v>7.5160997819900004</c:v>
                </c:pt>
                <c:pt idx="5902">
                  <c:v>6.0291496992111036</c:v>
                </c:pt>
                <c:pt idx="5903">
                  <c:v>5.8584998893737996</c:v>
                </c:pt>
                <c:pt idx="5904">
                  <c:v>8.5691497397422474</c:v>
                </c:pt>
                <c:pt idx="5905">
                  <c:v>2.8565499591827503</c:v>
                </c:pt>
                <c:pt idx="5906">
                  <c:v>7.3154498291015955</c:v>
                </c:pt>
                <c:pt idx="5907">
                  <c:v>7.1313498497009533</c:v>
                </c:pt>
                <c:pt idx="5908">
                  <c:v>8.5828497838974513</c:v>
                </c:pt>
                <c:pt idx="5909">
                  <c:v>11.311249794960055</c:v>
                </c:pt>
                <c:pt idx="5910">
                  <c:v>7.6743998336791464</c:v>
                </c:pt>
                <c:pt idx="5911">
                  <c:v>4.9236498618125992</c:v>
                </c:pt>
                <c:pt idx="5912">
                  <c:v>5.2738497495651515</c:v>
                </c:pt>
                <c:pt idx="5913">
                  <c:v>5.6386498832702507</c:v>
                </c:pt>
                <c:pt idx="5914">
                  <c:v>3.4948500108719003</c:v>
                </c:pt>
                <c:pt idx="5915">
                  <c:v>3.6443998050689501</c:v>
                </c:pt>
                <c:pt idx="5916">
                  <c:v>6.1612497949600495</c:v>
                </c:pt>
                <c:pt idx="5917">
                  <c:v>6.5737996578217022</c:v>
                </c:pt>
                <c:pt idx="5918">
                  <c:v>7.5038498306274448</c:v>
                </c:pt>
                <c:pt idx="5919">
                  <c:v>5.5406997203826478</c:v>
                </c:pt>
                <c:pt idx="5920">
                  <c:v>14.96860000610355</c:v>
                </c:pt>
                <c:pt idx="5921">
                  <c:v>8.6774498605727999</c:v>
                </c:pt>
                <c:pt idx="5922">
                  <c:v>6.9623998498916499</c:v>
                </c:pt>
                <c:pt idx="5923">
                  <c:v>9.7762000274658512</c:v>
                </c:pt>
                <c:pt idx="5924">
                  <c:v>5.2799998795986003</c:v>
                </c:pt>
                <c:pt idx="5925">
                  <c:v>10.34294978141785</c:v>
                </c:pt>
                <c:pt idx="5926">
                  <c:v>5.0590997838974019</c:v>
                </c:pt>
                <c:pt idx="5927">
                  <c:v>8.1314498615264554</c:v>
                </c:pt>
                <c:pt idx="5928">
                  <c:v>10.044999914169299</c:v>
                </c:pt>
                <c:pt idx="5929">
                  <c:v>5.7941498422622502</c:v>
                </c:pt>
                <c:pt idx="5930">
                  <c:v>11.75944976806645</c:v>
                </c:pt>
                <c:pt idx="5931">
                  <c:v>5.8188498115540028</c:v>
                </c:pt>
                <c:pt idx="5932">
                  <c:v>8.9652497816085486</c:v>
                </c:pt>
                <c:pt idx="5933">
                  <c:v>8.8805998802184973</c:v>
                </c:pt>
                <c:pt idx="5934">
                  <c:v>10.844949889183049</c:v>
                </c:pt>
                <c:pt idx="5935">
                  <c:v>12.995649781227097</c:v>
                </c:pt>
                <c:pt idx="5936">
                  <c:v>10.236499876976001</c:v>
                </c:pt>
                <c:pt idx="5937">
                  <c:v>38.958100147247301</c:v>
                </c:pt>
                <c:pt idx="5938">
                  <c:v>7.3275498342513998</c:v>
                </c:pt>
                <c:pt idx="5939">
                  <c:v>8.9444998693466502</c:v>
                </c:pt>
                <c:pt idx="5940">
                  <c:v>9.6146497201919487</c:v>
                </c:pt>
                <c:pt idx="5941">
                  <c:v>11.844249835014299</c:v>
                </c:pt>
                <c:pt idx="5942">
                  <c:v>5.0639498186110998</c:v>
                </c:pt>
                <c:pt idx="5943">
                  <c:v>4.0479998254776497</c:v>
                </c:pt>
                <c:pt idx="5944">
                  <c:v>16.303450193405148</c:v>
                </c:pt>
                <c:pt idx="5945">
                  <c:v>5.6262999153137514</c:v>
                </c:pt>
                <c:pt idx="5946">
                  <c:v>5.824649872779851</c:v>
                </c:pt>
                <c:pt idx="5947">
                  <c:v>13.789749994277948</c:v>
                </c:pt>
                <c:pt idx="5948">
                  <c:v>6.243149905204799</c:v>
                </c:pt>
                <c:pt idx="5949">
                  <c:v>7.9118496799469007</c:v>
                </c:pt>
                <c:pt idx="5950">
                  <c:v>7.1579998445510995</c:v>
                </c:pt>
                <c:pt idx="5951">
                  <c:v>5.6688997650146504</c:v>
                </c:pt>
                <c:pt idx="5952">
                  <c:v>5.6688997650146504</c:v>
                </c:pt>
                <c:pt idx="5953">
                  <c:v>8.5822997617721519</c:v>
                </c:pt>
                <c:pt idx="5954">
                  <c:v>7.7560998630523983</c:v>
                </c:pt>
                <c:pt idx="5955">
                  <c:v>2.6527498817443984</c:v>
                </c:pt>
                <c:pt idx="5956">
                  <c:v>5.0359499645233505</c:v>
                </c:pt>
                <c:pt idx="5957">
                  <c:v>6.1800999450683491</c:v>
                </c:pt>
                <c:pt idx="5958">
                  <c:v>3.9318997859955545</c:v>
                </c:pt>
                <c:pt idx="5959">
                  <c:v>5.7626000356674005</c:v>
                </c:pt>
                <c:pt idx="5960">
                  <c:v>2.3123497152329016</c:v>
                </c:pt>
                <c:pt idx="5961">
                  <c:v>4.7199497461318956</c:v>
                </c:pt>
                <c:pt idx="5962">
                  <c:v>8.104199814796452</c:v>
                </c:pt>
                <c:pt idx="5963">
                  <c:v>7.2671998023986504</c:v>
                </c:pt>
                <c:pt idx="5964">
                  <c:v>5.3618497800827001</c:v>
                </c:pt>
                <c:pt idx="5965">
                  <c:v>5.5733998823166004</c:v>
                </c:pt>
                <c:pt idx="5966">
                  <c:v>10.539799914359996</c:v>
                </c:pt>
                <c:pt idx="5967">
                  <c:v>10.925899844169649</c:v>
                </c:pt>
                <c:pt idx="5968">
                  <c:v>3.2611999654769974</c:v>
                </c:pt>
                <c:pt idx="5969">
                  <c:v>5.1874998903275014</c:v>
                </c:pt>
                <c:pt idx="5970">
                  <c:v>4.0729497981071496</c:v>
                </c:pt>
                <c:pt idx="5971">
                  <c:v>7.7590499353409008</c:v>
                </c:pt>
                <c:pt idx="5972">
                  <c:v>8.0722497749328994</c:v>
                </c:pt>
                <c:pt idx="5973">
                  <c:v>11.795499806404052</c:v>
                </c:pt>
                <c:pt idx="5974">
                  <c:v>7.2299499225615982</c:v>
                </c:pt>
                <c:pt idx="5975">
                  <c:v>3.0890000295638984</c:v>
                </c:pt>
                <c:pt idx="5976">
                  <c:v>9.5413999462127492</c:v>
                </c:pt>
                <c:pt idx="5977">
                  <c:v>7.5622498893737955</c:v>
                </c:pt>
                <c:pt idx="5978">
                  <c:v>6.4939997768402513</c:v>
                </c:pt>
                <c:pt idx="5979">
                  <c:v>6.6781497573852491</c:v>
                </c:pt>
                <c:pt idx="5980">
                  <c:v>6.4437998819351492</c:v>
                </c:pt>
                <c:pt idx="5981">
                  <c:v>4.5072998476028481</c:v>
                </c:pt>
                <c:pt idx="5982">
                  <c:v>7.8159998941421485</c:v>
                </c:pt>
                <c:pt idx="5983">
                  <c:v>4.8353498792647969</c:v>
                </c:pt>
                <c:pt idx="5984">
                  <c:v>6.4911496210098463</c:v>
                </c:pt>
                <c:pt idx="5985">
                  <c:v>4.6293497371673489</c:v>
                </c:pt>
                <c:pt idx="5986">
                  <c:v>13.838599946498899</c:v>
                </c:pt>
                <c:pt idx="5987">
                  <c:v>5.0440497827530031</c:v>
                </c:pt>
                <c:pt idx="5988">
                  <c:v>7.9800498795509505</c:v>
                </c:pt>
                <c:pt idx="5989">
                  <c:v>3.5907998961210481</c:v>
                </c:pt>
                <c:pt idx="5990">
                  <c:v>8.6618499231338504</c:v>
                </c:pt>
                <c:pt idx="5991">
                  <c:v>5.6658498144149974</c:v>
                </c:pt>
                <c:pt idx="5992">
                  <c:v>39.858399884700745</c:v>
                </c:pt>
                <c:pt idx="5993">
                  <c:v>38.826749949455248</c:v>
                </c:pt>
                <c:pt idx="5994">
                  <c:v>0.52545000731945057</c:v>
                </c:pt>
                <c:pt idx="5995">
                  <c:v>0.564399998188019</c:v>
                </c:pt>
                <c:pt idx="5996">
                  <c:v>-8.1250000000000488E-2</c:v>
                </c:pt>
                <c:pt idx="5997">
                  <c:v>40.707200057506583</c:v>
                </c:pt>
                <c:pt idx="5998">
                  <c:v>0</c:v>
                </c:pt>
                <c:pt idx="5999">
                  <c:v>0</c:v>
                </c:pt>
                <c:pt idx="6000">
                  <c:v>0</c:v>
                </c:pt>
                <c:pt idx="6001">
                  <c:v>0</c:v>
                </c:pt>
                <c:pt idx="6002">
                  <c:v>0</c:v>
                </c:pt>
                <c:pt idx="6003">
                  <c:v>0</c:v>
                </c:pt>
                <c:pt idx="6004">
                  <c:v>0</c:v>
                </c:pt>
                <c:pt idx="6005">
                  <c:v>0</c:v>
                </c:pt>
                <c:pt idx="6006">
                  <c:v>0</c:v>
                </c:pt>
                <c:pt idx="6007">
                  <c:v>0</c:v>
                </c:pt>
                <c:pt idx="6008">
                  <c:v>0</c:v>
                </c:pt>
                <c:pt idx="6009">
                  <c:v>0</c:v>
                </c:pt>
                <c:pt idx="6010">
                  <c:v>0</c:v>
                </c:pt>
                <c:pt idx="6011">
                  <c:v>0</c:v>
                </c:pt>
                <c:pt idx="6012">
                  <c:v>0</c:v>
                </c:pt>
                <c:pt idx="6013">
                  <c:v>0</c:v>
                </c:pt>
                <c:pt idx="6014">
                  <c:v>0</c:v>
                </c:pt>
                <c:pt idx="6015">
                  <c:v>0</c:v>
                </c:pt>
                <c:pt idx="6016">
                  <c:v>0</c:v>
                </c:pt>
                <c:pt idx="6017">
                  <c:v>0</c:v>
                </c:pt>
              </c:numCache>
            </c:numRef>
          </c:xVal>
          <c:yVal>
            <c:numRef>
              <c:f>'sacCer3_quantified Set1 in -100'!$Y$2:$Y$6019</c:f>
              <c:numCache>
                <c:formatCode>General</c:formatCode>
                <c:ptCount val="6018"/>
                <c:pt idx="0">
                  <c:v>182.08625165939304</c:v>
                </c:pt>
                <c:pt idx="1">
                  <c:v>159.41795034408568</c:v>
                </c:pt>
                <c:pt idx="2">
                  <c:v>88.757250299454228</c:v>
                </c:pt>
                <c:pt idx="3">
                  <c:v>82.613100469112595</c:v>
                </c:pt>
                <c:pt idx="4">
                  <c:v>79.772049913406278</c:v>
                </c:pt>
                <c:pt idx="5">
                  <c:v>136.38564931869473</c:v>
                </c:pt>
                <c:pt idx="6">
                  <c:v>76.519099999665769</c:v>
                </c:pt>
                <c:pt idx="7">
                  <c:v>139.06264983177169</c:v>
                </c:pt>
                <c:pt idx="8">
                  <c:v>54.816399426459981</c:v>
                </c:pt>
                <c:pt idx="9">
                  <c:v>130.27449927330019</c:v>
                </c:pt>
                <c:pt idx="10">
                  <c:v>129.01439986705805</c:v>
                </c:pt>
                <c:pt idx="11">
                  <c:v>120.75009995460471</c:v>
                </c:pt>
                <c:pt idx="12">
                  <c:v>116.51620012283324</c:v>
                </c:pt>
                <c:pt idx="13">
                  <c:v>115.14160008907334</c:v>
                </c:pt>
                <c:pt idx="14">
                  <c:v>66.983399581909111</c:v>
                </c:pt>
                <c:pt idx="15">
                  <c:v>112.22335029602036</c:v>
                </c:pt>
                <c:pt idx="16">
                  <c:v>63.395199737548822</c:v>
                </c:pt>
                <c:pt idx="17">
                  <c:v>114.31080022811916</c:v>
                </c:pt>
                <c:pt idx="18">
                  <c:v>97.12755015373213</c:v>
                </c:pt>
                <c:pt idx="19">
                  <c:v>98.53590024471265</c:v>
                </c:pt>
                <c:pt idx="20">
                  <c:v>92.335200023650955</c:v>
                </c:pt>
                <c:pt idx="21">
                  <c:v>40.220199851989804</c:v>
                </c:pt>
                <c:pt idx="22">
                  <c:v>90.483549947738553</c:v>
                </c:pt>
                <c:pt idx="23">
                  <c:v>89.503049879074013</c:v>
                </c:pt>
                <c:pt idx="24">
                  <c:v>86.626300363540253</c:v>
                </c:pt>
                <c:pt idx="25">
                  <c:v>86.32695040702842</c:v>
                </c:pt>
                <c:pt idx="26">
                  <c:v>83.088949937820246</c:v>
                </c:pt>
                <c:pt idx="27">
                  <c:v>83.859949965477142</c:v>
                </c:pt>
                <c:pt idx="28">
                  <c:v>86.494499936103693</c:v>
                </c:pt>
                <c:pt idx="29">
                  <c:v>79.085550251006595</c:v>
                </c:pt>
                <c:pt idx="30">
                  <c:v>80.012600107193151</c:v>
                </c:pt>
                <c:pt idx="31">
                  <c:v>80.784000120162801</c:v>
                </c:pt>
                <c:pt idx="32">
                  <c:v>80.73139986038214</c:v>
                </c:pt>
                <c:pt idx="33">
                  <c:v>78.264800004959056</c:v>
                </c:pt>
                <c:pt idx="34">
                  <c:v>77.266550145149196</c:v>
                </c:pt>
                <c:pt idx="35">
                  <c:v>74.367450022697298</c:v>
                </c:pt>
                <c:pt idx="36">
                  <c:v>74.1727502155303</c:v>
                </c:pt>
                <c:pt idx="37">
                  <c:v>73.801200227737553</c:v>
                </c:pt>
                <c:pt idx="38">
                  <c:v>78.37009982109069</c:v>
                </c:pt>
                <c:pt idx="39">
                  <c:v>68.803050146102763</c:v>
                </c:pt>
                <c:pt idx="40">
                  <c:v>70.659750165939343</c:v>
                </c:pt>
                <c:pt idx="41">
                  <c:v>70.064350070953452</c:v>
                </c:pt>
                <c:pt idx="42">
                  <c:v>73.528100018501391</c:v>
                </c:pt>
                <c:pt idx="43">
                  <c:v>69.671800107956201</c:v>
                </c:pt>
                <c:pt idx="44">
                  <c:v>70.286649637222197</c:v>
                </c:pt>
                <c:pt idx="45">
                  <c:v>68.232099790573258</c:v>
                </c:pt>
                <c:pt idx="46">
                  <c:v>73.88279979705824</c:v>
                </c:pt>
                <c:pt idx="47">
                  <c:v>64.045600290298609</c:v>
                </c:pt>
                <c:pt idx="48">
                  <c:v>66.558850383758369</c:v>
                </c:pt>
                <c:pt idx="49">
                  <c:v>66.911500148773158</c:v>
                </c:pt>
                <c:pt idx="50">
                  <c:v>69.272999877929465</c:v>
                </c:pt>
                <c:pt idx="51">
                  <c:v>65.856900115013246</c:v>
                </c:pt>
                <c:pt idx="52">
                  <c:v>65.973500003814948</c:v>
                </c:pt>
                <c:pt idx="53">
                  <c:v>62.145450115203602</c:v>
                </c:pt>
                <c:pt idx="54">
                  <c:v>67.917050061225993</c:v>
                </c:pt>
                <c:pt idx="55">
                  <c:v>60.841800012588401</c:v>
                </c:pt>
                <c:pt idx="56">
                  <c:v>59.976899881363103</c:v>
                </c:pt>
                <c:pt idx="57">
                  <c:v>59.965550174713343</c:v>
                </c:pt>
                <c:pt idx="58">
                  <c:v>62.061299858093292</c:v>
                </c:pt>
                <c:pt idx="59">
                  <c:v>58.459899969101102</c:v>
                </c:pt>
                <c:pt idx="60">
                  <c:v>59.443999948501691</c:v>
                </c:pt>
                <c:pt idx="61">
                  <c:v>53.31824961662295</c:v>
                </c:pt>
                <c:pt idx="62">
                  <c:v>55.546450219154387</c:v>
                </c:pt>
                <c:pt idx="63">
                  <c:v>57.086050014495797</c:v>
                </c:pt>
                <c:pt idx="64">
                  <c:v>53.298700103759757</c:v>
                </c:pt>
                <c:pt idx="65">
                  <c:v>55.235650143623403</c:v>
                </c:pt>
                <c:pt idx="66">
                  <c:v>55.022550277709961</c:v>
                </c:pt>
                <c:pt idx="67">
                  <c:v>52.7463496017456</c:v>
                </c:pt>
                <c:pt idx="68">
                  <c:v>51.885749950408993</c:v>
                </c:pt>
                <c:pt idx="69">
                  <c:v>55.327499814033651</c:v>
                </c:pt>
                <c:pt idx="70">
                  <c:v>53.081849985122552</c:v>
                </c:pt>
                <c:pt idx="71">
                  <c:v>55.377349853515661</c:v>
                </c:pt>
                <c:pt idx="72">
                  <c:v>54.092600002288805</c:v>
                </c:pt>
                <c:pt idx="73">
                  <c:v>53.614549903869644</c:v>
                </c:pt>
                <c:pt idx="74">
                  <c:v>54.875649871826155</c:v>
                </c:pt>
                <c:pt idx="75">
                  <c:v>53.412649850845298</c:v>
                </c:pt>
                <c:pt idx="76">
                  <c:v>53.994349999427754</c:v>
                </c:pt>
                <c:pt idx="77">
                  <c:v>50.605050029754651</c:v>
                </c:pt>
                <c:pt idx="78">
                  <c:v>55.449400234222402</c:v>
                </c:pt>
                <c:pt idx="79">
                  <c:v>53.043749895095843</c:v>
                </c:pt>
                <c:pt idx="80">
                  <c:v>52.155199918746952</c:v>
                </c:pt>
                <c:pt idx="81">
                  <c:v>51.435199804306095</c:v>
                </c:pt>
                <c:pt idx="82">
                  <c:v>52.403349776268001</c:v>
                </c:pt>
                <c:pt idx="83">
                  <c:v>50.646850066184996</c:v>
                </c:pt>
                <c:pt idx="84">
                  <c:v>50.554699935913042</c:v>
                </c:pt>
                <c:pt idx="85">
                  <c:v>47.234750223159793</c:v>
                </c:pt>
                <c:pt idx="86">
                  <c:v>49.052600264549291</c:v>
                </c:pt>
                <c:pt idx="87">
                  <c:v>50.766200027465842</c:v>
                </c:pt>
                <c:pt idx="88">
                  <c:v>49.476699852943398</c:v>
                </c:pt>
                <c:pt idx="89">
                  <c:v>47.685450181961052</c:v>
                </c:pt>
                <c:pt idx="90">
                  <c:v>44.449850063323943</c:v>
                </c:pt>
                <c:pt idx="91">
                  <c:v>45.984500117301955</c:v>
                </c:pt>
                <c:pt idx="92">
                  <c:v>50.104350194931001</c:v>
                </c:pt>
                <c:pt idx="93">
                  <c:v>46.930900096893353</c:v>
                </c:pt>
                <c:pt idx="94">
                  <c:v>52.092600045204193</c:v>
                </c:pt>
                <c:pt idx="95">
                  <c:v>47.877899808883654</c:v>
                </c:pt>
                <c:pt idx="96">
                  <c:v>47.3498002052307</c:v>
                </c:pt>
                <c:pt idx="97">
                  <c:v>45.674350013732948</c:v>
                </c:pt>
                <c:pt idx="98">
                  <c:v>50.120900073051395</c:v>
                </c:pt>
                <c:pt idx="99">
                  <c:v>43.914299683570846</c:v>
                </c:pt>
                <c:pt idx="100">
                  <c:v>47.8543499183655</c:v>
                </c:pt>
                <c:pt idx="101">
                  <c:v>45.419000349044744</c:v>
                </c:pt>
                <c:pt idx="102">
                  <c:v>49.077049779892</c:v>
                </c:pt>
                <c:pt idx="103">
                  <c:v>45.973299961090099</c:v>
                </c:pt>
                <c:pt idx="104">
                  <c:v>49.31449999332424</c:v>
                </c:pt>
                <c:pt idx="105">
                  <c:v>48.07290017127994</c:v>
                </c:pt>
                <c:pt idx="106">
                  <c:v>46.959599990844701</c:v>
                </c:pt>
                <c:pt idx="107">
                  <c:v>42.098600172996491</c:v>
                </c:pt>
                <c:pt idx="108">
                  <c:v>40.635650095939646</c:v>
                </c:pt>
                <c:pt idx="109">
                  <c:v>46.102950325012195</c:v>
                </c:pt>
                <c:pt idx="110">
                  <c:v>47.17979985237114</c:v>
                </c:pt>
                <c:pt idx="111">
                  <c:v>46.92084977149964</c:v>
                </c:pt>
                <c:pt idx="112">
                  <c:v>45.497249917983993</c:v>
                </c:pt>
                <c:pt idx="113">
                  <c:v>43.753550024032606</c:v>
                </c:pt>
                <c:pt idx="114">
                  <c:v>41.477100133895853</c:v>
                </c:pt>
                <c:pt idx="115">
                  <c:v>45.307599935531606</c:v>
                </c:pt>
                <c:pt idx="116">
                  <c:v>44.262500023841852</c:v>
                </c:pt>
                <c:pt idx="117">
                  <c:v>42.174549789428703</c:v>
                </c:pt>
                <c:pt idx="118">
                  <c:v>43.730350036621097</c:v>
                </c:pt>
                <c:pt idx="119">
                  <c:v>46.19194995403285</c:v>
                </c:pt>
                <c:pt idx="120">
                  <c:v>43.018300299644451</c:v>
                </c:pt>
                <c:pt idx="121">
                  <c:v>42.599799871444702</c:v>
                </c:pt>
                <c:pt idx="122">
                  <c:v>42.322550120353654</c:v>
                </c:pt>
                <c:pt idx="123">
                  <c:v>41.361900053024293</c:v>
                </c:pt>
                <c:pt idx="124">
                  <c:v>40.9011998701096</c:v>
                </c:pt>
                <c:pt idx="125">
                  <c:v>38.601799945831303</c:v>
                </c:pt>
                <c:pt idx="126">
                  <c:v>41.165749988555959</c:v>
                </c:pt>
                <c:pt idx="127">
                  <c:v>42.211949710845943</c:v>
                </c:pt>
                <c:pt idx="128">
                  <c:v>40.630849728584337</c:v>
                </c:pt>
                <c:pt idx="129">
                  <c:v>40.683150119781544</c:v>
                </c:pt>
                <c:pt idx="130">
                  <c:v>42.926649932861295</c:v>
                </c:pt>
                <c:pt idx="131">
                  <c:v>41.565899968147249</c:v>
                </c:pt>
                <c:pt idx="132">
                  <c:v>40.676150064468395</c:v>
                </c:pt>
                <c:pt idx="133">
                  <c:v>41.850399966239948</c:v>
                </c:pt>
                <c:pt idx="134">
                  <c:v>39.125999960899293</c:v>
                </c:pt>
                <c:pt idx="135">
                  <c:v>42.239699964523297</c:v>
                </c:pt>
                <c:pt idx="136">
                  <c:v>39.435400214195305</c:v>
                </c:pt>
                <c:pt idx="137">
                  <c:v>43.952550134658807</c:v>
                </c:pt>
                <c:pt idx="138">
                  <c:v>40.053350200653107</c:v>
                </c:pt>
                <c:pt idx="139">
                  <c:v>41.090900077819796</c:v>
                </c:pt>
                <c:pt idx="140">
                  <c:v>41.731900172233594</c:v>
                </c:pt>
                <c:pt idx="141">
                  <c:v>39.742199621200605</c:v>
                </c:pt>
                <c:pt idx="142">
                  <c:v>40.922749938964891</c:v>
                </c:pt>
                <c:pt idx="143">
                  <c:v>40.155000143051211</c:v>
                </c:pt>
                <c:pt idx="144">
                  <c:v>40.836249828338651</c:v>
                </c:pt>
                <c:pt idx="145">
                  <c:v>42.380699849128753</c:v>
                </c:pt>
                <c:pt idx="146">
                  <c:v>36.940000095367452</c:v>
                </c:pt>
                <c:pt idx="147">
                  <c:v>40.596850204467742</c:v>
                </c:pt>
                <c:pt idx="148">
                  <c:v>39.597000179290745</c:v>
                </c:pt>
                <c:pt idx="149">
                  <c:v>40.54109993934631</c:v>
                </c:pt>
                <c:pt idx="150">
                  <c:v>41.020350122451802</c:v>
                </c:pt>
                <c:pt idx="151">
                  <c:v>39.503899946212755</c:v>
                </c:pt>
                <c:pt idx="152">
                  <c:v>41.421849846839905</c:v>
                </c:pt>
                <c:pt idx="153">
                  <c:v>38.278749923706044</c:v>
                </c:pt>
                <c:pt idx="154">
                  <c:v>31.949049882888751</c:v>
                </c:pt>
                <c:pt idx="155">
                  <c:v>39.493950223922695</c:v>
                </c:pt>
                <c:pt idx="156">
                  <c:v>38.995449943542496</c:v>
                </c:pt>
                <c:pt idx="157">
                  <c:v>40.098950004577603</c:v>
                </c:pt>
                <c:pt idx="158">
                  <c:v>38.125500173568746</c:v>
                </c:pt>
                <c:pt idx="159">
                  <c:v>41.185749998092597</c:v>
                </c:pt>
                <c:pt idx="160">
                  <c:v>38.466600027084354</c:v>
                </c:pt>
                <c:pt idx="161">
                  <c:v>40.747799873352051</c:v>
                </c:pt>
                <c:pt idx="162">
                  <c:v>39.002950077056852</c:v>
                </c:pt>
                <c:pt idx="163">
                  <c:v>37.21940016269685</c:v>
                </c:pt>
                <c:pt idx="164">
                  <c:v>33.964600195884699</c:v>
                </c:pt>
                <c:pt idx="165">
                  <c:v>37.2775000810623</c:v>
                </c:pt>
                <c:pt idx="166">
                  <c:v>34.797399911880497</c:v>
                </c:pt>
                <c:pt idx="167">
                  <c:v>37.940200138092003</c:v>
                </c:pt>
                <c:pt idx="168">
                  <c:v>34.950149993896396</c:v>
                </c:pt>
                <c:pt idx="169">
                  <c:v>37.427900066375756</c:v>
                </c:pt>
                <c:pt idx="170">
                  <c:v>37.492600202560396</c:v>
                </c:pt>
                <c:pt idx="171">
                  <c:v>37.170750055313093</c:v>
                </c:pt>
                <c:pt idx="172">
                  <c:v>40.114949970245355</c:v>
                </c:pt>
                <c:pt idx="173">
                  <c:v>37.229849920272848</c:v>
                </c:pt>
                <c:pt idx="174">
                  <c:v>36.376850032806402</c:v>
                </c:pt>
                <c:pt idx="175">
                  <c:v>37.130050239562998</c:v>
                </c:pt>
                <c:pt idx="176">
                  <c:v>35.390949993278042</c:v>
                </c:pt>
                <c:pt idx="177">
                  <c:v>34.786000204086349</c:v>
                </c:pt>
                <c:pt idx="178">
                  <c:v>39.022100110053998</c:v>
                </c:pt>
                <c:pt idx="179">
                  <c:v>36.624450101852396</c:v>
                </c:pt>
                <c:pt idx="180">
                  <c:v>35.552400114536248</c:v>
                </c:pt>
                <c:pt idx="181">
                  <c:v>35.415649857521004</c:v>
                </c:pt>
                <c:pt idx="182">
                  <c:v>36.620349965095507</c:v>
                </c:pt>
                <c:pt idx="183">
                  <c:v>35.650149736404401</c:v>
                </c:pt>
                <c:pt idx="184">
                  <c:v>35.910450220108046</c:v>
                </c:pt>
                <c:pt idx="185">
                  <c:v>35.238849792480451</c:v>
                </c:pt>
                <c:pt idx="186">
                  <c:v>35.456600074768048</c:v>
                </c:pt>
                <c:pt idx="187">
                  <c:v>31.497300033569349</c:v>
                </c:pt>
                <c:pt idx="188">
                  <c:v>35.608499751090946</c:v>
                </c:pt>
                <c:pt idx="189">
                  <c:v>34.147950091361999</c:v>
                </c:pt>
                <c:pt idx="190">
                  <c:v>35.0304499816895</c:v>
                </c:pt>
                <c:pt idx="191">
                  <c:v>36.414499974250852</c:v>
                </c:pt>
                <c:pt idx="192">
                  <c:v>34.96010000705715</c:v>
                </c:pt>
                <c:pt idx="193">
                  <c:v>32.695700187683151</c:v>
                </c:pt>
                <c:pt idx="194">
                  <c:v>33.638699927330052</c:v>
                </c:pt>
                <c:pt idx="195">
                  <c:v>36.885099844932554</c:v>
                </c:pt>
                <c:pt idx="196">
                  <c:v>34.421150126457249</c:v>
                </c:pt>
                <c:pt idx="197">
                  <c:v>36.010949983596845</c:v>
                </c:pt>
                <c:pt idx="198">
                  <c:v>30.971300172805805</c:v>
                </c:pt>
                <c:pt idx="199">
                  <c:v>33.438000164031997</c:v>
                </c:pt>
                <c:pt idx="200">
                  <c:v>31.707399897575407</c:v>
                </c:pt>
                <c:pt idx="201">
                  <c:v>33.366050148010245</c:v>
                </c:pt>
                <c:pt idx="202">
                  <c:v>32.548349800109847</c:v>
                </c:pt>
                <c:pt idx="203">
                  <c:v>31.222700119018604</c:v>
                </c:pt>
                <c:pt idx="204">
                  <c:v>34.695700149536108</c:v>
                </c:pt>
                <c:pt idx="205">
                  <c:v>33.688100056648253</c:v>
                </c:pt>
                <c:pt idx="206">
                  <c:v>34.463100218772851</c:v>
                </c:pt>
                <c:pt idx="207">
                  <c:v>28.832749977111803</c:v>
                </c:pt>
                <c:pt idx="208">
                  <c:v>31.134050140380857</c:v>
                </c:pt>
                <c:pt idx="209">
                  <c:v>34.211250081062303</c:v>
                </c:pt>
                <c:pt idx="210">
                  <c:v>34.025899991989107</c:v>
                </c:pt>
                <c:pt idx="211">
                  <c:v>33.392949762344301</c:v>
                </c:pt>
                <c:pt idx="212">
                  <c:v>31.256099877357503</c:v>
                </c:pt>
                <c:pt idx="213">
                  <c:v>31.19785024642945</c:v>
                </c:pt>
                <c:pt idx="214">
                  <c:v>32.813349838256848</c:v>
                </c:pt>
                <c:pt idx="215">
                  <c:v>29.995200066566497</c:v>
                </c:pt>
                <c:pt idx="216">
                  <c:v>31.924100155830402</c:v>
                </c:pt>
                <c:pt idx="217">
                  <c:v>31.654799861907946</c:v>
                </c:pt>
                <c:pt idx="218">
                  <c:v>29.143600053787196</c:v>
                </c:pt>
                <c:pt idx="219">
                  <c:v>34.140899930000352</c:v>
                </c:pt>
                <c:pt idx="220">
                  <c:v>30.236800003051748</c:v>
                </c:pt>
                <c:pt idx="221">
                  <c:v>32.903250041008</c:v>
                </c:pt>
                <c:pt idx="222">
                  <c:v>32.520450067520159</c:v>
                </c:pt>
                <c:pt idx="223">
                  <c:v>25.277650060653702</c:v>
                </c:pt>
                <c:pt idx="224">
                  <c:v>29.769699897766152</c:v>
                </c:pt>
                <c:pt idx="225">
                  <c:v>33.666750092506405</c:v>
                </c:pt>
                <c:pt idx="226">
                  <c:v>26.090350117683442</c:v>
                </c:pt>
                <c:pt idx="227">
                  <c:v>30.587150011062597</c:v>
                </c:pt>
                <c:pt idx="228">
                  <c:v>30.82994991779325</c:v>
                </c:pt>
                <c:pt idx="229">
                  <c:v>30.575899925231944</c:v>
                </c:pt>
                <c:pt idx="230">
                  <c:v>29.981449842453003</c:v>
                </c:pt>
                <c:pt idx="231">
                  <c:v>31.604300122261048</c:v>
                </c:pt>
                <c:pt idx="232">
                  <c:v>25.572550067901602</c:v>
                </c:pt>
                <c:pt idx="233">
                  <c:v>-39.547399897575453</c:v>
                </c:pt>
                <c:pt idx="234">
                  <c:v>30.699699869155904</c:v>
                </c:pt>
                <c:pt idx="235">
                  <c:v>29.250300111770596</c:v>
                </c:pt>
                <c:pt idx="236">
                  <c:v>31.776449713706953</c:v>
                </c:pt>
                <c:pt idx="237">
                  <c:v>27.006650176048304</c:v>
                </c:pt>
                <c:pt idx="238">
                  <c:v>27.718299970626799</c:v>
                </c:pt>
                <c:pt idx="239">
                  <c:v>28.864799680709851</c:v>
                </c:pt>
                <c:pt idx="240">
                  <c:v>27.450599780082698</c:v>
                </c:pt>
                <c:pt idx="241">
                  <c:v>26.959600052833501</c:v>
                </c:pt>
                <c:pt idx="242">
                  <c:v>28.339349837303196</c:v>
                </c:pt>
                <c:pt idx="243">
                  <c:v>26.2719000339508</c:v>
                </c:pt>
                <c:pt idx="244">
                  <c:v>26.955199990272554</c:v>
                </c:pt>
                <c:pt idx="245">
                  <c:v>28.135800218582098</c:v>
                </c:pt>
                <c:pt idx="246">
                  <c:v>25.036450023651099</c:v>
                </c:pt>
                <c:pt idx="247">
                  <c:v>31.866900119781505</c:v>
                </c:pt>
                <c:pt idx="248">
                  <c:v>28.114300093650797</c:v>
                </c:pt>
                <c:pt idx="249">
                  <c:v>30.168649826049801</c:v>
                </c:pt>
                <c:pt idx="250">
                  <c:v>25.548849935531603</c:v>
                </c:pt>
                <c:pt idx="251">
                  <c:v>27.709899752140096</c:v>
                </c:pt>
                <c:pt idx="252">
                  <c:v>24.9888000106811</c:v>
                </c:pt>
                <c:pt idx="253">
                  <c:v>28.373150105476405</c:v>
                </c:pt>
                <c:pt idx="254">
                  <c:v>30.188450059890698</c:v>
                </c:pt>
                <c:pt idx="255">
                  <c:v>24.482250041961656</c:v>
                </c:pt>
                <c:pt idx="256">
                  <c:v>15.127299928665153</c:v>
                </c:pt>
                <c:pt idx="257">
                  <c:v>24.6637999343872</c:v>
                </c:pt>
                <c:pt idx="258">
                  <c:v>28.5165499210358</c:v>
                </c:pt>
                <c:pt idx="259">
                  <c:v>28.045949759483356</c:v>
                </c:pt>
                <c:pt idx="260">
                  <c:v>23.909100036621105</c:v>
                </c:pt>
                <c:pt idx="261">
                  <c:v>28.322100224494953</c:v>
                </c:pt>
                <c:pt idx="262">
                  <c:v>29.344899926185601</c:v>
                </c:pt>
                <c:pt idx="263">
                  <c:v>27.039449920654299</c:v>
                </c:pt>
                <c:pt idx="264">
                  <c:v>26.031799898147547</c:v>
                </c:pt>
                <c:pt idx="265">
                  <c:v>25.210499911308254</c:v>
                </c:pt>
                <c:pt idx="266">
                  <c:v>27.289850106239346</c:v>
                </c:pt>
                <c:pt idx="267">
                  <c:v>28.323149857521052</c:v>
                </c:pt>
                <c:pt idx="268">
                  <c:v>28.507549791336054</c:v>
                </c:pt>
                <c:pt idx="269">
                  <c:v>26.983850049972549</c:v>
                </c:pt>
                <c:pt idx="270">
                  <c:v>23.75414999008175</c:v>
                </c:pt>
                <c:pt idx="271">
                  <c:v>26.733100008964499</c:v>
                </c:pt>
                <c:pt idx="272">
                  <c:v>25.250299830436703</c:v>
                </c:pt>
                <c:pt idx="273">
                  <c:v>25.76554987907415</c:v>
                </c:pt>
                <c:pt idx="274">
                  <c:v>27.123699984550449</c:v>
                </c:pt>
                <c:pt idx="275">
                  <c:v>28.980300083160401</c:v>
                </c:pt>
                <c:pt idx="276">
                  <c:v>25.353449859619154</c:v>
                </c:pt>
                <c:pt idx="277">
                  <c:v>16.231650094985952</c:v>
                </c:pt>
                <c:pt idx="278">
                  <c:v>25.175449972152649</c:v>
                </c:pt>
                <c:pt idx="279">
                  <c:v>21.661699905395501</c:v>
                </c:pt>
                <c:pt idx="280">
                  <c:v>27.917249951362603</c:v>
                </c:pt>
                <c:pt idx="281">
                  <c:v>25.196250128746048</c:v>
                </c:pt>
                <c:pt idx="282">
                  <c:v>24.090749926567099</c:v>
                </c:pt>
                <c:pt idx="283">
                  <c:v>25.919300017356854</c:v>
                </c:pt>
                <c:pt idx="284">
                  <c:v>27.187250189781196</c:v>
                </c:pt>
                <c:pt idx="285">
                  <c:v>21.678850226402304</c:v>
                </c:pt>
                <c:pt idx="286">
                  <c:v>21.80570011138915</c:v>
                </c:pt>
                <c:pt idx="287">
                  <c:v>24.849950065612806</c:v>
                </c:pt>
                <c:pt idx="288">
                  <c:v>27.863849925994849</c:v>
                </c:pt>
                <c:pt idx="289">
                  <c:v>19.833250145912146</c:v>
                </c:pt>
                <c:pt idx="290">
                  <c:v>25.826949934959401</c:v>
                </c:pt>
                <c:pt idx="291">
                  <c:v>24.419149875640848</c:v>
                </c:pt>
                <c:pt idx="292">
                  <c:v>28.580550241470348</c:v>
                </c:pt>
                <c:pt idx="293">
                  <c:v>24.446800127029448</c:v>
                </c:pt>
                <c:pt idx="294">
                  <c:v>15.4415500688553</c:v>
                </c:pt>
                <c:pt idx="295">
                  <c:v>24.305949940681451</c:v>
                </c:pt>
                <c:pt idx="296">
                  <c:v>24.036750040054301</c:v>
                </c:pt>
                <c:pt idx="297">
                  <c:v>26.323049936294602</c:v>
                </c:pt>
                <c:pt idx="298">
                  <c:v>23.598099970817554</c:v>
                </c:pt>
                <c:pt idx="299">
                  <c:v>24.913949956893905</c:v>
                </c:pt>
                <c:pt idx="300">
                  <c:v>26.022449903488194</c:v>
                </c:pt>
                <c:pt idx="301">
                  <c:v>25.997049922943098</c:v>
                </c:pt>
                <c:pt idx="302">
                  <c:v>25.630950150489795</c:v>
                </c:pt>
                <c:pt idx="303">
                  <c:v>23.029099912643403</c:v>
                </c:pt>
                <c:pt idx="304">
                  <c:v>24.028900041580201</c:v>
                </c:pt>
                <c:pt idx="305">
                  <c:v>25.713350000381446</c:v>
                </c:pt>
                <c:pt idx="306">
                  <c:v>24.151599922180097</c:v>
                </c:pt>
                <c:pt idx="307">
                  <c:v>26.279450016021752</c:v>
                </c:pt>
                <c:pt idx="308">
                  <c:v>25.153499941825846</c:v>
                </c:pt>
                <c:pt idx="309">
                  <c:v>24.074400024414103</c:v>
                </c:pt>
                <c:pt idx="310">
                  <c:v>24.421349949836703</c:v>
                </c:pt>
                <c:pt idx="311">
                  <c:v>22.938200030326847</c:v>
                </c:pt>
                <c:pt idx="312">
                  <c:v>28.09335013389585</c:v>
                </c:pt>
                <c:pt idx="313">
                  <c:v>23.451749777793946</c:v>
                </c:pt>
                <c:pt idx="314">
                  <c:v>24.563149895668055</c:v>
                </c:pt>
                <c:pt idx="315">
                  <c:v>23.049799718856747</c:v>
                </c:pt>
                <c:pt idx="316">
                  <c:v>21.732450032234198</c:v>
                </c:pt>
                <c:pt idx="317">
                  <c:v>25.741800060272155</c:v>
                </c:pt>
                <c:pt idx="318">
                  <c:v>27.339699981212696</c:v>
                </c:pt>
                <c:pt idx="319">
                  <c:v>26.848299880027852</c:v>
                </c:pt>
                <c:pt idx="320">
                  <c:v>22.262449846267749</c:v>
                </c:pt>
                <c:pt idx="321">
                  <c:v>21.99930000782015</c:v>
                </c:pt>
                <c:pt idx="322">
                  <c:v>23.635700058937104</c:v>
                </c:pt>
                <c:pt idx="323">
                  <c:v>22.58259997844695</c:v>
                </c:pt>
                <c:pt idx="324">
                  <c:v>23.514250059127804</c:v>
                </c:pt>
                <c:pt idx="325">
                  <c:v>22.012300062179555</c:v>
                </c:pt>
                <c:pt idx="326">
                  <c:v>26.042350039482148</c:v>
                </c:pt>
                <c:pt idx="327">
                  <c:v>24.556550014018995</c:v>
                </c:pt>
                <c:pt idx="328">
                  <c:v>21.338399934768702</c:v>
                </c:pt>
                <c:pt idx="329">
                  <c:v>18.200899906158448</c:v>
                </c:pt>
                <c:pt idx="330">
                  <c:v>22.571450037956247</c:v>
                </c:pt>
                <c:pt idx="331">
                  <c:v>23.222000036239596</c:v>
                </c:pt>
                <c:pt idx="332">
                  <c:v>23.433750085830653</c:v>
                </c:pt>
                <c:pt idx="333">
                  <c:v>10.932399969100899</c:v>
                </c:pt>
                <c:pt idx="334">
                  <c:v>10.932399969100899</c:v>
                </c:pt>
                <c:pt idx="335">
                  <c:v>21.224799947738603</c:v>
                </c:pt>
                <c:pt idx="336">
                  <c:v>21.292599892616252</c:v>
                </c:pt>
                <c:pt idx="337">
                  <c:v>16.35494987010955</c:v>
                </c:pt>
                <c:pt idx="338">
                  <c:v>13.696049952507</c:v>
                </c:pt>
                <c:pt idx="339">
                  <c:v>24.381400094032301</c:v>
                </c:pt>
                <c:pt idx="340">
                  <c:v>21.262100057601952</c:v>
                </c:pt>
                <c:pt idx="341">
                  <c:v>3.8145500755309953</c:v>
                </c:pt>
                <c:pt idx="342">
                  <c:v>21.565599942207349</c:v>
                </c:pt>
                <c:pt idx="343">
                  <c:v>16.924400072097747</c:v>
                </c:pt>
                <c:pt idx="344">
                  <c:v>21.82369993209835</c:v>
                </c:pt>
                <c:pt idx="345">
                  <c:v>23.384199943542505</c:v>
                </c:pt>
                <c:pt idx="346">
                  <c:v>20.593100056648296</c:v>
                </c:pt>
                <c:pt idx="347">
                  <c:v>22.773950009346045</c:v>
                </c:pt>
                <c:pt idx="348">
                  <c:v>21.8795499753952</c:v>
                </c:pt>
                <c:pt idx="349">
                  <c:v>15.291950125694299</c:v>
                </c:pt>
                <c:pt idx="350">
                  <c:v>20.6881999731064</c:v>
                </c:pt>
                <c:pt idx="351">
                  <c:v>22.979150009155248</c:v>
                </c:pt>
                <c:pt idx="352">
                  <c:v>19.658649930953953</c:v>
                </c:pt>
                <c:pt idx="353">
                  <c:v>22.932299828529345</c:v>
                </c:pt>
                <c:pt idx="354">
                  <c:v>19.988549866676298</c:v>
                </c:pt>
                <c:pt idx="355">
                  <c:v>19.425149927139309</c:v>
                </c:pt>
                <c:pt idx="356">
                  <c:v>21.804099974632301</c:v>
                </c:pt>
                <c:pt idx="357">
                  <c:v>21.420500054359451</c:v>
                </c:pt>
                <c:pt idx="358">
                  <c:v>23.845649962425206</c:v>
                </c:pt>
                <c:pt idx="359">
                  <c:v>21.746249942779553</c:v>
                </c:pt>
                <c:pt idx="360">
                  <c:v>23.349650163650548</c:v>
                </c:pt>
                <c:pt idx="361">
                  <c:v>22.272449831962604</c:v>
                </c:pt>
                <c:pt idx="362">
                  <c:v>24.633800196647655</c:v>
                </c:pt>
                <c:pt idx="363">
                  <c:v>22.474850149154701</c:v>
                </c:pt>
                <c:pt idx="364">
                  <c:v>24.119650001525848</c:v>
                </c:pt>
                <c:pt idx="365">
                  <c:v>23.710499873161304</c:v>
                </c:pt>
                <c:pt idx="366">
                  <c:v>11.598299961090099</c:v>
                </c:pt>
                <c:pt idx="367">
                  <c:v>19.525499968528756</c:v>
                </c:pt>
                <c:pt idx="368">
                  <c:v>19.122399883270248</c:v>
                </c:pt>
                <c:pt idx="369">
                  <c:v>17.684050116538998</c:v>
                </c:pt>
                <c:pt idx="370">
                  <c:v>23.101449913978598</c:v>
                </c:pt>
                <c:pt idx="371">
                  <c:v>19.02595004081725</c:v>
                </c:pt>
                <c:pt idx="372">
                  <c:v>13.417850227355949</c:v>
                </c:pt>
                <c:pt idx="373">
                  <c:v>20.357599954605099</c:v>
                </c:pt>
                <c:pt idx="374">
                  <c:v>22.534599981307956</c:v>
                </c:pt>
                <c:pt idx="375">
                  <c:v>21.881749944686902</c:v>
                </c:pt>
                <c:pt idx="376">
                  <c:v>18.7033500289917</c:v>
                </c:pt>
                <c:pt idx="377">
                  <c:v>21.157999920844951</c:v>
                </c:pt>
                <c:pt idx="378">
                  <c:v>21.1241500139236</c:v>
                </c:pt>
                <c:pt idx="379">
                  <c:v>22.307199888229398</c:v>
                </c:pt>
                <c:pt idx="380">
                  <c:v>20.702550086975094</c:v>
                </c:pt>
                <c:pt idx="381">
                  <c:v>21.744900212287902</c:v>
                </c:pt>
                <c:pt idx="382">
                  <c:v>18.723399944305402</c:v>
                </c:pt>
                <c:pt idx="383">
                  <c:v>19.733049921989455</c:v>
                </c:pt>
                <c:pt idx="384">
                  <c:v>24.317850008010854</c:v>
                </c:pt>
                <c:pt idx="385">
                  <c:v>20.240050168037342</c:v>
                </c:pt>
                <c:pt idx="386">
                  <c:v>20.38059994697565</c:v>
                </c:pt>
                <c:pt idx="387">
                  <c:v>22.57625000953675</c:v>
                </c:pt>
                <c:pt idx="388">
                  <c:v>20.793999934196506</c:v>
                </c:pt>
                <c:pt idx="389">
                  <c:v>2.484699935913099</c:v>
                </c:pt>
                <c:pt idx="390">
                  <c:v>23.913149957656849</c:v>
                </c:pt>
                <c:pt idx="391">
                  <c:v>22.676000108718853</c:v>
                </c:pt>
                <c:pt idx="392">
                  <c:v>20.031350011825552</c:v>
                </c:pt>
                <c:pt idx="393">
                  <c:v>25.001900081634545</c:v>
                </c:pt>
                <c:pt idx="394">
                  <c:v>20.821649971008348</c:v>
                </c:pt>
                <c:pt idx="395">
                  <c:v>10.368150081634504</c:v>
                </c:pt>
                <c:pt idx="396">
                  <c:v>22.991050014495848</c:v>
                </c:pt>
                <c:pt idx="397">
                  <c:v>20.788399996757548</c:v>
                </c:pt>
                <c:pt idx="398">
                  <c:v>25.422499961853003</c:v>
                </c:pt>
                <c:pt idx="399">
                  <c:v>17.769249992370604</c:v>
                </c:pt>
                <c:pt idx="400">
                  <c:v>18.411900024414052</c:v>
                </c:pt>
                <c:pt idx="401">
                  <c:v>20.658149886131298</c:v>
                </c:pt>
                <c:pt idx="402">
                  <c:v>19.373349881172199</c:v>
                </c:pt>
                <c:pt idx="403">
                  <c:v>18.669600052833552</c:v>
                </c:pt>
                <c:pt idx="404">
                  <c:v>18.2713501501084</c:v>
                </c:pt>
                <c:pt idx="405">
                  <c:v>21.968649973869347</c:v>
                </c:pt>
                <c:pt idx="406">
                  <c:v>20.427050013542146</c:v>
                </c:pt>
                <c:pt idx="407">
                  <c:v>21.20564999103545</c:v>
                </c:pt>
                <c:pt idx="408">
                  <c:v>19.743950080871596</c:v>
                </c:pt>
                <c:pt idx="409">
                  <c:v>20.877999958992</c:v>
                </c:pt>
                <c:pt idx="410">
                  <c:v>19.608950138092048</c:v>
                </c:pt>
                <c:pt idx="411">
                  <c:v>19.895549874305701</c:v>
                </c:pt>
                <c:pt idx="412">
                  <c:v>16.650199909210201</c:v>
                </c:pt>
                <c:pt idx="413">
                  <c:v>11.053150086402852</c:v>
                </c:pt>
                <c:pt idx="414">
                  <c:v>11.053150086402852</c:v>
                </c:pt>
                <c:pt idx="415">
                  <c:v>17.369799966812153</c:v>
                </c:pt>
                <c:pt idx="416">
                  <c:v>19.892650012970005</c:v>
                </c:pt>
                <c:pt idx="417">
                  <c:v>18.620250029563895</c:v>
                </c:pt>
                <c:pt idx="418">
                  <c:v>20.384349899292005</c:v>
                </c:pt>
                <c:pt idx="419">
                  <c:v>13.098000092506403</c:v>
                </c:pt>
                <c:pt idx="420">
                  <c:v>16.136150097846951</c:v>
                </c:pt>
                <c:pt idx="421">
                  <c:v>20.594850077629104</c:v>
                </c:pt>
                <c:pt idx="422">
                  <c:v>19.38559988021855</c:v>
                </c:pt>
                <c:pt idx="423">
                  <c:v>20.797350144386296</c:v>
                </c:pt>
                <c:pt idx="424">
                  <c:v>16.034750051498399</c:v>
                </c:pt>
                <c:pt idx="425">
                  <c:v>20.831050143241896</c:v>
                </c:pt>
                <c:pt idx="426">
                  <c:v>19.650500125884996</c:v>
                </c:pt>
                <c:pt idx="427">
                  <c:v>16.762399940490749</c:v>
                </c:pt>
                <c:pt idx="428">
                  <c:v>18.182500057220444</c:v>
                </c:pt>
                <c:pt idx="429">
                  <c:v>19.326400008201599</c:v>
                </c:pt>
                <c:pt idx="430">
                  <c:v>20.403400092124947</c:v>
                </c:pt>
                <c:pt idx="431">
                  <c:v>18.504849896430947</c:v>
                </c:pt>
                <c:pt idx="432">
                  <c:v>18.594050006866453</c:v>
                </c:pt>
                <c:pt idx="433">
                  <c:v>18.329400072097794</c:v>
                </c:pt>
                <c:pt idx="434">
                  <c:v>18.543550028800951</c:v>
                </c:pt>
                <c:pt idx="435">
                  <c:v>20.301299962997398</c:v>
                </c:pt>
                <c:pt idx="436">
                  <c:v>18.604699935913096</c:v>
                </c:pt>
                <c:pt idx="437">
                  <c:v>20.600850062370348</c:v>
                </c:pt>
                <c:pt idx="438">
                  <c:v>7.1760497379303061</c:v>
                </c:pt>
                <c:pt idx="439">
                  <c:v>18.40765000820155</c:v>
                </c:pt>
                <c:pt idx="440">
                  <c:v>18.147799892425603</c:v>
                </c:pt>
                <c:pt idx="441">
                  <c:v>17.949550051689201</c:v>
                </c:pt>
                <c:pt idx="442">
                  <c:v>14.243850026130652</c:v>
                </c:pt>
                <c:pt idx="443">
                  <c:v>17.651150059700004</c:v>
                </c:pt>
                <c:pt idx="444">
                  <c:v>16.702849874496447</c:v>
                </c:pt>
                <c:pt idx="445">
                  <c:v>15.314049992561351</c:v>
                </c:pt>
                <c:pt idx="446">
                  <c:v>17.192299952507057</c:v>
                </c:pt>
                <c:pt idx="447">
                  <c:v>18.116850047111495</c:v>
                </c:pt>
                <c:pt idx="448">
                  <c:v>19.805800042152402</c:v>
                </c:pt>
                <c:pt idx="449">
                  <c:v>19.433599967956546</c:v>
                </c:pt>
                <c:pt idx="450">
                  <c:v>18.814250078201297</c:v>
                </c:pt>
                <c:pt idx="451">
                  <c:v>17.453099980354246</c:v>
                </c:pt>
                <c:pt idx="452">
                  <c:v>17.021900119781549</c:v>
                </c:pt>
                <c:pt idx="453">
                  <c:v>18.943350067138645</c:v>
                </c:pt>
                <c:pt idx="454">
                  <c:v>17.551399984359751</c:v>
                </c:pt>
                <c:pt idx="455">
                  <c:v>19.319249887466398</c:v>
                </c:pt>
                <c:pt idx="456">
                  <c:v>18.183950033187894</c:v>
                </c:pt>
                <c:pt idx="457">
                  <c:v>17.29279994487765</c:v>
                </c:pt>
                <c:pt idx="458">
                  <c:v>23.238750171661394</c:v>
                </c:pt>
                <c:pt idx="459">
                  <c:v>19.587099895477298</c:v>
                </c:pt>
                <c:pt idx="460">
                  <c:v>19.662050118446352</c:v>
                </c:pt>
                <c:pt idx="461">
                  <c:v>17.682350039482102</c:v>
                </c:pt>
                <c:pt idx="462">
                  <c:v>19.032649903297347</c:v>
                </c:pt>
                <c:pt idx="463">
                  <c:v>17.139300050735503</c:v>
                </c:pt>
                <c:pt idx="464">
                  <c:v>20.482350125312848</c:v>
                </c:pt>
                <c:pt idx="465">
                  <c:v>19.157799930572498</c:v>
                </c:pt>
                <c:pt idx="466">
                  <c:v>15.799450235366756</c:v>
                </c:pt>
                <c:pt idx="467">
                  <c:v>18.055250039100606</c:v>
                </c:pt>
                <c:pt idx="468">
                  <c:v>17.861000041961695</c:v>
                </c:pt>
                <c:pt idx="469">
                  <c:v>18.4315998268127</c:v>
                </c:pt>
                <c:pt idx="470">
                  <c:v>16.696649780273496</c:v>
                </c:pt>
                <c:pt idx="471">
                  <c:v>20.985650067329399</c:v>
                </c:pt>
                <c:pt idx="472">
                  <c:v>16.601750016212449</c:v>
                </c:pt>
                <c:pt idx="473">
                  <c:v>19.237100024223295</c:v>
                </c:pt>
                <c:pt idx="474">
                  <c:v>18.648550133705093</c:v>
                </c:pt>
                <c:pt idx="475">
                  <c:v>20.301600060462945</c:v>
                </c:pt>
                <c:pt idx="476">
                  <c:v>20.838500018119749</c:v>
                </c:pt>
                <c:pt idx="477">
                  <c:v>13.414999980926449</c:v>
                </c:pt>
                <c:pt idx="478">
                  <c:v>16.231799969673155</c:v>
                </c:pt>
                <c:pt idx="479">
                  <c:v>19.104549846649196</c:v>
                </c:pt>
                <c:pt idx="480">
                  <c:v>14.7985001182556</c:v>
                </c:pt>
                <c:pt idx="481">
                  <c:v>16.154500060081503</c:v>
                </c:pt>
                <c:pt idx="482">
                  <c:v>9.5015500211716031</c:v>
                </c:pt>
                <c:pt idx="483">
                  <c:v>11.362550148963898</c:v>
                </c:pt>
                <c:pt idx="484">
                  <c:v>11.362550148963898</c:v>
                </c:pt>
                <c:pt idx="485">
                  <c:v>17.113150129318246</c:v>
                </c:pt>
                <c:pt idx="486">
                  <c:v>15.02110003948215</c:v>
                </c:pt>
                <c:pt idx="487">
                  <c:v>16.521700143814094</c:v>
                </c:pt>
                <c:pt idx="488">
                  <c:v>21.411800031661954</c:v>
                </c:pt>
                <c:pt idx="489">
                  <c:v>18.582149910926802</c:v>
                </c:pt>
                <c:pt idx="490">
                  <c:v>19.300849986076301</c:v>
                </c:pt>
                <c:pt idx="491">
                  <c:v>12.936250038146952</c:v>
                </c:pt>
                <c:pt idx="492">
                  <c:v>14.107649865150499</c:v>
                </c:pt>
                <c:pt idx="493">
                  <c:v>14.795949978828396</c:v>
                </c:pt>
                <c:pt idx="494">
                  <c:v>19.124000053405801</c:v>
                </c:pt>
                <c:pt idx="495">
                  <c:v>18.045400090217548</c:v>
                </c:pt>
                <c:pt idx="496">
                  <c:v>18.343300013542148</c:v>
                </c:pt>
                <c:pt idx="497">
                  <c:v>20.114000005722048</c:v>
                </c:pt>
                <c:pt idx="498">
                  <c:v>16.879050006866443</c:v>
                </c:pt>
                <c:pt idx="499">
                  <c:v>17.276850004196149</c:v>
                </c:pt>
                <c:pt idx="500">
                  <c:v>16.490799794197102</c:v>
                </c:pt>
                <c:pt idx="501">
                  <c:v>16.535950021743751</c:v>
                </c:pt>
                <c:pt idx="502">
                  <c:v>15.518550190925545</c:v>
                </c:pt>
                <c:pt idx="503">
                  <c:v>18.268850030899049</c:v>
                </c:pt>
                <c:pt idx="504">
                  <c:v>9.7854499816894496</c:v>
                </c:pt>
                <c:pt idx="505">
                  <c:v>15.051750164032001</c:v>
                </c:pt>
                <c:pt idx="506">
                  <c:v>18.974450082778954</c:v>
                </c:pt>
                <c:pt idx="507">
                  <c:v>17.193799896240254</c:v>
                </c:pt>
                <c:pt idx="508">
                  <c:v>15.721849937438947</c:v>
                </c:pt>
                <c:pt idx="509">
                  <c:v>17.560350079536406</c:v>
                </c:pt>
                <c:pt idx="510">
                  <c:v>12.994750127792344</c:v>
                </c:pt>
                <c:pt idx="511">
                  <c:v>16.533150000572196</c:v>
                </c:pt>
                <c:pt idx="512">
                  <c:v>15.713999924659749</c:v>
                </c:pt>
                <c:pt idx="513">
                  <c:v>13.062700090408356</c:v>
                </c:pt>
                <c:pt idx="514">
                  <c:v>17.6813501358032</c:v>
                </c:pt>
                <c:pt idx="515">
                  <c:v>12.26775010108955</c:v>
                </c:pt>
                <c:pt idx="516">
                  <c:v>19.04659996032715</c:v>
                </c:pt>
                <c:pt idx="517">
                  <c:v>9.4602000331878955</c:v>
                </c:pt>
                <c:pt idx="518">
                  <c:v>9.4602000331878955</c:v>
                </c:pt>
                <c:pt idx="519">
                  <c:v>16.143800005912752</c:v>
                </c:pt>
                <c:pt idx="520">
                  <c:v>18.458549942970244</c:v>
                </c:pt>
                <c:pt idx="521">
                  <c:v>15.4539499616623</c:v>
                </c:pt>
                <c:pt idx="522">
                  <c:v>17.763699917793303</c:v>
                </c:pt>
                <c:pt idx="523">
                  <c:v>15.742350101470997</c:v>
                </c:pt>
                <c:pt idx="524">
                  <c:v>14.736000022888145</c:v>
                </c:pt>
                <c:pt idx="525">
                  <c:v>17.073850121498097</c:v>
                </c:pt>
                <c:pt idx="526">
                  <c:v>15.329000096321103</c:v>
                </c:pt>
                <c:pt idx="527">
                  <c:v>15.615549960136455</c:v>
                </c:pt>
                <c:pt idx="528">
                  <c:v>19.315000095367399</c:v>
                </c:pt>
                <c:pt idx="529">
                  <c:v>9.0148500013351516</c:v>
                </c:pt>
                <c:pt idx="530">
                  <c:v>15.796549978256198</c:v>
                </c:pt>
                <c:pt idx="531">
                  <c:v>17.569249873161251</c:v>
                </c:pt>
                <c:pt idx="532">
                  <c:v>7.1998001718521039</c:v>
                </c:pt>
                <c:pt idx="533">
                  <c:v>14.023900098800702</c:v>
                </c:pt>
                <c:pt idx="534">
                  <c:v>14.614349951744096</c:v>
                </c:pt>
                <c:pt idx="535">
                  <c:v>14.849149975776651</c:v>
                </c:pt>
                <c:pt idx="536">
                  <c:v>17.329449896812406</c:v>
                </c:pt>
                <c:pt idx="537">
                  <c:v>15.885499868392948</c:v>
                </c:pt>
                <c:pt idx="538">
                  <c:v>17.512549915313752</c:v>
                </c:pt>
                <c:pt idx="539">
                  <c:v>13.919400100708003</c:v>
                </c:pt>
                <c:pt idx="540">
                  <c:v>17.37379993915555</c:v>
                </c:pt>
                <c:pt idx="541">
                  <c:v>16.535200099945101</c:v>
                </c:pt>
                <c:pt idx="542">
                  <c:v>16.947649869918848</c:v>
                </c:pt>
                <c:pt idx="543">
                  <c:v>17.807200112342805</c:v>
                </c:pt>
                <c:pt idx="544">
                  <c:v>18.00109995841985</c:v>
                </c:pt>
                <c:pt idx="545">
                  <c:v>16.438800077438298</c:v>
                </c:pt>
                <c:pt idx="546">
                  <c:v>17.071750006675749</c:v>
                </c:pt>
                <c:pt idx="547">
                  <c:v>14.404050149917609</c:v>
                </c:pt>
                <c:pt idx="548">
                  <c:v>15.925599966049198</c:v>
                </c:pt>
                <c:pt idx="549">
                  <c:v>15.473349943160997</c:v>
                </c:pt>
                <c:pt idx="550">
                  <c:v>17.034850001335151</c:v>
                </c:pt>
                <c:pt idx="551">
                  <c:v>14.049100003242501</c:v>
                </c:pt>
                <c:pt idx="552">
                  <c:v>18.170899748802199</c:v>
                </c:pt>
                <c:pt idx="553">
                  <c:v>15.892049965858444</c:v>
                </c:pt>
                <c:pt idx="554">
                  <c:v>15.521249895095792</c:v>
                </c:pt>
                <c:pt idx="555">
                  <c:v>14.919999938011202</c:v>
                </c:pt>
                <c:pt idx="556">
                  <c:v>8.5506500864029036</c:v>
                </c:pt>
                <c:pt idx="557">
                  <c:v>8.5506500864029036</c:v>
                </c:pt>
                <c:pt idx="558">
                  <c:v>16.258450045585644</c:v>
                </c:pt>
                <c:pt idx="559">
                  <c:v>14.778850097656303</c:v>
                </c:pt>
                <c:pt idx="560">
                  <c:v>14.911950173378003</c:v>
                </c:pt>
                <c:pt idx="561">
                  <c:v>17.362250018119799</c:v>
                </c:pt>
                <c:pt idx="562">
                  <c:v>15.326400032043502</c:v>
                </c:pt>
                <c:pt idx="563">
                  <c:v>14.895299930572548</c:v>
                </c:pt>
                <c:pt idx="564">
                  <c:v>16.943550052642848</c:v>
                </c:pt>
                <c:pt idx="565">
                  <c:v>16.244349927902256</c:v>
                </c:pt>
                <c:pt idx="566">
                  <c:v>13.798650007247954</c:v>
                </c:pt>
                <c:pt idx="567">
                  <c:v>14.59145013809205</c:v>
                </c:pt>
                <c:pt idx="568">
                  <c:v>16.543549942970252</c:v>
                </c:pt>
                <c:pt idx="569">
                  <c:v>16.73465002059935</c:v>
                </c:pt>
                <c:pt idx="570">
                  <c:v>16.760699968337999</c:v>
                </c:pt>
                <c:pt idx="571">
                  <c:v>14.861250028610254</c:v>
                </c:pt>
                <c:pt idx="572">
                  <c:v>15.05250002861025</c:v>
                </c:pt>
                <c:pt idx="573">
                  <c:v>15.281150012016347</c:v>
                </c:pt>
                <c:pt idx="574">
                  <c:v>13.994550113678002</c:v>
                </c:pt>
                <c:pt idx="575">
                  <c:v>13.753500070571899</c:v>
                </c:pt>
                <c:pt idx="576">
                  <c:v>17.785950026512154</c:v>
                </c:pt>
                <c:pt idx="577">
                  <c:v>16.468950033187852</c:v>
                </c:pt>
                <c:pt idx="578">
                  <c:v>18.09435002803805</c:v>
                </c:pt>
                <c:pt idx="579">
                  <c:v>17.588499891757948</c:v>
                </c:pt>
                <c:pt idx="580">
                  <c:v>19.598800082206694</c:v>
                </c:pt>
                <c:pt idx="581">
                  <c:v>12.778000106811504</c:v>
                </c:pt>
                <c:pt idx="582">
                  <c:v>15.537000145912149</c:v>
                </c:pt>
                <c:pt idx="583">
                  <c:v>14.428550014495855</c:v>
                </c:pt>
                <c:pt idx="584">
                  <c:v>14.17949993133545</c:v>
                </c:pt>
                <c:pt idx="585">
                  <c:v>16.336349840164146</c:v>
                </c:pt>
                <c:pt idx="586">
                  <c:v>17.327349958419752</c:v>
                </c:pt>
                <c:pt idx="587">
                  <c:v>15.568549981117201</c:v>
                </c:pt>
                <c:pt idx="588">
                  <c:v>13.507600016593898</c:v>
                </c:pt>
                <c:pt idx="589">
                  <c:v>13.531700162887546</c:v>
                </c:pt>
                <c:pt idx="590">
                  <c:v>17.3849501800537</c:v>
                </c:pt>
                <c:pt idx="591">
                  <c:v>16.894500093460053</c:v>
                </c:pt>
                <c:pt idx="592">
                  <c:v>14.755349941253648</c:v>
                </c:pt>
                <c:pt idx="593">
                  <c:v>14.0066998434067</c:v>
                </c:pt>
                <c:pt idx="594">
                  <c:v>15.712749838828998</c:v>
                </c:pt>
                <c:pt idx="595">
                  <c:v>13.98954995155335</c:v>
                </c:pt>
                <c:pt idx="596">
                  <c:v>14.1458999347687</c:v>
                </c:pt>
                <c:pt idx="597">
                  <c:v>14.642799968719498</c:v>
                </c:pt>
                <c:pt idx="598">
                  <c:v>16.192649955749548</c:v>
                </c:pt>
                <c:pt idx="599">
                  <c:v>13.94749996662145</c:v>
                </c:pt>
                <c:pt idx="600">
                  <c:v>14.764149909019494</c:v>
                </c:pt>
                <c:pt idx="601">
                  <c:v>13.429900012016297</c:v>
                </c:pt>
                <c:pt idx="602">
                  <c:v>15.768050065040601</c:v>
                </c:pt>
                <c:pt idx="603">
                  <c:v>16.924699826240555</c:v>
                </c:pt>
                <c:pt idx="604">
                  <c:v>16.6460000991821</c:v>
                </c:pt>
                <c:pt idx="605">
                  <c:v>14.334849901199355</c:v>
                </c:pt>
                <c:pt idx="606">
                  <c:v>17.515500025749255</c:v>
                </c:pt>
                <c:pt idx="607">
                  <c:v>14.357699956893903</c:v>
                </c:pt>
                <c:pt idx="608">
                  <c:v>12.4378001260758</c:v>
                </c:pt>
                <c:pt idx="609">
                  <c:v>10.646050100326494</c:v>
                </c:pt>
                <c:pt idx="610">
                  <c:v>15.766150045394902</c:v>
                </c:pt>
                <c:pt idx="611">
                  <c:v>13.825999975204503</c:v>
                </c:pt>
                <c:pt idx="612">
                  <c:v>11.748700094223</c:v>
                </c:pt>
                <c:pt idx="613">
                  <c:v>16.511999979019201</c:v>
                </c:pt>
                <c:pt idx="614">
                  <c:v>15.950900044441205</c:v>
                </c:pt>
                <c:pt idx="615">
                  <c:v>16.249250020980845</c:v>
                </c:pt>
                <c:pt idx="616">
                  <c:v>5.013550109863246</c:v>
                </c:pt>
                <c:pt idx="617">
                  <c:v>15.117699933052052</c:v>
                </c:pt>
                <c:pt idx="618">
                  <c:v>17.781599960327199</c:v>
                </c:pt>
                <c:pt idx="619">
                  <c:v>15.324399933814998</c:v>
                </c:pt>
                <c:pt idx="620">
                  <c:v>16.113349943160955</c:v>
                </c:pt>
                <c:pt idx="621">
                  <c:v>14.364599990844695</c:v>
                </c:pt>
                <c:pt idx="622">
                  <c:v>13.747200160026502</c:v>
                </c:pt>
                <c:pt idx="623">
                  <c:v>14.511549997329702</c:v>
                </c:pt>
                <c:pt idx="624">
                  <c:v>13.651350007057204</c:v>
                </c:pt>
                <c:pt idx="625">
                  <c:v>14.2667998552322</c:v>
                </c:pt>
                <c:pt idx="626">
                  <c:v>16.442250094413751</c:v>
                </c:pt>
                <c:pt idx="627">
                  <c:v>16.389800028800952</c:v>
                </c:pt>
                <c:pt idx="628">
                  <c:v>18.154699921608</c:v>
                </c:pt>
                <c:pt idx="629">
                  <c:v>14.067999954223602</c:v>
                </c:pt>
                <c:pt idx="630">
                  <c:v>12.118249945640549</c:v>
                </c:pt>
                <c:pt idx="631">
                  <c:v>16.199599957466106</c:v>
                </c:pt>
                <c:pt idx="632">
                  <c:v>15.467050099372798</c:v>
                </c:pt>
                <c:pt idx="633">
                  <c:v>14.424150195121747</c:v>
                </c:pt>
                <c:pt idx="634">
                  <c:v>10.267050056457549</c:v>
                </c:pt>
                <c:pt idx="635">
                  <c:v>15.159100041389447</c:v>
                </c:pt>
                <c:pt idx="636">
                  <c:v>14.923400149345397</c:v>
                </c:pt>
                <c:pt idx="637">
                  <c:v>13.949700088501004</c:v>
                </c:pt>
                <c:pt idx="638">
                  <c:v>14.364699854850748</c:v>
                </c:pt>
                <c:pt idx="639">
                  <c:v>14.220350055694553</c:v>
                </c:pt>
                <c:pt idx="640">
                  <c:v>17.508899993896449</c:v>
                </c:pt>
                <c:pt idx="641">
                  <c:v>10.714750013351448</c:v>
                </c:pt>
                <c:pt idx="642">
                  <c:v>12.509100055694546</c:v>
                </c:pt>
                <c:pt idx="643">
                  <c:v>18.520749962329848</c:v>
                </c:pt>
                <c:pt idx="644">
                  <c:v>5.3442503166198492</c:v>
                </c:pt>
                <c:pt idx="645">
                  <c:v>5.3442503166198492</c:v>
                </c:pt>
                <c:pt idx="646">
                  <c:v>14.273949933052151</c:v>
                </c:pt>
                <c:pt idx="647">
                  <c:v>15.0054500341415</c:v>
                </c:pt>
                <c:pt idx="648">
                  <c:v>15.980000000000004</c:v>
                </c:pt>
                <c:pt idx="649">
                  <c:v>13.756350131034853</c:v>
                </c:pt>
                <c:pt idx="650">
                  <c:v>15.289849991798391</c:v>
                </c:pt>
                <c:pt idx="651">
                  <c:v>13.911249904632648</c:v>
                </c:pt>
                <c:pt idx="652">
                  <c:v>15.879799818992556</c:v>
                </c:pt>
                <c:pt idx="653">
                  <c:v>15.894950013160702</c:v>
                </c:pt>
                <c:pt idx="654">
                  <c:v>14.156249966621452</c:v>
                </c:pt>
                <c:pt idx="655">
                  <c:v>14.857100067138646</c:v>
                </c:pt>
                <c:pt idx="656">
                  <c:v>12.474199910163904</c:v>
                </c:pt>
                <c:pt idx="657">
                  <c:v>16.062649936675999</c:v>
                </c:pt>
                <c:pt idx="658">
                  <c:v>12.320699968337998</c:v>
                </c:pt>
                <c:pt idx="659">
                  <c:v>14.170049905776999</c:v>
                </c:pt>
                <c:pt idx="660">
                  <c:v>13.325700049400353</c:v>
                </c:pt>
                <c:pt idx="661">
                  <c:v>14.441799955368094</c:v>
                </c:pt>
                <c:pt idx="662">
                  <c:v>8.6890501177310995</c:v>
                </c:pt>
                <c:pt idx="663">
                  <c:v>14.862550082206702</c:v>
                </c:pt>
                <c:pt idx="664">
                  <c:v>12.893850102424601</c:v>
                </c:pt>
                <c:pt idx="665">
                  <c:v>15.963400039672905</c:v>
                </c:pt>
                <c:pt idx="666">
                  <c:v>13.0372499704361</c:v>
                </c:pt>
                <c:pt idx="667">
                  <c:v>12.60934987545015</c:v>
                </c:pt>
                <c:pt idx="668">
                  <c:v>15.866149983406103</c:v>
                </c:pt>
                <c:pt idx="669">
                  <c:v>10.286349980831154</c:v>
                </c:pt>
                <c:pt idx="670">
                  <c:v>14.471250076293899</c:v>
                </c:pt>
                <c:pt idx="671">
                  <c:v>12.8042998838425</c:v>
                </c:pt>
                <c:pt idx="672">
                  <c:v>5.7691999530792017</c:v>
                </c:pt>
                <c:pt idx="673">
                  <c:v>5.7691999530792017</c:v>
                </c:pt>
                <c:pt idx="674">
                  <c:v>15.965349972248099</c:v>
                </c:pt>
                <c:pt idx="675">
                  <c:v>14.710999994277952</c:v>
                </c:pt>
                <c:pt idx="676">
                  <c:v>14.295450072288553</c:v>
                </c:pt>
                <c:pt idx="677">
                  <c:v>15.538799843788151</c:v>
                </c:pt>
                <c:pt idx="678">
                  <c:v>8.9505000019073471</c:v>
                </c:pt>
                <c:pt idx="679">
                  <c:v>13.105999999046354</c:v>
                </c:pt>
                <c:pt idx="680">
                  <c:v>15.182249982357003</c:v>
                </c:pt>
                <c:pt idx="681">
                  <c:v>15.998850021362294</c:v>
                </c:pt>
                <c:pt idx="682">
                  <c:v>11.924299950599707</c:v>
                </c:pt>
                <c:pt idx="683">
                  <c:v>13.260749917030402</c:v>
                </c:pt>
                <c:pt idx="684">
                  <c:v>15.475300207138105</c:v>
                </c:pt>
                <c:pt idx="685">
                  <c:v>9.1145000886916989</c:v>
                </c:pt>
                <c:pt idx="686">
                  <c:v>9.1145000886916989</c:v>
                </c:pt>
                <c:pt idx="687">
                  <c:v>15.094800086021444</c:v>
                </c:pt>
                <c:pt idx="688">
                  <c:v>6.7515001153945988</c:v>
                </c:pt>
                <c:pt idx="689">
                  <c:v>6.7515001153945988</c:v>
                </c:pt>
                <c:pt idx="690">
                  <c:v>10.811350083351101</c:v>
                </c:pt>
                <c:pt idx="691">
                  <c:v>13.672649984359694</c:v>
                </c:pt>
                <c:pt idx="692">
                  <c:v>14.943350081443796</c:v>
                </c:pt>
                <c:pt idx="693">
                  <c:v>13.685250067710903</c:v>
                </c:pt>
                <c:pt idx="694">
                  <c:v>13.649299941062953</c:v>
                </c:pt>
                <c:pt idx="695">
                  <c:v>11.987050075531002</c:v>
                </c:pt>
                <c:pt idx="696">
                  <c:v>15.862950015068101</c:v>
                </c:pt>
                <c:pt idx="697">
                  <c:v>12.370799903869653</c:v>
                </c:pt>
                <c:pt idx="698">
                  <c:v>11.128800039291399</c:v>
                </c:pt>
                <c:pt idx="699">
                  <c:v>9.3444000434875463</c:v>
                </c:pt>
                <c:pt idx="700">
                  <c:v>14.68425000667575</c:v>
                </c:pt>
                <c:pt idx="701">
                  <c:v>11.001949958801301</c:v>
                </c:pt>
                <c:pt idx="702">
                  <c:v>16.232500038147009</c:v>
                </c:pt>
                <c:pt idx="703">
                  <c:v>14.365300107002252</c:v>
                </c:pt>
                <c:pt idx="704">
                  <c:v>12.374500079154998</c:v>
                </c:pt>
                <c:pt idx="705">
                  <c:v>7.488450336456296</c:v>
                </c:pt>
                <c:pt idx="706">
                  <c:v>14.2441499996185</c:v>
                </c:pt>
                <c:pt idx="707">
                  <c:v>13.986150021553097</c:v>
                </c:pt>
                <c:pt idx="708">
                  <c:v>12.467900028228804</c:v>
                </c:pt>
                <c:pt idx="709">
                  <c:v>16.286850094795145</c:v>
                </c:pt>
                <c:pt idx="710">
                  <c:v>12.807000145912198</c:v>
                </c:pt>
                <c:pt idx="711">
                  <c:v>13.1204000711441</c:v>
                </c:pt>
                <c:pt idx="712">
                  <c:v>12.363199996948246</c:v>
                </c:pt>
                <c:pt idx="713">
                  <c:v>12.425199890136746</c:v>
                </c:pt>
                <c:pt idx="714">
                  <c:v>14.619649901390098</c:v>
                </c:pt>
                <c:pt idx="715">
                  <c:v>14.671900072097756</c:v>
                </c:pt>
                <c:pt idx="716">
                  <c:v>13.086100082397447</c:v>
                </c:pt>
                <c:pt idx="717">
                  <c:v>13.930100049972548</c:v>
                </c:pt>
                <c:pt idx="718">
                  <c:v>14.613150029182457</c:v>
                </c:pt>
                <c:pt idx="719">
                  <c:v>13.453099989891047</c:v>
                </c:pt>
                <c:pt idx="720">
                  <c:v>15.056199975013698</c:v>
                </c:pt>
                <c:pt idx="721">
                  <c:v>13.435199971198998</c:v>
                </c:pt>
                <c:pt idx="722">
                  <c:v>14.484850049018849</c:v>
                </c:pt>
                <c:pt idx="723">
                  <c:v>12.199250035285949</c:v>
                </c:pt>
                <c:pt idx="724">
                  <c:v>13.836500105857851</c:v>
                </c:pt>
                <c:pt idx="725">
                  <c:v>11.937349829673749</c:v>
                </c:pt>
                <c:pt idx="726">
                  <c:v>10.589699912071204</c:v>
                </c:pt>
                <c:pt idx="727">
                  <c:v>15.174799919128404</c:v>
                </c:pt>
                <c:pt idx="728">
                  <c:v>14.581000075340299</c:v>
                </c:pt>
                <c:pt idx="729">
                  <c:v>12.985050086975157</c:v>
                </c:pt>
                <c:pt idx="730">
                  <c:v>13.075800004005451</c:v>
                </c:pt>
                <c:pt idx="731">
                  <c:v>10.039500041008004</c:v>
                </c:pt>
                <c:pt idx="732">
                  <c:v>13.410300078391998</c:v>
                </c:pt>
                <c:pt idx="733">
                  <c:v>13.3229499483109</c:v>
                </c:pt>
                <c:pt idx="734">
                  <c:v>15.591599850654553</c:v>
                </c:pt>
                <c:pt idx="735">
                  <c:v>16.046100082397452</c:v>
                </c:pt>
                <c:pt idx="736">
                  <c:v>14.038199968337999</c:v>
                </c:pt>
                <c:pt idx="737">
                  <c:v>14.551549820899901</c:v>
                </c:pt>
                <c:pt idx="738">
                  <c:v>13.8400498867035</c:v>
                </c:pt>
                <c:pt idx="739">
                  <c:v>11.926999959945654</c:v>
                </c:pt>
                <c:pt idx="740">
                  <c:v>12.574499964714001</c:v>
                </c:pt>
                <c:pt idx="741">
                  <c:v>12.567549829482999</c:v>
                </c:pt>
                <c:pt idx="742">
                  <c:v>11.955100026130701</c:v>
                </c:pt>
                <c:pt idx="743">
                  <c:v>12.958749938011152</c:v>
                </c:pt>
                <c:pt idx="744">
                  <c:v>12.839400253295903</c:v>
                </c:pt>
                <c:pt idx="745">
                  <c:v>11.679050054550153</c:v>
                </c:pt>
                <c:pt idx="746">
                  <c:v>14.592399926185546</c:v>
                </c:pt>
                <c:pt idx="747">
                  <c:v>13.382449998855602</c:v>
                </c:pt>
                <c:pt idx="748">
                  <c:v>17.137100014686546</c:v>
                </c:pt>
                <c:pt idx="749">
                  <c:v>15.945050120353699</c:v>
                </c:pt>
                <c:pt idx="750">
                  <c:v>12.2106999397278</c:v>
                </c:pt>
                <c:pt idx="751">
                  <c:v>14.355449895858751</c:v>
                </c:pt>
                <c:pt idx="752">
                  <c:v>11.105300145149251</c:v>
                </c:pt>
                <c:pt idx="753">
                  <c:v>15.507500019073451</c:v>
                </c:pt>
                <c:pt idx="754">
                  <c:v>11.086100182533301</c:v>
                </c:pt>
                <c:pt idx="755">
                  <c:v>14.3478499555588</c:v>
                </c:pt>
                <c:pt idx="756">
                  <c:v>13.309000067710905</c:v>
                </c:pt>
                <c:pt idx="757">
                  <c:v>14.577150034904506</c:v>
                </c:pt>
                <c:pt idx="758">
                  <c:v>14.785100003480906</c:v>
                </c:pt>
                <c:pt idx="759">
                  <c:v>13.110199842453003</c:v>
                </c:pt>
                <c:pt idx="760">
                  <c:v>12.111450009345997</c:v>
                </c:pt>
                <c:pt idx="761">
                  <c:v>10.15025004386905</c:v>
                </c:pt>
                <c:pt idx="762">
                  <c:v>15.282750015258802</c:v>
                </c:pt>
                <c:pt idx="763">
                  <c:v>9.4950500774383997</c:v>
                </c:pt>
                <c:pt idx="764">
                  <c:v>14.152999944686904</c:v>
                </c:pt>
                <c:pt idx="765">
                  <c:v>12.184250025749204</c:v>
                </c:pt>
                <c:pt idx="766">
                  <c:v>14.740699996948251</c:v>
                </c:pt>
                <c:pt idx="767">
                  <c:v>13.432650055885347</c:v>
                </c:pt>
                <c:pt idx="768">
                  <c:v>12.485350022315998</c:v>
                </c:pt>
                <c:pt idx="769">
                  <c:v>12.195250034332297</c:v>
                </c:pt>
                <c:pt idx="770">
                  <c:v>15.270699982643151</c:v>
                </c:pt>
                <c:pt idx="771">
                  <c:v>16.085300016403195</c:v>
                </c:pt>
                <c:pt idx="772">
                  <c:v>9.7369000816345057</c:v>
                </c:pt>
                <c:pt idx="773">
                  <c:v>13.286850037574748</c:v>
                </c:pt>
                <c:pt idx="774">
                  <c:v>13.617849984168995</c:v>
                </c:pt>
                <c:pt idx="775">
                  <c:v>14.611649942398103</c:v>
                </c:pt>
                <c:pt idx="776">
                  <c:v>13.644199986457799</c:v>
                </c:pt>
                <c:pt idx="777">
                  <c:v>8.692500038146953</c:v>
                </c:pt>
                <c:pt idx="778">
                  <c:v>10.559199962615949</c:v>
                </c:pt>
                <c:pt idx="779">
                  <c:v>12.784349937439003</c:v>
                </c:pt>
                <c:pt idx="780">
                  <c:v>15.25904983997345</c:v>
                </c:pt>
                <c:pt idx="781">
                  <c:v>12.012650012970003</c:v>
                </c:pt>
                <c:pt idx="782">
                  <c:v>10.983000073432947</c:v>
                </c:pt>
                <c:pt idx="783">
                  <c:v>13.975399823188756</c:v>
                </c:pt>
                <c:pt idx="784">
                  <c:v>2.4075501203537542</c:v>
                </c:pt>
                <c:pt idx="785">
                  <c:v>12.188449974060049</c:v>
                </c:pt>
                <c:pt idx="786">
                  <c:v>10.334649825096101</c:v>
                </c:pt>
                <c:pt idx="787">
                  <c:v>11.5748499631882</c:v>
                </c:pt>
                <c:pt idx="788">
                  <c:v>13.831050014495847</c:v>
                </c:pt>
                <c:pt idx="789">
                  <c:v>11.935550169944747</c:v>
                </c:pt>
                <c:pt idx="790">
                  <c:v>13.568900008201602</c:v>
                </c:pt>
                <c:pt idx="791">
                  <c:v>17.049999980926501</c:v>
                </c:pt>
                <c:pt idx="792">
                  <c:v>11.305650067329399</c:v>
                </c:pt>
                <c:pt idx="793">
                  <c:v>14.449250044822698</c:v>
                </c:pt>
                <c:pt idx="794">
                  <c:v>13.630150008201596</c:v>
                </c:pt>
                <c:pt idx="795">
                  <c:v>11.965449967384352</c:v>
                </c:pt>
                <c:pt idx="796">
                  <c:v>7.2132500076293482</c:v>
                </c:pt>
                <c:pt idx="797">
                  <c:v>11.332149968147299</c:v>
                </c:pt>
                <c:pt idx="798">
                  <c:v>12.013350129127552</c:v>
                </c:pt>
                <c:pt idx="799">
                  <c:v>8.5811998414993518</c:v>
                </c:pt>
                <c:pt idx="800">
                  <c:v>8.5811998414993518</c:v>
                </c:pt>
                <c:pt idx="801">
                  <c:v>14.819350008964498</c:v>
                </c:pt>
                <c:pt idx="802">
                  <c:v>12.066749897003199</c:v>
                </c:pt>
                <c:pt idx="803">
                  <c:v>7.6093499422073556</c:v>
                </c:pt>
                <c:pt idx="804">
                  <c:v>12.834899892807051</c:v>
                </c:pt>
                <c:pt idx="805">
                  <c:v>10.554949932098403</c:v>
                </c:pt>
                <c:pt idx="806">
                  <c:v>10.414350070953397</c:v>
                </c:pt>
                <c:pt idx="807">
                  <c:v>11.685749950408898</c:v>
                </c:pt>
                <c:pt idx="808">
                  <c:v>13.414099988937444</c:v>
                </c:pt>
                <c:pt idx="809">
                  <c:v>13.262250046730049</c:v>
                </c:pt>
                <c:pt idx="810">
                  <c:v>12.600349898338301</c:v>
                </c:pt>
                <c:pt idx="811">
                  <c:v>14.3805499553681</c:v>
                </c:pt>
                <c:pt idx="812">
                  <c:v>9.4426000547409004</c:v>
                </c:pt>
                <c:pt idx="813">
                  <c:v>11.096200070381151</c:v>
                </c:pt>
                <c:pt idx="814">
                  <c:v>14.2555999040604</c:v>
                </c:pt>
                <c:pt idx="815">
                  <c:v>8.8571999931335483</c:v>
                </c:pt>
                <c:pt idx="816">
                  <c:v>12.672049894332901</c:v>
                </c:pt>
                <c:pt idx="817">
                  <c:v>13.908950009346</c:v>
                </c:pt>
                <c:pt idx="818">
                  <c:v>12.544800095558198</c:v>
                </c:pt>
                <c:pt idx="819">
                  <c:v>14.957699913978598</c:v>
                </c:pt>
                <c:pt idx="820">
                  <c:v>12.143899989128148</c:v>
                </c:pt>
                <c:pt idx="821">
                  <c:v>12.968100004196202</c:v>
                </c:pt>
                <c:pt idx="822">
                  <c:v>7.6726999473572022</c:v>
                </c:pt>
                <c:pt idx="823">
                  <c:v>9.2660999393462546</c:v>
                </c:pt>
                <c:pt idx="824">
                  <c:v>11.41094986915585</c:v>
                </c:pt>
                <c:pt idx="825">
                  <c:v>11.644150137901299</c:v>
                </c:pt>
                <c:pt idx="826">
                  <c:v>4.7475999879837048</c:v>
                </c:pt>
                <c:pt idx="827">
                  <c:v>4.7475999879837048</c:v>
                </c:pt>
                <c:pt idx="828">
                  <c:v>9.789200096130358</c:v>
                </c:pt>
                <c:pt idx="829">
                  <c:v>14.218300137519851</c:v>
                </c:pt>
                <c:pt idx="830">
                  <c:v>11.161750030517602</c:v>
                </c:pt>
                <c:pt idx="831">
                  <c:v>9.5374500846862489</c:v>
                </c:pt>
                <c:pt idx="832">
                  <c:v>10.314950222969102</c:v>
                </c:pt>
                <c:pt idx="833">
                  <c:v>12.888649997711152</c:v>
                </c:pt>
                <c:pt idx="834">
                  <c:v>17.962799973487847</c:v>
                </c:pt>
                <c:pt idx="835">
                  <c:v>14.979499979019149</c:v>
                </c:pt>
                <c:pt idx="836">
                  <c:v>12.763049931526197</c:v>
                </c:pt>
                <c:pt idx="837">
                  <c:v>13.022699980735752</c:v>
                </c:pt>
                <c:pt idx="838">
                  <c:v>12.876849999427748</c:v>
                </c:pt>
                <c:pt idx="839">
                  <c:v>10.2493999671936</c:v>
                </c:pt>
                <c:pt idx="840">
                  <c:v>10.581200027465854</c:v>
                </c:pt>
                <c:pt idx="841">
                  <c:v>14.3207999253273</c:v>
                </c:pt>
                <c:pt idx="842">
                  <c:v>7.9534000492095984</c:v>
                </c:pt>
                <c:pt idx="843">
                  <c:v>14.108800048828098</c:v>
                </c:pt>
                <c:pt idx="844">
                  <c:v>10.811250042915354</c:v>
                </c:pt>
                <c:pt idx="845">
                  <c:v>15.167749910354598</c:v>
                </c:pt>
                <c:pt idx="846">
                  <c:v>12.692000007629403</c:v>
                </c:pt>
                <c:pt idx="847">
                  <c:v>11.927400040626502</c:v>
                </c:pt>
                <c:pt idx="848">
                  <c:v>14.229899964332553</c:v>
                </c:pt>
                <c:pt idx="849">
                  <c:v>13.440599942207299</c:v>
                </c:pt>
                <c:pt idx="850">
                  <c:v>4.6223500680923522</c:v>
                </c:pt>
                <c:pt idx="851">
                  <c:v>14.778749899864199</c:v>
                </c:pt>
                <c:pt idx="852">
                  <c:v>11.623149857521053</c:v>
                </c:pt>
                <c:pt idx="853">
                  <c:v>13.100999803543054</c:v>
                </c:pt>
                <c:pt idx="854">
                  <c:v>13.594149971008299</c:v>
                </c:pt>
                <c:pt idx="855">
                  <c:v>14.294300012588501</c:v>
                </c:pt>
                <c:pt idx="856">
                  <c:v>10.47960015773775</c:v>
                </c:pt>
                <c:pt idx="857">
                  <c:v>13.862799968719457</c:v>
                </c:pt>
                <c:pt idx="858">
                  <c:v>9.0546500301361021</c:v>
                </c:pt>
                <c:pt idx="859">
                  <c:v>12.333599882125846</c:v>
                </c:pt>
                <c:pt idx="860">
                  <c:v>10.232649989128099</c:v>
                </c:pt>
                <c:pt idx="861">
                  <c:v>11.987550015449454</c:v>
                </c:pt>
                <c:pt idx="862">
                  <c:v>13.150600113868748</c:v>
                </c:pt>
                <c:pt idx="863">
                  <c:v>12.99649997234345</c:v>
                </c:pt>
                <c:pt idx="864">
                  <c:v>13.931299939155551</c:v>
                </c:pt>
                <c:pt idx="865">
                  <c:v>10.194099941253654</c:v>
                </c:pt>
                <c:pt idx="866">
                  <c:v>13.360700116157503</c:v>
                </c:pt>
                <c:pt idx="867">
                  <c:v>10.793349995613099</c:v>
                </c:pt>
                <c:pt idx="868">
                  <c:v>10.866200046539248</c:v>
                </c:pt>
                <c:pt idx="869">
                  <c:v>6.5176501464843994</c:v>
                </c:pt>
                <c:pt idx="870">
                  <c:v>13.424149765968352</c:v>
                </c:pt>
                <c:pt idx="871">
                  <c:v>11.964600062370298</c:v>
                </c:pt>
                <c:pt idx="872">
                  <c:v>11.445649933815005</c:v>
                </c:pt>
                <c:pt idx="873">
                  <c:v>11.911299872398352</c:v>
                </c:pt>
                <c:pt idx="874">
                  <c:v>10.822849988937399</c:v>
                </c:pt>
                <c:pt idx="875">
                  <c:v>16.205549950599696</c:v>
                </c:pt>
                <c:pt idx="876">
                  <c:v>10.752450013160697</c:v>
                </c:pt>
                <c:pt idx="877">
                  <c:v>11.525749998092646</c:v>
                </c:pt>
                <c:pt idx="878">
                  <c:v>12.426399827003504</c:v>
                </c:pt>
                <c:pt idx="879">
                  <c:v>5.9884502172470491</c:v>
                </c:pt>
                <c:pt idx="880">
                  <c:v>5.9884502172470491</c:v>
                </c:pt>
                <c:pt idx="881">
                  <c:v>11.713250026702845</c:v>
                </c:pt>
                <c:pt idx="882">
                  <c:v>14.126499948501603</c:v>
                </c:pt>
                <c:pt idx="883">
                  <c:v>10.644800038337703</c:v>
                </c:pt>
                <c:pt idx="884">
                  <c:v>14.092350020408595</c:v>
                </c:pt>
                <c:pt idx="885">
                  <c:v>14.673149995803801</c:v>
                </c:pt>
                <c:pt idx="886">
                  <c:v>13.556750130653302</c:v>
                </c:pt>
                <c:pt idx="887">
                  <c:v>10.384199848175001</c:v>
                </c:pt>
                <c:pt idx="888">
                  <c:v>10.791149883270251</c:v>
                </c:pt>
                <c:pt idx="889">
                  <c:v>13.590199990272495</c:v>
                </c:pt>
                <c:pt idx="890">
                  <c:v>13.320099887847903</c:v>
                </c:pt>
                <c:pt idx="891">
                  <c:v>15.343449892997747</c:v>
                </c:pt>
                <c:pt idx="892">
                  <c:v>13.643150067329398</c:v>
                </c:pt>
                <c:pt idx="893">
                  <c:v>14.134300007820052</c:v>
                </c:pt>
                <c:pt idx="894">
                  <c:v>12.29809990882875</c:v>
                </c:pt>
                <c:pt idx="895">
                  <c:v>11.798449907302853</c:v>
                </c:pt>
                <c:pt idx="896">
                  <c:v>12.821750001907297</c:v>
                </c:pt>
                <c:pt idx="897">
                  <c:v>9.9011500263213961</c:v>
                </c:pt>
                <c:pt idx="898">
                  <c:v>15.288300037383998</c:v>
                </c:pt>
                <c:pt idx="899">
                  <c:v>12.585600047111502</c:v>
                </c:pt>
                <c:pt idx="900">
                  <c:v>12.910200028419496</c:v>
                </c:pt>
                <c:pt idx="901">
                  <c:v>11.279050168991098</c:v>
                </c:pt>
                <c:pt idx="902">
                  <c:v>11.467699990272504</c:v>
                </c:pt>
                <c:pt idx="903">
                  <c:v>13.029399933814997</c:v>
                </c:pt>
                <c:pt idx="904">
                  <c:v>11.533150081634552</c:v>
                </c:pt>
                <c:pt idx="905">
                  <c:v>13.618350043296854</c:v>
                </c:pt>
                <c:pt idx="906">
                  <c:v>13.22759994029995</c:v>
                </c:pt>
                <c:pt idx="907">
                  <c:v>14.726000022888201</c:v>
                </c:pt>
                <c:pt idx="908">
                  <c:v>9.1102001714706482</c:v>
                </c:pt>
                <c:pt idx="909">
                  <c:v>10.6586499071121</c:v>
                </c:pt>
                <c:pt idx="910">
                  <c:v>10.76160012245175</c:v>
                </c:pt>
                <c:pt idx="911">
                  <c:v>10.446849966049204</c:v>
                </c:pt>
                <c:pt idx="912">
                  <c:v>11.6205000162125</c:v>
                </c:pt>
                <c:pt idx="913">
                  <c:v>13.3715499448776</c:v>
                </c:pt>
                <c:pt idx="914">
                  <c:v>12.630800075531003</c:v>
                </c:pt>
                <c:pt idx="915">
                  <c:v>11.839700040817252</c:v>
                </c:pt>
                <c:pt idx="916">
                  <c:v>14.852500061988806</c:v>
                </c:pt>
                <c:pt idx="917">
                  <c:v>9.3724999952315997</c:v>
                </c:pt>
                <c:pt idx="918">
                  <c:v>8.9874499320984462</c:v>
                </c:pt>
                <c:pt idx="919">
                  <c:v>10.117850008010798</c:v>
                </c:pt>
                <c:pt idx="920">
                  <c:v>10.499099960327094</c:v>
                </c:pt>
                <c:pt idx="921">
                  <c:v>10.908500037193299</c:v>
                </c:pt>
                <c:pt idx="922">
                  <c:v>11.897349901199355</c:v>
                </c:pt>
                <c:pt idx="923">
                  <c:v>15.929050230980003</c:v>
                </c:pt>
                <c:pt idx="924">
                  <c:v>13.384750027656551</c:v>
                </c:pt>
                <c:pt idx="925">
                  <c:v>12.246099929809603</c:v>
                </c:pt>
                <c:pt idx="926">
                  <c:v>5.4563999319076473</c:v>
                </c:pt>
                <c:pt idx="927">
                  <c:v>13.049349989891049</c:v>
                </c:pt>
                <c:pt idx="928">
                  <c:v>12.019849905967696</c:v>
                </c:pt>
                <c:pt idx="929">
                  <c:v>13.615799994468698</c:v>
                </c:pt>
                <c:pt idx="930">
                  <c:v>11.581649899482748</c:v>
                </c:pt>
                <c:pt idx="931">
                  <c:v>8.9892501258849968</c:v>
                </c:pt>
                <c:pt idx="932">
                  <c:v>10.688950037956253</c:v>
                </c:pt>
                <c:pt idx="933">
                  <c:v>9.5779999303817576</c:v>
                </c:pt>
                <c:pt idx="934">
                  <c:v>9.842049860954301</c:v>
                </c:pt>
                <c:pt idx="935">
                  <c:v>9.9838000106811009</c:v>
                </c:pt>
                <c:pt idx="936">
                  <c:v>11.740499887466399</c:v>
                </c:pt>
                <c:pt idx="937">
                  <c:v>11.494050059318546</c:v>
                </c:pt>
                <c:pt idx="938">
                  <c:v>5.5169500160217524</c:v>
                </c:pt>
                <c:pt idx="939">
                  <c:v>11.453300051689197</c:v>
                </c:pt>
                <c:pt idx="940">
                  <c:v>9.2975999116897512</c:v>
                </c:pt>
                <c:pt idx="941">
                  <c:v>12.164699745178247</c:v>
                </c:pt>
                <c:pt idx="942">
                  <c:v>12.207199954986599</c:v>
                </c:pt>
                <c:pt idx="943">
                  <c:v>8.5470998573303483</c:v>
                </c:pt>
                <c:pt idx="944">
                  <c:v>6.6726000833512025</c:v>
                </c:pt>
                <c:pt idx="945">
                  <c:v>11.140849981308001</c:v>
                </c:pt>
                <c:pt idx="946">
                  <c:v>11.573950052261353</c:v>
                </c:pt>
                <c:pt idx="947">
                  <c:v>10.645349907875051</c:v>
                </c:pt>
                <c:pt idx="948">
                  <c:v>9.8724998998641986</c:v>
                </c:pt>
                <c:pt idx="949">
                  <c:v>13.9305499720573</c:v>
                </c:pt>
                <c:pt idx="950">
                  <c:v>13.052699875831649</c:v>
                </c:pt>
                <c:pt idx="951">
                  <c:v>4.3539501953124997</c:v>
                </c:pt>
                <c:pt idx="952">
                  <c:v>4.3539501953124997</c:v>
                </c:pt>
                <c:pt idx="953">
                  <c:v>9.8348499965667457</c:v>
                </c:pt>
                <c:pt idx="954">
                  <c:v>12.938450074195849</c:v>
                </c:pt>
                <c:pt idx="955">
                  <c:v>10.599549975395202</c:v>
                </c:pt>
                <c:pt idx="956">
                  <c:v>9.2140999174118008</c:v>
                </c:pt>
                <c:pt idx="957">
                  <c:v>13.358000082969699</c:v>
                </c:pt>
                <c:pt idx="958">
                  <c:v>14.5807000827789</c:v>
                </c:pt>
                <c:pt idx="959">
                  <c:v>10.622649965286246</c:v>
                </c:pt>
                <c:pt idx="960">
                  <c:v>11.530199875831599</c:v>
                </c:pt>
                <c:pt idx="961">
                  <c:v>10.999700050354054</c:v>
                </c:pt>
                <c:pt idx="962">
                  <c:v>10.373149986267101</c:v>
                </c:pt>
                <c:pt idx="963">
                  <c:v>11.7392499637604</c:v>
                </c:pt>
                <c:pt idx="964">
                  <c:v>7.2559499549865514</c:v>
                </c:pt>
                <c:pt idx="965">
                  <c:v>10.623599910736047</c:v>
                </c:pt>
                <c:pt idx="966">
                  <c:v>9.8089499902725485</c:v>
                </c:pt>
                <c:pt idx="967">
                  <c:v>8.3403499603271456</c:v>
                </c:pt>
                <c:pt idx="968">
                  <c:v>11.180650033950851</c:v>
                </c:pt>
                <c:pt idx="969">
                  <c:v>8.2100499916076508</c:v>
                </c:pt>
                <c:pt idx="970">
                  <c:v>10.168650112152054</c:v>
                </c:pt>
                <c:pt idx="971">
                  <c:v>6.7283500051498457</c:v>
                </c:pt>
                <c:pt idx="972">
                  <c:v>6.7283500051498457</c:v>
                </c:pt>
                <c:pt idx="973">
                  <c:v>10.914950017929101</c:v>
                </c:pt>
                <c:pt idx="974">
                  <c:v>10.7993999528885</c:v>
                </c:pt>
                <c:pt idx="975">
                  <c:v>11.819499950409003</c:v>
                </c:pt>
                <c:pt idx="976">
                  <c:v>11.080550060272252</c:v>
                </c:pt>
                <c:pt idx="977">
                  <c:v>11.121300063133248</c:v>
                </c:pt>
                <c:pt idx="978">
                  <c:v>10.090300016403198</c:v>
                </c:pt>
                <c:pt idx="979">
                  <c:v>11.600649943351751</c:v>
                </c:pt>
                <c:pt idx="980">
                  <c:v>7.7265499973296983</c:v>
                </c:pt>
                <c:pt idx="981">
                  <c:v>10.839999952316301</c:v>
                </c:pt>
                <c:pt idx="982">
                  <c:v>12.474349913597102</c:v>
                </c:pt>
                <c:pt idx="983">
                  <c:v>11.204399995803797</c:v>
                </c:pt>
                <c:pt idx="984">
                  <c:v>10.304100127220195</c:v>
                </c:pt>
                <c:pt idx="985">
                  <c:v>9.0976501369475926</c:v>
                </c:pt>
                <c:pt idx="986">
                  <c:v>10.233699975013742</c:v>
                </c:pt>
                <c:pt idx="987">
                  <c:v>12.119549961090101</c:v>
                </c:pt>
                <c:pt idx="988">
                  <c:v>4.7559000158310027</c:v>
                </c:pt>
                <c:pt idx="989">
                  <c:v>4.7559000158310027</c:v>
                </c:pt>
                <c:pt idx="990">
                  <c:v>12.458299918174749</c:v>
                </c:pt>
                <c:pt idx="991">
                  <c:v>9.5601500415801972</c:v>
                </c:pt>
                <c:pt idx="992">
                  <c:v>11.845050001144401</c:v>
                </c:pt>
                <c:pt idx="993">
                  <c:v>12.747849965095497</c:v>
                </c:pt>
                <c:pt idx="994">
                  <c:v>12.5212000608444</c:v>
                </c:pt>
                <c:pt idx="995">
                  <c:v>7.7618501424789557</c:v>
                </c:pt>
                <c:pt idx="996">
                  <c:v>9.5714000654220506</c:v>
                </c:pt>
                <c:pt idx="997">
                  <c:v>11.722699937820398</c:v>
                </c:pt>
                <c:pt idx="998">
                  <c:v>12.058299970626848</c:v>
                </c:pt>
                <c:pt idx="999">
                  <c:v>10.383850064277702</c:v>
                </c:pt>
                <c:pt idx="1000">
                  <c:v>10.366099934577896</c:v>
                </c:pt>
                <c:pt idx="1001">
                  <c:v>9.0188500642777001</c:v>
                </c:pt>
                <c:pt idx="1002">
                  <c:v>11.13070004940035</c:v>
                </c:pt>
                <c:pt idx="1003">
                  <c:v>9.3710001468658533</c:v>
                </c:pt>
                <c:pt idx="1004">
                  <c:v>10.415049881935097</c:v>
                </c:pt>
                <c:pt idx="1005">
                  <c:v>10.474099963903448</c:v>
                </c:pt>
                <c:pt idx="1006">
                  <c:v>11.124849972724899</c:v>
                </c:pt>
                <c:pt idx="1007">
                  <c:v>10.128399930000299</c:v>
                </c:pt>
                <c:pt idx="1008">
                  <c:v>10.088500165939298</c:v>
                </c:pt>
                <c:pt idx="1009">
                  <c:v>9.3732000970839948</c:v>
                </c:pt>
                <c:pt idx="1010">
                  <c:v>12.477550044059754</c:v>
                </c:pt>
                <c:pt idx="1011">
                  <c:v>7.6086500453949029</c:v>
                </c:pt>
                <c:pt idx="1012">
                  <c:v>10.137199921607944</c:v>
                </c:pt>
                <c:pt idx="1013">
                  <c:v>11.205650038719146</c:v>
                </c:pt>
                <c:pt idx="1014">
                  <c:v>10.394400014877355</c:v>
                </c:pt>
                <c:pt idx="1015">
                  <c:v>9.0409999227523485</c:v>
                </c:pt>
                <c:pt idx="1016">
                  <c:v>11.076349849700897</c:v>
                </c:pt>
                <c:pt idx="1017">
                  <c:v>10.908549971580499</c:v>
                </c:pt>
                <c:pt idx="1018">
                  <c:v>8.9770999813079513</c:v>
                </c:pt>
                <c:pt idx="1019">
                  <c:v>8.0973999309539977</c:v>
                </c:pt>
                <c:pt idx="1020">
                  <c:v>10.93860012054445</c:v>
                </c:pt>
                <c:pt idx="1021">
                  <c:v>11.764400177001999</c:v>
                </c:pt>
                <c:pt idx="1022">
                  <c:v>10.619149971008301</c:v>
                </c:pt>
                <c:pt idx="1023">
                  <c:v>10.944950032234196</c:v>
                </c:pt>
                <c:pt idx="1024">
                  <c:v>9.9015999650955528</c:v>
                </c:pt>
                <c:pt idx="1025">
                  <c:v>10.022699923515304</c:v>
                </c:pt>
                <c:pt idx="1026">
                  <c:v>10.54629993438725</c:v>
                </c:pt>
                <c:pt idx="1027">
                  <c:v>13.693350090980495</c:v>
                </c:pt>
                <c:pt idx="1028">
                  <c:v>7.2326000022888053</c:v>
                </c:pt>
                <c:pt idx="1029">
                  <c:v>10.215850052833552</c:v>
                </c:pt>
                <c:pt idx="1030">
                  <c:v>13.24584997177125</c:v>
                </c:pt>
                <c:pt idx="1031">
                  <c:v>6.6737998580932469</c:v>
                </c:pt>
                <c:pt idx="1032">
                  <c:v>7.164000020027153</c:v>
                </c:pt>
                <c:pt idx="1033">
                  <c:v>7.2246000289916985</c:v>
                </c:pt>
                <c:pt idx="1034">
                  <c:v>9.0812500715256022</c:v>
                </c:pt>
                <c:pt idx="1035">
                  <c:v>10.732750029563899</c:v>
                </c:pt>
                <c:pt idx="1036">
                  <c:v>12.653199934959403</c:v>
                </c:pt>
                <c:pt idx="1037">
                  <c:v>7.3428498315811481</c:v>
                </c:pt>
                <c:pt idx="1038">
                  <c:v>10.28824979305265</c:v>
                </c:pt>
                <c:pt idx="1039">
                  <c:v>13.119499850273147</c:v>
                </c:pt>
                <c:pt idx="1040">
                  <c:v>12.059999880790649</c:v>
                </c:pt>
                <c:pt idx="1041">
                  <c:v>10.040850028991702</c:v>
                </c:pt>
                <c:pt idx="1042">
                  <c:v>10.704599990844702</c:v>
                </c:pt>
                <c:pt idx="1043">
                  <c:v>9.5152499151230501</c:v>
                </c:pt>
                <c:pt idx="1044">
                  <c:v>9.0562500572204456</c:v>
                </c:pt>
                <c:pt idx="1045">
                  <c:v>9.8974499654770014</c:v>
                </c:pt>
                <c:pt idx="1046">
                  <c:v>7.4301000022888459</c:v>
                </c:pt>
                <c:pt idx="1047">
                  <c:v>11.599249987602249</c:v>
                </c:pt>
                <c:pt idx="1048">
                  <c:v>11.940599932670601</c:v>
                </c:pt>
                <c:pt idx="1049">
                  <c:v>10.112599973678648</c:v>
                </c:pt>
                <c:pt idx="1050">
                  <c:v>9.7421501398086505</c:v>
                </c:pt>
                <c:pt idx="1051">
                  <c:v>9.799400095939653</c:v>
                </c:pt>
                <c:pt idx="1052">
                  <c:v>10.3784500551224</c:v>
                </c:pt>
                <c:pt idx="1053">
                  <c:v>12.537450070381155</c:v>
                </c:pt>
                <c:pt idx="1054">
                  <c:v>10.146099891662551</c:v>
                </c:pt>
                <c:pt idx="1055">
                  <c:v>7.2253499507904486</c:v>
                </c:pt>
                <c:pt idx="1056">
                  <c:v>7.9362498807907045</c:v>
                </c:pt>
                <c:pt idx="1057">
                  <c:v>12.962299842834497</c:v>
                </c:pt>
                <c:pt idx="1058">
                  <c:v>10.414600100517251</c:v>
                </c:pt>
                <c:pt idx="1059">
                  <c:v>7.3866999626159995</c:v>
                </c:pt>
                <c:pt idx="1060">
                  <c:v>7.0972500514983992</c:v>
                </c:pt>
                <c:pt idx="1061">
                  <c:v>7.1172001063823522</c:v>
                </c:pt>
                <c:pt idx="1062">
                  <c:v>7.1172001063823522</c:v>
                </c:pt>
                <c:pt idx="1063">
                  <c:v>11.223199944496201</c:v>
                </c:pt>
                <c:pt idx="1064">
                  <c:v>10.196199965477</c:v>
                </c:pt>
                <c:pt idx="1065">
                  <c:v>12.634649987220801</c:v>
                </c:pt>
                <c:pt idx="1066">
                  <c:v>9.4531999778747959</c:v>
                </c:pt>
                <c:pt idx="1067">
                  <c:v>10.017150011062654</c:v>
                </c:pt>
                <c:pt idx="1068">
                  <c:v>10.363050069808949</c:v>
                </c:pt>
                <c:pt idx="1069">
                  <c:v>5.859050021171555</c:v>
                </c:pt>
                <c:pt idx="1070">
                  <c:v>5.859050021171555</c:v>
                </c:pt>
                <c:pt idx="1071">
                  <c:v>10.302899961471553</c:v>
                </c:pt>
                <c:pt idx="1072">
                  <c:v>11.863900117874149</c:v>
                </c:pt>
                <c:pt idx="1073">
                  <c:v>10.584349818229651</c:v>
                </c:pt>
                <c:pt idx="1074">
                  <c:v>12.199549922943099</c:v>
                </c:pt>
                <c:pt idx="1075">
                  <c:v>10.566899957656847</c:v>
                </c:pt>
                <c:pt idx="1076">
                  <c:v>11.514699978828396</c:v>
                </c:pt>
                <c:pt idx="1077">
                  <c:v>7.7902498865127541</c:v>
                </c:pt>
                <c:pt idx="1078">
                  <c:v>13.090400032997099</c:v>
                </c:pt>
                <c:pt idx="1079">
                  <c:v>10.131349997520449</c:v>
                </c:pt>
                <c:pt idx="1080">
                  <c:v>5.4806499767303478</c:v>
                </c:pt>
                <c:pt idx="1081">
                  <c:v>11.488700037002548</c:v>
                </c:pt>
                <c:pt idx="1082">
                  <c:v>10.831000037193352</c:v>
                </c:pt>
                <c:pt idx="1083">
                  <c:v>9.6631999826430999</c:v>
                </c:pt>
                <c:pt idx="1084">
                  <c:v>13.395500040054301</c:v>
                </c:pt>
                <c:pt idx="1085">
                  <c:v>13.798900012969952</c:v>
                </c:pt>
                <c:pt idx="1086">
                  <c:v>11.652650003433202</c:v>
                </c:pt>
                <c:pt idx="1087">
                  <c:v>12.495199918746952</c:v>
                </c:pt>
                <c:pt idx="1088">
                  <c:v>8.251750092506402</c:v>
                </c:pt>
                <c:pt idx="1089">
                  <c:v>10.862299933433498</c:v>
                </c:pt>
                <c:pt idx="1090">
                  <c:v>-1.5261998844146554</c:v>
                </c:pt>
                <c:pt idx="1091">
                  <c:v>11.736499881744351</c:v>
                </c:pt>
                <c:pt idx="1092">
                  <c:v>10.816400079727149</c:v>
                </c:pt>
                <c:pt idx="1093">
                  <c:v>8.3814999103545986</c:v>
                </c:pt>
                <c:pt idx="1094">
                  <c:v>11.199550085067756</c:v>
                </c:pt>
                <c:pt idx="1095">
                  <c:v>5.7246001148224011</c:v>
                </c:pt>
                <c:pt idx="1096">
                  <c:v>9.2378000020980515</c:v>
                </c:pt>
                <c:pt idx="1097">
                  <c:v>11.420350022315947</c:v>
                </c:pt>
                <c:pt idx="1098">
                  <c:v>6.0738001728058038</c:v>
                </c:pt>
                <c:pt idx="1099">
                  <c:v>6.0738001728058038</c:v>
                </c:pt>
                <c:pt idx="1100">
                  <c:v>8.9007499980926994</c:v>
                </c:pt>
                <c:pt idx="1101">
                  <c:v>11.744399905204752</c:v>
                </c:pt>
                <c:pt idx="1102">
                  <c:v>9.4867999887466503</c:v>
                </c:pt>
                <c:pt idx="1103">
                  <c:v>7.4611999464035001</c:v>
                </c:pt>
                <c:pt idx="1104">
                  <c:v>10.882399935722301</c:v>
                </c:pt>
                <c:pt idx="1105">
                  <c:v>13.144299955368052</c:v>
                </c:pt>
                <c:pt idx="1106">
                  <c:v>7.7908999013901017</c:v>
                </c:pt>
                <c:pt idx="1107">
                  <c:v>10.632949995994601</c:v>
                </c:pt>
                <c:pt idx="1108">
                  <c:v>9.3465999031066538</c:v>
                </c:pt>
                <c:pt idx="1109">
                  <c:v>9.9825999641418512</c:v>
                </c:pt>
                <c:pt idx="1110">
                  <c:v>9.4157999897003997</c:v>
                </c:pt>
                <c:pt idx="1111">
                  <c:v>8.8604497957229498</c:v>
                </c:pt>
                <c:pt idx="1112">
                  <c:v>6.4049998998641513</c:v>
                </c:pt>
                <c:pt idx="1113">
                  <c:v>9.328649883270252</c:v>
                </c:pt>
                <c:pt idx="1114">
                  <c:v>8.3337998485565024</c:v>
                </c:pt>
                <c:pt idx="1115">
                  <c:v>11.121300005912801</c:v>
                </c:pt>
                <c:pt idx="1116">
                  <c:v>10.617499823570252</c:v>
                </c:pt>
                <c:pt idx="1117">
                  <c:v>11.267149934768646</c:v>
                </c:pt>
                <c:pt idx="1118">
                  <c:v>9.8587499189377041</c:v>
                </c:pt>
                <c:pt idx="1119">
                  <c:v>9.7473499774933003</c:v>
                </c:pt>
                <c:pt idx="1120">
                  <c:v>10.067050013542151</c:v>
                </c:pt>
                <c:pt idx="1121">
                  <c:v>7.4044500160217517</c:v>
                </c:pt>
                <c:pt idx="1122">
                  <c:v>4.5273000502586527</c:v>
                </c:pt>
                <c:pt idx="1123">
                  <c:v>4.5273000502586527</c:v>
                </c:pt>
                <c:pt idx="1124">
                  <c:v>10.885499925613349</c:v>
                </c:pt>
                <c:pt idx="1125">
                  <c:v>11.364950089454599</c:v>
                </c:pt>
                <c:pt idx="1126">
                  <c:v>10.429899988174451</c:v>
                </c:pt>
                <c:pt idx="1127">
                  <c:v>8.2497500944137485</c:v>
                </c:pt>
                <c:pt idx="1128">
                  <c:v>9.8591499376297023</c:v>
                </c:pt>
                <c:pt idx="1129">
                  <c:v>8.4340999174117997</c:v>
                </c:pt>
                <c:pt idx="1130">
                  <c:v>12.539450078010553</c:v>
                </c:pt>
                <c:pt idx="1131">
                  <c:v>5.758349933624249</c:v>
                </c:pt>
                <c:pt idx="1132">
                  <c:v>3.2805000305175476</c:v>
                </c:pt>
                <c:pt idx="1133">
                  <c:v>11.068300056457499</c:v>
                </c:pt>
                <c:pt idx="1134">
                  <c:v>11.409150133132947</c:v>
                </c:pt>
                <c:pt idx="1135">
                  <c:v>9.5031500864028509</c:v>
                </c:pt>
                <c:pt idx="1136">
                  <c:v>13.448499970436099</c:v>
                </c:pt>
                <c:pt idx="1137">
                  <c:v>13.123150053024304</c:v>
                </c:pt>
                <c:pt idx="1138">
                  <c:v>6.5889501571654989</c:v>
                </c:pt>
                <c:pt idx="1139">
                  <c:v>8.2628000211715502</c:v>
                </c:pt>
                <c:pt idx="1140">
                  <c:v>8.2875000715255993</c:v>
                </c:pt>
                <c:pt idx="1141">
                  <c:v>10.563499951362648</c:v>
                </c:pt>
                <c:pt idx="1142">
                  <c:v>8.4181999492645474</c:v>
                </c:pt>
                <c:pt idx="1143">
                  <c:v>4.3738500118255494</c:v>
                </c:pt>
                <c:pt idx="1144">
                  <c:v>12.098049917221097</c:v>
                </c:pt>
                <c:pt idx="1145">
                  <c:v>10.597049875259401</c:v>
                </c:pt>
                <c:pt idx="1146">
                  <c:v>10.087650098800648</c:v>
                </c:pt>
                <c:pt idx="1147">
                  <c:v>8.3826000690459992</c:v>
                </c:pt>
                <c:pt idx="1148">
                  <c:v>11.4522000741959</c:v>
                </c:pt>
                <c:pt idx="1149">
                  <c:v>9.0224499082564975</c:v>
                </c:pt>
                <c:pt idx="1150">
                  <c:v>8.2978998804093003</c:v>
                </c:pt>
                <c:pt idx="1151">
                  <c:v>9.7523998832702503</c:v>
                </c:pt>
                <c:pt idx="1152">
                  <c:v>10.626249828338651</c:v>
                </c:pt>
                <c:pt idx="1153">
                  <c:v>8.9756998586655001</c:v>
                </c:pt>
                <c:pt idx="1154">
                  <c:v>9.3903498268127485</c:v>
                </c:pt>
                <c:pt idx="1155">
                  <c:v>10.135149998664801</c:v>
                </c:pt>
                <c:pt idx="1156">
                  <c:v>8.4332501459121971</c:v>
                </c:pt>
                <c:pt idx="1157">
                  <c:v>10.3020000219345</c:v>
                </c:pt>
                <c:pt idx="1158">
                  <c:v>9.190749974250803</c:v>
                </c:pt>
                <c:pt idx="1159">
                  <c:v>11.412049913406349</c:v>
                </c:pt>
                <c:pt idx="1160">
                  <c:v>12.960299935340849</c:v>
                </c:pt>
                <c:pt idx="1161">
                  <c:v>6.7957000923156485</c:v>
                </c:pt>
                <c:pt idx="1162">
                  <c:v>8.2432000970839994</c:v>
                </c:pt>
                <c:pt idx="1163">
                  <c:v>5.7491000175476046</c:v>
                </c:pt>
                <c:pt idx="1164">
                  <c:v>10.034099907875103</c:v>
                </c:pt>
                <c:pt idx="1165">
                  <c:v>11.227299904823351</c:v>
                </c:pt>
                <c:pt idx="1166">
                  <c:v>9.538800044059748</c:v>
                </c:pt>
                <c:pt idx="1167">
                  <c:v>5.7165000343322454</c:v>
                </c:pt>
                <c:pt idx="1168">
                  <c:v>11.573499836921702</c:v>
                </c:pt>
                <c:pt idx="1169">
                  <c:v>13.891300039291401</c:v>
                </c:pt>
                <c:pt idx="1170">
                  <c:v>8.6563499498367484</c:v>
                </c:pt>
                <c:pt idx="1171">
                  <c:v>6.1867500734330001</c:v>
                </c:pt>
                <c:pt idx="1172">
                  <c:v>6.1867500734330001</c:v>
                </c:pt>
                <c:pt idx="1173">
                  <c:v>11.103549919128398</c:v>
                </c:pt>
                <c:pt idx="1174">
                  <c:v>6.2554000473021993</c:v>
                </c:pt>
                <c:pt idx="1175">
                  <c:v>8.944100012779252</c:v>
                </c:pt>
                <c:pt idx="1176">
                  <c:v>11.268850102424651</c:v>
                </c:pt>
                <c:pt idx="1177">
                  <c:v>8.725399937629696</c:v>
                </c:pt>
                <c:pt idx="1178">
                  <c:v>9.632599911689752</c:v>
                </c:pt>
                <c:pt idx="1179">
                  <c:v>6.9486999893188468</c:v>
                </c:pt>
                <c:pt idx="1180">
                  <c:v>6.9486999893188468</c:v>
                </c:pt>
                <c:pt idx="1181">
                  <c:v>10.378800001144398</c:v>
                </c:pt>
                <c:pt idx="1182">
                  <c:v>8.9090501308441503</c:v>
                </c:pt>
                <c:pt idx="1183">
                  <c:v>10.527249855995201</c:v>
                </c:pt>
                <c:pt idx="1184">
                  <c:v>4.8674999952316504</c:v>
                </c:pt>
                <c:pt idx="1185">
                  <c:v>4.8674999952316504</c:v>
                </c:pt>
                <c:pt idx="1186">
                  <c:v>-10.157049903869602</c:v>
                </c:pt>
                <c:pt idx="1187">
                  <c:v>7.0967499113083008</c:v>
                </c:pt>
                <c:pt idx="1188">
                  <c:v>8.8377000474929517</c:v>
                </c:pt>
                <c:pt idx="1189">
                  <c:v>11.490300054550151</c:v>
                </c:pt>
                <c:pt idx="1190">
                  <c:v>8.6191999816894516</c:v>
                </c:pt>
                <c:pt idx="1191">
                  <c:v>9.9674499034880988</c:v>
                </c:pt>
                <c:pt idx="1192">
                  <c:v>10.181000123023953</c:v>
                </c:pt>
                <c:pt idx="1193">
                  <c:v>9.095899958610552</c:v>
                </c:pt>
                <c:pt idx="1194">
                  <c:v>7.0729500102997029</c:v>
                </c:pt>
                <c:pt idx="1195">
                  <c:v>11.018999943733199</c:v>
                </c:pt>
                <c:pt idx="1196">
                  <c:v>9.2732500267028506</c:v>
                </c:pt>
                <c:pt idx="1197">
                  <c:v>10.858449859619153</c:v>
                </c:pt>
                <c:pt idx="1198">
                  <c:v>8.9793999195098984</c:v>
                </c:pt>
                <c:pt idx="1199">
                  <c:v>11.10104999542235</c:v>
                </c:pt>
                <c:pt idx="1200">
                  <c:v>9.4154999637604035</c:v>
                </c:pt>
                <c:pt idx="1201">
                  <c:v>8.3564499759674007</c:v>
                </c:pt>
                <c:pt idx="1202">
                  <c:v>8.5820999479293967</c:v>
                </c:pt>
                <c:pt idx="1203">
                  <c:v>9.6466500091552021</c:v>
                </c:pt>
                <c:pt idx="1204">
                  <c:v>10.6397498464584</c:v>
                </c:pt>
                <c:pt idx="1205">
                  <c:v>7.8616500377654503</c:v>
                </c:pt>
                <c:pt idx="1206">
                  <c:v>9.0808999729157023</c:v>
                </c:pt>
                <c:pt idx="1207">
                  <c:v>9.3511999845504512</c:v>
                </c:pt>
                <c:pt idx="1208">
                  <c:v>9.6016500377654985</c:v>
                </c:pt>
                <c:pt idx="1209">
                  <c:v>10.165649909973201</c:v>
                </c:pt>
                <c:pt idx="1210">
                  <c:v>12.875150008201601</c:v>
                </c:pt>
                <c:pt idx="1211">
                  <c:v>12.020849933624252</c:v>
                </c:pt>
                <c:pt idx="1212">
                  <c:v>9.1079498243331543</c:v>
                </c:pt>
                <c:pt idx="1213">
                  <c:v>9.3932499122619504</c:v>
                </c:pt>
                <c:pt idx="1214">
                  <c:v>9.7338500595093009</c:v>
                </c:pt>
                <c:pt idx="1215">
                  <c:v>8.1649499082564994</c:v>
                </c:pt>
                <c:pt idx="1216">
                  <c:v>10.690900106430046</c:v>
                </c:pt>
                <c:pt idx="1217">
                  <c:v>7.9091000270842997</c:v>
                </c:pt>
                <c:pt idx="1218">
                  <c:v>10.357199969291646</c:v>
                </c:pt>
                <c:pt idx="1219">
                  <c:v>11.039199843406699</c:v>
                </c:pt>
                <c:pt idx="1220">
                  <c:v>5.7544999504089489</c:v>
                </c:pt>
                <c:pt idx="1221">
                  <c:v>11.183549871444697</c:v>
                </c:pt>
                <c:pt idx="1222">
                  <c:v>9.9083499813079996</c:v>
                </c:pt>
                <c:pt idx="1223">
                  <c:v>9.0844499921798523</c:v>
                </c:pt>
                <c:pt idx="1224">
                  <c:v>9.5713498830795025</c:v>
                </c:pt>
                <c:pt idx="1225">
                  <c:v>7.7252498769760045</c:v>
                </c:pt>
                <c:pt idx="1226">
                  <c:v>7.3063499450684013</c:v>
                </c:pt>
                <c:pt idx="1227">
                  <c:v>7.3063499450684013</c:v>
                </c:pt>
                <c:pt idx="1228">
                  <c:v>12.921049847602848</c:v>
                </c:pt>
                <c:pt idx="1229">
                  <c:v>6.5404000473022492</c:v>
                </c:pt>
                <c:pt idx="1230">
                  <c:v>8.6671498489380028</c:v>
                </c:pt>
                <c:pt idx="1231">
                  <c:v>7.5799999713897499</c:v>
                </c:pt>
                <c:pt idx="1232">
                  <c:v>9.0729499292373497</c:v>
                </c:pt>
                <c:pt idx="1233">
                  <c:v>6.4121500015259016</c:v>
                </c:pt>
                <c:pt idx="1234">
                  <c:v>9.6643499469756513</c:v>
                </c:pt>
                <c:pt idx="1235">
                  <c:v>12.035800065994302</c:v>
                </c:pt>
                <c:pt idx="1236">
                  <c:v>9.0093500089644998</c:v>
                </c:pt>
                <c:pt idx="1237">
                  <c:v>7.9062999248504973</c:v>
                </c:pt>
                <c:pt idx="1238">
                  <c:v>10.586700110435451</c:v>
                </c:pt>
                <c:pt idx="1239">
                  <c:v>8.9112999725341524</c:v>
                </c:pt>
                <c:pt idx="1240">
                  <c:v>10.285599975585995</c:v>
                </c:pt>
                <c:pt idx="1241">
                  <c:v>8.8977000331878493</c:v>
                </c:pt>
                <c:pt idx="1242">
                  <c:v>10.501399993896449</c:v>
                </c:pt>
                <c:pt idx="1243">
                  <c:v>5.5910499429703009</c:v>
                </c:pt>
                <c:pt idx="1244">
                  <c:v>8.3318500375747462</c:v>
                </c:pt>
                <c:pt idx="1245">
                  <c:v>9.1589499473572502</c:v>
                </c:pt>
                <c:pt idx="1246">
                  <c:v>9.7125499176978494</c:v>
                </c:pt>
                <c:pt idx="1247">
                  <c:v>6.478600001335149</c:v>
                </c:pt>
                <c:pt idx="1248">
                  <c:v>9.5213998985290473</c:v>
                </c:pt>
                <c:pt idx="1249">
                  <c:v>9.5347999715805472</c:v>
                </c:pt>
                <c:pt idx="1250">
                  <c:v>9.0689000368118009</c:v>
                </c:pt>
                <c:pt idx="1251">
                  <c:v>8.7223500442505504</c:v>
                </c:pt>
                <c:pt idx="1252">
                  <c:v>8.2030501079559528</c:v>
                </c:pt>
                <c:pt idx="1253">
                  <c:v>8.1592999553680485</c:v>
                </c:pt>
                <c:pt idx="1254">
                  <c:v>8.7266000127792474</c:v>
                </c:pt>
                <c:pt idx="1255">
                  <c:v>10.256749906539952</c:v>
                </c:pt>
                <c:pt idx="1256">
                  <c:v>5.4193500518798494</c:v>
                </c:pt>
                <c:pt idx="1257">
                  <c:v>9.5715000820159517</c:v>
                </c:pt>
                <c:pt idx="1258">
                  <c:v>10.172449989318796</c:v>
                </c:pt>
                <c:pt idx="1259">
                  <c:v>8.7689999341965041</c:v>
                </c:pt>
                <c:pt idx="1260">
                  <c:v>3.6576001262664519</c:v>
                </c:pt>
                <c:pt idx="1261">
                  <c:v>8.8600499868393499</c:v>
                </c:pt>
                <c:pt idx="1262">
                  <c:v>8.130399904251103</c:v>
                </c:pt>
                <c:pt idx="1263">
                  <c:v>11.911750001907354</c:v>
                </c:pt>
                <c:pt idx="1264">
                  <c:v>10.292050032615652</c:v>
                </c:pt>
                <c:pt idx="1265">
                  <c:v>8.3640999031066983</c:v>
                </c:pt>
                <c:pt idx="1266">
                  <c:v>11.37229981660845</c:v>
                </c:pt>
                <c:pt idx="1267">
                  <c:v>8.271149964332551</c:v>
                </c:pt>
                <c:pt idx="1268">
                  <c:v>10.321499953269896</c:v>
                </c:pt>
                <c:pt idx="1269">
                  <c:v>12.22004992485045</c:v>
                </c:pt>
                <c:pt idx="1270">
                  <c:v>10.399650001525899</c:v>
                </c:pt>
                <c:pt idx="1271">
                  <c:v>12.074000020027153</c:v>
                </c:pt>
                <c:pt idx="1272">
                  <c:v>8.2940497922897514</c:v>
                </c:pt>
                <c:pt idx="1273">
                  <c:v>11.07165008068085</c:v>
                </c:pt>
                <c:pt idx="1274">
                  <c:v>7.8551498270035047</c:v>
                </c:pt>
                <c:pt idx="1275">
                  <c:v>9.4360999488831006</c:v>
                </c:pt>
                <c:pt idx="1276">
                  <c:v>9.2953499412536509</c:v>
                </c:pt>
                <c:pt idx="1277">
                  <c:v>6.4090499162673993</c:v>
                </c:pt>
                <c:pt idx="1278">
                  <c:v>9.755950098037701</c:v>
                </c:pt>
                <c:pt idx="1279">
                  <c:v>8.3178499984740988</c:v>
                </c:pt>
                <c:pt idx="1280">
                  <c:v>9.805699915885949</c:v>
                </c:pt>
                <c:pt idx="1281">
                  <c:v>10.132449913024949</c:v>
                </c:pt>
                <c:pt idx="1282">
                  <c:v>7.2748999118804996</c:v>
                </c:pt>
                <c:pt idx="1283">
                  <c:v>10.351900057792651</c:v>
                </c:pt>
                <c:pt idx="1284">
                  <c:v>10.121399984359698</c:v>
                </c:pt>
                <c:pt idx="1285">
                  <c:v>9.7979999494553027</c:v>
                </c:pt>
                <c:pt idx="1286">
                  <c:v>9.5256499242782482</c:v>
                </c:pt>
                <c:pt idx="1287">
                  <c:v>9.6204500484466529</c:v>
                </c:pt>
                <c:pt idx="1288">
                  <c:v>10.852599902153049</c:v>
                </c:pt>
                <c:pt idx="1289">
                  <c:v>12.0746998691559</c:v>
                </c:pt>
                <c:pt idx="1290">
                  <c:v>9.0660500431060989</c:v>
                </c:pt>
                <c:pt idx="1291">
                  <c:v>8.2013000059128025</c:v>
                </c:pt>
                <c:pt idx="1292">
                  <c:v>11.642249941825799</c:v>
                </c:pt>
                <c:pt idx="1293">
                  <c:v>2.8106500482559476</c:v>
                </c:pt>
                <c:pt idx="1294">
                  <c:v>2.8106500482559476</c:v>
                </c:pt>
                <c:pt idx="1295">
                  <c:v>8.3144499969481984</c:v>
                </c:pt>
                <c:pt idx="1296">
                  <c:v>9.2824997806548986</c:v>
                </c:pt>
                <c:pt idx="1297">
                  <c:v>11.04074999809265</c:v>
                </c:pt>
                <c:pt idx="1298">
                  <c:v>9.2686999416351483</c:v>
                </c:pt>
                <c:pt idx="1299">
                  <c:v>9.0442000198364028</c:v>
                </c:pt>
                <c:pt idx="1300">
                  <c:v>12.846699914932202</c:v>
                </c:pt>
                <c:pt idx="1301">
                  <c:v>9.0883499526977509</c:v>
                </c:pt>
                <c:pt idx="1302">
                  <c:v>9.1295500755310002</c:v>
                </c:pt>
                <c:pt idx="1303">
                  <c:v>7.9243498897552485</c:v>
                </c:pt>
                <c:pt idx="1304">
                  <c:v>1.8890997982024977</c:v>
                </c:pt>
                <c:pt idx="1305">
                  <c:v>1.8890997982024977</c:v>
                </c:pt>
                <c:pt idx="1306">
                  <c:v>7.2826498508453525</c:v>
                </c:pt>
                <c:pt idx="1307">
                  <c:v>7.3245499944686969</c:v>
                </c:pt>
                <c:pt idx="1308">
                  <c:v>6.5690498113632003</c:v>
                </c:pt>
                <c:pt idx="1309">
                  <c:v>5.917000021934502</c:v>
                </c:pt>
                <c:pt idx="1310">
                  <c:v>10.19674990177155</c:v>
                </c:pt>
                <c:pt idx="1311">
                  <c:v>8.9051998138427493</c:v>
                </c:pt>
                <c:pt idx="1312">
                  <c:v>10.242849926948502</c:v>
                </c:pt>
                <c:pt idx="1313">
                  <c:v>10.745799903869649</c:v>
                </c:pt>
                <c:pt idx="1314">
                  <c:v>9.5562498140334995</c:v>
                </c:pt>
                <c:pt idx="1315">
                  <c:v>8.2855499505996448</c:v>
                </c:pt>
                <c:pt idx="1316">
                  <c:v>8.2521000480651985</c:v>
                </c:pt>
                <c:pt idx="1317">
                  <c:v>6.2575499391555987</c:v>
                </c:pt>
                <c:pt idx="1318">
                  <c:v>11.324849948883049</c:v>
                </c:pt>
                <c:pt idx="1319">
                  <c:v>7.4226000547409043</c:v>
                </c:pt>
                <c:pt idx="1320">
                  <c:v>9.7829500770569027</c:v>
                </c:pt>
                <c:pt idx="1321">
                  <c:v>11.231899962425203</c:v>
                </c:pt>
                <c:pt idx="1322">
                  <c:v>9.2418999242782505</c:v>
                </c:pt>
                <c:pt idx="1323">
                  <c:v>9.1104499244690516</c:v>
                </c:pt>
                <c:pt idx="1324">
                  <c:v>7.8328998565673977</c:v>
                </c:pt>
                <c:pt idx="1325">
                  <c:v>10.297949905395502</c:v>
                </c:pt>
                <c:pt idx="1326">
                  <c:v>7.4039998912811527</c:v>
                </c:pt>
                <c:pt idx="1327">
                  <c:v>9.3162499427795495</c:v>
                </c:pt>
                <c:pt idx="1328">
                  <c:v>10.111199889183052</c:v>
                </c:pt>
                <c:pt idx="1329">
                  <c:v>6.787449851036051</c:v>
                </c:pt>
                <c:pt idx="1330">
                  <c:v>6.3890000343322981</c:v>
                </c:pt>
                <c:pt idx="1331">
                  <c:v>10.04879983901975</c:v>
                </c:pt>
                <c:pt idx="1332">
                  <c:v>9.4115000677109002</c:v>
                </c:pt>
                <c:pt idx="1333">
                  <c:v>9.2700000643729972</c:v>
                </c:pt>
                <c:pt idx="1334">
                  <c:v>8.6692000341414968</c:v>
                </c:pt>
                <c:pt idx="1335">
                  <c:v>9.7273498535156513</c:v>
                </c:pt>
                <c:pt idx="1336">
                  <c:v>8.3525500297546991</c:v>
                </c:pt>
                <c:pt idx="1337">
                  <c:v>9.5256500816345522</c:v>
                </c:pt>
                <c:pt idx="1338">
                  <c:v>8.3456000328063524</c:v>
                </c:pt>
                <c:pt idx="1339">
                  <c:v>8.3368998861313024</c:v>
                </c:pt>
                <c:pt idx="1340">
                  <c:v>10.3902499961853</c:v>
                </c:pt>
                <c:pt idx="1341">
                  <c:v>9.015999937057547</c:v>
                </c:pt>
                <c:pt idx="1342">
                  <c:v>7.7952498674393027</c:v>
                </c:pt>
                <c:pt idx="1343">
                  <c:v>9.1134500408172556</c:v>
                </c:pt>
                <c:pt idx="1344">
                  <c:v>8.6486999130248492</c:v>
                </c:pt>
                <c:pt idx="1345">
                  <c:v>8.6326499938965</c:v>
                </c:pt>
                <c:pt idx="1346">
                  <c:v>7.1639000511169471</c:v>
                </c:pt>
                <c:pt idx="1347">
                  <c:v>8.1056499958038515</c:v>
                </c:pt>
                <c:pt idx="1348">
                  <c:v>5.4022499418258505</c:v>
                </c:pt>
                <c:pt idx="1349">
                  <c:v>6.5733500337600503</c:v>
                </c:pt>
                <c:pt idx="1350">
                  <c:v>7.8973500633239482</c:v>
                </c:pt>
                <c:pt idx="1351">
                  <c:v>6.4961499309539974</c:v>
                </c:pt>
                <c:pt idx="1352">
                  <c:v>10.830000009536747</c:v>
                </c:pt>
                <c:pt idx="1353">
                  <c:v>10.23114981174465</c:v>
                </c:pt>
                <c:pt idx="1354">
                  <c:v>7.3483998441696485</c:v>
                </c:pt>
                <c:pt idx="1355">
                  <c:v>7.2385499620437486</c:v>
                </c:pt>
                <c:pt idx="1356">
                  <c:v>9.4599500083923544</c:v>
                </c:pt>
                <c:pt idx="1357">
                  <c:v>10.874199995994548</c:v>
                </c:pt>
                <c:pt idx="1358">
                  <c:v>6.8909499502182001</c:v>
                </c:pt>
                <c:pt idx="1359">
                  <c:v>8.8933501291274979</c:v>
                </c:pt>
                <c:pt idx="1360">
                  <c:v>9.7060499334335475</c:v>
                </c:pt>
                <c:pt idx="1361">
                  <c:v>8.6461000442504456</c:v>
                </c:pt>
                <c:pt idx="1362">
                  <c:v>6.6797000789641992</c:v>
                </c:pt>
                <c:pt idx="1363">
                  <c:v>7.8442499399185017</c:v>
                </c:pt>
                <c:pt idx="1364">
                  <c:v>10.5276999998093</c:v>
                </c:pt>
                <c:pt idx="1365">
                  <c:v>9.5198999977111001</c:v>
                </c:pt>
                <c:pt idx="1366">
                  <c:v>8.5813499832153468</c:v>
                </c:pt>
                <c:pt idx="1367">
                  <c:v>5.4047000217437997</c:v>
                </c:pt>
                <c:pt idx="1368">
                  <c:v>8.7028000545501989</c:v>
                </c:pt>
                <c:pt idx="1369">
                  <c:v>11.3229499673843</c:v>
                </c:pt>
                <c:pt idx="1370">
                  <c:v>10.316099920272798</c:v>
                </c:pt>
                <c:pt idx="1371">
                  <c:v>8.5501498651504519</c:v>
                </c:pt>
                <c:pt idx="1372">
                  <c:v>7.6205999374389997</c:v>
                </c:pt>
                <c:pt idx="1373">
                  <c:v>9.2500500106812034</c:v>
                </c:pt>
                <c:pt idx="1374">
                  <c:v>8.8831500053406494</c:v>
                </c:pt>
                <c:pt idx="1375">
                  <c:v>5.8316999292374518</c:v>
                </c:pt>
                <c:pt idx="1376">
                  <c:v>8.9598500299454003</c:v>
                </c:pt>
                <c:pt idx="1377">
                  <c:v>6.6838999795913523</c:v>
                </c:pt>
                <c:pt idx="1378">
                  <c:v>3.6408499574661519</c:v>
                </c:pt>
                <c:pt idx="1379">
                  <c:v>9.1179499292373514</c:v>
                </c:pt>
                <c:pt idx="1380">
                  <c:v>9.7687499475478496</c:v>
                </c:pt>
                <c:pt idx="1381">
                  <c:v>9.8119000387192017</c:v>
                </c:pt>
                <c:pt idx="1382">
                  <c:v>7.0625498056411473</c:v>
                </c:pt>
                <c:pt idx="1383">
                  <c:v>11.293449907302847</c:v>
                </c:pt>
                <c:pt idx="1384">
                  <c:v>9.7386500215530489</c:v>
                </c:pt>
                <c:pt idx="1385">
                  <c:v>10.204149951934799</c:v>
                </c:pt>
                <c:pt idx="1386">
                  <c:v>-2.8556499147415018</c:v>
                </c:pt>
                <c:pt idx="1387">
                  <c:v>9.4902998161315999</c:v>
                </c:pt>
                <c:pt idx="1388">
                  <c:v>8.364049897193901</c:v>
                </c:pt>
                <c:pt idx="1389">
                  <c:v>8.344700102806101</c:v>
                </c:pt>
                <c:pt idx="1390">
                  <c:v>6.5784000539779512</c:v>
                </c:pt>
                <c:pt idx="1391">
                  <c:v>10.682249903678901</c:v>
                </c:pt>
                <c:pt idx="1392">
                  <c:v>6.468299965858499</c:v>
                </c:pt>
                <c:pt idx="1393">
                  <c:v>6.9731000423431482</c:v>
                </c:pt>
                <c:pt idx="1394">
                  <c:v>7.0585998487471997</c:v>
                </c:pt>
                <c:pt idx="1395">
                  <c:v>9.8612499141692993</c:v>
                </c:pt>
                <c:pt idx="1396">
                  <c:v>9.3210500001906986</c:v>
                </c:pt>
                <c:pt idx="1397">
                  <c:v>9.8141998672485506</c:v>
                </c:pt>
                <c:pt idx="1398">
                  <c:v>6.4356999731063986</c:v>
                </c:pt>
                <c:pt idx="1399">
                  <c:v>5.972700057029698</c:v>
                </c:pt>
                <c:pt idx="1400">
                  <c:v>5.5229498481750525</c:v>
                </c:pt>
                <c:pt idx="1401">
                  <c:v>5.660199880600004</c:v>
                </c:pt>
                <c:pt idx="1402">
                  <c:v>7.7003498077391974</c:v>
                </c:pt>
                <c:pt idx="1403">
                  <c:v>10.812550115585346</c:v>
                </c:pt>
                <c:pt idx="1404">
                  <c:v>7.1341998052596978</c:v>
                </c:pt>
                <c:pt idx="1405">
                  <c:v>7.8727498412131993</c:v>
                </c:pt>
                <c:pt idx="1406">
                  <c:v>10.735550017356847</c:v>
                </c:pt>
                <c:pt idx="1407">
                  <c:v>10.948499999046348</c:v>
                </c:pt>
                <c:pt idx="1408">
                  <c:v>7.0560499191284514</c:v>
                </c:pt>
                <c:pt idx="1409">
                  <c:v>7.6026500368117986</c:v>
                </c:pt>
                <c:pt idx="1410">
                  <c:v>8.9104500484466485</c:v>
                </c:pt>
                <c:pt idx="1411">
                  <c:v>6.99709992408755</c:v>
                </c:pt>
                <c:pt idx="1412">
                  <c:v>8.1075001335143995</c:v>
                </c:pt>
                <c:pt idx="1413">
                  <c:v>11.668849997520397</c:v>
                </c:pt>
                <c:pt idx="1414">
                  <c:v>5.2705500602722495</c:v>
                </c:pt>
                <c:pt idx="1415">
                  <c:v>6.2132998228073504</c:v>
                </c:pt>
                <c:pt idx="1416">
                  <c:v>6.3605998945236522</c:v>
                </c:pt>
                <c:pt idx="1417">
                  <c:v>9.823800001144452</c:v>
                </c:pt>
                <c:pt idx="1418">
                  <c:v>7.4832499313354504</c:v>
                </c:pt>
                <c:pt idx="1419">
                  <c:v>5.7475999164581495</c:v>
                </c:pt>
                <c:pt idx="1420">
                  <c:v>8.1473999261855994</c:v>
                </c:pt>
                <c:pt idx="1421">
                  <c:v>9.0055001163482977</c:v>
                </c:pt>
                <c:pt idx="1422">
                  <c:v>8.5327998971939003</c:v>
                </c:pt>
                <c:pt idx="1423">
                  <c:v>7.0951000595092495</c:v>
                </c:pt>
                <c:pt idx="1424">
                  <c:v>9.4186999034881502</c:v>
                </c:pt>
                <c:pt idx="1425">
                  <c:v>10.488649897575353</c:v>
                </c:pt>
                <c:pt idx="1426">
                  <c:v>11.078400030136152</c:v>
                </c:pt>
                <c:pt idx="1427">
                  <c:v>7.8499501371383502</c:v>
                </c:pt>
                <c:pt idx="1428">
                  <c:v>11.62835003376005</c:v>
                </c:pt>
                <c:pt idx="1429">
                  <c:v>7.0191499853133976</c:v>
                </c:pt>
                <c:pt idx="1430">
                  <c:v>7.8879999208450009</c:v>
                </c:pt>
                <c:pt idx="1431">
                  <c:v>9.2879999876022552</c:v>
                </c:pt>
                <c:pt idx="1432">
                  <c:v>7.8645999097823989</c:v>
                </c:pt>
                <c:pt idx="1433">
                  <c:v>9.5856999444961488</c:v>
                </c:pt>
                <c:pt idx="1434">
                  <c:v>9.6282499217987514</c:v>
                </c:pt>
                <c:pt idx="1435">
                  <c:v>8.7711999320983516</c:v>
                </c:pt>
                <c:pt idx="1436">
                  <c:v>7.9987499570846481</c:v>
                </c:pt>
                <c:pt idx="1437">
                  <c:v>10.622299962043801</c:v>
                </c:pt>
                <c:pt idx="1438">
                  <c:v>8.3663000583648</c:v>
                </c:pt>
                <c:pt idx="1439">
                  <c:v>7.6871998977660994</c:v>
                </c:pt>
                <c:pt idx="1440">
                  <c:v>7.4333000612258999</c:v>
                </c:pt>
                <c:pt idx="1441">
                  <c:v>7.3222500038147018</c:v>
                </c:pt>
                <c:pt idx="1442">
                  <c:v>7.2385998058319529</c:v>
                </c:pt>
                <c:pt idx="1443">
                  <c:v>9.0815000200271996</c:v>
                </c:pt>
                <c:pt idx="1444">
                  <c:v>6.6854501152038495</c:v>
                </c:pt>
                <c:pt idx="1445">
                  <c:v>9.0962999868393482</c:v>
                </c:pt>
                <c:pt idx="1446">
                  <c:v>10.729200038909902</c:v>
                </c:pt>
                <c:pt idx="1447">
                  <c:v>9.9368999004363978</c:v>
                </c:pt>
                <c:pt idx="1448">
                  <c:v>6.9762500619888534</c:v>
                </c:pt>
                <c:pt idx="1449">
                  <c:v>8.943500070571897</c:v>
                </c:pt>
                <c:pt idx="1450">
                  <c:v>8.2445498895645031</c:v>
                </c:pt>
                <c:pt idx="1451">
                  <c:v>5.2643498849868493</c:v>
                </c:pt>
                <c:pt idx="1452">
                  <c:v>9.2579998016357479</c:v>
                </c:pt>
                <c:pt idx="1453">
                  <c:v>9.9691998672484985</c:v>
                </c:pt>
                <c:pt idx="1454">
                  <c:v>9.4670500659943002</c:v>
                </c:pt>
                <c:pt idx="1455">
                  <c:v>9.3235998511314513</c:v>
                </c:pt>
                <c:pt idx="1456">
                  <c:v>8.8260499620437542</c:v>
                </c:pt>
                <c:pt idx="1457">
                  <c:v>10.7649001407623</c:v>
                </c:pt>
                <c:pt idx="1458">
                  <c:v>8.6828999471664474</c:v>
                </c:pt>
                <c:pt idx="1459">
                  <c:v>6.8502999687194972</c:v>
                </c:pt>
                <c:pt idx="1460">
                  <c:v>9.7620998716353995</c:v>
                </c:pt>
                <c:pt idx="1461">
                  <c:v>7.0298498630523518</c:v>
                </c:pt>
                <c:pt idx="1462">
                  <c:v>8.1084999513626492</c:v>
                </c:pt>
                <c:pt idx="1463">
                  <c:v>9.5436999177933011</c:v>
                </c:pt>
                <c:pt idx="1464">
                  <c:v>10.004200005531349</c:v>
                </c:pt>
                <c:pt idx="1465">
                  <c:v>9.2341998624801498</c:v>
                </c:pt>
                <c:pt idx="1466">
                  <c:v>5.0143498182297037</c:v>
                </c:pt>
                <c:pt idx="1467">
                  <c:v>6.3533999729156498</c:v>
                </c:pt>
                <c:pt idx="1468">
                  <c:v>9.6456999588012522</c:v>
                </c:pt>
                <c:pt idx="1469">
                  <c:v>7.7324499797820501</c:v>
                </c:pt>
                <c:pt idx="1470">
                  <c:v>8.5073497200012014</c:v>
                </c:pt>
                <c:pt idx="1471">
                  <c:v>6.9510500860214464</c:v>
                </c:pt>
                <c:pt idx="1472">
                  <c:v>9.2276499032973973</c:v>
                </c:pt>
                <c:pt idx="1473">
                  <c:v>9.1828998899460004</c:v>
                </c:pt>
                <c:pt idx="1474">
                  <c:v>7.1603499078750517</c:v>
                </c:pt>
                <c:pt idx="1475">
                  <c:v>5.2193501901627002</c:v>
                </c:pt>
                <c:pt idx="1476">
                  <c:v>2.2265999460219987</c:v>
                </c:pt>
                <c:pt idx="1477">
                  <c:v>2.2265999460219987</c:v>
                </c:pt>
                <c:pt idx="1478">
                  <c:v>8.1988500499724992</c:v>
                </c:pt>
                <c:pt idx="1479">
                  <c:v>7.7284999656676945</c:v>
                </c:pt>
                <c:pt idx="1480">
                  <c:v>7.9952999544143992</c:v>
                </c:pt>
                <c:pt idx="1481">
                  <c:v>8.5159000205993536</c:v>
                </c:pt>
                <c:pt idx="1482">
                  <c:v>7.5077998733520488</c:v>
                </c:pt>
                <c:pt idx="1483">
                  <c:v>6.5711501121521003</c:v>
                </c:pt>
                <c:pt idx="1484">
                  <c:v>6.1996499967575005</c:v>
                </c:pt>
                <c:pt idx="1485">
                  <c:v>9.4621499013900987</c:v>
                </c:pt>
                <c:pt idx="1486">
                  <c:v>6.6188498878478974</c:v>
                </c:pt>
                <c:pt idx="1487">
                  <c:v>7.0108498620987518</c:v>
                </c:pt>
                <c:pt idx="1488">
                  <c:v>4.1368501281737977</c:v>
                </c:pt>
                <c:pt idx="1489">
                  <c:v>7.6501001119614003</c:v>
                </c:pt>
                <c:pt idx="1490">
                  <c:v>8.6357999753952015</c:v>
                </c:pt>
                <c:pt idx="1491">
                  <c:v>6.364850149154698</c:v>
                </c:pt>
                <c:pt idx="1492">
                  <c:v>10.97364999294285</c:v>
                </c:pt>
                <c:pt idx="1493">
                  <c:v>10.342599997520399</c:v>
                </c:pt>
                <c:pt idx="1494">
                  <c:v>10.2272000074387</c:v>
                </c:pt>
                <c:pt idx="1495">
                  <c:v>4.9270999145507979</c:v>
                </c:pt>
                <c:pt idx="1496">
                  <c:v>9.0144000196457021</c:v>
                </c:pt>
                <c:pt idx="1497">
                  <c:v>9.2341000509262017</c:v>
                </c:pt>
                <c:pt idx="1498">
                  <c:v>8.792750048637398</c:v>
                </c:pt>
                <c:pt idx="1499">
                  <c:v>6.9640999889373987</c:v>
                </c:pt>
                <c:pt idx="1500">
                  <c:v>8.0349499559403021</c:v>
                </c:pt>
                <c:pt idx="1501">
                  <c:v>9.8540500164031499</c:v>
                </c:pt>
                <c:pt idx="1502">
                  <c:v>5.7377501678466984</c:v>
                </c:pt>
                <c:pt idx="1503">
                  <c:v>8.7460498905181971</c:v>
                </c:pt>
                <c:pt idx="1504">
                  <c:v>9.7828999614715002</c:v>
                </c:pt>
                <c:pt idx="1505">
                  <c:v>4.7676000547408997</c:v>
                </c:pt>
                <c:pt idx="1506">
                  <c:v>7.029549860954301</c:v>
                </c:pt>
                <c:pt idx="1507">
                  <c:v>8.1243499660491523</c:v>
                </c:pt>
                <c:pt idx="1508">
                  <c:v>9.9227000141143478</c:v>
                </c:pt>
                <c:pt idx="1509">
                  <c:v>6.3122498512268486</c:v>
                </c:pt>
                <c:pt idx="1510">
                  <c:v>5.2059499788284498</c:v>
                </c:pt>
                <c:pt idx="1511">
                  <c:v>7.7736498451232521</c:v>
                </c:pt>
                <c:pt idx="1512">
                  <c:v>8.8109000205993979</c:v>
                </c:pt>
                <c:pt idx="1513">
                  <c:v>8.9725499534606996</c:v>
                </c:pt>
                <c:pt idx="1514">
                  <c:v>11.800400023460348</c:v>
                </c:pt>
                <c:pt idx="1515">
                  <c:v>8.2284998893737473</c:v>
                </c:pt>
                <c:pt idx="1516">
                  <c:v>7.1544499683379996</c:v>
                </c:pt>
                <c:pt idx="1517">
                  <c:v>5.3838499355316003</c:v>
                </c:pt>
                <c:pt idx="1518">
                  <c:v>7.278000020980901</c:v>
                </c:pt>
                <c:pt idx="1519">
                  <c:v>6.6485499668121477</c:v>
                </c:pt>
                <c:pt idx="1520">
                  <c:v>8.6621000099181984</c:v>
                </c:pt>
                <c:pt idx="1521">
                  <c:v>7.6909498882294045</c:v>
                </c:pt>
                <c:pt idx="1522">
                  <c:v>8.3858000135421484</c:v>
                </c:pt>
                <c:pt idx="1523">
                  <c:v>8.0442500877380496</c:v>
                </c:pt>
                <c:pt idx="1524">
                  <c:v>6.2975000214577008</c:v>
                </c:pt>
                <c:pt idx="1525">
                  <c:v>8.2615998554229506</c:v>
                </c:pt>
                <c:pt idx="1526">
                  <c:v>8.5619999790192018</c:v>
                </c:pt>
                <c:pt idx="1527">
                  <c:v>9.3064999818802008</c:v>
                </c:pt>
                <c:pt idx="1528">
                  <c:v>8.3763999843597468</c:v>
                </c:pt>
                <c:pt idx="1529">
                  <c:v>7.2031998634337526</c:v>
                </c:pt>
                <c:pt idx="1530">
                  <c:v>7.661449952125551</c:v>
                </c:pt>
                <c:pt idx="1531">
                  <c:v>6.6246999359130498</c:v>
                </c:pt>
                <c:pt idx="1532">
                  <c:v>8.9341500139236487</c:v>
                </c:pt>
                <c:pt idx="1533">
                  <c:v>10.1808500051498</c:v>
                </c:pt>
                <c:pt idx="1534">
                  <c:v>10.275799989700353</c:v>
                </c:pt>
                <c:pt idx="1535">
                  <c:v>8.1588499402999979</c:v>
                </c:pt>
                <c:pt idx="1536">
                  <c:v>11.488749961852996</c:v>
                </c:pt>
                <c:pt idx="1537">
                  <c:v>7.4736499357223494</c:v>
                </c:pt>
                <c:pt idx="1538">
                  <c:v>7.034099817276001</c:v>
                </c:pt>
                <c:pt idx="1539">
                  <c:v>7.3113500070572002</c:v>
                </c:pt>
                <c:pt idx="1540">
                  <c:v>5.6326998901367489</c:v>
                </c:pt>
                <c:pt idx="1541">
                  <c:v>6.0882999229431505</c:v>
                </c:pt>
                <c:pt idx="1542">
                  <c:v>6.7821001005172548</c:v>
                </c:pt>
                <c:pt idx="1543">
                  <c:v>5.8717498970031485</c:v>
                </c:pt>
                <c:pt idx="1544">
                  <c:v>4.9209000444412538</c:v>
                </c:pt>
                <c:pt idx="1545">
                  <c:v>4.2294999456405513</c:v>
                </c:pt>
                <c:pt idx="1546">
                  <c:v>7.3783999776840474</c:v>
                </c:pt>
                <c:pt idx="1547">
                  <c:v>7.8017499303817495</c:v>
                </c:pt>
                <c:pt idx="1548">
                  <c:v>7.5623000669479516</c:v>
                </c:pt>
                <c:pt idx="1549">
                  <c:v>6.6765999460221011</c:v>
                </c:pt>
                <c:pt idx="1550">
                  <c:v>5.4890999221802019</c:v>
                </c:pt>
                <c:pt idx="1551">
                  <c:v>6.1297000408172977</c:v>
                </c:pt>
                <c:pt idx="1552">
                  <c:v>7.0019999790191498</c:v>
                </c:pt>
                <c:pt idx="1553">
                  <c:v>10.077399907112152</c:v>
                </c:pt>
                <c:pt idx="1554">
                  <c:v>7.6623498630524018</c:v>
                </c:pt>
                <c:pt idx="1555">
                  <c:v>9.4338000249862475</c:v>
                </c:pt>
                <c:pt idx="1556">
                  <c:v>7.4446499443054464</c:v>
                </c:pt>
                <c:pt idx="1557">
                  <c:v>7.0500001144409516</c:v>
                </c:pt>
                <c:pt idx="1558">
                  <c:v>8.1643999576568547</c:v>
                </c:pt>
                <c:pt idx="1559">
                  <c:v>7.136199960708602</c:v>
                </c:pt>
                <c:pt idx="1560">
                  <c:v>3.4547499752044466</c:v>
                </c:pt>
                <c:pt idx="1561">
                  <c:v>3.4547499752044466</c:v>
                </c:pt>
                <c:pt idx="1562">
                  <c:v>6.0927000665664508</c:v>
                </c:pt>
                <c:pt idx="1563">
                  <c:v>6.5251998710632009</c:v>
                </c:pt>
                <c:pt idx="1564">
                  <c:v>8.0137999963759974</c:v>
                </c:pt>
                <c:pt idx="1565">
                  <c:v>10.796599907875052</c:v>
                </c:pt>
                <c:pt idx="1566">
                  <c:v>7.8011499452590982</c:v>
                </c:pt>
                <c:pt idx="1567">
                  <c:v>9.0087000370025514</c:v>
                </c:pt>
                <c:pt idx="1568">
                  <c:v>9.439299974441596</c:v>
                </c:pt>
                <c:pt idx="1569">
                  <c:v>7.918599948883049</c:v>
                </c:pt>
                <c:pt idx="1570">
                  <c:v>7.6219499015808019</c:v>
                </c:pt>
                <c:pt idx="1571">
                  <c:v>8.8811500358581519</c:v>
                </c:pt>
                <c:pt idx="1572">
                  <c:v>5.6750500154495498</c:v>
                </c:pt>
                <c:pt idx="1573">
                  <c:v>7.0622998523712006</c:v>
                </c:pt>
                <c:pt idx="1574">
                  <c:v>8.5160999679565492</c:v>
                </c:pt>
                <c:pt idx="1575">
                  <c:v>8.572099909782402</c:v>
                </c:pt>
                <c:pt idx="1576">
                  <c:v>8.1640499973297018</c:v>
                </c:pt>
                <c:pt idx="1577">
                  <c:v>2.6028999662398995</c:v>
                </c:pt>
                <c:pt idx="1578">
                  <c:v>5.7091501283645485</c:v>
                </c:pt>
                <c:pt idx="1579">
                  <c:v>8.2594498920440529</c:v>
                </c:pt>
                <c:pt idx="1580">
                  <c:v>9.865449957847602</c:v>
                </c:pt>
                <c:pt idx="1581">
                  <c:v>10.017149968147301</c:v>
                </c:pt>
                <c:pt idx="1582">
                  <c:v>7.6757498979568517</c:v>
                </c:pt>
                <c:pt idx="1583">
                  <c:v>4.0476999282837021</c:v>
                </c:pt>
                <c:pt idx="1584">
                  <c:v>9.0822999811172522</c:v>
                </c:pt>
                <c:pt idx="1585">
                  <c:v>9.0248500013351531</c:v>
                </c:pt>
                <c:pt idx="1586">
                  <c:v>7.8551499414443988</c:v>
                </c:pt>
                <c:pt idx="1587">
                  <c:v>6.6709498786925998</c:v>
                </c:pt>
                <c:pt idx="1588">
                  <c:v>5.9294000148773023</c:v>
                </c:pt>
                <c:pt idx="1589">
                  <c:v>7.4890500688552528</c:v>
                </c:pt>
                <c:pt idx="1590">
                  <c:v>7.3339000844955464</c:v>
                </c:pt>
                <c:pt idx="1591">
                  <c:v>6.59664999485015</c:v>
                </c:pt>
                <c:pt idx="1592">
                  <c:v>7.2932499694823498</c:v>
                </c:pt>
                <c:pt idx="1593">
                  <c:v>6.5142001295089997</c:v>
                </c:pt>
                <c:pt idx="1594">
                  <c:v>4.9109500598907481</c:v>
                </c:pt>
                <c:pt idx="1595">
                  <c:v>4.3766001653671509</c:v>
                </c:pt>
                <c:pt idx="1596">
                  <c:v>6.849550013542153</c:v>
                </c:pt>
                <c:pt idx="1597">
                  <c:v>8.698399882316604</c:v>
                </c:pt>
                <c:pt idx="1598">
                  <c:v>8.3241999387741004</c:v>
                </c:pt>
                <c:pt idx="1599">
                  <c:v>6.6236000585555992</c:v>
                </c:pt>
                <c:pt idx="1600">
                  <c:v>10.721150031089799</c:v>
                </c:pt>
                <c:pt idx="1601">
                  <c:v>5.2235000419616497</c:v>
                </c:pt>
                <c:pt idx="1602">
                  <c:v>5.2235000419616497</c:v>
                </c:pt>
                <c:pt idx="1603">
                  <c:v>9.0371499347686495</c:v>
                </c:pt>
                <c:pt idx="1604">
                  <c:v>8.0523999309539533</c:v>
                </c:pt>
                <c:pt idx="1605">
                  <c:v>9.7430499649048024</c:v>
                </c:pt>
                <c:pt idx="1606">
                  <c:v>9.0077000951766983</c:v>
                </c:pt>
                <c:pt idx="1607">
                  <c:v>5.1194999504089509</c:v>
                </c:pt>
                <c:pt idx="1608">
                  <c:v>7.3024500370025507</c:v>
                </c:pt>
                <c:pt idx="1609">
                  <c:v>8.3728499364852951</c:v>
                </c:pt>
                <c:pt idx="1610">
                  <c:v>7.1721498584747003</c:v>
                </c:pt>
                <c:pt idx="1611">
                  <c:v>5.442849993705746</c:v>
                </c:pt>
                <c:pt idx="1612">
                  <c:v>5.8040001296997019</c:v>
                </c:pt>
                <c:pt idx="1613">
                  <c:v>5.8656498813629021</c:v>
                </c:pt>
                <c:pt idx="1614">
                  <c:v>7.2068499898910012</c:v>
                </c:pt>
                <c:pt idx="1615">
                  <c:v>7.4198999261856002</c:v>
                </c:pt>
                <c:pt idx="1616">
                  <c:v>7.2125998163222995</c:v>
                </c:pt>
                <c:pt idx="1617">
                  <c:v>8.237799997329752</c:v>
                </c:pt>
                <c:pt idx="1618">
                  <c:v>7.2965500116348494</c:v>
                </c:pt>
                <c:pt idx="1619">
                  <c:v>9.1687998962402517</c:v>
                </c:pt>
                <c:pt idx="1620">
                  <c:v>7.1832999753952009</c:v>
                </c:pt>
                <c:pt idx="1621">
                  <c:v>8.4103498888016013</c:v>
                </c:pt>
                <c:pt idx="1622">
                  <c:v>8.3801498842239504</c:v>
                </c:pt>
                <c:pt idx="1623">
                  <c:v>7.943799891471798</c:v>
                </c:pt>
                <c:pt idx="1624">
                  <c:v>4.945550017356851</c:v>
                </c:pt>
                <c:pt idx="1625">
                  <c:v>3.9530500221252467</c:v>
                </c:pt>
                <c:pt idx="1626">
                  <c:v>6.5365498685837053</c:v>
                </c:pt>
                <c:pt idx="1627">
                  <c:v>8.8259500360489476</c:v>
                </c:pt>
                <c:pt idx="1628">
                  <c:v>8.0791499519347987</c:v>
                </c:pt>
                <c:pt idx="1629">
                  <c:v>7.3302499771118015</c:v>
                </c:pt>
                <c:pt idx="1630">
                  <c:v>7.3936998939513998</c:v>
                </c:pt>
                <c:pt idx="1631">
                  <c:v>6.4591498804092495</c:v>
                </c:pt>
                <c:pt idx="1632">
                  <c:v>6.7602000665664477</c:v>
                </c:pt>
                <c:pt idx="1633">
                  <c:v>8.608399872779799</c:v>
                </c:pt>
                <c:pt idx="1634">
                  <c:v>6.7682999849319003</c:v>
                </c:pt>
                <c:pt idx="1635">
                  <c:v>7.2138498353957985</c:v>
                </c:pt>
                <c:pt idx="1636">
                  <c:v>7.0310999584198015</c:v>
                </c:pt>
                <c:pt idx="1637">
                  <c:v>5.4087499427795009</c:v>
                </c:pt>
                <c:pt idx="1638">
                  <c:v>6.5461001110076502</c:v>
                </c:pt>
                <c:pt idx="1639">
                  <c:v>11.598199901580799</c:v>
                </c:pt>
                <c:pt idx="1640">
                  <c:v>4.9387500333785965</c:v>
                </c:pt>
                <c:pt idx="1641">
                  <c:v>8.4861998701095978</c:v>
                </c:pt>
                <c:pt idx="1642">
                  <c:v>4.9558998537064021</c:v>
                </c:pt>
                <c:pt idx="1643">
                  <c:v>8.0798500108719011</c:v>
                </c:pt>
                <c:pt idx="1644">
                  <c:v>3.5335999679564978</c:v>
                </c:pt>
                <c:pt idx="1645">
                  <c:v>10.34854994773865</c:v>
                </c:pt>
                <c:pt idx="1646">
                  <c:v>10.906550035476698</c:v>
                </c:pt>
                <c:pt idx="1647">
                  <c:v>5.0410000801085992</c:v>
                </c:pt>
                <c:pt idx="1648">
                  <c:v>10.114799990653999</c:v>
                </c:pt>
                <c:pt idx="1649">
                  <c:v>5.1967499589919974</c:v>
                </c:pt>
                <c:pt idx="1650">
                  <c:v>8.5320999288558497</c:v>
                </c:pt>
                <c:pt idx="1651">
                  <c:v>7.000450067520152</c:v>
                </c:pt>
                <c:pt idx="1652">
                  <c:v>6.2378999423981014</c:v>
                </c:pt>
                <c:pt idx="1653">
                  <c:v>6.7880001401901495</c:v>
                </c:pt>
                <c:pt idx="1654">
                  <c:v>6.5716499853134493</c:v>
                </c:pt>
                <c:pt idx="1655">
                  <c:v>9.1691499996184973</c:v>
                </c:pt>
                <c:pt idx="1656">
                  <c:v>2.244599885940552</c:v>
                </c:pt>
                <c:pt idx="1657">
                  <c:v>4.5017500638961963</c:v>
                </c:pt>
                <c:pt idx="1658">
                  <c:v>9.1652999782562006</c:v>
                </c:pt>
                <c:pt idx="1659">
                  <c:v>6.7762498617171971</c:v>
                </c:pt>
                <c:pt idx="1660">
                  <c:v>7.7754000425338994</c:v>
                </c:pt>
                <c:pt idx="1661">
                  <c:v>8.6449000024795524</c:v>
                </c:pt>
                <c:pt idx="1662">
                  <c:v>6.0299498891830474</c:v>
                </c:pt>
                <c:pt idx="1663">
                  <c:v>6.302649927139349</c:v>
                </c:pt>
                <c:pt idx="1664">
                  <c:v>5.7625501060485504</c:v>
                </c:pt>
                <c:pt idx="1665">
                  <c:v>8.5343499183654998</c:v>
                </c:pt>
                <c:pt idx="1666">
                  <c:v>6.9288499164581481</c:v>
                </c:pt>
                <c:pt idx="1667">
                  <c:v>7.8675999450683989</c:v>
                </c:pt>
                <c:pt idx="1668">
                  <c:v>5.2580500650405959</c:v>
                </c:pt>
                <c:pt idx="1669">
                  <c:v>5.5619999313354</c:v>
                </c:pt>
                <c:pt idx="1670">
                  <c:v>6.9227999734878978</c:v>
                </c:pt>
                <c:pt idx="1671">
                  <c:v>7.6752499675751018</c:v>
                </c:pt>
                <c:pt idx="1672">
                  <c:v>7.7437498855591009</c:v>
                </c:pt>
                <c:pt idx="1673">
                  <c:v>6.1644999599456511</c:v>
                </c:pt>
                <c:pt idx="1674">
                  <c:v>7.6235498142242513</c:v>
                </c:pt>
                <c:pt idx="1675">
                  <c:v>5.3018000602721997</c:v>
                </c:pt>
                <c:pt idx="1676">
                  <c:v>7.0177999734878469</c:v>
                </c:pt>
                <c:pt idx="1677">
                  <c:v>5.7146499872207954</c:v>
                </c:pt>
                <c:pt idx="1678">
                  <c:v>6.3016499376297048</c:v>
                </c:pt>
                <c:pt idx="1679">
                  <c:v>7.1396999835968025</c:v>
                </c:pt>
                <c:pt idx="1680">
                  <c:v>6.3024000167846452</c:v>
                </c:pt>
                <c:pt idx="1681">
                  <c:v>10.695700068473801</c:v>
                </c:pt>
                <c:pt idx="1682">
                  <c:v>3.773849930763248</c:v>
                </c:pt>
                <c:pt idx="1683">
                  <c:v>7.1781000614166501</c:v>
                </c:pt>
                <c:pt idx="1684">
                  <c:v>9.7355000305175992</c:v>
                </c:pt>
                <c:pt idx="1685">
                  <c:v>8.1450000000000031</c:v>
                </c:pt>
                <c:pt idx="1686">
                  <c:v>6.6093999767303444</c:v>
                </c:pt>
                <c:pt idx="1687">
                  <c:v>10.04049997568135</c:v>
                </c:pt>
                <c:pt idx="1688">
                  <c:v>9.9142999792099005</c:v>
                </c:pt>
                <c:pt idx="1689">
                  <c:v>5.1265998220443478</c:v>
                </c:pt>
                <c:pt idx="1690">
                  <c:v>5.915400009155249</c:v>
                </c:pt>
                <c:pt idx="1691">
                  <c:v>-10.002100014686604</c:v>
                </c:pt>
                <c:pt idx="1692">
                  <c:v>8.7622498798370003</c:v>
                </c:pt>
                <c:pt idx="1693">
                  <c:v>8.6681500291824527</c:v>
                </c:pt>
                <c:pt idx="1694">
                  <c:v>6.7572500205039958</c:v>
                </c:pt>
                <c:pt idx="1695">
                  <c:v>7.5150000095366991</c:v>
                </c:pt>
                <c:pt idx="1696">
                  <c:v>6.3159499549865501</c:v>
                </c:pt>
                <c:pt idx="1697">
                  <c:v>9.2596999311446986</c:v>
                </c:pt>
                <c:pt idx="1698">
                  <c:v>5.4585499048232968</c:v>
                </c:pt>
                <c:pt idx="1699">
                  <c:v>9.2217499685287549</c:v>
                </c:pt>
                <c:pt idx="1700">
                  <c:v>8.554149980545052</c:v>
                </c:pt>
                <c:pt idx="1701">
                  <c:v>6.8014998960495028</c:v>
                </c:pt>
                <c:pt idx="1702">
                  <c:v>6.3579998731613507</c:v>
                </c:pt>
                <c:pt idx="1703">
                  <c:v>8.3585998868942539</c:v>
                </c:pt>
                <c:pt idx="1704">
                  <c:v>10.23544997692105</c:v>
                </c:pt>
                <c:pt idx="1705">
                  <c:v>7.7385499620438019</c:v>
                </c:pt>
                <c:pt idx="1706">
                  <c:v>7.9985999798774507</c:v>
                </c:pt>
                <c:pt idx="1707">
                  <c:v>9.6442499351501496</c:v>
                </c:pt>
                <c:pt idx="1708">
                  <c:v>7.9132500362396527</c:v>
                </c:pt>
                <c:pt idx="1709">
                  <c:v>7.9437499189376481</c:v>
                </c:pt>
                <c:pt idx="1710">
                  <c:v>4.0237499761581503</c:v>
                </c:pt>
                <c:pt idx="1711">
                  <c:v>5.8558000230789027</c:v>
                </c:pt>
                <c:pt idx="1712">
                  <c:v>7.9614500761031479</c:v>
                </c:pt>
                <c:pt idx="1713">
                  <c:v>9.041300029754602</c:v>
                </c:pt>
                <c:pt idx="1714">
                  <c:v>7.0947000145911971</c:v>
                </c:pt>
                <c:pt idx="1715">
                  <c:v>3.689799833297748</c:v>
                </c:pt>
                <c:pt idx="1716">
                  <c:v>5.4365499353408993</c:v>
                </c:pt>
                <c:pt idx="1717">
                  <c:v>8.0342999935149493</c:v>
                </c:pt>
                <c:pt idx="1718">
                  <c:v>6.5665500354766486</c:v>
                </c:pt>
                <c:pt idx="1719">
                  <c:v>4.1088999843597485</c:v>
                </c:pt>
                <c:pt idx="1720">
                  <c:v>6.2166998481751001</c:v>
                </c:pt>
                <c:pt idx="1721">
                  <c:v>4.6919999694823531</c:v>
                </c:pt>
                <c:pt idx="1722">
                  <c:v>7.6237000703811546</c:v>
                </c:pt>
                <c:pt idx="1723">
                  <c:v>6.5214999103545992</c:v>
                </c:pt>
                <c:pt idx="1724">
                  <c:v>6.6510000371932989</c:v>
                </c:pt>
                <c:pt idx="1725">
                  <c:v>7.254200010299698</c:v>
                </c:pt>
                <c:pt idx="1726">
                  <c:v>6.954499869346602</c:v>
                </c:pt>
                <c:pt idx="1727">
                  <c:v>6.3737499856949</c:v>
                </c:pt>
                <c:pt idx="1728">
                  <c:v>4.8442499351501525</c:v>
                </c:pt>
                <c:pt idx="1729">
                  <c:v>3.9565999603271464</c:v>
                </c:pt>
                <c:pt idx="1730">
                  <c:v>5.9873998546600475</c:v>
                </c:pt>
                <c:pt idx="1731">
                  <c:v>8.7889498853683499</c:v>
                </c:pt>
                <c:pt idx="1732">
                  <c:v>9.0502999496459502</c:v>
                </c:pt>
                <c:pt idx="1733">
                  <c:v>6.3412499666214011</c:v>
                </c:pt>
                <c:pt idx="1734">
                  <c:v>5.9107998514175506</c:v>
                </c:pt>
                <c:pt idx="1735">
                  <c:v>8.5850999259948964</c:v>
                </c:pt>
                <c:pt idx="1736">
                  <c:v>8.1797999048233052</c:v>
                </c:pt>
                <c:pt idx="1737">
                  <c:v>4.923749938011202</c:v>
                </c:pt>
                <c:pt idx="1738">
                  <c:v>3.213099970817499</c:v>
                </c:pt>
                <c:pt idx="1739">
                  <c:v>6.1492998743056972</c:v>
                </c:pt>
                <c:pt idx="1740">
                  <c:v>7.2864000415801513</c:v>
                </c:pt>
                <c:pt idx="1741">
                  <c:v>7.493299922943045</c:v>
                </c:pt>
                <c:pt idx="1742">
                  <c:v>6.2120499897002972</c:v>
                </c:pt>
                <c:pt idx="1743">
                  <c:v>8.6782498741149965</c:v>
                </c:pt>
                <c:pt idx="1744">
                  <c:v>9.7475498914718521</c:v>
                </c:pt>
                <c:pt idx="1745">
                  <c:v>6.2198000907897963</c:v>
                </c:pt>
                <c:pt idx="1746">
                  <c:v>7.4279499387740984</c:v>
                </c:pt>
                <c:pt idx="1747">
                  <c:v>5.4166999959946018</c:v>
                </c:pt>
                <c:pt idx="1748">
                  <c:v>6.8264499759674493</c:v>
                </c:pt>
                <c:pt idx="1749">
                  <c:v>6.2220998859406009</c:v>
                </c:pt>
                <c:pt idx="1750">
                  <c:v>6.0590000200271987</c:v>
                </c:pt>
                <c:pt idx="1751">
                  <c:v>8.3831999731063505</c:v>
                </c:pt>
                <c:pt idx="1752">
                  <c:v>9.5823000383376531</c:v>
                </c:pt>
                <c:pt idx="1753">
                  <c:v>8.5702501010894991</c:v>
                </c:pt>
                <c:pt idx="1754">
                  <c:v>5.6122000217437957</c:v>
                </c:pt>
                <c:pt idx="1755">
                  <c:v>7.671749897003199</c:v>
                </c:pt>
                <c:pt idx="1756">
                  <c:v>6.4843999576568976</c:v>
                </c:pt>
                <c:pt idx="1757">
                  <c:v>5.749499912262003</c:v>
                </c:pt>
                <c:pt idx="1758">
                  <c:v>8.1958500194549515</c:v>
                </c:pt>
                <c:pt idx="1759">
                  <c:v>6.303449988365152</c:v>
                </c:pt>
                <c:pt idx="1760">
                  <c:v>7.8634498929977532</c:v>
                </c:pt>
                <c:pt idx="1761">
                  <c:v>7.0090000057220507</c:v>
                </c:pt>
                <c:pt idx="1762">
                  <c:v>5.7664999437331979</c:v>
                </c:pt>
                <c:pt idx="1763">
                  <c:v>6.7283499383926539</c:v>
                </c:pt>
                <c:pt idx="1764">
                  <c:v>7.8419000530243004</c:v>
                </c:pt>
                <c:pt idx="1765">
                  <c:v>5.8186498737334986</c:v>
                </c:pt>
                <c:pt idx="1766">
                  <c:v>4.6016501426696976</c:v>
                </c:pt>
                <c:pt idx="1767">
                  <c:v>8.8755499982834003</c:v>
                </c:pt>
                <c:pt idx="1768">
                  <c:v>4.977099938392648</c:v>
                </c:pt>
                <c:pt idx="1769">
                  <c:v>5.5634999799728533</c:v>
                </c:pt>
                <c:pt idx="1770">
                  <c:v>6.6316500759124537</c:v>
                </c:pt>
                <c:pt idx="1771">
                  <c:v>7.4486500501632982</c:v>
                </c:pt>
                <c:pt idx="1772">
                  <c:v>3.4438000726699478</c:v>
                </c:pt>
                <c:pt idx="1773">
                  <c:v>8.6251498937606996</c:v>
                </c:pt>
                <c:pt idx="1774">
                  <c:v>4.8340498924255471</c:v>
                </c:pt>
                <c:pt idx="1775">
                  <c:v>7.3951500797272018</c:v>
                </c:pt>
                <c:pt idx="1776">
                  <c:v>7.3022500085830941</c:v>
                </c:pt>
                <c:pt idx="1777">
                  <c:v>5.9752499818802001</c:v>
                </c:pt>
                <c:pt idx="1778">
                  <c:v>9.0798000097274496</c:v>
                </c:pt>
                <c:pt idx="1779">
                  <c:v>7.0970998954772995</c:v>
                </c:pt>
                <c:pt idx="1780">
                  <c:v>6.8474499750136992</c:v>
                </c:pt>
                <c:pt idx="1781">
                  <c:v>6.88894983291625</c:v>
                </c:pt>
                <c:pt idx="1782">
                  <c:v>4.187799954414352</c:v>
                </c:pt>
                <c:pt idx="1783">
                  <c:v>5.5443001031875525</c:v>
                </c:pt>
                <c:pt idx="1784">
                  <c:v>6.6301999568938506</c:v>
                </c:pt>
                <c:pt idx="1785">
                  <c:v>5.1875499391555984</c:v>
                </c:pt>
                <c:pt idx="1786">
                  <c:v>6.3057500791549508</c:v>
                </c:pt>
                <c:pt idx="1787">
                  <c:v>5.5050499820709504</c:v>
                </c:pt>
                <c:pt idx="1788">
                  <c:v>7.3512500143051511</c:v>
                </c:pt>
                <c:pt idx="1789">
                  <c:v>9.7841999983787531</c:v>
                </c:pt>
                <c:pt idx="1790">
                  <c:v>4.6735498619079507</c:v>
                </c:pt>
                <c:pt idx="1791">
                  <c:v>7.7216999053954964</c:v>
                </c:pt>
                <c:pt idx="1792">
                  <c:v>7.418999862670951</c:v>
                </c:pt>
                <c:pt idx="1793">
                  <c:v>5.8906499624252504</c:v>
                </c:pt>
                <c:pt idx="1794">
                  <c:v>6.4818499374389482</c:v>
                </c:pt>
                <c:pt idx="1795">
                  <c:v>8.6928999614715963</c:v>
                </c:pt>
                <c:pt idx="1796">
                  <c:v>3.9040999794006481</c:v>
                </c:pt>
                <c:pt idx="1797">
                  <c:v>6.203799972534199</c:v>
                </c:pt>
                <c:pt idx="1798">
                  <c:v>9.7515998983382488</c:v>
                </c:pt>
                <c:pt idx="1799">
                  <c:v>3.3117499780654995</c:v>
                </c:pt>
                <c:pt idx="1800">
                  <c:v>6.9997000074386015</c:v>
                </c:pt>
                <c:pt idx="1801">
                  <c:v>10.834199938774049</c:v>
                </c:pt>
                <c:pt idx="1802">
                  <c:v>5.6126500892639015</c:v>
                </c:pt>
                <c:pt idx="1803">
                  <c:v>6.7493499898910478</c:v>
                </c:pt>
                <c:pt idx="1804">
                  <c:v>6.0448999118804991</c:v>
                </c:pt>
                <c:pt idx="1805">
                  <c:v>7.8148000288009491</c:v>
                </c:pt>
                <c:pt idx="1806">
                  <c:v>7.6003500080108495</c:v>
                </c:pt>
                <c:pt idx="1807">
                  <c:v>6.9779500102996472</c:v>
                </c:pt>
                <c:pt idx="1808">
                  <c:v>8.0145998716354505</c:v>
                </c:pt>
                <c:pt idx="1809">
                  <c:v>7.5176499032974498</c:v>
                </c:pt>
                <c:pt idx="1810">
                  <c:v>6.7855999326705501</c:v>
                </c:pt>
                <c:pt idx="1811">
                  <c:v>5.9610499763488995</c:v>
                </c:pt>
                <c:pt idx="1812">
                  <c:v>4.9361498403549469</c:v>
                </c:pt>
                <c:pt idx="1813">
                  <c:v>9.3257500267028988</c:v>
                </c:pt>
                <c:pt idx="1814">
                  <c:v>6.4778499412536519</c:v>
                </c:pt>
                <c:pt idx="1815">
                  <c:v>7.3705999851226984</c:v>
                </c:pt>
                <c:pt idx="1816">
                  <c:v>7.2604499292373497</c:v>
                </c:pt>
                <c:pt idx="1817">
                  <c:v>7.1738999032974</c:v>
                </c:pt>
                <c:pt idx="1818">
                  <c:v>5.2044498968124486</c:v>
                </c:pt>
                <c:pt idx="1819">
                  <c:v>7.0780999088286976</c:v>
                </c:pt>
                <c:pt idx="1820">
                  <c:v>7.6812998342514014</c:v>
                </c:pt>
                <c:pt idx="1821">
                  <c:v>3.8358999681472952</c:v>
                </c:pt>
                <c:pt idx="1822">
                  <c:v>7.9552999663352999</c:v>
                </c:pt>
                <c:pt idx="1823">
                  <c:v>7.4000499343872477</c:v>
                </c:pt>
                <c:pt idx="1824">
                  <c:v>7.8342999124526997</c:v>
                </c:pt>
                <c:pt idx="1825">
                  <c:v>8.4521499013901007</c:v>
                </c:pt>
                <c:pt idx="1826">
                  <c:v>8.5125999736786007</c:v>
                </c:pt>
                <c:pt idx="1827">
                  <c:v>6.9200499725342013</c:v>
                </c:pt>
                <c:pt idx="1828">
                  <c:v>4.0316499042511005</c:v>
                </c:pt>
                <c:pt idx="1829">
                  <c:v>7.0347500228882005</c:v>
                </c:pt>
                <c:pt idx="1830">
                  <c:v>6.4877498817443495</c:v>
                </c:pt>
                <c:pt idx="1831">
                  <c:v>7.4586499595642479</c:v>
                </c:pt>
                <c:pt idx="1832">
                  <c:v>5.5035999155043989</c:v>
                </c:pt>
                <c:pt idx="1833">
                  <c:v>7.1997999143600495</c:v>
                </c:pt>
                <c:pt idx="1834">
                  <c:v>3.5045999193191015</c:v>
                </c:pt>
                <c:pt idx="1835">
                  <c:v>5.5567500019073499</c:v>
                </c:pt>
                <c:pt idx="1836">
                  <c:v>6.2337000560761027</c:v>
                </c:pt>
                <c:pt idx="1837">
                  <c:v>5.5454499626160008</c:v>
                </c:pt>
                <c:pt idx="1838">
                  <c:v>-0.92894974708555011</c:v>
                </c:pt>
                <c:pt idx="1839">
                  <c:v>8.421700015068101</c:v>
                </c:pt>
                <c:pt idx="1840">
                  <c:v>5.0574500131607039</c:v>
                </c:pt>
                <c:pt idx="1841">
                  <c:v>6.7388000297546</c:v>
                </c:pt>
                <c:pt idx="1842">
                  <c:v>8.224799966812153</c:v>
                </c:pt>
                <c:pt idx="1843">
                  <c:v>6.2878999328613503</c:v>
                </c:pt>
                <c:pt idx="1844">
                  <c:v>7.0305499124526989</c:v>
                </c:pt>
                <c:pt idx="1845">
                  <c:v>5.7290499401092987</c:v>
                </c:pt>
                <c:pt idx="1846">
                  <c:v>4.651199922561652</c:v>
                </c:pt>
                <c:pt idx="1847">
                  <c:v>6.8917499303817991</c:v>
                </c:pt>
                <c:pt idx="1848">
                  <c:v>5.9578998804092507</c:v>
                </c:pt>
                <c:pt idx="1849">
                  <c:v>9.3407499074935956</c:v>
                </c:pt>
                <c:pt idx="1850">
                  <c:v>7.3085000085831027</c:v>
                </c:pt>
                <c:pt idx="1851">
                  <c:v>8.0998000717163485</c:v>
                </c:pt>
                <c:pt idx="1852">
                  <c:v>8.3097500920295495</c:v>
                </c:pt>
                <c:pt idx="1853">
                  <c:v>8.5326999568939002</c:v>
                </c:pt>
                <c:pt idx="1854">
                  <c:v>6.7390499877929493</c:v>
                </c:pt>
                <c:pt idx="1855">
                  <c:v>-0.51059999465945083</c:v>
                </c:pt>
                <c:pt idx="1856">
                  <c:v>6.7879998922348008</c:v>
                </c:pt>
                <c:pt idx="1857">
                  <c:v>5.8399499034881508</c:v>
                </c:pt>
                <c:pt idx="1858">
                  <c:v>8.3772999334335516</c:v>
                </c:pt>
                <c:pt idx="1859">
                  <c:v>5.9051000785828016</c:v>
                </c:pt>
                <c:pt idx="1860">
                  <c:v>7.1522999286651512</c:v>
                </c:pt>
                <c:pt idx="1861">
                  <c:v>7.1696499109268004</c:v>
                </c:pt>
                <c:pt idx="1862">
                  <c:v>8.2367999029159513</c:v>
                </c:pt>
                <c:pt idx="1863">
                  <c:v>5.0638498878478977</c:v>
                </c:pt>
                <c:pt idx="1864">
                  <c:v>9.4348499822617029</c:v>
                </c:pt>
                <c:pt idx="1865">
                  <c:v>5.3444499826431482</c:v>
                </c:pt>
                <c:pt idx="1866">
                  <c:v>6.0072999382018963</c:v>
                </c:pt>
                <c:pt idx="1867">
                  <c:v>8.1004999971389999</c:v>
                </c:pt>
                <c:pt idx="1868">
                  <c:v>6.273849930763248</c:v>
                </c:pt>
                <c:pt idx="1869">
                  <c:v>9.3093499851227008</c:v>
                </c:pt>
                <c:pt idx="1870">
                  <c:v>7.2271500158310005</c:v>
                </c:pt>
                <c:pt idx="1871">
                  <c:v>5.3745999431610016</c:v>
                </c:pt>
                <c:pt idx="1872">
                  <c:v>7.089470672270199</c:v>
                </c:pt>
                <c:pt idx="1873">
                  <c:v>6.8038998699187978</c:v>
                </c:pt>
                <c:pt idx="1874">
                  <c:v>4.540749902725203</c:v>
                </c:pt>
                <c:pt idx="1875">
                  <c:v>4.7966499710082999</c:v>
                </c:pt>
                <c:pt idx="1876">
                  <c:v>6.4568000316619987</c:v>
                </c:pt>
                <c:pt idx="1877">
                  <c:v>5.8986500596999996</c:v>
                </c:pt>
                <c:pt idx="1878">
                  <c:v>8.5333999347687524</c:v>
                </c:pt>
                <c:pt idx="1879">
                  <c:v>7.1479999065398978</c:v>
                </c:pt>
                <c:pt idx="1880">
                  <c:v>4.3220000600814998</c:v>
                </c:pt>
                <c:pt idx="1881">
                  <c:v>6.0420999526978001</c:v>
                </c:pt>
                <c:pt idx="1882">
                  <c:v>5.6034997797012025</c:v>
                </c:pt>
                <c:pt idx="1883">
                  <c:v>5.6045000886917506</c:v>
                </c:pt>
                <c:pt idx="1884">
                  <c:v>7.6924000215530484</c:v>
                </c:pt>
                <c:pt idx="1885">
                  <c:v>7.9256500005721975</c:v>
                </c:pt>
                <c:pt idx="1886">
                  <c:v>8.043550009727447</c:v>
                </c:pt>
                <c:pt idx="1887">
                  <c:v>7.9831500244140514</c:v>
                </c:pt>
                <c:pt idx="1888">
                  <c:v>7.1774998664856007</c:v>
                </c:pt>
                <c:pt idx="1889">
                  <c:v>7.7441500282287983</c:v>
                </c:pt>
                <c:pt idx="1890">
                  <c:v>6.9565000677109055</c:v>
                </c:pt>
                <c:pt idx="1891">
                  <c:v>6.7791499090194485</c:v>
                </c:pt>
                <c:pt idx="1892">
                  <c:v>8.4353000712394497</c:v>
                </c:pt>
                <c:pt idx="1893">
                  <c:v>2.9223999500274971</c:v>
                </c:pt>
                <c:pt idx="1894">
                  <c:v>6.4844001054763503</c:v>
                </c:pt>
                <c:pt idx="1895">
                  <c:v>6.972049980163554</c:v>
                </c:pt>
                <c:pt idx="1896">
                  <c:v>9.7690499830245976</c:v>
                </c:pt>
                <c:pt idx="1897">
                  <c:v>6.1946999740601001</c:v>
                </c:pt>
                <c:pt idx="1898">
                  <c:v>5.7357499265670988</c:v>
                </c:pt>
                <c:pt idx="1899">
                  <c:v>4.7494001245498474</c:v>
                </c:pt>
                <c:pt idx="1900">
                  <c:v>5.6525499677658502</c:v>
                </c:pt>
                <c:pt idx="1901">
                  <c:v>6.9313000202178507</c:v>
                </c:pt>
                <c:pt idx="1902">
                  <c:v>4.496500024795548</c:v>
                </c:pt>
                <c:pt idx="1903">
                  <c:v>7.0537998485565012</c:v>
                </c:pt>
                <c:pt idx="1904">
                  <c:v>6.106899886131302</c:v>
                </c:pt>
                <c:pt idx="1905">
                  <c:v>7.0033000183106004</c:v>
                </c:pt>
                <c:pt idx="1906">
                  <c:v>6.7016999197006477</c:v>
                </c:pt>
                <c:pt idx="1907">
                  <c:v>5.9279000520705978</c:v>
                </c:pt>
                <c:pt idx="1908">
                  <c:v>4.2616999340057475</c:v>
                </c:pt>
                <c:pt idx="1909">
                  <c:v>5.7113000154494991</c:v>
                </c:pt>
                <c:pt idx="1910">
                  <c:v>11.316000046730053</c:v>
                </c:pt>
                <c:pt idx="1911">
                  <c:v>6.1200998497008996</c:v>
                </c:pt>
                <c:pt idx="1912">
                  <c:v>6.5665999412536493</c:v>
                </c:pt>
                <c:pt idx="1913">
                  <c:v>5.4226499605178979</c:v>
                </c:pt>
                <c:pt idx="1914">
                  <c:v>7.0029999303817974</c:v>
                </c:pt>
                <c:pt idx="1915">
                  <c:v>6.7478498840332009</c:v>
                </c:pt>
                <c:pt idx="1916">
                  <c:v>6.6801499319076996</c:v>
                </c:pt>
                <c:pt idx="1917">
                  <c:v>5.1607999229430987</c:v>
                </c:pt>
                <c:pt idx="1918">
                  <c:v>7.4692500019073975</c:v>
                </c:pt>
                <c:pt idx="1919">
                  <c:v>5.0559497594833509</c:v>
                </c:pt>
                <c:pt idx="1920">
                  <c:v>7.7431498861313521</c:v>
                </c:pt>
                <c:pt idx="1921">
                  <c:v>10.235200004577599</c:v>
                </c:pt>
                <c:pt idx="1922">
                  <c:v>7.7818499469757505</c:v>
                </c:pt>
                <c:pt idx="1923">
                  <c:v>6.5451000308990501</c:v>
                </c:pt>
                <c:pt idx="1924">
                  <c:v>5.9760499668121483</c:v>
                </c:pt>
                <c:pt idx="1925">
                  <c:v>7.478099913597152</c:v>
                </c:pt>
                <c:pt idx="1926">
                  <c:v>6.9806998634338484</c:v>
                </c:pt>
                <c:pt idx="1927">
                  <c:v>4.9027000617981003</c:v>
                </c:pt>
                <c:pt idx="1928">
                  <c:v>5.8398998689651513</c:v>
                </c:pt>
                <c:pt idx="1929">
                  <c:v>7.1279999446868985</c:v>
                </c:pt>
                <c:pt idx="1930">
                  <c:v>3.0196999120712</c:v>
                </c:pt>
                <c:pt idx="1931">
                  <c:v>5.0073999309539481</c:v>
                </c:pt>
                <c:pt idx="1932">
                  <c:v>8.1844497871398971</c:v>
                </c:pt>
                <c:pt idx="1933">
                  <c:v>6.3598001623153948</c:v>
                </c:pt>
                <c:pt idx="1934">
                  <c:v>8.0904499006271493</c:v>
                </c:pt>
                <c:pt idx="1935">
                  <c:v>7.3877498912811532</c:v>
                </c:pt>
                <c:pt idx="1936">
                  <c:v>7.0909999799727998</c:v>
                </c:pt>
                <c:pt idx="1937">
                  <c:v>6.6772499322891008</c:v>
                </c:pt>
                <c:pt idx="1938">
                  <c:v>7.8203998994827018</c:v>
                </c:pt>
                <c:pt idx="1939">
                  <c:v>6.5907500886917028</c:v>
                </c:pt>
                <c:pt idx="1940">
                  <c:v>4.7535999584198017</c:v>
                </c:pt>
                <c:pt idx="1941">
                  <c:v>6.6068999457359538</c:v>
                </c:pt>
                <c:pt idx="1942">
                  <c:v>7.1011500024794998</c:v>
                </c:pt>
                <c:pt idx="1943">
                  <c:v>2.3924999523162995</c:v>
                </c:pt>
                <c:pt idx="1944">
                  <c:v>5.8134499692916961</c:v>
                </c:pt>
                <c:pt idx="1945">
                  <c:v>3.9628500652313505</c:v>
                </c:pt>
                <c:pt idx="1946">
                  <c:v>5.8387999916077007</c:v>
                </c:pt>
                <c:pt idx="1947">
                  <c:v>5.815149903297403</c:v>
                </c:pt>
                <c:pt idx="1948">
                  <c:v>6.0138498783111984</c:v>
                </c:pt>
                <c:pt idx="1949">
                  <c:v>3.9826501846313462</c:v>
                </c:pt>
                <c:pt idx="1950">
                  <c:v>4.2911000442505021</c:v>
                </c:pt>
                <c:pt idx="1951">
                  <c:v>4.9191499948501516</c:v>
                </c:pt>
                <c:pt idx="1952">
                  <c:v>7.5556499671936521</c:v>
                </c:pt>
                <c:pt idx="1953">
                  <c:v>2.555049972534249</c:v>
                </c:pt>
                <c:pt idx="1954">
                  <c:v>5.793750033378597</c:v>
                </c:pt>
                <c:pt idx="1955">
                  <c:v>6.5687499046325506</c:v>
                </c:pt>
                <c:pt idx="1956">
                  <c:v>5.2506500720977485</c:v>
                </c:pt>
                <c:pt idx="1957">
                  <c:v>7.1233000230788974</c:v>
                </c:pt>
                <c:pt idx="1958">
                  <c:v>5.5830501079559482</c:v>
                </c:pt>
                <c:pt idx="1959">
                  <c:v>7.3416499137878013</c:v>
                </c:pt>
                <c:pt idx="1960">
                  <c:v>3.5809498596191496</c:v>
                </c:pt>
                <c:pt idx="1961">
                  <c:v>7.4981499481200977</c:v>
                </c:pt>
                <c:pt idx="1962">
                  <c:v>6.8657998847961466</c:v>
                </c:pt>
                <c:pt idx="1963">
                  <c:v>8.9210000658035042</c:v>
                </c:pt>
                <c:pt idx="1964">
                  <c:v>6.3837499332428003</c:v>
                </c:pt>
                <c:pt idx="1965">
                  <c:v>8.5723500204086527</c:v>
                </c:pt>
                <c:pt idx="1966">
                  <c:v>8.5211500072479005</c:v>
                </c:pt>
                <c:pt idx="1967">
                  <c:v>6.913999919891296</c:v>
                </c:pt>
                <c:pt idx="1968">
                  <c:v>8.1305000400543506</c:v>
                </c:pt>
                <c:pt idx="1969">
                  <c:v>6.7386498928069969</c:v>
                </c:pt>
                <c:pt idx="1970">
                  <c:v>5.6151499891281489</c:v>
                </c:pt>
                <c:pt idx="1971">
                  <c:v>4.7488998556137005</c:v>
                </c:pt>
                <c:pt idx="1972">
                  <c:v>6.2248999357223518</c:v>
                </c:pt>
                <c:pt idx="1973">
                  <c:v>5.2124499225616532</c:v>
                </c:pt>
                <c:pt idx="1974">
                  <c:v>5.5582498836516976</c:v>
                </c:pt>
                <c:pt idx="1975">
                  <c:v>6.241799860000647</c:v>
                </c:pt>
                <c:pt idx="1976">
                  <c:v>7.8263498353958489</c:v>
                </c:pt>
                <c:pt idx="1977">
                  <c:v>6.4923500156403016</c:v>
                </c:pt>
                <c:pt idx="1978">
                  <c:v>8.1229499959945493</c:v>
                </c:pt>
                <c:pt idx="1979">
                  <c:v>6.4258227537617003</c:v>
                </c:pt>
                <c:pt idx="1980">
                  <c:v>5.7538499927521016</c:v>
                </c:pt>
                <c:pt idx="1981">
                  <c:v>5.9105500316620478</c:v>
                </c:pt>
                <c:pt idx="1982">
                  <c:v>9.4326500034332526</c:v>
                </c:pt>
                <c:pt idx="1983">
                  <c:v>5.6872999858856481</c:v>
                </c:pt>
                <c:pt idx="1984">
                  <c:v>2.2437999916076521</c:v>
                </c:pt>
                <c:pt idx="1985">
                  <c:v>6.1616000175475989</c:v>
                </c:pt>
                <c:pt idx="1986">
                  <c:v>7.8652498960495549</c:v>
                </c:pt>
                <c:pt idx="1987">
                  <c:v>7.1325998497009522</c:v>
                </c:pt>
                <c:pt idx="1988">
                  <c:v>5.5183999013900511</c:v>
                </c:pt>
                <c:pt idx="1989">
                  <c:v>7.3115999841690495</c:v>
                </c:pt>
                <c:pt idx="1990">
                  <c:v>3.9688498163224004</c:v>
                </c:pt>
                <c:pt idx="1991">
                  <c:v>7.0768999195098985</c:v>
                </c:pt>
                <c:pt idx="1992">
                  <c:v>7.5426498794555492</c:v>
                </c:pt>
                <c:pt idx="1993">
                  <c:v>7.561950054168701</c:v>
                </c:pt>
                <c:pt idx="1994">
                  <c:v>5.8219000244140489</c:v>
                </c:pt>
                <c:pt idx="1995">
                  <c:v>5.4601498985290498</c:v>
                </c:pt>
                <c:pt idx="1996">
                  <c:v>6.4014999055862489</c:v>
                </c:pt>
                <c:pt idx="1997">
                  <c:v>6.1894999408722029</c:v>
                </c:pt>
                <c:pt idx="1998">
                  <c:v>6.594449930191054</c:v>
                </c:pt>
                <c:pt idx="1999">
                  <c:v>7.3558999252319452</c:v>
                </c:pt>
                <c:pt idx="2000">
                  <c:v>3.6379498624802018</c:v>
                </c:pt>
                <c:pt idx="2001">
                  <c:v>8.4286998414992986</c:v>
                </c:pt>
                <c:pt idx="2002">
                  <c:v>7.91474997997285</c:v>
                </c:pt>
                <c:pt idx="2003">
                  <c:v>5.5553001070022532</c:v>
                </c:pt>
                <c:pt idx="2004">
                  <c:v>4.9338000154495489</c:v>
                </c:pt>
                <c:pt idx="2005">
                  <c:v>7.1594000005722052</c:v>
                </c:pt>
                <c:pt idx="2006">
                  <c:v>4.2873000001907506</c:v>
                </c:pt>
                <c:pt idx="2007">
                  <c:v>7.6685499858855977</c:v>
                </c:pt>
                <c:pt idx="2008">
                  <c:v>5.8564999246597012</c:v>
                </c:pt>
                <c:pt idx="2009">
                  <c:v>4.6915999460220519</c:v>
                </c:pt>
                <c:pt idx="2010">
                  <c:v>3.6244501256943522</c:v>
                </c:pt>
                <c:pt idx="2011">
                  <c:v>7.4154499840736001</c:v>
                </c:pt>
                <c:pt idx="2012">
                  <c:v>3.8521999454498008</c:v>
                </c:pt>
                <c:pt idx="2013">
                  <c:v>6.0424500560759995</c:v>
                </c:pt>
                <c:pt idx="2014">
                  <c:v>4.9635000038147012</c:v>
                </c:pt>
                <c:pt idx="2015">
                  <c:v>5.0070999717712539</c:v>
                </c:pt>
                <c:pt idx="2016">
                  <c:v>5.4715998363494478</c:v>
                </c:pt>
                <c:pt idx="2017">
                  <c:v>5.8115499019623016</c:v>
                </c:pt>
                <c:pt idx="2018">
                  <c:v>3.8615999984740981</c:v>
                </c:pt>
                <c:pt idx="2019">
                  <c:v>6.4885999202727973</c:v>
                </c:pt>
                <c:pt idx="2020">
                  <c:v>5.8450999450683518</c:v>
                </c:pt>
                <c:pt idx="2021">
                  <c:v>7.3914499711990516</c:v>
                </c:pt>
                <c:pt idx="2022">
                  <c:v>7.7958498191833456</c:v>
                </c:pt>
                <c:pt idx="2023">
                  <c:v>6.0715000200271518</c:v>
                </c:pt>
                <c:pt idx="2024">
                  <c:v>7.5531000137329016</c:v>
                </c:pt>
                <c:pt idx="2025">
                  <c:v>6.1318999433517014</c:v>
                </c:pt>
                <c:pt idx="2026">
                  <c:v>5.0881499958037963</c:v>
                </c:pt>
                <c:pt idx="2027">
                  <c:v>6.4319999456405021</c:v>
                </c:pt>
                <c:pt idx="2028">
                  <c:v>9.9322000265121488</c:v>
                </c:pt>
                <c:pt idx="2029">
                  <c:v>8.749400014877299</c:v>
                </c:pt>
                <c:pt idx="2030">
                  <c:v>8.0908500432968005</c:v>
                </c:pt>
                <c:pt idx="2031">
                  <c:v>6.6821499633789472</c:v>
                </c:pt>
                <c:pt idx="2032">
                  <c:v>6.1438999366760498</c:v>
                </c:pt>
                <c:pt idx="2033">
                  <c:v>4.8517499303818035</c:v>
                </c:pt>
                <c:pt idx="2034">
                  <c:v>5.2434000110626506</c:v>
                </c:pt>
                <c:pt idx="2035">
                  <c:v>5.842349915504446</c:v>
                </c:pt>
                <c:pt idx="2036">
                  <c:v>-1.7400059700051429E-2</c:v>
                </c:pt>
                <c:pt idx="2037">
                  <c:v>6.4128499412537003</c:v>
                </c:pt>
                <c:pt idx="2038">
                  <c:v>5.6758000326156512</c:v>
                </c:pt>
                <c:pt idx="2039">
                  <c:v>5.2988999652862034</c:v>
                </c:pt>
                <c:pt idx="2040">
                  <c:v>3.5269498968124005</c:v>
                </c:pt>
                <c:pt idx="2041">
                  <c:v>5.6310999345779535</c:v>
                </c:pt>
                <c:pt idx="2042">
                  <c:v>8.0763999748230013</c:v>
                </c:pt>
                <c:pt idx="2043">
                  <c:v>8.6493000459670988</c:v>
                </c:pt>
                <c:pt idx="2044">
                  <c:v>4.5778499031066495</c:v>
                </c:pt>
                <c:pt idx="2045">
                  <c:v>6.5652499437331997</c:v>
                </c:pt>
                <c:pt idx="2046">
                  <c:v>5.2294499254227027</c:v>
                </c:pt>
                <c:pt idx="2047">
                  <c:v>7.6905998706818011</c:v>
                </c:pt>
                <c:pt idx="2048">
                  <c:v>4.6753500270843524</c:v>
                </c:pt>
                <c:pt idx="2049">
                  <c:v>4.2771500062942529</c:v>
                </c:pt>
                <c:pt idx="2050">
                  <c:v>5.9091998958587482</c:v>
                </c:pt>
                <c:pt idx="2051">
                  <c:v>3.307050051689103</c:v>
                </c:pt>
                <c:pt idx="2052">
                  <c:v>8.310949931144755</c:v>
                </c:pt>
                <c:pt idx="2053">
                  <c:v>5.7653998088836467</c:v>
                </c:pt>
                <c:pt idx="2054">
                  <c:v>4.3228999376296997</c:v>
                </c:pt>
                <c:pt idx="2055">
                  <c:v>5.7019000101090036</c:v>
                </c:pt>
                <c:pt idx="2056">
                  <c:v>6.0378500366211014</c:v>
                </c:pt>
                <c:pt idx="2057">
                  <c:v>8.2381501054764499</c:v>
                </c:pt>
                <c:pt idx="2058">
                  <c:v>7.6053999042510512</c:v>
                </c:pt>
                <c:pt idx="2059">
                  <c:v>7.6901499533652995</c:v>
                </c:pt>
                <c:pt idx="2060">
                  <c:v>4.7437999534607016</c:v>
                </c:pt>
                <c:pt idx="2061">
                  <c:v>7.2618999767304011</c:v>
                </c:pt>
                <c:pt idx="2062">
                  <c:v>6.211699881553649</c:v>
                </c:pt>
                <c:pt idx="2063">
                  <c:v>5.1554000663757016</c:v>
                </c:pt>
                <c:pt idx="2064">
                  <c:v>7.3508500194550024</c:v>
                </c:pt>
                <c:pt idx="2065">
                  <c:v>3.2093999958037998</c:v>
                </c:pt>
                <c:pt idx="2066">
                  <c:v>5.6673500013351514</c:v>
                </c:pt>
                <c:pt idx="2067">
                  <c:v>7.1982500362396031</c:v>
                </c:pt>
                <c:pt idx="2068">
                  <c:v>5.3241500329971494</c:v>
                </c:pt>
                <c:pt idx="2069">
                  <c:v>-1.9033999824524024</c:v>
                </c:pt>
                <c:pt idx="2070">
                  <c:v>6.4693497896194998</c:v>
                </c:pt>
                <c:pt idx="2071">
                  <c:v>5.8232999658584461</c:v>
                </c:pt>
                <c:pt idx="2072">
                  <c:v>5.1376998972892984</c:v>
                </c:pt>
                <c:pt idx="2073">
                  <c:v>5.6199499607085954</c:v>
                </c:pt>
                <c:pt idx="2074">
                  <c:v>4.5379001045227021</c:v>
                </c:pt>
                <c:pt idx="2075">
                  <c:v>5.6595499086380023</c:v>
                </c:pt>
                <c:pt idx="2076">
                  <c:v>4.6976999521255536</c:v>
                </c:pt>
                <c:pt idx="2077">
                  <c:v>5.1116499137878506</c:v>
                </c:pt>
                <c:pt idx="2078">
                  <c:v>4.7595499134063495</c:v>
                </c:pt>
                <c:pt idx="2079">
                  <c:v>5.6278499317169484</c:v>
                </c:pt>
                <c:pt idx="2080">
                  <c:v>4.9173501014709515</c:v>
                </c:pt>
                <c:pt idx="2081">
                  <c:v>6.6290500736236986</c:v>
                </c:pt>
                <c:pt idx="2082">
                  <c:v>6.7450499010086489</c:v>
                </c:pt>
                <c:pt idx="2083">
                  <c:v>6.1594000005721981</c:v>
                </c:pt>
                <c:pt idx="2084">
                  <c:v>6.9668000125884966</c:v>
                </c:pt>
                <c:pt idx="2085">
                  <c:v>4.7329500246048539</c:v>
                </c:pt>
                <c:pt idx="2086">
                  <c:v>7.2739498996735001</c:v>
                </c:pt>
                <c:pt idx="2087">
                  <c:v>3.834100036621102</c:v>
                </c:pt>
                <c:pt idx="2088">
                  <c:v>2.6546500587463484</c:v>
                </c:pt>
                <c:pt idx="2089">
                  <c:v>9.1888499855994965</c:v>
                </c:pt>
                <c:pt idx="2090">
                  <c:v>7.8452999114990476</c:v>
                </c:pt>
                <c:pt idx="2091">
                  <c:v>6.1584000301360966</c:v>
                </c:pt>
                <c:pt idx="2092">
                  <c:v>4.5986000251769994</c:v>
                </c:pt>
                <c:pt idx="2093">
                  <c:v>6.5803999614715529</c:v>
                </c:pt>
                <c:pt idx="2094">
                  <c:v>4.1891000366210989</c:v>
                </c:pt>
                <c:pt idx="2095">
                  <c:v>4.7559499073029023</c:v>
                </c:pt>
                <c:pt idx="2096">
                  <c:v>7.3092999553681004</c:v>
                </c:pt>
                <c:pt idx="2097">
                  <c:v>6.4241000843048006</c:v>
                </c:pt>
                <c:pt idx="2098">
                  <c:v>3.5591499519347991</c:v>
                </c:pt>
                <c:pt idx="2099">
                  <c:v>5.9963501119613483</c:v>
                </c:pt>
                <c:pt idx="2100">
                  <c:v>4.9268499183654519</c:v>
                </c:pt>
                <c:pt idx="2101">
                  <c:v>3.0089500427245994</c:v>
                </c:pt>
                <c:pt idx="2102">
                  <c:v>5.8681000947951958</c:v>
                </c:pt>
                <c:pt idx="2103">
                  <c:v>9.3996999549865521</c:v>
                </c:pt>
                <c:pt idx="2104">
                  <c:v>7.6681500148772983</c:v>
                </c:pt>
                <c:pt idx="2105">
                  <c:v>4.3984000158309975</c:v>
                </c:pt>
                <c:pt idx="2106">
                  <c:v>6.7921998548507503</c:v>
                </c:pt>
                <c:pt idx="2107">
                  <c:v>7.7855999135970997</c:v>
                </c:pt>
                <c:pt idx="2108">
                  <c:v>6.437700033187852</c:v>
                </c:pt>
                <c:pt idx="2109">
                  <c:v>7.0968999099731001</c:v>
                </c:pt>
                <c:pt idx="2110">
                  <c:v>5.9221000289917001</c:v>
                </c:pt>
                <c:pt idx="2111">
                  <c:v>7.7090500068664483</c:v>
                </c:pt>
                <c:pt idx="2112">
                  <c:v>6.3137499618529986</c:v>
                </c:pt>
                <c:pt idx="2113">
                  <c:v>4.2483000421523975</c:v>
                </c:pt>
                <c:pt idx="2114">
                  <c:v>5.4621500349045</c:v>
                </c:pt>
                <c:pt idx="2115">
                  <c:v>3.9966000652313518</c:v>
                </c:pt>
                <c:pt idx="2116">
                  <c:v>5.2323999881744001</c:v>
                </c:pt>
                <c:pt idx="2117">
                  <c:v>4.7579499340057509</c:v>
                </c:pt>
                <c:pt idx="2118">
                  <c:v>5.7494000148773026</c:v>
                </c:pt>
                <c:pt idx="2119">
                  <c:v>6.9050500488282012</c:v>
                </c:pt>
                <c:pt idx="2120">
                  <c:v>4.7180499792099475</c:v>
                </c:pt>
                <c:pt idx="2121">
                  <c:v>4.4126500606536538</c:v>
                </c:pt>
                <c:pt idx="2122">
                  <c:v>3.5045500278472979</c:v>
                </c:pt>
                <c:pt idx="2123">
                  <c:v>1.5049999332427504</c:v>
                </c:pt>
                <c:pt idx="2124">
                  <c:v>5.430399866104203</c:v>
                </c:pt>
                <c:pt idx="2125">
                  <c:v>9.0239999294281006</c:v>
                </c:pt>
                <c:pt idx="2126">
                  <c:v>7.0728999757766999</c:v>
                </c:pt>
                <c:pt idx="2127">
                  <c:v>3.2782999753952495</c:v>
                </c:pt>
                <c:pt idx="2128">
                  <c:v>5.9353998231887992</c:v>
                </c:pt>
                <c:pt idx="2129">
                  <c:v>4.6164999246597986</c:v>
                </c:pt>
                <c:pt idx="2130">
                  <c:v>8.4194999647139994</c:v>
                </c:pt>
                <c:pt idx="2131">
                  <c:v>5.6761500453949054</c:v>
                </c:pt>
                <c:pt idx="2132">
                  <c:v>4.0123499202728503</c:v>
                </c:pt>
                <c:pt idx="2133">
                  <c:v>6.8543997335434028</c:v>
                </c:pt>
                <c:pt idx="2134">
                  <c:v>5.6923999786376953</c:v>
                </c:pt>
                <c:pt idx="2135">
                  <c:v>4.0124999952316003</c:v>
                </c:pt>
                <c:pt idx="2136">
                  <c:v>5.8157999801635469</c:v>
                </c:pt>
                <c:pt idx="2137">
                  <c:v>5.5844999885559012</c:v>
                </c:pt>
                <c:pt idx="2138">
                  <c:v>6.1922999763488491</c:v>
                </c:pt>
                <c:pt idx="2139">
                  <c:v>5.6754500436782997</c:v>
                </c:pt>
                <c:pt idx="2140">
                  <c:v>7.7157498931884518</c:v>
                </c:pt>
                <c:pt idx="2141">
                  <c:v>4.3755498790741036</c:v>
                </c:pt>
                <c:pt idx="2142">
                  <c:v>3.3261999750137505</c:v>
                </c:pt>
                <c:pt idx="2143">
                  <c:v>3.3223499250411983</c:v>
                </c:pt>
                <c:pt idx="2144">
                  <c:v>8.8618999624251984</c:v>
                </c:pt>
                <c:pt idx="2145">
                  <c:v>5.1758999061583992</c:v>
                </c:pt>
                <c:pt idx="2146">
                  <c:v>5.10749984741215</c:v>
                </c:pt>
                <c:pt idx="2147">
                  <c:v>5.3709499216079486</c:v>
                </c:pt>
                <c:pt idx="2148">
                  <c:v>5.5740499162673487</c:v>
                </c:pt>
                <c:pt idx="2149">
                  <c:v>5.4814999866486005</c:v>
                </c:pt>
                <c:pt idx="2150">
                  <c:v>4.2430500078201483</c:v>
                </c:pt>
                <c:pt idx="2151">
                  <c:v>4.8230499458313005</c:v>
                </c:pt>
                <c:pt idx="2152">
                  <c:v>4.3269499444961532</c:v>
                </c:pt>
                <c:pt idx="2153">
                  <c:v>3.5315499067306</c:v>
                </c:pt>
                <c:pt idx="2154">
                  <c:v>6.0488499736785997</c:v>
                </c:pt>
                <c:pt idx="2155">
                  <c:v>4.2132998371124515</c:v>
                </c:pt>
                <c:pt idx="2156">
                  <c:v>1.6734500503540026</c:v>
                </c:pt>
                <c:pt idx="2157">
                  <c:v>6.4337500429153955</c:v>
                </c:pt>
                <c:pt idx="2158">
                  <c:v>6.9506499195098499</c:v>
                </c:pt>
                <c:pt idx="2159">
                  <c:v>2.8799500274658492</c:v>
                </c:pt>
                <c:pt idx="2160">
                  <c:v>8.2318499851226505</c:v>
                </c:pt>
                <c:pt idx="2161">
                  <c:v>4.8280999803542493</c:v>
                </c:pt>
                <c:pt idx="2162">
                  <c:v>6.0870499563216995</c:v>
                </c:pt>
                <c:pt idx="2163">
                  <c:v>7.5461001014709979</c:v>
                </c:pt>
                <c:pt idx="2164">
                  <c:v>7.4475999784469487</c:v>
                </c:pt>
                <c:pt idx="2165">
                  <c:v>5.1042500591278497</c:v>
                </c:pt>
                <c:pt idx="2166">
                  <c:v>4.6861498785018512</c:v>
                </c:pt>
                <c:pt idx="2167">
                  <c:v>6.4816999197005956</c:v>
                </c:pt>
                <c:pt idx="2168">
                  <c:v>4.6367000246047994</c:v>
                </c:pt>
                <c:pt idx="2169">
                  <c:v>4.9541501140594519</c:v>
                </c:pt>
                <c:pt idx="2170">
                  <c:v>3.9374999904632482</c:v>
                </c:pt>
                <c:pt idx="2171">
                  <c:v>3.4453999614715478</c:v>
                </c:pt>
                <c:pt idx="2172">
                  <c:v>6.343950037956251</c:v>
                </c:pt>
                <c:pt idx="2173">
                  <c:v>4.3010997724532984</c:v>
                </c:pt>
                <c:pt idx="2174">
                  <c:v>4.933799939155552</c:v>
                </c:pt>
                <c:pt idx="2175">
                  <c:v>5.3068000793457522</c:v>
                </c:pt>
                <c:pt idx="2176">
                  <c:v>8.0438499546051005</c:v>
                </c:pt>
                <c:pt idx="2177">
                  <c:v>5.1785499334335512</c:v>
                </c:pt>
                <c:pt idx="2178">
                  <c:v>6.4768000292778005</c:v>
                </c:pt>
                <c:pt idx="2179">
                  <c:v>6.4768000292778005</c:v>
                </c:pt>
                <c:pt idx="2180">
                  <c:v>6.7008999776840454</c:v>
                </c:pt>
                <c:pt idx="2181">
                  <c:v>6.4350999784468996</c:v>
                </c:pt>
                <c:pt idx="2182">
                  <c:v>7.0159499931334999</c:v>
                </c:pt>
                <c:pt idx="2183">
                  <c:v>7.6976499176024973</c:v>
                </c:pt>
                <c:pt idx="2184">
                  <c:v>7.8078499937057479</c:v>
                </c:pt>
                <c:pt idx="2185">
                  <c:v>5.6983499383926457</c:v>
                </c:pt>
                <c:pt idx="2186">
                  <c:v>7.25304994583135</c:v>
                </c:pt>
                <c:pt idx="2187">
                  <c:v>5.3013499879837482</c:v>
                </c:pt>
                <c:pt idx="2188">
                  <c:v>6.1873999404907529</c:v>
                </c:pt>
                <c:pt idx="2189">
                  <c:v>5.7140999746322478</c:v>
                </c:pt>
                <c:pt idx="2190">
                  <c:v>3.7985500860214003</c:v>
                </c:pt>
                <c:pt idx="2191">
                  <c:v>6.6272998142242017</c:v>
                </c:pt>
                <c:pt idx="2192">
                  <c:v>5.1981998395919504</c:v>
                </c:pt>
                <c:pt idx="2193">
                  <c:v>2.6669001007079984</c:v>
                </c:pt>
                <c:pt idx="2194">
                  <c:v>3.4831499767303491</c:v>
                </c:pt>
                <c:pt idx="2195">
                  <c:v>5.7838500404357518</c:v>
                </c:pt>
                <c:pt idx="2196">
                  <c:v>8.8989999389648489</c:v>
                </c:pt>
                <c:pt idx="2197">
                  <c:v>3.2533999824524003</c:v>
                </c:pt>
                <c:pt idx="2198">
                  <c:v>4.985499916076698</c:v>
                </c:pt>
                <c:pt idx="2199">
                  <c:v>4.2287999534606975</c:v>
                </c:pt>
                <c:pt idx="2200">
                  <c:v>0.17269996166229618</c:v>
                </c:pt>
                <c:pt idx="2201">
                  <c:v>4.5043500804901022</c:v>
                </c:pt>
                <c:pt idx="2202">
                  <c:v>8.0711000633239998</c:v>
                </c:pt>
                <c:pt idx="2203">
                  <c:v>5.4753499031066966</c:v>
                </c:pt>
                <c:pt idx="2204">
                  <c:v>7.6232499170303498</c:v>
                </c:pt>
                <c:pt idx="2205">
                  <c:v>20.99529995679854</c:v>
                </c:pt>
                <c:pt idx="2206">
                  <c:v>4.4395000076293982</c:v>
                </c:pt>
                <c:pt idx="2207">
                  <c:v>3.599449934959349</c:v>
                </c:pt>
                <c:pt idx="2208">
                  <c:v>4.0981499290466026</c:v>
                </c:pt>
                <c:pt idx="2209">
                  <c:v>3.0157000446319486</c:v>
                </c:pt>
                <c:pt idx="2210">
                  <c:v>5.3043500041961522</c:v>
                </c:pt>
                <c:pt idx="2211">
                  <c:v>2.8840000200271518</c:v>
                </c:pt>
                <c:pt idx="2212">
                  <c:v>5.863249959945648</c:v>
                </c:pt>
                <c:pt idx="2213">
                  <c:v>7.241849803924552</c:v>
                </c:pt>
                <c:pt idx="2214">
                  <c:v>6.4134498548507999</c:v>
                </c:pt>
                <c:pt idx="2215">
                  <c:v>6.8701500082016018</c:v>
                </c:pt>
                <c:pt idx="2216">
                  <c:v>4.4924000596999996</c:v>
                </c:pt>
                <c:pt idx="2217">
                  <c:v>5.7346500825881961</c:v>
                </c:pt>
                <c:pt idx="2218">
                  <c:v>3.7033000469207487</c:v>
                </c:pt>
                <c:pt idx="2219">
                  <c:v>6.8469000005722016</c:v>
                </c:pt>
                <c:pt idx="2220">
                  <c:v>6.9609500408172487</c:v>
                </c:pt>
                <c:pt idx="2221">
                  <c:v>6.9664998769760018</c:v>
                </c:pt>
                <c:pt idx="2222">
                  <c:v>9.5131498742102991</c:v>
                </c:pt>
                <c:pt idx="2223">
                  <c:v>7.8883500766753976</c:v>
                </c:pt>
                <c:pt idx="2224">
                  <c:v>5.2062498426437003</c:v>
                </c:pt>
                <c:pt idx="2225">
                  <c:v>3.2734500265121511</c:v>
                </c:pt>
                <c:pt idx="2226">
                  <c:v>6.7447499608993979</c:v>
                </c:pt>
                <c:pt idx="2227">
                  <c:v>5.4517999601363982</c:v>
                </c:pt>
                <c:pt idx="2228">
                  <c:v>3.8572999811172473</c:v>
                </c:pt>
                <c:pt idx="2229">
                  <c:v>3.9440999650955497</c:v>
                </c:pt>
                <c:pt idx="2230">
                  <c:v>3.6920000314711992</c:v>
                </c:pt>
                <c:pt idx="2231">
                  <c:v>4.1795500469208022</c:v>
                </c:pt>
                <c:pt idx="2232">
                  <c:v>6.3525500583648515</c:v>
                </c:pt>
                <c:pt idx="2233">
                  <c:v>3.4287499475478995</c:v>
                </c:pt>
                <c:pt idx="2234">
                  <c:v>4.11429989814755</c:v>
                </c:pt>
                <c:pt idx="2235">
                  <c:v>5.1847500514984013</c:v>
                </c:pt>
                <c:pt idx="2236">
                  <c:v>3.4287499666213499</c:v>
                </c:pt>
                <c:pt idx="2237">
                  <c:v>3.3656499671935478</c:v>
                </c:pt>
                <c:pt idx="2238">
                  <c:v>5.7935500288009507</c:v>
                </c:pt>
                <c:pt idx="2239">
                  <c:v>8.8839499759674041</c:v>
                </c:pt>
                <c:pt idx="2240">
                  <c:v>2.2403998994827496</c:v>
                </c:pt>
                <c:pt idx="2241">
                  <c:v>6.2388499641418527</c:v>
                </c:pt>
                <c:pt idx="2242">
                  <c:v>7.3315497827529974</c:v>
                </c:pt>
                <c:pt idx="2243">
                  <c:v>6.9943999958038461</c:v>
                </c:pt>
                <c:pt idx="2244">
                  <c:v>3.6548500442505016</c:v>
                </c:pt>
                <c:pt idx="2245">
                  <c:v>4.3321500158310009</c:v>
                </c:pt>
                <c:pt idx="2246">
                  <c:v>7.1037499260902486</c:v>
                </c:pt>
                <c:pt idx="2247">
                  <c:v>4.2929498291016017</c:v>
                </c:pt>
                <c:pt idx="2248">
                  <c:v>4.7625999689102017</c:v>
                </c:pt>
                <c:pt idx="2249">
                  <c:v>4.2454998826979988</c:v>
                </c:pt>
                <c:pt idx="2250">
                  <c:v>6.6976500082015988</c:v>
                </c:pt>
                <c:pt idx="2251">
                  <c:v>6.4330501079559497</c:v>
                </c:pt>
                <c:pt idx="2252">
                  <c:v>2.5650999593734483</c:v>
                </c:pt>
                <c:pt idx="2253">
                  <c:v>5.6831999826431492</c:v>
                </c:pt>
                <c:pt idx="2254">
                  <c:v>6.1630498504639029</c:v>
                </c:pt>
                <c:pt idx="2255">
                  <c:v>4.628399949073799</c:v>
                </c:pt>
                <c:pt idx="2256">
                  <c:v>6.4947999095916984</c:v>
                </c:pt>
                <c:pt idx="2257">
                  <c:v>6.3529999113082987</c:v>
                </c:pt>
                <c:pt idx="2258">
                  <c:v>-0.13735001087189858</c:v>
                </c:pt>
                <c:pt idx="2259">
                  <c:v>5.9472499656677513</c:v>
                </c:pt>
                <c:pt idx="2260">
                  <c:v>7.3730999183655008</c:v>
                </c:pt>
                <c:pt idx="2261">
                  <c:v>3.6293999242782498</c:v>
                </c:pt>
                <c:pt idx="2262">
                  <c:v>3.1465498399734493</c:v>
                </c:pt>
                <c:pt idx="2263">
                  <c:v>6.0480499744415468</c:v>
                </c:pt>
                <c:pt idx="2264">
                  <c:v>8.5223999643325996</c:v>
                </c:pt>
                <c:pt idx="2265">
                  <c:v>3.2902499437332011</c:v>
                </c:pt>
                <c:pt idx="2266">
                  <c:v>5.8887000036239492</c:v>
                </c:pt>
                <c:pt idx="2267">
                  <c:v>5.3409000587463034</c:v>
                </c:pt>
                <c:pt idx="2268">
                  <c:v>6.2434497928619521</c:v>
                </c:pt>
                <c:pt idx="2269">
                  <c:v>6.2682500410079989</c:v>
                </c:pt>
                <c:pt idx="2270">
                  <c:v>4.9971999692916498</c:v>
                </c:pt>
                <c:pt idx="2271">
                  <c:v>8.1016499805450515</c:v>
                </c:pt>
                <c:pt idx="2272">
                  <c:v>4.2803000116348002</c:v>
                </c:pt>
                <c:pt idx="2273">
                  <c:v>5.8122000432014502</c:v>
                </c:pt>
                <c:pt idx="2274">
                  <c:v>3.466399993896502</c:v>
                </c:pt>
                <c:pt idx="2275">
                  <c:v>6.2196998977661053</c:v>
                </c:pt>
                <c:pt idx="2276">
                  <c:v>5.546449899673501</c:v>
                </c:pt>
                <c:pt idx="2277">
                  <c:v>4.0104999637603953</c:v>
                </c:pt>
                <c:pt idx="2278">
                  <c:v>3.06984994888305</c:v>
                </c:pt>
                <c:pt idx="2279">
                  <c:v>6.9736999416351537</c:v>
                </c:pt>
                <c:pt idx="2280">
                  <c:v>4.6896998262404992</c:v>
                </c:pt>
                <c:pt idx="2281">
                  <c:v>3.0417500495911014</c:v>
                </c:pt>
                <c:pt idx="2282">
                  <c:v>5.9525500249862979</c:v>
                </c:pt>
                <c:pt idx="2283">
                  <c:v>5.4671500349045523</c:v>
                </c:pt>
                <c:pt idx="2284">
                  <c:v>6.3826000118255486</c:v>
                </c:pt>
                <c:pt idx="2285">
                  <c:v>3.6038499927520533</c:v>
                </c:pt>
                <c:pt idx="2286">
                  <c:v>5.4256000947952003</c:v>
                </c:pt>
                <c:pt idx="2287">
                  <c:v>6.1198999404907006</c:v>
                </c:pt>
                <c:pt idx="2288">
                  <c:v>5.9553001022338492</c:v>
                </c:pt>
                <c:pt idx="2289">
                  <c:v>7.1728998613357504</c:v>
                </c:pt>
                <c:pt idx="2290">
                  <c:v>6.5035000514984489</c:v>
                </c:pt>
                <c:pt idx="2291">
                  <c:v>6.0105999708175517</c:v>
                </c:pt>
                <c:pt idx="2292">
                  <c:v>7.1441499972343507</c:v>
                </c:pt>
                <c:pt idx="2293">
                  <c:v>5.5574499702453473</c:v>
                </c:pt>
                <c:pt idx="2294">
                  <c:v>3.6734499311447024</c:v>
                </c:pt>
                <c:pt idx="2295">
                  <c:v>4.0054999303817986</c:v>
                </c:pt>
                <c:pt idx="2296">
                  <c:v>6.9244000482559507</c:v>
                </c:pt>
                <c:pt idx="2297">
                  <c:v>5.3127500915527506</c:v>
                </c:pt>
                <c:pt idx="2298">
                  <c:v>4.787499976158152</c:v>
                </c:pt>
                <c:pt idx="2299">
                  <c:v>5.9599499130249001</c:v>
                </c:pt>
                <c:pt idx="2300">
                  <c:v>6.5382499694824503</c:v>
                </c:pt>
                <c:pt idx="2301">
                  <c:v>5.6505999040603498</c:v>
                </c:pt>
                <c:pt idx="2302">
                  <c:v>5.9776500797271481</c:v>
                </c:pt>
                <c:pt idx="2303">
                  <c:v>6.987999963760398</c:v>
                </c:pt>
                <c:pt idx="2304">
                  <c:v>5.711149959564203</c:v>
                </c:pt>
                <c:pt idx="2305">
                  <c:v>4.24379990100865</c:v>
                </c:pt>
                <c:pt idx="2306">
                  <c:v>7.0865999937057502</c:v>
                </c:pt>
                <c:pt idx="2307">
                  <c:v>3.1954000759124526</c:v>
                </c:pt>
                <c:pt idx="2308">
                  <c:v>5.7144499492645053</c:v>
                </c:pt>
                <c:pt idx="2309">
                  <c:v>8.0920499372482517</c:v>
                </c:pt>
                <c:pt idx="2310">
                  <c:v>3.9401999568939523</c:v>
                </c:pt>
                <c:pt idx="2311">
                  <c:v>4.5246499776840494</c:v>
                </c:pt>
                <c:pt idx="2312">
                  <c:v>6.8403999662399997</c:v>
                </c:pt>
                <c:pt idx="2313">
                  <c:v>5.2333999204635511</c:v>
                </c:pt>
                <c:pt idx="2314">
                  <c:v>5.3957500362396473</c:v>
                </c:pt>
                <c:pt idx="2315">
                  <c:v>5.2911999177932998</c:v>
                </c:pt>
                <c:pt idx="2316">
                  <c:v>1.9695499324798504</c:v>
                </c:pt>
                <c:pt idx="2317">
                  <c:v>3.5177999782562495</c:v>
                </c:pt>
                <c:pt idx="2318">
                  <c:v>3.1707500648498481</c:v>
                </c:pt>
                <c:pt idx="2319">
                  <c:v>7.918899998664898</c:v>
                </c:pt>
                <c:pt idx="2320">
                  <c:v>3.5661999940871993</c:v>
                </c:pt>
                <c:pt idx="2321">
                  <c:v>1.1953500652312989</c:v>
                </c:pt>
                <c:pt idx="2322">
                  <c:v>4.7607499504089503</c:v>
                </c:pt>
                <c:pt idx="2323">
                  <c:v>4.1413500690460019</c:v>
                </c:pt>
                <c:pt idx="2324">
                  <c:v>7.7111999845505039</c:v>
                </c:pt>
                <c:pt idx="2325">
                  <c:v>3.8831999635696519</c:v>
                </c:pt>
                <c:pt idx="2326">
                  <c:v>5.1714999246597522</c:v>
                </c:pt>
                <c:pt idx="2327">
                  <c:v>6.4317999601364022</c:v>
                </c:pt>
                <c:pt idx="2328">
                  <c:v>4.3612998867035486</c:v>
                </c:pt>
                <c:pt idx="2329">
                  <c:v>4.8960000085831012</c:v>
                </c:pt>
                <c:pt idx="2330">
                  <c:v>6.0472499418258501</c:v>
                </c:pt>
                <c:pt idx="2331">
                  <c:v>4.3674499750137521</c:v>
                </c:pt>
                <c:pt idx="2332">
                  <c:v>6.3985999441146468</c:v>
                </c:pt>
                <c:pt idx="2333">
                  <c:v>6.4800498819350985</c:v>
                </c:pt>
                <c:pt idx="2334">
                  <c:v>8.8578999233245455</c:v>
                </c:pt>
                <c:pt idx="2335">
                  <c:v>2.995299901962305</c:v>
                </c:pt>
                <c:pt idx="2336">
                  <c:v>1.796450042724647</c:v>
                </c:pt>
                <c:pt idx="2337">
                  <c:v>7.2446000647544508</c:v>
                </c:pt>
                <c:pt idx="2338">
                  <c:v>7.5312499856949024</c:v>
                </c:pt>
                <c:pt idx="2339">
                  <c:v>5.1984499931335968</c:v>
                </c:pt>
                <c:pt idx="2340">
                  <c:v>3.3425500106810979</c:v>
                </c:pt>
                <c:pt idx="2341">
                  <c:v>5.0691998338699484</c:v>
                </c:pt>
                <c:pt idx="2342">
                  <c:v>3.1834499740600535</c:v>
                </c:pt>
                <c:pt idx="2343">
                  <c:v>4.5093498945236519</c:v>
                </c:pt>
                <c:pt idx="2344">
                  <c:v>6.1994000148773019</c:v>
                </c:pt>
                <c:pt idx="2345">
                  <c:v>3.8855500411987016</c:v>
                </c:pt>
                <c:pt idx="2346">
                  <c:v>4.3500499963760504</c:v>
                </c:pt>
                <c:pt idx="2347">
                  <c:v>4.5223500347137531</c:v>
                </c:pt>
                <c:pt idx="2348">
                  <c:v>3.1839999008178523</c:v>
                </c:pt>
                <c:pt idx="2349">
                  <c:v>4.022249984741201</c:v>
                </c:pt>
                <c:pt idx="2350">
                  <c:v>3.8174999666214013</c:v>
                </c:pt>
                <c:pt idx="2351">
                  <c:v>2.920799913406352</c:v>
                </c:pt>
                <c:pt idx="2352">
                  <c:v>4.7595499753952524</c:v>
                </c:pt>
                <c:pt idx="2353">
                  <c:v>4.3067998266219973</c:v>
                </c:pt>
                <c:pt idx="2354">
                  <c:v>6.4988500452041507</c:v>
                </c:pt>
                <c:pt idx="2355">
                  <c:v>4.9297000360489029</c:v>
                </c:pt>
                <c:pt idx="2356">
                  <c:v>6.5073001337050975</c:v>
                </c:pt>
                <c:pt idx="2357">
                  <c:v>5.6668499517441013</c:v>
                </c:pt>
                <c:pt idx="2358">
                  <c:v>6.3135499906539962</c:v>
                </c:pt>
                <c:pt idx="2359">
                  <c:v>6.3076499080658479</c:v>
                </c:pt>
                <c:pt idx="2360">
                  <c:v>6.8410999011993496</c:v>
                </c:pt>
                <c:pt idx="2361">
                  <c:v>5.2492499780654995</c:v>
                </c:pt>
                <c:pt idx="2362">
                  <c:v>4.3545499086379991</c:v>
                </c:pt>
                <c:pt idx="2363">
                  <c:v>6.5574998378753477</c:v>
                </c:pt>
                <c:pt idx="2364">
                  <c:v>5.3450999498367011</c:v>
                </c:pt>
                <c:pt idx="2365">
                  <c:v>4.398700037002552</c:v>
                </c:pt>
                <c:pt idx="2366">
                  <c:v>3.9153498315810964</c:v>
                </c:pt>
                <c:pt idx="2367">
                  <c:v>4.165899963378898</c:v>
                </c:pt>
                <c:pt idx="2368">
                  <c:v>5.8975000667571997</c:v>
                </c:pt>
                <c:pt idx="2369">
                  <c:v>6.5152999782561984</c:v>
                </c:pt>
                <c:pt idx="2370">
                  <c:v>6.7992999887466539</c:v>
                </c:pt>
                <c:pt idx="2371">
                  <c:v>4.7018000221252514</c:v>
                </c:pt>
                <c:pt idx="2372">
                  <c:v>4.5062499380112477</c:v>
                </c:pt>
                <c:pt idx="2373">
                  <c:v>6.2703000164031515</c:v>
                </c:pt>
                <c:pt idx="2374">
                  <c:v>5.8312001132965001</c:v>
                </c:pt>
                <c:pt idx="2375">
                  <c:v>6.6704000520705975</c:v>
                </c:pt>
                <c:pt idx="2376">
                  <c:v>5.4153999948501479</c:v>
                </c:pt>
                <c:pt idx="2377">
                  <c:v>6.0038998985290988</c:v>
                </c:pt>
                <c:pt idx="2378">
                  <c:v>2.772250027656554</c:v>
                </c:pt>
                <c:pt idx="2379">
                  <c:v>3.6160500144958512</c:v>
                </c:pt>
                <c:pt idx="2380">
                  <c:v>3.2877500104904058</c:v>
                </c:pt>
                <c:pt idx="2381">
                  <c:v>3.8752999639510506</c:v>
                </c:pt>
                <c:pt idx="2382">
                  <c:v>1.6229499053954974</c:v>
                </c:pt>
                <c:pt idx="2383">
                  <c:v>2.9216000843048029</c:v>
                </c:pt>
                <c:pt idx="2384">
                  <c:v>5.3317000198364468</c:v>
                </c:pt>
                <c:pt idx="2385">
                  <c:v>4.8827498626708987</c:v>
                </c:pt>
                <c:pt idx="2386">
                  <c:v>3.9828499746323018</c:v>
                </c:pt>
                <c:pt idx="2387">
                  <c:v>6.5577999687194506</c:v>
                </c:pt>
                <c:pt idx="2388">
                  <c:v>7.2560500478744459</c:v>
                </c:pt>
                <c:pt idx="2389">
                  <c:v>2.4307000994681971</c:v>
                </c:pt>
                <c:pt idx="2390">
                  <c:v>2.2309000539779547</c:v>
                </c:pt>
                <c:pt idx="2391">
                  <c:v>6.4683998250961494</c:v>
                </c:pt>
                <c:pt idx="2392">
                  <c:v>5.9152500057221005</c:v>
                </c:pt>
                <c:pt idx="2393">
                  <c:v>3.2507999610900491</c:v>
                </c:pt>
                <c:pt idx="2394">
                  <c:v>3.2701499652863006</c:v>
                </c:pt>
                <c:pt idx="2395">
                  <c:v>5.7484999799728485</c:v>
                </c:pt>
                <c:pt idx="2396">
                  <c:v>5.3248999214172521</c:v>
                </c:pt>
                <c:pt idx="2397">
                  <c:v>6.4249999094009489</c:v>
                </c:pt>
                <c:pt idx="2398">
                  <c:v>3.0210500097275492</c:v>
                </c:pt>
                <c:pt idx="2399">
                  <c:v>5.4179999065398974</c:v>
                </c:pt>
                <c:pt idx="2400">
                  <c:v>5.0766498804092492</c:v>
                </c:pt>
                <c:pt idx="2401">
                  <c:v>7.5639999389648018</c:v>
                </c:pt>
                <c:pt idx="2402">
                  <c:v>2.2632499837876026</c:v>
                </c:pt>
                <c:pt idx="2403">
                  <c:v>4.1469998836517021</c:v>
                </c:pt>
                <c:pt idx="2404">
                  <c:v>6.825599975585952</c:v>
                </c:pt>
                <c:pt idx="2405">
                  <c:v>2.245049910545351</c:v>
                </c:pt>
                <c:pt idx="2406">
                  <c:v>3.5467501258849516</c:v>
                </c:pt>
                <c:pt idx="2407">
                  <c:v>2.0318998575210507</c:v>
                </c:pt>
                <c:pt idx="2408">
                  <c:v>5.3832499599456476</c:v>
                </c:pt>
                <c:pt idx="2409">
                  <c:v>5.1589499378204522</c:v>
                </c:pt>
                <c:pt idx="2410">
                  <c:v>5.6128499889373984</c:v>
                </c:pt>
                <c:pt idx="2411">
                  <c:v>3.0306500625609978</c:v>
                </c:pt>
                <c:pt idx="2412">
                  <c:v>5.7224000120162977</c:v>
                </c:pt>
                <c:pt idx="2413">
                  <c:v>4.5443998765945537</c:v>
                </c:pt>
                <c:pt idx="2414">
                  <c:v>4.3202000093460491</c:v>
                </c:pt>
                <c:pt idx="2415">
                  <c:v>6.0182998704909991</c:v>
                </c:pt>
                <c:pt idx="2416">
                  <c:v>5.099649977683999</c:v>
                </c:pt>
                <c:pt idx="2417">
                  <c:v>6.1276000165938953</c:v>
                </c:pt>
                <c:pt idx="2418">
                  <c:v>6.6153999614716028</c:v>
                </c:pt>
                <c:pt idx="2419">
                  <c:v>3.6042500829696991</c:v>
                </c:pt>
                <c:pt idx="2420">
                  <c:v>7.1057499885559032</c:v>
                </c:pt>
                <c:pt idx="2421">
                  <c:v>7.6263499927520506</c:v>
                </c:pt>
                <c:pt idx="2422">
                  <c:v>6.5350999832152965</c:v>
                </c:pt>
                <c:pt idx="2423">
                  <c:v>7.6964499998093032</c:v>
                </c:pt>
                <c:pt idx="2424">
                  <c:v>5.3469000625609979</c:v>
                </c:pt>
                <c:pt idx="2425">
                  <c:v>4.4139999675750516</c:v>
                </c:pt>
                <c:pt idx="2426">
                  <c:v>4.3746498441695998</c:v>
                </c:pt>
                <c:pt idx="2427">
                  <c:v>3.3148500919342503</c:v>
                </c:pt>
                <c:pt idx="2428">
                  <c:v>8.0837000417709497</c:v>
                </c:pt>
                <c:pt idx="2429">
                  <c:v>4.7633999204636019</c:v>
                </c:pt>
                <c:pt idx="2430">
                  <c:v>3.5377998924255465</c:v>
                </c:pt>
                <c:pt idx="2431">
                  <c:v>1.7013000440597494</c:v>
                </c:pt>
                <c:pt idx="2432">
                  <c:v>4.0061499023437506</c:v>
                </c:pt>
                <c:pt idx="2433">
                  <c:v>7.4859500217437471</c:v>
                </c:pt>
                <c:pt idx="2434">
                  <c:v>5.4875999116897489</c:v>
                </c:pt>
                <c:pt idx="2435">
                  <c:v>3.933499979972801</c:v>
                </c:pt>
                <c:pt idx="2436">
                  <c:v>4.5575499868393017</c:v>
                </c:pt>
                <c:pt idx="2437">
                  <c:v>5.5047999572753987</c:v>
                </c:pt>
                <c:pt idx="2438">
                  <c:v>1.7449500656128016</c:v>
                </c:pt>
                <c:pt idx="2439">
                  <c:v>3.3793499422073481</c:v>
                </c:pt>
                <c:pt idx="2440">
                  <c:v>6.601750018596654</c:v>
                </c:pt>
                <c:pt idx="2441">
                  <c:v>3.5945000505447524</c:v>
                </c:pt>
                <c:pt idx="2442">
                  <c:v>4.1732999372481991</c:v>
                </c:pt>
                <c:pt idx="2443">
                  <c:v>5.288800044059748</c:v>
                </c:pt>
                <c:pt idx="2444">
                  <c:v>4.1412500095367513</c:v>
                </c:pt>
                <c:pt idx="2445">
                  <c:v>1.9390000343322988</c:v>
                </c:pt>
                <c:pt idx="2446">
                  <c:v>6.0403998804093</c:v>
                </c:pt>
                <c:pt idx="2447">
                  <c:v>4.6957999324798507</c:v>
                </c:pt>
                <c:pt idx="2448">
                  <c:v>2.1264499711990013</c:v>
                </c:pt>
                <c:pt idx="2449">
                  <c:v>4.7380499887466456</c:v>
                </c:pt>
                <c:pt idx="2450">
                  <c:v>5.6971999216079539</c:v>
                </c:pt>
                <c:pt idx="2451">
                  <c:v>4.8591499948501493</c:v>
                </c:pt>
                <c:pt idx="2452">
                  <c:v>5.4011000442504979</c:v>
                </c:pt>
                <c:pt idx="2453">
                  <c:v>5.4429999208450539</c:v>
                </c:pt>
                <c:pt idx="2454">
                  <c:v>5.869150071144098</c:v>
                </c:pt>
                <c:pt idx="2455">
                  <c:v>4.2216998624801505</c:v>
                </c:pt>
                <c:pt idx="2456">
                  <c:v>5.4455498695373521</c:v>
                </c:pt>
                <c:pt idx="2457">
                  <c:v>2.963899993896451</c:v>
                </c:pt>
                <c:pt idx="2458">
                  <c:v>6.1392500495910483</c:v>
                </c:pt>
                <c:pt idx="2459">
                  <c:v>5.4426000738143472</c:v>
                </c:pt>
                <c:pt idx="2460">
                  <c:v>1.7824999284744507</c:v>
                </c:pt>
                <c:pt idx="2461">
                  <c:v>5.3137000131606484</c:v>
                </c:pt>
                <c:pt idx="2462">
                  <c:v>3.5021499109267999</c:v>
                </c:pt>
                <c:pt idx="2463">
                  <c:v>3.4181999921798507</c:v>
                </c:pt>
                <c:pt idx="2464">
                  <c:v>5.8674000024795525</c:v>
                </c:pt>
                <c:pt idx="2465">
                  <c:v>6.4260000014305518</c:v>
                </c:pt>
                <c:pt idx="2466">
                  <c:v>6.6451000356674541</c:v>
                </c:pt>
                <c:pt idx="2467">
                  <c:v>6.5680499172210531</c:v>
                </c:pt>
                <c:pt idx="2468">
                  <c:v>3.3310500621795498</c:v>
                </c:pt>
                <c:pt idx="2469">
                  <c:v>5.0636499071121008</c:v>
                </c:pt>
                <c:pt idx="2470">
                  <c:v>5.7867499780654974</c:v>
                </c:pt>
                <c:pt idx="2471">
                  <c:v>4.7416500473021976</c:v>
                </c:pt>
                <c:pt idx="2472">
                  <c:v>5.4986499309539987</c:v>
                </c:pt>
                <c:pt idx="2473">
                  <c:v>3.6090498566627502</c:v>
                </c:pt>
                <c:pt idx="2474">
                  <c:v>3.2632500076293489</c:v>
                </c:pt>
                <c:pt idx="2475">
                  <c:v>3.5350000047683494</c:v>
                </c:pt>
                <c:pt idx="2476">
                  <c:v>2.9616000628471504</c:v>
                </c:pt>
                <c:pt idx="2477">
                  <c:v>3.9596000242232989</c:v>
                </c:pt>
                <c:pt idx="2478">
                  <c:v>5.4240498828888484</c:v>
                </c:pt>
                <c:pt idx="2479">
                  <c:v>5.1770999717711987</c:v>
                </c:pt>
                <c:pt idx="2480">
                  <c:v>5.5176999330520502</c:v>
                </c:pt>
                <c:pt idx="2481">
                  <c:v>7.5846498870849466</c:v>
                </c:pt>
                <c:pt idx="2482">
                  <c:v>7.9570500469207985</c:v>
                </c:pt>
                <c:pt idx="2483">
                  <c:v>7.0464999675750484</c:v>
                </c:pt>
                <c:pt idx="2484">
                  <c:v>5.0893999958038023</c:v>
                </c:pt>
                <c:pt idx="2485">
                  <c:v>2.9218500757217498</c:v>
                </c:pt>
                <c:pt idx="2486">
                  <c:v>4.3546499776840548</c:v>
                </c:pt>
                <c:pt idx="2487">
                  <c:v>2.3248999929427967</c:v>
                </c:pt>
                <c:pt idx="2488">
                  <c:v>8.3457500457763487</c:v>
                </c:pt>
                <c:pt idx="2489">
                  <c:v>3.5935999870300463</c:v>
                </c:pt>
                <c:pt idx="2490">
                  <c:v>6.2586498975753457</c:v>
                </c:pt>
                <c:pt idx="2491">
                  <c:v>0.73619996309279756</c:v>
                </c:pt>
                <c:pt idx="2492">
                  <c:v>1.7597999858856497</c:v>
                </c:pt>
                <c:pt idx="2493">
                  <c:v>2.9782498407364031</c:v>
                </c:pt>
                <c:pt idx="2494">
                  <c:v>1.1356500482559007</c:v>
                </c:pt>
                <c:pt idx="2495">
                  <c:v>5.3278998994826985</c:v>
                </c:pt>
                <c:pt idx="2496">
                  <c:v>5.5417000532150453</c:v>
                </c:pt>
                <c:pt idx="2497">
                  <c:v>1.9368999481201499</c:v>
                </c:pt>
                <c:pt idx="2498">
                  <c:v>6.684549965858448</c:v>
                </c:pt>
                <c:pt idx="2499">
                  <c:v>4.7073499679565529</c:v>
                </c:pt>
                <c:pt idx="2500">
                  <c:v>4.0857501173019557</c:v>
                </c:pt>
                <c:pt idx="2501">
                  <c:v>7.8765499210357461</c:v>
                </c:pt>
                <c:pt idx="2502">
                  <c:v>3.7759499931335512</c:v>
                </c:pt>
                <c:pt idx="2503">
                  <c:v>3.0732499980926526</c:v>
                </c:pt>
                <c:pt idx="2504">
                  <c:v>3.3844998931883978</c:v>
                </c:pt>
                <c:pt idx="2505">
                  <c:v>4.6163999271392981</c:v>
                </c:pt>
                <c:pt idx="2506">
                  <c:v>4.0158500289917001</c:v>
                </c:pt>
                <c:pt idx="2507">
                  <c:v>6.146099934577947</c:v>
                </c:pt>
                <c:pt idx="2508">
                  <c:v>2.6022499656677027</c:v>
                </c:pt>
                <c:pt idx="2509">
                  <c:v>5.5561999034882028</c:v>
                </c:pt>
                <c:pt idx="2510">
                  <c:v>4.6970498991012519</c:v>
                </c:pt>
                <c:pt idx="2511">
                  <c:v>5.4252499723434013</c:v>
                </c:pt>
                <c:pt idx="2512">
                  <c:v>5.0273500061034966</c:v>
                </c:pt>
                <c:pt idx="2513">
                  <c:v>5.4332000780106</c:v>
                </c:pt>
                <c:pt idx="2514">
                  <c:v>3.0613500499724999</c:v>
                </c:pt>
                <c:pt idx="2515">
                  <c:v>3.745550031661999</c:v>
                </c:pt>
                <c:pt idx="2516">
                  <c:v>4.4062499189376965</c:v>
                </c:pt>
                <c:pt idx="2517">
                  <c:v>5.2356999540328957</c:v>
                </c:pt>
                <c:pt idx="2518">
                  <c:v>2.3397500324249521</c:v>
                </c:pt>
                <c:pt idx="2519">
                  <c:v>3.8807999801635518</c:v>
                </c:pt>
                <c:pt idx="2520">
                  <c:v>4.4335999488830993</c:v>
                </c:pt>
                <c:pt idx="2521">
                  <c:v>2.7907499933242512</c:v>
                </c:pt>
                <c:pt idx="2522">
                  <c:v>5.8879499816894487</c:v>
                </c:pt>
                <c:pt idx="2523">
                  <c:v>4.9905499410628984</c:v>
                </c:pt>
                <c:pt idx="2524">
                  <c:v>5.4125000000000512</c:v>
                </c:pt>
                <c:pt idx="2525">
                  <c:v>4.5119999980926515</c:v>
                </c:pt>
                <c:pt idx="2526">
                  <c:v>5.0616499948501499</c:v>
                </c:pt>
                <c:pt idx="2527">
                  <c:v>4.0109501171112036</c:v>
                </c:pt>
                <c:pt idx="2528">
                  <c:v>4.2678500747681021</c:v>
                </c:pt>
                <c:pt idx="2529">
                  <c:v>3.6290499639510507</c:v>
                </c:pt>
                <c:pt idx="2530">
                  <c:v>1.4668500232696999</c:v>
                </c:pt>
                <c:pt idx="2531">
                  <c:v>5.262599992752051</c:v>
                </c:pt>
                <c:pt idx="2532">
                  <c:v>4.6232499766349484</c:v>
                </c:pt>
                <c:pt idx="2533">
                  <c:v>3.5317498874665034</c:v>
                </c:pt>
                <c:pt idx="2534">
                  <c:v>3.6160499095917018</c:v>
                </c:pt>
                <c:pt idx="2535">
                  <c:v>4.961099929809599</c:v>
                </c:pt>
                <c:pt idx="2536">
                  <c:v>2.7792500257491994</c:v>
                </c:pt>
                <c:pt idx="2537">
                  <c:v>2.9425999975204498</c:v>
                </c:pt>
                <c:pt idx="2538">
                  <c:v>5.5619998693466499</c:v>
                </c:pt>
                <c:pt idx="2539">
                  <c:v>6.9582500886916989</c:v>
                </c:pt>
                <c:pt idx="2540">
                  <c:v>6.9313999223709004</c:v>
                </c:pt>
                <c:pt idx="2541">
                  <c:v>4.6297999668121506</c:v>
                </c:pt>
                <c:pt idx="2542">
                  <c:v>7.201699910163903</c:v>
                </c:pt>
                <c:pt idx="2543">
                  <c:v>3.1764000463485509</c:v>
                </c:pt>
                <c:pt idx="2544">
                  <c:v>3.2344499588012496</c:v>
                </c:pt>
                <c:pt idx="2545">
                  <c:v>2.9416999769211003</c:v>
                </c:pt>
                <c:pt idx="2546">
                  <c:v>4.1685500764846992</c:v>
                </c:pt>
                <c:pt idx="2547">
                  <c:v>4.8407499837875498</c:v>
                </c:pt>
                <c:pt idx="2548">
                  <c:v>3.8821998357772536</c:v>
                </c:pt>
                <c:pt idx="2549">
                  <c:v>6.2137000656127483</c:v>
                </c:pt>
                <c:pt idx="2550">
                  <c:v>3.3203500413894993</c:v>
                </c:pt>
                <c:pt idx="2551">
                  <c:v>4.2767998981475479</c:v>
                </c:pt>
                <c:pt idx="2552">
                  <c:v>6.629300007820202</c:v>
                </c:pt>
                <c:pt idx="2553">
                  <c:v>1.9642500686645477</c:v>
                </c:pt>
                <c:pt idx="2554">
                  <c:v>4.6251999902725025</c:v>
                </c:pt>
                <c:pt idx="2555">
                  <c:v>2.6536000967025473</c:v>
                </c:pt>
                <c:pt idx="2556">
                  <c:v>5.4991999530791524</c:v>
                </c:pt>
                <c:pt idx="2557">
                  <c:v>5.7643500137329475</c:v>
                </c:pt>
                <c:pt idx="2558">
                  <c:v>4.4755500316619994</c:v>
                </c:pt>
                <c:pt idx="2559">
                  <c:v>5.9223500442504999</c:v>
                </c:pt>
                <c:pt idx="2560">
                  <c:v>2.6185500383377018</c:v>
                </c:pt>
                <c:pt idx="2561">
                  <c:v>4.1765500640869</c:v>
                </c:pt>
                <c:pt idx="2562">
                  <c:v>5.272699942588801</c:v>
                </c:pt>
                <c:pt idx="2563">
                  <c:v>4.1616498947143477</c:v>
                </c:pt>
                <c:pt idx="2564">
                  <c:v>4.0376498222350996</c:v>
                </c:pt>
                <c:pt idx="2565">
                  <c:v>4.0393000030517499</c:v>
                </c:pt>
                <c:pt idx="2566">
                  <c:v>3.4828499984740944</c:v>
                </c:pt>
                <c:pt idx="2567">
                  <c:v>4.5780999946593965</c:v>
                </c:pt>
                <c:pt idx="2568">
                  <c:v>5.8013499116897513</c:v>
                </c:pt>
                <c:pt idx="2569">
                  <c:v>2.717250123023998</c:v>
                </c:pt>
                <c:pt idx="2570">
                  <c:v>5.7624498891830989</c:v>
                </c:pt>
                <c:pt idx="2571">
                  <c:v>3.0807499647140482</c:v>
                </c:pt>
                <c:pt idx="2572">
                  <c:v>5.4881500148773519</c:v>
                </c:pt>
                <c:pt idx="2573">
                  <c:v>3.9924499082565461</c:v>
                </c:pt>
                <c:pt idx="2574">
                  <c:v>6.1081499528885033</c:v>
                </c:pt>
                <c:pt idx="2575">
                  <c:v>6.4257000827788993</c:v>
                </c:pt>
                <c:pt idx="2576">
                  <c:v>4.6928999423980997</c:v>
                </c:pt>
                <c:pt idx="2577">
                  <c:v>5.8942500257492476</c:v>
                </c:pt>
                <c:pt idx="2578">
                  <c:v>6.1722999429703513</c:v>
                </c:pt>
                <c:pt idx="2579">
                  <c:v>6.0428499412536532</c:v>
                </c:pt>
                <c:pt idx="2580">
                  <c:v>6.0107999992370509</c:v>
                </c:pt>
                <c:pt idx="2581">
                  <c:v>5.8939000606536531</c:v>
                </c:pt>
                <c:pt idx="2582">
                  <c:v>7.0278500223159988</c:v>
                </c:pt>
                <c:pt idx="2583">
                  <c:v>6.2714499473571479</c:v>
                </c:pt>
                <c:pt idx="2584">
                  <c:v>3.6817000865935938</c:v>
                </c:pt>
                <c:pt idx="2585">
                  <c:v>5.5908999919892004</c:v>
                </c:pt>
                <c:pt idx="2586">
                  <c:v>3.5419499063491493</c:v>
                </c:pt>
                <c:pt idx="2587">
                  <c:v>4.2310998964309974</c:v>
                </c:pt>
                <c:pt idx="2588">
                  <c:v>-2.1708997774124477</c:v>
                </c:pt>
                <c:pt idx="2589">
                  <c:v>5.9427000474929983</c:v>
                </c:pt>
                <c:pt idx="2590">
                  <c:v>3.940349946022053</c:v>
                </c:pt>
                <c:pt idx="2591">
                  <c:v>4.2490000247955493</c:v>
                </c:pt>
                <c:pt idx="2592">
                  <c:v>4.2417998313903489</c:v>
                </c:pt>
                <c:pt idx="2593">
                  <c:v>2.8748499345779521</c:v>
                </c:pt>
                <c:pt idx="2594">
                  <c:v>5.8667999887466031</c:v>
                </c:pt>
                <c:pt idx="2595">
                  <c:v>5.0493500375747544</c:v>
                </c:pt>
                <c:pt idx="2596">
                  <c:v>4.2041999697685526</c:v>
                </c:pt>
                <c:pt idx="2597">
                  <c:v>5.8553998899459998</c:v>
                </c:pt>
                <c:pt idx="2598">
                  <c:v>2.9680000400542994</c:v>
                </c:pt>
                <c:pt idx="2599">
                  <c:v>2.8337000942229977</c:v>
                </c:pt>
                <c:pt idx="2600">
                  <c:v>5.4353498506545996</c:v>
                </c:pt>
                <c:pt idx="2601">
                  <c:v>3.3242000055312992</c:v>
                </c:pt>
                <c:pt idx="2602">
                  <c:v>5.0213000679015991</c:v>
                </c:pt>
                <c:pt idx="2603">
                  <c:v>3.2980499649047488</c:v>
                </c:pt>
                <c:pt idx="2604">
                  <c:v>5.1243999052047471</c:v>
                </c:pt>
                <c:pt idx="2605">
                  <c:v>4.5305000400542959</c:v>
                </c:pt>
                <c:pt idx="2606">
                  <c:v>6.1695498847962043</c:v>
                </c:pt>
                <c:pt idx="2607">
                  <c:v>4.3695999526977474</c:v>
                </c:pt>
                <c:pt idx="2608">
                  <c:v>3.0089999771117988</c:v>
                </c:pt>
                <c:pt idx="2609">
                  <c:v>2.4091499185562526</c:v>
                </c:pt>
                <c:pt idx="2610">
                  <c:v>4.2273500442504499</c:v>
                </c:pt>
                <c:pt idx="2611">
                  <c:v>3.0532499170303495</c:v>
                </c:pt>
                <c:pt idx="2612">
                  <c:v>3.7604998588562495</c:v>
                </c:pt>
                <c:pt idx="2613">
                  <c:v>3.5219500303267992</c:v>
                </c:pt>
                <c:pt idx="2614">
                  <c:v>2.9167498874664517</c:v>
                </c:pt>
                <c:pt idx="2615">
                  <c:v>-5.8182998800277979</c:v>
                </c:pt>
                <c:pt idx="2616">
                  <c:v>6.5936999416350979</c:v>
                </c:pt>
                <c:pt idx="2617">
                  <c:v>4.8596499490737557</c:v>
                </c:pt>
                <c:pt idx="2618">
                  <c:v>4.0172501087189012</c:v>
                </c:pt>
                <c:pt idx="2619">
                  <c:v>3.7649499511718503</c:v>
                </c:pt>
                <c:pt idx="2620">
                  <c:v>3.1303999376296971</c:v>
                </c:pt>
                <c:pt idx="2621">
                  <c:v>-2.8849983215351926E-2</c:v>
                </c:pt>
                <c:pt idx="2622">
                  <c:v>2.9173000144958507</c:v>
                </c:pt>
                <c:pt idx="2623">
                  <c:v>5.0600998973845996</c:v>
                </c:pt>
                <c:pt idx="2624">
                  <c:v>3.1597000169754494</c:v>
                </c:pt>
                <c:pt idx="2625">
                  <c:v>3.0543999338150485</c:v>
                </c:pt>
                <c:pt idx="2626">
                  <c:v>3.8582999801636007</c:v>
                </c:pt>
                <c:pt idx="2627">
                  <c:v>5.8358500528335036</c:v>
                </c:pt>
                <c:pt idx="2628">
                  <c:v>5.1213000440597973</c:v>
                </c:pt>
                <c:pt idx="2629">
                  <c:v>5.0971500253677533</c:v>
                </c:pt>
                <c:pt idx="2630">
                  <c:v>1.691149973869301</c:v>
                </c:pt>
                <c:pt idx="2631">
                  <c:v>4.8182500314712513</c:v>
                </c:pt>
                <c:pt idx="2632">
                  <c:v>5.5070000314712999</c:v>
                </c:pt>
                <c:pt idx="2633">
                  <c:v>5.3350500011444026</c:v>
                </c:pt>
                <c:pt idx="2634">
                  <c:v>2.5529999732970516</c:v>
                </c:pt>
                <c:pt idx="2635">
                  <c:v>3.9634499359131006</c:v>
                </c:pt>
                <c:pt idx="2636">
                  <c:v>5.7370999765396498</c:v>
                </c:pt>
                <c:pt idx="2637">
                  <c:v>2.8447499942780006</c:v>
                </c:pt>
                <c:pt idx="2638">
                  <c:v>4.3988999319076498</c:v>
                </c:pt>
                <c:pt idx="2639">
                  <c:v>6.7953999280929978</c:v>
                </c:pt>
                <c:pt idx="2640">
                  <c:v>5.3698500490189005</c:v>
                </c:pt>
                <c:pt idx="2641">
                  <c:v>5.2809999608993508</c:v>
                </c:pt>
                <c:pt idx="2642">
                  <c:v>4.3405999326705498</c:v>
                </c:pt>
                <c:pt idx="2643">
                  <c:v>4.9583001089096008</c:v>
                </c:pt>
                <c:pt idx="2644">
                  <c:v>4.691349892616298</c:v>
                </c:pt>
                <c:pt idx="2645">
                  <c:v>4.0754999256133999</c:v>
                </c:pt>
                <c:pt idx="2646">
                  <c:v>2.2594499778747519</c:v>
                </c:pt>
                <c:pt idx="2647">
                  <c:v>5.4115499591827003</c:v>
                </c:pt>
                <c:pt idx="2648">
                  <c:v>3.7709999370574536</c:v>
                </c:pt>
                <c:pt idx="2649">
                  <c:v>4.7744500446320011</c:v>
                </c:pt>
                <c:pt idx="2650">
                  <c:v>5.5616499996185524</c:v>
                </c:pt>
                <c:pt idx="2651">
                  <c:v>5.7805499172210517</c:v>
                </c:pt>
                <c:pt idx="2652">
                  <c:v>2.430100011825548</c:v>
                </c:pt>
                <c:pt idx="2653">
                  <c:v>4.2188999080658505</c:v>
                </c:pt>
                <c:pt idx="2654">
                  <c:v>7.7316500759124551</c:v>
                </c:pt>
                <c:pt idx="2655">
                  <c:v>4.8878000354766513</c:v>
                </c:pt>
                <c:pt idx="2656">
                  <c:v>4.2036500263214016</c:v>
                </c:pt>
                <c:pt idx="2657">
                  <c:v>6.3388500261307001</c:v>
                </c:pt>
                <c:pt idx="2658">
                  <c:v>4.9077000427246027</c:v>
                </c:pt>
                <c:pt idx="2659">
                  <c:v>5.4624998712539963</c:v>
                </c:pt>
                <c:pt idx="2660">
                  <c:v>5.2123000621795477</c:v>
                </c:pt>
                <c:pt idx="2661">
                  <c:v>1.8395000267028507</c:v>
                </c:pt>
                <c:pt idx="2662">
                  <c:v>3.7976000642776029</c:v>
                </c:pt>
                <c:pt idx="2663">
                  <c:v>3.5643499612808043</c:v>
                </c:pt>
                <c:pt idx="2664">
                  <c:v>3.9840498447418042</c:v>
                </c:pt>
                <c:pt idx="2665">
                  <c:v>-3.0502499437331991</c:v>
                </c:pt>
                <c:pt idx="2666">
                  <c:v>2.855849962234501</c:v>
                </c:pt>
                <c:pt idx="2667">
                  <c:v>4.4382999753951999</c:v>
                </c:pt>
                <c:pt idx="2668">
                  <c:v>-3.355002880094915E-2</c:v>
                </c:pt>
                <c:pt idx="2669">
                  <c:v>3.9788499498367536</c:v>
                </c:pt>
                <c:pt idx="2670">
                  <c:v>2.5433000898361513</c:v>
                </c:pt>
                <c:pt idx="2671">
                  <c:v>6.4340499925613486</c:v>
                </c:pt>
                <c:pt idx="2672">
                  <c:v>6.4649999475479483</c:v>
                </c:pt>
                <c:pt idx="2673">
                  <c:v>2.5236500644683524</c:v>
                </c:pt>
                <c:pt idx="2674">
                  <c:v>6.0163000249863003</c:v>
                </c:pt>
                <c:pt idx="2675">
                  <c:v>6.9345499992370989</c:v>
                </c:pt>
                <c:pt idx="2676">
                  <c:v>5.809400005340553</c:v>
                </c:pt>
                <c:pt idx="2677">
                  <c:v>6.1381000518798992</c:v>
                </c:pt>
                <c:pt idx="2678">
                  <c:v>3.6141998243332054</c:v>
                </c:pt>
                <c:pt idx="2679">
                  <c:v>4.8403500270843516</c:v>
                </c:pt>
                <c:pt idx="2680">
                  <c:v>3.9668000364303495</c:v>
                </c:pt>
                <c:pt idx="2681">
                  <c:v>3.68880010604855</c:v>
                </c:pt>
                <c:pt idx="2682">
                  <c:v>3.3103000020980993</c:v>
                </c:pt>
                <c:pt idx="2683">
                  <c:v>3.1465999937058022</c:v>
                </c:pt>
                <c:pt idx="2684">
                  <c:v>2.6984002113342456</c:v>
                </c:pt>
                <c:pt idx="2685">
                  <c:v>5.6556999778747006</c:v>
                </c:pt>
                <c:pt idx="2686">
                  <c:v>5.4191999006271487</c:v>
                </c:pt>
                <c:pt idx="2687">
                  <c:v>4.8527999782562041</c:v>
                </c:pt>
                <c:pt idx="2688">
                  <c:v>4.1077999782562493</c:v>
                </c:pt>
                <c:pt idx="2689">
                  <c:v>2.5307998514175019</c:v>
                </c:pt>
                <c:pt idx="2690">
                  <c:v>2.0671500253677522</c:v>
                </c:pt>
                <c:pt idx="2691">
                  <c:v>5.7820999860763997</c:v>
                </c:pt>
                <c:pt idx="2692">
                  <c:v>7.2280499744415501</c:v>
                </c:pt>
                <c:pt idx="2693">
                  <c:v>-2.8722499799728496</c:v>
                </c:pt>
                <c:pt idx="2694">
                  <c:v>4.0447498607635453</c:v>
                </c:pt>
                <c:pt idx="2695">
                  <c:v>3.2847999525070009</c:v>
                </c:pt>
                <c:pt idx="2696">
                  <c:v>4.6296000051499036</c:v>
                </c:pt>
                <c:pt idx="2697">
                  <c:v>4.8628500223159961</c:v>
                </c:pt>
                <c:pt idx="2698">
                  <c:v>4.4403500843048498</c:v>
                </c:pt>
                <c:pt idx="2699">
                  <c:v>5.2144500494003516</c:v>
                </c:pt>
                <c:pt idx="2700">
                  <c:v>5.2508000135421469</c:v>
                </c:pt>
                <c:pt idx="2701">
                  <c:v>7.3302000045777014</c:v>
                </c:pt>
                <c:pt idx="2702">
                  <c:v>2.5293000173568991</c:v>
                </c:pt>
                <c:pt idx="2703">
                  <c:v>4.7632000494002966</c:v>
                </c:pt>
                <c:pt idx="2704">
                  <c:v>4.586500039100649</c:v>
                </c:pt>
                <c:pt idx="2705">
                  <c:v>4.4804497504234497</c:v>
                </c:pt>
                <c:pt idx="2706">
                  <c:v>6.1434499406814034</c:v>
                </c:pt>
                <c:pt idx="2707">
                  <c:v>3.2685000562667526</c:v>
                </c:pt>
                <c:pt idx="2708">
                  <c:v>4.4353001165390467</c:v>
                </c:pt>
                <c:pt idx="2709">
                  <c:v>2.8847999620437008</c:v>
                </c:pt>
                <c:pt idx="2710">
                  <c:v>4.2375000333785984</c:v>
                </c:pt>
                <c:pt idx="2711">
                  <c:v>4.0015001010895048</c:v>
                </c:pt>
                <c:pt idx="2712">
                  <c:v>4.0515999937057465</c:v>
                </c:pt>
                <c:pt idx="2713">
                  <c:v>6.2127999877929518</c:v>
                </c:pt>
                <c:pt idx="2714">
                  <c:v>3.2678500795365011</c:v>
                </c:pt>
                <c:pt idx="2715">
                  <c:v>5.7375999212264546</c:v>
                </c:pt>
                <c:pt idx="2716">
                  <c:v>3.9641999483108492</c:v>
                </c:pt>
                <c:pt idx="2717">
                  <c:v>4.3879000234604035</c:v>
                </c:pt>
                <c:pt idx="2718">
                  <c:v>8.1700010299698533E-2</c:v>
                </c:pt>
                <c:pt idx="2719">
                  <c:v>5.6030000305175491</c:v>
                </c:pt>
                <c:pt idx="2720">
                  <c:v>6.180250072479204</c:v>
                </c:pt>
                <c:pt idx="2721">
                  <c:v>4.8217499828339001</c:v>
                </c:pt>
                <c:pt idx="2722">
                  <c:v>0.23535002708435115</c:v>
                </c:pt>
                <c:pt idx="2723">
                  <c:v>2.5799500226974033</c:v>
                </c:pt>
                <c:pt idx="2724">
                  <c:v>3.1784998464584504</c:v>
                </c:pt>
                <c:pt idx="2725">
                  <c:v>6.2047499513626505</c:v>
                </c:pt>
                <c:pt idx="2726">
                  <c:v>2.8336999249458508</c:v>
                </c:pt>
                <c:pt idx="2727">
                  <c:v>2.5917499589920006</c:v>
                </c:pt>
                <c:pt idx="2728">
                  <c:v>1.9153500986099488</c:v>
                </c:pt>
                <c:pt idx="2729">
                  <c:v>3.5182999515533488</c:v>
                </c:pt>
                <c:pt idx="2730">
                  <c:v>2.5893999195099013</c:v>
                </c:pt>
                <c:pt idx="2731">
                  <c:v>4.718850026130653</c:v>
                </c:pt>
                <c:pt idx="2732">
                  <c:v>4.795899949073803</c:v>
                </c:pt>
                <c:pt idx="2733">
                  <c:v>3.2801000213623013</c:v>
                </c:pt>
                <c:pt idx="2734">
                  <c:v>1.6684000682831019</c:v>
                </c:pt>
                <c:pt idx="2735">
                  <c:v>3.3781000471115021</c:v>
                </c:pt>
                <c:pt idx="2736">
                  <c:v>2.6849999284743973</c:v>
                </c:pt>
                <c:pt idx="2737">
                  <c:v>3.3222500514984468</c:v>
                </c:pt>
                <c:pt idx="2738">
                  <c:v>7.0540499091149016</c:v>
                </c:pt>
                <c:pt idx="2739">
                  <c:v>4.0548998928070468</c:v>
                </c:pt>
                <c:pt idx="2740">
                  <c:v>5.7296499776840015</c:v>
                </c:pt>
                <c:pt idx="2741">
                  <c:v>1.6570000791549475</c:v>
                </c:pt>
                <c:pt idx="2742">
                  <c:v>5.3897999811172497</c:v>
                </c:pt>
                <c:pt idx="2743">
                  <c:v>0.81685000896455051</c:v>
                </c:pt>
                <c:pt idx="2744">
                  <c:v>5.673649981021903</c:v>
                </c:pt>
                <c:pt idx="2745">
                  <c:v>2.0669999790191511</c:v>
                </c:pt>
                <c:pt idx="2746">
                  <c:v>4.2689001035690488</c:v>
                </c:pt>
                <c:pt idx="2747">
                  <c:v>5.5547498846054495</c:v>
                </c:pt>
                <c:pt idx="2748">
                  <c:v>6.3631000041962018</c:v>
                </c:pt>
                <c:pt idx="2749">
                  <c:v>4.6442499971389495</c:v>
                </c:pt>
                <c:pt idx="2750">
                  <c:v>5.3429499387740975</c:v>
                </c:pt>
                <c:pt idx="2751">
                  <c:v>5.2159000778197964</c:v>
                </c:pt>
                <c:pt idx="2752">
                  <c:v>4.8218500280380496</c:v>
                </c:pt>
                <c:pt idx="2753">
                  <c:v>3.6841499996184979</c:v>
                </c:pt>
                <c:pt idx="2754">
                  <c:v>3.6027500677109003</c:v>
                </c:pt>
                <c:pt idx="2755">
                  <c:v>2.5653499507904023</c:v>
                </c:pt>
                <c:pt idx="2756">
                  <c:v>3.3915499401092504</c:v>
                </c:pt>
                <c:pt idx="2757">
                  <c:v>2.5030500173568981</c:v>
                </c:pt>
                <c:pt idx="2758">
                  <c:v>3.3513999462127515</c:v>
                </c:pt>
                <c:pt idx="2759">
                  <c:v>6.5608998680115</c:v>
                </c:pt>
                <c:pt idx="2760">
                  <c:v>1.9524499797820489</c:v>
                </c:pt>
                <c:pt idx="2761">
                  <c:v>5.9131999254227026</c:v>
                </c:pt>
                <c:pt idx="2762">
                  <c:v>5.1233499574661998</c:v>
                </c:pt>
                <c:pt idx="2763">
                  <c:v>3.9497500133514514</c:v>
                </c:pt>
                <c:pt idx="2764">
                  <c:v>5.478299918174752</c:v>
                </c:pt>
                <c:pt idx="2765">
                  <c:v>2.7715497827529987</c:v>
                </c:pt>
                <c:pt idx="2766">
                  <c:v>2.7451999950408492</c:v>
                </c:pt>
                <c:pt idx="2767">
                  <c:v>7.3071999073028486</c:v>
                </c:pt>
                <c:pt idx="2768">
                  <c:v>4.5458499860763482</c:v>
                </c:pt>
                <c:pt idx="2769">
                  <c:v>3.6475500011444026</c:v>
                </c:pt>
                <c:pt idx="2770">
                  <c:v>4.2985998582839997</c:v>
                </c:pt>
                <c:pt idx="2771">
                  <c:v>7.9900000095367467</c:v>
                </c:pt>
                <c:pt idx="2772">
                  <c:v>4.7631999492645534</c:v>
                </c:pt>
                <c:pt idx="2773">
                  <c:v>7.1014000320434505</c:v>
                </c:pt>
                <c:pt idx="2774">
                  <c:v>7.5201499247550494</c:v>
                </c:pt>
                <c:pt idx="2775">
                  <c:v>5.3656998443603499</c:v>
                </c:pt>
                <c:pt idx="2776">
                  <c:v>3.4434999227523519</c:v>
                </c:pt>
                <c:pt idx="2777">
                  <c:v>3.8805999517440952</c:v>
                </c:pt>
                <c:pt idx="2778">
                  <c:v>3.8208500576019446</c:v>
                </c:pt>
                <c:pt idx="2779">
                  <c:v>0.44709998130800344</c:v>
                </c:pt>
                <c:pt idx="2780">
                  <c:v>0.7565499782561993</c:v>
                </c:pt>
                <c:pt idx="2781">
                  <c:v>3.8180500507354509</c:v>
                </c:pt>
                <c:pt idx="2782">
                  <c:v>4.2821999597549514</c:v>
                </c:pt>
                <c:pt idx="2783">
                  <c:v>5.1556998872756985</c:v>
                </c:pt>
                <c:pt idx="2784">
                  <c:v>4.4462499094009971</c:v>
                </c:pt>
                <c:pt idx="2785">
                  <c:v>1.8905999946593965</c:v>
                </c:pt>
                <c:pt idx="2786">
                  <c:v>4.1825000715256024</c:v>
                </c:pt>
                <c:pt idx="2787">
                  <c:v>4.3239999485015979</c:v>
                </c:pt>
                <c:pt idx="2788">
                  <c:v>2.0806999492644991</c:v>
                </c:pt>
                <c:pt idx="2789">
                  <c:v>1.9243500518798484</c:v>
                </c:pt>
                <c:pt idx="2790">
                  <c:v>4.1680500841140997</c:v>
                </c:pt>
                <c:pt idx="2791">
                  <c:v>2.305800080299349</c:v>
                </c:pt>
                <c:pt idx="2792">
                  <c:v>5.2666000604629488</c:v>
                </c:pt>
                <c:pt idx="2793">
                  <c:v>2.6293000507354982</c:v>
                </c:pt>
                <c:pt idx="2794">
                  <c:v>3.6046499776839482</c:v>
                </c:pt>
                <c:pt idx="2795">
                  <c:v>5.6318499660492023</c:v>
                </c:pt>
                <c:pt idx="2796">
                  <c:v>4.1510500431060997</c:v>
                </c:pt>
                <c:pt idx="2797">
                  <c:v>0.43280002117155192</c:v>
                </c:pt>
                <c:pt idx="2798">
                  <c:v>1.7507500028610536</c:v>
                </c:pt>
                <c:pt idx="2799">
                  <c:v>5.6320999479293476</c:v>
                </c:pt>
                <c:pt idx="2800">
                  <c:v>2.4333000087738519</c:v>
                </c:pt>
                <c:pt idx="2801">
                  <c:v>1.7302500247955521</c:v>
                </c:pt>
                <c:pt idx="2802">
                  <c:v>7.2904501342773997</c:v>
                </c:pt>
                <c:pt idx="2803">
                  <c:v>4.2686499738693016</c:v>
                </c:pt>
                <c:pt idx="2804">
                  <c:v>4.06979991912835</c:v>
                </c:pt>
                <c:pt idx="2805">
                  <c:v>2.2780499124527509</c:v>
                </c:pt>
                <c:pt idx="2806">
                  <c:v>4.3604499816894489</c:v>
                </c:pt>
                <c:pt idx="2807">
                  <c:v>0.96229997634890196</c:v>
                </c:pt>
                <c:pt idx="2808">
                  <c:v>1.60385003089905</c:v>
                </c:pt>
                <c:pt idx="2809">
                  <c:v>2.273850002288853</c:v>
                </c:pt>
                <c:pt idx="2810">
                  <c:v>1.4440000486373989</c:v>
                </c:pt>
                <c:pt idx="2811">
                  <c:v>1.8171499300002978</c:v>
                </c:pt>
                <c:pt idx="2812">
                  <c:v>3.6472500562667989</c:v>
                </c:pt>
                <c:pt idx="2813">
                  <c:v>4.4765501022338476</c:v>
                </c:pt>
                <c:pt idx="2814">
                  <c:v>3.7558500361442455</c:v>
                </c:pt>
                <c:pt idx="2815">
                  <c:v>5.3567499256133999</c:v>
                </c:pt>
                <c:pt idx="2816">
                  <c:v>1.3400501108169465</c:v>
                </c:pt>
                <c:pt idx="2817">
                  <c:v>2.9178500032424459</c:v>
                </c:pt>
                <c:pt idx="2818">
                  <c:v>5.7990498924254972</c:v>
                </c:pt>
                <c:pt idx="2819">
                  <c:v>5.8735500478744527</c:v>
                </c:pt>
                <c:pt idx="2820">
                  <c:v>2.1898500537872003</c:v>
                </c:pt>
                <c:pt idx="2821">
                  <c:v>5.3971500253677505</c:v>
                </c:pt>
                <c:pt idx="2822">
                  <c:v>4.3593499183654956</c:v>
                </c:pt>
                <c:pt idx="2823">
                  <c:v>4.8325999069213523</c:v>
                </c:pt>
                <c:pt idx="2824">
                  <c:v>6.3514500379562975</c:v>
                </c:pt>
                <c:pt idx="2825">
                  <c:v>1.2191000080108978</c:v>
                </c:pt>
                <c:pt idx="2826">
                  <c:v>1.9281000995636006</c:v>
                </c:pt>
                <c:pt idx="2827">
                  <c:v>4.8691499614715497</c:v>
                </c:pt>
                <c:pt idx="2828">
                  <c:v>4.9194499874115003</c:v>
                </c:pt>
                <c:pt idx="2829">
                  <c:v>3.0945500564575994</c:v>
                </c:pt>
                <c:pt idx="2830">
                  <c:v>3.3322499513626056</c:v>
                </c:pt>
                <c:pt idx="2831">
                  <c:v>5.1525000286102021</c:v>
                </c:pt>
                <c:pt idx="2832">
                  <c:v>1.9131998634337997</c:v>
                </c:pt>
                <c:pt idx="2833">
                  <c:v>5.1379000234603964</c:v>
                </c:pt>
                <c:pt idx="2834">
                  <c:v>-0.88205010414120011</c:v>
                </c:pt>
                <c:pt idx="2835">
                  <c:v>5.5446499013901018</c:v>
                </c:pt>
                <c:pt idx="2836">
                  <c:v>1.9445499706268521</c:v>
                </c:pt>
                <c:pt idx="2837">
                  <c:v>5.2981000614166511</c:v>
                </c:pt>
                <c:pt idx="2838">
                  <c:v>2.1705499458312971</c:v>
                </c:pt>
                <c:pt idx="2839">
                  <c:v>2.5759999608993986</c:v>
                </c:pt>
                <c:pt idx="2840">
                  <c:v>2.5795498657227007</c:v>
                </c:pt>
                <c:pt idx="2841">
                  <c:v>5.5731999874115026</c:v>
                </c:pt>
                <c:pt idx="2842">
                  <c:v>1.763749923706051</c:v>
                </c:pt>
                <c:pt idx="2843">
                  <c:v>1.701349925994851</c:v>
                </c:pt>
                <c:pt idx="2844">
                  <c:v>2.378999929428101</c:v>
                </c:pt>
                <c:pt idx="2845">
                  <c:v>5.5485999536514541</c:v>
                </c:pt>
                <c:pt idx="2846">
                  <c:v>4.2835500478744528</c:v>
                </c:pt>
                <c:pt idx="2847">
                  <c:v>2.6693999385834033</c:v>
                </c:pt>
                <c:pt idx="2848">
                  <c:v>1.8467499637604021</c:v>
                </c:pt>
                <c:pt idx="2849">
                  <c:v>1.7438001012802005</c:v>
                </c:pt>
                <c:pt idx="2850">
                  <c:v>2.7611500096320967</c:v>
                </c:pt>
                <c:pt idx="2851">
                  <c:v>1.5818999385833514</c:v>
                </c:pt>
                <c:pt idx="2852">
                  <c:v>4.1237000441551501</c:v>
                </c:pt>
                <c:pt idx="2853">
                  <c:v>2.4871999645232989</c:v>
                </c:pt>
                <c:pt idx="2854">
                  <c:v>2.8960000705719011</c:v>
                </c:pt>
                <c:pt idx="2855">
                  <c:v>1.6104000520706521</c:v>
                </c:pt>
                <c:pt idx="2856">
                  <c:v>4.8792499399184521</c:v>
                </c:pt>
                <c:pt idx="2857">
                  <c:v>3.6467999935149997</c:v>
                </c:pt>
                <c:pt idx="2858">
                  <c:v>6.3526498842238972</c:v>
                </c:pt>
                <c:pt idx="2859">
                  <c:v>8.1974998950957492</c:v>
                </c:pt>
                <c:pt idx="2860">
                  <c:v>1.5113999986648494</c:v>
                </c:pt>
                <c:pt idx="2861">
                  <c:v>5.93139998435975</c:v>
                </c:pt>
                <c:pt idx="2862">
                  <c:v>5.7360999727249506</c:v>
                </c:pt>
                <c:pt idx="2863">
                  <c:v>1.5656000041961988</c:v>
                </c:pt>
                <c:pt idx="2864">
                  <c:v>2.3045999622344482</c:v>
                </c:pt>
                <c:pt idx="2865">
                  <c:v>2.5505999708176006</c:v>
                </c:pt>
                <c:pt idx="2866">
                  <c:v>3.6987999677658507</c:v>
                </c:pt>
                <c:pt idx="2867">
                  <c:v>1.1719000816345009</c:v>
                </c:pt>
                <c:pt idx="2868">
                  <c:v>3.3497500729560983</c:v>
                </c:pt>
                <c:pt idx="2869">
                  <c:v>3.3316500377655061</c:v>
                </c:pt>
                <c:pt idx="2870">
                  <c:v>3.446200098991401</c:v>
                </c:pt>
                <c:pt idx="2871">
                  <c:v>3.1506998682022491</c:v>
                </c:pt>
                <c:pt idx="2872">
                  <c:v>2.7425499391556016</c:v>
                </c:pt>
                <c:pt idx="2873">
                  <c:v>2.5382000017166497</c:v>
                </c:pt>
                <c:pt idx="2874">
                  <c:v>3.6793501281738479</c:v>
                </c:pt>
                <c:pt idx="2875">
                  <c:v>2.4546501302719506</c:v>
                </c:pt>
                <c:pt idx="2876">
                  <c:v>1.7036999893188991</c:v>
                </c:pt>
                <c:pt idx="2877">
                  <c:v>3.1205499362945481</c:v>
                </c:pt>
                <c:pt idx="2878">
                  <c:v>3.1584500503540021</c:v>
                </c:pt>
                <c:pt idx="2879">
                  <c:v>3.1934499931336013</c:v>
                </c:pt>
                <c:pt idx="2880">
                  <c:v>2.892900023460399</c:v>
                </c:pt>
                <c:pt idx="2881">
                  <c:v>5.1597501325607524</c:v>
                </c:pt>
                <c:pt idx="2882">
                  <c:v>4.5602998638153487</c:v>
                </c:pt>
                <c:pt idx="2883">
                  <c:v>-6.9256499433517504</c:v>
                </c:pt>
                <c:pt idx="2884">
                  <c:v>2.1781500625610519</c:v>
                </c:pt>
                <c:pt idx="2885">
                  <c:v>3.7788499784469494</c:v>
                </c:pt>
                <c:pt idx="2886">
                  <c:v>3.9686500263214519</c:v>
                </c:pt>
                <c:pt idx="2887">
                  <c:v>4.4650999975204471</c:v>
                </c:pt>
                <c:pt idx="2888">
                  <c:v>2.8904998970031457</c:v>
                </c:pt>
                <c:pt idx="2889">
                  <c:v>3.2969500637054487</c:v>
                </c:pt>
                <c:pt idx="2890">
                  <c:v>4.924600005149852</c:v>
                </c:pt>
                <c:pt idx="2891">
                  <c:v>5.8553000545501988</c:v>
                </c:pt>
                <c:pt idx="2892">
                  <c:v>4.0389499378204476</c:v>
                </c:pt>
                <c:pt idx="2893">
                  <c:v>0.18285002231600345</c:v>
                </c:pt>
                <c:pt idx="2894">
                  <c:v>6.0500499105453507</c:v>
                </c:pt>
                <c:pt idx="2895">
                  <c:v>4.3256998252868968</c:v>
                </c:pt>
                <c:pt idx="2896">
                  <c:v>0.70789990901945288</c:v>
                </c:pt>
                <c:pt idx="2897">
                  <c:v>4.5842499208450498</c:v>
                </c:pt>
                <c:pt idx="2898">
                  <c:v>1.7077499485015508</c:v>
                </c:pt>
                <c:pt idx="2899">
                  <c:v>5.2851498460769477</c:v>
                </c:pt>
                <c:pt idx="2900">
                  <c:v>4.8178000688552984</c:v>
                </c:pt>
                <c:pt idx="2901">
                  <c:v>4.0293500232696466</c:v>
                </c:pt>
                <c:pt idx="2902">
                  <c:v>3.7926500844954987</c:v>
                </c:pt>
                <c:pt idx="2903">
                  <c:v>5.1409499597548987</c:v>
                </c:pt>
                <c:pt idx="2904">
                  <c:v>3.3345000219345522</c:v>
                </c:pt>
                <c:pt idx="2905">
                  <c:v>2.5703499221801991</c:v>
                </c:pt>
                <c:pt idx="2906">
                  <c:v>3.9959998512267987</c:v>
                </c:pt>
                <c:pt idx="2907">
                  <c:v>5.8426500129700045</c:v>
                </c:pt>
                <c:pt idx="2908">
                  <c:v>4.6372498750687043</c:v>
                </c:pt>
                <c:pt idx="2909">
                  <c:v>4.8508499717712539</c:v>
                </c:pt>
                <c:pt idx="2910">
                  <c:v>0.96894995212549873</c:v>
                </c:pt>
                <c:pt idx="2911">
                  <c:v>4.8483500385283982</c:v>
                </c:pt>
                <c:pt idx="2912">
                  <c:v>4.9759998941421486</c:v>
                </c:pt>
                <c:pt idx="2913">
                  <c:v>4.0210499334335488</c:v>
                </c:pt>
                <c:pt idx="2914">
                  <c:v>2.4997999858856019</c:v>
                </c:pt>
                <c:pt idx="2915">
                  <c:v>4.9102999448776501</c:v>
                </c:pt>
                <c:pt idx="2916">
                  <c:v>2.6479499244690032</c:v>
                </c:pt>
                <c:pt idx="2917">
                  <c:v>3.1130500555038516</c:v>
                </c:pt>
                <c:pt idx="2918">
                  <c:v>1.7921500253677465</c:v>
                </c:pt>
                <c:pt idx="2919">
                  <c:v>3.0966000366211475</c:v>
                </c:pt>
                <c:pt idx="2920">
                  <c:v>3.0403499650955013</c:v>
                </c:pt>
                <c:pt idx="2921">
                  <c:v>-1.2800998926162492</c:v>
                </c:pt>
                <c:pt idx="2922">
                  <c:v>4.2711000108718977</c:v>
                </c:pt>
                <c:pt idx="2923">
                  <c:v>4.8495000123977476</c:v>
                </c:pt>
                <c:pt idx="2924">
                  <c:v>0.46449983596805211</c:v>
                </c:pt>
                <c:pt idx="2925">
                  <c:v>4.6612499523162505</c:v>
                </c:pt>
                <c:pt idx="2926">
                  <c:v>3.6572500514984512</c:v>
                </c:pt>
                <c:pt idx="2927">
                  <c:v>5.0955998659134494</c:v>
                </c:pt>
                <c:pt idx="2928">
                  <c:v>2.4203999471664481</c:v>
                </c:pt>
                <c:pt idx="2929">
                  <c:v>1.3027999734878506</c:v>
                </c:pt>
                <c:pt idx="2930">
                  <c:v>3.1444999313354494</c:v>
                </c:pt>
                <c:pt idx="2931">
                  <c:v>5.9093499851226987</c:v>
                </c:pt>
                <c:pt idx="2932">
                  <c:v>3.7462000989913982</c:v>
                </c:pt>
                <c:pt idx="2933">
                  <c:v>5.1683498382568018</c:v>
                </c:pt>
                <c:pt idx="2934">
                  <c:v>5.7677499675751029</c:v>
                </c:pt>
                <c:pt idx="2935">
                  <c:v>6.9745999145507511</c:v>
                </c:pt>
                <c:pt idx="2936">
                  <c:v>3.1412999582290482</c:v>
                </c:pt>
                <c:pt idx="2937">
                  <c:v>3.5547499752044516</c:v>
                </c:pt>
                <c:pt idx="2938">
                  <c:v>2.517850017547552</c:v>
                </c:pt>
                <c:pt idx="2939">
                  <c:v>1.9792500782012468</c:v>
                </c:pt>
                <c:pt idx="2940">
                  <c:v>4.4653499507904044</c:v>
                </c:pt>
                <c:pt idx="2941">
                  <c:v>4.2908000087738003</c:v>
                </c:pt>
                <c:pt idx="2942">
                  <c:v>4.5562000274658487</c:v>
                </c:pt>
                <c:pt idx="2943">
                  <c:v>2.4606499481201496</c:v>
                </c:pt>
                <c:pt idx="2944">
                  <c:v>2.2481999826431505</c:v>
                </c:pt>
                <c:pt idx="2945">
                  <c:v>4.1910501003264997</c:v>
                </c:pt>
                <c:pt idx="2946">
                  <c:v>3.979949936866749</c:v>
                </c:pt>
                <c:pt idx="2947">
                  <c:v>4.2985999011992995</c:v>
                </c:pt>
                <c:pt idx="2948">
                  <c:v>4.9436499214172507</c:v>
                </c:pt>
                <c:pt idx="2949">
                  <c:v>3.5718999719619511</c:v>
                </c:pt>
                <c:pt idx="2950">
                  <c:v>1.6872999048232984</c:v>
                </c:pt>
                <c:pt idx="2951">
                  <c:v>5.2497499036788469</c:v>
                </c:pt>
                <c:pt idx="2952">
                  <c:v>6.1520999193191521</c:v>
                </c:pt>
                <c:pt idx="2953">
                  <c:v>0.88900002956395241</c:v>
                </c:pt>
                <c:pt idx="2954">
                  <c:v>5.0430000305175504</c:v>
                </c:pt>
                <c:pt idx="2955">
                  <c:v>2.5768500280380024</c:v>
                </c:pt>
                <c:pt idx="2956">
                  <c:v>5.6953001070022466</c:v>
                </c:pt>
                <c:pt idx="2957">
                  <c:v>4.4619999027252533</c:v>
                </c:pt>
                <c:pt idx="2958">
                  <c:v>3.6535000610352029</c:v>
                </c:pt>
                <c:pt idx="2959">
                  <c:v>2.1316499137878502</c:v>
                </c:pt>
                <c:pt idx="2960">
                  <c:v>2.4192499637604001</c:v>
                </c:pt>
                <c:pt idx="2961">
                  <c:v>4.9611999225617005</c:v>
                </c:pt>
                <c:pt idx="2962">
                  <c:v>2.5404500007629522</c:v>
                </c:pt>
                <c:pt idx="2963">
                  <c:v>4.2901500558853485</c:v>
                </c:pt>
                <c:pt idx="2964">
                  <c:v>4.8897501134872492</c:v>
                </c:pt>
                <c:pt idx="2965">
                  <c:v>3.2810499525069972</c:v>
                </c:pt>
                <c:pt idx="2966">
                  <c:v>6.2728999948501496</c:v>
                </c:pt>
                <c:pt idx="2967">
                  <c:v>3.5748998928069469</c:v>
                </c:pt>
                <c:pt idx="2968">
                  <c:v>5.5601000070571445</c:v>
                </c:pt>
                <c:pt idx="2969">
                  <c:v>4.859249820709298</c:v>
                </c:pt>
                <c:pt idx="2970">
                  <c:v>2.8565500307082985</c:v>
                </c:pt>
                <c:pt idx="2971">
                  <c:v>0.70055003643039981</c:v>
                </c:pt>
                <c:pt idx="2972">
                  <c:v>2.2382999348640524</c:v>
                </c:pt>
                <c:pt idx="2973">
                  <c:v>1.8112001085281015</c:v>
                </c:pt>
                <c:pt idx="2974">
                  <c:v>2.8871999597549483</c:v>
                </c:pt>
                <c:pt idx="2975">
                  <c:v>-1.153799986839303</c:v>
                </c:pt>
                <c:pt idx="2976">
                  <c:v>3.8932500028610484</c:v>
                </c:pt>
                <c:pt idx="2977">
                  <c:v>2.5934999847412499</c:v>
                </c:pt>
                <c:pt idx="2978">
                  <c:v>5.2356499910354515</c:v>
                </c:pt>
                <c:pt idx="2979">
                  <c:v>6.8093000125885013</c:v>
                </c:pt>
                <c:pt idx="2980">
                  <c:v>3.6725499677658</c:v>
                </c:pt>
                <c:pt idx="2981">
                  <c:v>4.7080498933792008</c:v>
                </c:pt>
                <c:pt idx="2982">
                  <c:v>3.8468499660491489</c:v>
                </c:pt>
                <c:pt idx="2983">
                  <c:v>1.7169999551773003</c:v>
                </c:pt>
                <c:pt idx="2984">
                  <c:v>1.9936499118805493</c:v>
                </c:pt>
                <c:pt idx="2985">
                  <c:v>3.0483998966217491</c:v>
                </c:pt>
                <c:pt idx="2986">
                  <c:v>0.63045001983645221</c:v>
                </c:pt>
                <c:pt idx="2987">
                  <c:v>3.0801999616622986</c:v>
                </c:pt>
                <c:pt idx="2988">
                  <c:v>6.1794000530242954</c:v>
                </c:pt>
                <c:pt idx="2989">
                  <c:v>2.5479499864578479</c:v>
                </c:pt>
                <c:pt idx="2990">
                  <c:v>-0.47315001010894875</c:v>
                </c:pt>
                <c:pt idx="2991">
                  <c:v>3.2208998203277517</c:v>
                </c:pt>
                <c:pt idx="2992">
                  <c:v>4.1641999864578523</c:v>
                </c:pt>
                <c:pt idx="2993">
                  <c:v>1.9162999296188516</c:v>
                </c:pt>
                <c:pt idx="2994">
                  <c:v>3.6550498819351027</c:v>
                </c:pt>
                <c:pt idx="2995">
                  <c:v>4.2105000162124497</c:v>
                </c:pt>
                <c:pt idx="2996">
                  <c:v>3.6424999618530016</c:v>
                </c:pt>
                <c:pt idx="2997">
                  <c:v>4.4802001070976516</c:v>
                </c:pt>
                <c:pt idx="2998">
                  <c:v>3.2894499540329534</c:v>
                </c:pt>
                <c:pt idx="2999">
                  <c:v>3.0474000787734994</c:v>
                </c:pt>
                <c:pt idx="3000">
                  <c:v>4.6884000253677023</c:v>
                </c:pt>
                <c:pt idx="3001">
                  <c:v>3.3871499156951508</c:v>
                </c:pt>
                <c:pt idx="3002">
                  <c:v>2.6463001346588015</c:v>
                </c:pt>
                <c:pt idx="3003">
                  <c:v>2.6213499402999503</c:v>
                </c:pt>
                <c:pt idx="3004">
                  <c:v>4.1907999372482507</c:v>
                </c:pt>
                <c:pt idx="3005">
                  <c:v>4.6151999568938997</c:v>
                </c:pt>
                <c:pt idx="3006">
                  <c:v>4.4417999935150014</c:v>
                </c:pt>
                <c:pt idx="3007">
                  <c:v>2.4888001346588027</c:v>
                </c:pt>
                <c:pt idx="3008">
                  <c:v>4.4338999605179019</c:v>
                </c:pt>
                <c:pt idx="3009">
                  <c:v>3.8945998859405968</c:v>
                </c:pt>
                <c:pt idx="3010">
                  <c:v>1.6487500047683525</c:v>
                </c:pt>
                <c:pt idx="3011">
                  <c:v>4.0643999290467008</c:v>
                </c:pt>
                <c:pt idx="3012">
                  <c:v>1.7205000734330014</c:v>
                </c:pt>
                <c:pt idx="3013">
                  <c:v>3.7162998819351003</c:v>
                </c:pt>
                <c:pt idx="3014">
                  <c:v>3.0216000127791993</c:v>
                </c:pt>
                <c:pt idx="3015">
                  <c:v>3.6717501211166024</c:v>
                </c:pt>
                <c:pt idx="3016">
                  <c:v>4.4009999704360538</c:v>
                </c:pt>
                <c:pt idx="3017">
                  <c:v>3.3847999429702469</c:v>
                </c:pt>
                <c:pt idx="3018">
                  <c:v>4.463499922752451</c:v>
                </c:pt>
                <c:pt idx="3019">
                  <c:v>4.3174000310898002</c:v>
                </c:pt>
                <c:pt idx="3020">
                  <c:v>5.3084999895096026</c:v>
                </c:pt>
                <c:pt idx="3021">
                  <c:v>3.2006999540329026</c:v>
                </c:pt>
                <c:pt idx="3022">
                  <c:v>3.2435999202728496</c:v>
                </c:pt>
                <c:pt idx="3023">
                  <c:v>3.1237999153136968</c:v>
                </c:pt>
                <c:pt idx="3024">
                  <c:v>2.4846500301360983</c:v>
                </c:pt>
                <c:pt idx="3025">
                  <c:v>3.5011000299453983</c:v>
                </c:pt>
                <c:pt idx="3026">
                  <c:v>5.128600020408598</c:v>
                </c:pt>
                <c:pt idx="3027">
                  <c:v>-1.5886998844146518</c:v>
                </c:pt>
                <c:pt idx="3028">
                  <c:v>5.068200073242199</c:v>
                </c:pt>
                <c:pt idx="3029">
                  <c:v>4.3980999064445498</c:v>
                </c:pt>
                <c:pt idx="3030">
                  <c:v>2.1170000457763472</c:v>
                </c:pt>
                <c:pt idx="3031">
                  <c:v>3.5881000471114994</c:v>
                </c:pt>
                <c:pt idx="3032">
                  <c:v>2.077399954795851</c:v>
                </c:pt>
                <c:pt idx="3033">
                  <c:v>2.9462999296187995</c:v>
                </c:pt>
                <c:pt idx="3034">
                  <c:v>1.6520999145507496</c:v>
                </c:pt>
                <c:pt idx="3035">
                  <c:v>3.9722499918938006</c:v>
                </c:pt>
                <c:pt idx="3036">
                  <c:v>5.7136999368667531</c:v>
                </c:pt>
                <c:pt idx="3037">
                  <c:v>5.5097499513625969</c:v>
                </c:pt>
                <c:pt idx="3038">
                  <c:v>6.1523999452590985</c:v>
                </c:pt>
                <c:pt idx="3039">
                  <c:v>7.9555499768256972</c:v>
                </c:pt>
                <c:pt idx="3040">
                  <c:v>3.5729500150680487</c:v>
                </c:pt>
                <c:pt idx="3041">
                  <c:v>-3.1350999355316027</c:v>
                </c:pt>
                <c:pt idx="3042">
                  <c:v>3.270349950790397</c:v>
                </c:pt>
                <c:pt idx="3043">
                  <c:v>0.76604999065404655</c:v>
                </c:pt>
                <c:pt idx="3044">
                  <c:v>4.1254498910903479</c:v>
                </c:pt>
                <c:pt idx="3045">
                  <c:v>2.8784001159668016</c:v>
                </c:pt>
                <c:pt idx="3046">
                  <c:v>4.4112002182007473</c:v>
                </c:pt>
                <c:pt idx="3047">
                  <c:v>5.1073498725891007</c:v>
                </c:pt>
                <c:pt idx="3048">
                  <c:v>4.2756500625610485</c:v>
                </c:pt>
                <c:pt idx="3049">
                  <c:v>-0.92070006370545343</c:v>
                </c:pt>
                <c:pt idx="3050">
                  <c:v>0.39935006618500068</c:v>
                </c:pt>
                <c:pt idx="3051">
                  <c:v>1.441950163841252</c:v>
                </c:pt>
                <c:pt idx="3052">
                  <c:v>3.5686001157760998</c:v>
                </c:pt>
                <c:pt idx="3053">
                  <c:v>3.4884000158310009</c:v>
                </c:pt>
                <c:pt idx="3054">
                  <c:v>1.6778999853133953</c:v>
                </c:pt>
                <c:pt idx="3055">
                  <c:v>3.1449999046325985</c:v>
                </c:pt>
                <c:pt idx="3056">
                  <c:v>4.8844999647140455</c:v>
                </c:pt>
                <c:pt idx="3057">
                  <c:v>1.744799957275351</c:v>
                </c:pt>
                <c:pt idx="3058">
                  <c:v>4.3570499944686496</c:v>
                </c:pt>
                <c:pt idx="3059">
                  <c:v>4.1799000358581466</c:v>
                </c:pt>
                <c:pt idx="3060">
                  <c:v>4.9415500402450476</c:v>
                </c:pt>
                <c:pt idx="3061">
                  <c:v>2.7160499811172514</c:v>
                </c:pt>
                <c:pt idx="3062">
                  <c:v>5.7408000135421986</c:v>
                </c:pt>
                <c:pt idx="3063">
                  <c:v>4.8574000263213968</c:v>
                </c:pt>
                <c:pt idx="3064">
                  <c:v>-2.16644995212555</c:v>
                </c:pt>
                <c:pt idx="3065">
                  <c:v>4.4061000442505005</c:v>
                </c:pt>
                <c:pt idx="3066">
                  <c:v>1.1097499275207028</c:v>
                </c:pt>
                <c:pt idx="3067">
                  <c:v>1.7518000984191495</c:v>
                </c:pt>
                <c:pt idx="3068">
                  <c:v>2.4786500453949003</c:v>
                </c:pt>
                <c:pt idx="3069">
                  <c:v>3.4525498390198024</c:v>
                </c:pt>
                <c:pt idx="3070">
                  <c:v>4.8131999969482031</c:v>
                </c:pt>
                <c:pt idx="3071">
                  <c:v>2.6277999162673993</c:v>
                </c:pt>
                <c:pt idx="3072">
                  <c:v>5.068000044822746</c:v>
                </c:pt>
                <c:pt idx="3073">
                  <c:v>6.4212999582290529</c:v>
                </c:pt>
                <c:pt idx="3074">
                  <c:v>1.521750092506398</c:v>
                </c:pt>
                <c:pt idx="3075">
                  <c:v>5.3825000095367486</c:v>
                </c:pt>
                <c:pt idx="3076">
                  <c:v>3.774149951934799</c:v>
                </c:pt>
                <c:pt idx="3077">
                  <c:v>3.9267001056671482</c:v>
                </c:pt>
                <c:pt idx="3078">
                  <c:v>1.5315999722480029</c:v>
                </c:pt>
                <c:pt idx="3079">
                  <c:v>5.2236500406264987</c:v>
                </c:pt>
                <c:pt idx="3080">
                  <c:v>3.8167500615119501</c:v>
                </c:pt>
                <c:pt idx="3081">
                  <c:v>2.9694499206542488</c:v>
                </c:pt>
                <c:pt idx="3082">
                  <c:v>3.8166999053954527</c:v>
                </c:pt>
                <c:pt idx="3083">
                  <c:v>3.3073500967025531</c:v>
                </c:pt>
                <c:pt idx="3084">
                  <c:v>-0.26704998493199739</c:v>
                </c:pt>
                <c:pt idx="3085">
                  <c:v>3.5480500316620009</c:v>
                </c:pt>
                <c:pt idx="3086">
                  <c:v>3.4983998250961506</c:v>
                </c:pt>
                <c:pt idx="3087">
                  <c:v>0.22445009708410169</c:v>
                </c:pt>
                <c:pt idx="3088">
                  <c:v>2.6267500114440487</c:v>
                </c:pt>
                <c:pt idx="3089">
                  <c:v>0.17125000476835339</c:v>
                </c:pt>
                <c:pt idx="3090">
                  <c:v>3.5364499044418487</c:v>
                </c:pt>
                <c:pt idx="3091">
                  <c:v>4.1313998985290539</c:v>
                </c:pt>
                <c:pt idx="3092">
                  <c:v>2.6615998697281498</c:v>
                </c:pt>
                <c:pt idx="3093">
                  <c:v>6.32019998550415</c:v>
                </c:pt>
                <c:pt idx="3094">
                  <c:v>4.0328999567031474</c:v>
                </c:pt>
                <c:pt idx="3095">
                  <c:v>3.4287999010085457</c:v>
                </c:pt>
                <c:pt idx="3096">
                  <c:v>4.6948500251770007</c:v>
                </c:pt>
                <c:pt idx="3097">
                  <c:v>3.2972000074387005</c:v>
                </c:pt>
                <c:pt idx="3098">
                  <c:v>2.8719000339507978</c:v>
                </c:pt>
                <c:pt idx="3099">
                  <c:v>1.930999908447248</c:v>
                </c:pt>
                <c:pt idx="3100">
                  <c:v>4.6306999945640506</c:v>
                </c:pt>
                <c:pt idx="3101">
                  <c:v>3.5853999948501496</c:v>
                </c:pt>
                <c:pt idx="3102">
                  <c:v>2.0049999475478515</c:v>
                </c:pt>
                <c:pt idx="3103">
                  <c:v>5.0559999608993529</c:v>
                </c:pt>
                <c:pt idx="3104">
                  <c:v>4.2796999073028488</c:v>
                </c:pt>
                <c:pt idx="3105">
                  <c:v>4.3142000579834487</c:v>
                </c:pt>
                <c:pt idx="3106">
                  <c:v>3.5983998870850016</c:v>
                </c:pt>
                <c:pt idx="3107">
                  <c:v>4.0368999481201513</c:v>
                </c:pt>
                <c:pt idx="3108">
                  <c:v>4.7411499357222979</c:v>
                </c:pt>
                <c:pt idx="3109">
                  <c:v>2.8589999294281014</c:v>
                </c:pt>
                <c:pt idx="3110">
                  <c:v>1.7851500844955517</c:v>
                </c:pt>
                <c:pt idx="3111">
                  <c:v>5.7893999147414981</c:v>
                </c:pt>
                <c:pt idx="3112">
                  <c:v>4.2971500110625982</c:v>
                </c:pt>
                <c:pt idx="3113">
                  <c:v>1.7230000233650493</c:v>
                </c:pt>
                <c:pt idx="3114">
                  <c:v>2.2237499284744473</c:v>
                </c:pt>
                <c:pt idx="3115">
                  <c:v>3.4187500143050542</c:v>
                </c:pt>
                <c:pt idx="3116">
                  <c:v>3.0976999568939014</c:v>
                </c:pt>
                <c:pt idx="3117">
                  <c:v>4.5397000169753525</c:v>
                </c:pt>
                <c:pt idx="3118">
                  <c:v>3.605350008010852</c:v>
                </c:pt>
                <c:pt idx="3119">
                  <c:v>3.649899911880496</c:v>
                </c:pt>
                <c:pt idx="3120">
                  <c:v>-0.59950004100799958</c:v>
                </c:pt>
                <c:pt idx="3121">
                  <c:v>1.8558500671386504</c:v>
                </c:pt>
                <c:pt idx="3122">
                  <c:v>1.3019999408722001</c:v>
                </c:pt>
                <c:pt idx="3123">
                  <c:v>3.2928500223159958</c:v>
                </c:pt>
                <c:pt idx="3124">
                  <c:v>2.0694001102447501</c:v>
                </c:pt>
                <c:pt idx="3125">
                  <c:v>2.8698500204085988</c:v>
                </c:pt>
                <c:pt idx="3126">
                  <c:v>4.792949914932251</c:v>
                </c:pt>
                <c:pt idx="3127">
                  <c:v>3.8538999867439543</c:v>
                </c:pt>
                <c:pt idx="3128">
                  <c:v>3.7953999471664481</c:v>
                </c:pt>
                <c:pt idx="3129">
                  <c:v>1.7056001329421981</c:v>
                </c:pt>
                <c:pt idx="3130">
                  <c:v>0.85589994907379818</c:v>
                </c:pt>
                <c:pt idx="3131">
                  <c:v>3.5849499511719003</c:v>
                </c:pt>
                <c:pt idx="3132">
                  <c:v>5.4790999174118014</c:v>
                </c:pt>
                <c:pt idx="3133">
                  <c:v>5.2207500267028983</c:v>
                </c:pt>
                <c:pt idx="3134">
                  <c:v>4.3055497932434008</c:v>
                </c:pt>
                <c:pt idx="3135">
                  <c:v>3.4410500144959002</c:v>
                </c:pt>
                <c:pt idx="3136">
                  <c:v>2.2829500412940504</c:v>
                </c:pt>
                <c:pt idx="3137">
                  <c:v>4.9958998537064012</c:v>
                </c:pt>
                <c:pt idx="3138">
                  <c:v>4.2039499998092538</c:v>
                </c:pt>
                <c:pt idx="3139">
                  <c:v>3.9531499576569047</c:v>
                </c:pt>
                <c:pt idx="3140">
                  <c:v>3.2657499456405503</c:v>
                </c:pt>
                <c:pt idx="3141">
                  <c:v>3.5463999366760497</c:v>
                </c:pt>
                <c:pt idx="3142">
                  <c:v>1.4823500299454011</c:v>
                </c:pt>
                <c:pt idx="3143">
                  <c:v>1.4115999794005987</c:v>
                </c:pt>
                <c:pt idx="3144">
                  <c:v>2.8457500219344993</c:v>
                </c:pt>
                <c:pt idx="3145">
                  <c:v>4.443249902725249</c:v>
                </c:pt>
                <c:pt idx="3146">
                  <c:v>3.5287999010086004</c:v>
                </c:pt>
                <c:pt idx="3147">
                  <c:v>2.0644000911712972</c:v>
                </c:pt>
                <c:pt idx="3148">
                  <c:v>4.0339500188827486</c:v>
                </c:pt>
                <c:pt idx="3149">
                  <c:v>2.2309498691559</c:v>
                </c:pt>
                <c:pt idx="3150">
                  <c:v>1.2364999246597037</c:v>
                </c:pt>
                <c:pt idx="3151">
                  <c:v>2.322100005149899</c:v>
                </c:pt>
                <c:pt idx="3152">
                  <c:v>3.2703998851775999</c:v>
                </c:pt>
                <c:pt idx="3153">
                  <c:v>5.9658000946045</c:v>
                </c:pt>
                <c:pt idx="3154">
                  <c:v>3.7628998899459525</c:v>
                </c:pt>
                <c:pt idx="3155">
                  <c:v>2.411099963188196</c:v>
                </c:pt>
                <c:pt idx="3156">
                  <c:v>4.2388998794555519</c:v>
                </c:pt>
                <c:pt idx="3157">
                  <c:v>4.5583000183105469</c:v>
                </c:pt>
                <c:pt idx="3158">
                  <c:v>3.2963499212264509</c:v>
                </c:pt>
                <c:pt idx="3159">
                  <c:v>5.2053499460220465</c:v>
                </c:pt>
                <c:pt idx="3160">
                  <c:v>3.1956499671936491</c:v>
                </c:pt>
                <c:pt idx="3161">
                  <c:v>3.7609499788283998</c:v>
                </c:pt>
                <c:pt idx="3162">
                  <c:v>3.3852999877929015</c:v>
                </c:pt>
                <c:pt idx="3163">
                  <c:v>3.5872498798369996</c:v>
                </c:pt>
                <c:pt idx="3164">
                  <c:v>4.4960000467299999</c:v>
                </c:pt>
                <c:pt idx="3165">
                  <c:v>4.0993500471114999</c:v>
                </c:pt>
                <c:pt idx="3166">
                  <c:v>2.7392000913619974</c:v>
                </c:pt>
                <c:pt idx="3167">
                  <c:v>4.680299916267451</c:v>
                </c:pt>
                <c:pt idx="3168">
                  <c:v>5.0773000001907498</c:v>
                </c:pt>
                <c:pt idx="3169">
                  <c:v>-0.2098500537871999</c:v>
                </c:pt>
                <c:pt idx="3170">
                  <c:v>5.2127000474930014</c:v>
                </c:pt>
                <c:pt idx="3171">
                  <c:v>4.3471500062941999</c:v>
                </c:pt>
                <c:pt idx="3172">
                  <c:v>2.0880499649048012</c:v>
                </c:pt>
                <c:pt idx="3173">
                  <c:v>4.1859498643875028</c:v>
                </c:pt>
                <c:pt idx="3174">
                  <c:v>0.31694993734360111</c:v>
                </c:pt>
                <c:pt idx="3175">
                  <c:v>4.2977000141143975</c:v>
                </c:pt>
                <c:pt idx="3176">
                  <c:v>3.0270499706268517</c:v>
                </c:pt>
                <c:pt idx="3177">
                  <c:v>-0.10655002117155021</c:v>
                </c:pt>
                <c:pt idx="3178">
                  <c:v>1.6800999927521012</c:v>
                </c:pt>
                <c:pt idx="3179">
                  <c:v>3.5542999124527519</c:v>
                </c:pt>
                <c:pt idx="3180">
                  <c:v>5.0122501134872515</c:v>
                </c:pt>
                <c:pt idx="3181">
                  <c:v>4.0009499216079476</c:v>
                </c:pt>
                <c:pt idx="3182">
                  <c:v>1.9855000019072975</c:v>
                </c:pt>
                <c:pt idx="3183">
                  <c:v>4.1542999792098954</c:v>
                </c:pt>
                <c:pt idx="3184">
                  <c:v>4.372399959564202</c:v>
                </c:pt>
                <c:pt idx="3185">
                  <c:v>3.8461499357223019</c:v>
                </c:pt>
                <c:pt idx="3186">
                  <c:v>3.3765999412536516</c:v>
                </c:pt>
                <c:pt idx="3187">
                  <c:v>2.2388499927520975</c:v>
                </c:pt>
                <c:pt idx="3188">
                  <c:v>2.3201999807358007</c:v>
                </c:pt>
                <c:pt idx="3189">
                  <c:v>2.011100006103554</c:v>
                </c:pt>
                <c:pt idx="3190">
                  <c:v>1.416049871444649</c:v>
                </c:pt>
                <c:pt idx="3191">
                  <c:v>3.7463500595092469</c:v>
                </c:pt>
                <c:pt idx="3192">
                  <c:v>3.9516499471664019</c:v>
                </c:pt>
                <c:pt idx="3193">
                  <c:v>1.4656499242782495</c:v>
                </c:pt>
                <c:pt idx="3194">
                  <c:v>3.4464999723434531</c:v>
                </c:pt>
                <c:pt idx="3195">
                  <c:v>1.7567500543594008</c:v>
                </c:pt>
                <c:pt idx="3196">
                  <c:v>1.5593499660492043</c:v>
                </c:pt>
                <c:pt idx="3197">
                  <c:v>3.0883999681472467</c:v>
                </c:pt>
                <c:pt idx="3198">
                  <c:v>2.0501500320435007</c:v>
                </c:pt>
                <c:pt idx="3199">
                  <c:v>-4.2699961662250985E-2</c:v>
                </c:pt>
                <c:pt idx="3200">
                  <c:v>2.844649987220798</c:v>
                </c:pt>
                <c:pt idx="3201">
                  <c:v>4.2345498871803002</c:v>
                </c:pt>
                <c:pt idx="3202">
                  <c:v>3.5456999635696498</c:v>
                </c:pt>
                <c:pt idx="3203">
                  <c:v>1.985000004768402</c:v>
                </c:pt>
                <c:pt idx="3204">
                  <c:v>4.1019000482558994</c:v>
                </c:pt>
                <c:pt idx="3205">
                  <c:v>-1.0772500085830501</c:v>
                </c:pt>
                <c:pt idx="3206">
                  <c:v>5.0613499307632495</c:v>
                </c:pt>
                <c:pt idx="3207">
                  <c:v>3.9254000186919988</c:v>
                </c:pt>
                <c:pt idx="3208">
                  <c:v>4.4514499568939527</c:v>
                </c:pt>
                <c:pt idx="3209">
                  <c:v>4.2380500030517503</c:v>
                </c:pt>
                <c:pt idx="3210">
                  <c:v>3.9217999625205522</c:v>
                </c:pt>
                <c:pt idx="3211">
                  <c:v>4.3912999248504505</c:v>
                </c:pt>
                <c:pt idx="3212">
                  <c:v>4.1064000034332508</c:v>
                </c:pt>
                <c:pt idx="3213">
                  <c:v>0.70715004920960212</c:v>
                </c:pt>
                <c:pt idx="3214">
                  <c:v>4.4264499044418031</c:v>
                </c:pt>
                <c:pt idx="3215">
                  <c:v>5.0598499059677522</c:v>
                </c:pt>
                <c:pt idx="3216">
                  <c:v>0.38330001354215071</c:v>
                </c:pt>
                <c:pt idx="3217">
                  <c:v>3.3984499311446967</c:v>
                </c:pt>
                <c:pt idx="3218">
                  <c:v>4.5637500524520505</c:v>
                </c:pt>
                <c:pt idx="3219">
                  <c:v>1.7553499698639001</c:v>
                </c:pt>
                <c:pt idx="3220">
                  <c:v>4.6817999887466506</c:v>
                </c:pt>
                <c:pt idx="3221">
                  <c:v>4.0328000926971512</c:v>
                </c:pt>
                <c:pt idx="3222">
                  <c:v>6.930004596710404E-2</c:v>
                </c:pt>
                <c:pt idx="3223">
                  <c:v>5.2703499364852959</c:v>
                </c:pt>
                <c:pt idx="3224">
                  <c:v>3.6164499807358013</c:v>
                </c:pt>
                <c:pt idx="3225">
                  <c:v>4.0099498605728456</c:v>
                </c:pt>
                <c:pt idx="3226">
                  <c:v>2.4879000377655025</c:v>
                </c:pt>
                <c:pt idx="3227">
                  <c:v>2.8466999340056987</c:v>
                </c:pt>
                <c:pt idx="3228">
                  <c:v>2.6816000270843467</c:v>
                </c:pt>
                <c:pt idx="3229">
                  <c:v>2.1187499809265482</c:v>
                </c:pt>
                <c:pt idx="3230">
                  <c:v>3.2637999725341977</c:v>
                </c:pt>
                <c:pt idx="3231">
                  <c:v>2.9811500501633006</c:v>
                </c:pt>
                <c:pt idx="3232">
                  <c:v>4.9601501083373982</c:v>
                </c:pt>
                <c:pt idx="3233">
                  <c:v>3.9069498896598986</c:v>
                </c:pt>
                <c:pt idx="3234">
                  <c:v>2.4972999525070492</c:v>
                </c:pt>
                <c:pt idx="3235">
                  <c:v>3.7335499310493461</c:v>
                </c:pt>
                <c:pt idx="3236">
                  <c:v>0.93785003185269744</c:v>
                </c:pt>
                <c:pt idx="3237">
                  <c:v>3.969299836158747</c:v>
                </c:pt>
                <c:pt idx="3238">
                  <c:v>1.6077999734878503</c:v>
                </c:pt>
                <c:pt idx="3239">
                  <c:v>1.8407499551773014</c:v>
                </c:pt>
                <c:pt idx="3240">
                  <c:v>4.6927999782562537</c:v>
                </c:pt>
                <c:pt idx="3241">
                  <c:v>2.6201499032973992</c:v>
                </c:pt>
                <c:pt idx="3242">
                  <c:v>3.3650499963760012</c:v>
                </c:pt>
                <c:pt idx="3243">
                  <c:v>2.1451999425887998</c:v>
                </c:pt>
                <c:pt idx="3244">
                  <c:v>2.11934997320175</c:v>
                </c:pt>
                <c:pt idx="3245">
                  <c:v>3.443049893379154</c:v>
                </c:pt>
                <c:pt idx="3246">
                  <c:v>4.5859500312805004</c:v>
                </c:pt>
                <c:pt idx="3247">
                  <c:v>3.6153499221802505</c:v>
                </c:pt>
                <c:pt idx="3248">
                  <c:v>3.0894500160217007</c:v>
                </c:pt>
                <c:pt idx="3249">
                  <c:v>2.8799001216887987</c:v>
                </c:pt>
                <c:pt idx="3250">
                  <c:v>2.8224499702453514</c:v>
                </c:pt>
                <c:pt idx="3251">
                  <c:v>0.79389998912814974</c:v>
                </c:pt>
                <c:pt idx="3252">
                  <c:v>0.75269993305204963</c:v>
                </c:pt>
                <c:pt idx="3253">
                  <c:v>5.4991499137878499</c:v>
                </c:pt>
                <c:pt idx="3254">
                  <c:v>3.187899918556198</c:v>
                </c:pt>
                <c:pt idx="3255">
                  <c:v>-0.79580001831055114</c:v>
                </c:pt>
                <c:pt idx="3256">
                  <c:v>2.7616499280929503</c:v>
                </c:pt>
                <c:pt idx="3257">
                  <c:v>3.7377500295638981</c:v>
                </c:pt>
                <c:pt idx="3258">
                  <c:v>2.7061499929427484</c:v>
                </c:pt>
                <c:pt idx="3259">
                  <c:v>3.9180000448227048</c:v>
                </c:pt>
                <c:pt idx="3260">
                  <c:v>-1.2164999246597006</c:v>
                </c:pt>
                <c:pt idx="3261">
                  <c:v>3.7547000670433519</c:v>
                </c:pt>
                <c:pt idx="3262">
                  <c:v>1.3911501789092497</c:v>
                </c:pt>
                <c:pt idx="3263">
                  <c:v>0.79070001602169881</c:v>
                </c:pt>
                <c:pt idx="3264">
                  <c:v>3.1085500001907462</c:v>
                </c:pt>
                <c:pt idx="3265">
                  <c:v>2.5853498744965009</c:v>
                </c:pt>
                <c:pt idx="3266">
                  <c:v>8.4699954986600545E-2</c:v>
                </c:pt>
                <c:pt idx="3267">
                  <c:v>3.69554994106295</c:v>
                </c:pt>
                <c:pt idx="3268">
                  <c:v>4.633749985694898</c:v>
                </c:pt>
                <c:pt idx="3269">
                  <c:v>2.6626500749588011</c:v>
                </c:pt>
                <c:pt idx="3270">
                  <c:v>3.9677999401092521</c:v>
                </c:pt>
                <c:pt idx="3271">
                  <c:v>1.5808000183105975</c:v>
                </c:pt>
                <c:pt idx="3272">
                  <c:v>2.6482999038696491</c:v>
                </c:pt>
                <c:pt idx="3273">
                  <c:v>0.3571499633789017</c:v>
                </c:pt>
                <c:pt idx="3274">
                  <c:v>5.3304500102996997</c:v>
                </c:pt>
                <c:pt idx="3275">
                  <c:v>-1.3895001077651514</c:v>
                </c:pt>
                <c:pt idx="3276">
                  <c:v>3.0901999664306992</c:v>
                </c:pt>
                <c:pt idx="3277">
                  <c:v>4.3747999906539974</c:v>
                </c:pt>
                <c:pt idx="3278">
                  <c:v>3.3266999816894014</c:v>
                </c:pt>
                <c:pt idx="3279">
                  <c:v>3.82280003547665</c:v>
                </c:pt>
                <c:pt idx="3280">
                  <c:v>2.5611500263213998</c:v>
                </c:pt>
                <c:pt idx="3281">
                  <c:v>3.5134499311447023</c:v>
                </c:pt>
                <c:pt idx="3282">
                  <c:v>-0.81549992084504908</c:v>
                </c:pt>
                <c:pt idx="3283">
                  <c:v>1.4769000339507983</c:v>
                </c:pt>
                <c:pt idx="3284">
                  <c:v>1.8954000568390015</c:v>
                </c:pt>
                <c:pt idx="3285">
                  <c:v>1.770999970436101</c:v>
                </c:pt>
                <c:pt idx="3286">
                  <c:v>5.3495500612258979</c:v>
                </c:pt>
                <c:pt idx="3287">
                  <c:v>2.791099991798351</c:v>
                </c:pt>
                <c:pt idx="3288">
                  <c:v>2.2067999982833513</c:v>
                </c:pt>
                <c:pt idx="3289">
                  <c:v>4.0349499225615979</c:v>
                </c:pt>
                <c:pt idx="3290">
                  <c:v>3.6443500328064005</c:v>
                </c:pt>
                <c:pt idx="3291">
                  <c:v>4.2215499091148487</c:v>
                </c:pt>
                <c:pt idx="3292">
                  <c:v>4.8886998939514505</c:v>
                </c:pt>
                <c:pt idx="3293">
                  <c:v>3.1827999782562024</c:v>
                </c:pt>
                <c:pt idx="3294">
                  <c:v>3.1443999433517007</c:v>
                </c:pt>
                <c:pt idx="3295">
                  <c:v>1.3002500581741501</c:v>
                </c:pt>
                <c:pt idx="3296">
                  <c:v>3.4381500244140497</c:v>
                </c:pt>
                <c:pt idx="3297">
                  <c:v>2.2579001808166517</c:v>
                </c:pt>
                <c:pt idx="3298">
                  <c:v>1.8333000040054515</c:v>
                </c:pt>
                <c:pt idx="3299">
                  <c:v>4.5770000028610021</c:v>
                </c:pt>
                <c:pt idx="3300">
                  <c:v>5.0677500200271481</c:v>
                </c:pt>
                <c:pt idx="3301">
                  <c:v>2.8784999704360494</c:v>
                </c:pt>
                <c:pt idx="3302">
                  <c:v>1.7897500514984017</c:v>
                </c:pt>
                <c:pt idx="3303">
                  <c:v>4.2099000263213497</c:v>
                </c:pt>
                <c:pt idx="3304">
                  <c:v>4.1176000738144012</c:v>
                </c:pt>
                <c:pt idx="3305">
                  <c:v>5.013249893188501</c:v>
                </c:pt>
                <c:pt idx="3306">
                  <c:v>2.2532499265670474</c:v>
                </c:pt>
                <c:pt idx="3307">
                  <c:v>5.7214500808716515</c:v>
                </c:pt>
                <c:pt idx="3308">
                  <c:v>3.6002499198913043</c:v>
                </c:pt>
                <c:pt idx="3309">
                  <c:v>4.3866000509262513</c:v>
                </c:pt>
                <c:pt idx="3310">
                  <c:v>1.8829999113082501</c:v>
                </c:pt>
                <c:pt idx="3311">
                  <c:v>5.1182001352309996</c:v>
                </c:pt>
                <c:pt idx="3312">
                  <c:v>0.42555002212525039</c:v>
                </c:pt>
                <c:pt idx="3313">
                  <c:v>5.4857500219344999</c:v>
                </c:pt>
                <c:pt idx="3314">
                  <c:v>5.4857500219344999</c:v>
                </c:pt>
                <c:pt idx="3315">
                  <c:v>2.9971000003814012</c:v>
                </c:pt>
                <c:pt idx="3316">
                  <c:v>1.6132500028609975</c:v>
                </c:pt>
                <c:pt idx="3317">
                  <c:v>-0.47544986248015064</c:v>
                </c:pt>
                <c:pt idx="3318">
                  <c:v>5.8458499574661005</c:v>
                </c:pt>
                <c:pt idx="3319">
                  <c:v>7.2986999511719013</c:v>
                </c:pt>
                <c:pt idx="3320">
                  <c:v>2.8549001169204509</c:v>
                </c:pt>
                <c:pt idx="3321">
                  <c:v>3.0153499412536462</c:v>
                </c:pt>
                <c:pt idx="3322">
                  <c:v>1.2028999137878458</c:v>
                </c:pt>
                <c:pt idx="3323">
                  <c:v>3.5305499219894543</c:v>
                </c:pt>
                <c:pt idx="3324">
                  <c:v>2.6207000732421974</c:v>
                </c:pt>
                <c:pt idx="3325">
                  <c:v>2.7011999320983975</c:v>
                </c:pt>
                <c:pt idx="3326">
                  <c:v>2.7848500490188535</c:v>
                </c:pt>
                <c:pt idx="3327">
                  <c:v>2.7933999919891477</c:v>
                </c:pt>
                <c:pt idx="3328">
                  <c:v>4.0458000946044947</c:v>
                </c:pt>
                <c:pt idx="3329">
                  <c:v>4.7276999616622497</c:v>
                </c:pt>
                <c:pt idx="3330">
                  <c:v>1.3156502008438018</c:v>
                </c:pt>
                <c:pt idx="3331">
                  <c:v>0.76800002098084974</c:v>
                </c:pt>
                <c:pt idx="3332">
                  <c:v>3.1346500134468016</c:v>
                </c:pt>
                <c:pt idx="3333">
                  <c:v>2.3797498846054488</c:v>
                </c:pt>
                <c:pt idx="3334">
                  <c:v>2.4737499713898004</c:v>
                </c:pt>
                <c:pt idx="3335">
                  <c:v>4.026150007247896</c:v>
                </c:pt>
                <c:pt idx="3336">
                  <c:v>3.3814999580384004</c:v>
                </c:pt>
                <c:pt idx="3337">
                  <c:v>2.4917999553679984</c:v>
                </c:pt>
                <c:pt idx="3338">
                  <c:v>1.5053498888016037</c:v>
                </c:pt>
                <c:pt idx="3339">
                  <c:v>0.79209999084469729</c:v>
                </c:pt>
                <c:pt idx="3340">
                  <c:v>2.5536499738692982</c:v>
                </c:pt>
                <c:pt idx="3341">
                  <c:v>4.1413499450683524</c:v>
                </c:pt>
                <c:pt idx="3342">
                  <c:v>1.8565999364853489</c:v>
                </c:pt>
                <c:pt idx="3343">
                  <c:v>4.2716500473022485</c:v>
                </c:pt>
                <c:pt idx="3344">
                  <c:v>4.9606000089645015</c:v>
                </c:pt>
                <c:pt idx="3345">
                  <c:v>1.9305999040603474</c:v>
                </c:pt>
                <c:pt idx="3346">
                  <c:v>2.4939499616623486</c:v>
                </c:pt>
                <c:pt idx="3347">
                  <c:v>1.6688499736786007</c:v>
                </c:pt>
                <c:pt idx="3348">
                  <c:v>0.78100016593935351</c:v>
                </c:pt>
                <c:pt idx="3349">
                  <c:v>3.9905499267578008</c:v>
                </c:pt>
                <c:pt idx="3350">
                  <c:v>5.4058999228477518</c:v>
                </c:pt>
                <c:pt idx="3351">
                  <c:v>2.3615000152588514</c:v>
                </c:pt>
                <c:pt idx="3352">
                  <c:v>4.1688499665260004</c:v>
                </c:pt>
                <c:pt idx="3353">
                  <c:v>2.7965000104903979</c:v>
                </c:pt>
                <c:pt idx="3354">
                  <c:v>3.5351500701904541</c:v>
                </c:pt>
                <c:pt idx="3355">
                  <c:v>3.8762498903274469</c:v>
                </c:pt>
                <c:pt idx="3356">
                  <c:v>0.80484993934629756</c:v>
                </c:pt>
                <c:pt idx="3357">
                  <c:v>1.2768500041960991</c:v>
                </c:pt>
                <c:pt idx="3358">
                  <c:v>4.4350499582291008</c:v>
                </c:pt>
                <c:pt idx="3359">
                  <c:v>5.4556000757217511</c:v>
                </c:pt>
                <c:pt idx="3360">
                  <c:v>1.133049936294551</c:v>
                </c:pt>
                <c:pt idx="3361">
                  <c:v>2.4061999177933018</c:v>
                </c:pt>
                <c:pt idx="3362">
                  <c:v>1.2573500394821515</c:v>
                </c:pt>
                <c:pt idx="3363">
                  <c:v>1.8393499755859999</c:v>
                </c:pt>
                <c:pt idx="3364">
                  <c:v>3.441150012016351</c:v>
                </c:pt>
                <c:pt idx="3365">
                  <c:v>1.8627001047135003</c:v>
                </c:pt>
                <c:pt idx="3366">
                  <c:v>5.713650004863748</c:v>
                </c:pt>
                <c:pt idx="3367">
                  <c:v>4.1314499759674028</c:v>
                </c:pt>
                <c:pt idx="3368">
                  <c:v>1.3962000370025507</c:v>
                </c:pt>
                <c:pt idx="3369">
                  <c:v>5.0129499721527466</c:v>
                </c:pt>
                <c:pt idx="3370">
                  <c:v>2.7013000392914002</c:v>
                </c:pt>
                <c:pt idx="3371">
                  <c:v>4.254199998378752</c:v>
                </c:pt>
                <c:pt idx="3372">
                  <c:v>4.0854000854492512</c:v>
                </c:pt>
                <c:pt idx="3373">
                  <c:v>4.1080998945236509</c:v>
                </c:pt>
                <c:pt idx="3374">
                  <c:v>1.8516999578476501</c:v>
                </c:pt>
                <c:pt idx="3375">
                  <c:v>0.94764983177185158</c:v>
                </c:pt>
                <c:pt idx="3376">
                  <c:v>3.3963500118255503</c:v>
                </c:pt>
                <c:pt idx="3377">
                  <c:v>1.5369000148772969</c:v>
                </c:pt>
                <c:pt idx="3378">
                  <c:v>1.5415999460220036</c:v>
                </c:pt>
                <c:pt idx="3379">
                  <c:v>2.5113500118255487</c:v>
                </c:pt>
                <c:pt idx="3380">
                  <c:v>3.6117499065399521</c:v>
                </c:pt>
                <c:pt idx="3381">
                  <c:v>4.6344500160217024</c:v>
                </c:pt>
                <c:pt idx="3382">
                  <c:v>3.1333998632431488</c:v>
                </c:pt>
                <c:pt idx="3383">
                  <c:v>4.1413999557495025</c:v>
                </c:pt>
                <c:pt idx="3384">
                  <c:v>0.88689989089965238</c:v>
                </c:pt>
                <c:pt idx="3385">
                  <c:v>4.6216000461578481</c:v>
                </c:pt>
                <c:pt idx="3386">
                  <c:v>2.7605999183654504</c:v>
                </c:pt>
                <c:pt idx="3387">
                  <c:v>3.490949993133551</c:v>
                </c:pt>
                <c:pt idx="3388">
                  <c:v>1.9136499786377001</c:v>
                </c:pt>
                <c:pt idx="3389">
                  <c:v>4.6683499717712493</c:v>
                </c:pt>
                <c:pt idx="3390">
                  <c:v>5.8945999336242991</c:v>
                </c:pt>
                <c:pt idx="3391">
                  <c:v>3.9791498947144035</c:v>
                </c:pt>
                <c:pt idx="3392">
                  <c:v>4.659650058746351</c:v>
                </c:pt>
                <c:pt idx="3393">
                  <c:v>1.5617500019072992</c:v>
                </c:pt>
                <c:pt idx="3394">
                  <c:v>4.8998500347137011</c:v>
                </c:pt>
                <c:pt idx="3395">
                  <c:v>3.6914999580383494</c:v>
                </c:pt>
                <c:pt idx="3396">
                  <c:v>1.6109999275207478</c:v>
                </c:pt>
                <c:pt idx="3397">
                  <c:v>4.2838000059128021</c:v>
                </c:pt>
                <c:pt idx="3398">
                  <c:v>4.3402500009536524</c:v>
                </c:pt>
                <c:pt idx="3399">
                  <c:v>3.6678500652312991</c:v>
                </c:pt>
                <c:pt idx="3400">
                  <c:v>4.4457999086379978</c:v>
                </c:pt>
                <c:pt idx="3401">
                  <c:v>5.2189999866485479</c:v>
                </c:pt>
                <c:pt idx="3402">
                  <c:v>-0.10284999847405274</c:v>
                </c:pt>
                <c:pt idx="3403">
                  <c:v>4.2979500150680536</c:v>
                </c:pt>
                <c:pt idx="3404">
                  <c:v>2.5622499227523505</c:v>
                </c:pt>
                <c:pt idx="3405">
                  <c:v>3.9367999362945554</c:v>
                </c:pt>
                <c:pt idx="3406">
                  <c:v>0.78899997711184966</c:v>
                </c:pt>
                <c:pt idx="3407">
                  <c:v>2.9662499475478974</c:v>
                </c:pt>
                <c:pt idx="3408">
                  <c:v>7.0337500476837498</c:v>
                </c:pt>
                <c:pt idx="3409">
                  <c:v>3.3128500223160025</c:v>
                </c:pt>
                <c:pt idx="3410">
                  <c:v>3.4561999607086484</c:v>
                </c:pt>
                <c:pt idx="3411">
                  <c:v>2.9229999828338507</c:v>
                </c:pt>
                <c:pt idx="3412">
                  <c:v>2.9166500377654536</c:v>
                </c:pt>
                <c:pt idx="3413">
                  <c:v>1.6070999193191469</c:v>
                </c:pt>
                <c:pt idx="3414">
                  <c:v>1.6100499343871988</c:v>
                </c:pt>
                <c:pt idx="3415">
                  <c:v>2.2688999843597522</c:v>
                </c:pt>
                <c:pt idx="3416">
                  <c:v>1.7599999523163028</c:v>
                </c:pt>
                <c:pt idx="3417">
                  <c:v>3.5932998800278</c:v>
                </c:pt>
                <c:pt idx="3418">
                  <c:v>3.976200041770948</c:v>
                </c:pt>
                <c:pt idx="3419">
                  <c:v>3.4521499967575018</c:v>
                </c:pt>
                <c:pt idx="3420">
                  <c:v>-3.2101999998093014</c:v>
                </c:pt>
                <c:pt idx="3421">
                  <c:v>3.0646000051498525</c:v>
                </c:pt>
                <c:pt idx="3422">
                  <c:v>2.0468999719619987</c:v>
                </c:pt>
                <c:pt idx="3423">
                  <c:v>1.6811000156402507</c:v>
                </c:pt>
                <c:pt idx="3424">
                  <c:v>4.830099883079555</c:v>
                </c:pt>
                <c:pt idx="3425">
                  <c:v>1.9823499894141996</c:v>
                </c:pt>
                <c:pt idx="3426">
                  <c:v>2.9343499422072483</c:v>
                </c:pt>
                <c:pt idx="3427">
                  <c:v>3.1841001319885542</c:v>
                </c:pt>
                <c:pt idx="3428">
                  <c:v>1.6423499679565481</c:v>
                </c:pt>
                <c:pt idx="3429">
                  <c:v>4.6143499279021967</c:v>
                </c:pt>
                <c:pt idx="3430">
                  <c:v>3.0393999290465992</c:v>
                </c:pt>
                <c:pt idx="3431">
                  <c:v>-0.60625001907345322</c:v>
                </c:pt>
                <c:pt idx="3432">
                  <c:v>5.1732499456406025</c:v>
                </c:pt>
                <c:pt idx="3433">
                  <c:v>2.0583498620987015</c:v>
                </c:pt>
                <c:pt idx="3434">
                  <c:v>7.1018501567840495</c:v>
                </c:pt>
                <c:pt idx="3435">
                  <c:v>3.4816000604629984</c:v>
                </c:pt>
                <c:pt idx="3436">
                  <c:v>-0.48849999904635055</c:v>
                </c:pt>
                <c:pt idx="3437">
                  <c:v>3.2612999916076539</c:v>
                </c:pt>
                <c:pt idx="3438">
                  <c:v>3.8083999443054495</c:v>
                </c:pt>
                <c:pt idx="3439">
                  <c:v>4.9000500202178507</c:v>
                </c:pt>
                <c:pt idx="3440">
                  <c:v>3.382199864387502</c:v>
                </c:pt>
                <c:pt idx="3441">
                  <c:v>3.6997999763488494</c:v>
                </c:pt>
                <c:pt idx="3442">
                  <c:v>2.459949870109547</c:v>
                </c:pt>
                <c:pt idx="3443">
                  <c:v>1.9290499734878495</c:v>
                </c:pt>
                <c:pt idx="3444">
                  <c:v>5.2662500286102514</c:v>
                </c:pt>
                <c:pt idx="3445">
                  <c:v>0.27039995670314809</c:v>
                </c:pt>
                <c:pt idx="3446">
                  <c:v>1.3041000795364468</c:v>
                </c:pt>
                <c:pt idx="3447">
                  <c:v>3.8749998903274516</c:v>
                </c:pt>
                <c:pt idx="3448">
                  <c:v>2.9380000448227008</c:v>
                </c:pt>
                <c:pt idx="3449">
                  <c:v>1.4113499927520508</c:v>
                </c:pt>
                <c:pt idx="3450">
                  <c:v>3.0037500524520979</c:v>
                </c:pt>
                <c:pt idx="3451">
                  <c:v>0.65439999580384622</c:v>
                </c:pt>
                <c:pt idx="3452">
                  <c:v>1.0750499916076492</c:v>
                </c:pt>
                <c:pt idx="3453">
                  <c:v>0.75525002002719788</c:v>
                </c:pt>
                <c:pt idx="3454">
                  <c:v>2.0175499868392492</c:v>
                </c:pt>
                <c:pt idx="3455">
                  <c:v>1.9484000205994008</c:v>
                </c:pt>
                <c:pt idx="3456">
                  <c:v>3.738649983405999</c:v>
                </c:pt>
                <c:pt idx="3457">
                  <c:v>3.2830999565124479</c:v>
                </c:pt>
                <c:pt idx="3458">
                  <c:v>-0.59700009822849864</c:v>
                </c:pt>
                <c:pt idx="3459">
                  <c:v>2.6826999044418542</c:v>
                </c:pt>
                <c:pt idx="3460">
                  <c:v>3.4394498777389515</c:v>
                </c:pt>
                <c:pt idx="3461">
                  <c:v>1.9769500589370992</c:v>
                </c:pt>
                <c:pt idx="3462">
                  <c:v>1.2357000064850006</c:v>
                </c:pt>
                <c:pt idx="3463">
                  <c:v>2.1841499567031448</c:v>
                </c:pt>
                <c:pt idx="3464">
                  <c:v>2.4568499326706004</c:v>
                </c:pt>
                <c:pt idx="3465">
                  <c:v>1.7133499002456496</c:v>
                </c:pt>
                <c:pt idx="3466">
                  <c:v>1.2432998847961514</c:v>
                </c:pt>
                <c:pt idx="3467">
                  <c:v>4.1254499912262013</c:v>
                </c:pt>
                <c:pt idx="3468">
                  <c:v>2.1727500438689979</c:v>
                </c:pt>
                <c:pt idx="3469">
                  <c:v>4.6445499801635002</c:v>
                </c:pt>
                <c:pt idx="3470">
                  <c:v>4.1830999183654498</c:v>
                </c:pt>
                <c:pt idx="3471">
                  <c:v>2.0127499341964494</c:v>
                </c:pt>
                <c:pt idx="3472">
                  <c:v>1.5405000734329484</c:v>
                </c:pt>
                <c:pt idx="3473">
                  <c:v>2.2985999298095479</c:v>
                </c:pt>
                <c:pt idx="3474">
                  <c:v>1.5145000362397028</c:v>
                </c:pt>
                <c:pt idx="3475">
                  <c:v>1.5756999969482486</c:v>
                </c:pt>
                <c:pt idx="3476">
                  <c:v>3.5841999006271479</c:v>
                </c:pt>
                <c:pt idx="3477">
                  <c:v>2.0261000108719003</c:v>
                </c:pt>
                <c:pt idx="3478">
                  <c:v>3.6223500108718483</c:v>
                </c:pt>
                <c:pt idx="3479">
                  <c:v>-2.1006999492644987</c:v>
                </c:pt>
                <c:pt idx="3480">
                  <c:v>1.5876499748229946</c:v>
                </c:pt>
                <c:pt idx="3481">
                  <c:v>5.0579999494552972</c:v>
                </c:pt>
                <c:pt idx="3482">
                  <c:v>1.235849833488448</c:v>
                </c:pt>
                <c:pt idx="3483">
                  <c:v>2.268849878311201</c:v>
                </c:pt>
                <c:pt idx="3484">
                  <c:v>0.60170005321505116</c:v>
                </c:pt>
                <c:pt idx="3485">
                  <c:v>2.7372000074386484</c:v>
                </c:pt>
                <c:pt idx="3486">
                  <c:v>2.9478499698639027</c:v>
                </c:pt>
                <c:pt idx="3487">
                  <c:v>-0.815950016975453</c:v>
                </c:pt>
                <c:pt idx="3488">
                  <c:v>2.7933500289916502</c:v>
                </c:pt>
                <c:pt idx="3489">
                  <c:v>3.0261000061034515</c:v>
                </c:pt>
                <c:pt idx="3490">
                  <c:v>2.1567000246048025</c:v>
                </c:pt>
                <c:pt idx="3491">
                  <c:v>2.9236000776291</c:v>
                </c:pt>
                <c:pt idx="3492">
                  <c:v>1.6706000232695999</c:v>
                </c:pt>
                <c:pt idx="3493">
                  <c:v>1.7188999891281505</c:v>
                </c:pt>
                <c:pt idx="3494">
                  <c:v>5.0620499181748002</c:v>
                </c:pt>
                <c:pt idx="3495">
                  <c:v>-0.18654979705805275</c:v>
                </c:pt>
                <c:pt idx="3496">
                  <c:v>2.6225001382827458</c:v>
                </c:pt>
                <c:pt idx="3497">
                  <c:v>0.89135014533994905</c:v>
                </c:pt>
                <c:pt idx="3498">
                  <c:v>2.0090000104904497</c:v>
                </c:pt>
                <c:pt idx="3499">
                  <c:v>3.8710999631881506</c:v>
                </c:pt>
                <c:pt idx="3500">
                  <c:v>2.8210499429702978</c:v>
                </c:pt>
                <c:pt idx="3501">
                  <c:v>-1.4080499553679964</c:v>
                </c:pt>
                <c:pt idx="3502">
                  <c:v>2.0574501562118499</c:v>
                </c:pt>
                <c:pt idx="3503">
                  <c:v>2.086450037956201</c:v>
                </c:pt>
                <c:pt idx="3504">
                  <c:v>4.0713499498367476</c:v>
                </c:pt>
                <c:pt idx="3505">
                  <c:v>5.4145999503136011</c:v>
                </c:pt>
                <c:pt idx="3506">
                  <c:v>2.0806499910355001</c:v>
                </c:pt>
                <c:pt idx="3507">
                  <c:v>4.1668500280379988</c:v>
                </c:pt>
                <c:pt idx="3508">
                  <c:v>3.0183000898361492</c:v>
                </c:pt>
                <c:pt idx="3509">
                  <c:v>2.8893500232695999</c:v>
                </c:pt>
                <c:pt idx="3510">
                  <c:v>3.6771501445770518</c:v>
                </c:pt>
                <c:pt idx="3511">
                  <c:v>4.0143499755859509</c:v>
                </c:pt>
                <c:pt idx="3512">
                  <c:v>3.7006500101089479</c:v>
                </c:pt>
                <c:pt idx="3513">
                  <c:v>-2.0805000543594474</c:v>
                </c:pt>
                <c:pt idx="3514">
                  <c:v>5.310850033760051</c:v>
                </c:pt>
                <c:pt idx="3515">
                  <c:v>2.825149936676052</c:v>
                </c:pt>
                <c:pt idx="3516">
                  <c:v>2.0937999868393007</c:v>
                </c:pt>
                <c:pt idx="3517">
                  <c:v>3.0111998987197985</c:v>
                </c:pt>
                <c:pt idx="3518">
                  <c:v>3.0581999206543031</c:v>
                </c:pt>
                <c:pt idx="3519">
                  <c:v>2.5797498941421502</c:v>
                </c:pt>
                <c:pt idx="3520">
                  <c:v>1.9272999238968005</c:v>
                </c:pt>
                <c:pt idx="3521">
                  <c:v>2.9994998311996532</c:v>
                </c:pt>
                <c:pt idx="3522">
                  <c:v>3.7430499553680505</c:v>
                </c:pt>
                <c:pt idx="3523">
                  <c:v>2.240300064086945</c:v>
                </c:pt>
                <c:pt idx="3524">
                  <c:v>2.6609499883652035</c:v>
                </c:pt>
                <c:pt idx="3525">
                  <c:v>-0.25574999809265009</c:v>
                </c:pt>
                <c:pt idx="3526">
                  <c:v>4.4640499830245943</c:v>
                </c:pt>
                <c:pt idx="3527">
                  <c:v>1.4638000106811475</c:v>
                </c:pt>
                <c:pt idx="3528">
                  <c:v>1.8083000469207491</c:v>
                </c:pt>
                <c:pt idx="3529">
                  <c:v>2.7305998778343472</c:v>
                </c:pt>
                <c:pt idx="3530">
                  <c:v>3.5453999614715528</c:v>
                </c:pt>
                <c:pt idx="3531">
                  <c:v>2.6495999097824026</c:v>
                </c:pt>
                <c:pt idx="3532">
                  <c:v>4.0902999210358004</c:v>
                </c:pt>
                <c:pt idx="3533">
                  <c:v>2.2826000165939035</c:v>
                </c:pt>
                <c:pt idx="3534">
                  <c:v>2.9707499313353978</c:v>
                </c:pt>
                <c:pt idx="3535">
                  <c:v>1.8475499200820522</c:v>
                </c:pt>
                <c:pt idx="3536">
                  <c:v>-2.3786499881744483</c:v>
                </c:pt>
                <c:pt idx="3537">
                  <c:v>3.998399977684052</c:v>
                </c:pt>
                <c:pt idx="3538">
                  <c:v>4.803600111007654</c:v>
                </c:pt>
                <c:pt idx="3539">
                  <c:v>2.7486499142646501</c:v>
                </c:pt>
                <c:pt idx="3540">
                  <c:v>2.1049999237060533</c:v>
                </c:pt>
                <c:pt idx="3541">
                  <c:v>3.9937000751495511</c:v>
                </c:pt>
                <c:pt idx="3542">
                  <c:v>2.8198500299453499</c:v>
                </c:pt>
                <c:pt idx="3543">
                  <c:v>2.7507499885559028</c:v>
                </c:pt>
                <c:pt idx="3544">
                  <c:v>3.6312500953674487</c:v>
                </c:pt>
                <c:pt idx="3545">
                  <c:v>3.6432499456405978</c:v>
                </c:pt>
                <c:pt idx="3546">
                  <c:v>2.9753498554229481</c:v>
                </c:pt>
                <c:pt idx="3547">
                  <c:v>3.0371999597549504</c:v>
                </c:pt>
                <c:pt idx="3548">
                  <c:v>2.8785499668121481</c:v>
                </c:pt>
                <c:pt idx="3549">
                  <c:v>1.991900053024299</c:v>
                </c:pt>
                <c:pt idx="3550">
                  <c:v>4.8190499639511479</c:v>
                </c:pt>
                <c:pt idx="3551">
                  <c:v>2.5793999290466516</c:v>
                </c:pt>
                <c:pt idx="3552">
                  <c:v>1.3645500373839994</c:v>
                </c:pt>
                <c:pt idx="3553">
                  <c:v>2.9341999483108481</c:v>
                </c:pt>
                <c:pt idx="3554">
                  <c:v>1.8938498592376973</c:v>
                </c:pt>
                <c:pt idx="3555">
                  <c:v>3.0936999893188499</c:v>
                </c:pt>
                <c:pt idx="3556">
                  <c:v>3.7589998817444013</c:v>
                </c:pt>
                <c:pt idx="3557">
                  <c:v>2.4233998537063499</c:v>
                </c:pt>
                <c:pt idx="3558">
                  <c:v>3.2198501491546523</c:v>
                </c:pt>
                <c:pt idx="3559">
                  <c:v>1.5455000543594508</c:v>
                </c:pt>
                <c:pt idx="3560">
                  <c:v>1.1121499967574984</c:v>
                </c:pt>
                <c:pt idx="3561">
                  <c:v>-1.3550499391555988</c:v>
                </c:pt>
                <c:pt idx="3562">
                  <c:v>2.9665001392364516</c:v>
                </c:pt>
                <c:pt idx="3563">
                  <c:v>2.4460999631881535</c:v>
                </c:pt>
                <c:pt idx="3564">
                  <c:v>2.5332501220702994</c:v>
                </c:pt>
                <c:pt idx="3565">
                  <c:v>2.4693000173569004</c:v>
                </c:pt>
                <c:pt idx="3566">
                  <c:v>4.0577499794959984</c:v>
                </c:pt>
                <c:pt idx="3567">
                  <c:v>3.5789999151229495</c:v>
                </c:pt>
                <c:pt idx="3568">
                  <c:v>2.1336499309540002</c:v>
                </c:pt>
                <c:pt idx="3569">
                  <c:v>3.2259000205994006</c:v>
                </c:pt>
                <c:pt idx="3570">
                  <c:v>1.2715000867843997</c:v>
                </c:pt>
                <c:pt idx="3571">
                  <c:v>2.5164499902725517</c:v>
                </c:pt>
                <c:pt idx="3572">
                  <c:v>3.2615500640868973</c:v>
                </c:pt>
                <c:pt idx="3573">
                  <c:v>3.305999908447248</c:v>
                </c:pt>
                <c:pt idx="3574">
                  <c:v>1.3624999666213995</c:v>
                </c:pt>
                <c:pt idx="3575">
                  <c:v>3.0866501379012519</c:v>
                </c:pt>
                <c:pt idx="3576">
                  <c:v>2.8253999662399494</c:v>
                </c:pt>
                <c:pt idx="3577">
                  <c:v>2.4666999483108505</c:v>
                </c:pt>
                <c:pt idx="3578">
                  <c:v>2.9250500440598017</c:v>
                </c:pt>
                <c:pt idx="3579">
                  <c:v>0.48094998359680119</c:v>
                </c:pt>
                <c:pt idx="3580">
                  <c:v>3.4785999584198031</c:v>
                </c:pt>
                <c:pt idx="3581">
                  <c:v>1.7736999940872025</c:v>
                </c:pt>
                <c:pt idx="3582">
                  <c:v>0.47344999313355274</c:v>
                </c:pt>
                <c:pt idx="3583">
                  <c:v>-0.32624989032744622</c:v>
                </c:pt>
                <c:pt idx="3584">
                  <c:v>4.5045999050140537</c:v>
                </c:pt>
                <c:pt idx="3585">
                  <c:v>0.16664996147154909</c:v>
                </c:pt>
                <c:pt idx="3586">
                  <c:v>1.6250000381470002</c:v>
                </c:pt>
                <c:pt idx="3587">
                  <c:v>4.4164500808715985</c:v>
                </c:pt>
                <c:pt idx="3588">
                  <c:v>1.9780000734328986</c:v>
                </c:pt>
                <c:pt idx="3589">
                  <c:v>-3.266799945831302</c:v>
                </c:pt>
                <c:pt idx="3590">
                  <c:v>1.6381999635696474</c:v>
                </c:pt>
                <c:pt idx="3591">
                  <c:v>1.4316999340057031</c:v>
                </c:pt>
                <c:pt idx="3592">
                  <c:v>2.3031999516487502</c:v>
                </c:pt>
                <c:pt idx="3593">
                  <c:v>2.4009499073028486</c:v>
                </c:pt>
                <c:pt idx="3594">
                  <c:v>3.6011999559401957</c:v>
                </c:pt>
                <c:pt idx="3595">
                  <c:v>6.625005245204818E-2</c:v>
                </c:pt>
                <c:pt idx="3596">
                  <c:v>3.4282501220703026</c:v>
                </c:pt>
                <c:pt idx="3597">
                  <c:v>3.929050059318552</c:v>
                </c:pt>
                <c:pt idx="3598">
                  <c:v>1.3590000939369027</c:v>
                </c:pt>
                <c:pt idx="3599">
                  <c:v>2.7088998842239498</c:v>
                </c:pt>
                <c:pt idx="3600">
                  <c:v>2.5263999557495538</c:v>
                </c:pt>
                <c:pt idx="3601">
                  <c:v>0.89234993934629969</c:v>
                </c:pt>
                <c:pt idx="3602">
                  <c:v>2.2129499578476022</c:v>
                </c:pt>
                <c:pt idx="3603">
                  <c:v>0.41290001392365028</c:v>
                </c:pt>
                <c:pt idx="3604">
                  <c:v>3.5050499105452992</c:v>
                </c:pt>
                <c:pt idx="3605">
                  <c:v>2.1203499889373987</c:v>
                </c:pt>
                <c:pt idx="3606">
                  <c:v>0.48844999790189902</c:v>
                </c:pt>
                <c:pt idx="3607">
                  <c:v>-3.1653998851775995</c:v>
                </c:pt>
                <c:pt idx="3608">
                  <c:v>-0.49135011196134926</c:v>
                </c:pt>
                <c:pt idx="3609">
                  <c:v>3.2465999984741494</c:v>
                </c:pt>
                <c:pt idx="3610">
                  <c:v>-3.0549000453948985</c:v>
                </c:pt>
                <c:pt idx="3611">
                  <c:v>3.1780999851226497</c:v>
                </c:pt>
                <c:pt idx="3612">
                  <c:v>1.7789000892638995</c:v>
                </c:pt>
                <c:pt idx="3613">
                  <c:v>0.80360010147089866</c:v>
                </c:pt>
                <c:pt idx="3614">
                  <c:v>2.0610499811172538</c:v>
                </c:pt>
                <c:pt idx="3615">
                  <c:v>2.5918499875068974</c:v>
                </c:pt>
                <c:pt idx="3616">
                  <c:v>4.3611000633239989</c:v>
                </c:pt>
                <c:pt idx="3617">
                  <c:v>4.518400030136096</c:v>
                </c:pt>
                <c:pt idx="3618">
                  <c:v>-9.1750063896199663E-2</c:v>
                </c:pt>
                <c:pt idx="3619">
                  <c:v>2.6037999629974493</c:v>
                </c:pt>
                <c:pt idx="3620">
                  <c:v>-0.26469994544984843</c:v>
                </c:pt>
                <c:pt idx="3621">
                  <c:v>3.8104000329971512</c:v>
                </c:pt>
                <c:pt idx="3622">
                  <c:v>3.4727999544143486</c:v>
                </c:pt>
                <c:pt idx="3623">
                  <c:v>4.9958500242233015</c:v>
                </c:pt>
                <c:pt idx="3624">
                  <c:v>1.8410999488831017</c:v>
                </c:pt>
                <c:pt idx="3625">
                  <c:v>-0.25265004158020332</c:v>
                </c:pt>
                <c:pt idx="3626">
                  <c:v>4.3819500207901001</c:v>
                </c:pt>
                <c:pt idx="3627">
                  <c:v>0.13400003433225294</c:v>
                </c:pt>
                <c:pt idx="3628">
                  <c:v>3.4781000900268495</c:v>
                </c:pt>
                <c:pt idx="3629">
                  <c:v>3.7754499602317999</c:v>
                </c:pt>
                <c:pt idx="3630">
                  <c:v>3.1988500595092511</c:v>
                </c:pt>
                <c:pt idx="3631">
                  <c:v>2.0096999883651989</c:v>
                </c:pt>
                <c:pt idx="3632">
                  <c:v>3.6824500513076508</c:v>
                </c:pt>
                <c:pt idx="3633">
                  <c:v>3.5196000528335034</c:v>
                </c:pt>
                <c:pt idx="3634">
                  <c:v>0.49094987392425082</c:v>
                </c:pt>
                <c:pt idx="3635">
                  <c:v>3.0285500049591505</c:v>
                </c:pt>
                <c:pt idx="3636">
                  <c:v>0.58274998664854749</c:v>
                </c:pt>
                <c:pt idx="3637">
                  <c:v>3.2412000036239483</c:v>
                </c:pt>
                <c:pt idx="3638">
                  <c:v>4.3399968147301848E-2</c:v>
                </c:pt>
                <c:pt idx="3639">
                  <c:v>0.10009998798369679</c:v>
                </c:pt>
                <c:pt idx="3640">
                  <c:v>3.2672999477386</c:v>
                </c:pt>
                <c:pt idx="3641">
                  <c:v>1.6051499652862482</c:v>
                </c:pt>
                <c:pt idx="3642">
                  <c:v>2.0744499158859497</c:v>
                </c:pt>
                <c:pt idx="3643">
                  <c:v>1.8741500186920028</c:v>
                </c:pt>
                <c:pt idx="3644">
                  <c:v>1.713649969100949</c:v>
                </c:pt>
                <c:pt idx="3645">
                  <c:v>1.3871500301361515</c:v>
                </c:pt>
                <c:pt idx="3646">
                  <c:v>2.2472000098228513</c:v>
                </c:pt>
                <c:pt idx="3647">
                  <c:v>2.2472000098228513</c:v>
                </c:pt>
                <c:pt idx="3648">
                  <c:v>3.6241999769211013</c:v>
                </c:pt>
                <c:pt idx="3649">
                  <c:v>1.390199980735801</c:v>
                </c:pt>
                <c:pt idx="3650">
                  <c:v>2.4389998865127502</c:v>
                </c:pt>
                <c:pt idx="3651">
                  <c:v>0.2866001319885001</c:v>
                </c:pt>
                <c:pt idx="3652">
                  <c:v>1.4028999614715509</c:v>
                </c:pt>
                <c:pt idx="3653">
                  <c:v>2.1856000566482514</c:v>
                </c:pt>
                <c:pt idx="3654">
                  <c:v>0.95224988460540061</c:v>
                </c:pt>
                <c:pt idx="3655">
                  <c:v>0.73415007114414976</c:v>
                </c:pt>
                <c:pt idx="3656">
                  <c:v>5.5475000476837479</c:v>
                </c:pt>
                <c:pt idx="3657">
                  <c:v>1.5087500095367474</c:v>
                </c:pt>
                <c:pt idx="3658">
                  <c:v>0.26880011081694732</c:v>
                </c:pt>
                <c:pt idx="3659">
                  <c:v>1.3884499311447485</c:v>
                </c:pt>
                <c:pt idx="3660">
                  <c:v>4.4550999641419011</c:v>
                </c:pt>
                <c:pt idx="3661">
                  <c:v>0.38425012111665069</c:v>
                </c:pt>
                <c:pt idx="3662">
                  <c:v>1.1609500741959025</c:v>
                </c:pt>
                <c:pt idx="3663">
                  <c:v>4.0354499769210506</c:v>
                </c:pt>
                <c:pt idx="3664">
                  <c:v>0.99495003700260298</c:v>
                </c:pt>
                <c:pt idx="3665">
                  <c:v>2.4117498493194525</c:v>
                </c:pt>
                <c:pt idx="3666">
                  <c:v>2.5813999748230003</c:v>
                </c:pt>
                <c:pt idx="3667">
                  <c:v>2.3707000875472986</c:v>
                </c:pt>
                <c:pt idx="3668">
                  <c:v>2.5383499050140514</c:v>
                </c:pt>
                <c:pt idx="3669">
                  <c:v>3.8676999855041991</c:v>
                </c:pt>
                <c:pt idx="3670">
                  <c:v>0.54815002441409888</c:v>
                </c:pt>
                <c:pt idx="3671">
                  <c:v>0.74670000553129867</c:v>
                </c:pt>
                <c:pt idx="3672">
                  <c:v>1.8522999191283986</c:v>
                </c:pt>
                <c:pt idx="3673">
                  <c:v>3.6350499749183953</c:v>
                </c:pt>
                <c:pt idx="3674">
                  <c:v>4.0420999288558512</c:v>
                </c:pt>
                <c:pt idx="3675">
                  <c:v>-3.4276999473572509</c:v>
                </c:pt>
                <c:pt idx="3676">
                  <c:v>0.54239993095405126</c:v>
                </c:pt>
                <c:pt idx="3677">
                  <c:v>5.4049968719454E-2</c:v>
                </c:pt>
                <c:pt idx="3678">
                  <c:v>2.2350998973846004</c:v>
                </c:pt>
                <c:pt idx="3679">
                  <c:v>2.6973000812530508</c:v>
                </c:pt>
                <c:pt idx="3680">
                  <c:v>2.3005499887466456</c:v>
                </c:pt>
                <c:pt idx="3681">
                  <c:v>2.6167500114440472</c:v>
                </c:pt>
                <c:pt idx="3682">
                  <c:v>2.6167500114440472</c:v>
                </c:pt>
                <c:pt idx="3683">
                  <c:v>2.4661499547958528</c:v>
                </c:pt>
                <c:pt idx="3684">
                  <c:v>1.8302999496459513</c:v>
                </c:pt>
                <c:pt idx="3685">
                  <c:v>0.56009980201724829</c:v>
                </c:pt>
                <c:pt idx="3686">
                  <c:v>2.9931998729706528</c:v>
                </c:pt>
                <c:pt idx="3687">
                  <c:v>2.9444000196457516</c:v>
                </c:pt>
                <c:pt idx="3688">
                  <c:v>-0.34570004940034949</c:v>
                </c:pt>
                <c:pt idx="3689">
                  <c:v>1.8967999649048011</c:v>
                </c:pt>
                <c:pt idx="3690">
                  <c:v>-1.2628999996185506</c:v>
                </c:pt>
                <c:pt idx="3691">
                  <c:v>0.21899998426439993</c:v>
                </c:pt>
                <c:pt idx="3692">
                  <c:v>0.65934989452365045</c:v>
                </c:pt>
                <c:pt idx="3693">
                  <c:v>2.3376999998092494</c:v>
                </c:pt>
                <c:pt idx="3694">
                  <c:v>3.5669999122619487</c:v>
                </c:pt>
                <c:pt idx="3695">
                  <c:v>4.1753999996185485</c:v>
                </c:pt>
                <c:pt idx="3696">
                  <c:v>4.4853999900818025</c:v>
                </c:pt>
                <c:pt idx="3697">
                  <c:v>4.2891000747680508</c:v>
                </c:pt>
                <c:pt idx="3698">
                  <c:v>4.4675499153137501</c:v>
                </c:pt>
                <c:pt idx="3699">
                  <c:v>2.5326498556137054</c:v>
                </c:pt>
                <c:pt idx="3700">
                  <c:v>2.5407498931884511</c:v>
                </c:pt>
                <c:pt idx="3701">
                  <c:v>-3.535050106048601</c:v>
                </c:pt>
                <c:pt idx="3702">
                  <c:v>-0.38854997634884825</c:v>
                </c:pt>
                <c:pt idx="3703">
                  <c:v>4.5930999898910514</c:v>
                </c:pt>
                <c:pt idx="3704">
                  <c:v>2.2981499433517456</c:v>
                </c:pt>
                <c:pt idx="3705">
                  <c:v>1.1135999965667516</c:v>
                </c:pt>
                <c:pt idx="3706">
                  <c:v>1.876099977493304</c:v>
                </c:pt>
                <c:pt idx="3707">
                  <c:v>1.5086999750136982</c:v>
                </c:pt>
                <c:pt idx="3708">
                  <c:v>3.4922999238968018</c:v>
                </c:pt>
                <c:pt idx="3709">
                  <c:v>3.8591379738335512</c:v>
                </c:pt>
                <c:pt idx="3710">
                  <c:v>0.4264999246596517</c:v>
                </c:pt>
                <c:pt idx="3711">
                  <c:v>2.4147999525070034</c:v>
                </c:pt>
                <c:pt idx="3712">
                  <c:v>1.6023001050948977</c:v>
                </c:pt>
                <c:pt idx="3713">
                  <c:v>-1.3974999284744491</c:v>
                </c:pt>
                <c:pt idx="3714">
                  <c:v>3.5752501153945992</c:v>
                </c:pt>
                <c:pt idx="3715">
                  <c:v>2.6984499144553524</c:v>
                </c:pt>
                <c:pt idx="3716">
                  <c:v>-0.85295007705690296</c:v>
                </c:pt>
                <c:pt idx="3717">
                  <c:v>1.2078999280929494</c:v>
                </c:pt>
                <c:pt idx="3718">
                  <c:v>1.1644499683380509</c:v>
                </c:pt>
                <c:pt idx="3719">
                  <c:v>1.8706999897956997</c:v>
                </c:pt>
                <c:pt idx="3720">
                  <c:v>4.6520499467850023</c:v>
                </c:pt>
                <c:pt idx="3721">
                  <c:v>1.555650024414053</c:v>
                </c:pt>
                <c:pt idx="3722">
                  <c:v>1.3575499510765496</c:v>
                </c:pt>
                <c:pt idx="3723">
                  <c:v>3.5471998405457015</c:v>
                </c:pt>
                <c:pt idx="3724">
                  <c:v>2.7078999567031481</c:v>
                </c:pt>
                <c:pt idx="3725">
                  <c:v>2.6906499576568983</c:v>
                </c:pt>
                <c:pt idx="3726">
                  <c:v>1.4433999347686495</c:v>
                </c:pt>
                <c:pt idx="3727">
                  <c:v>2.0006499099731485</c:v>
                </c:pt>
                <c:pt idx="3728">
                  <c:v>1.3523999500275004</c:v>
                </c:pt>
                <c:pt idx="3729">
                  <c:v>2.6939999103546022</c:v>
                </c:pt>
                <c:pt idx="3730">
                  <c:v>3.024449939727802</c:v>
                </c:pt>
                <c:pt idx="3731">
                  <c:v>-0.74230002403260187</c:v>
                </c:pt>
                <c:pt idx="3732">
                  <c:v>1.8728500080108539</c:v>
                </c:pt>
                <c:pt idx="3733">
                  <c:v>0.49000013828280231</c:v>
                </c:pt>
                <c:pt idx="3734">
                  <c:v>1.2602000331878997</c:v>
                </c:pt>
                <c:pt idx="3735">
                  <c:v>0.18264995098115122</c:v>
                </c:pt>
                <c:pt idx="3736">
                  <c:v>0.22920001983644767</c:v>
                </c:pt>
                <c:pt idx="3737">
                  <c:v>0.96680000305175184</c:v>
                </c:pt>
                <c:pt idx="3738">
                  <c:v>-3.0050048828101694E-2</c:v>
                </c:pt>
                <c:pt idx="3739">
                  <c:v>3.9909998154640505</c:v>
                </c:pt>
                <c:pt idx="3740">
                  <c:v>-1.9849996566748018E-2</c:v>
                </c:pt>
                <c:pt idx="3741">
                  <c:v>3.3620498228073004</c:v>
                </c:pt>
                <c:pt idx="3742">
                  <c:v>2.8730499386787471</c:v>
                </c:pt>
                <c:pt idx="3743">
                  <c:v>2.6063999295234481</c:v>
                </c:pt>
                <c:pt idx="3744">
                  <c:v>2.772049908638003</c:v>
                </c:pt>
                <c:pt idx="3745">
                  <c:v>1.048800115585351</c:v>
                </c:pt>
                <c:pt idx="3746">
                  <c:v>2.6510999917984002</c:v>
                </c:pt>
                <c:pt idx="3747">
                  <c:v>1.8613499498367503</c:v>
                </c:pt>
                <c:pt idx="3748">
                  <c:v>1.8746000051498477</c:v>
                </c:pt>
                <c:pt idx="3749">
                  <c:v>1.6201000404358012</c:v>
                </c:pt>
                <c:pt idx="3750">
                  <c:v>0.47534996509550353</c:v>
                </c:pt>
                <c:pt idx="3751">
                  <c:v>1.9291500663757475</c:v>
                </c:pt>
                <c:pt idx="3752">
                  <c:v>3.991149988174449</c:v>
                </c:pt>
                <c:pt idx="3753">
                  <c:v>0.51080002307890027</c:v>
                </c:pt>
                <c:pt idx="3754">
                  <c:v>0.57360003948209837</c:v>
                </c:pt>
                <c:pt idx="3755">
                  <c:v>1.6925499248504998</c:v>
                </c:pt>
                <c:pt idx="3756">
                  <c:v>0.80650005817414794</c:v>
                </c:pt>
                <c:pt idx="3757">
                  <c:v>2.8059000015258491</c:v>
                </c:pt>
                <c:pt idx="3758">
                  <c:v>3.9059000015259002</c:v>
                </c:pt>
                <c:pt idx="3759">
                  <c:v>3.3494499182701034</c:v>
                </c:pt>
                <c:pt idx="3760">
                  <c:v>2.0222500562667989</c:v>
                </c:pt>
                <c:pt idx="3761">
                  <c:v>1.5296499633788976</c:v>
                </c:pt>
                <c:pt idx="3762">
                  <c:v>1.8569499540328991</c:v>
                </c:pt>
                <c:pt idx="3763">
                  <c:v>3.6281000804900998</c:v>
                </c:pt>
                <c:pt idx="3764">
                  <c:v>1.5606499528885003</c:v>
                </c:pt>
                <c:pt idx="3765">
                  <c:v>2.4165001058578497</c:v>
                </c:pt>
                <c:pt idx="3766">
                  <c:v>1.6482998466491026</c:v>
                </c:pt>
                <c:pt idx="3767">
                  <c:v>3.1833499193191521</c:v>
                </c:pt>
                <c:pt idx="3768">
                  <c:v>3.7879499864578499</c:v>
                </c:pt>
                <c:pt idx="3769">
                  <c:v>2.1118499469757488</c:v>
                </c:pt>
                <c:pt idx="3770">
                  <c:v>2.7933498764038482</c:v>
                </c:pt>
                <c:pt idx="3771">
                  <c:v>1.1227000093460013</c:v>
                </c:pt>
                <c:pt idx="3772">
                  <c:v>2.9724000167846469</c:v>
                </c:pt>
                <c:pt idx="3773">
                  <c:v>3.0169999313354978</c:v>
                </c:pt>
                <c:pt idx="3774">
                  <c:v>2.2099001359938981</c:v>
                </c:pt>
                <c:pt idx="3775">
                  <c:v>0.22329998970029763</c:v>
                </c:pt>
                <c:pt idx="3776">
                  <c:v>1.5982500219345503</c:v>
                </c:pt>
                <c:pt idx="3777">
                  <c:v>2.127899942398102</c:v>
                </c:pt>
                <c:pt idx="3778">
                  <c:v>2.321949839591948</c:v>
                </c:pt>
                <c:pt idx="3779">
                  <c:v>1.2457500457763473</c:v>
                </c:pt>
                <c:pt idx="3780">
                  <c:v>1.7039999341964496</c:v>
                </c:pt>
                <c:pt idx="3781">
                  <c:v>1.7287999439239954</c:v>
                </c:pt>
                <c:pt idx="3782">
                  <c:v>1.4551499843597497</c:v>
                </c:pt>
                <c:pt idx="3783">
                  <c:v>2.3087000131607489</c:v>
                </c:pt>
                <c:pt idx="3784">
                  <c:v>4.333249931335402</c:v>
                </c:pt>
                <c:pt idx="3785">
                  <c:v>3.4830999612808</c:v>
                </c:pt>
                <c:pt idx="3786">
                  <c:v>2.1012499046325033</c:v>
                </c:pt>
                <c:pt idx="3787">
                  <c:v>2.7114500808716038</c:v>
                </c:pt>
                <c:pt idx="3788">
                  <c:v>2.7777000617980967</c:v>
                </c:pt>
                <c:pt idx="3789">
                  <c:v>1.7636000680923019</c:v>
                </c:pt>
                <c:pt idx="3790">
                  <c:v>5.0133000326156498</c:v>
                </c:pt>
                <c:pt idx="3791">
                  <c:v>4.2963500404358008</c:v>
                </c:pt>
                <c:pt idx="3792">
                  <c:v>2.2248486423354983</c:v>
                </c:pt>
                <c:pt idx="3793">
                  <c:v>1.805749950408952</c:v>
                </c:pt>
                <c:pt idx="3794">
                  <c:v>2.2989499092102008</c:v>
                </c:pt>
                <c:pt idx="3795">
                  <c:v>3.0978499984741035</c:v>
                </c:pt>
                <c:pt idx="3796">
                  <c:v>2.4614500761031977</c:v>
                </c:pt>
                <c:pt idx="3797">
                  <c:v>0.94525008201599903</c:v>
                </c:pt>
                <c:pt idx="3798">
                  <c:v>0.1818999385833493</c:v>
                </c:pt>
                <c:pt idx="3799">
                  <c:v>2.5114000034331987</c:v>
                </c:pt>
                <c:pt idx="3800">
                  <c:v>1.8318500518799006</c:v>
                </c:pt>
                <c:pt idx="3801">
                  <c:v>2.4998498964309519</c:v>
                </c:pt>
                <c:pt idx="3802">
                  <c:v>3.4750499916076976</c:v>
                </c:pt>
                <c:pt idx="3803">
                  <c:v>-0.30289995670320025</c:v>
                </c:pt>
                <c:pt idx="3804">
                  <c:v>2.0155500316619488</c:v>
                </c:pt>
                <c:pt idx="3805">
                  <c:v>3.7945499420166016</c:v>
                </c:pt>
                <c:pt idx="3806">
                  <c:v>1.2571999740601036</c:v>
                </c:pt>
                <c:pt idx="3807">
                  <c:v>0.46030002117159796</c:v>
                </c:pt>
                <c:pt idx="3808">
                  <c:v>1.9362999391556031</c:v>
                </c:pt>
                <c:pt idx="3809">
                  <c:v>6.130650038719196</c:v>
                </c:pt>
                <c:pt idx="3810">
                  <c:v>3.2480000782013008</c:v>
                </c:pt>
                <c:pt idx="3811">
                  <c:v>1.6399498367309491</c:v>
                </c:pt>
                <c:pt idx="3812">
                  <c:v>2.7668500614166014</c:v>
                </c:pt>
                <c:pt idx="3813">
                  <c:v>3.3248500537872019</c:v>
                </c:pt>
                <c:pt idx="3814">
                  <c:v>5.5995500469208004</c:v>
                </c:pt>
                <c:pt idx="3815">
                  <c:v>1.2303999662399008</c:v>
                </c:pt>
                <c:pt idx="3816">
                  <c:v>2.463849864006054</c:v>
                </c:pt>
                <c:pt idx="3817">
                  <c:v>1.6146000289916991</c:v>
                </c:pt>
                <c:pt idx="3818">
                  <c:v>3.720299968719452</c:v>
                </c:pt>
                <c:pt idx="3819">
                  <c:v>5.5032000350952011</c:v>
                </c:pt>
                <c:pt idx="3820">
                  <c:v>1.3284500694274506</c:v>
                </c:pt>
                <c:pt idx="3821">
                  <c:v>1.9414000463486509</c:v>
                </c:pt>
                <c:pt idx="3822">
                  <c:v>3.7330500125884996</c:v>
                </c:pt>
                <c:pt idx="3823">
                  <c:v>2.7938500356674503</c:v>
                </c:pt>
                <c:pt idx="3824">
                  <c:v>2.5941999578476</c:v>
                </c:pt>
                <c:pt idx="3825">
                  <c:v>2.0425999975205009</c:v>
                </c:pt>
                <c:pt idx="3826">
                  <c:v>-2.0729499626160006</c:v>
                </c:pt>
                <c:pt idx="3827">
                  <c:v>2.8733000707626033</c:v>
                </c:pt>
                <c:pt idx="3828">
                  <c:v>1.777049989700302</c:v>
                </c:pt>
                <c:pt idx="3829">
                  <c:v>1.3747500801086474</c:v>
                </c:pt>
                <c:pt idx="3830">
                  <c:v>0.97425001621249763</c:v>
                </c:pt>
                <c:pt idx="3831">
                  <c:v>0.80874998569489875</c:v>
                </c:pt>
                <c:pt idx="3832">
                  <c:v>1.8452000188827995</c:v>
                </c:pt>
                <c:pt idx="3833">
                  <c:v>4.7628999853134033</c:v>
                </c:pt>
                <c:pt idx="3834">
                  <c:v>2.9590999794006514</c:v>
                </c:pt>
                <c:pt idx="3835">
                  <c:v>2.8165499877929498</c:v>
                </c:pt>
                <c:pt idx="3836">
                  <c:v>1.2003999805450007</c:v>
                </c:pt>
                <c:pt idx="3837">
                  <c:v>0.7990999364852982</c:v>
                </c:pt>
                <c:pt idx="3838">
                  <c:v>3.5958000612258978</c:v>
                </c:pt>
                <c:pt idx="3839">
                  <c:v>0.76024996280665036</c:v>
                </c:pt>
                <c:pt idx="3840">
                  <c:v>2.7860999393462507</c:v>
                </c:pt>
                <c:pt idx="3841">
                  <c:v>-3.2278499269486005</c:v>
                </c:pt>
                <c:pt idx="3842">
                  <c:v>1.0852000570297982</c:v>
                </c:pt>
                <c:pt idx="3843">
                  <c:v>1.5757999229431547</c:v>
                </c:pt>
                <c:pt idx="3844">
                  <c:v>-9.5050129890402957E-2</c:v>
                </c:pt>
                <c:pt idx="3845">
                  <c:v>4.0334499645233031</c:v>
                </c:pt>
                <c:pt idx="3846">
                  <c:v>3.1469000244140481</c:v>
                </c:pt>
                <c:pt idx="3847">
                  <c:v>2.3356999397278528</c:v>
                </c:pt>
                <c:pt idx="3848">
                  <c:v>3.4169000101089466</c:v>
                </c:pt>
                <c:pt idx="3849">
                  <c:v>-0.58265002727510051</c:v>
                </c:pt>
                <c:pt idx="3850">
                  <c:v>3.6690000009537016</c:v>
                </c:pt>
                <c:pt idx="3851">
                  <c:v>2.5872000265121464</c:v>
                </c:pt>
                <c:pt idx="3852">
                  <c:v>-1.8940998601913499</c:v>
                </c:pt>
                <c:pt idx="3853">
                  <c:v>-2.4122999095917024</c:v>
                </c:pt>
                <c:pt idx="3854">
                  <c:v>2.5385499620436995</c:v>
                </c:pt>
                <c:pt idx="3855">
                  <c:v>1.78199998378755</c:v>
                </c:pt>
                <c:pt idx="3856">
                  <c:v>3.9135499477387015</c:v>
                </c:pt>
                <c:pt idx="3857">
                  <c:v>0.87535001516344835</c:v>
                </c:pt>
                <c:pt idx="3858">
                  <c:v>4.1245499753952473</c:v>
                </c:pt>
                <c:pt idx="3859">
                  <c:v>2.0852001237869509</c:v>
                </c:pt>
                <c:pt idx="3860">
                  <c:v>1.7411499500274523</c:v>
                </c:pt>
                <c:pt idx="3861">
                  <c:v>2.3506998491286986</c:v>
                </c:pt>
                <c:pt idx="3862">
                  <c:v>2.6132499933242457</c:v>
                </c:pt>
                <c:pt idx="3863">
                  <c:v>0.29719999313354961</c:v>
                </c:pt>
                <c:pt idx="3864">
                  <c:v>0.83554998874664932</c:v>
                </c:pt>
                <c:pt idx="3865">
                  <c:v>3.5160000324249481</c:v>
                </c:pt>
                <c:pt idx="3866">
                  <c:v>2.0092500925064485</c:v>
                </c:pt>
                <c:pt idx="3867">
                  <c:v>4.2190498971938979</c:v>
                </c:pt>
                <c:pt idx="3868">
                  <c:v>1.3400499963759991</c:v>
                </c:pt>
                <c:pt idx="3869">
                  <c:v>0.91645000457759807</c:v>
                </c:pt>
                <c:pt idx="3870">
                  <c:v>-1.4132499313354998</c:v>
                </c:pt>
                <c:pt idx="3871">
                  <c:v>0.73240012168885471</c:v>
                </c:pt>
                <c:pt idx="3872">
                  <c:v>3.6161500835418963</c:v>
                </c:pt>
                <c:pt idx="3873">
                  <c:v>-2.8475998735427979</c:v>
                </c:pt>
                <c:pt idx="3874">
                  <c:v>1.3192999458313004</c:v>
                </c:pt>
                <c:pt idx="3875">
                  <c:v>-0.1733000993728524</c:v>
                </c:pt>
                <c:pt idx="3876">
                  <c:v>-0.30985005855560033</c:v>
                </c:pt>
                <c:pt idx="3877">
                  <c:v>2.9288000249861987</c:v>
                </c:pt>
                <c:pt idx="3878">
                  <c:v>1.5469999408721513</c:v>
                </c:pt>
                <c:pt idx="3879">
                  <c:v>4.6660818430390023</c:v>
                </c:pt>
                <c:pt idx="3880">
                  <c:v>1.4273499584198035</c:v>
                </c:pt>
                <c:pt idx="3881">
                  <c:v>1.3665499353409025</c:v>
                </c:pt>
                <c:pt idx="3882">
                  <c:v>3.5001499223709018</c:v>
                </c:pt>
                <c:pt idx="3883">
                  <c:v>1.2740500640869001</c:v>
                </c:pt>
                <c:pt idx="3884">
                  <c:v>2.3626500368118499</c:v>
                </c:pt>
                <c:pt idx="3885">
                  <c:v>1.2739998698234487</c:v>
                </c:pt>
                <c:pt idx="3886">
                  <c:v>3.0853500509261984</c:v>
                </c:pt>
                <c:pt idx="3887">
                  <c:v>2.4396000242232958</c:v>
                </c:pt>
                <c:pt idx="3888">
                  <c:v>3.7356499147415008</c:v>
                </c:pt>
                <c:pt idx="3889">
                  <c:v>1.6987499976158524</c:v>
                </c:pt>
                <c:pt idx="3890">
                  <c:v>3.7009499359130977</c:v>
                </c:pt>
                <c:pt idx="3891">
                  <c:v>1.6403500032424994</c:v>
                </c:pt>
                <c:pt idx="3892">
                  <c:v>2.6246499872207494</c:v>
                </c:pt>
                <c:pt idx="3893">
                  <c:v>3.6791999530791486</c:v>
                </c:pt>
                <c:pt idx="3894">
                  <c:v>-2.0025499558448523</c:v>
                </c:pt>
                <c:pt idx="3895">
                  <c:v>2.0370499229431474</c:v>
                </c:pt>
                <c:pt idx="3896">
                  <c:v>1.4733500075340515</c:v>
                </c:pt>
                <c:pt idx="3897">
                  <c:v>2.8918999481201517</c:v>
                </c:pt>
                <c:pt idx="3898">
                  <c:v>3.4602500247954993</c:v>
                </c:pt>
                <c:pt idx="3899">
                  <c:v>0.55930013656615074</c:v>
                </c:pt>
                <c:pt idx="3900">
                  <c:v>4.2290999650954966</c:v>
                </c:pt>
                <c:pt idx="3901">
                  <c:v>3.046250066757203</c:v>
                </c:pt>
                <c:pt idx="3902">
                  <c:v>0.38765002250675096</c:v>
                </c:pt>
                <c:pt idx="3903">
                  <c:v>1.1868999719619957</c:v>
                </c:pt>
                <c:pt idx="3904">
                  <c:v>0.61259996891020307</c:v>
                </c:pt>
                <c:pt idx="3905">
                  <c:v>1.3993000125885011</c:v>
                </c:pt>
                <c:pt idx="3906">
                  <c:v>3.0603000593185499</c:v>
                </c:pt>
                <c:pt idx="3907">
                  <c:v>1.1269499874115034</c:v>
                </c:pt>
                <c:pt idx="3908">
                  <c:v>1.0078000402450513</c:v>
                </c:pt>
                <c:pt idx="3909">
                  <c:v>1.0560499811172512</c:v>
                </c:pt>
                <c:pt idx="3910">
                  <c:v>1.0787499570846499</c:v>
                </c:pt>
                <c:pt idx="3911">
                  <c:v>2.8865499639510546</c:v>
                </c:pt>
                <c:pt idx="3912">
                  <c:v>3.3170500326156542</c:v>
                </c:pt>
                <c:pt idx="3913">
                  <c:v>-0.34134990692139766</c:v>
                </c:pt>
                <c:pt idx="3914">
                  <c:v>0.94094999790189959</c:v>
                </c:pt>
                <c:pt idx="3915">
                  <c:v>2.0158499622345474</c:v>
                </c:pt>
                <c:pt idx="3916">
                  <c:v>3.9039999055862005</c:v>
                </c:pt>
                <c:pt idx="3917">
                  <c:v>2.063850011825501</c:v>
                </c:pt>
                <c:pt idx="3918">
                  <c:v>1.3327999019622467</c:v>
                </c:pt>
                <c:pt idx="3919">
                  <c:v>3.039800012111705</c:v>
                </c:pt>
                <c:pt idx="3920">
                  <c:v>4.5513000583648981</c:v>
                </c:pt>
                <c:pt idx="3921">
                  <c:v>2.0396500730514013</c:v>
                </c:pt>
                <c:pt idx="3922">
                  <c:v>0.74765005111690286</c:v>
                </c:pt>
                <c:pt idx="3923">
                  <c:v>1.8584000253677004</c:v>
                </c:pt>
                <c:pt idx="3924">
                  <c:v>1.7085500192642478</c:v>
                </c:pt>
                <c:pt idx="3925">
                  <c:v>2.4230499124527007</c:v>
                </c:pt>
                <c:pt idx="3926">
                  <c:v>1.888860073763901</c:v>
                </c:pt>
                <c:pt idx="3927">
                  <c:v>2.3390499973297452</c:v>
                </c:pt>
                <c:pt idx="3928">
                  <c:v>0.54169988632204991</c:v>
                </c:pt>
                <c:pt idx="3929">
                  <c:v>1.5646500062941975</c:v>
                </c:pt>
                <c:pt idx="3930">
                  <c:v>3.5019500494003495</c:v>
                </c:pt>
                <c:pt idx="3931">
                  <c:v>1.6174500465393002</c:v>
                </c:pt>
                <c:pt idx="3932">
                  <c:v>-0.17750009536744926</c:v>
                </c:pt>
                <c:pt idx="3933">
                  <c:v>1.3208499908446996</c:v>
                </c:pt>
                <c:pt idx="3934">
                  <c:v>1.4016999053955033</c:v>
                </c:pt>
                <c:pt idx="3935">
                  <c:v>2.9171500968932982</c:v>
                </c:pt>
                <c:pt idx="3936">
                  <c:v>1.4409999370574482</c:v>
                </c:pt>
                <c:pt idx="3937">
                  <c:v>3.4108500099181995</c:v>
                </c:pt>
                <c:pt idx="3938">
                  <c:v>1.4630499792099023</c:v>
                </c:pt>
                <c:pt idx="3939">
                  <c:v>2.565799975395251</c:v>
                </c:pt>
                <c:pt idx="3940">
                  <c:v>0.44244996070859699</c:v>
                </c:pt>
                <c:pt idx="3941">
                  <c:v>2.7853001689910997</c:v>
                </c:pt>
                <c:pt idx="3942">
                  <c:v>1.0595500230789483</c:v>
                </c:pt>
                <c:pt idx="3943">
                  <c:v>3.8113500070572499</c:v>
                </c:pt>
                <c:pt idx="3944">
                  <c:v>3.8347999000548967</c:v>
                </c:pt>
                <c:pt idx="3945">
                  <c:v>-3.5824499273300461</c:v>
                </c:pt>
                <c:pt idx="3946">
                  <c:v>1.4527000474929963</c:v>
                </c:pt>
                <c:pt idx="3947">
                  <c:v>1.0088499546051004</c:v>
                </c:pt>
                <c:pt idx="3948">
                  <c:v>2.8945500087737486</c:v>
                </c:pt>
                <c:pt idx="3949">
                  <c:v>3.1045998382568492</c:v>
                </c:pt>
                <c:pt idx="3950">
                  <c:v>1.1189499711989974</c:v>
                </c:pt>
                <c:pt idx="3951">
                  <c:v>1.3526499366760518</c:v>
                </c:pt>
                <c:pt idx="3952">
                  <c:v>2.7841999626159506</c:v>
                </c:pt>
                <c:pt idx="3953">
                  <c:v>-0.12375003814700136</c:v>
                </c:pt>
                <c:pt idx="3954">
                  <c:v>2.4555000162124472</c:v>
                </c:pt>
                <c:pt idx="3955">
                  <c:v>4.2418000221251972</c:v>
                </c:pt>
                <c:pt idx="3956">
                  <c:v>0.93664999485019962</c:v>
                </c:pt>
                <c:pt idx="3957">
                  <c:v>1.2333499670029049</c:v>
                </c:pt>
                <c:pt idx="3958">
                  <c:v>0.5645500326156494</c:v>
                </c:pt>
                <c:pt idx="3959">
                  <c:v>1.4913000059128017</c:v>
                </c:pt>
                <c:pt idx="3960">
                  <c:v>3.1937999773026036</c:v>
                </c:pt>
                <c:pt idx="3961">
                  <c:v>0.2772500038147534</c:v>
                </c:pt>
                <c:pt idx="3962">
                  <c:v>1.2778500032425022</c:v>
                </c:pt>
                <c:pt idx="3963">
                  <c:v>2.5128001070023025</c:v>
                </c:pt>
                <c:pt idx="3964">
                  <c:v>2.9339999675750512</c:v>
                </c:pt>
                <c:pt idx="3965">
                  <c:v>2.0576499891281514</c:v>
                </c:pt>
                <c:pt idx="3966">
                  <c:v>2.0469999742508485</c:v>
                </c:pt>
                <c:pt idx="3967">
                  <c:v>2.1748000669479026</c:v>
                </c:pt>
                <c:pt idx="3968">
                  <c:v>2.0197999954224031</c:v>
                </c:pt>
                <c:pt idx="3969">
                  <c:v>3.3523499917983983</c:v>
                </c:pt>
                <c:pt idx="3970">
                  <c:v>2.7380997943878</c:v>
                </c:pt>
                <c:pt idx="3971">
                  <c:v>-1.4046998691559018</c:v>
                </c:pt>
                <c:pt idx="3972">
                  <c:v>3.1181999635696513</c:v>
                </c:pt>
                <c:pt idx="3973">
                  <c:v>3.2546500253677983</c:v>
                </c:pt>
                <c:pt idx="3974">
                  <c:v>0.74094998836515202</c:v>
                </c:pt>
                <c:pt idx="3975">
                  <c:v>2.3948499202728506</c:v>
                </c:pt>
                <c:pt idx="3976">
                  <c:v>1.4353499650955008</c:v>
                </c:pt>
                <c:pt idx="3977">
                  <c:v>2.4787999629974493</c:v>
                </c:pt>
                <c:pt idx="3978">
                  <c:v>1.2089499187469492</c:v>
                </c:pt>
                <c:pt idx="3979">
                  <c:v>0.37640000343324687</c:v>
                </c:pt>
                <c:pt idx="3980">
                  <c:v>3.078699970245399</c:v>
                </c:pt>
                <c:pt idx="3981">
                  <c:v>1.1960500097274505</c:v>
                </c:pt>
                <c:pt idx="3982">
                  <c:v>1.7871500730514498</c:v>
                </c:pt>
                <c:pt idx="3983">
                  <c:v>2.441949882507302</c:v>
                </c:pt>
                <c:pt idx="3984">
                  <c:v>3.8225500226020515</c:v>
                </c:pt>
                <c:pt idx="3985">
                  <c:v>0.23965009212500377</c:v>
                </c:pt>
                <c:pt idx="3986">
                  <c:v>2.2197499275207484</c:v>
                </c:pt>
                <c:pt idx="3987">
                  <c:v>3.4999499654769544</c:v>
                </c:pt>
                <c:pt idx="3988">
                  <c:v>3.9562000656127481</c:v>
                </c:pt>
                <c:pt idx="3989">
                  <c:v>1.0338499164581023</c:v>
                </c:pt>
                <c:pt idx="3990">
                  <c:v>1.1691999673843512</c:v>
                </c:pt>
                <c:pt idx="3991">
                  <c:v>0.59005000829700194</c:v>
                </c:pt>
                <c:pt idx="3992">
                  <c:v>1.9608000516891479</c:v>
                </c:pt>
                <c:pt idx="3993">
                  <c:v>-0.14189996242524927</c:v>
                </c:pt>
                <c:pt idx="3994">
                  <c:v>3.8657499313355004</c:v>
                </c:pt>
                <c:pt idx="3995">
                  <c:v>1.8580499315261463</c:v>
                </c:pt>
                <c:pt idx="3996">
                  <c:v>3.0899000644683987</c:v>
                </c:pt>
                <c:pt idx="3997">
                  <c:v>1.8193999958038489</c:v>
                </c:pt>
                <c:pt idx="3998">
                  <c:v>1.0873001146316987</c:v>
                </c:pt>
                <c:pt idx="3999">
                  <c:v>0.78655010700224892</c:v>
                </c:pt>
                <c:pt idx="4000">
                  <c:v>-2.7708499479293991</c:v>
                </c:pt>
                <c:pt idx="4001">
                  <c:v>0.70640007972715324</c:v>
                </c:pt>
                <c:pt idx="4002">
                  <c:v>2.3672499227524</c:v>
                </c:pt>
                <c:pt idx="4003">
                  <c:v>0.59764999389649986</c:v>
                </c:pt>
                <c:pt idx="4004">
                  <c:v>1.4625500535964981</c:v>
                </c:pt>
                <c:pt idx="4005">
                  <c:v>0.12525006294250218</c:v>
                </c:pt>
                <c:pt idx="4006">
                  <c:v>2.1277000236511014</c:v>
                </c:pt>
                <c:pt idx="4007">
                  <c:v>1.5919998884200481</c:v>
                </c:pt>
                <c:pt idx="4008">
                  <c:v>3.0276998949051013</c:v>
                </c:pt>
                <c:pt idx="4009">
                  <c:v>-8.6499996185349204E-2</c:v>
                </c:pt>
                <c:pt idx="4010">
                  <c:v>2.0663000488281043</c:v>
                </c:pt>
                <c:pt idx="4011">
                  <c:v>2.6641999673843522</c:v>
                </c:pt>
                <c:pt idx="4012">
                  <c:v>1.9651499128341996</c:v>
                </c:pt>
                <c:pt idx="4013">
                  <c:v>-1.1948000049590526</c:v>
                </c:pt>
                <c:pt idx="4014">
                  <c:v>1.9656501054763993</c:v>
                </c:pt>
                <c:pt idx="4015">
                  <c:v>3.0236000394821048</c:v>
                </c:pt>
                <c:pt idx="4016">
                  <c:v>-0.26919992446899954</c:v>
                </c:pt>
                <c:pt idx="4017">
                  <c:v>-0.19354992389680348</c:v>
                </c:pt>
                <c:pt idx="4018">
                  <c:v>2.6320500636100483</c:v>
                </c:pt>
                <c:pt idx="4019">
                  <c:v>-0.92134993076325244</c:v>
                </c:pt>
                <c:pt idx="4020">
                  <c:v>-0.27220002174374969</c:v>
                </c:pt>
                <c:pt idx="4021">
                  <c:v>3.4608499526977994</c:v>
                </c:pt>
                <c:pt idx="4022">
                  <c:v>0.87109996318819682</c:v>
                </c:pt>
                <c:pt idx="4023">
                  <c:v>3.5621999859809961</c:v>
                </c:pt>
                <c:pt idx="4024">
                  <c:v>0.57835004329680118</c:v>
                </c:pt>
                <c:pt idx="4025">
                  <c:v>2.1524999904632516</c:v>
                </c:pt>
                <c:pt idx="4026">
                  <c:v>3.4104499912261979</c:v>
                </c:pt>
                <c:pt idx="4027">
                  <c:v>1.1679000377655484</c:v>
                </c:pt>
                <c:pt idx="4028">
                  <c:v>-0.91599994659420148</c:v>
                </c:pt>
                <c:pt idx="4029">
                  <c:v>2.3539499855041512</c:v>
                </c:pt>
                <c:pt idx="4030">
                  <c:v>0.96834990501404761</c:v>
                </c:pt>
                <c:pt idx="4031">
                  <c:v>2.0136999368667006</c:v>
                </c:pt>
                <c:pt idx="4032">
                  <c:v>0.96584987163544866</c:v>
                </c:pt>
                <c:pt idx="4033">
                  <c:v>2.708700094223051</c:v>
                </c:pt>
                <c:pt idx="4034">
                  <c:v>2.0461999273300009</c:v>
                </c:pt>
                <c:pt idx="4035">
                  <c:v>0.85845007896424974</c:v>
                </c:pt>
                <c:pt idx="4036">
                  <c:v>2.1858000040054506</c:v>
                </c:pt>
                <c:pt idx="4037">
                  <c:v>3.0277499914169006</c:v>
                </c:pt>
                <c:pt idx="4038">
                  <c:v>0.40064991950984918</c:v>
                </c:pt>
                <c:pt idx="4039">
                  <c:v>0.40064991950984918</c:v>
                </c:pt>
                <c:pt idx="4040">
                  <c:v>3.2336499452590495</c:v>
                </c:pt>
                <c:pt idx="4041">
                  <c:v>-0.23624999046324646</c:v>
                </c:pt>
                <c:pt idx="4042">
                  <c:v>1.3243499803542989</c:v>
                </c:pt>
                <c:pt idx="4043">
                  <c:v>2.035200061798097</c:v>
                </c:pt>
                <c:pt idx="4044">
                  <c:v>3.8197500371932485</c:v>
                </c:pt>
                <c:pt idx="4045">
                  <c:v>0.87180005550385076</c:v>
                </c:pt>
                <c:pt idx="4046">
                  <c:v>1.8030999135971015</c:v>
                </c:pt>
                <c:pt idx="4047">
                  <c:v>-0.35134992599485315</c:v>
                </c:pt>
                <c:pt idx="4048">
                  <c:v>3.024149909019453</c:v>
                </c:pt>
                <c:pt idx="4049">
                  <c:v>2.3988001060486006</c:v>
                </c:pt>
                <c:pt idx="4050">
                  <c:v>1.8569499921798993</c:v>
                </c:pt>
                <c:pt idx="4051">
                  <c:v>2.5183499670029015</c:v>
                </c:pt>
                <c:pt idx="4052">
                  <c:v>4.0427999353408985</c:v>
                </c:pt>
                <c:pt idx="4053">
                  <c:v>0.61005002021790133</c:v>
                </c:pt>
                <c:pt idx="4054">
                  <c:v>-0.76925002098079887</c:v>
                </c:pt>
                <c:pt idx="4055">
                  <c:v>0.81554996967314963</c:v>
                </c:pt>
                <c:pt idx="4056">
                  <c:v>2.3589500904083494</c:v>
                </c:pt>
                <c:pt idx="4057">
                  <c:v>-0.93599987983704835</c:v>
                </c:pt>
                <c:pt idx="4058">
                  <c:v>2.8244000291824491</c:v>
                </c:pt>
                <c:pt idx="4059">
                  <c:v>-0.64454994916914643</c:v>
                </c:pt>
                <c:pt idx="4060">
                  <c:v>2.0876999711990507</c:v>
                </c:pt>
                <c:pt idx="4061">
                  <c:v>2.306949923038502</c:v>
                </c:pt>
                <c:pt idx="4062">
                  <c:v>0.9728500795363999</c:v>
                </c:pt>
                <c:pt idx="4063">
                  <c:v>2.3780500364303983</c:v>
                </c:pt>
                <c:pt idx="4064">
                  <c:v>-1.1246499776840473</c:v>
                </c:pt>
                <c:pt idx="4065">
                  <c:v>2.7344999599456941</c:v>
                </c:pt>
                <c:pt idx="4066">
                  <c:v>1.5110500288010016</c:v>
                </c:pt>
                <c:pt idx="4067">
                  <c:v>-2.5294999217986991</c:v>
                </c:pt>
                <c:pt idx="4068">
                  <c:v>0.85580002784729814</c:v>
                </c:pt>
                <c:pt idx="4069">
                  <c:v>3.4417999887466486</c:v>
                </c:pt>
                <c:pt idx="4070">
                  <c:v>2.1547998809813969</c:v>
                </c:pt>
                <c:pt idx="4071">
                  <c:v>1.3367000246048022</c:v>
                </c:pt>
                <c:pt idx="4072">
                  <c:v>1.4693000984191968</c:v>
                </c:pt>
                <c:pt idx="4073">
                  <c:v>0.22950000286105166</c:v>
                </c:pt>
                <c:pt idx="4074">
                  <c:v>1.120150084495549</c:v>
                </c:pt>
                <c:pt idx="4075">
                  <c:v>-1.2453000259399971</c:v>
                </c:pt>
                <c:pt idx="4076">
                  <c:v>1.3581499576568525</c:v>
                </c:pt>
                <c:pt idx="4077">
                  <c:v>1.6019000434875466</c:v>
                </c:pt>
                <c:pt idx="4078">
                  <c:v>1.5910000562668003</c:v>
                </c:pt>
                <c:pt idx="4079">
                  <c:v>1.8466499280928979</c:v>
                </c:pt>
                <c:pt idx="4080">
                  <c:v>2.7777999019622541</c:v>
                </c:pt>
                <c:pt idx="4081">
                  <c:v>0.77870004653935254</c:v>
                </c:pt>
                <c:pt idx="4082">
                  <c:v>2.6339000368117986</c:v>
                </c:pt>
                <c:pt idx="4083">
                  <c:v>0.9926999855041494</c:v>
                </c:pt>
                <c:pt idx="4084">
                  <c:v>2.3820999240875551</c:v>
                </c:pt>
                <c:pt idx="4085">
                  <c:v>-1.4826999521255502</c:v>
                </c:pt>
                <c:pt idx="4086">
                  <c:v>2.1055500268936029</c:v>
                </c:pt>
                <c:pt idx="4087">
                  <c:v>1.2074499416351507</c:v>
                </c:pt>
                <c:pt idx="4088">
                  <c:v>0.45510001659389587</c:v>
                </c:pt>
                <c:pt idx="4089">
                  <c:v>-0.85465004444124659</c:v>
                </c:pt>
                <c:pt idx="4090">
                  <c:v>2.4293000888824494</c:v>
                </c:pt>
                <c:pt idx="4091">
                  <c:v>1.1101499128341956</c:v>
                </c:pt>
                <c:pt idx="4092">
                  <c:v>2.8191498994827526</c:v>
                </c:pt>
                <c:pt idx="4093">
                  <c:v>2.5300016403150494E-2</c:v>
                </c:pt>
                <c:pt idx="4094">
                  <c:v>1.0006000757217492</c:v>
                </c:pt>
                <c:pt idx="4095">
                  <c:v>1.5868999242782493</c:v>
                </c:pt>
                <c:pt idx="4096">
                  <c:v>4.8291500067710977</c:v>
                </c:pt>
                <c:pt idx="4097">
                  <c:v>2.6914500713347991</c:v>
                </c:pt>
                <c:pt idx="4098">
                  <c:v>0.16494995355609987</c:v>
                </c:pt>
                <c:pt idx="4099">
                  <c:v>-0.96755000591280194</c:v>
                </c:pt>
                <c:pt idx="4100">
                  <c:v>1.9121999788284505</c:v>
                </c:pt>
                <c:pt idx="4101">
                  <c:v>4.1080499601364053</c:v>
                </c:pt>
                <c:pt idx="4102">
                  <c:v>2.2794500207901507</c:v>
                </c:pt>
                <c:pt idx="4103">
                  <c:v>3.1353000640868984</c:v>
                </c:pt>
                <c:pt idx="4104">
                  <c:v>4.1949998521804979</c:v>
                </c:pt>
                <c:pt idx="4105">
                  <c:v>0.4451500463485516</c:v>
                </c:pt>
                <c:pt idx="4106">
                  <c:v>1.8795075641497512</c:v>
                </c:pt>
                <c:pt idx="4107">
                  <c:v>-0.14044994831085233</c:v>
                </c:pt>
                <c:pt idx="4108">
                  <c:v>1.0717499136924999</c:v>
                </c:pt>
                <c:pt idx="4109">
                  <c:v>0.10164993286129942</c:v>
                </c:pt>
                <c:pt idx="4110">
                  <c:v>0.56244986534125019</c:v>
                </c:pt>
                <c:pt idx="4111">
                  <c:v>1.8147999477385994</c:v>
                </c:pt>
                <c:pt idx="4112">
                  <c:v>0.75374987125400139</c:v>
                </c:pt>
                <c:pt idx="4113">
                  <c:v>3.0838499879837507</c:v>
                </c:pt>
                <c:pt idx="4114">
                  <c:v>1.2607999992370509</c:v>
                </c:pt>
                <c:pt idx="4115">
                  <c:v>-4.3788000106811502</c:v>
                </c:pt>
                <c:pt idx="4116">
                  <c:v>2.8877999925613516</c:v>
                </c:pt>
                <c:pt idx="4117">
                  <c:v>7.1168999695778012</c:v>
                </c:pt>
                <c:pt idx="4118">
                  <c:v>1.30195001125335</c:v>
                </c:pt>
                <c:pt idx="4119">
                  <c:v>1.2401999378204493</c:v>
                </c:pt>
                <c:pt idx="4120">
                  <c:v>-1.4346500730515004</c:v>
                </c:pt>
                <c:pt idx="4121">
                  <c:v>-1.8274999332428514</c:v>
                </c:pt>
                <c:pt idx="4122">
                  <c:v>1.1549000024794971</c:v>
                </c:pt>
                <c:pt idx="4123">
                  <c:v>0.73170010566710175</c:v>
                </c:pt>
                <c:pt idx="4124">
                  <c:v>-0.1401000928878986</c:v>
                </c:pt>
                <c:pt idx="4125">
                  <c:v>2.3429000473022477</c:v>
                </c:pt>
                <c:pt idx="4126">
                  <c:v>2.3429000473022477</c:v>
                </c:pt>
                <c:pt idx="4127">
                  <c:v>-4.9199919700598116E-2</c:v>
                </c:pt>
                <c:pt idx="4128">
                  <c:v>0.39020002841949974</c:v>
                </c:pt>
                <c:pt idx="4129">
                  <c:v>1.5088999891280999</c:v>
                </c:pt>
                <c:pt idx="4130">
                  <c:v>-0.87685001373290206</c:v>
                </c:pt>
                <c:pt idx="4131">
                  <c:v>0.22625004291534978</c:v>
                </c:pt>
                <c:pt idx="4132">
                  <c:v>-1.8280499458312995</c:v>
                </c:pt>
                <c:pt idx="4133">
                  <c:v>2.2171000480652019</c:v>
                </c:pt>
                <c:pt idx="4134">
                  <c:v>-0.48765004158015302</c:v>
                </c:pt>
                <c:pt idx="4135">
                  <c:v>1.8686000370979485</c:v>
                </c:pt>
                <c:pt idx="4136">
                  <c:v>3.2227999734878452</c:v>
                </c:pt>
                <c:pt idx="4137">
                  <c:v>0.74410007953644808</c:v>
                </c:pt>
                <c:pt idx="4138">
                  <c:v>1.4607500791550017</c:v>
                </c:pt>
                <c:pt idx="4139">
                  <c:v>2.0797499275208011</c:v>
                </c:pt>
                <c:pt idx="4140">
                  <c:v>1.1970999860763527</c:v>
                </c:pt>
                <c:pt idx="4141">
                  <c:v>4.0953000354767006</c:v>
                </c:pt>
                <c:pt idx="4142">
                  <c:v>-0.42569999217985099</c:v>
                </c:pt>
                <c:pt idx="4143">
                  <c:v>0.25015002250670193</c:v>
                </c:pt>
                <c:pt idx="4144">
                  <c:v>-2.6254999399184982</c:v>
                </c:pt>
                <c:pt idx="4145">
                  <c:v>-5.8500099181983956E-3</c:v>
                </c:pt>
                <c:pt idx="4146">
                  <c:v>1.1223498964309471</c:v>
                </c:pt>
                <c:pt idx="4147">
                  <c:v>0.38745001792904787</c:v>
                </c:pt>
                <c:pt idx="4148">
                  <c:v>1.9460000181198005</c:v>
                </c:pt>
                <c:pt idx="4149">
                  <c:v>1.9698999977112024</c:v>
                </c:pt>
                <c:pt idx="4150">
                  <c:v>0.71230000495915391</c:v>
                </c:pt>
                <c:pt idx="4151">
                  <c:v>-1.3041499948501496</c:v>
                </c:pt>
                <c:pt idx="4152">
                  <c:v>0.19894997119899926</c:v>
                </c:pt>
                <c:pt idx="4153">
                  <c:v>3.2023998594284002</c:v>
                </c:pt>
                <c:pt idx="4154">
                  <c:v>2.6154499483108502</c:v>
                </c:pt>
                <c:pt idx="4155">
                  <c:v>-0.97009998798364805</c:v>
                </c:pt>
                <c:pt idx="4156">
                  <c:v>1.8869500637053989</c:v>
                </c:pt>
                <c:pt idx="4157">
                  <c:v>1.9522999715805511</c:v>
                </c:pt>
                <c:pt idx="4158">
                  <c:v>0.84185006618499969</c:v>
                </c:pt>
                <c:pt idx="4159">
                  <c:v>4.1434499597549497</c:v>
                </c:pt>
                <c:pt idx="4160">
                  <c:v>-0.13010011196135096</c:v>
                </c:pt>
                <c:pt idx="4161">
                  <c:v>2.0086499929428001</c:v>
                </c:pt>
                <c:pt idx="4162">
                  <c:v>2.6295499467849517</c:v>
                </c:pt>
                <c:pt idx="4163">
                  <c:v>-1.3179500913620004</c:v>
                </c:pt>
                <c:pt idx="4164">
                  <c:v>0.84424991607670208</c:v>
                </c:pt>
                <c:pt idx="4165">
                  <c:v>-1.0167998600006527</c:v>
                </c:pt>
                <c:pt idx="4166">
                  <c:v>1.9238000869750991</c:v>
                </c:pt>
                <c:pt idx="4167">
                  <c:v>0.79559998035430368</c:v>
                </c:pt>
                <c:pt idx="4168">
                  <c:v>0.53150006294250218</c:v>
                </c:pt>
                <c:pt idx="4169">
                  <c:v>1.3717500114440995</c:v>
                </c:pt>
                <c:pt idx="4170">
                  <c:v>0.65320001602174926</c:v>
                </c:pt>
                <c:pt idx="4171">
                  <c:v>0.58814998149874853</c:v>
                </c:pt>
                <c:pt idx="4172">
                  <c:v>-0.71605000495910076</c:v>
                </c:pt>
                <c:pt idx="4173">
                  <c:v>1.9060499262809962</c:v>
                </c:pt>
                <c:pt idx="4174">
                  <c:v>1.486350102424602</c:v>
                </c:pt>
                <c:pt idx="4175">
                  <c:v>0.35789993762964656</c:v>
                </c:pt>
                <c:pt idx="4176">
                  <c:v>1.6915001034736505</c:v>
                </c:pt>
                <c:pt idx="4177">
                  <c:v>0.96390002250669937</c:v>
                </c:pt>
                <c:pt idx="4178">
                  <c:v>0.96390002250669937</c:v>
                </c:pt>
                <c:pt idx="4179">
                  <c:v>1.4235501527786489</c:v>
                </c:pt>
                <c:pt idx="4180">
                  <c:v>0.45714997768404686</c:v>
                </c:pt>
                <c:pt idx="4181">
                  <c:v>-2.4708500766754042</c:v>
                </c:pt>
                <c:pt idx="4182">
                  <c:v>2.7838000726699477</c:v>
                </c:pt>
                <c:pt idx="4183">
                  <c:v>1.2759500360488509</c:v>
                </c:pt>
                <c:pt idx="4184">
                  <c:v>1.1573999309539502</c:v>
                </c:pt>
                <c:pt idx="4185">
                  <c:v>3.0712500977516015</c:v>
                </c:pt>
                <c:pt idx="4186">
                  <c:v>4.164999485015386E-2</c:v>
                </c:pt>
                <c:pt idx="4187">
                  <c:v>4.164999485015386E-2</c:v>
                </c:pt>
                <c:pt idx="4188">
                  <c:v>1.6340500211715998</c:v>
                </c:pt>
                <c:pt idx="4189">
                  <c:v>2.1642500638961479</c:v>
                </c:pt>
                <c:pt idx="4190">
                  <c:v>-0.60419985771179796</c:v>
                </c:pt>
                <c:pt idx="4191">
                  <c:v>1.6275000190734978</c:v>
                </c:pt>
                <c:pt idx="4192">
                  <c:v>0.78904991149904902</c:v>
                </c:pt>
                <c:pt idx="4193">
                  <c:v>-2.0105999517440516</c:v>
                </c:pt>
                <c:pt idx="4194">
                  <c:v>2.8554500198364536</c:v>
                </c:pt>
                <c:pt idx="4195">
                  <c:v>0.46639993190764883</c:v>
                </c:pt>
                <c:pt idx="4196">
                  <c:v>3.5506000471115513</c:v>
                </c:pt>
                <c:pt idx="4197">
                  <c:v>3.3787500286102521</c:v>
                </c:pt>
                <c:pt idx="4198">
                  <c:v>1.7864500093459981</c:v>
                </c:pt>
                <c:pt idx="4199">
                  <c:v>0.49449991703034613</c:v>
                </c:pt>
                <c:pt idx="4200">
                  <c:v>0.71619993209839805</c:v>
                </c:pt>
                <c:pt idx="4201">
                  <c:v>1.9776500749587989</c:v>
                </c:pt>
                <c:pt idx="4202">
                  <c:v>0.59670005321500241</c:v>
                </c:pt>
                <c:pt idx="4203">
                  <c:v>3.4680499792099013</c:v>
                </c:pt>
                <c:pt idx="4204">
                  <c:v>-0.80454998970029834</c:v>
                </c:pt>
                <c:pt idx="4205">
                  <c:v>1.2850141525298397E-2</c:v>
                </c:pt>
                <c:pt idx="4206">
                  <c:v>3.7723000860213958</c:v>
                </c:pt>
                <c:pt idx="4207">
                  <c:v>-8.5999917984018737E-3</c:v>
                </c:pt>
                <c:pt idx="4208">
                  <c:v>3.6492000055312985</c:v>
                </c:pt>
                <c:pt idx="4209">
                  <c:v>0.31929997444154878</c:v>
                </c:pt>
                <c:pt idx="4210">
                  <c:v>1.7024500036240013</c:v>
                </c:pt>
                <c:pt idx="4211">
                  <c:v>-2.3430499219894472</c:v>
                </c:pt>
                <c:pt idx="4212">
                  <c:v>1.1375000762939997</c:v>
                </c:pt>
                <c:pt idx="4213">
                  <c:v>-9.8500027656548639E-2</c:v>
                </c:pt>
                <c:pt idx="4214">
                  <c:v>1.6401500988006532</c:v>
                </c:pt>
                <c:pt idx="4215">
                  <c:v>-1.3634999608993503</c:v>
                </c:pt>
                <c:pt idx="4216">
                  <c:v>1.8856500816345516</c:v>
                </c:pt>
                <c:pt idx="4217">
                  <c:v>1.8856500816345516</c:v>
                </c:pt>
                <c:pt idx="4218">
                  <c:v>2.0178000020980491</c:v>
                </c:pt>
                <c:pt idx="4219">
                  <c:v>1.6387999129295991</c:v>
                </c:pt>
                <c:pt idx="4220">
                  <c:v>1.6387999129295991</c:v>
                </c:pt>
                <c:pt idx="4221">
                  <c:v>0.60149992465970215</c:v>
                </c:pt>
                <c:pt idx="4222">
                  <c:v>1.3891500234604024</c:v>
                </c:pt>
                <c:pt idx="4223">
                  <c:v>2.5167999362945466</c:v>
                </c:pt>
                <c:pt idx="4224">
                  <c:v>-1.9788499546050957</c:v>
                </c:pt>
                <c:pt idx="4225">
                  <c:v>0.75319986343390255</c:v>
                </c:pt>
                <c:pt idx="4226">
                  <c:v>-1.6385000324249503</c:v>
                </c:pt>
                <c:pt idx="4227">
                  <c:v>1.2563000917434515</c:v>
                </c:pt>
                <c:pt idx="4228">
                  <c:v>-0.31364999771114555</c:v>
                </c:pt>
                <c:pt idx="4229">
                  <c:v>1.2332999420166004</c:v>
                </c:pt>
                <c:pt idx="4230">
                  <c:v>0.60245003700260114</c:v>
                </c:pt>
                <c:pt idx="4231">
                  <c:v>1.3590499782562517</c:v>
                </c:pt>
                <c:pt idx="4232">
                  <c:v>0.50980002880094943</c:v>
                </c:pt>
                <c:pt idx="4233">
                  <c:v>-3.9563999605178495</c:v>
                </c:pt>
                <c:pt idx="4234">
                  <c:v>1.3974499845505051</c:v>
                </c:pt>
                <c:pt idx="4235">
                  <c:v>-1.3581000280380486</c:v>
                </c:pt>
                <c:pt idx="4236">
                  <c:v>1.3611999464034952</c:v>
                </c:pt>
                <c:pt idx="4237">
                  <c:v>-0.37570014953610098</c:v>
                </c:pt>
                <c:pt idx="4238">
                  <c:v>3.5979999923705996</c:v>
                </c:pt>
                <c:pt idx="4239">
                  <c:v>0.81494999885559949</c:v>
                </c:pt>
                <c:pt idx="4240">
                  <c:v>1.3778500127792483</c:v>
                </c:pt>
                <c:pt idx="4241">
                  <c:v>-0.4174999094010019</c:v>
                </c:pt>
                <c:pt idx="4242">
                  <c:v>1.8943999624251973</c:v>
                </c:pt>
                <c:pt idx="4243">
                  <c:v>3.5399990081749877E-2</c:v>
                </c:pt>
                <c:pt idx="4244">
                  <c:v>2.1102500963211526</c:v>
                </c:pt>
                <c:pt idx="4245">
                  <c:v>-1.3853500080108994</c:v>
                </c:pt>
                <c:pt idx="4246">
                  <c:v>3.1259999799727964</c:v>
                </c:pt>
                <c:pt idx="4247">
                  <c:v>0.91634996414190084</c:v>
                </c:pt>
                <c:pt idx="4248">
                  <c:v>2.2110499525070004</c:v>
                </c:pt>
                <c:pt idx="4249">
                  <c:v>-0.30160013675690323</c:v>
                </c:pt>
                <c:pt idx="4250">
                  <c:v>2.6587999868392984</c:v>
                </c:pt>
                <c:pt idx="4251">
                  <c:v>0.64804994583124653</c:v>
                </c:pt>
                <c:pt idx="4252">
                  <c:v>1.9484499692917012</c:v>
                </c:pt>
                <c:pt idx="4253">
                  <c:v>1.3630000925063968</c:v>
                </c:pt>
                <c:pt idx="4254">
                  <c:v>-0.63465003967285227</c:v>
                </c:pt>
                <c:pt idx="4255">
                  <c:v>8.69999885560091E-3</c:v>
                </c:pt>
                <c:pt idx="4256">
                  <c:v>2.2033000373840004</c:v>
                </c:pt>
                <c:pt idx="4257">
                  <c:v>0.8464499855042007</c:v>
                </c:pt>
                <c:pt idx="4258">
                  <c:v>-0.89959999084469899</c:v>
                </c:pt>
                <c:pt idx="4259">
                  <c:v>-0.81230003833774589</c:v>
                </c:pt>
                <c:pt idx="4260">
                  <c:v>-0.54514997959135414</c:v>
                </c:pt>
                <c:pt idx="4261">
                  <c:v>3.3188001394272</c:v>
                </c:pt>
                <c:pt idx="4262">
                  <c:v>0.28425005912785295</c:v>
                </c:pt>
                <c:pt idx="4263">
                  <c:v>2.3264500045776515</c:v>
                </c:pt>
                <c:pt idx="4264">
                  <c:v>1.3491499805450964</c:v>
                </c:pt>
                <c:pt idx="4265">
                  <c:v>0.58805016994475068</c:v>
                </c:pt>
                <c:pt idx="4266">
                  <c:v>-0.3255500602722492</c:v>
                </c:pt>
                <c:pt idx="4267">
                  <c:v>-0.34539997100824849</c:v>
                </c:pt>
                <c:pt idx="4268">
                  <c:v>3.6130499410629007</c:v>
                </c:pt>
                <c:pt idx="4269">
                  <c:v>3.0345500135422014</c:v>
                </c:pt>
                <c:pt idx="4270">
                  <c:v>1.097449967861202</c:v>
                </c:pt>
                <c:pt idx="4271">
                  <c:v>1.4646000146866029</c:v>
                </c:pt>
                <c:pt idx="4272">
                  <c:v>1.1524001264571986</c:v>
                </c:pt>
                <c:pt idx="4273">
                  <c:v>2.0534500026702531</c:v>
                </c:pt>
                <c:pt idx="4274">
                  <c:v>1.5912999773025973</c:v>
                </c:pt>
                <c:pt idx="4275">
                  <c:v>2.4515999746322485</c:v>
                </c:pt>
                <c:pt idx="4276">
                  <c:v>1.5528000116348508</c:v>
                </c:pt>
                <c:pt idx="4277">
                  <c:v>-1.2394000291824518</c:v>
                </c:pt>
                <c:pt idx="4278">
                  <c:v>2.4486999511718999</c:v>
                </c:pt>
                <c:pt idx="4279">
                  <c:v>2.2760000228881978</c:v>
                </c:pt>
                <c:pt idx="4280">
                  <c:v>-0.30390004158019934</c:v>
                </c:pt>
                <c:pt idx="4281">
                  <c:v>1.0625500202178983</c:v>
                </c:pt>
                <c:pt idx="4282">
                  <c:v>0.14895007133485194</c:v>
                </c:pt>
                <c:pt idx="4283">
                  <c:v>0.71255002975460258</c:v>
                </c:pt>
                <c:pt idx="4284">
                  <c:v>2.0750000715256007</c:v>
                </c:pt>
                <c:pt idx="4285">
                  <c:v>2.2020000648497984</c:v>
                </c:pt>
                <c:pt idx="4286">
                  <c:v>3.0448500132561023</c:v>
                </c:pt>
                <c:pt idx="4287">
                  <c:v>1.6512000036239982</c:v>
                </c:pt>
                <c:pt idx="4288">
                  <c:v>0.10644994735720203</c:v>
                </c:pt>
                <c:pt idx="4289">
                  <c:v>2.1895500969887038</c:v>
                </c:pt>
                <c:pt idx="4290">
                  <c:v>-0.99969996452335153</c:v>
                </c:pt>
                <c:pt idx="4291">
                  <c:v>1.675049991607704</c:v>
                </c:pt>
                <c:pt idx="4292">
                  <c:v>0.15810005187984899</c:v>
                </c:pt>
                <c:pt idx="4293">
                  <c:v>0.56815004825590165</c:v>
                </c:pt>
                <c:pt idx="4294">
                  <c:v>0.94394994258885134</c:v>
                </c:pt>
                <c:pt idx="4295">
                  <c:v>-1.467400059700001</c:v>
                </c:pt>
                <c:pt idx="4296">
                  <c:v>4.4065000581741494</c:v>
                </c:pt>
                <c:pt idx="4297">
                  <c:v>0.26985002279285197</c:v>
                </c:pt>
                <c:pt idx="4298">
                  <c:v>0.73895006656654871</c:v>
                </c:pt>
                <c:pt idx="4299">
                  <c:v>9.4450078010545724E-2</c:v>
                </c:pt>
                <c:pt idx="4300">
                  <c:v>0.14985003948214626</c:v>
                </c:pt>
                <c:pt idx="4301">
                  <c:v>1.1443500471115513</c:v>
                </c:pt>
                <c:pt idx="4302">
                  <c:v>1.7382500839233508</c:v>
                </c:pt>
                <c:pt idx="4303">
                  <c:v>1.5547500038146964</c:v>
                </c:pt>
                <c:pt idx="4304">
                  <c:v>9.4899973869353005E-2</c:v>
                </c:pt>
                <c:pt idx="4305">
                  <c:v>0.75064988136290012</c:v>
                </c:pt>
                <c:pt idx="4306">
                  <c:v>2.7161000061035487</c:v>
                </c:pt>
                <c:pt idx="4307">
                  <c:v>1.7961499738693512</c:v>
                </c:pt>
                <c:pt idx="4308">
                  <c:v>0.94475521920414707</c:v>
                </c:pt>
                <c:pt idx="4309">
                  <c:v>1.1467499971389472</c:v>
                </c:pt>
                <c:pt idx="4310">
                  <c:v>-2.0971499729156946</c:v>
                </c:pt>
                <c:pt idx="4311">
                  <c:v>-2.6249947547903218E-2</c:v>
                </c:pt>
                <c:pt idx="4312">
                  <c:v>0.61755003452304891</c:v>
                </c:pt>
                <c:pt idx="4313">
                  <c:v>1.7085999608039515</c:v>
                </c:pt>
                <c:pt idx="4314">
                  <c:v>-1.4049978256249318E-2</c:v>
                </c:pt>
                <c:pt idx="4315">
                  <c:v>2.6434500360489466</c:v>
                </c:pt>
                <c:pt idx="4316">
                  <c:v>0.68604999065394878</c:v>
                </c:pt>
                <c:pt idx="4317">
                  <c:v>-4.1199922561702351E-2</c:v>
                </c:pt>
                <c:pt idx="4318">
                  <c:v>-0.33139995574950021</c:v>
                </c:pt>
                <c:pt idx="4319">
                  <c:v>2.2526498794555501</c:v>
                </c:pt>
                <c:pt idx="4320">
                  <c:v>3.1190500068664484</c:v>
                </c:pt>
                <c:pt idx="4321">
                  <c:v>-0.49315000534054931</c:v>
                </c:pt>
                <c:pt idx="4322">
                  <c:v>1.8998000097274996</c:v>
                </c:pt>
                <c:pt idx="4323">
                  <c:v>0.18599995613094933</c:v>
                </c:pt>
                <c:pt idx="4324">
                  <c:v>3.1134998989104972</c:v>
                </c:pt>
                <c:pt idx="4325">
                  <c:v>2.1457500600814505</c:v>
                </c:pt>
                <c:pt idx="4326">
                  <c:v>2.438599929809552</c:v>
                </c:pt>
                <c:pt idx="4327">
                  <c:v>2.5264500617980978</c:v>
                </c:pt>
                <c:pt idx="4328">
                  <c:v>1.2725499773025497</c:v>
                </c:pt>
                <c:pt idx="4329">
                  <c:v>1.5025999927520495</c:v>
                </c:pt>
                <c:pt idx="4330">
                  <c:v>3.5074500751495492</c:v>
                </c:pt>
                <c:pt idx="4331">
                  <c:v>-0.21070000171659586</c:v>
                </c:pt>
                <c:pt idx="4332">
                  <c:v>-2.2698499107361521</c:v>
                </c:pt>
                <c:pt idx="4333">
                  <c:v>3.4643001604081007</c:v>
                </c:pt>
                <c:pt idx="4334">
                  <c:v>0.42860000133514831</c:v>
                </c:pt>
                <c:pt idx="4335">
                  <c:v>2.4614499378203973</c:v>
                </c:pt>
                <c:pt idx="4336">
                  <c:v>2.2518999719620005</c:v>
                </c:pt>
                <c:pt idx="4337">
                  <c:v>0.10985001564024799</c:v>
                </c:pt>
                <c:pt idx="4338">
                  <c:v>-0.15680000305174957</c:v>
                </c:pt>
                <c:pt idx="4339">
                  <c:v>0.75249991655349646</c:v>
                </c:pt>
                <c:pt idx="4340">
                  <c:v>1.2402999782562496</c:v>
                </c:pt>
                <c:pt idx="4341">
                  <c:v>1.8511000585555948</c:v>
                </c:pt>
                <c:pt idx="4342">
                  <c:v>-0.14629997253420157</c:v>
                </c:pt>
                <c:pt idx="4343">
                  <c:v>0.72509996891020023</c:v>
                </c:pt>
                <c:pt idx="4344">
                  <c:v>1.7016999101638994</c:v>
                </c:pt>
                <c:pt idx="4345">
                  <c:v>1.0346000480652506</c:v>
                </c:pt>
                <c:pt idx="4346">
                  <c:v>2.1375500059128001</c:v>
                </c:pt>
                <c:pt idx="4347">
                  <c:v>-6.0950012207001691E-2</c:v>
                </c:pt>
                <c:pt idx="4348">
                  <c:v>2.2515499258041487</c:v>
                </c:pt>
                <c:pt idx="4349">
                  <c:v>1.0505500268936494</c:v>
                </c:pt>
                <c:pt idx="4350">
                  <c:v>1.893949918746948</c:v>
                </c:pt>
                <c:pt idx="4351">
                  <c:v>1.5654499554634498</c:v>
                </c:pt>
                <c:pt idx="4352">
                  <c:v>0.18595009326935141</c:v>
                </c:pt>
                <c:pt idx="4353">
                  <c:v>1.2996000003814991</c:v>
                </c:pt>
                <c:pt idx="4354">
                  <c:v>0.51614997386934647</c:v>
                </c:pt>
                <c:pt idx="4355">
                  <c:v>1.2935500526428498</c:v>
                </c:pt>
                <c:pt idx="4356">
                  <c:v>1.0947999858856008</c:v>
                </c:pt>
                <c:pt idx="4357">
                  <c:v>0.77249995231625235</c:v>
                </c:pt>
                <c:pt idx="4358">
                  <c:v>2.5475000309943994</c:v>
                </c:pt>
                <c:pt idx="4359">
                  <c:v>-1.3507499313354501</c:v>
                </c:pt>
                <c:pt idx="4360">
                  <c:v>-3.6704499483108464</c:v>
                </c:pt>
                <c:pt idx="4361">
                  <c:v>1.4157999849319012</c:v>
                </c:pt>
                <c:pt idx="4362">
                  <c:v>-0.56014999389644871</c:v>
                </c:pt>
                <c:pt idx="4363">
                  <c:v>0.21260000705720472</c:v>
                </c:pt>
                <c:pt idx="4364">
                  <c:v>1.8585999822617012</c:v>
                </c:pt>
                <c:pt idx="4365">
                  <c:v>2.0427500581741498</c:v>
                </c:pt>
                <c:pt idx="4366">
                  <c:v>-0.88645008563999994</c:v>
                </c:pt>
                <c:pt idx="4367">
                  <c:v>2.5792998981475961</c:v>
                </c:pt>
                <c:pt idx="4368">
                  <c:v>1.8698500251769978</c:v>
                </c:pt>
                <c:pt idx="4369">
                  <c:v>0.14255002975469822</c:v>
                </c:pt>
                <c:pt idx="4370">
                  <c:v>0.94395009040830047</c:v>
                </c:pt>
                <c:pt idx="4371">
                  <c:v>1.8437000703810966</c:v>
                </c:pt>
                <c:pt idx="4372">
                  <c:v>1.602100057601902</c:v>
                </c:pt>
                <c:pt idx="4373">
                  <c:v>0.35734996795650176</c:v>
                </c:pt>
                <c:pt idx="4374">
                  <c:v>4.4088000488281516</c:v>
                </c:pt>
                <c:pt idx="4375">
                  <c:v>3.5568500328064516</c:v>
                </c:pt>
                <c:pt idx="4376">
                  <c:v>-3.6700081825198794E-2</c:v>
                </c:pt>
                <c:pt idx="4377">
                  <c:v>-1.9210499286651483</c:v>
                </c:pt>
                <c:pt idx="4378">
                  <c:v>-4.7700052261347992E-2</c:v>
                </c:pt>
                <c:pt idx="4379">
                  <c:v>-0.53694989681245175</c:v>
                </c:pt>
                <c:pt idx="4380">
                  <c:v>-1.7804500484466033</c:v>
                </c:pt>
                <c:pt idx="4381">
                  <c:v>-1.0307499790191486</c:v>
                </c:pt>
                <c:pt idx="4382">
                  <c:v>0.87549995660780056</c:v>
                </c:pt>
                <c:pt idx="4383">
                  <c:v>-0.19579998493200179</c:v>
                </c:pt>
                <c:pt idx="4384">
                  <c:v>1.0222000169754502</c:v>
                </c:pt>
                <c:pt idx="4385">
                  <c:v>9.4999966621447385E-2</c:v>
                </c:pt>
                <c:pt idx="4386">
                  <c:v>2.9961499786376997</c:v>
                </c:pt>
                <c:pt idx="4387">
                  <c:v>1.1734998893737973</c:v>
                </c:pt>
                <c:pt idx="4388">
                  <c:v>2.1530998921394513</c:v>
                </c:pt>
                <c:pt idx="4389">
                  <c:v>0.63350006103515</c:v>
                </c:pt>
                <c:pt idx="4390">
                  <c:v>0.98829994678495225</c:v>
                </c:pt>
                <c:pt idx="4391">
                  <c:v>-1.2996499729156525</c:v>
                </c:pt>
                <c:pt idx="4392">
                  <c:v>-0.27175008058545203</c:v>
                </c:pt>
                <c:pt idx="4393">
                  <c:v>0.26914997100830362</c:v>
                </c:pt>
                <c:pt idx="4394">
                  <c:v>0.70759998321535278</c:v>
                </c:pt>
                <c:pt idx="4395">
                  <c:v>2.7113000154495026</c:v>
                </c:pt>
                <c:pt idx="4396">
                  <c:v>0.44614990234374829</c:v>
                </c:pt>
                <c:pt idx="4397">
                  <c:v>2.4257998228072992</c:v>
                </c:pt>
                <c:pt idx="4398">
                  <c:v>0.14479995250700028</c:v>
                </c:pt>
                <c:pt idx="4399">
                  <c:v>1.4669500684738495</c:v>
                </c:pt>
                <c:pt idx="4400">
                  <c:v>-1.3522001218795481</c:v>
                </c:pt>
                <c:pt idx="4401">
                  <c:v>-2.482750005722</c:v>
                </c:pt>
                <c:pt idx="4402">
                  <c:v>-0.15805008411410171</c:v>
                </c:pt>
                <c:pt idx="4403">
                  <c:v>-1.313649976253501</c:v>
                </c:pt>
                <c:pt idx="4404">
                  <c:v>-1.9339325374431979</c:v>
                </c:pt>
                <c:pt idx="4405">
                  <c:v>1.28515001297</c:v>
                </c:pt>
                <c:pt idx="4406">
                  <c:v>1.2497500371933477</c:v>
                </c:pt>
                <c:pt idx="4407">
                  <c:v>2.1366999363898991</c:v>
                </c:pt>
                <c:pt idx="4408">
                  <c:v>-0.49990001678470009</c:v>
                </c:pt>
                <c:pt idx="4409">
                  <c:v>-0.51665009498594827</c:v>
                </c:pt>
                <c:pt idx="4410">
                  <c:v>-0.66735002040865155</c:v>
                </c:pt>
                <c:pt idx="4411">
                  <c:v>1.3451000380515481</c:v>
                </c:pt>
                <c:pt idx="4412">
                  <c:v>-6.4447000026703023</c:v>
                </c:pt>
                <c:pt idx="4413">
                  <c:v>0.74980000019075277</c:v>
                </c:pt>
                <c:pt idx="4414">
                  <c:v>9.4700117111148785E-2</c:v>
                </c:pt>
                <c:pt idx="4415">
                  <c:v>1.1431499147414996</c:v>
                </c:pt>
                <c:pt idx="4416">
                  <c:v>0.48249999046329606</c:v>
                </c:pt>
                <c:pt idx="4417">
                  <c:v>1.1889500188827995</c:v>
                </c:pt>
                <c:pt idx="4418">
                  <c:v>0.14164997100830234</c:v>
                </c:pt>
                <c:pt idx="4419">
                  <c:v>0.22265011787414934</c:v>
                </c:pt>
                <c:pt idx="4420">
                  <c:v>1.0064999961853509</c:v>
                </c:pt>
                <c:pt idx="4421">
                  <c:v>-0.35979998588560136</c:v>
                </c:pt>
                <c:pt idx="4422">
                  <c:v>-1.0548999834060986</c:v>
                </c:pt>
                <c:pt idx="4423">
                  <c:v>2.5900500535964994</c:v>
                </c:pt>
                <c:pt idx="4424">
                  <c:v>3.2929000139236493</c:v>
                </c:pt>
                <c:pt idx="4425">
                  <c:v>0.60439990043640535</c:v>
                </c:pt>
                <c:pt idx="4426">
                  <c:v>-2.6016498970985005</c:v>
                </c:pt>
                <c:pt idx="4427">
                  <c:v>0.51510006904599948</c:v>
                </c:pt>
                <c:pt idx="4428">
                  <c:v>1.0199999141693006</c:v>
                </c:pt>
                <c:pt idx="4429">
                  <c:v>2.466049962043801</c:v>
                </c:pt>
                <c:pt idx="4430">
                  <c:v>-0.1234500885009524</c:v>
                </c:pt>
                <c:pt idx="4431">
                  <c:v>1.228750071525603</c:v>
                </c:pt>
                <c:pt idx="4432">
                  <c:v>0.48074997901914784</c:v>
                </c:pt>
                <c:pt idx="4433">
                  <c:v>0.53220010757449998</c:v>
                </c:pt>
                <c:pt idx="4434">
                  <c:v>1.7293000411987478</c:v>
                </c:pt>
                <c:pt idx="4435">
                  <c:v>1.6493500804901018</c:v>
                </c:pt>
                <c:pt idx="4436">
                  <c:v>-1.3013999986648486</c:v>
                </c:pt>
                <c:pt idx="4437">
                  <c:v>0.24944994926449837</c:v>
                </c:pt>
                <c:pt idx="4438">
                  <c:v>-1.3594500732421473</c:v>
                </c:pt>
                <c:pt idx="4439">
                  <c:v>0.20710004806520033</c:v>
                </c:pt>
                <c:pt idx="4440">
                  <c:v>0.85065002918244659</c:v>
                </c:pt>
                <c:pt idx="4441">
                  <c:v>-0.71079990386964909</c:v>
                </c:pt>
                <c:pt idx="4442">
                  <c:v>2.0256000041962032</c:v>
                </c:pt>
                <c:pt idx="4443">
                  <c:v>-2.9718001461029004</c:v>
                </c:pt>
                <c:pt idx="4444">
                  <c:v>0.10399993419644815</c:v>
                </c:pt>
                <c:pt idx="4445">
                  <c:v>1.9756000280380022</c:v>
                </c:pt>
                <c:pt idx="4446">
                  <c:v>0.49249992847439827</c:v>
                </c:pt>
                <c:pt idx="4447">
                  <c:v>1.0830501651764024</c:v>
                </c:pt>
                <c:pt idx="4448">
                  <c:v>-0.23819999217990073</c:v>
                </c:pt>
                <c:pt idx="4449">
                  <c:v>0.80050008296969821</c:v>
                </c:pt>
                <c:pt idx="4450">
                  <c:v>-2.7748999738693492</c:v>
                </c:pt>
                <c:pt idx="4451">
                  <c:v>2.0914001131057525</c:v>
                </c:pt>
                <c:pt idx="4452">
                  <c:v>3.1501999425888023</c:v>
                </c:pt>
                <c:pt idx="4453">
                  <c:v>0.49319997787475245</c:v>
                </c:pt>
                <c:pt idx="4454">
                  <c:v>1.6863999938965009</c:v>
                </c:pt>
                <c:pt idx="4455">
                  <c:v>0.62579998016354921</c:v>
                </c:pt>
                <c:pt idx="4456">
                  <c:v>0.74824989795684616</c:v>
                </c:pt>
                <c:pt idx="4457">
                  <c:v>-1.0616500759124499</c:v>
                </c:pt>
                <c:pt idx="4458">
                  <c:v>-0.98604996204375084</c:v>
                </c:pt>
                <c:pt idx="4459">
                  <c:v>0.92474993705754827</c:v>
                </c:pt>
                <c:pt idx="4460">
                  <c:v>0.64505001544950247</c:v>
                </c:pt>
                <c:pt idx="4461">
                  <c:v>-1.7019500064849993</c:v>
                </c:pt>
                <c:pt idx="4462">
                  <c:v>-0.49314997196200139</c:v>
                </c:pt>
                <c:pt idx="4463">
                  <c:v>-0.10535015344619936</c:v>
                </c:pt>
                <c:pt idx="4464">
                  <c:v>2.3027500724793022</c:v>
                </c:pt>
                <c:pt idx="4465">
                  <c:v>0.50250003814694821</c:v>
                </c:pt>
                <c:pt idx="4466">
                  <c:v>-0.94824990272524801</c:v>
                </c:pt>
                <c:pt idx="4467">
                  <c:v>1.1534999561309469</c:v>
                </c:pt>
                <c:pt idx="4468">
                  <c:v>2.5894500398636033</c:v>
                </c:pt>
                <c:pt idx="4469">
                  <c:v>2.327350025177001</c:v>
                </c:pt>
                <c:pt idx="4470">
                  <c:v>0.8653499269485998</c:v>
                </c:pt>
                <c:pt idx="4471">
                  <c:v>0.76340003013610058</c:v>
                </c:pt>
                <c:pt idx="4472">
                  <c:v>0.83305001258844769</c:v>
                </c:pt>
                <c:pt idx="4473">
                  <c:v>2.7777501058578551</c:v>
                </c:pt>
                <c:pt idx="4474">
                  <c:v>-0.76749996662140063</c:v>
                </c:pt>
                <c:pt idx="4475">
                  <c:v>3.3981500196457013</c:v>
                </c:pt>
                <c:pt idx="4476">
                  <c:v>-0.64335010528565206</c:v>
                </c:pt>
                <c:pt idx="4477">
                  <c:v>2.1312500429153971</c:v>
                </c:pt>
                <c:pt idx="4478">
                  <c:v>1.1250998330115998</c:v>
                </c:pt>
                <c:pt idx="4479">
                  <c:v>1.5239000082016005</c:v>
                </c:pt>
                <c:pt idx="4480">
                  <c:v>2.8082999897003518</c:v>
                </c:pt>
                <c:pt idx="4481">
                  <c:v>1.0092500305175989</c:v>
                </c:pt>
                <c:pt idx="4482">
                  <c:v>0.44969994068144814</c:v>
                </c:pt>
                <c:pt idx="4483">
                  <c:v>0.35959994792944983</c:v>
                </c:pt>
                <c:pt idx="4484">
                  <c:v>1.4525999450683962</c:v>
                </c:pt>
                <c:pt idx="4485">
                  <c:v>-0.52020009040834836</c:v>
                </c:pt>
                <c:pt idx="4486">
                  <c:v>0.88309992790229686</c:v>
                </c:pt>
                <c:pt idx="4487">
                  <c:v>1.0190500879287505</c:v>
                </c:pt>
                <c:pt idx="4488">
                  <c:v>-1.7998999261856525</c:v>
                </c:pt>
                <c:pt idx="4489">
                  <c:v>1.0190499019622479</c:v>
                </c:pt>
                <c:pt idx="4490">
                  <c:v>2.368949971199001</c:v>
                </c:pt>
                <c:pt idx="4491">
                  <c:v>-6.3900027275103355E-2</c:v>
                </c:pt>
                <c:pt idx="4492">
                  <c:v>0.84159996986389984</c:v>
                </c:pt>
                <c:pt idx="4493">
                  <c:v>1.3169999122619487</c:v>
                </c:pt>
                <c:pt idx="4494">
                  <c:v>1.5978998994826981</c:v>
                </c:pt>
                <c:pt idx="4495">
                  <c:v>1.2131500124930987</c:v>
                </c:pt>
                <c:pt idx="4496">
                  <c:v>0.96960006713865354</c:v>
                </c:pt>
                <c:pt idx="4497">
                  <c:v>1.8890500068664018</c:v>
                </c:pt>
                <c:pt idx="4498">
                  <c:v>1.2662001276015999</c:v>
                </c:pt>
                <c:pt idx="4499">
                  <c:v>2.3343999457359494</c:v>
                </c:pt>
                <c:pt idx="4500">
                  <c:v>3.0602999496460512</c:v>
                </c:pt>
                <c:pt idx="4501">
                  <c:v>0.82685007095339813</c:v>
                </c:pt>
                <c:pt idx="4502">
                  <c:v>2.272350106239351</c:v>
                </c:pt>
                <c:pt idx="4503">
                  <c:v>0.99954985618590086</c:v>
                </c:pt>
                <c:pt idx="4504">
                  <c:v>0.95885010242460211</c:v>
                </c:pt>
                <c:pt idx="4505">
                  <c:v>1.1041499280929479</c:v>
                </c:pt>
                <c:pt idx="4506">
                  <c:v>1.7351000833511492</c:v>
                </c:pt>
                <c:pt idx="4507">
                  <c:v>1.7351000833511492</c:v>
                </c:pt>
                <c:pt idx="4508">
                  <c:v>0.62274995803834798</c:v>
                </c:pt>
                <c:pt idx="4509">
                  <c:v>2.8608499717711986</c:v>
                </c:pt>
                <c:pt idx="4510">
                  <c:v>0.44030001640314964</c:v>
                </c:pt>
                <c:pt idx="4511">
                  <c:v>0.58759992122650218</c:v>
                </c:pt>
                <c:pt idx="4512">
                  <c:v>-0.24994992733005006</c:v>
                </c:pt>
                <c:pt idx="4513">
                  <c:v>0.73939994335175285</c:v>
                </c:pt>
                <c:pt idx="4514">
                  <c:v>-0.67675000667570018</c:v>
                </c:pt>
                <c:pt idx="4515">
                  <c:v>-0.41195003986359779</c:v>
                </c:pt>
                <c:pt idx="4516">
                  <c:v>1.9190500450134493</c:v>
                </c:pt>
                <c:pt idx="4517">
                  <c:v>1.1218501329421997</c:v>
                </c:pt>
                <c:pt idx="4518">
                  <c:v>1.2400500345230512</c:v>
                </c:pt>
                <c:pt idx="4519">
                  <c:v>1.9561999177932989</c:v>
                </c:pt>
                <c:pt idx="4520">
                  <c:v>2.1361000108718997</c:v>
                </c:pt>
                <c:pt idx="4521">
                  <c:v>-1.2917500162124007</c:v>
                </c:pt>
                <c:pt idx="4522">
                  <c:v>0.49860004901879762</c:v>
                </c:pt>
                <c:pt idx="4523">
                  <c:v>2.3395500087738057</c:v>
                </c:pt>
                <c:pt idx="4524">
                  <c:v>1.1326499938965</c:v>
                </c:pt>
                <c:pt idx="4525">
                  <c:v>0.60110008716579699</c:v>
                </c:pt>
                <c:pt idx="4526">
                  <c:v>-0.68959995269779739</c:v>
                </c:pt>
                <c:pt idx="4527">
                  <c:v>8.9200048446702596E-2</c:v>
                </c:pt>
                <c:pt idx="4528">
                  <c:v>2.5341500377654498</c:v>
                </c:pt>
                <c:pt idx="4529">
                  <c:v>0.74300001144404604</c:v>
                </c:pt>
                <c:pt idx="4530">
                  <c:v>-2.6876000595093004</c:v>
                </c:pt>
                <c:pt idx="4531">
                  <c:v>1.0474999284744513</c:v>
                </c:pt>
                <c:pt idx="4532">
                  <c:v>-0.74704998970035064</c:v>
                </c:pt>
                <c:pt idx="4533">
                  <c:v>0.51140000343319514</c:v>
                </c:pt>
                <c:pt idx="4534">
                  <c:v>1.3544999694824007</c:v>
                </c:pt>
                <c:pt idx="4535">
                  <c:v>1.0870999622344968</c:v>
                </c:pt>
                <c:pt idx="4536">
                  <c:v>0.80244997501375082</c:v>
                </c:pt>
                <c:pt idx="4537">
                  <c:v>1.5396000051498504</c:v>
                </c:pt>
                <c:pt idx="4538">
                  <c:v>2.0011500930786035</c:v>
                </c:pt>
                <c:pt idx="4539">
                  <c:v>2.6307999992371016</c:v>
                </c:pt>
                <c:pt idx="4540">
                  <c:v>2.2869499015807477</c:v>
                </c:pt>
                <c:pt idx="4541">
                  <c:v>-0.36170002460480077</c:v>
                </c:pt>
                <c:pt idx="4542">
                  <c:v>-0.2507000255584515</c:v>
                </c:pt>
                <c:pt idx="4543">
                  <c:v>0.74594994068144871</c:v>
                </c:pt>
                <c:pt idx="4544">
                  <c:v>-1.844199914932247</c:v>
                </c:pt>
                <c:pt idx="4545">
                  <c:v>3.1601000642776498</c:v>
                </c:pt>
                <c:pt idx="4546">
                  <c:v>-2.4209499549865008</c:v>
                </c:pt>
                <c:pt idx="4547">
                  <c:v>0.188649973869353</c:v>
                </c:pt>
                <c:pt idx="4548">
                  <c:v>0.81735006809239863</c:v>
                </c:pt>
                <c:pt idx="4549">
                  <c:v>-1.9555499100684983</c:v>
                </c:pt>
                <c:pt idx="4550">
                  <c:v>-1.5488499832153053</c:v>
                </c:pt>
                <c:pt idx="4551">
                  <c:v>-0.78445007801055056</c:v>
                </c:pt>
                <c:pt idx="4552">
                  <c:v>2.8491999626159483</c:v>
                </c:pt>
                <c:pt idx="4553">
                  <c:v>-0.37794999599460155</c:v>
                </c:pt>
                <c:pt idx="4554">
                  <c:v>2.5535500955581512</c:v>
                </c:pt>
                <c:pt idx="4555">
                  <c:v>2.6348000478744495</c:v>
                </c:pt>
                <c:pt idx="4556">
                  <c:v>0.17439988136290197</c:v>
                </c:pt>
                <c:pt idx="4557">
                  <c:v>8.6700062751798868E-2</c:v>
                </c:pt>
                <c:pt idx="4558">
                  <c:v>-2.7225998353957976</c:v>
                </c:pt>
                <c:pt idx="4559">
                  <c:v>0.41030002355574879</c:v>
                </c:pt>
                <c:pt idx="4560">
                  <c:v>-0.11505003452305473</c:v>
                </c:pt>
                <c:pt idx="4561">
                  <c:v>-2.4328000259400007</c:v>
                </c:pt>
                <c:pt idx="4562">
                  <c:v>0.23115001201630037</c:v>
                </c:pt>
                <c:pt idx="4563">
                  <c:v>2.2757500600814495</c:v>
                </c:pt>
                <c:pt idx="4564">
                  <c:v>4.7579499530792013</c:v>
                </c:pt>
                <c:pt idx="4565">
                  <c:v>-1.4288501214981011</c:v>
                </c:pt>
                <c:pt idx="4566">
                  <c:v>0.35940003395080211</c:v>
                </c:pt>
                <c:pt idx="4567">
                  <c:v>0.47145002841950046</c:v>
                </c:pt>
                <c:pt idx="4568">
                  <c:v>2.1804999685287498</c:v>
                </c:pt>
                <c:pt idx="4569">
                  <c:v>2.8942000293731986</c:v>
                </c:pt>
                <c:pt idx="4570">
                  <c:v>0.9209500074386483</c:v>
                </c:pt>
                <c:pt idx="4571">
                  <c:v>1.4666001605987482</c:v>
                </c:pt>
                <c:pt idx="4572">
                  <c:v>-0.92620003700260156</c:v>
                </c:pt>
                <c:pt idx="4573">
                  <c:v>3.0787999629974507</c:v>
                </c:pt>
                <c:pt idx="4574">
                  <c:v>3.7000017166150201E-2</c:v>
                </c:pt>
                <c:pt idx="4575">
                  <c:v>-0.31694997787480261</c:v>
                </c:pt>
                <c:pt idx="4576">
                  <c:v>0.22730016708374734</c:v>
                </c:pt>
                <c:pt idx="4577">
                  <c:v>3.5015000486373999</c:v>
                </c:pt>
                <c:pt idx="4578">
                  <c:v>0.25999997138969988</c:v>
                </c:pt>
                <c:pt idx="4579">
                  <c:v>-1.6213499307632517</c:v>
                </c:pt>
                <c:pt idx="4580">
                  <c:v>2.4222000265121508</c:v>
                </c:pt>
                <c:pt idx="4581">
                  <c:v>0.798999946117398</c:v>
                </c:pt>
                <c:pt idx="4582">
                  <c:v>0.29215010166170075</c:v>
                </c:pt>
                <c:pt idx="4583">
                  <c:v>1.3494500017166473</c:v>
                </c:pt>
                <c:pt idx="4584">
                  <c:v>3.6104499864578017</c:v>
                </c:pt>
                <c:pt idx="4585">
                  <c:v>-1.5565500259399556</c:v>
                </c:pt>
                <c:pt idx="4586">
                  <c:v>1.3191001605987509</c:v>
                </c:pt>
                <c:pt idx="4587">
                  <c:v>1.840249938964849</c:v>
                </c:pt>
                <c:pt idx="4588">
                  <c:v>1.6661501407622978</c:v>
                </c:pt>
                <c:pt idx="4589">
                  <c:v>0.78920005798339687</c:v>
                </c:pt>
                <c:pt idx="4590">
                  <c:v>-0.57199988365174903</c:v>
                </c:pt>
                <c:pt idx="4591">
                  <c:v>0.77634993076319603</c:v>
                </c:pt>
                <c:pt idx="4592">
                  <c:v>3.2741499280929496</c:v>
                </c:pt>
                <c:pt idx="4593">
                  <c:v>0.26400016307834662</c:v>
                </c:pt>
                <c:pt idx="4594">
                  <c:v>1.8313999342918024</c:v>
                </c:pt>
                <c:pt idx="4595">
                  <c:v>2.9049500083923014</c:v>
                </c:pt>
                <c:pt idx="4596">
                  <c:v>-5.7084501218796504</c:v>
                </c:pt>
                <c:pt idx="4597">
                  <c:v>0.53599998478940236</c:v>
                </c:pt>
                <c:pt idx="4598">
                  <c:v>-4.1476999187469517</c:v>
                </c:pt>
                <c:pt idx="4599">
                  <c:v>-0.3184998798369989</c:v>
                </c:pt>
                <c:pt idx="4600">
                  <c:v>-5.2100005149803508E-2</c:v>
                </c:pt>
                <c:pt idx="4601">
                  <c:v>0.38545002460485023</c:v>
                </c:pt>
                <c:pt idx="4602">
                  <c:v>2.4056001281737949</c:v>
                </c:pt>
                <c:pt idx="4603">
                  <c:v>-0.89560005187984615</c:v>
                </c:pt>
                <c:pt idx="4604">
                  <c:v>1.313399982452399</c:v>
                </c:pt>
                <c:pt idx="4605">
                  <c:v>1.0067998695373497</c:v>
                </c:pt>
                <c:pt idx="4606">
                  <c:v>0.84320004940034821</c:v>
                </c:pt>
                <c:pt idx="4607">
                  <c:v>0.30860007762910158</c:v>
                </c:pt>
                <c:pt idx="4608">
                  <c:v>-0.92189997196199869</c:v>
                </c:pt>
                <c:pt idx="4609">
                  <c:v>1.398500089645399</c:v>
                </c:pt>
                <c:pt idx="4610">
                  <c:v>-0.463099966049203</c:v>
                </c:pt>
                <c:pt idx="4611">
                  <c:v>1.302050018310549</c:v>
                </c:pt>
                <c:pt idx="4612">
                  <c:v>0.6234500312805018</c:v>
                </c:pt>
                <c:pt idx="4613">
                  <c:v>1.895749974250851</c:v>
                </c:pt>
                <c:pt idx="4614">
                  <c:v>-0.18569993972780097</c:v>
                </c:pt>
                <c:pt idx="4615">
                  <c:v>2.0531499099731505</c:v>
                </c:pt>
                <c:pt idx="4616">
                  <c:v>-9.0179499530792491</c:v>
                </c:pt>
                <c:pt idx="4617">
                  <c:v>-1.1619500517845012</c:v>
                </c:pt>
                <c:pt idx="4618">
                  <c:v>-1.0544000101089495</c:v>
                </c:pt>
                <c:pt idx="4619">
                  <c:v>1.2169000577926461</c:v>
                </c:pt>
                <c:pt idx="4620">
                  <c:v>-0.77979999542240108</c:v>
                </c:pt>
                <c:pt idx="4621">
                  <c:v>3.3103000354766507</c:v>
                </c:pt>
                <c:pt idx="4622">
                  <c:v>2.7944499921798496</c:v>
                </c:pt>
                <c:pt idx="4623">
                  <c:v>0.56165007829670088</c:v>
                </c:pt>
                <c:pt idx="4624">
                  <c:v>-1.9929000329970989</c:v>
                </c:pt>
                <c:pt idx="4625">
                  <c:v>-1.891949954032853</c:v>
                </c:pt>
                <c:pt idx="4626">
                  <c:v>-4.0115499973297517</c:v>
                </c:pt>
                <c:pt idx="4627">
                  <c:v>0.99439999580384608</c:v>
                </c:pt>
                <c:pt idx="4628">
                  <c:v>1.3199000573158486</c:v>
                </c:pt>
                <c:pt idx="4629">
                  <c:v>-0.99760000705719776</c:v>
                </c:pt>
                <c:pt idx="4630">
                  <c:v>1.9433999967574991</c:v>
                </c:pt>
                <c:pt idx="4631">
                  <c:v>2.1447999477386013</c:v>
                </c:pt>
                <c:pt idx="4632">
                  <c:v>-0.91810003280635044</c:v>
                </c:pt>
                <c:pt idx="4633">
                  <c:v>1.5175000715255464</c:v>
                </c:pt>
                <c:pt idx="4634">
                  <c:v>-1.5035999488830498</c:v>
                </c:pt>
                <c:pt idx="4635">
                  <c:v>2.0619000506401015</c:v>
                </c:pt>
                <c:pt idx="4636">
                  <c:v>3.0850024223301631E-2</c:v>
                </c:pt>
                <c:pt idx="4637">
                  <c:v>-0.14150002717970267</c:v>
                </c:pt>
                <c:pt idx="4638">
                  <c:v>1.3840501499176483</c:v>
                </c:pt>
                <c:pt idx="4639">
                  <c:v>2.2986999368667469</c:v>
                </c:pt>
                <c:pt idx="4640">
                  <c:v>0.51139993190760435</c:v>
                </c:pt>
                <c:pt idx="4641">
                  <c:v>-1.4147500038147491</c:v>
                </c:pt>
                <c:pt idx="4642">
                  <c:v>0.48544992923735109</c:v>
                </c:pt>
                <c:pt idx="4643">
                  <c:v>-0.16294999122620268</c:v>
                </c:pt>
                <c:pt idx="4644">
                  <c:v>-0.21029999256135312</c:v>
                </c:pt>
                <c:pt idx="4645">
                  <c:v>0.19389991998669842</c:v>
                </c:pt>
                <c:pt idx="4646">
                  <c:v>-1.7649970054648634E-2</c:v>
                </c:pt>
                <c:pt idx="4647">
                  <c:v>1.6086999082565043</c:v>
                </c:pt>
                <c:pt idx="4648">
                  <c:v>-5.0274999451637008</c:v>
                </c:pt>
                <c:pt idx="4649">
                  <c:v>2.422200012207</c:v>
                </c:pt>
                <c:pt idx="4650">
                  <c:v>0.58684989929199816</c:v>
                </c:pt>
                <c:pt idx="4651">
                  <c:v>-0.96779987812039536</c:v>
                </c:pt>
                <c:pt idx="4652">
                  <c:v>-0.29449997425080099</c:v>
                </c:pt>
                <c:pt idx="4653">
                  <c:v>1.240650005340548</c:v>
                </c:pt>
                <c:pt idx="4654">
                  <c:v>-0.17865005016324886</c:v>
                </c:pt>
                <c:pt idx="4655">
                  <c:v>-1.7378998804092518</c:v>
                </c:pt>
                <c:pt idx="4656">
                  <c:v>-0.28545010566709905</c:v>
                </c:pt>
                <c:pt idx="4657">
                  <c:v>4.3403999710082992</c:v>
                </c:pt>
                <c:pt idx="4658">
                  <c:v>1.0626000642776496</c:v>
                </c:pt>
                <c:pt idx="4659">
                  <c:v>0.56405004501345246</c:v>
                </c:pt>
                <c:pt idx="4660">
                  <c:v>0.40665001869200523</c:v>
                </c:pt>
                <c:pt idx="4661">
                  <c:v>0.90979997634889997</c:v>
                </c:pt>
                <c:pt idx="4662">
                  <c:v>-1.0603998517990014</c:v>
                </c:pt>
                <c:pt idx="4663">
                  <c:v>0.72735000610349942</c:v>
                </c:pt>
                <c:pt idx="4664">
                  <c:v>-0.9830500292777522</c:v>
                </c:pt>
                <c:pt idx="4665">
                  <c:v>-0.32144995212554761</c:v>
                </c:pt>
                <c:pt idx="4666">
                  <c:v>0.30955006122589879</c:v>
                </c:pt>
                <c:pt idx="4667">
                  <c:v>-1.4706499767303498</c:v>
                </c:pt>
                <c:pt idx="4668">
                  <c:v>-0.79634998321530048</c:v>
                </c:pt>
                <c:pt idx="4669">
                  <c:v>0.48605004310610056</c:v>
                </c:pt>
                <c:pt idx="4670">
                  <c:v>-1.62574998378755</c:v>
                </c:pt>
                <c:pt idx="4671">
                  <c:v>1.8114999675751022</c:v>
                </c:pt>
                <c:pt idx="4672">
                  <c:v>-0.78634995937349927</c:v>
                </c:pt>
                <c:pt idx="4673">
                  <c:v>-1.1470999431610487</c:v>
                </c:pt>
                <c:pt idx="4674">
                  <c:v>-1.9600499868393513</c:v>
                </c:pt>
                <c:pt idx="4675">
                  <c:v>-1.5457998609542507</c:v>
                </c:pt>
                <c:pt idx="4676">
                  <c:v>-0.21609996318815305</c:v>
                </c:pt>
                <c:pt idx="4677">
                  <c:v>-1.2511501264572011</c:v>
                </c:pt>
                <c:pt idx="4678">
                  <c:v>-4.4302000665665027</c:v>
                </c:pt>
                <c:pt idx="4679">
                  <c:v>-1.6134999132156516</c:v>
                </c:pt>
                <c:pt idx="4680">
                  <c:v>0.48329999923705103</c:v>
                </c:pt>
                <c:pt idx="4681">
                  <c:v>-0.2117001438141024</c:v>
                </c:pt>
                <c:pt idx="4682">
                  <c:v>1.5714500665664488</c:v>
                </c:pt>
                <c:pt idx="4683">
                  <c:v>-1.3553000259399468</c:v>
                </c:pt>
                <c:pt idx="4684">
                  <c:v>0.37690001964575259</c:v>
                </c:pt>
                <c:pt idx="4685">
                  <c:v>0.72380009174344906</c:v>
                </c:pt>
                <c:pt idx="4686">
                  <c:v>0.95779994964604853</c:v>
                </c:pt>
                <c:pt idx="4687">
                  <c:v>-0.41754996299739844</c:v>
                </c:pt>
                <c:pt idx="4688">
                  <c:v>-0.29809999942780152</c:v>
                </c:pt>
                <c:pt idx="4689">
                  <c:v>1.3984999942779481</c:v>
                </c:pt>
                <c:pt idx="4690">
                  <c:v>-3.3449969291748261E-2</c:v>
                </c:pt>
                <c:pt idx="4691">
                  <c:v>-2.2859500217438011</c:v>
                </c:pt>
                <c:pt idx="4692">
                  <c:v>-0.78109985351564859</c:v>
                </c:pt>
                <c:pt idx="4693">
                  <c:v>-3.0858999538421479</c:v>
                </c:pt>
                <c:pt idx="4694">
                  <c:v>6.7250061035149855E-2</c:v>
                </c:pt>
                <c:pt idx="4695">
                  <c:v>1.8211500597000523</c:v>
                </c:pt>
                <c:pt idx="4696">
                  <c:v>0.27360010623929654</c:v>
                </c:pt>
                <c:pt idx="4697">
                  <c:v>0.33769996643064815</c:v>
                </c:pt>
                <c:pt idx="4698">
                  <c:v>2.5148999881744487</c:v>
                </c:pt>
                <c:pt idx="4699">
                  <c:v>2.3540500354767033</c:v>
                </c:pt>
                <c:pt idx="4700">
                  <c:v>0.11219997882840005</c:v>
                </c:pt>
                <c:pt idx="4701">
                  <c:v>0.7819999885559028</c:v>
                </c:pt>
                <c:pt idx="4702">
                  <c:v>1.6924498510360984</c:v>
                </c:pt>
                <c:pt idx="4703">
                  <c:v>-2.4314999437332503</c:v>
                </c:pt>
                <c:pt idx="4704">
                  <c:v>1.2498000144958006</c:v>
                </c:pt>
                <c:pt idx="4705">
                  <c:v>3.495650033950799</c:v>
                </c:pt>
                <c:pt idx="4706">
                  <c:v>1.2716499996185</c:v>
                </c:pt>
                <c:pt idx="4707">
                  <c:v>1.5241499900817992</c:v>
                </c:pt>
                <c:pt idx="4708">
                  <c:v>1.6700501060485529</c:v>
                </c:pt>
                <c:pt idx="4709">
                  <c:v>0.77714998245239642</c:v>
                </c:pt>
                <c:pt idx="4710">
                  <c:v>1.7582501506804959</c:v>
                </c:pt>
                <c:pt idx="4711">
                  <c:v>-0.3322500634193517</c:v>
                </c:pt>
                <c:pt idx="4712">
                  <c:v>1.4288000059127484</c:v>
                </c:pt>
                <c:pt idx="4713">
                  <c:v>3.2047000479698511</c:v>
                </c:pt>
                <c:pt idx="4714">
                  <c:v>-0.40664987564084498</c:v>
                </c:pt>
                <c:pt idx="4715">
                  <c:v>-4.585299983024651</c:v>
                </c:pt>
                <c:pt idx="4716">
                  <c:v>2.5008499717712027</c:v>
                </c:pt>
                <c:pt idx="4717">
                  <c:v>-1.3683000373840493</c:v>
                </c:pt>
                <c:pt idx="4718">
                  <c:v>4.6510999250412013</c:v>
                </c:pt>
                <c:pt idx="4719">
                  <c:v>-1.8587497806549464</c:v>
                </c:pt>
                <c:pt idx="4720">
                  <c:v>3.3687000417709498</c:v>
                </c:pt>
                <c:pt idx="4721">
                  <c:v>3.1135000514984483</c:v>
                </c:pt>
                <c:pt idx="4722">
                  <c:v>1.5752998590469502</c:v>
                </c:pt>
                <c:pt idx="4723">
                  <c:v>0.21924994945524645</c:v>
                </c:pt>
                <c:pt idx="4724">
                  <c:v>-1.2806499052047968</c:v>
                </c:pt>
                <c:pt idx="4725">
                  <c:v>-0.17570000886920312</c:v>
                </c:pt>
                <c:pt idx="4726">
                  <c:v>0.60630001544950218</c:v>
                </c:pt>
                <c:pt idx="4727">
                  <c:v>1.2315500307083482</c:v>
                </c:pt>
                <c:pt idx="4728">
                  <c:v>2.4560999822616481</c:v>
                </c:pt>
                <c:pt idx="4729">
                  <c:v>0.21909989833829968</c:v>
                </c:pt>
                <c:pt idx="4730">
                  <c:v>0.58965006351474969</c:v>
                </c:pt>
                <c:pt idx="4731">
                  <c:v>2.3984501123428004</c:v>
                </c:pt>
                <c:pt idx="4732">
                  <c:v>0.51840010166165484</c:v>
                </c:pt>
                <c:pt idx="4733">
                  <c:v>8.449994087219892E-2</c:v>
                </c:pt>
                <c:pt idx="4734">
                  <c:v>1.129950008392349</c:v>
                </c:pt>
                <c:pt idx="4735">
                  <c:v>-0.49549991130830051</c:v>
                </c:pt>
                <c:pt idx="4736">
                  <c:v>-2.4771998882293467</c:v>
                </c:pt>
                <c:pt idx="4737">
                  <c:v>1.1292500424385494</c:v>
                </c:pt>
                <c:pt idx="4738">
                  <c:v>5.4849863052400138E-2</c:v>
                </c:pt>
                <c:pt idx="4739">
                  <c:v>1.2984500408172011</c:v>
                </c:pt>
                <c:pt idx="4740">
                  <c:v>-2.0422999811172531</c:v>
                </c:pt>
                <c:pt idx="4741">
                  <c:v>-1.6527999448775503</c:v>
                </c:pt>
                <c:pt idx="4742">
                  <c:v>-7.4699931144703413E-2</c:v>
                </c:pt>
                <c:pt idx="4743">
                  <c:v>2.2565999388694493</c:v>
                </c:pt>
                <c:pt idx="4744">
                  <c:v>-2.8004999351500999</c:v>
                </c:pt>
                <c:pt idx="4745">
                  <c:v>-0.26289999485019777</c:v>
                </c:pt>
                <c:pt idx="4746">
                  <c:v>0.97685001850124564</c:v>
                </c:pt>
                <c:pt idx="4747">
                  <c:v>1.2062499666214492</c:v>
                </c:pt>
                <c:pt idx="4748">
                  <c:v>2.3002499747275991</c:v>
                </c:pt>
                <c:pt idx="4749">
                  <c:v>-1.1268500757217517</c:v>
                </c:pt>
                <c:pt idx="4750">
                  <c:v>-0.31179998874659987</c:v>
                </c:pt>
                <c:pt idx="4751">
                  <c:v>0.61649990558625234</c:v>
                </c:pt>
                <c:pt idx="4752">
                  <c:v>3.7117999982834</c:v>
                </c:pt>
                <c:pt idx="4753">
                  <c:v>0.89444996356959905</c:v>
                </c:pt>
                <c:pt idx="4754">
                  <c:v>1.6282500553131491</c:v>
                </c:pt>
                <c:pt idx="4755">
                  <c:v>0.69779997348785372</c:v>
                </c:pt>
                <c:pt idx="4756">
                  <c:v>1.0320001125335487</c:v>
                </c:pt>
                <c:pt idx="4757">
                  <c:v>0.20815009593960099</c:v>
                </c:pt>
                <c:pt idx="4758">
                  <c:v>3.4435001325607502</c:v>
                </c:pt>
                <c:pt idx="4759">
                  <c:v>-5.9349913597099402E-2</c:v>
                </c:pt>
                <c:pt idx="4760">
                  <c:v>0.18685003757475016</c:v>
                </c:pt>
                <c:pt idx="4761">
                  <c:v>-0.84774997234345051</c:v>
                </c:pt>
                <c:pt idx="4762">
                  <c:v>0.77899993896490116</c:v>
                </c:pt>
                <c:pt idx="4763">
                  <c:v>1.1780500030518013</c:v>
                </c:pt>
                <c:pt idx="4764">
                  <c:v>-0.94095001697539971</c:v>
                </c:pt>
                <c:pt idx="4765">
                  <c:v>1.8777500534057978</c:v>
                </c:pt>
                <c:pt idx="4766">
                  <c:v>-1.4012000703811509</c:v>
                </c:pt>
                <c:pt idx="4767">
                  <c:v>-0.24735002279285112</c:v>
                </c:pt>
                <c:pt idx="4768">
                  <c:v>-0.9055499982833517</c:v>
                </c:pt>
                <c:pt idx="4769">
                  <c:v>0.62389997005460174</c:v>
                </c:pt>
                <c:pt idx="4770">
                  <c:v>0.94384999513630419</c:v>
                </c:pt>
                <c:pt idx="4771">
                  <c:v>0.23010753882054757</c:v>
                </c:pt>
                <c:pt idx="4772">
                  <c:v>2.2624500370026013</c:v>
                </c:pt>
                <c:pt idx="4773">
                  <c:v>-1.2554000043868996</c:v>
                </c:pt>
                <c:pt idx="4774">
                  <c:v>1.8722000217437973</c:v>
                </c:pt>
                <c:pt idx="4775">
                  <c:v>-0.41870003700254799</c:v>
                </c:pt>
                <c:pt idx="4776">
                  <c:v>1.956000142097448</c:v>
                </c:pt>
                <c:pt idx="4777">
                  <c:v>0.82935011625295019</c:v>
                </c:pt>
                <c:pt idx="4778">
                  <c:v>1.5779499959946008</c:v>
                </c:pt>
                <c:pt idx="4779">
                  <c:v>-2.2649931907601228E-2</c:v>
                </c:pt>
                <c:pt idx="4780">
                  <c:v>2.4660500526427995</c:v>
                </c:pt>
                <c:pt idx="4781">
                  <c:v>0.1881501102447487</c:v>
                </c:pt>
                <c:pt idx="4782">
                  <c:v>1.2518000316620004</c:v>
                </c:pt>
                <c:pt idx="4783">
                  <c:v>1.0520000696181988</c:v>
                </c:pt>
                <c:pt idx="4784">
                  <c:v>-0.39025007724765004</c:v>
                </c:pt>
                <c:pt idx="4785">
                  <c:v>-1.0455999565124472</c:v>
                </c:pt>
                <c:pt idx="4786">
                  <c:v>-1.022250065803501</c:v>
                </c:pt>
                <c:pt idx="4787">
                  <c:v>0.35489983558655069</c:v>
                </c:pt>
                <c:pt idx="4788">
                  <c:v>1.1129999923706002</c:v>
                </c:pt>
                <c:pt idx="4789">
                  <c:v>-0.69379999160770467</c:v>
                </c:pt>
                <c:pt idx="4790">
                  <c:v>-0.37949995756149946</c:v>
                </c:pt>
                <c:pt idx="4791">
                  <c:v>0.80159995079039703</c:v>
                </c:pt>
                <c:pt idx="4792">
                  <c:v>-0.89135009765630002</c:v>
                </c:pt>
                <c:pt idx="4793">
                  <c:v>-0.22135000705720032</c:v>
                </c:pt>
                <c:pt idx="4794">
                  <c:v>1.393149967193601</c:v>
                </c:pt>
                <c:pt idx="4795">
                  <c:v>1.7616999340057475</c:v>
                </c:pt>
                <c:pt idx="4796">
                  <c:v>0.8135500812530978</c:v>
                </c:pt>
                <c:pt idx="4797">
                  <c:v>-0.91999995231629939</c:v>
                </c:pt>
                <c:pt idx="4798">
                  <c:v>-0.46530002117155078</c:v>
                </c:pt>
                <c:pt idx="4799">
                  <c:v>2.1948999118804977</c:v>
                </c:pt>
                <c:pt idx="4800">
                  <c:v>-0.21724998712539545</c:v>
                </c:pt>
                <c:pt idx="4801">
                  <c:v>-0.18429999351495141</c:v>
                </c:pt>
                <c:pt idx="4802">
                  <c:v>3.2641499805450493</c:v>
                </c:pt>
                <c:pt idx="4803">
                  <c:v>0.14224998950960099</c:v>
                </c:pt>
                <c:pt idx="4804">
                  <c:v>0.53524995803839914</c:v>
                </c:pt>
                <c:pt idx="4805">
                  <c:v>-0.44905002117155135</c:v>
                </c:pt>
                <c:pt idx="4806">
                  <c:v>2.948199987411499</c:v>
                </c:pt>
                <c:pt idx="4807">
                  <c:v>-1.1690999841690015</c:v>
                </c:pt>
                <c:pt idx="4808">
                  <c:v>0.52365001201630434</c:v>
                </c:pt>
                <c:pt idx="4809">
                  <c:v>0.88550008296964933</c:v>
                </c:pt>
                <c:pt idx="4810">
                  <c:v>-5.3386499404906971</c:v>
                </c:pt>
                <c:pt idx="4811">
                  <c:v>-2.7332499217987021</c:v>
                </c:pt>
                <c:pt idx="4812">
                  <c:v>1.3430499649048002</c:v>
                </c:pt>
                <c:pt idx="4813">
                  <c:v>0.16595000267030002</c:v>
                </c:pt>
                <c:pt idx="4814">
                  <c:v>1.0813500308989958</c:v>
                </c:pt>
                <c:pt idx="4815">
                  <c:v>1.3550062179604083E-2</c:v>
                </c:pt>
                <c:pt idx="4816">
                  <c:v>1.2590499401092003</c:v>
                </c:pt>
                <c:pt idx="4817">
                  <c:v>0.49695007801054913</c:v>
                </c:pt>
                <c:pt idx="4818">
                  <c:v>1.8110999488830544</c:v>
                </c:pt>
                <c:pt idx="4819">
                  <c:v>7.0250082015999027E-2</c:v>
                </c:pt>
                <c:pt idx="4820">
                  <c:v>0.20005008220670106</c:v>
                </c:pt>
                <c:pt idx="4821">
                  <c:v>-1.9483001041412535</c:v>
                </c:pt>
                <c:pt idx="4822">
                  <c:v>3.1870498371124505</c:v>
                </c:pt>
                <c:pt idx="4823">
                  <c:v>2.8098000669479006</c:v>
                </c:pt>
                <c:pt idx="4824">
                  <c:v>-0.8264000415802002</c:v>
                </c:pt>
                <c:pt idx="4825">
                  <c:v>1.155100011825553</c:v>
                </c:pt>
                <c:pt idx="4826">
                  <c:v>1.1811500167846489</c:v>
                </c:pt>
                <c:pt idx="4827">
                  <c:v>1.282350077629097</c:v>
                </c:pt>
                <c:pt idx="4828">
                  <c:v>0.76955009937280394</c:v>
                </c:pt>
                <c:pt idx="4829">
                  <c:v>2.8504500150680521</c:v>
                </c:pt>
                <c:pt idx="4830">
                  <c:v>-1.1476499986648534</c:v>
                </c:pt>
                <c:pt idx="4831">
                  <c:v>3.7327500963211016</c:v>
                </c:pt>
                <c:pt idx="4832">
                  <c:v>-1.1792000675201493</c:v>
                </c:pt>
                <c:pt idx="4833">
                  <c:v>-0.39249995231629597</c:v>
                </c:pt>
                <c:pt idx="4834">
                  <c:v>-4.2894499540328503</c:v>
                </c:pt>
                <c:pt idx="4835">
                  <c:v>1.9727999448776501</c:v>
                </c:pt>
                <c:pt idx="4836">
                  <c:v>0.48350006103514787</c:v>
                </c:pt>
                <c:pt idx="4837">
                  <c:v>-3.0265500783920487</c:v>
                </c:pt>
                <c:pt idx="4838">
                  <c:v>-1.1406500148773482</c:v>
                </c:pt>
                <c:pt idx="4839">
                  <c:v>1.8987499952316504</c:v>
                </c:pt>
                <c:pt idx="4840">
                  <c:v>0.2211999702453511</c:v>
                </c:pt>
                <c:pt idx="4841">
                  <c:v>1.202100038528453</c:v>
                </c:pt>
                <c:pt idx="4842">
                  <c:v>-1.0374499464035019</c:v>
                </c:pt>
                <c:pt idx="4843">
                  <c:v>-0.52740015506745408</c:v>
                </c:pt>
                <c:pt idx="4844">
                  <c:v>1.39765001773835</c:v>
                </c:pt>
                <c:pt idx="4845">
                  <c:v>-2.11390007019045</c:v>
                </c:pt>
                <c:pt idx="4846">
                  <c:v>-1.7678498506546028</c:v>
                </c:pt>
                <c:pt idx="4847">
                  <c:v>-0.11569995880125106</c:v>
                </c:pt>
                <c:pt idx="4848">
                  <c:v>-2.1620499610901014</c:v>
                </c:pt>
                <c:pt idx="4849">
                  <c:v>0.44594997882839849</c:v>
                </c:pt>
                <c:pt idx="4850">
                  <c:v>1.4281499862670977</c:v>
                </c:pt>
                <c:pt idx="4851">
                  <c:v>-2.6854000473022452</c:v>
                </c:pt>
                <c:pt idx="4852">
                  <c:v>-1.5895000910759514</c:v>
                </c:pt>
                <c:pt idx="4853">
                  <c:v>0.21945002079010223</c:v>
                </c:pt>
                <c:pt idx="4854">
                  <c:v>-2.891000013351448</c:v>
                </c:pt>
                <c:pt idx="4855">
                  <c:v>1.4514499521255964</c:v>
                </c:pt>
                <c:pt idx="4856">
                  <c:v>-0.10884996891020293</c:v>
                </c:pt>
                <c:pt idx="4857">
                  <c:v>1.1322000980376998</c:v>
                </c:pt>
                <c:pt idx="4858">
                  <c:v>0.44464994430544991</c:v>
                </c:pt>
                <c:pt idx="4859">
                  <c:v>0.56340005874635324</c:v>
                </c:pt>
                <c:pt idx="4860">
                  <c:v>-0.77985018730160149</c:v>
                </c:pt>
                <c:pt idx="4861">
                  <c:v>0.98650004386900036</c:v>
                </c:pt>
                <c:pt idx="4862">
                  <c:v>-1.2510500335693528</c:v>
                </c:pt>
                <c:pt idx="4863">
                  <c:v>-0.2454999828338984</c:v>
                </c:pt>
                <c:pt idx="4864">
                  <c:v>-0.98080011844634996</c:v>
                </c:pt>
                <c:pt idx="4865">
                  <c:v>0.12145018577569644</c:v>
                </c:pt>
                <c:pt idx="4866">
                  <c:v>-0.23904997110370019</c:v>
                </c:pt>
                <c:pt idx="4867">
                  <c:v>1.1283000469207529</c:v>
                </c:pt>
                <c:pt idx="4868">
                  <c:v>1.5333500385284466</c:v>
                </c:pt>
                <c:pt idx="4869">
                  <c:v>3.0421000742912483</c:v>
                </c:pt>
                <c:pt idx="4870">
                  <c:v>-0.46115007400515395</c:v>
                </c:pt>
                <c:pt idx="4871">
                  <c:v>-2.991649987697599</c:v>
                </c:pt>
                <c:pt idx="4872">
                  <c:v>2.4446999979018997</c:v>
                </c:pt>
                <c:pt idx="4873">
                  <c:v>-0.22239990711209856</c:v>
                </c:pt>
                <c:pt idx="4874">
                  <c:v>-7.343600053787199</c:v>
                </c:pt>
                <c:pt idx="4875">
                  <c:v>1.501949973106349</c:v>
                </c:pt>
                <c:pt idx="4876">
                  <c:v>-0.14760002136225125</c:v>
                </c:pt>
                <c:pt idx="4877">
                  <c:v>0.39834998369214603</c:v>
                </c:pt>
                <c:pt idx="4878">
                  <c:v>-1.1042999744414992</c:v>
                </c:pt>
                <c:pt idx="4879">
                  <c:v>0.56375009059905068</c:v>
                </c:pt>
                <c:pt idx="4880">
                  <c:v>1.9939499616622527</c:v>
                </c:pt>
                <c:pt idx="4881">
                  <c:v>-1.7769500112533514</c:v>
                </c:pt>
                <c:pt idx="4882">
                  <c:v>-0.99709997177125231</c:v>
                </c:pt>
                <c:pt idx="4883">
                  <c:v>2.156300125122101</c:v>
                </c:pt>
                <c:pt idx="4884">
                  <c:v>1.4612000751495025</c:v>
                </c:pt>
                <c:pt idx="4885">
                  <c:v>-2.2841999006270974</c:v>
                </c:pt>
                <c:pt idx="4886">
                  <c:v>1.3421501159668523</c:v>
                </c:pt>
                <c:pt idx="4887">
                  <c:v>-2.3488000631332469</c:v>
                </c:pt>
                <c:pt idx="4888">
                  <c:v>0.1217500782013019</c:v>
                </c:pt>
                <c:pt idx="4889">
                  <c:v>-1.6986500430106979</c:v>
                </c:pt>
                <c:pt idx="4890">
                  <c:v>-0.66504996776580327</c:v>
                </c:pt>
                <c:pt idx="4891">
                  <c:v>-0.4466000604628988</c:v>
                </c:pt>
                <c:pt idx="4892">
                  <c:v>-4.8600999021529994</c:v>
                </c:pt>
                <c:pt idx="4893">
                  <c:v>1.8514000225066987</c:v>
                </c:pt>
                <c:pt idx="4894">
                  <c:v>-0.91430004835125089</c:v>
                </c:pt>
                <c:pt idx="4895">
                  <c:v>1.8973000073433042</c:v>
                </c:pt>
                <c:pt idx="4896">
                  <c:v>-1.3683500766754015</c:v>
                </c:pt>
                <c:pt idx="4897">
                  <c:v>3.0830000114440494</c:v>
                </c:pt>
                <c:pt idx="4898">
                  <c:v>0.65334993124010055</c:v>
                </c:pt>
                <c:pt idx="4899">
                  <c:v>1.240449886321997</c:v>
                </c:pt>
                <c:pt idx="4900">
                  <c:v>2.1396999406814992</c:v>
                </c:pt>
                <c:pt idx="4901">
                  <c:v>-1.6124000668525973</c:v>
                </c:pt>
                <c:pt idx="4902">
                  <c:v>1.0333000373839951</c:v>
                </c:pt>
                <c:pt idx="4903">
                  <c:v>2.5683500289917021</c:v>
                </c:pt>
                <c:pt idx="4904">
                  <c:v>0.53015006065370329</c:v>
                </c:pt>
                <c:pt idx="4905">
                  <c:v>0.58095001935955182</c:v>
                </c:pt>
                <c:pt idx="4906">
                  <c:v>-2.1018499088287008</c:v>
                </c:pt>
                <c:pt idx="4907">
                  <c:v>0.86369995355605056</c:v>
                </c:pt>
                <c:pt idx="4908">
                  <c:v>-0.85339990377424968</c:v>
                </c:pt>
                <c:pt idx="4909">
                  <c:v>1.1278499364853012</c:v>
                </c:pt>
                <c:pt idx="4910">
                  <c:v>-0.60639990091324947</c:v>
                </c:pt>
                <c:pt idx="4911">
                  <c:v>-1.4106999349593998</c:v>
                </c:pt>
                <c:pt idx="4912">
                  <c:v>-2.1792999649048497</c:v>
                </c:pt>
                <c:pt idx="4913">
                  <c:v>2.241949920654303</c:v>
                </c:pt>
                <c:pt idx="4914">
                  <c:v>-3.9749999666214002</c:v>
                </c:pt>
                <c:pt idx="4915">
                  <c:v>-0.34064986705779887</c:v>
                </c:pt>
                <c:pt idx="4916">
                  <c:v>1.2104499244689997</c:v>
                </c:pt>
                <c:pt idx="4917">
                  <c:v>0.12104995489115211</c:v>
                </c:pt>
                <c:pt idx="4918">
                  <c:v>1.1717499685287507</c:v>
                </c:pt>
                <c:pt idx="4919">
                  <c:v>1.7022500514984031</c:v>
                </c:pt>
                <c:pt idx="4920">
                  <c:v>0.97775009632110255</c:v>
                </c:pt>
                <c:pt idx="4921">
                  <c:v>0.57970007419585201</c:v>
                </c:pt>
                <c:pt idx="4922">
                  <c:v>-1.7336499977111508</c:v>
                </c:pt>
                <c:pt idx="4923">
                  <c:v>-0.47644995212554875</c:v>
                </c:pt>
                <c:pt idx="4924">
                  <c:v>-4.4699983596849791E-2</c:v>
                </c:pt>
                <c:pt idx="4925">
                  <c:v>3.7445999956131004</c:v>
                </c:pt>
                <c:pt idx="4926">
                  <c:v>-1.3943999052047999</c:v>
                </c:pt>
                <c:pt idx="4927">
                  <c:v>-0.28820003747940248</c:v>
                </c:pt>
                <c:pt idx="4928">
                  <c:v>0.523500056266748</c:v>
                </c:pt>
                <c:pt idx="4929">
                  <c:v>2.1147500252724001</c:v>
                </c:pt>
                <c:pt idx="4930">
                  <c:v>-0.63245002269749762</c:v>
                </c:pt>
                <c:pt idx="4931">
                  <c:v>-0.54064999103545119</c:v>
                </c:pt>
                <c:pt idx="4932">
                  <c:v>0.63044997692109916</c:v>
                </c:pt>
                <c:pt idx="4933">
                  <c:v>0.36334999561305281</c:v>
                </c:pt>
                <c:pt idx="4934">
                  <c:v>0.74354990005495125</c:v>
                </c:pt>
                <c:pt idx="4935">
                  <c:v>-0.61225003242489962</c:v>
                </c:pt>
                <c:pt idx="4936">
                  <c:v>1.1096999120712496</c:v>
                </c:pt>
                <c:pt idx="4937">
                  <c:v>0.89609995603565196</c:v>
                </c:pt>
                <c:pt idx="4938">
                  <c:v>-7.6099925041148708E-2</c:v>
                </c:pt>
                <c:pt idx="4939">
                  <c:v>0.22255012035369859</c:v>
                </c:pt>
                <c:pt idx="4940">
                  <c:v>-0.46365006923674912</c:v>
                </c:pt>
                <c:pt idx="4941">
                  <c:v>3.0910501098633034</c:v>
                </c:pt>
                <c:pt idx="4942">
                  <c:v>-2.4196000576018974</c:v>
                </c:pt>
                <c:pt idx="4943">
                  <c:v>1.0389500522613488</c:v>
                </c:pt>
                <c:pt idx="4944">
                  <c:v>-0.24030005455015058</c:v>
                </c:pt>
                <c:pt idx="4945">
                  <c:v>-0.30099998950959872</c:v>
                </c:pt>
                <c:pt idx="4946">
                  <c:v>0.41699995517729604</c:v>
                </c:pt>
                <c:pt idx="4947">
                  <c:v>-3.6521499729156517</c:v>
                </c:pt>
                <c:pt idx="4948">
                  <c:v>-0.5772000217437494</c:v>
                </c:pt>
                <c:pt idx="4949">
                  <c:v>0.72550003528595042</c:v>
                </c:pt>
                <c:pt idx="4950">
                  <c:v>-0.70990003585809802</c:v>
                </c:pt>
                <c:pt idx="4951">
                  <c:v>-0.85589997053150313</c:v>
                </c:pt>
                <c:pt idx="4952">
                  <c:v>-1.0945000648499033</c:v>
                </c:pt>
                <c:pt idx="4953">
                  <c:v>0.89760007381440232</c:v>
                </c:pt>
                <c:pt idx="4954">
                  <c:v>0.98250004768370047</c:v>
                </c:pt>
                <c:pt idx="4955">
                  <c:v>2.6115999460219967</c:v>
                </c:pt>
                <c:pt idx="4956">
                  <c:v>0.37609992742540044</c:v>
                </c:pt>
                <c:pt idx="4957">
                  <c:v>-1.4950008392350611E-2</c:v>
                </c:pt>
                <c:pt idx="4958">
                  <c:v>-0.16790011405939964</c:v>
                </c:pt>
                <c:pt idx="4959">
                  <c:v>-1.8311000037192997</c:v>
                </c:pt>
                <c:pt idx="4960">
                  <c:v>0.47134994983670353</c:v>
                </c:pt>
                <c:pt idx="4961">
                  <c:v>0.89820003271104909</c:v>
                </c:pt>
                <c:pt idx="4962">
                  <c:v>0.29504999637610041</c:v>
                </c:pt>
                <c:pt idx="4963">
                  <c:v>1.629600052833549</c:v>
                </c:pt>
                <c:pt idx="4964">
                  <c:v>-0.75195011615754836</c:v>
                </c:pt>
                <c:pt idx="4965">
                  <c:v>-0.61780000925065082</c:v>
                </c:pt>
                <c:pt idx="4966">
                  <c:v>-1.4545500516891501</c:v>
                </c:pt>
                <c:pt idx="4967">
                  <c:v>-0.33200002193449762</c:v>
                </c:pt>
                <c:pt idx="4968">
                  <c:v>3.4106999731063503</c:v>
                </c:pt>
                <c:pt idx="4969">
                  <c:v>-2.6471000337600543</c:v>
                </c:pt>
                <c:pt idx="4970">
                  <c:v>0.17639995574955236</c:v>
                </c:pt>
                <c:pt idx="4971">
                  <c:v>1.6985500574112002</c:v>
                </c:pt>
                <c:pt idx="4972">
                  <c:v>-0.56180004119875093</c:v>
                </c:pt>
                <c:pt idx="4973">
                  <c:v>2.1113500404358021</c:v>
                </c:pt>
                <c:pt idx="4974">
                  <c:v>-0.34974993705749924</c:v>
                </c:pt>
                <c:pt idx="4975">
                  <c:v>1.5206499147415506</c:v>
                </c:pt>
                <c:pt idx="4976">
                  <c:v>-0.14214995622635485</c:v>
                </c:pt>
                <c:pt idx="4977">
                  <c:v>-1.5753500270844008</c:v>
                </c:pt>
                <c:pt idx="4978">
                  <c:v>-0.10620000123975259</c:v>
                </c:pt>
                <c:pt idx="4979">
                  <c:v>-3.3999500226974533</c:v>
                </c:pt>
                <c:pt idx="4980">
                  <c:v>-0.91425009965900017</c:v>
                </c:pt>
                <c:pt idx="4981">
                  <c:v>4.4850025177002095E-2</c:v>
                </c:pt>
                <c:pt idx="4982">
                  <c:v>1.7199912071248491E-2</c:v>
                </c:pt>
                <c:pt idx="4983">
                  <c:v>2.1260000371933501</c:v>
                </c:pt>
                <c:pt idx="4984">
                  <c:v>0.2345499825477475</c:v>
                </c:pt>
                <c:pt idx="4985">
                  <c:v>-1.0947499799728</c:v>
                </c:pt>
                <c:pt idx="4986">
                  <c:v>-2.2797500729561015</c:v>
                </c:pt>
                <c:pt idx="4987">
                  <c:v>1.5875500106812019</c:v>
                </c:pt>
                <c:pt idx="4988">
                  <c:v>-0.72180001258850268</c:v>
                </c:pt>
                <c:pt idx="4989">
                  <c:v>1.3918500614165978</c:v>
                </c:pt>
                <c:pt idx="4990">
                  <c:v>-0.27124999999999844</c:v>
                </c:pt>
                <c:pt idx="4991">
                  <c:v>-0.61550001621244732</c:v>
                </c:pt>
                <c:pt idx="4992">
                  <c:v>1.1636000299453499</c:v>
                </c:pt>
                <c:pt idx="4993">
                  <c:v>-0.87139997482299947</c:v>
                </c:pt>
                <c:pt idx="4994">
                  <c:v>1.594900026321401</c:v>
                </c:pt>
                <c:pt idx="4995">
                  <c:v>-1.1333499908446498</c:v>
                </c:pt>
                <c:pt idx="4996">
                  <c:v>-2.0747499465942525</c:v>
                </c:pt>
                <c:pt idx="4997">
                  <c:v>-0.2653999757766492</c:v>
                </c:pt>
                <c:pt idx="4998">
                  <c:v>-3.4216500139236459</c:v>
                </c:pt>
                <c:pt idx="4999">
                  <c:v>1.7684500169754003</c:v>
                </c:pt>
                <c:pt idx="5000">
                  <c:v>0.34580005645754852</c:v>
                </c:pt>
                <c:pt idx="5001">
                  <c:v>0.56355003356929956</c:v>
                </c:pt>
                <c:pt idx="5002">
                  <c:v>2.8352500319480498</c:v>
                </c:pt>
                <c:pt idx="5003">
                  <c:v>0.89359997749330233</c:v>
                </c:pt>
                <c:pt idx="5004">
                  <c:v>-0.50090000629430165</c:v>
                </c:pt>
                <c:pt idx="5005">
                  <c:v>-0.16839998960494995</c:v>
                </c:pt>
                <c:pt idx="5006">
                  <c:v>-1.130700073242199</c:v>
                </c:pt>
                <c:pt idx="5007">
                  <c:v>0.76694997787474861</c:v>
                </c:pt>
                <c:pt idx="5008">
                  <c:v>-0.56485004901885105</c:v>
                </c:pt>
                <c:pt idx="5009">
                  <c:v>2.1019500589370494</c:v>
                </c:pt>
                <c:pt idx="5010">
                  <c:v>-0.48944982528685088</c:v>
                </c:pt>
                <c:pt idx="5011">
                  <c:v>-0.8744500589370503</c:v>
                </c:pt>
                <c:pt idx="5012">
                  <c:v>-0.37575000286105364</c:v>
                </c:pt>
                <c:pt idx="5013">
                  <c:v>-0.62084993362424967</c:v>
                </c:pt>
                <c:pt idx="5014">
                  <c:v>1.6852999734878971</c:v>
                </c:pt>
                <c:pt idx="5015">
                  <c:v>-0.42235006809234932</c:v>
                </c:pt>
                <c:pt idx="5016">
                  <c:v>-1.7796999311447479</c:v>
                </c:pt>
                <c:pt idx="5017">
                  <c:v>0.76890002250669909</c:v>
                </c:pt>
                <c:pt idx="5018">
                  <c:v>0.81670002937315189</c:v>
                </c:pt>
                <c:pt idx="5019">
                  <c:v>-1.1011000394821018</c:v>
                </c:pt>
                <c:pt idx="5020">
                  <c:v>-1.8376498889922992</c:v>
                </c:pt>
                <c:pt idx="5021">
                  <c:v>-2.6301000142097486</c:v>
                </c:pt>
                <c:pt idx="5022">
                  <c:v>-1.584499959945699</c:v>
                </c:pt>
                <c:pt idx="5023">
                  <c:v>1.4332498693465503</c:v>
                </c:pt>
                <c:pt idx="5024">
                  <c:v>2.5802999234199504</c:v>
                </c:pt>
                <c:pt idx="5025">
                  <c:v>0.21360004901885077</c:v>
                </c:pt>
                <c:pt idx="5026">
                  <c:v>-3.5197498989105043</c:v>
                </c:pt>
                <c:pt idx="5027">
                  <c:v>0.69810003757474703</c:v>
                </c:pt>
                <c:pt idx="5028">
                  <c:v>-2.1923998737334998</c:v>
                </c:pt>
                <c:pt idx="5029">
                  <c:v>1.1046500229835523</c:v>
                </c:pt>
                <c:pt idx="5030">
                  <c:v>0.74934994220734907</c:v>
                </c:pt>
                <c:pt idx="5031">
                  <c:v>-9.1949882507400105E-2</c:v>
                </c:pt>
                <c:pt idx="5032">
                  <c:v>-0.18054995059964796</c:v>
                </c:pt>
                <c:pt idx="5033">
                  <c:v>0.56479999780650303</c:v>
                </c:pt>
                <c:pt idx="5034">
                  <c:v>0.44120003223419957</c:v>
                </c:pt>
                <c:pt idx="5035">
                  <c:v>1.2420999813080016</c:v>
                </c:pt>
                <c:pt idx="5036">
                  <c:v>-4.3271000957489001</c:v>
                </c:pt>
                <c:pt idx="5037">
                  <c:v>0.40939996719360039</c:v>
                </c:pt>
                <c:pt idx="5038">
                  <c:v>1.883450064659101</c:v>
                </c:pt>
                <c:pt idx="5039">
                  <c:v>-3.1869499826430996</c:v>
                </c:pt>
                <c:pt idx="5040">
                  <c:v>3.8648499250412005</c:v>
                </c:pt>
                <c:pt idx="5041">
                  <c:v>3.8648499250412005</c:v>
                </c:pt>
                <c:pt idx="5042">
                  <c:v>-1.2566499900817512</c:v>
                </c:pt>
                <c:pt idx="5043">
                  <c:v>1.9701999378204498</c:v>
                </c:pt>
                <c:pt idx="5044">
                  <c:v>-1.8399999642371974</c:v>
                </c:pt>
                <c:pt idx="5045">
                  <c:v>0.64745003223420383</c:v>
                </c:pt>
                <c:pt idx="5046">
                  <c:v>0.30670003175740135</c:v>
                </c:pt>
                <c:pt idx="5047">
                  <c:v>-0.40805000782010126</c:v>
                </c:pt>
                <c:pt idx="5048">
                  <c:v>-0.5985499763488491</c:v>
                </c:pt>
                <c:pt idx="5049">
                  <c:v>1.5071499371528994</c:v>
                </c:pt>
                <c:pt idx="5050">
                  <c:v>-0.95370011329654858</c:v>
                </c:pt>
                <c:pt idx="5051">
                  <c:v>0.57285000562669808</c:v>
                </c:pt>
                <c:pt idx="5052">
                  <c:v>-2.0087999916076456</c:v>
                </c:pt>
                <c:pt idx="5053">
                  <c:v>2.2673000454902983</c:v>
                </c:pt>
                <c:pt idx="5054">
                  <c:v>-0.56940005302429952</c:v>
                </c:pt>
                <c:pt idx="5055">
                  <c:v>-0.4421500205993496</c:v>
                </c:pt>
                <c:pt idx="5056">
                  <c:v>-2.2108500528335497</c:v>
                </c:pt>
                <c:pt idx="5057">
                  <c:v>-0.4569000339507987</c:v>
                </c:pt>
                <c:pt idx="5058">
                  <c:v>-2.9027500200272023</c:v>
                </c:pt>
                <c:pt idx="5059">
                  <c:v>0.76600003242490189</c:v>
                </c:pt>
                <c:pt idx="5060">
                  <c:v>0.85365001678464836</c:v>
                </c:pt>
                <c:pt idx="5061">
                  <c:v>-1.0581499195099013</c:v>
                </c:pt>
                <c:pt idx="5062">
                  <c:v>-0.10940010547640355</c:v>
                </c:pt>
                <c:pt idx="5063">
                  <c:v>0.96539999485009886</c:v>
                </c:pt>
                <c:pt idx="5064">
                  <c:v>1.0234999370574975</c:v>
                </c:pt>
                <c:pt idx="5065">
                  <c:v>-0.23384997129440421</c:v>
                </c:pt>
                <c:pt idx="5066">
                  <c:v>1.0675500202179009</c:v>
                </c:pt>
                <c:pt idx="5067">
                  <c:v>-0.8606000661850004</c:v>
                </c:pt>
                <c:pt idx="5068">
                  <c:v>-1.8009999108314503</c:v>
                </c:pt>
                <c:pt idx="5069">
                  <c:v>0.36349998235699843</c:v>
                </c:pt>
                <c:pt idx="5070">
                  <c:v>1.23980001688005</c:v>
                </c:pt>
                <c:pt idx="5071">
                  <c:v>1.0162499713898008</c:v>
                </c:pt>
                <c:pt idx="5072">
                  <c:v>0.65754995584489961</c:v>
                </c:pt>
                <c:pt idx="5073">
                  <c:v>1.2252500486374487</c:v>
                </c:pt>
                <c:pt idx="5074">
                  <c:v>1.5248499822616495</c:v>
                </c:pt>
                <c:pt idx="5075">
                  <c:v>-2.7543999958038512</c:v>
                </c:pt>
                <c:pt idx="5076">
                  <c:v>0.55330007553099847</c:v>
                </c:pt>
                <c:pt idx="5077">
                  <c:v>-1.5768499803543001</c:v>
                </c:pt>
                <c:pt idx="5078">
                  <c:v>1.1747999715804518</c:v>
                </c:pt>
                <c:pt idx="5079">
                  <c:v>-0.17685004711150043</c:v>
                </c:pt>
                <c:pt idx="5080">
                  <c:v>0.63809988021850117</c:v>
                </c:pt>
                <c:pt idx="5081">
                  <c:v>1.0263499832153506</c:v>
                </c:pt>
                <c:pt idx="5082">
                  <c:v>1.7672999954223521</c:v>
                </c:pt>
                <c:pt idx="5083">
                  <c:v>-3.2668000173568501</c:v>
                </c:pt>
                <c:pt idx="5084">
                  <c:v>-0.55354992866514863</c:v>
                </c:pt>
                <c:pt idx="5085">
                  <c:v>-1.5807500576973013</c:v>
                </c:pt>
                <c:pt idx="5086">
                  <c:v>1.4617000555992519</c:v>
                </c:pt>
                <c:pt idx="5087">
                  <c:v>-0.4350501441955501</c:v>
                </c:pt>
                <c:pt idx="5088">
                  <c:v>-9.1100025176999111E-2</c:v>
                </c:pt>
                <c:pt idx="5089">
                  <c:v>-1.9810499119758482</c:v>
                </c:pt>
                <c:pt idx="5090">
                  <c:v>-2.7163500452041482</c:v>
                </c:pt>
                <c:pt idx="5091">
                  <c:v>-3.5918999671936547</c:v>
                </c:pt>
                <c:pt idx="5092">
                  <c:v>3.9477000904083503</c:v>
                </c:pt>
                <c:pt idx="5093">
                  <c:v>0.28134998798370248</c:v>
                </c:pt>
                <c:pt idx="5094">
                  <c:v>-1.7753500080108964</c:v>
                </c:pt>
                <c:pt idx="5095">
                  <c:v>1.6484500694274971</c:v>
                </c:pt>
                <c:pt idx="5096">
                  <c:v>2.3049845695503279E-2</c:v>
                </c:pt>
                <c:pt idx="5097">
                  <c:v>-1.6397999715804978</c:v>
                </c:pt>
                <c:pt idx="5098">
                  <c:v>0.14634993553159958</c:v>
                </c:pt>
                <c:pt idx="5099">
                  <c:v>0.81420006513594956</c:v>
                </c:pt>
                <c:pt idx="5100">
                  <c:v>1.9821999931335483</c:v>
                </c:pt>
                <c:pt idx="5101">
                  <c:v>-2.1645999717712492</c:v>
                </c:pt>
                <c:pt idx="5102">
                  <c:v>5.4799971580500539E-2</c:v>
                </c:pt>
                <c:pt idx="5103">
                  <c:v>-0.22765000820159997</c:v>
                </c:pt>
                <c:pt idx="5104">
                  <c:v>0.79645004272460085</c:v>
                </c:pt>
                <c:pt idx="5105">
                  <c:v>-1.9868998241424514</c:v>
                </c:pt>
                <c:pt idx="5106">
                  <c:v>0.44035002231595399</c:v>
                </c:pt>
                <c:pt idx="5107">
                  <c:v>-2.6432499599456989</c:v>
                </c:pt>
                <c:pt idx="5108">
                  <c:v>-1.843099966049202</c:v>
                </c:pt>
                <c:pt idx="5109">
                  <c:v>0.74944996356959948</c:v>
                </c:pt>
                <c:pt idx="5110">
                  <c:v>-0.32099998235705129</c:v>
                </c:pt>
                <c:pt idx="5111">
                  <c:v>2.5312499284743986</c:v>
                </c:pt>
                <c:pt idx="5112">
                  <c:v>-0.58089995384219861</c:v>
                </c:pt>
                <c:pt idx="5113">
                  <c:v>-1.0411500310897495</c:v>
                </c:pt>
                <c:pt idx="5114">
                  <c:v>1.0860000181197513</c:v>
                </c:pt>
                <c:pt idx="5115">
                  <c:v>-1.6011500501632518</c:v>
                </c:pt>
                <c:pt idx="5116">
                  <c:v>-0.99895011425019931</c:v>
                </c:pt>
                <c:pt idx="5117">
                  <c:v>-0.41935000181200266</c:v>
                </c:pt>
                <c:pt idx="5118">
                  <c:v>-1.4189999723433999</c:v>
                </c:pt>
                <c:pt idx="5119">
                  <c:v>-0.95889991760249771</c:v>
                </c:pt>
                <c:pt idx="5120">
                  <c:v>-3.2288000726699977</c:v>
                </c:pt>
                <c:pt idx="5121">
                  <c:v>-3.6197000074386487</c:v>
                </c:pt>
                <c:pt idx="5122">
                  <c:v>-2.2749000263214505</c:v>
                </c:pt>
                <c:pt idx="5123">
                  <c:v>-2.0520499849319513</c:v>
                </c:pt>
                <c:pt idx="5124">
                  <c:v>1.2818999958038475</c:v>
                </c:pt>
                <c:pt idx="5125">
                  <c:v>0.10265000581739869</c:v>
                </c:pt>
                <c:pt idx="5126">
                  <c:v>1.8272499704360996</c:v>
                </c:pt>
                <c:pt idx="5127">
                  <c:v>-0.26950001716609862</c:v>
                </c:pt>
                <c:pt idx="5128">
                  <c:v>-0.65630000591279725</c:v>
                </c:pt>
                <c:pt idx="5129">
                  <c:v>-3.0398498344421512</c:v>
                </c:pt>
                <c:pt idx="5130">
                  <c:v>1.2631501245498988</c:v>
                </c:pt>
                <c:pt idx="5131">
                  <c:v>-1.3437500286103017</c:v>
                </c:pt>
                <c:pt idx="5132">
                  <c:v>-0.27370006799700164</c:v>
                </c:pt>
                <c:pt idx="5133">
                  <c:v>1.2196501255035521</c:v>
                </c:pt>
                <c:pt idx="5134">
                  <c:v>4.3499779701505759E-3</c:v>
                </c:pt>
                <c:pt idx="5135">
                  <c:v>-3.7017999649048505</c:v>
                </c:pt>
                <c:pt idx="5136">
                  <c:v>-1.7828500223158983</c:v>
                </c:pt>
                <c:pt idx="5137">
                  <c:v>-3.5058999681473004</c:v>
                </c:pt>
                <c:pt idx="5138">
                  <c:v>-3.7252000355720511</c:v>
                </c:pt>
                <c:pt idx="5139">
                  <c:v>-9.8449933528897304E-2</c:v>
                </c:pt>
                <c:pt idx="5140">
                  <c:v>-0.88969995498659671</c:v>
                </c:pt>
                <c:pt idx="5141">
                  <c:v>-2.0726500272751025</c:v>
                </c:pt>
                <c:pt idx="5142">
                  <c:v>0.40519996881485199</c:v>
                </c:pt>
                <c:pt idx="5143">
                  <c:v>0.50179988384244467</c:v>
                </c:pt>
                <c:pt idx="5144">
                  <c:v>8.3199975490551026E-2</c:v>
                </c:pt>
                <c:pt idx="5145">
                  <c:v>0.79205004453660166</c:v>
                </c:pt>
                <c:pt idx="5146">
                  <c:v>1.083499965667702</c:v>
                </c:pt>
                <c:pt idx="5147">
                  <c:v>4.6650013923645872E-2</c:v>
                </c:pt>
                <c:pt idx="5148">
                  <c:v>0.55870005130769584</c:v>
                </c:pt>
                <c:pt idx="5149">
                  <c:v>-2.2814500570297511</c:v>
                </c:pt>
                <c:pt idx="5150">
                  <c:v>-0.55060008049009923</c:v>
                </c:pt>
                <c:pt idx="5151">
                  <c:v>-1.1453999614716004</c:v>
                </c:pt>
                <c:pt idx="5152">
                  <c:v>-0.35005006313330256</c:v>
                </c:pt>
                <c:pt idx="5153">
                  <c:v>0.60630005836484813</c:v>
                </c:pt>
                <c:pt idx="5154">
                  <c:v>-1.592950100898701</c:v>
                </c:pt>
                <c:pt idx="5155">
                  <c:v>-1.1332499837875005</c:v>
                </c:pt>
                <c:pt idx="5156">
                  <c:v>-2.1446500682830489</c:v>
                </c:pt>
                <c:pt idx="5157">
                  <c:v>-0.91584995269774794</c:v>
                </c:pt>
                <c:pt idx="5158">
                  <c:v>1.0747000694274504</c:v>
                </c:pt>
                <c:pt idx="5159">
                  <c:v>-0.31084998607639847</c:v>
                </c:pt>
                <c:pt idx="5160">
                  <c:v>-3.1107999610900983</c:v>
                </c:pt>
                <c:pt idx="5161">
                  <c:v>0.21140004396439949</c:v>
                </c:pt>
                <c:pt idx="5162">
                  <c:v>0.58075005292894843</c:v>
                </c:pt>
                <c:pt idx="5163">
                  <c:v>-0.35080011844635095</c:v>
                </c:pt>
                <c:pt idx="5164">
                  <c:v>0.14125002145765109</c:v>
                </c:pt>
                <c:pt idx="5165">
                  <c:v>0.73769990682604814</c:v>
                </c:pt>
                <c:pt idx="5166">
                  <c:v>2.5646000146866008</c:v>
                </c:pt>
                <c:pt idx="5167">
                  <c:v>-2.0084000301361513</c:v>
                </c:pt>
                <c:pt idx="5168">
                  <c:v>-3.5589000749587996</c:v>
                </c:pt>
                <c:pt idx="5169">
                  <c:v>1.1542500591278042</c:v>
                </c:pt>
                <c:pt idx="5170">
                  <c:v>-2.0200014114351461E-2</c:v>
                </c:pt>
                <c:pt idx="5171">
                  <c:v>-1.5420000314712468</c:v>
                </c:pt>
                <c:pt idx="5172">
                  <c:v>-2.4283499622344493</c:v>
                </c:pt>
                <c:pt idx="5173">
                  <c:v>-1.9868499612807966</c:v>
                </c:pt>
                <c:pt idx="5174">
                  <c:v>-8.1849961280799022E-2</c:v>
                </c:pt>
                <c:pt idx="5175">
                  <c:v>-3.1584999799727953</c:v>
                </c:pt>
                <c:pt idx="5176">
                  <c:v>-0.55980006456374909</c:v>
                </c:pt>
                <c:pt idx="5177">
                  <c:v>0.12720000267029974</c:v>
                </c:pt>
                <c:pt idx="5178">
                  <c:v>-0.81790001869200069</c:v>
                </c:pt>
                <c:pt idx="5179">
                  <c:v>-3.6133500623703014</c:v>
                </c:pt>
                <c:pt idx="5180">
                  <c:v>-1.7444999980926497</c:v>
                </c:pt>
                <c:pt idx="5181">
                  <c:v>-6.1850075721750386E-2</c:v>
                </c:pt>
                <c:pt idx="5182">
                  <c:v>0.5283000087738472</c:v>
                </c:pt>
                <c:pt idx="5183">
                  <c:v>-3.7200002670296328E-2</c:v>
                </c:pt>
                <c:pt idx="5184">
                  <c:v>-2.5088000583648977</c:v>
                </c:pt>
                <c:pt idx="5185">
                  <c:v>-0.36419997692109618</c:v>
                </c:pt>
                <c:pt idx="5186">
                  <c:v>-2.5545499563217504</c:v>
                </c:pt>
                <c:pt idx="5187">
                  <c:v>1.5003999972343465</c:v>
                </c:pt>
                <c:pt idx="5188">
                  <c:v>1.37619994163515</c:v>
                </c:pt>
                <c:pt idx="5189">
                  <c:v>-0.20760002613064898</c:v>
                </c:pt>
                <c:pt idx="5190">
                  <c:v>1.7534501075745013</c:v>
                </c:pt>
                <c:pt idx="5191">
                  <c:v>-1.4946000432967992</c:v>
                </c:pt>
                <c:pt idx="5192">
                  <c:v>-1.9761000430584019</c:v>
                </c:pt>
                <c:pt idx="5193">
                  <c:v>-0.15399989604949837</c:v>
                </c:pt>
                <c:pt idx="5194">
                  <c:v>-3.0050499439238969</c:v>
                </c:pt>
                <c:pt idx="5195">
                  <c:v>-0.6695998716354552</c:v>
                </c:pt>
                <c:pt idx="5196">
                  <c:v>0.67395002841950102</c:v>
                </c:pt>
                <c:pt idx="5197">
                  <c:v>-1.473749909400901</c:v>
                </c:pt>
                <c:pt idx="5198">
                  <c:v>-1.960499970912899</c:v>
                </c:pt>
                <c:pt idx="5199">
                  <c:v>-0.13354978084560187</c:v>
                </c:pt>
                <c:pt idx="5200">
                  <c:v>1.5657499790191487</c:v>
                </c:pt>
                <c:pt idx="5201">
                  <c:v>-3.1620499372482023</c:v>
                </c:pt>
                <c:pt idx="5202">
                  <c:v>-0.48175009250639889</c:v>
                </c:pt>
                <c:pt idx="5203">
                  <c:v>-1.0167500638961506</c:v>
                </c:pt>
                <c:pt idx="5204">
                  <c:v>-0.59284992218020349</c:v>
                </c:pt>
                <c:pt idx="5205">
                  <c:v>-1.228350071907002</c:v>
                </c:pt>
                <c:pt idx="5206">
                  <c:v>1.1145000886917025</c:v>
                </c:pt>
                <c:pt idx="5207">
                  <c:v>0.86519993305205389</c:v>
                </c:pt>
                <c:pt idx="5208">
                  <c:v>2.035000324249836E-2</c:v>
                </c:pt>
                <c:pt idx="5209">
                  <c:v>1.1233001065254022</c:v>
                </c:pt>
                <c:pt idx="5210">
                  <c:v>0.56045003890994849</c:v>
                </c:pt>
                <c:pt idx="5211">
                  <c:v>-4.7495000600815018</c:v>
                </c:pt>
                <c:pt idx="5212">
                  <c:v>-4.894200053215048</c:v>
                </c:pt>
                <c:pt idx="5213">
                  <c:v>-5.3749980926550478E-2</c:v>
                </c:pt>
                <c:pt idx="5214">
                  <c:v>0.54195001125335196</c:v>
                </c:pt>
                <c:pt idx="5215">
                  <c:v>0.57445003509524639</c:v>
                </c:pt>
                <c:pt idx="5216">
                  <c:v>-1.1387499952315991</c:v>
                </c:pt>
                <c:pt idx="5217">
                  <c:v>-2.5874499702453519</c:v>
                </c:pt>
                <c:pt idx="5218">
                  <c:v>-0.21775001287459972</c:v>
                </c:pt>
                <c:pt idx="5219">
                  <c:v>1.9338000702857983</c:v>
                </c:pt>
                <c:pt idx="5220">
                  <c:v>0.62810003280634774</c:v>
                </c:pt>
                <c:pt idx="5221">
                  <c:v>-5.0700030326847667E-2</c:v>
                </c:pt>
                <c:pt idx="5222">
                  <c:v>3.4850499677658</c:v>
                </c:pt>
                <c:pt idx="5223">
                  <c:v>-3.0772500133514455</c:v>
                </c:pt>
                <c:pt idx="5224">
                  <c:v>0.14294990301134902</c:v>
                </c:pt>
                <c:pt idx="5225">
                  <c:v>-0.8731498718262003</c:v>
                </c:pt>
                <c:pt idx="5226">
                  <c:v>0.44110006332394747</c:v>
                </c:pt>
                <c:pt idx="5227">
                  <c:v>-1.1043500375747506</c:v>
                </c:pt>
                <c:pt idx="5228">
                  <c:v>-1.4856499838829507</c:v>
                </c:pt>
                <c:pt idx="5229">
                  <c:v>-0.17799988269804956</c:v>
                </c:pt>
                <c:pt idx="5230">
                  <c:v>-0.32164987564089742</c:v>
                </c:pt>
                <c:pt idx="5231">
                  <c:v>-0.71845004081724895</c:v>
                </c:pt>
                <c:pt idx="5232">
                  <c:v>-2.0609999394417002</c:v>
                </c:pt>
                <c:pt idx="5233">
                  <c:v>-0.8791000509261977</c:v>
                </c:pt>
                <c:pt idx="5234">
                  <c:v>-1.3346499443054007</c:v>
                </c:pt>
                <c:pt idx="5235">
                  <c:v>-0.86145010948185075</c:v>
                </c:pt>
                <c:pt idx="5236">
                  <c:v>-0.66314995765685225</c:v>
                </c:pt>
                <c:pt idx="5237">
                  <c:v>7.3499956131001909E-2</c:v>
                </c:pt>
                <c:pt idx="5238">
                  <c:v>-1.8144499897956479</c:v>
                </c:pt>
                <c:pt idx="5239">
                  <c:v>-4.1207499742507991</c:v>
                </c:pt>
                <c:pt idx="5240">
                  <c:v>-2.1006000185012468</c:v>
                </c:pt>
                <c:pt idx="5241">
                  <c:v>-1.0960500621795504</c:v>
                </c:pt>
                <c:pt idx="5242">
                  <c:v>-0.6428498935699487</c:v>
                </c:pt>
                <c:pt idx="5243">
                  <c:v>0.68245001316074649</c:v>
                </c:pt>
                <c:pt idx="5244">
                  <c:v>-0.70105002880099931</c:v>
                </c:pt>
                <c:pt idx="5245">
                  <c:v>-0.49734998226164606</c:v>
                </c:pt>
                <c:pt idx="5246">
                  <c:v>2.2273500776290476</c:v>
                </c:pt>
                <c:pt idx="5247">
                  <c:v>1.0069498729706012</c:v>
                </c:pt>
                <c:pt idx="5248">
                  <c:v>-1.6201499772071983</c:v>
                </c:pt>
                <c:pt idx="5249">
                  <c:v>-2.3612499570846524</c:v>
                </c:pt>
                <c:pt idx="5250">
                  <c:v>-0.89449999332430252</c:v>
                </c:pt>
                <c:pt idx="5251">
                  <c:v>-0.60214996337884941</c:v>
                </c:pt>
                <c:pt idx="5252">
                  <c:v>-0.80320007324225173</c:v>
                </c:pt>
                <c:pt idx="5253">
                  <c:v>0.15480003356934802</c:v>
                </c:pt>
                <c:pt idx="5254">
                  <c:v>0.89784999370579754</c:v>
                </c:pt>
                <c:pt idx="5255">
                  <c:v>-2.3392500090598531</c:v>
                </c:pt>
                <c:pt idx="5256">
                  <c:v>-0.27425000190735105</c:v>
                </c:pt>
                <c:pt idx="5257">
                  <c:v>-3.2544999885558994</c:v>
                </c:pt>
                <c:pt idx="5258">
                  <c:v>1.3655500578880009</c:v>
                </c:pt>
                <c:pt idx="5259">
                  <c:v>4.2999930381803608E-2</c:v>
                </c:pt>
                <c:pt idx="5260">
                  <c:v>1.0218000221251984</c:v>
                </c:pt>
                <c:pt idx="5261">
                  <c:v>0.3674500250815953</c:v>
                </c:pt>
                <c:pt idx="5262">
                  <c:v>-0.83004997253420143</c:v>
                </c:pt>
                <c:pt idx="5263">
                  <c:v>-0.73154987335205135</c:v>
                </c:pt>
                <c:pt idx="5264">
                  <c:v>-0.8860999560355971</c:v>
                </c:pt>
                <c:pt idx="5265">
                  <c:v>-1.051199979782151</c:v>
                </c:pt>
                <c:pt idx="5266">
                  <c:v>-0.46950011730194774</c:v>
                </c:pt>
                <c:pt idx="5267">
                  <c:v>-0.84839995384215072</c:v>
                </c:pt>
                <c:pt idx="5268">
                  <c:v>-2.4931000423431477</c:v>
                </c:pt>
                <c:pt idx="5269">
                  <c:v>0.85455006122590049</c:v>
                </c:pt>
                <c:pt idx="5270">
                  <c:v>-0.71735014915465101</c:v>
                </c:pt>
                <c:pt idx="5271">
                  <c:v>0.68265004634854876</c:v>
                </c:pt>
                <c:pt idx="5272">
                  <c:v>-1.6171500301361021</c:v>
                </c:pt>
                <c:pt idx="5273">
                  <c:v>0.93845001697539843</c:v>
                </c:pt>
                <c:pt idx="5274">
                  <c:v>-1.6032000637055006</c:v>
                </c:pt>
                <c:pt idx="5275">
                  <c:v>-1.3863499832153536</c:v>
                </c:pt>
                <c:pt idx="5276">
                  <c:v>0.79709997177129921</c:v>
                </c:pt>
                <c:pt idx="5277">
                  <c:v>-2.1976999425887485</c:v>
                </c:pt>
                <c:pt idx="5278">
                  <c:v>-1.8798499250411993</c:v>
                </c:pt>
                <c:pt idx="5279">
                  <c:v>-2.8999499654769991</c:v>
                </c:pt>
                <c:pt idx="5280">
                  <c:v>-9.5499973297101803E-2</c:v>
                </c:pt>
                <c:pt idx="5281">
                  <c:v>-3.1604500627518028</c:v>
                </c:pt>
                <c:pt idx="5282">
                  <c:v>1.5316999626159991</c:v>
                </c:pt>
                <c:pt idx="5283">
                  <c:v>-0.18734988212584369</c:v>
                </c:pt>
                <c:pt idx="5284">
                  <c:v>-1.8882000064849507</c:v>
                </c:pt>
                <c:pt idx="5285">
                  <c:v>-0.77845001459125385</c:v>
                </c:pt>
                <c:pt idx="5286">
                  <c:v>-3.5349888801597729E-2</c:v>
                </c:pt>
                <c:pt idx="5287">
                  <c:v>-1.678300025463102</c:v>
                </c:pt>
                <c:pt idx="5288">
                  <c:v>0.46804997444155205</c:v>
                </c:pt>
                <c:pt idx="5289">
                  <c:v>-0.73755002975465089</c:v>
                </c:pt>
                <c:pt idx="5290">
                  <c:v>-1.0553499794006456</c:v>
                </c:pt>
                <c:pt idx="5291">
                  <c:v>-0.91000002145764824</c:v>
                </c:pt>
                <c:pt idx="5292">
                  <c:v>-0.62130004405974759</c:v>
                </c:pt>
                <c:pt idx="5293">
                  <c:v>-6.7219498872756986</c:v>
                </c:pt>
                <c:pt idx="5294">
                  <c:v>7.9849977493299917E-2</c:v>
                </c:pt>
                <c:pt idx="5295">
                  <c:v>-2.0789999365806509</c:v>
                </c:pt>
                <c:pt idx="5296">
                  <c:v>-1.0123498487471991</c:v>
                </c:pt>
                <c:pt idx="5297">
                  <c:v>1.3143499827385483</c:v>
                </c:pt>
                <c:pt idx="5298">
                  <c:v>-1.3619999432564001</c:v>
                </c:pt>
                <c:pt idx="5299">
                  <c:v>-1.7482500076293981</c:v>
                </c:pt>
                <c:pt idx="5300">
                  <c:v>1.2394500207900983</c:v>
                </c:pt>
                <c:pt idx="5301">
                  <c:v>-1.0781999444961485</c:v>
                </c:pt>
                <c:pt idx="5302">
                  <c:v>-0.41924994468685028</c:v>
                </c:pt>
                <c:pt idx="5303">
                  <c:v>-2.6066000938414966</c:v>
                </c:pt>
                <c:pt idx="5304">
                  <c:v>3.3133499789238527</c:v>
                </c:pt>
                <c:pt idx="5305">
                  <c:v>-2.4545000314712517</c:v>
                </c:pt>
                <c:pt idx="5306">
                  <c:v>-0.41519998312000439</c:v>
                </c:pt>
                <c:pt idx="5307">
                  <c:v>-2.4846999585628495</c:v>
                </c:pt>
                <c:pt idx="5308">
                  <c:v>-1.9265499734879015</c:v>
                </c:pt>
                <c:pt idx="5309">
                  <c:v>0.98929998397830232</c:v>
                </c:pt>
                <c:pt idx="5310">
                  <c:v>-3.328300075530997</c:v>
                </c:pt>
                <c:pt idx="5311">
                  <c:v>-0.43175002574920285</c:v>
                </c:pt>
                <c:pt idx="5312">
                  <c:v>-4.7054499053954473</c:v>
                </c:pt>
                <c:pt idx="5313">
                  <c:v>-2.1635501194000497</c:v>
                </c:pt>
                <c:pt idx="5314">
                  <c:v>-1.8689501428603492</c:v>
                </c:pt>
                <c:pt idx="5315">
                  <c:v>0.1538999795913476</c:v>
                </c:pt>
                <c:pt idx="5316">
                  <c:v>-0.32164999008174888</c:v>
                </c:pt>
                <c:pt idx="5317">
                  <c:v>-0.7163999652862465</c:v>
                </c:pt>
                <c:pt idx="5318">
                  <c:v>0.53805007934565197</c:v>
                </c:pt>
                <c:pt idx="5319">
                  <c:v>-0.82465003490445099</c:v>
                </c:pt>
                <c:pt idx="5320">
                  <c:v>-1.8060000944137506</c:v>
                </c:pt>
                <c:pt idx="5321">
                  <c:v>-0.79680008411405367</c:v>
                </c:pt>
                <c:pt idx="5322">
                  <c:v>-1.6510000801086484</c:v>
                </c:pt>
                <c:pt idx="5323">
                  <c:v>-1.0023499584198028</c:v>
                </c:pt>
                <c:pt idx="5324">
                  <c:v>1.0766000699996496</c:v>
                </c:pt>
                <c:pt idx="5325">
                  <c:v>-3.0540999460219993</c:v>
                </c:pt>
                <c:pt idx="5326">
                  <c:v>0.22090011119840014</c:v>
                </c:pt>
                <c:pt idx="5327">
                  <c:v>-0.80349997520450245</c:v>
                </c:pt>
                <c:pt idx="5328">
                  <c:v>-0.11364993572235349</c:v>
                </c:pt>
                <c:pt idx="5329">
                  <c:v>-1.1091499567031988</c:v>
                </c:pt>
                <c:pt idx="5330">
                  <c:v>0.16580000638960257</c:v>
                </c:pt>
                <c:pt idx="5331">
                  <c:v>-2.0410500192642012</c:v>
                </c:pt>
                <c:pt idx="5332">
                  <c:v>-2.978849916458099</c:v>
                </c:pt>
                <c:pt idx="5333">
                  <c:v>-2.1091000223159995</c:v>
                </c:pt>
                <c:pt idx="5334">
                  <c:v>-1.6757000160217004</c:v>
                </c:pt>
                <c:pt idx="5335">
                  <c:v>0.917549982070895</c:v>
                </c:pt>
                <c:pt idx="5336">
                  <c:v>-1.9416999840736544</c:v>
                </c:pt>
                <c:pt idx="5337">
                  <c:v>-3.1501999950409498</c:v>
                </c:pt>
                <c:pt idx="5338">
                  <c:v>0.31200010538099576</c:v>
                </c:pt>
                <c:pt idx="5339">
                  <c:v>-5.3749914169298307E-2</c:v>
                </c:pt>
                <c:pt idx="5340">
                  <c:v>-2.7501500105857986</c:v>
                </c:pt>
                <c:pt idx="5341">
                  <c:v>-0.65460003852839677</c:v>
                </c:pt>
                <c:pt idx="5342">
                  <c:v>-2.6014000439643539</c:v>
                </c:pt>
                <c:pt idx="5343">
                  <c:v>2.7173501491547007</c:v>
                </c:pt>
                <c:pt idx="5344">
                  <c:v>0.87635001659394973</c:v>
                </c:pt>
                <c:pt idx="5345">
                  <c:v>0.4476000642776512</c:v>
                </c:pt>
                <c:pt idx="5346">
                  <c:v>-0.3036999511719003</c:v>
                </c:pt>
                <c:pt idx="5347">
                  <c:v>-0.5001499485969525</c:v>
                </c:pt>
                <c:pt idx="5348">
                  <c:v>0.5406001043319506</c:v>
                </c:pt>
                <c:pt idx="5349">
                  <c:v>-1.5966499257087499</c:v>
                </c:pt>
                <c:pt idx="5350">
                  <c:v>-1.3999999737739479</c:v>
                </c:pt>
                <c:pt idx="5351">
                  <c:v>0.47669996738435216</c:v>
                </c:pt>
                <c:pt idx="5352">
                  <c:v>-1.1624499583243981</c:v>
                </c:pt>
                <c:pt idx="5353">
                  <c:v>1.8338999772071531</c:v>
                </c:pt>
                <c:pt idx="5354">
                  <c:v>-3.1266499948501014</c:v>
                </c:pt>
                <c:pt idx="5355">
                  <c:v>1.0721000432967998</c:v>
                </c:pt>
                <c:pt idx="5356">
                  <c:v>-2.3775999593734554</c:v>
                </c:pt>
                <c:pt idx="5357">
                  <c:v>-1.8126498913765019</c:v>
                </c:pt>
                <c:pt idx="5358">
                  <c:v>-2.0304499053955034</c:v>
                </c:pt>
                <c:pt idx="5359">
                  <c:v>0.38590009927749946</c:v>
                </c:pt>
                <c:pt idx="5360">
                  <c:v>-1.6729500675200981</c:v>
                </c:pt>
                <c:pt idx="5361">
                  <c:v>4.5549931526149834E-2</c:v>
                </c:pt>
                <c:pt idx="5362">
                  <c:v>-1.8806499719619509</c:v>
                </c:pt>
                <c:pt idx="5363">
                  <c:v>-2.777100038528399</c:v>
                </c:pt>
                <c:pt idx="5364">
                  <c:v>0.6399499559402031</c:v>
                </c:pt>
                <c:pt idx="5365">
                  <c:v>-1.697699985504201</c:v>
                </c:pt>
                <c:pt idx="5366">
                  <c:v>-2.4591999769211021</c:v>
                </c:pt>
                <c:pt idx="5367">
                  <c:v>-0.73335008382795053</c:v>
                </c:pt>
                <c:pt idx="5368">
                  <c:v>-0.99739996910094675</c:v>
                </c:pt>
                <c:pt idx="5369">
                  <c:v>-3.2602500247955533</c:v>
                </c:pt>
                <c:pt idx="5370">
                  <c:v>-1.9482999825477521</c:v>
                </c:pt>
                <c:pt idx="5371">
                  <c:v>-1.2261499595641965</c:v>
                </c:pt>
                <c:pt idx="5372">
                  <c:v>-2.10500006198885</c:v>
                </c:pt>
                <c:pt idx="5373">
                  <c:v>0.43815004825584936</c:v>
                </c:pt>
                <c:pt idx="5374">
                  <c:v>0.58415004730225206</c:v>
                </c:pt>
                <c:pt idx="5375">
                  <c:v>-0.14535006999975053</c:v>
                </c:pt>
                <c:pt idx="5376">
                  <c:v>-3.7156500101089485</c:v>
                </c:pt>
                <c:pt idx="5377">
                  <c:v>-7.6515999841690032</c:v>
                </c:pt>
                <c:pt idx="5378">
                  <c:v>-2.5267998981475941</c:v>
                </c:pt>
                <c:pt idx="5379">
                  <c:v>-1.1448501324654003</c:v>
                </c:pt>
                <c:pt idx="5380">
                  <c:v>-2.2677500915527027</c:v>
                </c:pt>
                <c:pt idx="5381">
                  <c:v>-1.1959500908850984</c:v>
                </c:pt>
                <c:pt idx="5382">
                  <c:v>-0.8116999912262024</c:v>
                </c:pt>
                <c:pt idx="5383">
                  <c:v>0.15550003528595013</c:v>
                </c:pt>
                <c:pt idx="5384">
                  <c:v>-0.84724994659420361</c:v>
                </c:pt>
                <c:pt idx="5385">
                  <c:v>-1.3928001308441011</c:v>
                </c:pt>
                <c:pt idx="5386">
                  <c:v>0.97659999847405032</c:v>
                </c:pt>
                <c:pt idx="5387">
                  <c:v>1.2302499914169012</c:v>
                </c:pt>
                <c:pt idx="5388">
                  <c:v>-2.0391499924659477</c:v>
                </c:pt>
                <c:pt idx="5389">
                  <c:v>-1.4234500455856534</c:v>
                </c:pt>
                <c:pt idx="5390">
                  <c:v>-0.38404993534085463</c:v>
                </c:pt>
                <c:pt idx="5391">
                  <c:v>-0.27335004329679791</c:v>
                </c:pt>
                <c:pt idx="5392">
                  <c:v>-2.0661999750136992</c:v>
                </c:pt>
                <c:pt idx="5393">
                  <c:v>-2.1563499855995012</c:v>
                </c:pt>
                <c:pt idx="5394">
                  <c:v>0.56404998302454956</c:v>
                </c:pt>
                <c:pt idx="5395">
                  <c:v>-1.547600002288803</c:v>
                </c:pt>
                <c:pt idx="5396">
                  <c:v>-1.1866999650001482</c:v>
                </c:pt>
                <c:pt idx="5397">
                  <c:v>-2.669350051879853</c:v>
                </c:pt>
                <c:pt idx="5398">
                  <c:v>-2.2942498731613519</c:v>
                </c:pt>
                <c:pt idx="5399">
                  <c:v>0.22760007381440062</c:v>
                </c:pt>
                <c:pt idx="5400">
                  <c:v>0.71300000548365006</c:v>
                </c:pt>
                <c:pt idx="5401">
                  <c:v>0.71300000548365006</c:v>
                </c:pt>
                <c:pt idx="5402">
                  <c:v>0.76184998989110397</c:v>
                </c:pt>
                <c:pt idx="5403">
                  <c:v>-0.9190499591827006</c:v>
                </c:pt>
                <c:pt idx="5404">
                  <c:v>-1.7307499909400548</c:v>
                </c:pt>
                <c:pt idx="5405">
                  <c:v>-2.4492499804497001</c:v>
                </c:pt>
                <c:pt idx="5406">
                  <c:v>0.11244999408724965</c:v>
                </c:pt>
                <c:pt idx="5407">
                  <c:v>-1.3021500396728527</c:v>
                </c:pt>
                <c:pt idx="5408">
                  <c:v>-4.3869499778747532</c:v>
                </c:pt>
                <c:pt idx="5409">
                  <c:v>-3.5210000658034986</c:v>
                </c:pt>
                <c:pt idx="5410">
                  <c:v>0.47024991989140119</c:v>
                </c:pt>
                <c:pt idx="5411">
                  <c:v>-0.96400005340579753</c:v>
                </c:pt>
                <c:pt idx="5412">
                  <c:v>-2.629249935150149</c:v>
                </c:pt>
                <c:pt idx="5413">
                  <c:v>-1.5076001310348985</c:v>
                </c:pt>
                <c:pt idx="5414">
                  <c:v>0.79069992065430128</c:v>
                </c:pt>
                <c:pt idx="5415">
                  <c:v>-1.6089999723434509</c:v>
                </c:pt>
                <c:pt idx="5416">
                  <c:v>-2.3665499567985506</c:v>
                </c:pt>
                <c:pt idx="5417">
                  <c:v>-0.17179991006855033</c:v>
                </c:pt>
                <c:pt idx="5418">
                  <c:v>-0.82229991674419978</c:v>
                </c:pt>
                <c:pt idx="5419">
                  <c:v>0.46939993858340046</c:v>
                </c:pt>
                <c:pt idx="5420">
                  <c:v>-0.14370004177095197</c:v>
                </c:pt>
                <c:pt idx="5421">
                  <c:v>-1.8928999996185034</c:v>
                </c:pt>
                <c:pt idx="5422">
                  <c:v>-2.1964000225067011</c:v>
                </c:pt>
                <c:pt idx="5423">
                  <c:v>7.0650033950798274E-2</c:v>
                </c:pt>
                <c:pt idx="5424">
                  <c:v>-0.64880000114445124</c:v>
                </c:pt>
                <c:pt idx="5425">
                  <c:v>1.8463500261307004</c:v>
                </c:pt>
                <c:pt idx="5426">
                  <c:v>0.1761000990867494</c:v>
                </c:pt>
                <c:pt idx="5427">
                  <c:v>-2.3174499464034497</c:v>
                </c:pt>
                <c:pt idx="5428">
                  <c:v>-0.82560002803804977</c:v>
                </c:pt>
                <c:pt idx="5429">
                  <c:v>-1.7669000482559483</c:v>
                </c:pt>
                <c:pt idx="5430">
                  <c:v>0.93644999980924837</c:v>
                </c:pt>
                <c:pt idx="5431">
                  <c:v>-3.2882000899315003</c:v>
                </c:pt>
                <c:pt idx="5432">
                  <c:v>-3.1054999828338978</c:v>
                </c:pt>
                <c:pt idx="5433">
                  <c:v>0.630799932479853</c:v>
                </c:pt>
                <c:pt idx="5434">
                  <c:v>-3.5374499678612494</c:v>
                </c:pt>
                <c:pt idx="5435">
                  <c:v>-3.0757499742508543</c:v>
                </c:pt>
                <c:pt idx="5436">
                  <c:v>-1.2413500022888506</c:v>
                </c:pt>
                <c:pt idx="5437">
                  <c:v>0.44304999828340286</c:v>
                </c:pt>
                <c:pt idx="5438">
                  <c:v>-9.3499994278001708E-2</c:v>
                </c:pt>
                <c:pt idx="5439">
                  <c:v>-0.90815005302430052</c:v>
                </c:pt>
                <c:pt idx="5440">
                  <c:v>-1.7909001016617019</c:v>
                </c:pt>
                <c:pt idx="5441">
                  <c:v>6.7100057601901852E-2</c:v>
                </c:pt>
                <c:pt idx="5442">
                  <c:v>0.37575002193450047</c:v>
                </c:pt>
                <c:pt idx="5443">
                  <c:v>-1.3901001143455503</c:v>
                </c:pt>
                <c:pt idx="5444">
                  <c:v>-2.3090000629424985</c:v>
                </c:pt>
                <c:pt idx="5445">
                  <c:v>1.4417999982834004</c:v>
                </c:pt>
                <c:pt idx="5446">
                  <c:v>-3.7342999672889476</c:v>
                </c:pt>
                <c:pt idx="5447">
                  <c:v>-1.0822999525070003</c:v>
                </c:pt>
                <c:pt idx="5448">
                  <c:v>-2.3402499580382994</c:v>
                </c:pt>
                <c:pt idx="5449">
                  <c:v>-1.3938499808310993</c:v>
                </c:pt>
                <c:pt idx="5450">
                  <c:v>-0.90594997406009981</c:v>
                </c:pt>
                <c:pt idx="5451">
                  <c:v>-2.3800499629974539</c:v>
                </c:pt>
                <c:pt idx="5452">
                  <c:v>-2.5842000627517976</c:v>
                </c:pt>
                <c:pt idx="5453">
                  <c:v>0.5224499082565508</c:v>
                </c:pt>
                <c:pt idx="5454">
                  <c:v>-0.29985006093975031</c:v>
                </c:pt>
                <c:pt idx="5455">
                  <c:v>-2.3155500125885027</c:v>
                </c:pt>
                <c:pt idx="5456">
                  <c:v>-1.986199960708646</c:v>
                </c:pt>
                <c:pt idx="5457">
                  <c:v>-0.50934993743894807</c:v>
                </c:pt>
                <c:pt idx="5458">
                  <c:v>-4.6967000007629522</c:v>
                </c:pt>
                <c:pt idx="5459">
                  <c:v>-4.5256000614166503</c:v>
                </c:pt>
                <c:pt idx="5460">
                  <c:v>-0.63309992790224712</c:v>
                </c:pt>
                <c:pt idx="5461">
                  <c:v>0.19590000152584963</c:v>
                </c:pt>
                <c:pt idx="5462">
                  <c:v>-1.0731999921798518</c:v>
                </c:pt>
                <c:pt idx="5463">
                  <c:v>-2.6971999692916526</c:v>
                </c:pt>
                <c:pt idx="5464">
                  <c:v>0.61834994316104996</c:v>
                </c:pt>
                <c:pt idx="5465">
                  <c:v>-3.5439999198914016</c:v>
                </c:pt>
                <c:pt idx="5466">
                  <c:v>-0.84644991874694853</c:v>
                </c:pt>
                <c:pt idx="5467">
                  <c:v>-3.9300000524520513</c:v>
                </c:pt>
                <c:pt idx="5468">
                  <c:v>-0.76915005207064624</c:v>
                </c:pt>
                <c:pt idx="5469">
                  <c:v>-2.9855501127243471</c:v>
                </c:pt>
                <c:pt idx="5470">
                  <c:v>-1.5635999965667509</c:v>
                </c:pt>
                <c:pt idx="5471">
                  <c:v>-1.1882000255584977</c:v>
                </c:pt>
                <c:pt idx="5472">
                  <c:v>-0.24069995403294797</c:v>
                </c:pt>
                <c:pt idx="5473">
                  <c:v>-1.7205499410629486</c:v>
                </c:pt>
                <c:pt idx="5474">
                  <c:v>-3.1446000170708004</c:v>
                </c:pt>
                <c:pt idx="5475">
                  <c:v>-0.2230501317977982</c:v>
                </c:pt>
                <c:pt idx="5476">
                  <c:v>-3.6400500249862482</c:v>
                </c:pt>
                <c:pt idx="5477">
                  <c:v>-2.2546000719070491</c:v>
                </c:pt>
                <c:pt idx="5478">
                  <c:v>-2.0203000378608493</c:v>
                </c:pt>
                <c:pt idx="5479">
                  <c:v>0.61059988021850131</c:v>
                </c:pt>
                <c:pt idx="5480">
                  <c:v>-0.72830000638965231</c:v>
                </c:pt>
                <c:pt idx="5481">
                  <c:v>-4.6368499231338518</c:v>
                </c:pt>
                <c:pt idx="5482">
                  <c:v>-2.492899951934799</c:v>
                </c:pt>
                <c:pt idx="5483">
                  <c:v>-1.8788999986648527</c:v>
                </c:pt>
                <c:pt idx="5484">
                  <c:v>3.8250041007952262E-2</c:v>
                </c:pt>
                <c:pt idx="5485">
                  <c:v>1.0154000091552504</c:v>
                </c:pt>
                <c:pt idx="5486">
                  <c:v>-3.3756999897956526</c:v>
                </c:pt>
                <c:pt idx="5487">
                  <c:v>-3.9009999990463484</c:v>
                </c:pt>
                <c:pt idx="5488">
                  <c:v>-0.92275003433224967</c:v>
                </c:pt>
                <c:pt idx="5489">
                  <c:v>0.2707000541687492</c:v>
                </c:pt>
                <c:pt idx="5490">
                  <c:v>-0.9354501247406013</c:v>
                </c:pt>
                <c:pt idx="5491">
                  <c:v>-1.2909001255035548</c:v>
                </c:pt>
                <c:pt idx="5492">
                  <c:v>-2.856549985408801</c:v>
                </c:pt>
                <c:pt idx="5493">
                  <c:v>-0.31705006122589907</c:v>
                </c:pt>
                <c:pt idx="5494">
                  <c:v>0.67545017004015051</c:v>
                </c:pt>
                <c:pt idx="5495">
                  <c:v>-2.1998000049591013</c:v>
                </c:pt>
                <c:pt idx="5496">
                  <c:v>-2.50405000686645</c:v>
                </c:pt>
                <c:pt idx="5497">
                  <c:v>-1.2164499330521004</c:v>
                </c:pt>
                <c:pt idx="5498">
                  <c:v>-5.7329000473022482</c:v>
                </c:pt>
                <c:pt idx="5499">
                  <c:v>-1.6673500776290489</c:v>
                </c:pt>
                <c:pt idx="5500">
                  <c:v>-2.5774499511718965</c:v>
                </c:pt>
                <c:pt idx="5501">
                  <c:v>-0.9452499079704495</c:v>
                </c:pt>
                <c:pt idx="5502">
                  <c:v>0.38849998950955467</c:v>
                </c:pt>
                <c:pt idx="5503">
                  <c:v>-3.7065999317169016</c:v>
                </c:pt>
                <c:pt idx="5504">
                  <c:v>-1.9992499327659523</c:v>
                </c:pt>
                <c:pt idx="5505">
                  <c:v>-1.1813500833512016</c:v>
                </c:pt>
                <c:pt idx="5506">
                  <c:v>-0.73109990596770302</c:v>
                </c:pt>
                <c:pt idx="5507">
                  <c:v>-0.12529996871945315</c:v>
                </c:pt>
                <c:pt idx="5508">
                  <c:v>-0.24320009708399937</c:v>
                </c:pt>
                <c:pt idx="5509">
                  <c:v>2.6749930381800624E-2</c:v>
                </c:pt>
                <c:pt idx="5510">
                  <c:v>-0.9706499433517024</c:v>
                </c:pt>
                <c:pt idx="5511">
                  <c:v>-0.11565001964569888</c:v>
                </c:pt>
                <c:pt idx="5512">
                  <c:v>2.1500055789946515E-2</c:v>
                </c:pt>
                <c:pt idx="5513">
                  <c:v>-0.70725001335140547</c:v>
                </c:pt>
                <c:pt idx="5514">
                  <c:v>-3.8098500609397519</c:v>
                </c:pt>
                <c:pt idx="5515">
                  <c:v>-2.4567333456964491</c:v>
                </c:pt>
                <c:pt idx="5516">
                  <c:v>-0.25915007114415189</c:v>
                </c:pt>
                <c:pt idx="5517">
                  <c:v>-1.1194498610496488</c:v>
                </c:pt>
                <c:pt idx="5518">
                  <c:v>1.5558500194549509</c:v>
                </c:pt>
                <c:pt idx="5519">
                  <c:v>-1.6280500030517011</c:v>
                </c:pt>
                <c:pt idx="5520">
                  <c:v>-1.0236000061035497</c:v>
                </c:pt>
                <c:pt idx="5521">
                  <c:v>1.3149999999999977</c:v>
                </c:pt>
                <c:pt idx="5522">
                  <c:v>-0.36515009880069726</c:v>
                </c:pt>
                <c:pt idx="5523">
                  <c:v>-2.1942001008987546</c:v>
                </c:pt>
                <c:pt idx="5524">
                  <c:v>-0.98400001049035168</c:v>
                </c:pt>
                <c:pt idx="5525">
                  <c:v>-0.83510002136230099</c:v>
                </c:pt>
                <c:pt idx="5526">
                  <c:v>1.0345499682427004</c:v>
                </c:pt>
                <c:pt idx="5527">
                  <c:v>-2.9955999374389464</c:v>
                </c:pt>
                <c:pt idx="5528">
                  <c:v>1.2849957942947299E-2</c:v>
                </c:pt>
                <c:pt idx="5529">
                  <c:v>-1.2126999759674</c:v>
                </c:pt>
                <c:pt idx="5530">
                  <c:v>3.7500066757200301E-2</c:v>
                </c:pt>
                <c:pt idx="5531">
                  <c:v>-2.5108999967575016</c:v>
                </c:pt>
                <c:pt idx="5532">
                  <c:v>0.72269998550414982</c:v>
                </c:pt>
                <c:pt idx="5533">
                  <c:v>-3.0469500660896038</c:v>
                </c:pt>
                <c:pt idx="5534">
                  <c:v>-1.5492999148369009</c:v>
                </c:pt>
                <c:pt idx="5535">
                  <c:v>-1.7055000233650475</c:v>
                </c:pt>
                <c:pt idx="5536">
                  <c:v>-0.69625002145770054</c:v>
                </c:pt>
                <c:pt idx="5537">
                  <c:v>-2.4517500638962026</c:v>
                </c:pt>
                <c:pt idx="5538">
                  <c:v>0.26050004959109785</c:v>
                </c:pt>
                <c:pt idx="5539">
                  <c:v>-1.818450098037701</c:v>
                </c:pt>
                <c:pt idx="5540">
                  <c:v>-2.1007499337196478</c:v>
                </c:pt>
                <c:pt idx="5541">
                  <c:v>-1.6675500440597482</c:v>
                </c:pt>
                <c:pt idx="5542">
                  <c:v>7.0009946820093205E-4</c:v>
                </c:pt>
                <c:pt idx="5543">
                  <c:v>0.33324998378755311</c:v>
                </c:pt>
                <c:pt idx="5544">
                  <c:v>-0.21410002231600345</c:v>
                </c:pt>
                <c:pt idx="5545">
                  <c:v>5.1299986839303813E-2</c:v>
                </c:pt>
                <c:pt idx="5546">
                  <c:v>-3.8328500032424984</c:v>
                </c:pt>
                <c:pt idx="5547">
                  <c:v>-3.0491999530792455</c:v>
                </c:pt>
                <c:pt idx="5548">
                  <c:v>-1.1777499914169489</c:v>
                </c:pt>
                <c:pt idx="5549">
                  <c:v>-3.0294000291824972</c:v>
                </c:pt>
                <c:pt idx="5550">
                  <c:v>-1.8377499365806997</c:v>
                </c:pt>
                <c:pt idx="5551">
                  <c:v>-1.4159499502181987</c:v>
                </c:pt>
                <c:pt idx="5552">
                  <c:v>2.7773499703406976</c:v>
                </c:pt>
                <c:pt idx="5553">
                  <c:v>-3.2075000762939467</c:v>
                </c:pt>
                <c:pt idx="5554">
                  <c:v>-3.9780501079558981</c:v>
                </c:pt>
                <c:pt idx="5555">
                  <c:v>-0.73380002260204691</c:v>
                </c:pt>
                <c:pt idx="5556">
                  <c:v>-1.3192499017715527</c:v>
                </c:pt>
                <c:pt idx="5557">
                  <c:v>-0.24569988012314781</c:v>
                </c:pt>
                <c:pt idx="5558">
                  <c:v>-3.7269501197337505</c:v>
                </c:pt>
                <c:pt idx="5559">
                  <c:v>0.81204997897145148</c:v>
                </c:pt>
                <c:pt idx="5560">
                  <c:v>-2.737549974918398</c:v>
                </c:pt>
                <c:pt idx="5561">
                  <c:v>-0.50710001945495264</c:v>
                </c:pt>
                <c:pt idx="5562">
                  <c:v>-0.65434999465944799</c:v>
                </c:pt>
                <c:pt idx="5563">
                  <c:v>-2.0643499994278045</c:v>
                </c:pt>
                <c:pt idx="5564">
                  <c:v>-0.32450006484985039</c:v>
                </c:pt>
                <c:pt idx="5565">
                  <c:v>-1.7289999771117479</c:v>
                </c:pt>
                <c:pt idx="5566">
                  <c:v>-1.4077000498771994</c:v>
                </c:pt>
                <c:pt idx="5567">
                  <c:v>2.1099000883101979</c:v>
                </c:pt>
                <c:pt idx="5568">
                  <c:v>-1.3316500425339015</c:v>
                </c:pt>
                <c:pt idx="5569">
                  <c:v>-2.3088501095772003</c:v>
                </c:pt>
                <c:pt idx="5570">
                  <c:v>-2.6639999651908539</c:v>
                </c:pt>
                <c:pt idx="5571">
                  <c:v>-0.34190009117125086</c:v>
                </c:pt>
                <c:pt idx="5572">
                  <c:v>-3.0453500223160006</c:v>
                </c:pt>
                <c:pt idx="5573">
                  <c:v>0.7924500346183514</c:v>
                </c:pt>
                <c:pt idx="5574">
                  <c:v>-0.48795007705690097</c:v>
                </c:pt>
                <c:pt idx="5575">
                  <c:v>-0.99325006961824869</c:v>
                </c:pt>
                <c:pt idx="5576">
                  <c:v>-2.9025499200821017</c:v>
                </c:pt>
                <c:pt idx="5577">
                  <c:v>0.18140015125269571</c:v>
                </c:pt>
                <c:pt idx="5578">
                  <c:v>-0.40624991416934719</c:v>
                </c:pt>
                <c:pt idx="5579">
                  <c:v>-2.2872500848770017</c:v>
                </c:pt>
                <c:pt idx="5580">
                  <c:v>-5.4599952697749643E-2</c:v>
                </c:pt>
                <c:pt idx="5581">
                  <c:v>-2.369649963378901</c:v>
                </c:pt>
                <c:pt idx="5582">
                  <c:v>-1.5100499343872009</c:v>
                </c:pt>
                <c:pt idx="5583">
                  <c:v>-0.43905010461815053</c:v>
                </c:pt>
                <c:pt idx="5584">
                  <c:v>-1.3339500570297531</c:v>
                </c:pt>
                <c:pt idx="5585">
                  <c:v>0.34505002021785103</c:v>
                </c:pt>
                <c:pt idx="5586">
                  <c:v>-0.90890013217924803</c:v>
                </c:pt>
                <c:pt idx="5587">
                  <c:v>-4.6410000467300492</c:v>
                </c:pt>
                <c:pt idx="5588">
                  <c:v>-0.17189995050430085</c:v>
                </c:pt>
                <c:pt idx="5589">
                  <c:v>0.68054993391040242</c:v>
                </c:pt>
                <c:pt idx="5590">
                  <c:v>-1.7473500275611507</c:v>
                </c:pt>
                <c:pt idx="5591">
                  <c:v>-1.3751500058174528</c:v>
                </c:pt>
                <c:pt idx="5592">
                  <c:v>-2.2247998857498494</c:v>
                </c:pt>
                <c:pt idx="5593">
                  <c:v>-3.0452501058578498</c:v>
                </c:pt>
                <c:pt idx="5594">
                  <c:v>-1.14390000581745</c:v>
                </c:pt>
                <c:pt idx="5595">
                  <c:v>5.4998874665201924E-4</c:v>
                </c:pt>
                <c:pt idx="5596">
                  <c:v>-3.5852500629424995</c:v>
                </c:pt>
                <c:pt idx="5597">
                  <c:v>-0.5584000492096024</c:v>
                </c:pt>
                <c:pt idx="5598">
                  <c:v>-2.9677501153945975</c:v>
                </c:pt>
                <c:pt idx="5599">
                  <c:v>-3.3399500751495488</c:v>
                </c:pt>
                <c:pt idx="5600">
                  <c:v>-0.65255002260209949</c:v>
                </c:pt>
                <c:pt idx="5601">
                  <c:v>-1.6134499549865495</c:v>
                </c:pt>
                <c:pt idx="5602">
                  <c:v>-6.7800006866448825E-2</c:v>
                </c:pt>
                <c:pt idx="5603">
                  <c:v>-6.3048000121116985</c:v>
                </c:pt>
                <c:pt idx="5604">
                  <c:v>-1.3483499526976992</c:v>
                </c:pt>
                <c:pt idx="5605">
                  <c:v>1.3816999244689967</c:v>
                </c:pt>
                <c:pt idx="5606">
                  <c:v>-3.0826999878883008</c:v>
                </c:pt>
                <c:pt idx="5607">
                  <c:v>-1.9005500125884964</c:v>
                </c:pt>
                <c:pt idx="5608">
                  <c:v>0.3787499618530461</c:v>
                </c:pt>
                <c:pt idx="5609">
                  <c:v>-3.6931999778747517</c:v>
                </c:pt>
                <c:pt idx="5610">
                  <c:v>-2.1457000827789017</c:v>
                </c:pt>
                <c:pt idx="5611">
                  <c:v>-1.9200034141547917E-2</c:v>
                </c:pt>
                <c:pt idx="5612">
                  <c:v>-2.0336000680922979</c:v>
                </c:pt>
                <c:pt idx="5613">
                  <c:v>-0.45560000658035094</c:v>
                </c:pt>
                <c:pt idx="5614">
                  <c:v>-4.3382998919487008</c:v>
                </c:pt>
                <c:pt idx="5615">
                  <c:v>-3.8342000579833986</c:v>
                </c:pt>
                <c:pt idx="5616">
                  <c:v>-0.5564499735831987</c:v>
                </c:pt>
                <c:pt idx="5617">
                  <c:v>-0.34685005664825042</c:v>
                </c:pt>
                <c:pt idx="5618">
                  <c:v>-2.5274498939514487</c:v>
                </c:pt>
                <c:pt idx="5619">
                  <c:v>-3.9972999572753984</c:v>
                </c:pt>
                <c:pt idx="5620">
                  <c:v>-0.88190009593964902</c:v>
                </c:pt>
                <c:pt idx="5621">
                  <c:v>-1.3016500353813001</c:v>
                </c:pt>
                <c:pt idx="5622">
                  <c:v>1.9669499492645492</c:v>
                </c:pt>
                <c:pt idx="5623">
                  <c:v>-3.7587999391555513</c:v>
                </c:pt>
                <c:pt idx="5624">
                  <c:v>-2.1993999361991499</c:v>
                </c:pt>
                <c:pt idx="5625">
                  <c:v>-1.7791499614715001</c:v>
                </c:pt>
                <c:pt idx="5626">
                  <c:v>-2.166249945163699</c:v>
                </c:pt>
                <c:pt idx="5627">
                  <c:v>1.1043499898910483</c:v>
                </c:pt>
                <c:pt idx="5628">
                  <c:v>-1.8990999555587003</c:v>
                </c:pt>
                <c:pt idx="5629">
                  <c:v>-7.6045499181747509</c:v>
                </c:pt>
                <c:pt idx="5630">
                  <c:v>-3.728600010871844</c:v>
                </c:pt>
                <c:pt idx="5631">
                  <c:v>-2.3077000713348497</c:v>
                </c:pt>
                <c:pt idx="5632">
                  <c:v>-3.7420000314712496</c:v>
                </c:pt>
                <c:pt idx="5633">
                  <c:v>-5.0345499014854482</c:v>
                </c:pt>
                <c:pt idx="5634">
                  <c:v>-1.817450089454649</c:v>
                </c:pt>
                <c:pt idx="5635">
                  <c:v>-1.0494499397278503</c:v>
                </c:pt>
                <c:pt idx="5636">
                  <c:v>-1.4240500211715457</c:v>
                </c:pt>
                <c:pt idx="5637">
                  <c:v>-1.4117499971389478</c:v>
                </c:pt>
                <c:pt idx="5638">
                  <c:v>-1.7503499746323001</c:v>
                </c:pt>
                <c:pt idx="5639">
                  <c:v>-4.2403000450134485</c:v>
                </c:pt>
                <c:pt idx="5640">
                  <c:v>-2.3950499963760485</c:v>
                </c:pt>
                <c:pt idx="5641">
                  <c:v>8.4400172233550563E-2</c:v>
                </c:pt>
                <c:pt idx="5642">
                  <c:v>-0.26139986038199936</c:v>
                </c:pt>
                <c:pt idx="5643">
                  <c:v>-2.7703000068664494</c:v>
                </c:pt>
                <c:pt idx="5644">
                  <c:v>-1.2541500234604008</c:v>
                </c:pt>
                <c:pt idx="5645">
                  <c:v>-2.0967500591278494</c:v>
                </c:pt>
                <c:pt idx="5646">
                  <c:v>-3.744800016880049</c:v>
                </c:pt>
                <c:pt idx="5647">
                  <c:v>-3.1492499947548005</c:v>
                </c:pt>
                <c:pt idx="5648">
                  <c:v>-2.9045500278472502</c:v>
                </c:pt>
                <c:pt idx="5649">
                  <c:v>-3.2745000743866015</c:v>
                </c:pt>
                <c:pt idx="5650">
                  <c:v>-1.1805000019073475</c:v>
                </c:pt>
                <c:pt idx="5651">
                  <c:v>-2.2117499375343996</c:v>
                </c:pt>
                <c:pt idx="5652">
                  <c:v>-1.8679999971389485</c:v>
                </c:pt>
                <c:pt idx="5653">
                  <c:v>0.36775013923645261</c:v>
                </c:pt>
                <c:pt idx="5654">
                  <c:v>-3.0351499128341501</c:v>
                </c:pt>
                <c:pt idx="5655">
                  <c:v>-1.956000056266749</c:v>
                </c:pt>
                <c:pt idx="5656">
                  <c:v>-2.2733999919891517</c:v>
                </c:pt>
                <c:pt idx="5657">
                  <c:v>-4.7547499012946979</c:v>
                </c:pt>
                <c:pt idx="5658">
                  <c:v>3.6750142574302203E-2</c:v>
                </c:pt>
                <c:pt idx="5659">
                  <c:v>-2.3489000105858011</c:v>
                </c:pt>
                <c:pt idx="5660">
                  <c:v>-3.1383999276161489</c:v>
                </c:pt>
                <c:pt idx="5661">
                  <c:v>-1.309700095653497</c:v>
                </c:pt>
                <c:pt idx="5662">
                  <c:v>-2.5100999808311002</c:v>
                </c:pt>
                <c:pt idx="5663">
                  <c:v>-2.033599991798404</c:v>
                </c:pt>
                <c:pt idx="5664">
                  <c:v>-1.6045001125336</c:v>
                </c:pt>
                <c:pt idx="5665">
                  <c:v>-1.2117000484466516</c:v>
                </c:pt>
                <c:pt idx="5666">
                  <c:v>-2.4457000041008001</c:v>
                </c:pt>
                <c:pt idx="5667">
                  <c:v>-0.20709995746615206</c:v>
                </c:pt>
                <c:pt idx="5668">
                  <c:v>-0.55145003795625414</c:v>
                </c:pt>
                <c:pt idx="5669">
                  <c:v>-3.8041000199317985</c:v>
                </c:pt>
                <c:pt idx="5670">
                  <c:v>0.58315003871919657</c:v>
                </c:pt>
                <c:pt idx="5671">
                  <c:v>-5.7927499389647998</c:v>
                </c:pt>
                <c:pt idx="5672">
                  <c:v>-1.6885000276565485</c:v>
                </c:pt>
                <c:pt idx="5673">
                  <c:v>-1.0669000077248008</c:v>
                </c:pt>
                <c:pt idx="5674">
                  <c:v>-1.8830499267578027</c:v>
                </c:pt>
                <c:pt idx="5675">
                  <c:v>-0.5294999289512532</c:v>
                </c:pt>
                <c:pt idx="5676">
                  <c:v>-5.722749881744349</c:v>
                </c:pt>
                <c:pt idx="5677">
                  <c:v>-1.2612501049042031</c:v>
                </c:pt>
                <c:pt idx="5678">
                  <c:v>-1.5987000417709538</c:v>
                </c:pt>
                <c:pt idx="5679">
                  <c:v>-2.8596499586105466</c:v>
                </c:pt>
                <c:pt idx="5680">
                  <c:v>-3.1381500720978011</c:v>
                </c:pt>
                <c:pt idx="5681">
                  <c:v>-3.6812499666214009</c:v>
                </c:pt>
                <c:pt idx="5682">
                  <c:v>-2.8683500194549509</c:v>
                </c:pt>
                <c:pt idx="5683">
                  <c:v>-0.27215012311934927</c:v>
                </c:pt>
                <c:pt idx="5684">
                  <c:v>-1.794149990081749</c:v>
                </c:pt>
                <c:pt idx="5685">
                  <c:v>-2.3995500421523488</c:v>
                </c:pt>
                <c:pt idx="5686">
                  <c:v>-1.9481000590323987</c:v>
                </c:pt>
                <c:pt idx="5687">
                  <c:v>-3.7483500075340004</c:v>
                </c:pt>
                <c:pt idx="5688">
                  <c:v>-2.4008000993728515</c:v>
                </c:pt>
                <c:pt idx="5689">
                  <c:v>-4.427800073623601</c:v>
                </c:pt>
                <c:pt idx="5690">
                  <c:v>-4.5536499786377007</c:v>
                </c:pt>
                <c:pt idx="5691">
                  <c:v>-0.48500000715254998</c:v>
                </c:pt>
                <c:pt idx="5692">
                  <c:v>-1.8902999472617985</c:v>
                </c:pt>
                <c:pt idx="5693">
                  <c:v>-0.88560000896454838</c:v>
                </c:pt>
                <c:pt idx="5694">
                  <c:v>-7.5849845409351246E-2</c:v>
                </c:pt>
                <c:pt idx="5695">
                  <c:v>-3.0337499666214001</c:v>
                </c:pt>
                <c:pt idx="5696">
                  <c:v>-1.0009500598907515</c:v>
                </c:pt>
                <c:pt idx="5697">
                  <c:v>-1.2398500108719475</c:v>
                </c:pt>
                <c:pt idx="5698">
                  <c:v>-1.5868500351905972</c:v>
                </c:pt>
                <c:pt idx="5699">
                  <c:v>-1.1055499601364502</c:v>
                </c:pt>
                <c:pt idx="5700">
                  <c:v>-2.123450074195901</c:v>
                </c:pt>
                <c:pt idx="5701">
                  <c:v>1.3300500535964481</c:v>
                </c:pt>
                <c:pt idx="5702">
                  <c:v>-4.6000075340515423E-3</c:v>
                </c:pt>
                <c:pt idx="5703">
                  <c:v>-0.54354998111725195</c:v>
                </c:pt>
                <c:pt idx="5704">
                  <c:v>-5.5969999933242995</c:v>
                </c:pt>
                <c:pt idx="5705">
                  <c:v>-2.0675000429153023</c:v>
                </c:pt>
                <c:pt idx="5706">
                  <c:v>-1.6248499488830994</c:v>
                </c:pt>
                <c:pt idx="5707">
                  <c:v>-3.4994000053406005</c:v>
                </c:pt>
                <c:pt idx="5708">
                  <c:v>-0.95110005378720075</c:v>
                </c:pt>
                <c:pt idx="5709">
                  <c:v>-4.346550037860851</c:v>
                </c:pt>
                <c:pt idx="5710">
                  <c:v>-0.95059993267059895</c:v>
                </c:pt>
                <c:pt idx="5711">
                  <c:v>-0.96845001220700055</c:v>
                </c:pt>
                <c:pt idx="5712">
                  <c:v>-1.8201499652862481</c:v>
                </c:pt>
                <c:pt idx="5713">
                  <c:v>-0.12679994821550267</c:v>
                </c:pt>
                <c:pt idx="5714">
                  <c:v>-0.27509997367855021</c:v>
                </c:pt>
                <c:pt idx="5715">
                  <c:v>-2.6914000177383492</c:v>
                </c:pt>
                <c:pt idx="5716">
                  <c:v>-4.4054001474380478</c:v>
                </c:pt>
                <c:pt idx="5717">
                  <c:v>-2.0389000892639508</c:v>
                </c:pt>
                <c:pt idx="5718">
                  <c:v>-0.11399991035460033</c:v>
                </c:pt>
                <c:pt idx="5719">
                  <c:v>-1.0400999236107538</c:v>
                </c:pt>
                <c:pt idx="5720">
                  <c:v>0.45990006446839971</c:v>
                </c:pt>
                <c:pt idx="5721">
                  <c:v>-0.71004996299739531</c:v>
                </c:pt>
                <c:pt idx="5722">
                  <c:v>-4.4143499088286973</c:v>
                </c:pt>
                <c:pt idx="5723">
                  <c:v>-1.4518499517440482</c:v>
                </c:pt>
                <c:pt idx="5724">
                  <c:v>-1.2815499401092509</c:v>
                </c:pt>
                <c:pt idx="5725">
                  <c:v>-2.4757000494003023</c:v>
                </c:pt>
                <c:pt idx="5726">
                  <c:v>-3.9935500383376983</c:v>
                </c:pt>
                <c:pt idx="5727">
                  <c:v>-1.9331000232696027</c:v>
                </c:pt>
                <c:pt idx="5728">
                  <c:v>-2.7655499935150019</c:v>
                </c:pt>
                <c:pt idx="5729">
                  <c:v>-0.87975008249279796</c:v>
                </c:pt>
                <c:pt idx="5730">
                  <c:v>-5.8317998719215502</c:v>
                </c:pt>
                <c:pt idx="5731">
                  <c:v>-1.6408498525620026</c:v>
                </c:pt>
                <c:pt idx="5732">
                  <c:v>-3.3962500691413986</c:v>
                </c:pt>
                <c:pt idx="5733">
                  <c:v>-0.47879997968680144</c:v>
                </c:pt>
                <c:pt idx="5734">
                  <c:v>-2.2733500003814484</c:v>
                </c:pt>
                <c:pt idx="5735">
                  <c:v>-1.4618499922752513</c:v>
                </c:pt>
                <c:pt idx="5736">
                  <c:v>-1.1063000750541008</c:v>
                </c:pt>
                <c:pt idx="5737">
                  <c:v>3.7622001028061014</c:v>
                </c:pt>
                <c:pt idx="5738">
                  <c:v>-1.8309000611305493</c:v>
                </c:pt>
                <c:pt idx="5739">
                  <c:v>-3.9937999582290971</c:v>
                </c:pt>
                <c:pt idx="5740">
                  <c:v>-2.7270000791550011</c:v>
                </c:pt>
                <c:pt idx="5741">
                  <c:v>-1.5487499737739476</c:v>
                </c:pt>
                <c:pt idx="5742">
                  <c:v>-3.1204499197005973</c:v>
                </c:pt>
                <c:pt idx="5743">
                  <c:v>-0.29184989452360099</c:v>
                </c:pt>
                <c:pt idx="5744">
                  <c:v>-0.51900002479555241</c:v>
                </c:pt>
                <c:pt idx="5745">
                  <c:v>0.43300009489059832</c:v>
                </c:pt>
                <c:pt idx="5746">
                  <c:v>-3.1016499662399042</c:v>
                </c:pt>
                <c:pt idx="5747">
                  <c:v>-2.5601500391959959</c:v>
                </c:pt>
                <c:pt idx="5748">
                  <c:v>-2.9662999367713532</c:v>
                </c:pt>
                <c:pt idx="5749">
                  <c:v>-1.2048500061035483</c:v>
                </c:pt>
                <c:pt idx="5750">
                  <c:v>-2.8876999378204502</c:v>
                </c:pt>
                <c:pt idx="5751">
                  <c:v>-1.7636500453948472</c:v>
                </c:pt>
                <c:pt idx="5752">
                  <c:v>-0.56089985609055049</c:v>
                </c:pt>
                <c:pt idx="5753">
                  <c:v>-2.5334001541137994</c:v>
                </c:pt>
                <c:pt idx="5754">
                  <c:v>-2.0063999819755516</c:v>
                </c:pt>
                <c:pt idx="5755">
                  <c:v>-2.8247500514984516</c:v>
                </c:pt>
                <c:pt idx="5756">
                  <c:v>-4.8781499385833484</c:v>
                </c:pt>
                <c:pt idx="5757">
                  <c:v>-1.4021999502182041</c:v>
                </c:pt>
                <c:pt idx="5758">
                  <c:v>-3.289850068092349</c:v>
                </c:pt>
                <c:pt idx="5759">
                  <c:v>-2.6578499507903999</c:v>
                </c:pt>
                <c:pt idx="5760">
                  <c:v>-1.2621000623702976</c:v>
                </c:pt>
                <c:pt idx="5761">
                  <c:v>-4.265350155830351</c:v>
                </c:pt>
                <c:pt idx="5762">
                  <c:v>-2.4508499670028527</c:v>
                </c:pt>
                <c:pt idx="5763">
                  <c:v>-2.7739000415801982</c:v>
                </c:pt>
                <c:pt idx="5764">
                  <c:v>0.63729997634889912</c:v>
                </c:pt>
                <c:pt idx="5765">
                  <c:v>-4.2761000418663002</c:v>
                </c:pt>
                <c:pt idx="5766">
                  <c:v>-0.97065002918245114</c:v>
                </c:pt>
                <c:pt idx="5767">
                  <c:v>-1.7998000597953983</c:v>
                </c:pt>
                <c:pt idx="5768">
                  <c:v>-3.0361000418662982</c:v>
                </c:pt>
                <c:pt idx="5769">
                  <c:v>-3.5936500525474457</c:v>
                </c:pt>
                <c:pt idx="5770">
                  <c:v>-2.9105000448226477</c:v>
                </c:pt>
                <c:pt idx="5771">
                  <c:v>-0.59359998941414815</c:v>
                </c:pt>
                <c:pt idx="5772">
                  <c:v>-3.9630499911308519</c:v>
                </c:pt>
                <c:pt idx="5773">
                  <c:v>-0.24144994735720005</c:v>
                </c:pt>
                <c:pt idx="5774">
                  <c:v>-1.7581000041961516</c:v>
                </c:pt>
                <c:pt idx="5775">
                  <c:v>-1.5297499752045027</c:v>
                </c:pt>
                <c:pt idx="5776">
                  <c:v>-2.5715500879287987</c:v>
                </c:pt>
                <c:pt idx="5777">
                  <c:v>-2.3712499570846504</c:v>
                </c:pt>
                <c:pt idx="5778">
                  <c:v>-1.3797500085830485</c:v>
                </c:pt>
                <c:pt idx="5779">
                  <c:v>-1.4710999822616486</c:v>
                </c:pt>
                <c:pt idx="5780">
                  <c:v>-1.4963000249862972</c:v>
                </c:pt>
                <c:pt idx="5781">
                  <c:v>-0.18485003948214995</c:v>
                </c:pt>
                <c:pt idx="5782">
                  <c:v>-1.6736499309538964</c:v>
                </c:pt>
                <c:pt idx="5783">
                  <c:v>-0.7875000190734518</c:v>
                </c:pt>
                <c:pt idx="5784">
                  <c:v>0.58345000743864972</c:v>
                </c:pt>
                <c:pt idx="5785">
                  <c:v>-1.076399919986752</c:v>
                </c:pt>
                <c:pt idx="5786">
                  <c:v>-4.2150499534606993</c:v>
                </c:pt>
                <c:pt idx="5787">
                  <c:v>-1.6342500567436034</c:v>
                </c:pt>
                <c:pt idx="5788">
                  <c:v>-1.8670998907089533</c:v>
                </c:pt>
                <c:pt idx="5789">
                  <c:v>-5.9840500164031987</c:v>
                </c:pt>
                <c:pt idx="5790">
                  <c:v>-0.5414498996734487</c:v>
                </c:pt>
                <c:pt idx="5791">
                  <c:v>0.18684989213944903</c:v>
                </c:pt>
                <c:pt idx="5792">
                  <c:v>-1.8985500574111995</c:v>
                </c:pt>
                <c:pt idx="5793">
                  <c:v>-1.5642498493194523</c:v>
                </c:pt>
                <c:pt idx="5794">
                  <c:v>-7.4571998882292974</c:v>
                </c:pt>
                <c:pt idx="5795">
                  <c:v>-2.1748500609397965</c:v>
                </c:pt>
                <c:pt idx="5796">
                  <c:v>-2.9120999383927035</c:v>
                </c:pt>
                <c:pt idx="5797">
                  <c:v>-0.85960004329680118</c:v>
                </c:pt>
                <c:pt idx="5798">
                  <c:v>2.3213999724387975</c:v>
                </c:pt>
                <c:pt idx="5799">
                  <c:v>-1.1749892234750092E-2</c:v>
                </c:pt>
                <c:pt idx="5800">
                  <c:v>-7.9699988365149466E-2</c:v>
                </c:pt>
                <c:pt idx="5801">
                  <c:v>-0.6748501062392549</c:v>
                </c:pt>
                <c:pt idx="5802">
                  <c:v>-2.4770000147819502</c:v>
                </c:pt>
                <c:pt idx="5803">
                  <c:v>-2.6229500436782978</c:v>
                </c:pt>
                <c:pt idx="5804">
                  <c:v>4.650053977997004E-3</c:v>
                </c:pt>
                <c:pt idx="5805">
                  <c:v>-0.59945002079015097</c:v>
                </c:pt>
                <c:pt idx="5806">
                  <c:v>-1.8748500633239473</c:v>
                </c:pt>
                <c:pt idx="5807">
                  <c:v>-1.4655000233649993</c:v>
                </c:pt>
                <c:pt idx="5808">
                  <c:v>-1.3564000606536979</c:v>
                </c:pt>
                <c:pt idx="5809">
                  <c:v>-1.33469999790195</c:v>
                </c:pt>
                <c:pt idx="5810">
                  <c:v>0.42759999990465047</c:v>
                </c:pt>
                <c:pt idx="5811">
                  <c:v>1.0040000391006494</c:v>
                </c:pt>
                <c:pt idx="5812">
                  <c:v>-1.4818999135493982</c:v>
                </c:pt>
                <c:pt idx="5813">
                  <c:v>-2.9752499032020481</c:v>
                </c:pt>
                <c:pt idx="5814">
                  <c:v>-2.6714500665664502</c:v>
                </c:pt>
                <c:pt idx="5815">
                  <c:v>-1.8968499112129464</c:v>
                </c:pt>
                <c:pt idx="5816">
                  <c:v>-1.1541999816894482</c:v>
                </c:pt>
                <c:pt idx="5817">
                  <c:v>-0.90640003204345376</c:v>
                </c:pt>
                <c:pt idx="5818">
                  <c:v>-0.30194996595385248</c:v>
                </c:pt>
                <c:pt idx="5819">
                  <c:v>-2.7712000298500001</c:v>
                </c:pt>
                <c:pt idx="5820">
                  <c:v>0.89104994058609854</c:v>
                </c:pt>
                <c:pt idx="5821">
                  <c:v>-3.0045990460328511</c:v>
                </c:pt>
                <c:pt idx="5822">
                  <c:v>-4.5149500656127479</c:v>
                </c:pt>
                <c:pt idx="5823">
                  <c:v>-2.7242999744415499</c:v>
                </c:pt>
                <c:pt idx="5824">
                  <c:v>-1.7695500016212478</c:v>
                </c:pt>
                <c:pt idx="5825">
                  <c:v>-4.0863999938964497</c:v>
                </c:pt>
                <c:pt idx="5826">
                  <c:v>-1.3507499742507996</c:v>
                </c:pt>
                <c:pt idx="5827">
                  <c:v>-3.8166999793052483</c:v>
                </c:pt>
                <c:pt idx="5828">
                  <c:v>-5.0897999954223536</c:v>
                </c:pt>
                <c:pt idx="5829">
                  <c:v>-2.5561999797821535</c:v>
                </c:pt>
                <c:pt idx="5830">
                  <c:v>-1.0439500737190457</c:v>
                </c:pt>
                <c:pt idx="5831">
                  <c:v>-4.1641999411583512</c:v>
                </c:pt>
                <c:pt idx="5832">
                  <c:v>-1.684750003814699</c:v>
                </c:pt>
                <c:pt idx="5833">
                  <c:v>-3.4059999394416458</c:v>
                </c:pt>
                <c:pt idx="5834">
                  <c:v>-6.5240999388694476</c:v>
                </c:pt>
                <c:pt idx="5835">
                  <c:v>-1.4322999358177491</c:v>
                </c:pt>
                <c:pt idx="5836">
                  <c:v>-3.5444001293182517</c:v>
                </c:pt>
                <c:pt idx="5837">
                  <c:v>-2.4821500158310528</c:v>
                </c:pt>
                <c:pt idx="5838">
                  <c:v>-1.0360000562668006</c:v>
                </c:pt>
                <c:pt idx="5839">
                  <c:v>-2.9079999852181011</c:v>
                </c:pt>
                <c:pt idx="5840">
                  <c:v>1.4223999619484005</c:v>
                </c:pt>
                <c:pt idx="5841">
                  <c:v>-3.5176500463485993</c:v>
                </c:pt>
                <c:pt idx="5842">
                  <c:v>-2.8215000820159979</c:v>
                </c:pt>
                <c:pt idx="5843">
                  <c:v>-3.4780499982833497</c:v>
                </c:pt>
                <c:pt idx="5844">
                  <c:v>-0.45484998941419974</c:v>
                </c:pt>
                <c:pt idx="5845">
                  <c:v>-0.4466000652313511</c:v>
                </c:pt>
                <c:pt idx="5846">
                  <c:v>-0.26439998149870192</c:v>
                </c:pt>
                <c:pt idx="5847">
                  <c:v>-1.0882000207901008</c:v>
                </c:pt>
                <c:pt idx="5848">
                  <c:v>-2.9916500377654991</c:v>
                </c:pt>
                <c:pt idx="5849">
                  <c:v>-1.9168499803543035</c:v>
                </c:pt>
                <c:pt idx="5850">
                  <c:v>-3.9409500074385981</c:v>
                </c:pt>
                <c:pt idx="5851">
                  <c:v>-3.1306999206542976</c:v>
                </c:pt>
                <c:pt idx="5852">
                  <c:v>-3.8481500744819002</c:v>
                </c:pt>
                <c:pt idx="5853">
                  <c:v>-0.97895002126699993</c:v>
                </c:pt>
                <c:pt idx="5854">
                  <c:v>-2.1881499719619484</c:v>
                </c:pt>
                <c:pt idx="5855">
                  <c:v>-1.7004000735282467</c:v>
                </c:pt>
                <c:pt idx="5856">
                  <c:v>-3.6839999866485513</c:v>
                </c:pt>
                <c:pt idx="5857">
                  <c:v>-3.1416499829291986</c:v>
                </c:pt>
                <c:pt idx="5858">
                  <c:v>-2.8068999969959521</c:v>
                </c:pt>
                <c:pt idx="5859">
                  <c:v>-0.57869997262954698</c:v>
                </c:pt>
                <c:pt idx="5860">
                  <c:v>-3.123249988555898</c:v>
                </c:pt>
                <c:pt idx="5861">
                  <c:v>-3.1395500254631017</c:v>
                </c:pt>
                <c:pt idx="5862">
                  <c:v>-4.8708999991416491</c:v>
                </c:pt>
                <c:pt idx="5863">
                  <c:v>8.825004577640172E-2</c:v>
                </c:pt>
                <c:pt idx="5864">
                  <c:v>-2.8612000131606976</c:v>
                </c:pt>
                <c:pt idx="5865">
                  <c:v>-5.3072500205039965</c:v>
                </c:pt>
                <c:pt idx="5866">
                  <c:v>-1.6630499792099513</c:v>
                </c:pt>
                <c:pt idx="5867">
                  <c:v>-3.9181999230385038</c:v>
                </c:pt>
                <c:pt idx="5868">
                  <c:v>-3.3194000291824501</c:v>
                </c:pt>
                <c:pt idx="5869">
                  <c:v>-2.5929999184608477</c:v>
                </c:pt>
                <c:pt idx="5870">
                  <c:v>-2.1792500352859498</c:v>
                </c:pt>
                <c:pt idx="5871">
                  <c:v>-3.8202500462531965</c:v>
                </c:pt>
                <c:pt idx="5872">
                  <c:v>-4.9026999855041531</c:v>
                </c:pt>
                <c:pt idx="5873">
                  <c:v>-3.8245999860763504</c:v>
                </c:pt>
                <c:pt idx="5874">
                  <c:v>-2.357149930000304</c:v>
                </c:pt>
                <c:pt idx="5875">
                  <c:v>-2.4018500590324514</c:v>
                </c:pt>
                <c:pt idx="5876">
                  <c:v>-1.2573500061035485</c:v>
                </c:pt>
                <c:pt idx="5877">
                  <c:v>-2.4609000217914989</c:v>
                </c:pt>
                <c:pt idx="5878">
                  <c:v>-0.95605001211170126</c:v>
                </c:pt>
                <c:pt idx="5879">
                  <c:v>-1.6270499682426518</c:v>
                </c:pt>
                <c:pt idx="5880">
                  <c:v>-1.4416499805450513</c:v>
                </c:pt>
                <c:pt idx="5881">
                  <c:v>-2.5631999874114992</c:v>
                </c:pt>
                <c:pt idx="5882">
                  <c:v>-1.8916000556945498</c:v>
                </c:pt>
                <c:pt idx="5883">
                  <c:v>0.6535999298095998</c:v>
                </c:pt>
                <c:pt idx="5884">
                  <c:v>-3.3028500533104008</c:v>
                </c:pt>
                <c:pt idx="5885">
                  <c:v>-1.2091999673843503</c:v>
                </c:pt>
                <c:pt idx="5886">
                  <c:v>-1.3636500215529992</c:v>
                </c:pt>
                <c:pt idx="5887">
                  <c:v>-1.7402999949455005</c:v>
                </c:pt>
                <c:pt idx="5888">
                  <c:v>-1.5416500282288013</c:v>
                </c:pt>
                <c:pt idx="5889">
                  <c:v>-2.3849000430107488</c:v>
                </c:pt>
                <c:pt idx="5890">
                  <c:v>-3.3942999339103466</c:v>
                </c:pt>
                <c:pt idx="5891">
                  <c:v>-3.4089499592781465</c:v>
                </c:pt>
                <c:pt idx="5892">
                  <c:v>-5.7231499958038512</c:v>
                </c:pt>
                <c:pt idx="5893">
                  <c:v>-0.78074995040885042</c:v>
                </c:pt>
                <c:pt idx="5894">
                  <c:v>-3.5263500261307499</c:v>
                </c:pt>
                <c:pt idx="5895">
                  <c:v>-2.3302000498771491</c:v>
                </c:pt>
                <c:pt idx="5896">
                  <c:v>-2.2064499974251</c:v>
                </c:pt>
                <c:pt idx="5897">
                  <c:v>-3.4828000414371001</c:v>
                </c:pt>
                <c:pt idx="5898">
                  <c:v>-1.7677499890327475</c:v>
                </c:pt>
                <c:pt idx="5899">
                  <c:v>-4.4449001550674474</c:v>
                </c:pt>
                <c:pt idx="5900">
                  <c:v>-2.2112000226974011</c:v>
                </c:pt>
                <c:pt idx="5901">
                  <c:v>-3.9422501134872494</c:v>
                </c:pt>
                <c:pt idx="5902">
                  <c:v>-3.24104998111725</c:v>
                </c:pt>
                <c:pt idx="5903">
                  <c:v>-3.1882498717307506</c:v>
                </c:pt>
                <c:pt idx="5904">
                  <c:v>-3.1802000546456028</c:v>
                </c:pt>
                <c:pt idx="5905">
                  <c:v>-3.5985999703407519</c:v>
                </c:pt>
                <c:pt idx="5906">
                  <c:v>-4.4649500393867037</c:v>
                </c:pt>
                <c:pt idx="5907">
                  <c:v>-1.7108499336242495</c:v>
                </c:pt>
                <c:pt idx="5908">
                  <c:v>-3.4710000419616502</c:v>
                </c:pt>
                <c:pt idx="5909">
                  <c:v>-5.1747500658034973</c:v>
                </c:pt>
                <c:pt idx="5910">
                  <c:v>-4.1748500800133019</c:v>
                </c:pt>
                <c:pt idx="5911">
                  <c:v>-0.63679986476894967</c:v>
                </c:pt>
                <c:pt idx="5912">
                  <c:v>-5.0992499899864008</c:v>
                </c:pt>
                <c:pt idx="5913">
                  <c:v>-0.69584996223450091</c:v>
                </c:pt>
                <c:pt idx="5914">
                  <c:v>-2.1295500326156507</c:v>
                </c:pt>
                <c:pt idx="5915">
                  <c:v>-3.1813500452041517</c:v>
                </c:pt>
                <c:pt idx="5916">
                  <c:v>-2.2173500728606985</c:v>
                </c:pt>
                <c:pt idx="5917">
                  <c:v>-3.7493500733374994</c:v>
                </c:pt>
                <c:pt idx="5918">
                  <c:v>-3.1507000541686523</c:v>
                </c:pt>
                <c:pt idx="5919">
                  <c:v>-3.6403500294685518</c:v>
                </c:pt>
                <c:pt idx="5920">
                  <c:v>-1.9923999714850975</c:v>
                </c:pt>
                <c:pt idx="5921">
                  <c:v>-2.3727999925613013</c:v>
                </c:pt>
                <c:pt idx="5922">
                  <c:v>-0.16364996433259904</c:v>
                </c:pt>
                <c:pt idx="5923">
                  <c:v>-6.1460999965667504</c:v>
                </c:pt>
                <c:pt idx="5924">
                  <c:v>1.356299941539751</c:v>
                </c:pt>
                <c:pt idx="5925">
                  <c:v>-4.1365500926971475</c:v>
                </c:pt>
                <c:pt idx="5926">
                  <c:v>-4.4872001123427978</c:v>
                </c:pt>
                <c:pt idx="5927">
                  <c:v>-5.7753500318527475</c:v>
                </c:pt>
                <c:pt idx="5928">
                  <c:v>-3.487650010585801</c:v>
                </c:pt>
                <c:pt idx="5929">
                  <c:v>-5.0099500489235531</c:v>
                </c:pt>
                <c:pt idx="5930">
                  <c:v>-2.3965500545501506</c:v>
                </c:pt>
                <c:pt idx="5931">
                  <c:v>-3.1546000266074472</c:v>
                </c:pt>
                <c:pt idx="5932">
                  <c:v>-3.5345000839233514</c:v>
                </c:pt>
                <c:pt idx="5933">
                  <c:v>-2.5500999379158493</c:v>
                </c:pt>
                <c:pt idx="5934">
                  <c:v>-0.69730000734330133</c:v>
                </c:pt>
                <c:pt idx="5935">
                  <c:v>-5.3044000911712992</c:v>
                </c:pt>
                <c:pt idx="5936">
                  <c:v>-4.5604000139236991</c:v>
                </c:pt>
                <c:pt idx="5937">
                  <c:v>-4.7762500262260517</c:v>
                </c:pt>
                <c:pt idx="5938">
                  <c:v>-2.5040999889373516</c:v>
                </c:pt>
                <c:pt idx="5939">
                  <c:v>-2.9607999706267982</c:v>
                </c:pt>
                <c:pt idx="5940">
                  <c:v>-1.0323999524116516</c:v>
                </c:pt>
                <c:pt idx="5941">
                  <c:v>-1.7439499950409019</c:v>
                </c:pt>
                <c:pt idx="5942">
                  <c:v>-7.2605500388145519</c:v>
                </c:pt>
                <c:pt idx="5943">
                  <c:v>-3.3971499633789008</c:v>
                </c:pt>
                <c:pt idx="5944">
                  <c:v>-7.3102999877929982</c:v>
                </c:pt>
                <c:pt idx="5945">
                  <c:v>-5.0863000214099472</c:v>
                </c:pt>
                <c:pt idx="5946">
                  <c:v>-2.9767000246047992</c:v>
                </c:pt>
                <c:pt idx="5947">
                  <c:v>-1.6741999816894513</c:v>
                </c:pt>
                <c:pt idx="5948">
                  <c:v>-1.9847500252723513</c:v>
                </c:pt>
                <c:pt idx="5949">
                  <c:v>-4.1609001231193474</c:v>
                </c:pt>
                <c:pt idx="5950">
                  <c:v>-2.6519500327109498</c:v>
                </c:pt>
                <c:pt idx="5951">
                  <c:v>-5.0869500231742997</c:v>
                </c:pt>
                <c:pt idx="5952">
                  <c:v>-5.0869500231742997</c:v>
                </c:pt>
                <c:pt idx="5953">
                  <c:v>-4.4290999865531475</c:v>
                </c:pt>
                <c:pt idx="5954">
                  <c:v>-4.8971999812126015</c:v>
                </c:pt>
                <c:pt idx="5955">
                  <c:v>-4.0658000302314505</c:v>
                </c:pt>
                <c:pt idx="5956">
                  <c:v>-6.201149892806999</c:v>
                </c:pt>
                <c:pt idx="5957">
                  <c:v>-4.3891999578476018</c:v>
                </c:pt>
                <c:pt idx="5958">
                  <c:v>-4.9114000511168978</c:v>
                </c:pt>
                <c:pt idx="5959">
                  <c:v>-3.8381500196456493</c:v>
                </c:pt>
                <c:pt idx="5960">
                  <c:v>-6.2788999581336462</c:v>
                </c:pt>
                <c:pt idx="5961">
                  <c:v>-4.4870000815391009</c:v>
                </c:pt>
                <c:pt idx="5962">
                  <c:v>-2.9380500650406027</c:v>
                </c:pt>
                <c:pt idx="5963">
                  <c:v>-3.4421000480651998</c:v>
                </c:pt>
                <c:pt idx="5964">
                  <c:v>-3.7923999524116496</c:v>
                </c:pt>
                <c:pt idx="5965">
                  <c:v>-4.7664999389649001</c:v>
                </c:pt>
                <c:pt idx="5966">
                  <c:v>-2.9526000165939514</c:v>
                </c:pt>
                <c:pt idx="5967">
                  <c:v>-5.7344000339508003</c:v>
                </c:pt>
                <c:pt idx="5968">
                  <c:v>-7.8523000001907519</c:v>
                </c:pt>
                <c:pt idx="5969">
                  <c:v>-4.5779999637603481</c:v>
                </c:pt>
                <c:pt idx="5970">
                  <c:v>-5.1185500144958027</c:v>
                </c:pt>
                <c:pt idx="5971">
                  <c:v>-2.7632999384403512</c:v>
                </c:pt>
                <c:pt idx="5972">
                  <c:v>-2.9055999851226506</c:v>
                </c:pt>
                <c:pt idx="5973">
                  <c:v>-5.0716500425338786</c:v>
                </c:pt>
                <c:pt idx="5974">
                  <c:v>-2.2912999892235018</c:v>
                </c:pt>
                <c:pt idx="5975">
                  <c:v>-6.5199500274658675</c:v>
                </c:pt>
                <c:pt idx="5976">
                  <c:v>-4.4030000424384994</c:v>
                </c:pt>
                <c:pt idx="5977">
                  <c:v>-4.6117500305175518</c:v>
                </c:pt>
                <c:pt idx="5978">
                  <c:v>-4.5886498737335231</c:v>
                </c:pt>
                <c:pt idx="5979">
                  <c:v>-7.8739999723434515</c:v>
                </c:pt>
                <c:pt idx="5980">
                  <c:v>-3.1156999671459005</c:v>
                </c:pt>
                <c:pt idx="5981">
                  <c:v>-4.9720999467373002</c:v>
                </c:pt>
                <c:pt idx="5982">
                  <c:v>-1.9112500035762992</c:v>
                </c:pt>
                <c:pt idx="5983">
                  <c:v>-4.2427499437332532</c:v>
                </c:pt>
                <c:pt idx="5984">
                  <c:v>-4.5637000513076522</c:v>
                </c:pt>
                <c:pt idx="5985">
                  <c:v>-6.7397499942779788</c:v>
                </c:pt>
                <c:pt idx="5986">
                  <c:v>-3.0545999956131045</c:v>
                </c:pt>
                <c:pt idx="5987">
                  <c:v>-4.0992500591277974</c:v>
                </c:pt>
                <c:pt idx="5988">
                  <c:v>-2.1126999449730004</c:v>
                </c:pt>
                <c:pt idx="5989">
                  <c:v>-1.3011500525474506</c:v>
                </c:pt>
                <c:pt idx="5990">
                  <c:v>-5.5071499681472886</c:v>
                </c:pt>
                <c:pt idx="5991">
                  <c:v>-4.6652999699115512</c:v>
                </c:pt>
                <c:pt idx="5992">
                  <c:v>-2.2265000247955609</c:v>
                </c:pt>
                <c:pt idx="5993">
                  <c:v>-14.405849903821951</c:v>
                </c:pt>
                <c:pt idx="5994">
                  <c:v>2.3987499916553503</c:v>
                </c:pt>
                <c:pt idx="5995">
                  <c:v>0.2160500037670135</c:v>
                </c:pt>
                <c:pt idx="5996">
                  <c:v>0.172150005102157</c:v>
                </c:pt>
                <c:pt idx="5997">
                  <c:v>2.2350004911423013E-2</c:v>
                </c:pt>
                <c:pt idx="5998">
                  <c:v>0</c:v>
                </c:pt>
                <c:pt idx="5999">
                  <c:v>0</c:v>
                </c:pt>
                <c:pt idx="6000">
                  <c:v>0</c:v>
                </c:pt>
                <c:pt idx="6001">
                  <c:v>0</c:v>
                </c:pt>
                <c:pt idx="6002">
                  <c:v>0</c:v>
                </c:pt>
                <c:pt idx="6003">
                  <c:v>0</c:v>
                </c:pt>
                <c:pt idx="6004">
                  <c:v>0</c:v>
                </c:pt>
                <c:pt idx="6005">
                  <c:v>0</c:v>
                </c:pt>
                <c:pt idx="6006">
                  <c:v>0</c:v>
                </c:pt>
                <c:pt idx="6007">
                  <c:v>0</c:v>
                </c:pt>
                <c:pt idx="6008">
                  <c:v>0</c:v>
                </c:pt>
                <c:pt idx="6009">
                  <c:v>0</c:v>
                </c:pt>
                <c:pt idx="6010">
                  <c:v>0</c:v>
                </c:pt>
                <c:pt idx="6011">
                  <c:v>0</c:v>
                </c:pt>
                <c:pt idx="6012">
                  <c:v>0</c:v>
                </c:pt>
                <c:pt idx="6013">
                  <c:v>0</c:v>
                </c:pt>
                <c:pt idx="6014">
                  <c:v>0</c:v>
                </c:pt>
                <c:pt idx="6015">
                  <c:v>0</c:v>
                </c:pt>
                <c:pt idx="6016">
                  <c:v>0</c:v>
                </c:pt>
                <c:pt idx="6017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FA60-4C4B-B04A-55492684C8D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33327184"/>
        <c:axId val="333325224"/>
      </c:scatterChart>
      <c:valAx>
        <c:axId val="333327184"/>
        <c:scaling>
          <c:orientation val="minMax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ko-KR" sz="1000" b="1">
                    <a:solidFill>
                      <a:sysClr val="windowText" lastClr="000000"/>
                    </a:solidFill>
                  </a:rPr>
                  <a:t>Normalized</a:t>
                </a:r>
                <a:r>
                  <a:rPr lang="en-US" altLang="ko-KR" sz="1000" b="1" baseline="0">
                    <a:solidFill>
                      <a:sysClr val="windowText" lastClr="000000"/>
                    </a:solidFill>
                  </a:rPr>
                  <a:t> Set1 RPM in WT</a:t>
                </a:r>
                <a:endParaRPr lang="ko-KR" altLang="en-US" sz="1000" b="1">
                  <a:solidFill>
                    <a:sysClr val="windowText" lastClr="000000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ko-K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333325224"/>
        <c:crosses val="autoZero"/>
        <c:crossBetween val="midCat"/>
        <c:majorUnit val="50"/>
      </c:valAx>
      <c:valAx>
        <c:axId val="333325224"/>
        <c:scaling>
          <c:orientation val="minMax"/>
          <c:max val="50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ko-KR" sz="1000" b="1" i="0" baseline="0">
                    <a:solidFill>
                      <a:sysClr val="windowText" lastClr="000000"/>
                    </a:solidFill>
                    <a:effectLst/>
                  </a:rPr>
                  <a:t>Normalized Set1 RPM in </a:t>
                </a:r>
                <a:r>
                  <a:rPr lang="en-US" altLang="ko-KR" sz="1000" b="1" i="1" baseline="0">
                    <a:solidFill>
                      <a:sysClr val="windowText" lastClr="000000"/>
                    </a:solidFill>
                    <a:effectLst/>
                  </a:rPr>
                  <a:t>Δrad6</a:t>
                </a:r>
                <a:endParaRPr lang="ko-KR" altLang="ko-KR" sz="1000" i="1">
                  <a:solidFill>
                    <a:sysClr val="windowText" lastClr="000000"/>
                  </a:solidFill>
                  <a:effectLst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ko-K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33332718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4500" cy="5016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 dirty="0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902075" y="0"/>
            <a:ext cx="2984500" cy="5016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830FA25-952F-41F4-8483-CC30F225667A}" type="datetimeFigureOut">
              <a:rPr lang="ko-KR" altLang="en-US" smtClean="0"/>
              <a:t>2024-04-21</a:t>
            </a:fld>
            <a:endParaRPr lang="ko-KR" altLang="en-US" dirty="0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73300" y="1252538"/>
            <a:ext cx="2341563" cy="33829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 dirty="0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8975" y="4822825"/>
            <a:ext cx="5510213" cy="39465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520238"/>
            <a:ext cx="2984500" cy="5016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 dirty="0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902075" y="9520238"/>
            <a:ext cx="2984500" cy="5016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BC3EC22-E9C4-4EAC-92D6-F6AE04979719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5617581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BC3EC22-E9C4-4EAC-92D6-F6AE04979719}" type="slidenum">
              <a:rPr lang="ko-KR" altLang="en-US" smtClean="0"/>
              <a:t>2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42514116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7EDE-CE25-47B4-9188-D4D693980B46}" type="datetimeFigureOut">
              <a:rPr lang="ko-KR" altLang="en-US" smtClean="0"/>
              <a:t>2024-04-21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DFA597-E2DB-45E5-9D37-E85308C89BB4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9315210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7EDE-CE25-47B4-9188-D4D693980B46}" type="datetimeFigureOut">
              <a:rPr lang="ko-KR" altLang="en-US" smtClean="0"/>
              <a:t>2024-04-21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DFA597-E2DB-45E5-9D37-E85308C89BB4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6700504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7EDE-CE25-47B4-9188-D4D693980B46}" type="datetimeFigureOut">
              <a:rPr lang="ko-KR" altLang="en-US" smtClean="0"/>
              <a:t>2024-04-21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DFA597-E2DB-45E5-9D37-E85308C89BB4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5621919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7EDE-CE25-47B4-9188-D4D693980B46}" type="datetimeFigureOut">
              <a:rPr lang="ko-KR" altLang="en-US" smtClean="0"/>
              <a:t>2024-04-21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DFA597-E2DB-45E5-9D37-E85308C89BB4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4252573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7EDE-CE25-47B4-9188-D4D693980B46}" type="datetimeFigureOut">
              <a:rPr lang="ko-KR" altLang="en-US" smtClean="0"/>
              <a:t>2024-04-21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DFA597-E2DB-45E5-9D37-E85308C89BB4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36286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7EDE-CE25-47B4-9188-D4D693980B46}" type="datetimeFigureOut">
              <a:rPr lang="ko-KR" altLang="en-US" smtClean="0"/>
              <a:t>2024-04-21</a:t>
            </a:fld>
            <a:endParaRPr lang="ko-KR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DFA597-E2DB-45E5-9D37-E85308C89BB4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2746597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7EDE-CE25-47B4-9188-D4D693980B46}" type="datetimeFigureOut">
              <a:rPr lang="ko-KR" altLang="en-US" smtClean="0"/>
              <a:t>2024-04-21</a:t>
            </a:fld>
            <a:endParaRPr lang="ko-KR" alt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DFA597-E2DB-45E5-9D37-E85308C89BB4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7757964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7EDE-CE25-47B4-9188-D4D693980B46}" type="datetimeFigureOut">
              <a:rPr lang="ko-KR" altLang="en-US" smtClean="0"/>
              <a:t>2024-04-21</a:t>
            </a:fld>
            <a:endParaRPr lang="ko-KR" alt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DFA597-E2DB-45E5-9D37-E85308C89BB4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092103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7EDE-CE25-47B4-9188-D4D693980B46}" type="datetimeFigureOut">
              <a:rPr lang="ko-KR" altLang="en-US" smtClean="0"/>
              <a:t>2024-04-21</a:t>
            </a:fld>
            <a:endParaRPr lang="ko-KR" alt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DFA597-E2DB-45E5-9D37-E85308C89BB4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8694175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7EDE-CE25-47B4-9188-D4D693980B46}" type="datetimeFigureOut">
              <a:rPr lang="ko-KR" altLang="en-US" smtClean="0"/>
              <a:t>2024-04-21</a:t>
            </a:fld>
            <a:endParaRPr lang="ko-KR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DFA597-E2DB-45E5-9D37-E85308C89BB4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7970903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7EDE-CE25-47B4-9188-D4D693980B46}" type="datetimeFigureOut">
              <a:rPr lang="ko-KR" altLang="en-US" smtClean="0"/>
              <a:t>2024-04-21</a:t>
            </a:fld>
            <a:endParaRPr lang="ko-KR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DFA597-E2DB-45E5-9D37-E85308C89BB4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2325845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537EDE-CE25-47B4-9188-D4D693980B46}" type="datetimeFigureOut">
              <a:rPr lang="ko-KR" altLang="en-US" smtClean="0"/>
              <a:t>2024-04-21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DFA597-E2DB-45E5-9D37-E85308C89BB4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5848777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tmp"/><Relationship Id="rId3" Type="http://schemas.openxmlformats.org/officeDocument/2006/relationships/chart" Target="../charts/chart1.xml"/><Relationship Id="rId7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png"/><Relationship Id="rId11" Type="http://schemas.openxmlformats.org/officeDocument/2006/relationships/image" Target="../media/image14.png"/><Relationship Id="rId5" Type="http://schemas.openxmlformats.org/officeDocument/2006/relationships/image" Target="../media/image5.png"/><Relationship Id="rId10" Type="http://schemas.openxmlformats.org/officeDocument/2006/relationships/image" Target="../media/image13.tmp"/><Relationship Id="rId4" Type="http://schemas.openxmlformats.org/officeDocument/2006/relationships/image" Target="../media/image8.png"/><Relationship Id="rId9" Type="http://schemas.openxmlformats.org/officeDocument/2006/relationships/image" Target="../media/image12.tmp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TextBox 39"/>
          <p:cNvSpPr txBox="1"/>
          <p:nvPr/>
        </p:nvSpPr>
        <p:spPr bwMode="auto">
          <a:xfrm>
            <a:off x="-3402" y="-18808"/>
            <a:ext cx="378498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altLang="ko-KR" b="1" dirty="0">
                <a:latin typeface="+mj-lt"/>
                <a:cs typeface="Arial" panose="020B0604020202020204" pitchFamily="34" charset="0"/>
              </a:rPr>
              <a:t>Additional file Figure S1</a:t>
            </a:r>
            <a:endParaRPr lang="ko-KR" altLang="en-US" b="1" dirty="0">
              <a:latin typeface="+mj-lt"/>
              <a:cs typeface="Arial" panose="020B0604020202020204" pitchFamily="34" charset="0"/>
            </a:endParaRPr>
          </a:p>
        </p:txBody>
      </p:sp>
      <p:grpSp>
        <p:nvGrpSpPr>
          <p:cNvPr id="10" name="그룹 9"/>
          <p:cNvGrpSpPr/>
          <p:nvPr/>
        </p:nvGrpSpPr>
        <p:grpSpPr>
          <a:xfrm>
            <a:off x="308778" y="5671361"/>
            <a:ext cx="3026609" cy="1526723"/>
            <a:chOff x="308778" y="5671361"/>
            <a:chExt cx="3026609" cy="1526723"/>
          </a:xfrm>
        </p:grpSpPr>
        <p:pic>
          <p:nvPicPr>
            <p:cNvPr id="315" name="그림 314"/>
            <p:cNvPicPr>
              <a:picLocks/>
            </p:cNvPicPr>
            <p:nvPr/>
          </p:nvPicPr>
          <p:blipFill rotWithShape="1">
            <a:blip r:embed="rId2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rcRect l="3985" b="57451"/>
            <a:stretch/>
          </p:blipFill>
          <p:spPr>
            <a:xfrm>
              <a:off x="733492" y="5842299"/>
              <a:ext cx="2160000" cy="1080000"/>
            </a:xfrm>
            <a:prstGeom prst="rect">
              <a:avLst/>
            </a:prstGeom>
          </p:spPr>
        </p:pic>
        <p:sp>
          <p:nvSpPr>
            <p:cNvPr id="378" name="TextBox 214"/>
            <p:cNvSpPr txBox="1"/>
            <p:nvPr/>
          </p:nvSpPr>
          <p:spPr>
            <a:xfrm>
              <a:off x="1505932" y="5671361"/>
              <a:ext cx="106887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/>
                <a:t>H2B (rep2)</a:t>
              </a:r>
              <a:endParaRPr lang="ko-KR" altLang="en-US" sz="1100" b="1" dirty="0"/>
            </a:p>
          </p:txBody>
        </p:sp>
        <p:grpSp>
          <p:nvGrpSpPr>
            <p:cNvPr id="379" name="그룹 378"/>
            <p:cNvGrpSpPr/>
            <p:nvPr/>
          </p:nvGrpSpPr>
          <p:grpSpPr>
            <a:xfrm>
              <a:off x="308778" y="5743898"/>
              <a:ext cx="2838718" cy="1454186"/>
              <a:chOff x="215713" y="4356676"/>
              <a:chExt cx="3310404" cy="2066533"/>
            </a:xfrm>
          </p:grpSpPr>
          <p:cxnSp>
            <p:nvCxnSpPr>
              <p:cNvPr id="380" name="직선 연결선 379"/>
              <p:cNvCxnSpPr/>
              <p:nvPr/>
            </p:nvCxnSpPr>
            <p:spPr>
              <a:xfrm flipH="1">
                <a:off x="1950370" y="6119931"/>
                <a:ext cx="0" cy="76694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81" name="오른쪽 대괄호 380"/>
              <p:cNvSpPr/>
              <p:nvPr/>
            </p:nvSpPr>
            <p:spPr>
              <a:xfrm>
                <a:off x="550351" y="4482446"/>
                <a:ext cx="98755" cy="1636136"/>
              </a:xfrm>
              <a:prstGeom prst="rightBracket">
                <a:avLst>
                  <a:gd name="adj" fmla="val 0"/>
                </a:avLst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ko-KR" altLang="en-US" sz="1600"/>
              </a:p>
            </p:txBody>
          </p:sp>
          <p:cxnSp>
            <p:nvCxnSpPr>
              <p:cNvPr id="382" name="직선 연결선 381"/>
              <p:cNvCxnSpPr/>
              <p:nvPr/>
            </p:nvCxnSpPr>
            <p:spPr>
              <a:xfrm flipV="1">
                <a:off x="683644" y="6117477"/>
                <a:ext cx="2633467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83" name="TextBox 214"/>
              <p:cNvSpPr txBox="1"/>
              <p:nvPr/>
            </p:nvSpPr>
            <p:spPr>
              <a:xfrm>
                <a:off x="598284" y="6122454"/>
                <a:ext cx="577531" cy="2624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600" dirty="0"/>
                  <a:t>-3000bp</a:t>
                </a:r>
                <a:endParaRPr lang="ko-KR" altLang="en-US" sz="600" dirty="0"/>
              </a:p>
            </p:txBody>
          </p:sp>
          <p:sp>
            <p:nvSpPr>
              <p:cNvPr id="384" name="TextBox 214"/>
              <p:cNvSpPr txBox="1"/>
              <p:nvPr/>
            </p:nvSpPr>
            <p:spPr>
              <a:xfrm>
                <a:off x="2950473" y="6122457"/>
                <a:ext cx="575644" cy="2624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600" dirty="0"/>
                  <a:t>3000bp</a:t>
                </a:r>
                <a:endParaRPr lang="ko-KR" altLang="en-US" sz="600" dirty="0"/>
              </a:p>
            </p:txBody>
          </p:sp>
          <p:sp>
            <p:nvSpPr>
              <p:cNvPr id="385" name="TextBox 214"/>
              <p:cNvSpPr txBox="1"/>
              <p:nvPr/>
            </p:nvSpPr>
            <p:spPr>
              <a:xfrm>
                <a:off x="1776702" y="6160781"/>
                <a:ext cx="451883" cy="2624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600" dirty="0"/>
                  <a:t>TSS</a:t>
                </a:r>
                <a:endParaRPr lang="ko-KR" altLang="en-US" sz="600" dirty="0"/>
              </a:p>
            </p:txBody>
          </p:sp>
          <p:sp>
            <p:nvSpPr>
              <p:cNvPr id="386" name="TextBox 214"/>
              <p:cNvSpPr txBox="1"/>
              <p:nvPr/>
            </p:nvSpPr>
            <p:spPr>
              <a:xfrm>
                <a:off x="256173" y="5989341"/>
                <a:ext cx="349723" cy="26242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lang="en-US" altLang="ko-KR" sz="600" dirty="0"/>
                  <a:t>0</a:t>
                </a:r>
                <a:endParaRPr lang="ko-KR" altLang="en-US" sz="600" dirty="0"/>
              </a:p>
            </p:txBody>
          </p:sp>
          <p:sp>
            <p:nvSpPr>
              <p:cNvPr id="387" name="TextBox 214"/>
              <p:cNvSpPr txBox="1"/>
              <p:nvPr/>
            </p:nvSpPr>
            <p:spPr>
              <a:xfrm>
                <a:off x="215713" y="4356676"/>
                <a:ext cx="387378" cy="26242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lang="en-US" altLang="ko-KR" sz="600" dirty="0"/>
                  <a:t>200</a:t>
                </a:r>
                <a:endParaRPr lang="ko-KR" altLang="en-US" sz="600" dirty="0"/>
              </a:p>
            </p:txBody>
          </p:sp>
        </p:grpSp>
        <p:sp>
          <p:nvSpPr>
            <p:cNvPr id="388" name="TextBox 214"/>
            <p:cNvSpPr txBox="1"/>
            <p:nvPr/>
          </p:nvSpPr>
          <p:spPr>
            <a:xfrm rot="16200000">
              <a:off x="199549" y="6297192"/>
              <a:ext cx="80440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ko-KR" sz="600" dirty="0"/>
                <a:t>RPM</a:t>
              </a:r>
              <a:endParaRPr lang="ko-KR" altLang="en-US" sz="600" dirty="0"/>
            </a:p>
          </p:txBody>
        </p:sp>
        <p:sp>
          <p:nvSpPr>
            <p:cNvPr id="424" name="TextBox 214"/>
            <p:cNvSpPr txBox="1"/>
            <p:nvPr/>
          </p:nvSpPr>
          <p:spPr>
            <a:xfrm>
              <a:off x="2989917" y="5926561"/>
              <a:ext cx="19936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600" dirty="0"/>
                <a:t>M</a:t>
              </a:r>
              <a:endParaRPr lang="ko-KR" altLang="en-US" sz="600" dirty="0"/>
            </a:p>
          </p:txBody>
        </p:sp>
        <p:sp>
          <p:nvSpPr>
            <p:cNvPr id="425" name="직사각형 424"/>
            <p:cNvSpPr/>
            <p:nvPr/>
          </p:nvSpPr>
          <p:spPr>
            <a:xfrm>
              <a:off x="2931149" y="5985223"/>
              <a:ext cx="86360" cy="71077"/>
            </a:xfrm>
            <a:prstGeom prst="rect">
              <a:avLst/>
            </a:prstGeom>
            <a:solidFill>
              <a:srgbClr val="8D74B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600"/>
            </a:p>
          </p:txBody>
        </p:sp>
        <p:sp>
          <p:nvSpPr>
            <p:cNvPr id="426" name="직사각형 425"/>
            <p:cNvSpPr/>
            <p:nvPr/>
          </p:nvSpPr>
          <p:spPr>
            <a:xfrm>
              <a:off x="2931149" y="6078533"/>
              <a:ext cx="86360" cy="71077"/>
            </a:xfrm>
            <a:prstGeom prst="rect">
              <a:avLst/>
            </a:prstGeom>
            <a:solidFill>
              <a:srgbClr val="8C2A9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600"/>
            </a:p>
          </p:txBody>
        </p:sp>
        <p:sp>
          <p:nvSpPr>
            <p:cNvPr id="427" name="직사각형 426"/>
            <p:cNvSpPr/>
            <p:nvPr/>
          </p:nvSpPr>
          <p:spPr>
            <a:xfrm>
              <a:off x="2931149" y="6171842"/>
              <a:ext cx="86360" cy="71077"/>
            </a:xfrm>
            <a:prstGeom prst="rect">
              <a:avLst/>
            </a:prstGeom>
            <a:solidFill>
              <a:srgbClr val="4B014C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600"/>
            </a:p>
          </p:txBody>
        </p:sp>
        <p:sp>
          <p:nvSpPr>
            <p:cNvPr id="428" name="TextBox 214"/>
            <p:cNvSpPr txBox="1"/>
            <p:nvPr/>
          </p:nvSpPr>
          <p:spPr>
            <a:xfrm>
              <a:off x="2989916" y="6025892"/>
              <a:ext cx="22029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600" dirty="0"/>
                <a:t>L</a:t>
              </a:r>
              <a:endParaRPr lang="ko-KR" altLang="en-US" sz="600" dirty="0"/>
            </a:p>
          </p:txBody>
        </p:sp>
        <p:sp>
          <p:nvSpPr>
            <p:cNvPr id="429" name="TextBox 214"/>
            <p:cNvSpPr txBox="1"/>
            <p:nvPr/>
          </p:nvSpPr>
          <p:spPr>
            <a:xfrm>
              <a:off x="2989916" y="6129984"/>
              <a:ext cx="34547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600" dirty="0"/>
                <a:t>XL</a:t>
              </a:r>
              <a:endParaRPr lang="ko-KR" altLang="en-US" sz="600" dirty="0"/>
            </a:p>
          </p:txBody>
        </p:sp>
        <p:sp>
          <p:nvSpPr>
            <p:cNvPr id="430" name="직사각형 429"/>
            <p:cNvSpPr/>
            <p:nvPr/>
          </p:nvSpPr>
          <p:spPr>
            <a:xfrm>
              <a:off x="2931149" y="5801530"/>
              <a:ext cx="86360" cy="71077"/>
            </a:xfrm>
            <a:prstGeom prst="rect">
              <a:avLst/>
            </a:prstGeom>
            <a:solidFill>
              <a:srgbClr val="CCDEEC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600"/>
            </a:p>
          </p:txBody>
        </p:sp>
        <p:sp>
          <p:nvSpPr>
            <p:cNvPr id="431" name="직사각형 430"/>
            <p:cNvSpPr/>
            <p:nvPr/>
          </p:nvSpPr>
          <p:spPr>
            <a:xfrm>
              <a:off x="2931149" y="5894839"/>
              <a:ext cx="86360" cy="71077"/>
            </a:xfrm>
            <a:prstGeom prst="rect">
              <a:avLst/>
            </a:prstGeom>
            <a:solidFill>
              <a:srgbClr val="9AB4D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600"/>
            </a:p>
          </p:txBody>
        </p:sp>
        <p:sp>
          <p:nvSpPr>
            <p:cNvPr id="432" name="TextBox 214"/>
            <p:cNvSpPr txBox="1"/>
            <p:nvPr/>
          </p:nvSpPr>
          <p:spPr>
            <a:xfrm>
              <a:off x="2989916" y="5748874"/>
              <a:ext cx="33245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600" dirty="0"/>
                <a:t>XS</a:t>
              </a:r>
              <a:endParaRPr lang="ko-KR" altLang="en-US" sz="600" dirty="0"/>
            </a:p>
          </p:txBody>
        </p:sp>
        <p:sp>
          <p:nvSpPr>
            <p:cNvPr id="433" name="TextBox 214"/>
            <p:cNvSpPr txBox="1"/>
            <p:nvPr/>
          </p:nvSpPr>
          <p:spPr>
            <a:xfrm>
              <a:off x="2994647" y="5842723"/>
              <a:ext cx="19936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600" dirty="0"/>
                <a:t>S</a:t>
              </a:r>
              <a:endParaRPr lang="ko-KR" altLang="en-US" sz="600" dirty="0"/>
            </a:p>
          </p:txBody>
        </p:sp>
      </p:grpSp>
      <p:grpSp>
        <p:nvGrpSpPr>
          <p:cNvPr id="6" name="그룹 5"/>
          <p:cNvGrpSpPr/>
          <p:nvPr/>
        </p:nvGrpSpPr>
        <p:grpSpPr>
          <a:xfrm>
            <a:off x="308778" y="3872865"/>
            <a:ext cx="3026609" cy="1524172"/>
            <a:chOff x="308778" y="3872865"/>
            <a:chExt cx="3026609" cy="1524172"/>
          </a:xfrm>
        </p:grpSpPr>
        <p:pic>
          <p:nvPicPr>
            <p:cNvPr id="314" name="그림 313"/>
            <p:cNvPicPr>
              <a:picLocks/>
            </p:cNvPicPr>
            <p:nvPr/>
          </p:nvPicPr>
          <p:blipFill rotWithShape="1">
            <a:blip r:embed="rId3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rcRect l="3804" b="57634"/>
            <a:stretch/>
          </p:blipFill>
          <p:spPr>
            <a:xfrm>
              <a:off x="727349" y="4028054"/>
              <a:ext cx="2160000" cy="1080000"/>
            </a:xfrm>
            <a:prstGeom prst="rect">
              <a:avLst/>
            </a:prstGeom>
          </p:spPr>
        </p:pic>
        <p:cxnSp>
          <p:nvCxnSpPr>
            <p:cNvPr id="337" name="직선 연결선 336"/>
            <p:cNvCxnSpPr/>
            <p:nvPr/>
          </p:nvCxnSpPr>
          <p:spPr>
            <a:xfrm flipH="1">
              <a:off x="1804728" y="5183626"/>
              <a:ext cx="0" cy="53968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38" name="오른쪽 대괄호 337"/>
            <p:cNvSpPr/>
            <p:nvPr/>
          </p:nvSpPr>
          <p:spPr>
            <a:xfrm>
              <a:off x="604192" y="4031354"/>
              <a:ext cx="84684" cy="1151322"/>
            </a:xfrm>
            <a:prstGeom prst="rightBracket">
              <a:avLst>
                <a:gd name="adj" fmla="val 0"/>
              </a:avLst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ko-KR" altLang="en-US" sz="1600"/>
            </a:p>
          </p:txBody>
        </p:sp>
        <p:cxnSp>
          <p:nvCxnSpPr>
            <p:cNvPr id="339" name="직선 연결선 338"/>
            <p:cNvCxnSpPr/>
            <p:nvPr/>
          </p:nvCxnSpPr>
          <p:spPr>
            <a:xfrm flipV="1">
              <a:off x="718492" y="5181899"/>
              <a:ext cx="225823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40" name="TextBox 214"/>
            <p:cNvSpPr txBox="1"/>
            <p:nvPr/>
          </p:nvSpPr>
          <p:spPr>
            <a:xfrm>
              <a:off x="645295" y="5185401"/>
              <a:ext cx="49524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600" dirty="0"/>
                <a:t>-3000bp</a:t>
              </a:r>
              <a:endParaRPr lang="ko-KR" altLang="en-US" sz="600" dirty="0"/>
            </a:p>
          </p:txBody>
        </p:sp>
        <p:sp>
          <p:nvSpPr>
            <p:cNvPr id="341" name="TextBox 214"/>
            <p:cNvSpPr txBox="1"/>
            <p:nvPr/>
          </p:nvSpPr>
          <p:spPr>
            <a:xfrm>
              <a:off x="2662330" y="5185403"/>
              <a:ext cx="49312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600" dirty="0"/>
                <a:t>3000bp</a:t>
              </a:r>
              <a:endParaRPr lang="ko-KR" altLang="en-US" sz="600" dirty="0"/>
            </a:p>
          </p:txBody>
        </p:sp>
        <p:sp>
          <p:nvSpPr>
            <p:cNvPr id="342" name="TextBox 214"/>
            <p:cNvSpPr txBox="1"/>
            <p:nvPr/>
          </p:nvSpPr>
          <p:spPr>
            <a:xfrm>
              <a:off x="1655805" y="5212371"/>
              <a:ext cx="38379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600" dirty="0"/>
                <a:t>TSS</a:t>
              </a:r>
              <a:endParaRPr lang="ko-KR" altLang="en-US" sz="600" dirty="0"/>
            </a:p>
          </p:txBody>
        </p:sp>
        <p:sp>
          <p:nvSpPr>
            <p:cNvPr id="343" name="TextBox 214"/>
            <p:cNvSpPr txBox="1"/>
            <p:nvPr/>
          </p:nvSpPr>
          <p:spPr>
            <a:xfrm>
              <a:off x="351930" y="5091732"/>
              <a:ext cx="29989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ko-KR" sz="600" dirty="0"/>
                <a:t>0</a:t>
              </a:r>
              <a:endParaRPr lang="ko-KR" altLang="en-US" sz="600" dirty="0"/>
            </a:p>
          </p:txBody>
        </p:sp>
        <p:sp>
          <p:nvSpPr>
            <p:cNvPr id="344" name="TextBox 214"/>
            <p:cNvSpPr txBox="1"/>
            <p:nvPr/>
          </p:nvSpPr>
          <p:spPr>
            <a:xfrm>
              <a:off x="308778" y="3942852"/>
              <a:ext cx="34063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ko-KR" sz="600" dirty="0"/>
                <a:t>200</a:t>
              </a:r>
              <a:endParaRPr lang="ko-KR" altLang="en-US" sz="600" dirty="0"/>
            </a:p>
          </p:txBody>
        </p:sp>
        <p:sp>
          <p:nvSpPr>
            <p:cNvPr id="345" name="TextBox 214"/>
            <p:cNvSpPr txBox="1"/>
            <p:nvPr/>
          </p:nvSpPr>
          <p:spPr>
            <a:xfrm>
              <a:off x="1518403" y="3872865"/>
              <a:ext cx="89228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/>
                <a:t>H2B (rep1)</a:t>
              </a:r>
              <a:endParaRPr lang="ko-KR" altLang="en-US" sz="1100" b="1" dirty="0"/>
            </a:p>
          </p:txBody>
        </p:sp>
        <p:sp>
          <p:nvSpPr>
            <p:cNvPr id="357" name="TextBox 214"/>
            <p:cNvSpPr txBox="1"/>
            <p:nvPr/>
          </p:nvSpPr>
          <p:spPr>
            <a:xfrm rot="16200000">
              <a:off x="201990" y="4505636"/>
              <a:ext cx="80440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ko-KR" sz="600" dirty="0"/>
                <a:t>RPM</a:t>
              </a:r>
              <a:endParaRPr lang="ko-KR" altLang="en-US" sz="600" dirty="0"/>
            </a:p>
          </p:txBody>
        </p:sp>
        <p:sp>
          <p:nvSpPr>
            <p:cNvPr id="435" name="TextBox 214"/>
            <p:cNvSpPr txBox="1"/>
            <p:nvPr/>
          </p:nvSpPr>
          <p:spPr>
            <a:xfrm>
              <a:off x="2989917" y="4162460"/>
              <a:ext cx="19936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600" dirty="0"/>
                <a:t>M</a:t>
              </a:r>
              <a:endParaRPr lang="ko-KR" altLang="en-US" sz="600" dirty="0"/>
            </a:p>
          </p:txBody>
        </p:sp>
        <p:sp>
          <p:nvSpPr>
            <p:cNvPr id="436" name="직사각형 435"/>
            <p:cNvSpPr/>
            <p:nvPr/>
          </p:nvSpPr>
          <p:spPr>
            <a:xfrm>
              <a:off x="2931149" y="4221122"/>
              <a:ext cx="86360" cy="71077"/>
            </a:xfrm>
            <a:prstGeom prst="rect">
              <a:avLst/>
            </a:prstGeom>
            <a:solidFill>
              <a:srgbClr val="8D74B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600"/>
            </a:p>
          </p:txBody>
        </p:sp>
        <p:sp>
          <p:nvSpPr>
            <p:cNvPr id="437" name="직사각형 436"/>
            <p:cNvSpPr/>
            <p:nvPr/>
          </p:nvSpPr>
          <p:spPr>
            <a:xfrm>
              <a:off x="2931149" y="4314432"/>
              <a:ext cx="86360" cy="71077"/>
            </a:xfrm>
            <a:prstGeom prst="rect">
              <a:avLst/>
            </a:prstGeom>
            <a:solidFill>
              <a:srgbClr val="8C2A9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600"/>
            </a:p>
          </p:txBody>
        </p:sp>
        <p:sp>
          <p:nvSpPr>
            <p:cNvPr id="438" name="직사각형 437"/>
            <p:cNvSpPr/>
            <p:nvPr/>
          </p:nvSpPr>
          <p:spPr>
            <a:xfrm>
              <a:off x="2931149" y="4407741"/>
              <a:ext cx="86360" cy="71077"/>
            </a:xfrm>
            <a:prstGeom prst="rect">
              <a:avLst/>
            </a:prstGeom>
            <a:solidFill>
              <a:srgbClr val="4B014C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600"/>
            </a:p>
          </p:txBody>
        </p:sp>
        <p:sp>
          <p:nvSpPr>
            <p:cNvPr id="439" name="TextBox 214"/>
            <p:cNvSpPr txBox="1"/>
            <p:nvPr/>
          </p:nvSpPr>
          <p:spPr>
            <a:xfrm>
              <a:off x="2989916" y="4261791"/>
              <a:ext cx="22029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600" dirty="0"/>
                <a:t>L</a:t>
              </a:r>
              <a:endParaRPr lang="ko-KR" altLang="en-US" sz="600" dirty="0"/>
            </a:p>
          </p:txBody>
        </p:sp>
        <p:sp>
          <p:nvSpPr>
            <p:cNvPr id="440" name="TextBox 214"/>
            <p:cNvSpPr txBox="1"/>
            <p:nvPr/>
          </p:nvSpPr>
          <p:spPr>
            <a:xfrm>
              <a:off x="2989916" y="4365883"/>
              <a:ext cx="34547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600" dirty="0"/>
                <a:t>XL</a:t>
              </a:r>
              <a:endParaRPr lang="ko-KR" altLang="en-US" sz="600" dirty="0"/>
            </a:p>
          </p:txBody>
        </p:sp>
        <p:sp>
          <p:nvSpPr>
            <p:cNvPr id="441" name="직사각형 440"/>
            <p:cNvSpPr/>
            <p:nvPr/>
          </p:nvSpPr>
          <p:spPr>
            <a:xfrm>
              <a:off x="2931149" y="4037429"/>
              <a:ext cx="86360" cy="71077"/>
            </a:xfrm>
            <a:prstGeom prst="rect">
              <a:avLst/>
            </a:prstGeom>
            <a:solidFill>
              <a:srgbClr val="CCDEEC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600"/>
            </a:p>
          </p:txBody>
        </p:sp>
        <p:sp>
          <p:nvSpPr>
            <p:cNvPr id="442" name="직사각형 441"/>
            <p:cNvSpPr/>
            <p:nvPr/>
          </p:nvSpPr>
          <p:spPr>
            <a:xfrm>
              <a:off x="2931149" y="4130738"/>
              <a:ext cx="86360" cy="71077"/>
            </a:xfrm>
            <a:prstGeom prst="rect">
              <a:avLst/>
            </a:prstGeom>
            <a:solidFill>
              <a:srgbClr val="9AB4D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600"/>
            </a:p>
          </p:txBody>
        </p:sp>
        <p:sp>
          <p:nvSpPr>
            <p:cNvPr id="443" name="TextBox 214"/>
            <p:cNvSpPr txBox="1"/>
            <p:nvPr/>
          </p:nvSpPr>
          <p:spPr>
            <a:xfrm>
              <a:off x="2989916" y="3984773"/>
              <a:ext cx="33245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600" dirty="0"/>
                <a:t>XS</a:t>
              </a:r>
              <a:endParaRPr lang="ko-KR" altLang="en-US" sz="600" dirty="0"/>
            </a:p>
          </p:txBody>
        </p:sp>
        <p:sp>
          <p:nvSpPr>
            <p:cNvPr id="444" name="TextBox 214"/>
            <p:cNvSpPr txBox="1"/>
            <p:nvPr/>
          </p:nvSpPr>
          <p:spPr>
            <a:xfrm>
              <a:off x="2994647" y="4078622"/>
              <a:ext cx="19936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600" dirty="0"/>
                <a:t>S</a:t>
              </a:r>
              <a:endParaRPr lang="ko-KR" altLang="en-US" sz="600" dirty="0"/>
            </a:p>
          </p:txBody>
        </p:sp>
      </p:grpSp>
      <p:sp>
        <p:nvSpPr>
          <p:cNvPr id="446" name="TextBox 445"/>
          <p:cNvSpPr txBox="1"/>
          <p:nvPr/>
        </p:nvSpPr>
        <p:spPr bwMode="auto">
          <a:xfrm>
            <a:off x="345408" y="3686201"/>
            <a:ext cx="306416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>
              <a:defRPr/>
            </a:pPr>
            <a:r>
              <a:rPr lang="en-US" altLang="ko-KR" sz="1600" b="1" dirty="0">
                <a:latin typeface="+mj-lt"/>
                <a:cs typeface="Arial" panose="020B0604020202020204" pitchFamily="34" charset="0"/>
              </a:rPr>
              <a:t>b</a:t>
            </a:r>
            <a:endParaRPr lang="ko-KR" altLang="en-US" sz="1600" b="1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447" name="TextBox 446"/>
          <p:cNvSpPr txBox="1"/>
          <p:nvPr/>
        </p:nvSpPr>
        <p:spPr bwMode="auto">
          <a:xfrm>
            <a:off x="345408" y="5390787"/>
            <a:ext cx="306416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>
              <a:defRPr/>
            </a:pPr>
            <a:r>
              <a:rPr lang="en-US" altLang="ko-KR" sz="1600" b="1" dirty="0">
                <a:latin typeface="+mj-lt"/>
                <a:cs typeface="Arial" panose="020B0604020202020204" pitchFamily="34" charset="0"/>
              </a:rPr>
              <a:t>c</a:t>
            </a:r>
            <a:endParaRPr lang="ko-KR" altLang="en-US" sz="1600" b="1" dirty="0">
              <a:latin typeface="+mj-lt"/>
              <a:cs typeface="Arial" panose="020B0604020202020204" pitchFamily="34" charset="0"/>
            </a:endParaRPr>
          </a:p>
        </p:txBody>
      </p:sp>
      <p:grpSp>
        <p:nvGrpSpPr>
          <p:cNvPr id="8" name="그룹 7"/>
          <p:cNvGrpSpPr/>
          <p:nvPr/>
        </p:nvGrpSpPr>
        <p:grpSpPr>
          <a:xfrm>
            <a:off x="3536342" y="3874719"/>
            <a:ext cx="3113965" cy="1516896"/>
            <a:chOff x="3536342" y="3874719"/>
            <a:chExt cx="3113965" cy="1516896"/>
          </a:xfrm>
        </p:grpSpPr>
        <p:pic>
          <p:nvPicPr>
            <p:cNvPr id="312" name="그림 311"/>
            <p:cNvPicPr>
              <a:picLocks/>
            </p:cNvPicPr>
            <p:nvPr/>
          </p:nvPicPr>
          <p:blipFill rotWithShape="1">
            <a:blip r:embed="rId4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rcRect l="2277" b="57708"/>
            <a:stretch/>
          </p:blipFill>
          <p:spPr>
            <a:xfrm>
              <a:off x="3946822" y="4029908"/>
              <a:ext cx="2160000" cy="1080000"/>
            </a:xfrm>
            <a:prstGeom prst="rect">
              <a:avLst/>
            </a:prstGeom>
          </p:spPr>
        </p:pic>
        <p:sp>
          <p:nvSpPr>
            <p:cNvPr id="316" name="TextBox 214"/>
            <p:cNvSpPr txBox="1"/>
            <p:nvPr/>
          </p:nvSpPr>
          <p:spPr>
            <a:xfrm>
              <a:off x="4744868" y="3874719"/>
              <a:ext cx="108003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/>
                <a:t>H2Bub (rep1)</a:t>
              </a:r>
              <a:endParaRPr lang="ko-KR" altLang="en-US" sz="1100" b="1" dirty="0"/>
            </a:p>
          </p:txBody>
        </p:sp>
        <p:cxnSp>
          <p:nvCxnSpPr>
            <p:cNvPr id="317" name="직선 연결선 316"/>
            <p:cNvCxnSpPr/>
            <p:nvPr/>
          </p:nvCxnSpPr>
          <p:spPr>
            <a:xfrm flipH="1">
              <a:off x="5041735" y="5178204"/>
              <a:ext cx="0" cy="53968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18" name="오른쪽 대괄호 317"/>
            <p:cNvSpPr/>
            <p:nvPr/>
          </p:nvSpPr>
          <p:spPr>
            <a:xfrm>
              <a:off x="3841199" y="4025933"/>
              <a:ext cx="84684" cy="1151322"/>
            </a:xfrm>
            <a:prstGeom prst="rightBracket">
              <a:avLst>
                <a:gd name="adj" fmla="val 0"/>
              </a:avLst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ko-KR" altLang="en-US" sz="1600"/>
            </a:p>
          </p:txBody>
        </p:sp>
        <p:cxnSp>
          <p:nvCxnSpPr>
            <p:cNvPr id="319" name="직선 연결선 318"/>
            <p:cNvCxnSpPr/>
            <p:nvPr/>
          </p:nvCxnSpPr>
          <p:spPr>
            <a:xfrm flipV="1">
              <a:off x="3955499" y="5176478"/>
              <a:ext cx="225823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20" name="TextBox 214"/>
            <p:cNvSpPr txBox="1"/>
            <p:nvPr/>
          </p:nvSpPr>
          <p:spPr>
            <a:xfrm>
              <a:off x="3882302" y="5179980"/>
              <a:ext cx="49524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600" dirty="0"/>
                <a:t>-3000bp</a:t>
              </a:r>
              <a:endParaRPr lang="ko-KR" altLang="en-US" sz="600" dirty="0"/>
            </a:p>
          </p:txBody>
        </p:sp>
        <p:sp>
          <p:nvSpPr>
            <p:cNvPr id="321" name="TextBox 214"/>
            <p:cNvSpPr txBox="1"/>
            <p:nvPr/>
          </p:nvSpPr>
          <p:spPr>
            <a:xfrm>
              <a:off x="5899337" y="5179982"/>
              <a:ext cx="52611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600" dirty="0"/>
                <a:t>3000bp</a:t>
              </a:r>
              <a:endParaRPr lang="ko-KR" altLang="en-US" sz="600" dirty="0"/>
            </a:p>
          </p:txBody>
        </p:sp>
        <p:sp>
          <p:nvSpPr>
            <p:cNvPr id="322" name="TextBox 214"/>
            <p:cNvSpPr txBox="1"/>
            <p:nvPr/>
          </p:nvSpPr>
          <p:spPr>
            <a:xfrm>
              <a:off x="4892812" y="5206949"/>
              <a:ext cx="44003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600" dirty="0"/>
                <a:t>TSS</a:t>
              </a:r>
              <a:endParaRPr lang="ko-KR" altLang="en-US" sz="600" dirty="0"/>
            </a:p>
          </p:txBody>
        </p:sp>
        <p:sp>
          <p:nvSpPr>
            <p:cNvPr id="324" name="TextBox 214"/>
            <p:cNvSpPr txBox="1"/>
            <p:nvPr/>
          </p:nvSpPr>
          <p:spPr>
            <a:xfrm>
              <a:off x="6304837" y="4164314"/>
              <a:ext cx="19936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600" dirty="0"/>
                <a:t>M</a:t>
              </a:r>
              <a:endParaRPr lang="ko-KR" altLang="en-US" sz="600" dirty="0"/>
            </a:p>
          </p:txBody>
        </p:sp>
        <p:sp>
          <p:nvSpPr>
            <p:cNvPr id="325" name="직사각형 324"/>
            <p:cNvSpPr/>
            <p:nvPr/>
          </p:nvSpPr>
          <p:spPr>
            <a:xfrm>
              <a:off x="6246069" y="4222976"/>
              <a:ext cx="86360" cy="71077"/>
            </a:xfrm>
            <a:prstGeom prst="rect">
              <a:avLst/>
            </a:prstGeom>
            <a:solidFill>
              <a:srgbClr val="8D74B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600"/>
            </a:p>
          </p:txBody>
        </p:sp>
        <p:sp>
          <p:nvSpPr>
            <p:cNvPr id="326" name="직사각형 325"/>
            <p:cNvSpPr/>
            <p:nvPr/>
          </p:nvSpPr>
          <p:spPr>
            <a:xfrm>
              <a:off x="6246069" y="4316286"/>
              <a:ext cx="86360" cy="71077"/>
            </a:xfrm>
            <a:prstGeom prst="rect">
              <a:avLst/>
            </a:prstGeom>
            <a:solidFill>
              <a:srgbClr val="8C2A9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600"/>
            </a:p>
          </p:txBody>
        </p:sp>
        <p:sp>
          <p:nvSpPr>
            <p:cNvPr id="327" name="직사각형 326"/>
            <p:cNvSpPr/>
            <p:nvPr/>
          </p:nvSpPr>
          <p:spPr>
            <a:xfrm>
              <a:off x="6246069" y="4409595"/>
              <a:ext cx="86360" cy="71077"/>
            </a:xfrm>
            <a:prstGeom prst="rect">
              <a:avLst/>
            </a:prstGeom>
            <a:solidFill>
              <a:srgbClr val="4B014C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600"/>
            </a:p>
          </p:txBody>
        </p:sp>
        <p:sp>
          <p:nvSpPr>
            <p:cNvPr id="328" name="TextBox 214"/>
            <p:cNvSpPr txBox="1"/>
            <p:nvPr/>
          </p:nvSpPr>
          <p:spPr>
            <a:xfrm>
              <a:off x="6304836" y="4263645"/>
              <a:ext cx="22029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600" dirty="0"/>
                <a:t>L</a:t>
              </a:r>
              <a:endParaRPr lang="ko-KR" altLang="en-US" sz="600" dirty="0"/>
            </a:p>
          </p:txBody>
        </p:sp>
        <p:sp>
          <p:nvSpPr>
            <p:cNvPr id="329" name="TextBox 214"/>
            <p:cNvSpPr txBox="1"/>
            <p:nvPr/>
          </p:nvSpPr>
          <p:spPr>
            <a:xfrm>
              <a:off x="6304836" y="4367737"/>
              <a:ext cx="34547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600" dirty="0"/>
                <a:t>XL</a:t>
              </a:r>
              <a:endParaRPr lang="ko-KR" altLang="en-US" sz="600" dirty="0"/>
            </a:p>
          </p:txBody>
        </p:sp>
        <p:sp>
          <p:nvSpPr>
            <p:cNvPr id="330" name="직사각형 329"/>
            <p:cNvSpPr/>
            <p:nvPr/>
          </p:nvSpPr>
          <p:spPr>
            <a:xfrm>
              <a:off x="6246069" y="4039283"/>
              <a:ext cx="86360" cy="71077"/>
            </a:xfrm>
            <a:prstGeom prst="rect">
              <a:avLst/>
            </a:prstGeom>
            <a:solidFill>
              <a:srgbClr val="CCDEEC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600"/>
            </a:p>
          </p:txBody>
        </p:sp>
        <p:sp>
          <p:nvSpPr>
            <p:cNvPr id="331" name="직사각형 330"/>
            <p:cNvSpPr/>
            <p:nvPr/>
          </p:nvSpPr>
          <p:spPr>
            <a:xfrm>
              <a:off x="6246069" y="4132592"/>
              <a:ext cx="86360" cy="71077"/>
            </a:xfrm>
            <a:prstGeom prst="rect">
              <a:avLst/>
            </a:prstGeom>
            <a:solidFill>
              <a:srgbClr val="9AB4D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600"/>
            </a:p>
          </p:txBody>
        </p:sp>
        <p:sp>
          <p:nvSpPr>
            <p:cNvPr id="332" name="TextBox 214"/>
            <p:cNvSpPr txBox="1"/>
            <p:nvPr/>
          </p:nvSpPr>
          <p:spPr>
            <a:xfrm>
              <a:off x="6304836" y="3986627"/>
              <a:ext cx="33245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600" dirty="0"/>
                <a:t>XS</a:t>
              </a:r>
              <a:endParaRPr lang="ko-KR" altLang="en-US" sz="600" dirty="0"/>
            </a:p>
          </p:txBody>
        </p:sp>
        <p:sp>
          <p:nvSpPr>
            <p:cNvPr id="333" name="TextBox 214"/>
            <p:cNvSpPr txBox="1"/>
            <p:nvPr/>
          </p:nvSpPr>
          <p:spPr>
            <a:xfrm>
              <a:off x="6309567" y="4080476"/>
              <a:ext cx="19936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600" dirty="0"/>
                <a:t>S</a:t>
              </a:r>
              <a:endParaRPr lang="ko-KR" altLang="en-US" sz="600" dirty="0"/>
            </a:p>
          </p:txBody>
        </p:sp>
        <p:sp>
          <p:nvSpPr>
            <p:cNvPr id="334" name="TextBox 214"/>
            <p:cNvSpPr txBox="1"/>
            <p:nvPr/>
          </p:nvSpPr>
          <p:spPr>
            <a:xfrm rot="16200000">
              <a:off x="3444167" y="4500677"/>
              <a:ext cx="80440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ko-KR" sz="600" dirty="0"/>
                <a:t>RPM</a:t>
              </a:r>
              <a:endParaRPr lang="ko-KR" altLang="en-US" sz="600" dirty="0"/>
            </a:p>
          </p:txBody>
        </p:sp>
        <p:sp>
          <p:nvSpPr>
            <p:cNvPr id="335" name="TextBox 214"/>
            <p:cNvSpPr txBox="1"/>
            <p:nvPr/>
          </p:nvSpPr>
          <p:spPr>
            <a:xfrm>
              <a:off x="3588937" y="5079961"/>
              <a:ext cx="29989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ko-KR" sz="600" dirty="0"/>
                <a:t>0</a:t>
              </a:r>
              <a:endParaRPr lang="ko-KR" altLang="en-US" sz="600" dirty="0"/>
            </a:p>
          </p:txBody>
        </p:sp>
        <p:sp>
          <p:nvSpPr>
            <p:cNvPr id="336" name="TextBox 214"/>
            <p:cNvSpPr txBox="1"/>
            <p:nvPr/>
          </p:nvSpPr>
          <p:spPr>
            <a:xfrm>
              <a:off x="3536342" y="3931081"/>
              <a:ext cx="35008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ko-KR" sz="600" dirty="0"/>
                <a:t>200</a:t>
              </a:r>
              <a:endParaRPr lang="ko-KR" altLang="en-US" sz="600" dirty="0"/>
            </a:p>
          </p:txBody>
        </p:sp>
      </p:grpSp>
      <p:grpSp>
        <p:nvGrpSpPr>
          <p:cNvPr id="9" name="그룹 8"/>
          <p:cNvGrpSpPr/>
          <p:nvPr/>
        </p:nvGrpSpPr>
        <p:grpSpPr>
          <a:xfrm>
            <a:off x="3586002" y="5673215"/>
            <a:ext cx="3064305" cy="1524869"/>
            <a:chOff x="3586002" y="5673215"/>
            <a:chExt cx="3064305" cy="1524869"/>
          </a:xfrm>
        </p:grpSpPr>
        <p:pic>
          <p:nvPicPr>
            <p:cNvPr id="313" name="그림 312"/>
            <p:cNvPicPr>
              <a:picLocks/>
            </p:cNvPicPr>
            <p:nvPr/>
          </p:nvPicPr>
          <p:blipFill rotWithShape="1">
            <a:blip r:embed="rId5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rcRect l="3138" b="57499"/>
            <a:stretch/>
          </p:blipFill>
          <p:spPr>
            <a:xfrm>
              <a:off x="4015087" y="5844153"/>
              <a:ext cx="2160000" cy="1080000"/>
            </a:xfrm>
            <a:prstGeom prst="rect">
              <a:avLst/>
            </a:prstGeom>
          </p:spPr>
        </p:pic>
        <p:cxnSp>
          <p:nvCxnSpPr>
            <p:cNvPr id="358" name="직선 연결선 357"/>
            <p:cNvCxnSpPr/>
            <p:nvPr/>
          </p:nvCxnSpPr>
          <p:spPr>
            <a:xfrm flipH="1">
              <a:off x="5143941" y="6997656"/>
              <a:ext cx="0" cy="53968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59" name="오른쪽 대괄호 358"/>
            <p:cNvSpPr/>
            <p:nvPr/>
          </p:nvSpPr>
          <p:spPr>
            <a:xfrm>
              <a:off x="3881998" y="5847111"/>
              <a:ext cx="84684" cy="1151322"/>
            </a:xfrm>
            <a:prstGeom prst="rightBracket">
              <a:avLst>
                <a:gd name="adj" fmla="val 0"/>
              </a:avLst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ko-KR" altLang="en-US" sz="1600"/>
            </a:p>
          </p:txBody>
        </p:sp>
        <p:cxnSp>
          <p:nvCxnSpPr>
            <p:cNvPr id="360" name="직선 연결선 359"/>
            <p:cNvCxnSpPr/>
            <p:nvPr/>
          </p:nvCxnSpPr>
          <p:spPr>
            <a:xfrm flipV="1">
              <a:off x="3996298" y="6997656"/>
              <a:ext cx="225823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61" name="TextBox 214"/>
            <p:cNvSpPr txBox="1"/>
            <p:nvPr/>
          </p:nvSpPr>
          <p:spPr>
            <a:xfrm>
              <a:off x="3923101" y="7001158"/>
              <a:ext cx="49524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600" dirty="0"/>
                <a:t>-3000bp</a:t>
              </a:r>
              <a:endParaRPr lang="ko-KR" altLang="en-US" sz="600" dirty="0"/>
            </a:p>
          </p:txBody>
        </p:sp>
        <p:sp>
          <p:nvSpPr>
            <p:cNvPr id="362" name="TextBox 214"/>
            <p:cNvSpPr txBox="1"/>
            <p:nvPr/>
          </p:nvSpPr>
          <p:spPr>
            <a:xfrm>
              <a:off x="5940136" y="7001160"/>
              <a:ext cx="48871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600" dirty="0"/>
                <a:t>3000bp</a:t>
              </a:r>
              <a:endParaRPr lang="ko-KR" altLang="en-US" sz="600" dirty="0"/>
            </a:p>
          </p:txBody>
        </p:sp>
        <p:sp>
          <p:nvSpPr>
            <p:cNvPr id="363" name="TextBox 214"/>
            <p:cNvSpPr txBox="1"/>
            <p:nvPr/>
          </p:nvSpPr>
          <p:spPr>
            <a:xfrm>
              <a:off x="4996564" y="7013418"/>
              <a:ext cx="34233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600" dirty="0"/>
                <a:t>TSS</a:t>
              </a:r>
              <a:endParaRPr lang="ko-KR" altLang="en-US" sz="600" dirty="0"/>
            </a:p>
          </p:txBody>
        </p:sp>
        <p:sp>
          <p:nvSpPr>
            <p:cNvPr id="364" name="TextBox 214"/>
            <p:cNvSpPr txBox="1"/>
            <p:nvPr/>
          </p:nvSpPr>
          <p:spPr>
            <a:xfrm>
              <a:off x="3629736" y="6901139"/>
              <a:ext cx="29989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ko-KR" sz="600" dirty="0"/>
                <a:t>0</a:t>
              </a:r>
              <a:endParaRPr lang="ko-KR" altLang="en-US" sz="600" dirty="0"/>
            </a:p>
          </p:txBody>
        </p:sp>
        <p:sp>
          <p:nvSpPr>
            <p:cNvPr id="365" name="TextBox 214"/>
            <p:cNvSpPr txBox="1"/>
            <p:nvPr/>
          </p:nvSpPr>
          <p:spPr>
            <a:xfrm>
              <a:off x="3586002" y="5752259"/>
              <a:ext cx="34122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ko-KR" sz="600" dirty="0"/>
                <a:t>200</a:t>
              </a:r>
              <a:endParaRPr lang="ko-KR" altLang="en-US" sz="600" dirty="0"/>
            </a:p>
          </p:txBody>
        </p:sp>
        <p:sp>
          <p:nvSpPr>
            <p:cNvPr id="366" name="TextBox 214"/>
            <p:cNvSpPr txBox="1"/>
            <p:nvPr/>
          </p:nvSpPr>
          <p:spPr>
            <a:xfrm rot="16200000">
              <a:off x="3484953" y="6318921"/>
              <a:ext cx="80440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ko-KR" sz="600" dirty="0"/>
                <a:t>RPM</a:t>
              </a:r>
              <a:endParaRPr lang="ko-KR" altLang="en-US" sz="600" dirty="0"/>
            </a:p>
          </p:txBody>
        </p:sp>
        <p:sp>
          <p:nvSpPr>
            <p:cNvPr id="400" name="TextBox 214"/>
            <p:cNvSpPr txBox="1"/>
            <p:nvPr/>
          </p:nvSpPr>
          <p:spPr>
            <a:xfrm>
              <a:off x="4753332" y="5673215"/>
              <a:ext cx="108003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/>
                <a:t>H2Bub (rep2)</a:t>
              </a:r>
              <a:endParaRPr lang="ko-KR" altLang="en-US" sz="1100" b="1" dirty="0"/>
            </a:p>
          </p:txBody>
        </p:sp>
        <p:sp>
          <p:nvSpPr>
            <p:cNvPr id="402" name="TextBox 214"/>
            <p:cNvSpPr txBox="1"/>
            <p:nvPr/>
          </p:nvSpPr>
          <p:spPr>
            <a:xfrm>
              <a:off x="6304837" y="5928415"/>
              <a:ext cx="19936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600" dirty="0"/>
                <a:t>M</a:t>
              </a:r>
              <a:endParaRPr lang="ko-KR" altLang="en-US" sz="600" dirty="0"/>
            </a:p>
          </p:txBody>
        </p:sp>
        <p:sp>
          <p:nvSpPr>
            <p:cNvPr id="403" name="직사각형 402"/>
            <p:cNvSpPr/>
            <p:nvPr/>
          </p:nvSpPr>
          <p:spPr>
            <a:xfrm>
              <a:off x="6246069" y="5987077"/>
              <a:ext cx="86360" cy="71077"/>
            </a:xfrm>
            <a:prstGeom prst="rect">
              <a:avLst/>
            </a:prstGeom>
            <a:solidFill>
              <a:srgbClr val="8D74B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600"/>
            </a:p>
          </p:txBody>
        </p:sp>
        <p:sp>
          <p:nvSpPr>
            <p:cNvPr id="404" name="직사각형 403"/>
            <p:cNvSpPr/>
            <p:nvPr/>
          </p:nvSpPr>
          <p:spPr>
            <a:xfrm>
              <a:off x="6246069" y="6080387"/>
              <a:ext cx="86360" cy="71077"/>
            </a:xfrm>
            <a:prstGeom prst="rect">
              <a:avLst/>
            </a:prstGeom>
            <a:solidFill>
              <a:srgbClr val="8C2A9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600"/>
            </a:p>
          </p:txBody>
        </p:sp>
        <p:sp>
          <p:nvSpPr>
            <p:cNvPr id="405" name="직사각형 404"/>
            <p:cNvSpPr/>
            <p:nvPr/>
          </p:nvSpPr>
          <p:spPr>
            <a:xfrm>
              <a:off x="6246069" y="6173696"/>
              <a:ext cx="86360" cy="71077"/>
            </a:xfrm>
            <a:prstGeom prst="rect">
              <a:avLst/>
            </a:prstGeom>
            <a:solidFill>
              <a:srgbClr val="4B014C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600"/>
            </a:p>
          </p:txBody>
        </p:sp>
        <p:sp>
          <p:nvSpPr>
            <p:cNvPr id="406" name="TextBox 214"/>
            <p:cNvSpPr txBox="1"/>
            <p:nvPr/>
          </p:nvSpPr>
          <p:spPr>
            <a:xfrm>
              <a:off x="6304836" y="6027746"/>
              <a:ext cx="22029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600" dirty="0"/>
                <a:t>L</a:t>
              </a:r>
              <a:endParaRPr lang="ko-KR" altLang="en-US" sz="600" dirty="0"/>
            </a:p>
          </p:txBody>
        </p:sp>
        <p:sp>
          <p:nvSpPr>
            <p:cNvPr id="407" name="TextBox 214"/>
            <p:cNvSpPr txBox="1"/>
            <p:nvPr/>
          </p:nvSpPr>
          <p:spPr>
            <a:xfrm>
              <a:off x="6304836" y="6131838"/>
              <a:ext cx="34547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600" dirty="0"/>
                <a:t>XL</a:t>
              </a:r>
              <a:endParaRPr lang="ko-KR" altLang="en-US" sz="600" dirty="0"/>
            </a:p>
          </p:txBody>
        </p:sp>
        <p:sp>
          <p:nvSpPr>
            <p:cNvPr id="408" name="직사각형 407"/>
            <p:cNvSpPr/>
            <p:nvPr/>
          </p:nvSpPr>
          <p:spPr>
            <a:xfrm>
              <a:off x="6246069" y="5803384"/>
              <a:ext cx="86360" cy="71077"/>
            </a:xfrm>
            <a:prstGeom prst="rect">
              <a:avLst/>
            </a:prstGeom>
            <a:solidFill>
              <a:srgbClr val="CCDEEC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600"/>
            </a:p>
          </p:txBody>
        </p:sp>
        <p:sp>
          <p:nvSpPr>
            <p:cNvPr id="409" name="직사각형 408"/>
            <p:cNvSpPr/>
            <p:nvPr/>
          </p:nvSpPr>
          <p:spPr>
            <a:xfrm>
              <a:off x="6246069" y="5896693"/>
              <a:ext cx="86360" cy="71077"/>
            </a:xfrm>
            <a:prstGeom prst="rect">
              <a:avLst/>
            </a:prstGeom>
            <a:solidFill>
              <a:srgbClr val="9AB4D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600"/>
            </a:p>
          </p:txBody>
        </p:sp>
        <p:sp>
          <p:nvSpPr>
            <p:cNvPr id="410" name="TextBox 214"/>
            <p:cNvSpPr txBox="1"/>
            <p:nvPr/>
          </p:nvSpPr>
          <p:spPr>
            <a:xfrm>
              <a:off x="6304836" y="5750728"/>
              <a:ext cx="33245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600" dirty="0"/>
                <a:t>XS</a:t>
              </a:r>
              <a:endParaRPr lang="ko-KR" altLang="en-US" sz="600" dirty="0"/>
            </a:p>
          </p:txBody>
        </p:sp>
        <p:sp>
          <p:nvSpPr>
            <p:cNvPr id="411" name="TextBox 214"/>
            <p:cNvSpPr txBox="1"/>
            <p:nvPr/>
          </p:nvSpPr>
          <p:spPr>
            <a:xfrm>
              <a:off x="6309567" y="5844577"/>
              <a:ext cx="19936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600" dirty="0"/>
                <a:t>S</a:t>
              </a:r>
              <a:endParaRPr lang="ko-KR" altLang="en-US" sz="600" dirty="0"/>
            </a:p>
          </p:txBody>
        </p:sp>
      </p:grpSp>
      <p:sp>
        <p:nvSpPr>
          <p:cNvPr id="448" name="TextBox 447"/>
          <p:cNvSpPr txBox="1"/>
          <p:nvPr/>
        </p:nvSpPr>
        <p:spPr bwMode="auto">
          <a:xfrm>
            <a:off x="3660328" y="3670829"/>
            <a:ext cx="306416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>
              <a:defRPr/>
            </a:pPr>
            <a:r>
              <a:rPr lang="en-US" altLang="ko-KR" sz="1600" b="1" dirty="0">
                <a:latin typeface="+mj-lt"/>
                <a:cs typeface="Arial" panose="020B0604020202020204" pitchFamily="34" charset="0"/>
              </a:rPr>
              <a:t>d</a:t>
            </a:r>
            <a:endParaRPr lang="ko-KR" altLang="en-US" sz="1600" b="1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449" name="TextBox 448"/>
          <p:cNvSpPr txBox="1"/>
          <p:nvPr/>
        </p:nvSpPr>
        <p:spPr bwMode="auto">
          <a:xfrm>
            <a:off x="3660328" y="5396606"/>
            <a:ext cx="306416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>
              <a:defRPr/>
            </a:pPr>
            <a:r>
              <a:rPr lang="en-US" altLang="ko-KR" sz="1600" b="1" dirty="0">
                <a:latin typeface="+mj-lt"/>
                <a:cs typeface="Arial" panose="020B0604020202020204" pitchFamily="34" charset="0"/>
              </a:rPr>
              <a:t>e</a:t>
            </a:r>
            <a:endParaRPr lang="ko-KR" altLang="en-US" sz="1600" b="1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194" name="TextBox 193"/>
          <p:cNvSpPr txBox="1"/>
          <p:nvPr/>
        </p:nvSpPr>
        <p:spPr>
          <a:xfrm rot="16200000">
            <a:off x="569470" y="1633586"/>
            <a:ext cx="1935219" cy="2154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>
                <a:cs typeface="Helvetica" panose="020B0604020202020204" pitchFamily="34" charset="0"/>
              </a:rPr>
              <a:t>Gene length</a:t>
            </a:r>
          </a:p>
        </p:txBody>
      </p:sp>
      <p:sp>
        <p:nvSpPr>
          <p:cNvPr id="195" name="이등변 삼각형 194"/>
          <p:cNvSpPr/>
          <p:nvPr/>
        </p:nvSpPr>
        <p:spPr>
          <a:xfrm>
            <a:off x="1627638" y="1166185"/>
            <a:ext cx="78937" cy="2160000"/>
          </a:xfrm>
          <a:prstGeom prst="triangle">
            <a:avLst>
              <a:gd name="adj" fmla="val 98484"/>
            </a:avLst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2000" dirty="0"/>
          </a:p>
        </p:txBody>
      </p:sp>
      <p:pic>
        <p:nvPicPr>
          <p:cNvPr id="190" name="그림 189"/>
          <p:cNvPicPr>
            <a:picLocks/>
          </p:cNvPicPr>
          <p:nvPr/>
        </p:nvPicPr>
        <p:blipFill rotWithShape="1">
          <a:blip r:embed="rId6"/>
          <a:srcRect t="95814" b="2247"/>
          <a:stretch/>
        </p:blipFill>
        <p:spPr>
          <a:xfrm>
            <a:off x="4074192" y="3309816"/>
            <a:ext cx="720000" cy="48589"/>
          </a:xfrm>
          <a:prstGeom prst="rect">
            <a:avLst/>
          </a:prstGeom>
          <a:ln w="6350">
            <a:noFill/>
          </a:ln>
        </p:spPr>
      </p:pic>
      <p:sp>
        <p:nvSpPr>
          <p:cNvPr id="192" name="TextBox 191"/>
          <p:cNvSpPr txBox="1"/>
          <p:nvPr/>
        </p:nvSpPr>
        <p:spPr>
          <a:xfrm>
            <a:off x="4387039" y="3295324"/>
            <a:ext cx="46296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dirty="0">
                <a:cs typeface="Arial" panose="020B0604020202020204" pitchFamily="34" charset="0"/>
              </a:rPr>
              <a:t>1500 bp</a:t>
            </a:r>
            <a:endParaRPr lang="ko-KR" altLang="en-US" sz="600" i="1" dirty="0">
              <a:cs typeface="Arial" panose="020B0604020202020204" pitchFamily="34" charset="0"/>
            </a:endParaRPr>
          </a:p>
        </p:txBody>
      </p:sp>
      <p:sp>
        <p:nvSpPr>
          <p:cNvPr id="193" name="TextBox 214"/>
          <p:cNvSpPr txBox="1"/>
          <p:nvPr/>
        </p:nvSpPr>
        <p:spPr>
          <a:xfrm>
            <a:off x="4259848" y="3373604"/>
            <a:ext cx="38863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700" dirty="0"/>
              <a:t>TSS</a:t>
            </a:r>
            <a:endParaRPr lang="ko-KR" altLang="en-US" sz="700" dirty="0"/>
          </a:p>
        </p:txBody>
      </p:sp>
      <p:pic>
        <p:nvPicPr>
          <p:cNvPr id="189" name="그림 188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074923" y="3506457"/>
            <a:ext cx="238095" cy="4572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64" name="그림 163"/>
          <p:cNvPicPr>
            <a:picLocks/>
          </p:cNvPicPr>
          <p:nvPr/>
        </p:nvPicPr>
        <p:blipFill rotWithShape="1">
          <a:blip r:embed="rId6"/>
          <a:srcRect t="95814" b="2247"/>
          <a:stretch/>
        </p:blipFill>
        <p:spPr>
          <a:xfrm>
            <a:off x="3279288" y="3309816"/>
            <a:ext cx="720000" cy="48589"/>
          </a:xfrm>
          <a:prstGeom prst="rect">
            <a:avLst/>
          </a:prstGeom>
          <a:ln w="6350">
            <a:noFill/>
          </a:ln>
        </p:spPr>
      </p:pic>
      <p:sp>
        <p:nvSpPr>
          <p:cNvPr id="166" name="TextBox 165"/>
          <p:cNvSpPr txBox="1"/>
          <p:nvPr/>
        </p:nvSpPr>
        <p:spPr>
          <a:xfrm>
            <a:off x="3592135" y="3295324"/>
            <a:ext cx="46296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dirty="0">
                <a:cs typeface="Arial" panose="020B0604020202020204" pitchFamily="34" charset="0"/>
              </a:rPr>
              <a:t>1500 bp</a:t>
            </a:r>
            <a:endParaRPr lang="ko-KR" altLang="en-US" sz="600" i="1" dirty="0">
              <a:cs typeface="Arial" panose="020B0604020202020204" pitchFamily="34" charset="0"/>
            </a:endParaRPr>
          </a:p>
        </p:txBody>
      </p:sp>
      <p:sp>
        <p:nvSpPr>
          <p:cNvPr id="167" name="TextBox 214"/>
          <p:cNvSpPr txBox="1"/>
          <p:nvPr/>
        </p:nvSpPr>
        <p:spPr>
          <a:xfrm>
            <a:off x="3461769" y="3373604"/>
            <a:ext cx="38863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700" dirty="0"/>
              <a:t>TSS</a:t>
            </a:r>
            <a:endParaRPr lang="ko-KR" altLang="en-US" sz="700" dirty="0"/>
          </a:p>
        </p:txBody>
      </p:sp>
      <p:pic>
        <p:nvPicPr>
          <p:cNvPr id="152" name="그림 151"/>
          <p:cNvPicPr>
            <a:picLocks/>
          </p:cNvPicPr>
          <p:nvPr/>
        </p:nvPicPr>
        <p:blipFill rotWithShape="1">
          <a:blip r:embed="rId6"/>
          <a:srcRect t="95814" b="2247"/>
          <a:stretch/>
        </p:blipFill>
        <p:spPr>
          <a:xfrm>
            <a:off x="1735419" y="3309816"/>
            <a:ext cx="720000" cy="48589"/>
          </a:xfrm>
          <a:prstGeom prst="rect">
            <a:avLst/>
          </a:prstGeom>
          <a:ln w="6350">
            <a:noFill/>
          </a:ln>
        </p:spPr>
      </p:pic>
      <p:sp>
        <p:nvSpPr>
          <p:cNvPr id="157" name="TextBox 156"/>
          <p:cNvSpPr txBox="1"/>
          <p:nvPr/>
        </p:nvSpPr>
        <p:spPr>
          <a:xfrm>
            <a:off x="1906848" y="940784"/>
            <a:ext cx="3064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cs typeface="Arial" panose="020B0604020202020204" pitchFamily="34" charset="0"/>
              </a:rPr>
              <a:t>#1</a:t>
            </a:r>
            <a:endParaRPr lang="ko-KR" altLang="en-US" sz="800" i="1" dirty="0">
              <a:cs typeface="Arial" panose="020B0604020202020204" pitchFamily="34" charset="0"/>
            </a:endParaRPr>
          </a:p>
        </p:txBody>
      </p:sp>
      <p:sp>
        <p:nvSpPr>
          <p:cNvPr id="158" name="TextBox 157"/>
          <p:cNvSpPr txBox="1"/>
          <p:nvPr/>
        </p:nvSpPr>
        <p:spPr>
          <a:xfrm>
            <a:off x="2031840" y="3295324"/>
            <a:ext cx="46279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dirty="0">
                <a:cs typeface="Arial" panose="020B0604020202020204" pitchFamily="34" charset="0"/>
              </a:rPr>
              <a:t>1500 bp</a:t>
            </a:r>
            <a:endParaRPr lang="ko-KR" altLang="en-US" sz="600" i="1" dirty="0">
              <a:cs typeface="Arial" panose="020B0604020202020204" pitchFamily="34" charset="0"/>
            </a:endParaRPr>
          </a:p>
        </p:txBody>
      </p:sp>
      <p:sp>
        <p:nvSpPr>
          <p:cNvPr id="159" name="TextBox 214"/>
          <p:cNvSpPr txBox="1"/>
          <p:nvPr/>
        </p:nvSpPr>
        <p:spPr>
          <a:xfrm>
            <a:off x="1915953" y="3373604"/>
            <a:ext cx="38863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700" dirty="0"/>
              <a:t>TSS</a:t>
            </a:r>
            <a:endParaRPr lang="ko-KR" altLang="en-US" sz="700" dirty="0"/>
          </a:p>
        </p:txBody>
      </p:sp>
      <p:pic>
        <p:nvPicPr>
          <p:cNvPr id="148" name="그림 147"/>
          <p:cNvPicPr>
            <a:picLocks/>
          </p:cNvPicPr>
          <p:nvPr/>
        </p:nvPicPr>
        <p:blipFill rotWithShape="1">
          <a:blip r:embed="rId6"/>
          <a:srcRect t="95814" b="2247"/>
          <a:stretch/>
        </p:blipFill>
        <p:spPr>
          <a:xfrm>
            <a:off x="2505431" y="3309816"/>
            <a:ext cx="720000" cy="48589"/>
          </a:xfrm>
          <a:prstGeom prst="rect">
            <a:avLst/>
          </a:prstGeom>
          <a:ln w="6350">
            <a:noFill/>
          </a:ln>
        </p:spPr>
      </p:pic>
      <p:sp>
        <p:nvSpPr>
          <p:cNvPr id="150" name="TextBox 149"/>
          <p:cNvSpPr txBox="1"/>
          <p:nvPr/>
        </p:nvSpPr>
        <p:spPr>
          <a:xfrm>
            <a:off x="2818278" y="3295324"/>
            <a:ext cx="46296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dirty="0">
                <a:cs typeface="Arial" panose="020B0604020202020204" pitchFamily="34" charset="0"/>
              </a:rPr>
              <a:t>1500 bp</a:t>
            </a:r>
            <a:endParaRPr lang="ko-KR" altLang="en-US" sz="600" i="1" dirty="0">
              <a:cs typeface="Arial" panose="020B0604020202020204" pitchFamily="34" charset="0"/>
            </a:endParaRPr>
          </a:p>
        </p:txBody>
      </p:sp>
      <p:sp>
        <p:nvSpPr>
          <p:cNvPr id="151" name="TextBox 214"/>
          <p:cNvSpPr txBox="1"/>
          <p:nvPr/>
        </p:nvSpPr>
        <p:spPr>
          <a:xfrm>
            <a:off x="2690060" y="3373604"/>
            <a:ext cx="38863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700" dirty="0"/>
              <a:t>TSS</a:t>
            </a:r>
            <a:endParaRPr lang="ko-KR" altLang="en-US" sz="700" dirty="0"/>
          </a:p>
        </p:txBody>
      </p:sp>
      <p:pic>
        <p:nvPicPr>
          <p:cNvPr id="203" name="그림 20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739888" y="3506457"/>
            <a:ext cx="238095" cy="4572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07" name="그림 206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501260" y="3506457"/>
            <a:ext cx="238095" cy="4572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11" name="그림 210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291191" y="3506457"/>
            <a:ext cx="238095" cy="4572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212" name="TextBox 211"/>
          <p:cNvSpPr txBox="1"/>
          <p:nvPr/>
        </p:nvSpPr>
        <p:spPr>
          <a:xfrm>
            <a:off x="2697739" y="940784"/>
            <a:ext cx="3064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cs typeface="Arial" panose="020B0604020202020204" pitchFamily="34" charset="0"/>
              </a:rPr>
              <a:t>#2</a:t>
            </a:r>
            <a:endParaRPr lang="ko-KR" altLang="en-US" sz="800" i="1" dirty="0">
              <a:cs typeface="Arial" panose="020B0604020202020204" pitchFamily="34" charset="0"/>
            </a:endParaRPr>
          </a:p>
        </p:txBody>
      </p:sp>
      <p:sp>
        <p:nvSpPr>
          <p:cNvPr id="213" name="TextBox 212"/>
          <p:cNvSpPr txBox="1"/>
          <p:nvPr/>
        </p:nvSpPr>
        <p:spPr>
          <a:xfrm>
            <a:off x="3488630" y="940784"/>
            <a:ext cx="3064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cs typeface="Arial" panose="020B0604020202020204" pitchFamily="34" charset="0"/>
              </a:rPr>
              <a:t>#1</a:t>
            </a:r>
            <a:endParaRPr lang="ko-KR" altLang="en-US" sz="800" i="1" dirty="0">
              <a:cs typeface="Arial" panose="020B0604020202020204" pitchFamily="34" charset="0"/>
            </a:endParaRPr>
          </a:p>
        </p:txBody>
      </p:sp>
      <p:sp>
        <p:nvSpPr>
          <p:cNvPr id="214" name="TextBox 213"/>
          <p:cNvSpPr txBox="1"/>
          <p:nvPr/>
        </p:nvSpPr>
        <p:spPr>
          <a:xfrm>
            <a:off x="4279520" y="940784"/>
            <a:ext cx="3064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cs typeface="Arial" panose="020B0604020202020204" pitchFamily="34" charset="0"/>
              </a:rPr>
              <a:t>#2</a:t>
            </a:r>
            <a:endParaRPr lang="ko-KR" altLang="en-US" sz="800" i="1" dirty="0">
              <a:cs typeface="Arial" panose="020B0604020202020204" pitchFamily="34" charset="0"/>
            </a:endParaRPr>
          </a:p>
        </p:txBody>
      </p:sp>
      <p:cxnSp>
        <p:nvCxnSpPr>
          <p:cNvPr id="215" name="직선 연결선 214"/>
          <p:cNvCxnSpPr/>
          <p:nvPr/>
        </p:nvCxnSpPr>
        <p:spPr>
          <a:xfrm>
            <a:off x="1759849" y="940784"/>
            <a:ext cx="144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6" name="직선 연결선 215"/>
          <p:cNvCxnSpPr/>
          <p:nvPr/>
        </p:nvCxnSpPr>
        <p:spPr>
          <a:xfrm>
            <a:off x="3325416" y="940784"/>
            <a:ext cx="144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7" name="TextBox 216"/>
          <p:cNvSpPr txBox="1"/>
          <p:nvPr/>
        </p:nvSpPr>
        <p:spPr>
          <a:xfrm>
            <a:off x="2290929" y="756942"/>
            <a:ext cx="4023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cs typeface="Arial" panose="020B0604020202020204" pitchFamily="34" charset="0"/>
              </a:rPr>
              <a:t>H2B</a:t>
            </a:r>
            <a:endParaRPr lang="ko-KR" altLang="en-US" sz="800" i="1" dirty="0">
              <a:cs typeface="Arial" panose="020B0604020202020204" pitchFamily="34" charset="0"/>
            </a:endParaRPr>
          </a:p>
        </p:txBody>
      </p:sp>
      <p:sp>
        <p:nvSpPr>
          <p:cNvPr id="218" name="TextBox 217"/>
          <p:cNvSpPr txBox="1"/>
          <p:nvPr/>
        </p:nvSpPr>
        <p:spPr>
          <a:xfrm>
            <a:off x="3699899" y="756942"/>
            <a:ext cx="7542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cs typeface="Arial" panose="020B0604020202020204" pitchFamily="34" charset="0"/>
              </a:rPr>
              <a:t>H2BK123ub</a:t>
            </a:r>
            <a:endParaRPr lang="ko-KR" altLang="en-US" sz="800" i="1" dirty="0">
              <a:cs typeface="Arial" panose="020B0604020202020204" pitchFamily="34" charset="0"/>
            </a:endParaRPr>
          </a:p>
        </p:txBody>
      </p:sp>
      <p:sp>
        <p:nvSpPr>
          <p:cNvPr id="445" name="TextBox 444"/>
          <p:cNvSpPr txBox="1"/>
          <p:nvPr/>
        </p:nvSpPr>
        <p:spPr bwMode="auto">
          <a:xfrm>
            <a:off x="1361974" y="643479"/>
            <a:ext cx="306416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>
              <a:defRPr/>
            </a:pPr>
            <a:r>
              <a:rPr lang="en-US" altLang="ko-KR" sz="1600" b="1" dirty="0">
                <a:latin typeface="+mj-lt"/>
                <a:cs typeface="Arial" panose="020B0604020202020204" pitchFamily="34" charset="0"/>
              </a:rPr>
              <a:t>a</a:t>
            </a:r>
            <a:endParaRPr lang="ko-KR" altLang="en-US" sz="1600" b="1" dirty="0">
              <a:latin typeface="+mj-lt"/>
              <a:cs typeface="Arial" panose="020B0604020202020204" pitchFamily="34" charset="0"/>
            </a:endParaRPr>
          </a:p>
        </p:txBody>
      </p:sp>
      <p:pic>
        <p:nvPicPr>
          <p:cNvPr id="3" name="그림 2"/>
          <p:cNvPicPr>
            <a:picLocks/>
          </p:cNvPicPr>
          <p:nvPr/>
        </p:nvPicPr>
        <p:blipFill rotWithShape="1">
          <a:blip r:embed="rId8"/>
          <a:srcRect r="80546"/>
          <a:stretch/>
        </p:blipFill>
        <p:spPr>
          <a:xfrm>
            <a:off x="1735419" y="1145525"/>
            <a:ext cx="72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26" name="그림 225"/>
          <p:cNvPicPr>
            <a:picLocks/>
          </p:cNvPicPr>
          <p:nvPr/>
        </p:nvPicPr>
        <p:blipFill rotWithShape="1">
          <a:blip r:embed="rId8"/>
          <a:srcRect l="53631" r="26824"/>
          <a:stretch/>
        </p:blipFill>
        <p:spPr>
          <a:xfrm>
            <a:off x="3285970" y="1145525"/>
            <a:ext cx="72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27" name="그림 226"/>
          <p:cNvPicPr>
            <a:picLocks/>
          </p:cNvPicPr>
          <p:nvPr/>
        </p:nvPicPr>
        <p:blipFill rotWithShape="1">
          <a:blip r:embed="rId8"/>
          <a:srcRect l="26853" r="53537"/>
          <a:stretch/>
        </p:blipFill>
        <p:spPr>
          <a:xfrm>
            <a:off x="2507848" y="1145525"/>
            <a:ext cx="72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28" name="그림 227"/>
          <p:cNvPicPr>
            <a:picLocks/>
          </p:cNvPicPr>
          <p:nvPr/>
        </p:nvPicPr>
        <p:blipFill rotWithShape="1">
          <a:blip r:embed="rId8"/>
          <a:srcRect l="80373"/>
          <a:stretch/>
        </p:blipFill>
        <p:spPr>
          <a:xfrm>
            <a:off x="4079388" y="1145525"/>
            <a:ext cx="72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1972504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4" name="그룹 173"/>
          <p:cNvGrpSpPr/>
          <p:nvPr/>
        </p:nvGrpSpPr>
        <p:grpSpPr>
          <a:xfrm>
            <a:off x="409431" y="782880"/>
            <a:ext cx="3345827" cy="4056984"/>
            <a:chOff x="1444552" y="3653749"/>
            <a:chExt cx="3345827" cy="4056984"/>
          </a:xfrm>
        </p:grpSpPr>
        <p:graphicFrame>
          <p:nvGraphicFramePr>
            <p:cNvPr id="172" name="차트 17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266077070"/>
                </p:ext>
              </p:extLst>
            </p:nvPr>
          </p:nvGraphicFramePr>
          <p:xfrm>
            <a:off x="1444552" y="3653749"/>
            <a:ext cx="3345827" cy="405698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cxnSp>
          <p:nvCxnSpPr>
            <p:cNvPr id="173" name="직선 연결선 172"/>
            <p:cNvCxnSpPr/>
            <p:nvPr/>
          </p:nvCxnSpPr>
          <p:spPr>
            <a:xfrm flipV="1">
              <a:off x="2103859" y="4260339"/>
              <a:ext cx="2450020" cy="286207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75" name="TextBox 174"/>
          <p:cNvSpPr txBox="1"/>
          <p:nvPr/>
        </p:nvSpPr>
        <p:spPr bwMode="auto">
          <a:xfrm>
            <a:off x="101107" y="761691"/>
            <a:ext cx="292706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altLang="ko-KR" sz="1600" b="1" dirty="0">
                <a:cs typeface="Arial" panose="020B0604020202020204" pitchFamily="34" charset="0"/>
              </a:rPr>
              <a:t>a</a:t>
            </a:r>
            <a:endParaRPr lang="ko-KR" altLang="en-US" sz="1600" b="1" dirty="0">
              <a:cs typeface="Arial" panose="020B0604020202020204" pitchFamily="34" charset="0"/>
            </a:endParaRPr>
          </a:p>
        </p:txBody>
      </p:sp>
      <p:sp>
        <p:nvSpPr>
          <p:cNvPr id="176" name="TextBox 175"/>
          <p:cNvSpPr txBox="1"/>
          <p:nvPr/>
        </p:nvSpPr>
        <p:spPr bwMode="auto">
          <a:xfrm>
            <a:off x="3962926" y="1166643"/>
            <a:ext cx="42172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altLang="ko-KR" sz="1600" b="1" dirty="0">
                <a:cs typeface="Arial" panose="020B0604020202020204" pitchFamily="34" charset="0"/>
              </a:rPr>
              <a:t>b</a:t>
            </a:r>
            <a:endParaRPr lang="ko-KR" altLang="en-US" sz="1600" b="1" dirty="0">
              <a:cs typeface="Arial" panose="020B0604020202020204" pitchFamily="34" charset="0"/>
            </a:endParaRPr>
          </a:p>
        </p:txBody>
      </p:sp>
      <p:pic>
        <p:nvPicPr>
          <p:cNvPr id="2" name="그림 1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4605195" y="1866956"/>
            <a:ext cx="72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9" name="TextBox 58"/>
          <p:cNvSpPr txBox="1"/>
          <p:nvPr/>
        </p:nvSpPr>
        <p:spPr>
          <a:xfrm rot="16200000">
            <a:off x="3981909" y="2897919"/>
            <a:ext cx="774863" cy="2154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>
                <a:cs typeface="Helvetica" panose="020B0604020202020204" pitchFamily="34" charset="0"/>
              </a:rPr>
              <a:t>Gene length</a:t>
            </a:r>
          </a:p>
        </p:txBody>
      </p:sp>
      <p:sp>
        <p:nvSpPr>
          <p:cNvPr id="67" name="이등변 삼각형 66"/>
          <p:cNvSpPr/>
          <p:nvPr/>
        </p:nvSpPr>
        <p:spPr>
          <a:xfrm>
            <a:off x="4483241" y="1874695"/>
            <a:ext cx="78937" cy="2160000"/>
          </a:xfrm>
          <a:prstGeom prst="triangle">
            <a:avLst>
              <a:gd name="adj" fmla="val 98484"/>
            </a:avLst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2000" dirty="0"/>
          </a:p>
        </p:txBody>
      </p:sp>
      <p:pic>
        <p:nvPicPr>
          <p:cNvPr id="68" name="그림 67"/>
          <p:cNvPicPr>
            <a:picLocks/>
          </p:cNvPicPr>
          <p:nvPr/>
        </p:nvPicPr>
        <p:blipFill rotWithShape="1">
          <a:blip r:embed="rId5"/>
          <a:srcRect t="95814" b="2247"/>
          <a:stretch/>
        </p:blipFill>
        <p:spPr>
          <a:xfrm>
            <a:off x="5384971" y="4037282"/>
            <a:ext cx="720000" cy="48589"/>
          </a:xfrm>
          <a:prstGeom prst="rect">
            <a:avLst/>
          </a:prstGeom>
          <a:ln w="6350">
            <a:noFill/>
          </a:ln>
        </p:spPr>
      </p:pic>
      <p:sp>
        <p:nvSpPr>
          <p:cNvPr id="69" name="TextBox 68"/>
          <p:cNvSpPr txBox="1"/>
          <p:nvPr/>
        </p:nvSpPr>
        <p:spPr>
          <a:xfrm>
            <a:off x="5672439" y="4020409"/>
            <a:ext cx="47174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dirty="0">
                <a:cs typeface="Arial" panose="020B0604020202020204" pitchFamily="34" charset="0"/>
              </a:rPr>
              <a:t>1500 bp</a:t>
            </a:r>
            <a:endParaRPr lang="ko-KR" altLang="en-US" sz="600" i="1" dirty="0">
              <a:cs typeface="Arial" panose="020B0604020202020204" pitchFamily="34" charset="0"/>
            </a:endParaRPr>
          </a:p>
        </p:txBody>
      </p:sp>
      <p:sp>
        <p:nvSpPr>
          <p:cNvPr id="70" name="TextBox 214"/>
          <p:cNvSpPr txBox="1"/>
          <p:nvPr/>
        </p:nvSpPr>
        <p:spPr>
          <a:xfrm>
            <a:off x="5571856" y="4099254"/>
            <a:ext cx="38863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700" dirty="0"/>
              <a:t>TSS</a:t>
            </a:r>
            <a:endParaRPr lang="ko-KR" altLang="en-US" sz="700" dirty="0"/>
          </a:p>
        </p:txBody>
      </p:sp>
      <p:sp>
        <p:nvSpPr>
          <p:cNvPr id="85" name="TextBox 84"/>
          <p:cNvSpPr txBox="1"/>
          <p:nvPr/>
        </p:nvSpPr>
        <p:spPr>
          <a:xfrm>
            <a:off x="5495440" y="1648152"/>
            <a:ext cx="4708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cs typeface="Arial" panose="020B0604020202020204" pitchFamily="34" charset="0"/>
              </a:rPr>
              <a:t>Set1</a:t>
            </a:r>
            <a:endParaRPr lang="ko-KR" altLang="en-US" sz="1000" i="1" dirty="0">
              <a:cs typeface="Arial" panose="020B0604020202020204" pitchFamily="34" charset="0"/>
            </a:endParaRPr>
          </a:p>
        </p:txBody>
      </p:sp>
      <p:pic>
        <p:nvPicPr>
          <p:cNvPr id="105" name="그림 104"/>
          <p:cNvPicPr>
            <a:picLocks/>
          </p:cNvPicPr>
          <p:nvPr/>
        </p:nvPicPr>
        <p:blipFill rotWithShape="1">
          <a:blip r:embed="rId5"/>
          <a:srcRect t="95814" b="2247"/>
          <a:stretch/>
        </p:blipFill>
        <p:spPr>
          <a:xfrm>
            <a:off x="4605195" y="4037282"/>
            <a:ext cx="720000" cy="48589"/>
          </a:xfrm>
          <a:prstGeom prst="rect">
            <a:avLst/>
          </a:prstGeom>
          <a:ln w="6350">
            <a:noFill/>
          </a:ln>
        </p:spPr>
      </p:pic>
      <p:sp>
        <p:nvSpPr>
          <p:cNvPr id="106" name="TextBox 105"/>
          <p:cNvSpPr txBox="1"/>
          <p:nvPr/>
        </p:nvSpPr>
        <p:spPr>
          <a:xfrm>
            <a:off x="4892663" y="4020409"/>
            <a:ext cx="47174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dirty="0">
                <a:cs typeface="Arial" panose="020B0604020202020204" pitchFamily="34" charset="0"/>
              </a:rPr>
              <a:t>1500 bp</a:t>
            </a:r>
            <a:endParaRPr lang="ko-KR" altLang="en-US" sz="600" i="1" dirty="0">
              <a:cs typeface="Arial" panose="020B0604020202020204" pitchFamily="34" charset="0"/>
            </a:endParaRPr>
          </a:p>
        </p:txBody>
      </p:sp>
      <p:sp>
        <p:nvSpPr>
          <p:cNvPr id="107" name="TextBox 214"/>
          <p:cNvSpPr txBox="1"/>
          <p:nvPr/>
        </p:nvSpPr>
        <p:spPr>
          <a:xfrm>
            <a:off x="4792080" y="4099254"/>
            <a:ext cx="38863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700" dirty="0"/>
              <a:t>TSS</a:t>
            </a:r>
            <a:endParaRPr lang="ko-KR" altLang="en-US" sz="700" dirty="0"/>
          </a:p>
        </p:txBody>
      </p:sp>
      <p:sp>
        <p:nvSpPr>
          <p:cNvPr id="111" name="TextBox 110"/>
          <p:cNvSpPr txBox="1"/>
          <p:nvPr/>
        </p:nvSpPr>
        <p:spPr>
          <a:xfrm>
            <a:off x="4528848" y="1648152"/>
            <a:ext cx="8439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cs typeface="Arial" panose="020B0604020202020204" pitchFamily="34" charset="0"/>
              </a:rPr>
              <a:t>Sen1</a:t>
            </a:r>
            <a:endParaRPr lang="ko-KR" altLang="en-US" sz="1000" i="1" dirty="0">
              <a:cs typeface="Arial" panose="020B0604020202020204" pitchFamily="34" charset="0"/>
            </a:endParaRPr>
          </a:p>
        </p:txBody>
      </p:sp>
      <p:pic>
        <p:nvPicPr>
          <p:cNvPr id="112" name="그림 11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390489" y="4243226"/>
            <a:ext cx="236551" cy="4572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4" name="그림 3"/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4609664" y="4243226"/>
            <a:ext cx="237600" cy="468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222" name="TextBox 221"/>
          <p:cNvSpPr txBox="1"/>
          <p:nvPr/>
        </p:nvSpPr>
        <p:spPr bwMode="auto">
          <a:xfrm>
            <a:off x="171869" y="4865524"/>
            <a:ext cx="35727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>
              <a:defRPr/>
            </a:pPr>
            <a:r>
              <a:rPr lang="en-US" altLang="ko-KR" sz="1600" b="1" dirty="0">
                <a:latin typeface="+mj-lt"/>
                <a:cs typeface="Arial" panose="020B0604020202020204" pitchFamily="34" charset="0"/>
              </a:rPr>
              <a:t>c</a:t>
            </a:r>
            <a:endParaRPr lang="ko-KR" altLang="en-US" sz="1600" b="1" dirty="0">
              <a:latin typeface="+mj-lt"/>
              <a:cs typeface="Arial" panose="020B0604020202020204" pitchFamily="34" charset="0"/>
            </a:endParaRPr>
          </a:p>
        </p:txBody>
      </p:sp>
      <p:grpSp>
        <p:nvGrpSpPr>
          <p:cNvPr id="3" name="그룹 2">
            <a:extLst>
              <a:ext uri="{FF2B5EF4-FFF2-40B4-BE49-F238E27FC236}">
                <a16:creationId xmlns:a16="http://schemas.microsoft.com/office/drawing/2014/main" id="{0620BF5E-8014-4CAE-A06C-4DF9C5EE2175}"/>
              </a:ext>
            </a:extLst>
          </p:cNvPr>
          <p:cNvGrpSpPr/>
          <p:nvPr/>
        </p:nvGrpSpPr>
        <p:grpSpPr>
          <a:xfrm>
            <a:off x="130345" y="4839864"/>
            <a:ext cx="6369122" cy="3434218"/>
            <a:chOff x="130345" y="4839864"/>
            <a:chExt cx="6369122" cy="3434218"/>
          </a:xfrm>
        </p:grpSpPr>
        <p:pic>
          <p:nvPicPr>
            <p:cNvPr id="8" name="그림 7" descr="IGV - Session: C:\Users\JUNSOO\Desktop\Rad6_Swd2_BMCbiol_resubmission을위한 rawdata\Set1,CPF,H3K4me3_track.xml"/>
            <p:cNvPicPr>
              <a:picLocks/>
            </p:cNvPicPr>
            <p:nvPr/>
          </p:nvPicPr>
          <p:blipFill rotWithShape="1">
            <a:blip r:embed="rId8" cstate="print">
              <a:clrChange>
                <a:clrFrom>
                  <a:srgbClr val="FAFAFA"/>
                </a:clrFrom>
                <a:clrTo>
                  <a:srgbClr val="FAFAFA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792" t="25219" r="45219" b="29094"/>
            <a:stretch/>
          </p:blipFill>
          <p:spPr>
            <a:xfrm>
              <a:off x="3331578" y="5062472"/>
              <a:ext cx="1112521" cy="2880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" name="그림 5" descr="IGV - Session: C:\Users\JUNSOO\Desktop\Rad6_Swd2_BMCbiol_resubmission을위한 rawdata\Set1,CPF,H3K4me3_track.xml"/>
            <p:cNvPicPr>
              <a:picLocks/>
            </p:cNvPicPr>
            <p:nvPr/>
          </p:nvPicPr>
          <p:blipFill rotWithShape="1">
            <a:blip r:embed="rId9" cstate="print">
              <a:clrChange>
                <a:clrFrom>
                  <a:srgbClr val="FAFAFA"/>
                </a:clrFrom>
                <a:clrTo>
                  <a:srgbClr val="FAFAFA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306" t="25256" r="51139" b="29149"/>
            <a:stretch/>
          </p:blipFill>
          <p:spPr>
            <a:xfrm>
              <a:off x="1426578" y="5062472"/>
              <a:ext cx="1884681" cy="2880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77" name="직선 연결선 76"/>
            <p:cNvCxnSpPr/>
            <p:nvPr/>
          </p:nvCxnSpPr>
          <p:spPr>
            <a:xfrm>
              <a:off x="1416570" y="5019873"/>
              <a:ext cx="432000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0" name="오각형 79"/>
            <p:cNvSpPr/>
            <p:nvPr/>
          </p:nvSpPr>
          <p:spPr>
            <a:xfrm rot="10800000">
              <a:off x="1875003" y="7970725"/>
              <a:ext cx="1178915" cy="106680"/>
            </a:xfrm>
            <a:prstGeom prst="homePlat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latin typeface="+mj-lt"/>
              </a:endParaRP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F4CB92FC-DDAB-9185-D5F4-957CD065747C}"/>
                </a:ext>
              </a:extLst>
            </p:cNvPr>
            <p:cNvSpPr txBox="1"/>
            <p:nvPr/>
          </p:nvSpPr>
          <p:spPr>
            <a:xfrm>
              <a:off x="2146199" y="8043250"/>
              <a:ext cx="66890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90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+mj-lt"/>
                </a:rPr>
                <a:t>PMA1</a:t>
              </a:r>
              <a:endParaRPr kumimoji="0" lang="ko-KR" altLang="en-US" sz="90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j-lt"/>
              </a:endParaRPr>
            </a:p>
          </p:txBody>
        </p:sp>
        <p:sp>
          <p:nvSpPr>
            <p:cNvPr id="86" name="TextBox 214">
              <a:extLst>
                <a:ext uri="{FF2B5EF4-FFF2-40B4-BE49-F238E27FC236}">
                  <a16:creationId xmlns:a16="http://schemas.microsoft.com/office/drawing/2014/main" id="{9348E57E-BD33-1807-F6FD-53BE806F8D41}"/>
                </a:ext>
              </a:extLst>
            </p:cNvPr>
            <p:cNvSpPr txBox="1"/>
            <p:nvPr/>
          </p:nvSpPr>
          <p:spPr>
            <a:xfrm>
              <a:off x="1336634" y="4839864"/>
              <a:ext cx="18942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r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ko-KR" sz="600" dirty="0">
                  <a:solidFill>
                    <a:prstClr val="black"/>
                  </a:solidFill>
                  <a:latin typeface="+mj-lt"/>
                  <a:ea typeface="맑은 고딕" panose="020B0503020000020004" pitchFamily="50" charset="-127"/>
                </a:rPr>
                <a:t>0</a:t>
              </a:r>
              <a:endParaRPr kumimoji="0" lang="ko-KR" altLang="en-US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j-lt"/>
                <a:ea typeface="맑은 고딕" panose="020B0503020000020004" pitchFamily="50" charset="-127"/>
              </a:endParaRPr>
            </a:p>
          </p:txBody>
        </p:sp>
        <p:sp>
          <p:nvSpPr>
            <p:cNvPr id="89" name="TextBox 214">
              <a:extLst>
                <a:ext uri="{FF2B5EF4-FFF2-40B4-BE49-F238E27FC236}">
                  <a16:creationId xmlns:a16="http://schemas.microsoft.com/office/drawing/2014/main" id="{9348E57E-BD33-1807-F6FD-53BE806F8D41}"/>
                </a:ext>
              </a:extLst>
            </p:cNvPr>
            <p:cNvSpPr txBox="1"/>
            <p:nvPr/>
          </p:nvSpPr>
          <p:spPr>
            <a:xfrm>
              <a:off x="1635275" y="4839864"/>
              <a:ext cx="40325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r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ko-KR" sz="600" dirty="0">
                  <a:solidFill>
                    <a:prstClr val="black"/>
                  </a:solidFill>
                  <a:latin typeface="+mj-lt"/>
                  <a:ea typeface="맑은 고딕" panose="020B0503020000020004" pitchFamily="50" charset="-127"/>
                </a:rPr>
                <a:t>1kb</a:t>
              </a:r>
              <a:endParaRPr kumimoji="0" lang="ko-KR" altLang="en-US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j-lt"/>
                <a:ea typeface="맑은 고딕" panose="020B0503020000020004" pitchFamily="50" charset="-127"/>
              </a:endParaRPr>
            </a:p>
          </p:txBody>
        </p:sp>
        <p:sp>
          <p:nvSpPr>
            <p:cNvPr id="92" name="TextBox 214">
              <a:extLst>
                <a:ext uri="{FF2B5EF4-FFF2-40B4-BE49-F238E27FC236}">
                  <a16:creationId xmlns:a16="http://schemas.microsoft.com/office/drawing/2014/main" id="{9348E57E-BD33-1807-F6FD-53BE806F8D41}"/>
                </a:ext>
              </a:extLst>
            </p:cNvPr>
            <p:cNvSpPr txBox="1"/>
            <p:nvPr/>
          </p:nvSpPr>
          <p:spPr>
            <a:xfrm>
              <a:off x="799521" y="5823230"/>
              <a:ext cx="66177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r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+mj-lt"/>
                  <a:ea typeface="맑은 고딕" panose="020B0503020000020004" pitchFamily="50" charset="-127"/>
                  <a:cs typeface="+mn-cs"/>
                </a:rPr>
                <a:t>WT #1</a:t>
              </a:r>
              <a:endParaRPr kumimoji="0" lang="ko-KR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j-lt"/>
                <a:ea typeface="맑은 고딕" panose="020B0503020000020004" pitchFamily="50" charset="-127"/>
                <a:cs typeface="+mn-cs"/>
              </a:endParaRPr>
            </a:p>
          </p:txBody>
        </p:sp>
        <p:sp>
          <p:nvSpPr>
            <p:cNvPr id="93" name="TextBox 214">
              <a:extLst>
                <a:ext uri="{FF2B5EF4-FFF2-40B4-BE49-F238E27FC236}">
                  <a16:creationId xmlns:a16="http://schemas.microsoft.com/office/drawing/2014/main" id="{9091807C-2C07-E7CB-4A83-188CCC193027}"/>
                </a:ext>
              </a:extLst>
            </p:cNvPr>
            <p:cNvSpPr txBox="1"/>
            <p:nvPr/>
          </p:nvSpPr>
          <p:spPr>
            <a:xfrm>
              <a:off x="716280" y="6183480"/>
              <a:ext cx="74501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r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+mj-lt"/>
                  <a:ea typeface="맑은 고딕" panose="020B0503020000020004" pitchFamily="50" charset="-127"/>
                  <a:cs typeface="+mn-cs"/>
                </a:rPr>
                <a:t>WT #2</a:t>
              </a:r>
              <a:endParaRPr kumimoji="0" lang="ko-KR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j-lt"/>
                <a:ea typeface="맑은 고딕" panose="020B0503020000020004" pitchFamily="50" charset="-127"/>
                <a:cs typeface="+mn-cs"/>
              </a:endParaRPr>
            </a:p>
          </p:txBody>
        </p:sp>
        <p:sp>
          <p:nvSpPr>
            <p:cNvPr id="98" name="TextBox 214">
              <a:extLst>
                <a:ext uri="{FF2B5EF4-FFF2-40B4-BE49-F238E27FC236}">
                  <a16:creationId xmlns:a16="http://schemas.microsoft.com/office/drawing/2014/main" id="{4F125E29-B5B1-025F-5DD7-D9AF89EA9945}"/>
                </a:ext>
              </a:extLst>
            </p:cNvPr>
            <p:cNvSpPr txBox="1"/>
            <p:nvPr/>
          </p:nvSpPr>
          <p:spPr>
            <a:xfrm>
              <a:off x="674954" y="6543730"/>
              <a:ext cx="78634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r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+mj-lt"/>
                  <a:ea typeface="맑은 고딕" panose="020B0503020000020004" pitchFamily="50" charset="-127"/>
                  <a:cs typeface="+mn-cs"/>
                </a:rPr>
                <a:t>Δ</a:t>
              </a:r>
              <a:r>
                <a:rPr kumimoji="0" lang="en-US" altLang="ko-KR" sz="900" b="0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+mj-lt"/>
                  <a:ea typeface="맑은 고딕" panose="020B0503020000020004" pitchFamily="50" charset="-127"/>
                  <a:cs typeface="+mn-cs"/>
                </a:rPr>
                <a:t>set1</a:t>
              </a:r>
              <a:r>
                <a:rPr kumimoji="0" lang="en-US" altLang="ko-KR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+mj-lt"/>
                  <a:ea typeface="맑은 고딕" panose="020B0503020000020004" pitchFamily="50" charset="-127"/>
                  <a:cs typeface="+mn-cs"/>
                </a:rPr>
                <a:t> #1</a:t>
              </a:r>
              <a:endParaRPr kumimoji="0" lang="ko-KR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j-lt"/>
                <a:ea typeface="맑은 고딕" panose="020B0503020000020004" pitchFamily="50" charset="-127"/>
                <a:cs typeface="+mn-cs"/>
              </a:endParaRPr>
            </a:p>
          </p:txBody>
        </p:sp>
        <p:sp>
          <p:nvSpPr>
            <p:cNvPr id="99" name="TextBox 214">
              <a:extLst>
                <a:ext uri="{FF2B5EF4-FFF2-40B4-BE49-F238E27FC236}">
                  <a16:creationId xmlns:a16="http://schemas.microsoft.com/office/drawing/2014/main" id="{EB02FC5E-925C-5351-F533-34C9C592BD23}"/>
                </a:ext>
              </a:extLst>
            </p:cNvPr>
            <p:cNvSpPr txBox="1"/>
            <p:nvPr/>
          </p:nvSpPr>
          <p:spPr>
            <a:xfrm>
              <a:off x="674954" y="6903980"/>
              <a:ext cx="78634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r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+mj-lt"/>
                  <a:ea typeface="맑은 고딕" panose="020B0503020000020004" pitchFamily="50" charset="-127"/>
                  <a:cs typeface="+mn-cs"/>
                </a:rPr>
                <a:t>Δ</a:t>
              </a:r>
              <a:r>
                <a:rPr kumimoji="0" lang="en-US" altLang="ko-KR" sz="900" b="0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+mj-lt"/>
                  <a:ea typeface="맑은 고딕" panose="020B0503020000020004" pitchFamily="50" charset="-127"/>
                  <a:cs typeface="+mn-cs"/>
                </a:rPr>
                <a:t>set1</a:t>
              </a:r>
              <a:r>
                <a:rPr kumimoji="0" lang="en-US" altLang="ko-KR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+mj-lt"/>
                  <a:ea typeface="맑은 고딕" panose="020B0503020000020004" pitchFamily="50" charset="-127"/>
                  <a:cs typeface="+mn-cs"/>
                </a:rPr>
                <a:t> #2</a:t>
              </a:r>
              <a:endParaRPr kumimoji="0" lang="ko-KR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j-lt"/>
                <a:ea typeface="맑은 고딕" panose="020B0503020000020004" pitchFamily="50" charset="-127"/>
                <a:cs typeface="+mn-cs"/>
              </a:endParaRPr>
            </a:p>
          </p:txBody>
        </p:sp>
        <p:sp>
          <p:nvSpPr>
            <p:cNvPr id="100" name="TextBox 214">
              <a:extLst>
                <a:ext uri="{FF2B5EF4-FFF2-40B4-BE49-F238E27FC236}">
                  <a16:creationId xmlns:a16="http://schemas.microsoft.com/office/drawing/2014/main" id="{25910AA6-7978-3979-2FB1-561F522E4121}"/>
                </a:ext>
              </a:extLst>
            </p:cNvPr>
            <p:cNvSpPr txBox="1"/>
            <p:nvPr/>
          </p:nvSpPr>
          <p:spPr>
            <a:xfrm>
              <a:off x="378952" y="7264230"/>
              <a:ext cx="10823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r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ko-KR" sz="900" noProof="0" dirty="0">
                  <a:solidFill>
                    <a:prstClr val="black"/>
                  </a:solidFill>
                  <a:latin typeface="+mj-lt"/>
                  <a:ea typeface="맑은 고딕" panose="020B0503020000020004" pitchFamily="50" charset="-127"/>
                </a:rPr>
                <a:t>Sen1over #1</a:t>
              </a:r>
              <a:endParaRPr kumimoji="0" lang="ko-KR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j-lt"/>
                <a:ea typeface="맑은 고딕" panose="020B0503020000020004" pitchFamily="50" charset="-127"/>
                <a:cs typeface="+mn-cs"/>
              </a:endParaRPr>
            </a:p>
          </p:txBody>
        </p:sp>
        <p:sp>
          <p:nvSpPr>
            <p:cNvPr id="104" name="TextBox 214">
              <a:extLst>
                <a:ext uri="{FF2B5EF4-FFF2-40B4-BE49-F238E27FC236}">
                  <a16:creationId xmlns:a16="http://schemas.microsoft.com/office/drawing/2014/main" id="{9348E57E-BD33-1807-F6FD-53BE806F8D41}"/>
                </a:ext>
              </a:extLst>
            </p:cNvPr>
            <p:cNvSpPr txBox="1"/>
            <p:nvPr/>
          </p:nvSpPr>
          <p:spPr>
            <a:xfrm>
              <a:off x="1078358" y="5102730"/>
              <a:ext cx="38294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r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+mj-lt"/>
                  <a:ea typeface="맑은 고딕" panose="020B0503020000020004" pitchFamily="50" charset="-127"/>
                  <a:cs typeface="+mn-cs"/>
                </a:rPr>
                <a:t>#1</a:t>
              </a:r>
              <a:endParaRPr kumimoji="0" lang="ko-KR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j-lt"/>
                <a:ea typeface="맑은 고딕" panose="020B0503020000020004" pitchFamily="50" charset="-127"/>
                <a:cs typeface="+mn-cs"/>
              </a:endParaRPr>
            </a:p>
          </p:txBody>
        </p:sp>
        <p:sp>
          <p:nvSpPr>
            <p:cNvPr id="110" name="TextBox 214">
              <a:extLst>
                <a:ext uri="{FF2B5EF4-FFF2-40B4-BE49-F238E27FC236}">
                  <a16:creationId xmlns:a16="http://schemas.microsoft.com/office/drawing/2014/main" id="{9091807C-2C07-E7CB-4A83-188CCC193027}"/>
                </a:ext>
              </a:extLst>
            </p:cNvPr>
            <p:cNvSpPr txBox="1"/>
            <p:nvPr/>
          </p:nvSpPr>
          <p:spPr>
            <a:xfrm>
              <a:off x="1046122" y="5462980"/>
              <a:ext cx="41517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 algn="r">
                <a:defRPr/>
              </a:pPr>
              <a:r>
                <a:rPr lang="en-US" altLang="ko-KR" sz="900" dirty="0">
                  <a:solidFill>
                    <a:prstClr val="black"/>
                  </a:solidFill>
                  <a:latin typeface="+mj-lt"/>
                  <a:ea typeface="맑은 고딕" panose="020B0503020000020004" pitchFamily="50" charset="-127"/>
                </a:rPr>
                <a:t>#2</a:t>
              </a:r>
              <a:endParaRPr lang="ko-KR" altLang="en-US" sz="900" dirty="0">
                <a:solidFill>
                  <a:prstClr val="black"/>
                </a:solidFill>
                <a:latin typeface="+mj-lt"/>
                <a:ea typeface="맑은 고딕" panose="020B0503020000020004" pitchFamily="50" charset="-127"/>
              </a:endParaRPr>
            </a:p>
          </p:txBody>
        </p:sp>
        <p:sp>
          <p:nvSpPr>
            <p:cNvPr id="114" name="TextBox 214">
              <a:extLst>
                <a:ext uri="{FF2B5EF4-FFF2-40B4-BE49-F238E27FC236}">
                  <a16:creationId xmlns:a16="http://schemas.microsoft.com/office/drawing/2014/main" id="{9348E57E-BD33-1807-F6FD-53BE806F8D41}"/>
                </a:ext>
              </a:extLst>
            </p:cNvPr>
            <p:cNvSpPr txBox="1"/>
            <p:nvPr/>
          </p:nvSpPr>
          <p:spPr>
            <a:xfrm>
              <a:off x="420153" y="7624483"/>
              <a:ext cx="104114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 algn="r">
                <a:defRPr/>
              </a:pPr>
              <a:r>
                <a:rPr lang="en-US" altLang="ko-KR" sz="900" dirty="0">
                  <a:solidFill>
                    <a:prstClr val="black"/>
                  </a:solidFill>
                  <a:latin typeface="+mj-lt"/>
                  <a:ea typeface="맑은 고딕" panose="020B0503020000020004" pitchFamily="50" charset="-127"/>
                </a:rPr>
                <a:t>Sen1over #2</a:t>
              </a:r>
              <a:endParaRPr lang="ko-KR" altLang="en-US" sz="900" dirty="0">
                <a:solidFill>
                  <a:prstClr val="black"/>
                </a:solidFill>
                <a:latin typeface="+mj-lt"/>
                <a:ea typeface="맑은 고딕" panose="020B0503020000020004" pitchFamily="50" charset="-127"/>
              </a:endParaRPr>
            </a:p>
          </p:txBody>
        </p:sp>
        <p:cxnSp>
          <p:nvCxnSpPr>
            <p:cNvPr id="120" name="직선 연결선 119"/>
            <p:cNvCxnSpPr/>
            <p:nvPr/>
          </p:nvCxnSpPr>
          <p:spPr>
            <a:xfrm flipH="1">
              <a:off x="1104482" y="5062472"/>
              <a:ext cx="0" cy="68400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3" name="TextBox 214">
              <a:extLst>
                <a:ext uri="{FF2B5EF4-FFF2-40B4-BE49-F238E27FC236}">
                  <a16:creationId xmlns:a16="http://schemas.microsoft.com/office/drawing/2014/main" id="{9348E57E-BD33-1807-F6FD-53BE806F8D41}"/>
                </a:ext>
              </a:extLst>
            </p:cNvPr>
            <p:cNvSpPr txBox="1"/>
            <p:nvPr/>
          </p:nvSpPr>
          <p:spPr>
            <a:xfrm>
              <a:off x="195402" y="5121332"/>
              <a:ext cx="933415" cy="5386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r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ko-KR" sz="1100" b="1" dirty="0">
                  <a:solidFill>
                    <a:prstClr val="black"/>
                  </a:solidFill>
                  <a:latin typeface="+mj-lt"/>
                  <a:ea typeface="맑은 고딕" panose="020B0503020000020004" pitchFamily="50" charset="-127"/>
                </a:rPr>
                <a:t>Sen1</a:t>
              </a:r>
              <a:endParaRPr lang="en-US" altLang="ko-KR" sz="1100" b="1" noProof="0" dirty="0">
                <a:solidFill>
                  <a:prstClr val="black"/>
                </a:solidFill>
                <a:latin typeface="+mj-lt"/>
                <a:ea typeface="맑은 고딕" panose="020B0503020000020004" pitchFamily="50" charset="-127"/>
              </a:endParaRPr>
            </a:p>
            <a:p>
              <a:pPr lvl="0" algn="r">
                <a:defRPr/>
              </a:pPr>
              <a:r>
                <a:rPr kumimoji="0" lang="en-US" altLang="ko-KR" sz="900" i="0" u="none" strike="noStrike" kern="1200" cap="none" spc="0" normalizeH="0" baseline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+mj-lt"/>
                  <a:ea typeface="맑은 고딕" panose="020B0503020000020004" pitchFamily="50" charset="-127"/>
                </a:rPr>
                <a:t>(Data</a:t>
              </a:r>
              <a:r>
                <a:rPr lang="en-US" altLang="ko-KR" sz="900" dirty="0">
                  <a:solidFill>
                    <a:prstClr val="black"/>
                  </a:solidFill>
                  <a:latin typeface="+mj-lt"/>
                  <a:ea typeface="맑은 고딕" panose="020B0503020000020004" pitchFamily="50" charset="-127"/>
                </a:rPr>
                <a:t> from</a:t>
              </a:r>
            </a:p>
            <a:p>
              <a:pPr lvl="0" algn="r">
                <a:defRPr/>
              </a:pPr>
              <a:r>
                <a:rPr lang="en-US" altLang="ko-KR" sz="900" dirty="0">
                  <a:solidFill>
                    <a:prstClr val="black"/>
                  </a:solidFill>
                  <a:latin typeface="+mj-lt"/>
                  <a:ea typeface="맑은 고딕" panose="020B0503020000020004" pitchFamily="50" charset="-127"/>
                </a:rPr>
                <a:t> GSE147927</a:t>
              </a:r>
              <a:r>
                <a:rPr kumimoji="0" lang="en-US" altLang="ko-KR" sz="900" i="0" u="none" strike="noStrike" kern="1200" cap="none" spc="0" normalizeH="0" baseline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+mj-lt"/>
                  <a:ea typeface="맑은 고딕" panose="020B0503020000020004" pitchFamily="50" charset="-127"/>
                </a:rPr>
                <a:t>)</a:t>
              </a:r>
              <a:endParaRPr kumimoji="0" lang="ko-KR" altLang="en-US" sz="9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j-lt"/>
                <a:ea typeface="맑은 고딕" panose="020B0503020000020004" pitchFamily="50" charset="-127"/>
              </a:endParaRPr>
            </a:p>
          </p:txBody>
        </p:sp>
        <p:cxnSp>
          <p:nvCxnSpPr>
            <p:cNvPr id="124" name="직선 연결선 123"/>
            <p:cNvCxnSpPr/>
            <p:nvPr/>
          </p:nvCxnSpPr>
          <p:spPr>
            <a:xfrm flipH="1">
              <a:off x="582934" y="5847521"/>
              <a:ext cx="0" cy="212400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5" name="TextBox 214">
              <a:extLst>
                <a:ext uri="{FF2B5EF4-FFF2-40B4-BE49-F238E27FC236}">
                  <a16:creationId xmlns:a16="http://schemas.microsoft.com/office/drawing/2014/main" id="{9348E57E-BD33-1807-F6FD-53BE806F8D41}"/>
                </a:ext>
              </a:extLst>
            </p:cNvPr>
            <p:cNvSpPr txBox="1"/>
            <p:nvPr/>
          </p:nvSpPr>
          <p:spPr>
            <a:xfrm>
              <a:off x="130345" y="6707391"/>
              <a:ext cx="48903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r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ko-KR" sz="1100" b="1" noProof="0" dirty="0">
                  <a:solidFill>
                    <a:prstClr val="black"/>
                  </a:solidFill>
                  <a:latin typeface="+mj-lt"/>
                  <a:ea typeface="맑은 고딕" panose="020B0503020000020004" pitchFamily="50" charset="-127"/>
                </a:rPr>
                <a:t>Set1</a:t>
              </a:r>
              <a:endParaRPr kumimoji="0" lang="ko-KR" alt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j-lt"/>
                <a:ea typeface="맑은 고딕" panose="020B0503020000020004" pitchFamily="50" charset="-127"/>
              </a:endParaRPr>
            </a:p>
          </p:txBody>
        </p:sp>
        <p:grpSp>
          <p:nvGrpSpPr>
            <p:cNvPr id="126" name="그룹 125"/>
            <p:cNvGrpSpPr/>
            <p:nvPr/>
          </p:nvGrpSpPr>
          <p:grpSpPr>
            <a:xfrm>
              <a:off x="1436366" y="5068753"/>
              <a:ext cx="375925" cy="2623414"/>
              <a:chOff x="3262708" y="294979"/>
              <a:chExt cx="375925" cy="2623414"/>
            </a:xfrm>
          </p:grpSpPr>
          <p:sp>
            <p:nvSpPr>
              <p:cNvPr id="185" name="TextBox 233">
                <a:extLst>
                  <a:ext uri="{FF2B5EF4-FFF2-40B4-BE49-F238E27FC236}">
                    <a16:creationId xmlns:a16="http://schemas.microsoft.com/office/drawing/2014/main" id="{B07837BD-4FDA-E6AC-7CC7-CFAE58350B58}"/>
                  </a:ext>
                </a:extLst>
              </p:cNvPr>
              <p:cNvSpPr txBox="1"/>
              <p:nvPr/>
            </p:nvSpPr>
            <p:spPr>
              <a:xfrm>
                <a:off x="3262708" y="294979"/>
                <a:ext cx="375925" cy="92333"/>
              </a:xfrm>
              <a:prstGeom prst="rect">
                <a:avLst/>
              </a:prstGeom>
              <a:solidFill>
                <a:sysClr val="window" lastClr="FFFFFF"/>
              </a:solidFill>
            </p:spPr>
            <p:txBody>
              <a:bodyPr wrap="square" lIns="0" tIns="0" rIns="0" bIns="0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+mj-lt"/>
                    <a:ea typeface="맑은 고딕" panose="020B0503020000020004" pitchFamily="50" charset="-127"/>
                    <a:cs typeface="+mn-cs"/>
                  </a:rPr>
                  <a:t>[0 – 1600]</a:t>
                </a:r>
                <a:endParaRPr kumimoji="0" lang="ko-KR" alt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+mj-lt"/>
                  <a:ea typeface="맑은 고딕" panose="020B0503020000020004" pitchFamily="50" charset="-127"/>
                  <a:cs typeface="+mn-cs"/>
                </a:endParaRPr>
              </a:p>
            </p:txBody>
          </p:sp>
          <p:sp>
            <p:nvSpPr>
              <p:cNvPr id="186" name="TextBox 233">
                <a:extLst>
                  <a:ext uri="{FF2B5EF4-FFF2-40B4-BE49-F238E27FC236}">
                    <a16:creationId xmlns:a16="http://schemas.microsoft.com/office/drawing/2014/main" id="{501E0E55-84FD-51E0-188F-77E90D74EFB5}"/>
                  </a:ext>
                </a:extLst>
              </p:cNvPr>
              <p:cNvSpPr txBox="1"/>
              <p:nvPr/>
            </p:nvSpPr>
            <p:spPr>
              <a:xfrm>
                <a:off x="3262708" y="656562"/>
                <a:ext cx="375925" cy="92333"/>
              </a:xfrm>
              <a:prstGeom prst="rect">
                <a:avLst/>
              </a:prstGeom>
              <a:solidFill>
                <a:sysClr val="window" lastClr="FFFFFF"/>
              </a:solidFill>
            </p:spPr>
            <p:txBody>
              <a:bodyPr wrap="square" lIns="0" tIns="0" rIns="0" bIns="0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+mj-lt"/>
                    <a:ea typeface="맑은 고딕" panose="020B0503020000020004" pitchFamily="50" charset="-127"/>
                    <a:cs typeface="+mn-cs"/>
                  </a:rPr>
                  <a:t>[0 – 200]</a:t>
                </a:r>
                <a:endParaRPr kumimoji="0" lang="ko-KR" alt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+mj-lt"/>
                  <a:ea typeface="맑은 고딕" panose="020B0503020000020004" pitchFamily="50" charset="-127"/>
                  <a:cs typeface="+mn-cs"/>
                </a:endParaRPr>
              </a:p>
            </p:txBody>
          </p:sp>
          <p:sp>
            <p:nvSpPr>
              <p:cNvPr id="187" name="TextBox 233">
                <a:extLst>
                  <a:ext uri="{FF2B5EF4-FFF2-40B4-BE49-F238E27FC236}">
                    <a16:creationId xmlns:a16="http://schemas.microsoft.com/office/drawing/2014/main" id="{319CD849-124C-5911-0F08-F525FBCD5E98}"/>
                  </a:ext>
                </a:extLst>
              </p:cNvPr>
              <p:cNvSpPr txBox="1"/>
              <p:nvPr/>
            </p:nvSpPr>
            <p:spPr>
              <a:xfrm>
                <a:off x="3262708" y="1018145"/>
                <a:ext cx="375925" cy="92333"/>
              </a:xfrm>
              <a:prstGeom prst="rect">
                <a:avLst/>
              </a:prstGeom>
              <a:solidFill>
                <a:sysClr val="window" lastClr="FFFFFF"/>
              </a:solidFill>
            </p:spPr>
            <p:txBody>
              <a:bodyPr wrap="square" lIns="0" tIns="0" rIns="0" bIns="0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+mj-lt"/>
                    <a:ea typeface="맑은 고딕" panose="020B0503020000020004" pitchFamily="50" charset="-127"/>
                    <a:cs typeface="+mn-cs"/>
                  </a:rPr>
                  <a:t>[0 – 700]</a:t>
                </a:r>
                <a:endParaRPr kumimoji="0" lang="ko-KR" alt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+mj-lt"/>
                  <a:ea typeface="맑은 고딕" panose="020B0503020000020004" pitchFamily="50" charset="-127"/>
                  <a:cs typeface="+mn-cs"/>
                </a:endParaRPr>
              </a:p>
            </p:txBody>
          </p:sp>
          <p:sp>
            <p:nvSpPr>
              <p:cNvPr id="188" name="TextBox 233">
                <a:extLst>
                  <a:ext uri="{FF2B5EF4-FFF2-40B4-BE49-F238E27FC236}">
                    <a16:creationId xmlns:a16="http://schemas.microsoft.com/office/drawing/2014/main" id="{B01CF175-FFD3-BD3B-DD67-8D398F710FF3}"/>
                  </a:ext>
                </a:extLst>
              </p:cNvPr>
              <p:cNvSpPr txBox="1"/>
              <p:nvPr/>
            </p:nvSpPr>
            <p:spPr>
              <a:xfrm>
                <a:off x="3262708" y="1379728"/>
                <a:ext cx="375925" cy="92333"/>
              </a:xfrm>
              <a:prstGeom prst="rect">
                <a:avLst/>
              </a:prstGeom>
              <a:solidFill>
                <a:sysClr val="window" lastClr="FFFFFF"/>
              </a:solidFill>
            </p:spPr>
            <p:txBody>
              <a:bodyPr wrap="square" lIns="0" tIns="0" rIns="0" bIns="0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+mj-lt"/>
                    <a:ea typeface="맑은 고딕" panose="020B0503020000020004" pitchFamily="50" charset="-127"/>
                    <a:cs typeface="+mn-cs"/>
                  </a:rPr>
                  <a:t>[0 – 700]</a:t>
                </a:r>
                <a:endParaRPr kumimoji="0" lang="ko-KR" alt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+mj-lt"/>
                  <a:ea typeface="맑은 고딕" panose="020B0503020000020004" pitchFamily="50" charset="-127"/>
                  <a:cs typeface="+mn-cs"/>
                </a:endParaRPr>
              </a:p>
            </p:txBody>
          </p:sp>
          <p:sp>
            <p:nvSpPr>
              <p:cNvPr id="189" name="TextBox 233">
                <a:extLst>
                  <a:ext uri="{FF2B5EF4-FFF2-40B4-BE49-F238E27FC236}">
                    <a16:creationId xmlns:a16="http://schemas.microsoft.com/office/drawing/2014/main" id="{FF12FF75-044C-8F67-04A2-65C51E1F1A64}"/>
                  </a:ext>
                </a:extLst>
              </p:cNvPr>
              <p:cNvSpPr txBox="1"/>
              <p:nvPr/>
            </p:nvSpPr>
            <p:spPr>
              <a:xfrm>
                <a:off x="3262708" y="1741311"/>
                <a:ext cx="375925" cy="92333"/>
              </a:xfrm>
              <a:prstGeom prst="rect">
                <a:avLst/>
              </a:prstGeom>
              <a:solidFill>
                <a:sysClr val="window" lastClr="FFFFFF"/>
              </a:solidFill>
            </p:spPr>
            <p:txBody>
              <a:bodyPr wrap="square" lIns="0" tIns="0" rIns="0" bIns="0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+mj-lt"/>
                    <a:ea typeface="맑은 고딕" panose="020B0503020000020004" pitchFamily="50" charset="-127"/>
                    <a:cs typeface="+mn-cs"/>
                  </a:rPr>
                  <a:t>[0 – 700]</a:t>
                </a:r>
                <a:endParaRPr kumimoji="0" lang="ko-KR" alt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+mj-lt"/>
                  <a:ea typeface="맑은 고딕" panose="020B0503020000020004" pitchFamily="50" charset="-127"/>
                  <a:cs typeface="+mn-cs"/>
                </a:endParaRPr>
              </a:p>
            </p:txBody>
          </p:sp>
          <p:sp>
            <p:nvSpPr>
              <p:cNvPr id="190" name="TextBox 233">
                <a:extLst>
                  <a:ext uri="{FF2B5EF4-FFF2-40B4-BE49-F238E27FC236}">
                    <a16:creationId xmlns:a16="http://schemas.microsoft.com/office/drawing/2014/main" id="{B07837BD-4FDA-E6AC-7CC7-CFAE58350B58}"/>
                  </a:ext>
                </a:extLst>
              </p:cNvPr>
              <p:cNvSpPr txBox="1"/>
              <p:nvPr/>
            </p:nvSpPr>
            <p:spPr>
              <a:xfrm>
                <a:off x="3262708" y="2102894"/>
                <a:ext cx="375925" cy="92333"/>
              </a:xfrm>
              <a:prstGeom prst="rect">
                <a:avLst/>
              </a:prstGeom>
              <a:solidFill>
                <a:sysClr val="window" lastClr="FFFFFF"/>
              </a:solidFill>
            </p:spPr>
            <p:txBody>
              <a:bodyPr wrap="square" lIns="0" tIns="0" rIns="0" bIns="0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+mj-lt"/>
                    <a:ea typeface="맑은 고딕" panose="020B0503020000020004" pitchFamily="50" charset="-127"/>
                    <a:cs typeface="+mn-cs"/>
                  </a:rPr>
                  <a:t>[0 – 700]</a:t>
                </a:r>
                <a:endParaRPr kumimoji="0" lang="ko-KR" alt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+mj-lt"/>
                  <a:ea typeface="맑은 고딕" panose="020B0503020000020004" pitchFamily="50" charset="-127"/>
                  <a:cs typeface="+mn-cs"/>
                </a:endParaRPr>
              </a:p>
            </p:txBody>
          </p:sp>
          <p:sp>
            <p:nvSpPr>
              <p:cNvPr id="191" name="TextBox 233">
                <a:extLst>
                  <a:ext uri="{FF2B5EF4-FFF2-40B4-BE49-F238E27FC236}">
                    <a16:creationId xmlns:a16="http://schemas.microsoft.com/office/drawing/2014/main" id="{501E0E55-84FD-51E0-188F-77E90D74EFB5}"/>
                  </a:ext>
                </a:extLst>
              </p:cNvPr>
              <p:cNvSpPr txBox="1"/>
              <p:nvPr/>
            </p:nvSpPr>
            <p:spPr>
              <a:xfrm>
                <a:off x="3262708" y="2464477"/>
                <a:ext cx="375925" cy="92333"/>
              </a:xfrm>
              <a:prstGeom prst="rect">
                <a:avLst/>
              </a:prstGeom>
              <a:solidFill>
                <a:sysClr val="window" lastClr="FFFFFF"/>
              </a:solidFill>
            </p:spPr>
            <p:txBody>
              <a:bodyPr wrap="square" lIns="0" tIns="0" rIns="0" bIns="0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+mj-lt"/>
                    <a:ea typeface="맑은 고딕" panose="020B0503020000020004" pitchFamily="50" charset="-127"/>
                    <a:cs typeface="+mn-cs"/>
                  </a:rPr>
                  <a:t>[0 – 700]</a:t>
                </a:r>
                <a:endParaRPr kumimoji="0" lang="ko-KR" alt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+mj-lt"/>
                  <a:ea typeface="맑은 고딕" panose="020B0503020000020004" pitchFamily="50" charset="-127"/>
                  <a:cs typeface="+mn-cs"/>
                </a:endParaRPr>
              </a:p>
            </p:txBody>
          </p:sp>
          <p:sp>
            <p:nvSpPr>
              <p:cNvPr id="192" name="TextBox 233">
                <a:extLst>
                  <a:ext uri="{FF2B5EF4-FFF2-40B4-BE49-F238E27FC236}">
                    <a16:creationId xmlns:a16="http://schemas.microsoft.com/office/drawing/2014/main" id="{319CD849-124C-5911-0F08-F525FBCD5E98}"/>
                  </a:ext>
                </a:extLst>
              </p:cNvPr>
              <p:cNvSpPr txBox="1"/>
              <p:nvPr/>
            </p:nvSpPr>
            <p:spPr>
              <a:xfrm>
                <a:off x="3262708" y="2826060"/>
                <a:ext cx="375925" cy="92333"/>
              </a:xfrm>
              <a:prstGeom prst="rect">
                <a:avLst/>
              </a:prstGeom>
              <a:solidFill>
                <a:sysClr val="window" lastClr="FFFFFF"/>
              </a:solidFill>
            </p:spPr>
            <p:txBody>
              <a:bodyPr wrap="square" lIns="0" tIns="0" rIns="0" bIns="0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+mj-lt"/>
                    <a:ea typeface="맑은 고딕" panose="020B0503020000020004" pitchFamily="50" charset="-127"/>
                    <a:cs typeface="+mn-cs"/>
                  </a:rPr>
                  <a:t>[0 – 700]</a:t>
                </a:r>
                <a:endParaRPr kumimoji="0" lang="ko-KR" alt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+mj-lt"/>
                  <a:ea typeface="맑은 고딕" panose="020B0503020000020004" pitchFamily="50" charset="-127"/>
                  <a:cs typeface="+mn-cs"/>
                </a:endParaRPr>
              </a:p>
            </p:txBody>
          </p:sp>
        </p:grpSp>
        <p:sp>
          <p:nvSpPr>
            <p:cNvPr id="130" name="오각형 129"/>
            <p:cNvSpPr/>
            <p:nvPr/>
          </p:nvSpPr>
          <p:spPr>
            <a:xfrm>
              <a:off x="3528076" y="7970725"/>
              <a:ext cx="639278" cy="106680"/>
            </a:xfrm>
            <a:prstGeom prst="homePlat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latin typeface="+mj-lt"/>
              </a:endParaRPr>
            </a:p>
          </p:txBody>
        </p:sp>
        <p:cxnSp>
          <p:nvCxnSpPr>
            <p:cNvPr id="139" name="직선 연결선 138"/>
            <p:cNvCxnSpPr/>
            <p:nvPr/>
          </p:nvCxnSpPr>
          <p:spPr>
            <a:xfrm>
              <a:off x="3331466" y="7946977"/>
              <a:ext cx="11196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1" name="TextBox 140">
              <a:extLst>
                <a:ext uri="{FF2B5EF4-FFF2-40B4-BE49-F238E27FC236}">
                  <a16:creationId xmlns:a16="http://schemas.microsoft.com/office/drawing/2014/main" id="{F4CB92FC-DDAB-9185-D5F4-957CD065747C}"/>
                </a:ext>
              </a:extLst>
            </p:cNvPr>
            <p:cNvSpPr txBox="1"/>
            <p:nvPr/>
          </p:nvSpPr>
          <p:spPr>
            <a:xfrm>
              <a:off x="3468229" y="8043250"/>
              <a:ext cx="66890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90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+mj-lt"/>
                </a:rPr>
                <a:t>PYK1</a:t>
              </a:r>
              <a:endParaRPr kumimoji="0" lang="ko-KR" altLang="en-US" sz="90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j-lt"/>
              </a:endParaRPr>
            </a:p>
          </p:txBody>
        </p:sp>
        <p:sp>
          <p:nvSpPr>
            <p:cNvPr id="143" name="오각형 142"/>
            <p:cNvSpPr/>
            <p:nvPr/>
          </p:nvSpPr>
          <p:spPr>
            <a:xfrm>
              <a:off x="4732035" y="7970725"/>
              <a:ext cx="1351113" cy="106680"/>
            </a:xfrm>
            <a:prstGeom prst="homePlat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latin typeface="+mj-lt"/>
              </a:endParaRPr>
            </a:p>
          </p:txBody>
        </p:sp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id="{F4CB92FC-DDAB-9185-D5F4-957CD065747C}"/>
                </a:ext>
              </a:extLst>
            </p:cNvPr>
            <p:cNvSpPr txBox="1"/>
            <p:nvPr/>
          </p:nvSpPr>
          <p:spPr>
            <a:xfrm>
              <a:off x="5087051" y="8043250"/>
              <a:ext cx="66890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ko-KR" sz="900" i="1" kern="0" dirty="0">
                  <a:solidFill>
                    <a:prstClr val="black"/>
                  </a:solidFill>
                  <a:latin typeface="+mj-lt"/>
                </a:rPr>
                <a:t>YEF3</a:t>
              </a:r>
              <a:endParaRPr kumimoji="0" lang="ko-KR" altLang="en-US" sz="90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j-lt"/>
              </a:endParaRPr>
            </a:p>
          </p:txBody>
        </p:sp>
        <p:pic>
          <p:nvPicPr>
            <p:cNvPr id="7" name="그림 6" descr="IGV - Session: C:\Users\JUNSOO\Desktop\Rad6_Swd2_BMCbiol_resubmission을위한 rawdata\Set1,CPF,H3K4me3_track.xml"/>
            <p:cNvPicPr>
              <a:picLocks/>
            </p:cNvPicPr>
            <p:nvPr/>
          </p:nvPicPr>
          <p:blipFill rotWithShape="1">
            <a:blip r:embed="rId10" cstate="print">
              <a:clrChange>
                <a:clrFrom>
                  <a:srgbClr val="FAFAFA"/>
                </a:clrFrom>
                <a:clrTo>
                  <a:srgbClr val="FAFAFA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091" t="25099" r="41022" b="29035"/>
            <a:stretch/>
          </p:blipFill>
          <p:spPr>
            <a:xfrm>
              <a:off x="4487787" y="5062472"/>
              <a:ext cx="2011680" cy="2880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pSp>
          <p:nvGrpSpPr>
            <p:cNvPr id="204" name="그룹 203"/>
            <p:cNvGrpSpPr/>
            <p:nvPr/>
          </p:nvGrpSpPr>
          <p:grpSpPr>
            <a:xfrm>
              <a:off x="4495346" y="5068753"/>
              <a:ext cx="375925" cy="2623414"/>
              <a:chOff x="3262708" y="294979"/>
              <a:chExt cx="375925" cy="2623414"/>
            </a:xfrm>
          </p:grpSpPr>
          <p:sp>
            <p:nvSpPr>
              <p:cNvPr id="205" name="TextBox 233">
                <a:extLst>
                  <a:ext uri="{FF2B5EF4-FFF2-40B4-BE49-F238E27FC236}">
                    <a16:creationId xmlns:a16="http://schemas.microsoft.com/office/drawing/2014/main" id="{B07837BD-4FDA-E6AC-7CC7-CFAE58350B58}"/>
                  </a:ext>
                </a:extLst>
              </p:cNvPr>
              <p:cNvSpPr txBox="1"/>
              <p:nvPr/>
            </p:nvSpPr>
            <p:spPr>
              <a:xfrm>
                <a:off x="3262708" y="294979"/>
                <a:ext cx="375925" cy="92333"/>
              </a:xfrm>
              <a:prstGeom prst="rect">
                <a:avLst/>
              </a:prstGeom>
              <a:solidFill>
                <a:sysClr val="window" lastClr="FFFFFF"/>
              </a:solidFill>
            </p:spPr>
            <p:txBody>
              <a:bodyPr wrap="square" lIns="0" tIns="0" rIns="0" bIns="0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+mj-lt"/>
                    <a:ea typeface="맑은 고딕" panose="020B0503020000020004" pitchFamily="50" charset="-127"/>
                    <a:cs typeface="+mn-cs"/>
                  </a:rPr>
                  <a:t>[0 – 1600]</a:t>
                </a:r>
                <a:endParaRPr kumimoji="0" lang="ko-KR" alt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+mj-lt"/>
                  <a:ea typeface="맑은 고딕" panose="020B0503020000020004" pitchFamily="50" charset="-127"/>
                  <a:cs typeface="+mn-cs"/>
                </a:endParaRPr>
              </a:p>
            </p:txBody>
          </p:sp>
          <p:sp>
            <p:nvSpPr>
              <p:cNvPr id="206" name="TextBox 233">
                <a:extLst>
                  <a:ext uri="{FF2B5EF4-FFF2-40B4-BE49-F238E27FC236}">
                    <a16:creationId xmlns:a16="http://schemas.microsoft.com/office/drawing/2014/main" id="{501E0E55-84FD-51E0-188F-77E90D74EFB5}"/>
                  </a:ext>
                </a:extLst>
              </p:cNvPr>
              <p:cNvSpPr txBox="1"/>
              <p:nvPr/>
            </p:nvSpPr>
            <p:spPr>
              <a:xfrm>
                <a:off x="3262708" y="656562"/>
                <a:ext cx="375925" cy="92333"/>
              </a:xfrm>
              <a:prstGeom prst="rect">
                <a:avLst/>
              </a:prstGeom>
              <a:solidFill>
                <a:sysClr val="window" lastClr="FFFFFF"/>
              </a:solidFill>
            </p:spPr>
            <p:txBody>
              <a:bodyPr wrap="square" lIns="0" tIns="0" rIns="0" bIns="0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+mj-lt"/>
                    <a:ea typeface="맑은 고딕" panose="020B0503020000020004" pitchFamily="50" charset="-127"/>
                    <a:cs typeface="+mn-cs"/>
                  </a:rPr>
                  <a:t>[0 – 200]</a:t>
                </a:r>
                <a:endParaRPr kumimoji="0" lang="ko-KR" alt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+mj-lt"/>
                  <a:ea typeface="맑은 고딕" panose="020B0503020000020004" pitchFamily="50" charset="-127"/>
                  <a:cs typeface="+mn-cs"/>
                </a:endParaRPr>
              </a:p>
            </p:txBody>
          </p:sp>
          <p:sp>
            <p:nvSpPr>
              <p:cNvPr id="207" name="TextBox 233">
                <a:extLst>
                  <a:ext uri="{FF2B5EF4-FFF2-40B4-BE49-F238E27FC236}">
                    <a16:creationId xmlns:a16="http://schemas.microsoft.com/office/drawing/2014/main" id="{319CD849-124C-5911-0F08-F525FBCD5E98}"/>
                  </a:ext>
                </a:extLst>
              </p:cNvPr>
              <p:cNvSpPr txBox="1"/>
              <p:nvPr/>
            </p:nvSpPr>
            <p:spPr>
              <a:xfrm>
                <a:off x="3262708" y="1018145"/>
                <a:ext cx="375925" cy="92333"/>
              </a:xfrm>
              <a:prstGeom prst="rect">
                <a:avLst/>
              </a:prstGeom>
              <a:solidFill>
                <a:sysClr val="window" lastClr="FFFFFF"/>
              </a:solidFill>
            </p:spPr>
            <p:txBody>
              <a:bodyPr wrap="square" lIns="0" tIns="0" rIns="0" bIns="0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+mj-lt"/>
                    <a:ea typeface="맑은 고딕" panose="020B0503020000020004" pitchFamily="50" charset="-127"/>
                    <a:cs typeface="+mn-cs"/>
                  </a:rPr>
                  <a:t>[0 – 700]</a:t>
                </a:r>
                <a:endParaRPr kumimoji="0" lang="ko-KR" alt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+mj-lt"/>
                  <a:ea typeface="맑은 고딕" panose="020B0503020000020004" pitchFamily="50" charset="-127"/>
                  <a:cs typeface="+mn-cs"/>
                </a:endParaRPr>
              </a:p>
            </p:txBody>
          </p:sp>
          <p:sp>
            <p:nvSpPr>
              <p:cNvPr id="208" name="TextBox 233">
                <a:extLst>
                  <a:ext uri="{FF2B5EF4-FFF2-40B4-BE49-F238E27FC236}">
                    <a16:creationId xmlns:a16="http://schemas.microsoft.com/office/drawing/2014/main" id="{B01CF175-FFD3-BD3B-DD67-8D398F710FF3}"/>
                  </a:ext>
                </a:extLst>
              </p:cNvPr>
              <p:cNvSpPr txBox="1"/>
              <p:nvPr/>
            </p:nvSpPr>
            <p:spPr>
              <a:xfrm>
                <a:off x="3262708" y="1379728"/>
                <a:ext cx="375925" cy="92333"/>
              </a:xfrm>
              <a:prstGeom prst="rect">
                <a:avLst/>
              </a:prstGeom>
              <a:solidFill>
                <a:sysClr val="window" lastClr="FFFFFF"/>
              </a:solidFill>
            </p:spPr>
            <p:txBody>
              <a:bodyPr wrap="square" lIns="0" tIns="0" rIns="0" bIns="0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+mj-lt"/>
                    <a:ea typeface="맑은 고딕" panose="020B0503020000020004" pitchFamily="50" charset="-127"/>
                    <a:cs typeface="+mn-cs"/>
                  </a:rPr>
                  <a:t>[0 – 700]</a:t>
                </a:r>
                <a:endParaRPr kumimoji="0" lang="ko-KR" alt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+mj-lt"/>
                  <a:ea typeface="맑은 고딕" panose="020B0503020000020004" pitchFamily="50" charset="-127"/>
                  <a:cs typeface="+mn-cs"/>
                </a:endParaRPr>
              </a:p>
            </p:txBody>
          </p:sp>
          <p:sp>
            <p:nvSpPr>
              <p:cNvPr id="209" name="TextBox 233">
                <a:extLst>
                  <a:ext uri="{FF2B5EF4-FFF2-40B4-BE49-F238E27FC236}">
                    <a16:creationId xmlns:a16="http://schemas.microsoft.com/office/drawing/2014/main" id="{FF12FF75-044C-8F67-04A2-65C51E1F1A64}"/>
                  </a:ext>
                </a:extLst>
              </p:cNvPr>
              <p:cNvSpPr txBox="1"/>
              <p:nvPr/>
            </p:nvSpPr>
            <p:spPr>
              <a:xfrm>
                <a:off x="3262708" y="1741311"/>
                <a:ext cx="375925" cy="92333"/>
              </a:xfrm>
              <a:prstGeom prst="rect">
                <a:avLst/>
              </a:prstGeom>
              <a:solidFill>
                <a:sysClr val="window" lastClr="FFFFFF"/>
              </a:solidFill>
            </p:spPr>
            <p:txBody>
              <a:bodyPr wrap="square" lIns="0" tIns="0" rIns="0" bIns="0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+mj-lt"/>
                    <a:ea typeface="맑은 고딕" panose="020B0503020000020004" pitchFamily="50" charset="-127"/>
                    <a:cs typeface="+mn-cs"/>
                  </a:rPr>
                  <a:t>[0 – 700]</a:t>
                </a:r>
                <a:endParaRPr kumimoji="0" lang="ko-KR" alt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+mj-lt"/>
                  <a:ea typeface="맑은 고딕" panose="020B0503020000020004" pitchFamily="50" charset="-127"/>
                  <a:cs typeface="+mn-cs"/>
                </a:endParaRPr>
              </a:p>
            </p:txBody>
          </p:sp>
          <p:sp>
            <p:nvSpPr>
              <p:cNvPr id="210" name="TextBox 233">
                <a:extLst>
                  <a:ext uri="{FF2B5EF4-FFF2-40B4-BE49-F238E27FC236}">
                    <a16:creationId xmlns:a16="http://schemas.microsoft.com/office/drawing/2014/main" id="{B07837BD-4FDA-E6AC-7CC7-CFAE58350B58}"/>
                  </a:ext>
                </a:extLst>
              </p:cNvPr>
              <p:cNvSpPr txBox="1"/>
              <p:nvPr/>
            </p:nvSpPr>
            <p:spPr>
              <a:xfrm>
                <a:off x="3262708" y="2102894"/>
                <a:ext cx="375925" cy="92333"/>
              </a:xfrm>
              <a:prstGeom prst="rect">
                <a:avLst/>
              </a:prstGeom>
              <a:solidFill>
                <a:sysClr val="window" lastClr="FFFFFF"/>
              </a:solidFill>
            </p:spPr>
            <p:txBody>
              <a:bodyPr wrap="square" lIns="0" tIns="0" rIns="0" bIns="0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+mj-lt"/>
                    <a:ea typeface="맑은 고딕" panose="020B0503020000020004" pitchFamily="50" charset="-127"/>
                    <a:cs typeface="+mn-cs"/>
                  </a:rPr>
                  <a:t>[0 – 700]</a:t>
                </a:r>
                <a:endParaRPr kumimoji="0" lang="ko-KR" alt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+mj-lt"/>
                  <a:ea typeface="맑은 고딕" panose="020B0503020000020004" pitchFamily="50" charset="-127"/>
                  <a:cs typeface="+mn-cs"/>
                </a:endParaRPr>
              </a:p>
            </p:txBody>
          </p:sp>
          <p:sp>
            <p:nvSpPr>
              <p:cNvPr id="211" name="TextBox 233">
                <a:extLst>
                  <a:ext uri="{FF2B5EF4-FFF2-40B4-BE49-F238E27FC236}">
                    <a16:creationId xmlns:a16="http://schemas.microsoft.com/office/drawing/2014/main" id="{501E0E55-84FD-51E0-188F-77E90D74EFB5}"/>
                  </a:ext>
                </a:extLst>
              </p:cNvPr>
              <p:cNvSpPr txBox="1"/>
              <p:nvPr/>
            </p:nvSpPr>
            <p:spPr>
              <a:xfrm>
                <a:off x="3262708" y="2464477"/>
                <a:ext cx="375925" cy="92333"/>
              </a:xfrm>
              <a:prstGeom prst="rect">
                <a:avLst/>
              </a:prstGeom>
              <a:solidFill>
                <a:sysClr val="window" lastClr="FFFFFF"/>
              </a:solidFill>
            </p:spPr>
            <p:txBody>
              <a:bodyPr wrap="square" lIns="0" tIns="0" rIns="0" bIns="0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+mj-lt"/>
                    <a:ea typeface="맑은 고딕" panose="020B0503020000020004" pitchFamily="50" charset="-127"/>
                    <a:cs typeface="+mn-cs"/>
                  </a:rPr>
                  <a:t>[0 – 700]</a:t>
                </a:r>
                <a:endParaRPr kumimoji="0" lang="ko-KR" alt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+mj-lt"/>
                  <a:ea typeface="맑은 고딕" panose="020B0503020000020004" pitchFamily="50" charset="-127"/>
                  <a:cs typeface="+mn-cs"/>
                </a:endParaRPr>
              </a:p>
            </p:txBody>
          </p:sp>
          <p:sp>
            <p:nvSpPr>
              <p:cNvPr id="212" name="TextBox 233">
                <a:extLst>
                  <a:ext uri="{FF2B5EF4-FFF2-40B4-BE49-F238E27FC236}">
                    <a16:creationId xmlns:a16="http://schemas.microsoft.com/office/drawing/2014/main" id="{319CD849-124C-5911-0F08-F525FBCD5E98}"/>
                  </a:ext>
                </a:extLst>
              </p:cNvPr>
              <p:cNvSpPr txBox="1"/>
              <p:nvPr/>
            </p:nvSpPr>
            <p:spPr>
              <a:xfrm>
                <a:off x="3262708" y="2826060"/>
                <a:ext cx="375925" cy="92333"/>
              </a:xfrm>
              <a:prstGeom prst="rect">
                <a:avLst/>
              </a:prstGeom>
              <a:solidFill>
                <a:sysClr val="window" lastClr="FFFFFF"/>
              </a:solidFill>
            </p:spPr>
            <p:txBody>
              <a:bodyPr wrap="square" lIns="0" tIns="0" rIns="0" bIns="0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+mj-lt"/>
                    <a:ea typeface="맑은 고딕" panose="020B0503020000020004" pitchFamily="50" charset="-127"/>
                    <a:cs typeface="+mn-cs"/>
                  </a:rPr>
                  <a:t>[0 – 700]</a:t>
                </a:r>
                <a:endParaRPr kumimoji="0" lang="ko-KR" alt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+mj-lt"/>
                  <a:ea typeface="맑은 고딕" panose="020B0503020000020004" pitchFamily="50" charset="-127"/>
                  <a:cs typeface="+mn-cs"/>
                </a:endParaRPr>
              </a:p>
            </p:txBody>
          </p:sp>
        </p:grpSp>
        <p:grpSp>
          <p:nvGrpSpPr>
            <p:cNvPr id="213" name="그룹 212"/>
            <p:cNvGrpSpPr/>
            <p:nvPr/>
          </p:nvGrpSpPr>
          <p:grpSpPr>
            <a:xfrm>
              <a:off x="3342916" y="5068753"/>
              <a:ext cx="375925" cy="2623414"/>
              <a:chOff x="3262708" y="294979"/>
              <a:chExt cx="375925" cy="2623414"/>
            </a:xfrm>
          </p:grpSpPr>
          <p:sp>
            <p:nvSpPr>
              <p:cNvPr id="214" name="TextBox 233">
                <a:extLst>
                  <a:ext uri="{FF2B5EF4-FFF2-40B4-BE49-F238E27FC236}">
                    <a16:creationId xmlns:a16="http://schemas.microsoft.com/office/drawing/2014/main" id="{B07837BD-4FDA-E6AC-7CC7-CFAE58350B58}"/>
                  </a:ext>
                </a:extLst>
              </p:cNvPr>
              <p:cNvSpPr txBox="1"/>
              <p:nvPr/>
            </p:nvSpPr>
            <p:spPr>
              <a:xfrm>
                <a:off x="3262708" y="294979"/>
                <a:ext cx="375925" cy="92333"/>
              </a:xfrm>
              <a:prstGeom prst="rect">
                <a:avLst/>
              </a:prstGeom>
              <a:solidFill>
                <a:sysClr val="window" lastClr="FFFFFF"/>
              </a:solidFill>
            </p:spPr>
            <p:txBody>
              <a:bodyPr wrap="square" lIns="0" tIns="0" rIns="0" bIns="0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+mj-lt"/>
                    <a:ea typeface="맑은 고딕" panose="020B0503020000020004" pitchFamily="50" charset="-127"/>
                    <a:cs typeface="+mn-cs"/>
                  </a:rPr>
                  <a:t>[0 – 1600]</a:t>
                </a:r>
                <a:endParaRPr kumimoji="0" lang="ko-KR" alt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+mj-lt"/>
                  <a:ea typeface="맑은 고딕" panose="020B0503020000020004" pitchFamily="50" charset="-127"/>
                  <a:cs typeface="+mn-cs"/>
                </a:endParaRPr>
              </a:p>
            </p:txBody>
          </p:sp>
          <p:sp>
            <p:nvSpPr>
              <p:cNvPr id="215" name="TextBox 233">
                <a:extLst>
                  <a:ext uri="{FF2B5EF4-FFF2-40B4-BE49-F238E27FC236}">
                    <a16:creationId xmlns:a16="http://schemas.microsoft.com/office/drawing/2014/main" id="{501E0E55-84FD-51E0-188F-77E90D74EFB5}"/>
                  </a:ext>
                </a:extLst>
              </p:cNvPr>
              <p:cNvSpPr txBox="1"/>
              <p:nvPr/>
            </p:nvSpPr>
            <p:spPr>
              <a:xfrm>
                <a:off x="3262708" y="656562"/>
                <a:ext cx="375925" cy="92333"/>
              </a:xfrm>
              <a:prstGeom prst="rect">
                <a:avLst/>
              </a:prstGeom>
              <a:solidFill>
                <a:sysClr val="window" lastClr="FFFFFF"/>
              </a:solidFill>
            </p:spPr>
            <p:txBody>
              <a:bodyPr wrap="square" lIns="0" tIns="0" rIns="0" bIns="0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+mj-lt"/>
                    <a:ea typeface="맑은 고딕" panose="020B0503020000020004" pitchFamily="50" charset="-127"/>
                    <a:cs typeface="+mn-cs"/>
                  </a:rPr>
                  <a:t>[0 – 200]</a:t>
                </a:r>
                <a:endParaRPr kumimoji="0" lang="ko-KR" alt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+mj-lt"/>
                  <a:ea typeface="맑은 고딕" panose="020B0503020000020004" pitchFamily="50" charset="-127"/>
                  <a:cs typeface="+mn-cs"/>
                </a:endParaRPr>
              </a:p>
            </p:txBody>
          </p:sp>
          <p:sp>
            <p:nvSpPr>
              <p:cNvPr id="216" name="TextBox 233">
                <a:extLst>
                  <a:ext uri="{FF2B5EF4-FFF2-40B4-BE49-F238E27FC236}">
                    <a16:creationId xmlns:a16="http://schemas.microsoft.com/office/drawing/2014/main" id="{319CD849-124C-5911-0F08-F525FBCD5E98}"/>
                  </a:ext>
                </a:extLst>
              </p:cNvPr>
              <p:cNvSpPr txBox="1"/>
              <p:nvPr/>
            </p:nvSpPr>
            <p:spPr>
              <a:xfrm>
                <a:off x="3262708" y="1018145"/>
                <a:ext cx="375925" cy="92333"/>
              </a:xfrm>
              <a:prstGeom prst="rect">
                <a:avLst/>
              </a:prstGeom>
              <a:solidFill>
                <a:sysClr val="window" lastClr="FFFFFF"/>
              </a:solidFill>
            </p:spPr>
            <p:txBody>
              <a:bodyPr wrap="square" lIns="0" tIns="0" rIns="0" bIns="0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+mj-lt"/>
                    <a:ea typeface="맑은 고딕" panose="020B0503020000020004" pitchFamily="50" charset="-127"/>
                    <a:cs typeface="+mn-cs"/>
                  </a:rPr>
                  <a:t>[0 – 700]</a:t>
                </a:r>
                <a:endParaRPr kumimoji="0" lang="ko-KR" alt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+mj-lt"/>
                  <a:ea typeface="맑은 고딕" panose="020B0503020000020004" pitchFamily="50" charset="-127"/>
                  <a:cs typeface="+mn-cs"/>
                </a:endParaRPr>
              </a:p>
            </p:txBody>
          </p:sp>
          <p:sp>
            <p:nvSpPr>
              <p:cNvPr id="217" name="TextBox 233">
                <a:extLst>
                  <a:ext uri="{FF2B5EF4-FFF2-40B4-BE49-F238E27FC236}">
                    <a16:creationId xmlns:a16="http://schemas.microsoft.com/office/drawing/2014/main" id="{B01CF175-FFD3-BD3B-DD67-8D398F710FF3}"/>
                  </a:ext>
                </a:extLst>
              </p:cNvPr>
              <p:cNvSpPr txBox="1"/>
              <p:nvPr/>
            </p:nvSpPr>
            <p:spPr>
              <a:xfrm>
                <a:off x="3262708" y="1379728"/>
                <a:ext cx="375925" cy="92333"/>
              </a:xfrm>
              <a:prstGeom prst="rect">
                <a:avLst/>
              </a:prstGeom>
              <a:solidFill>
                <a:sysClr val="window" lastClr="FFFFFF"/>
              </a:solidFill>
            </p:spPr>
            <p:txBody>
              <a:bodyPr wrap="square" lIns="0" tIns="0" rIns="0" bIns="0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+mj-lt"/>
                    <a:ea typeface="맑은 고딕" panose="020B0503020000020004" pitchFamily="50" charset="-127"/>
                    <a:cs typeface="+mn-cs"/>
                  </a:rPr>
                  <a:t>[0 – 700]</a:t>
                </a:r>
                <a:endParaRPr kumimoji="0" lang="ko-KR" alt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+mj-lt"/>
                  <a:ea typeface="맑은 고딕" panose="020B0503020000020004" pitchFamily="50" charset="-127"/>
                  <a:cs typeface="+mn-cs"/>
                </a:endParaRPr>
              </a:p>
            </p:txBody>
          </p:sp>
          <p:sp>
            <p:nvSpPr>
              <p:cNvPr id="218" name="TextBox 233">
                <a:extLst>
                  <a:ext uri="{FF2B5EF4-FFF2-40B4-BE49-F238E27FC236}">
                    <a16:creationId xmlns:a16="http://schemas.microsoft.com/office/drawing/2014/main" id="{FF12FF75-044C-8F67-04A2-65C51E1F1A64}"/>
                  </a:ext>
                </a:extLst>
              </p:cNvPr>
              <p:cNvSpPr txBox="1"/>
              <p:nvPr/>
            </p:nvSpPr>
            <p:spPr>
              <a:xfrm>
                <a:off x="3262708" y="1741311"/>
                <a:ext cx="375925" cy="92333"/>
              </a:xfrm>
              <a:prstGeom prst="rect">
                <a:avLst/>
              </a:prstGeom>
              <a:solidFill>
                <a:sysClr val="window" lastClr="FFFFFF"/>
              </a:solidFill>
            </p:spPr>
            <p:txBody>
              <a:bodyPr wrap="square" lIns="0" tIns="0" rIns="0" bIns="0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+mj-lt"/>
                    <a:ea typeface="맑은 고딕" panose="020B0503020000020004" pitchFamily="50" charset="-127"/>
                    <a:cs typeface="+mn-cs"/>
                  </a:rPr>
                  <a:t>[0 – 700]</a:t>
                </a:r>
                <a:endParaRPr kumimoji="0" lang="ko-KR" alt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+mj-lt"/>
                  <a:ea typeface="맑은 고딕" panose="020B0503020000020004" pitchFamily="50" charset="-127"/>
                  <a:cs typeface="+mn-cs"/>
                </a:endParaRPr>
              </a:p>
            </p:txBody>
          </p:sp>
          <p:sp>
            <p:nvSpPr>
              <p:cNvPr id="219" name="TextBox 233">
                <a:extLst>
                  <a:ext uri="{FF2B5EF4-FFF2-40B4-BE49-F238E27FC236}">
                    <a16:creationId xmlns:a16="http://schemas.microsoft.com/office/drawing/2014/main" id="{B07837BD-4FDA-E6AC-7CC7-CFAE58350B58}"/>
                  </a:ext>
                </a:extLst>
              </p:cNvPr>
              <p:cNvSpPr txBox="1"/>
              <p:nvPr/>
            </p:nvSpPr>
            <p:spPr>
              <a:xfrm>
                <a:off x="3262708" y="2102894"/>
                <a:ext cx="375925" cy="92333"/>
              </a:xfrm>
              <a:prstGeom prst="rect">
                <a:avLst/>
              </a:prstGeom>
              <a:solidFill>
                <a:sysClr val="window" lastClr="FFFFFF"/>
              </a:solidFill>
            </p:spPr>
            <p:txBody>
              <a:bodyPr wrap="square" lIns="0" tIns="0" rIns="0" bIns="0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+mj-lt"/>
                    <a:ea typeface="맑은 고딕" panose="020B0503020000020004" pitchFamily="50" charset="-127"/>
                    <a:cs typeface="+mn-cs"/>
                  </a:rPr>
                  <a:t>[0 – 700]</a:t>
                </a:r>
                <a:endParaRPr kumimoji="0" lang="ko-KR" alt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+mj-lt"/>
                  <a:ea typeface="맑은 고딕" panose="020B0503020000020004" pitchFamily="50" charset="-127"/>
                  <a:cs typeface="+mn-cs"/>
                </a:endParaRPr>
              </a:p>
            </p:txBody>
          </p:sp>
          <p:sp>
            <p:nvSpPr>
              <p:cNvPr id="220" name="TextBox 233">
                <a:extLst>
                  <a:ext uri="{FF2B5EF4-FFF2-40B4-BE49-F238E27FC236}">
                    <a16:creationId xmlns:a16="http://schemas.microsoft.com/office/drawing/2014/main" id="{501E0E55-84FD-51E0-188F-77E90D74EFB5}"/>
                  </a:ext>
                </a:extLst>
              </p:cNvPr>
              <p:cNvSpPr txBox="1"/>
              <p:nvPr/>
            </p:nvSpPr>
            <p:spPr>
              <a:xfrm>
                <a:off x="3262708" y="2464477"/>
                <a:ext cx="375925" cy="92333"/>
              </a:xfrm>
              <a:prstGeom prst="rect">
                <a:avLst/>
              </a:prstGeom>
              <a:solidFill>
                <a:sysClr val="window" lastClr="FFFFFF"/>
              </a:solidFill>
            </p:spPr>
            <p:txBody>
              <a:bodyPr wrap="square" lIns="0" tIns="0" rIns="0" bIns="0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+mj-lt"/>
                    <a:ea typeface="맑은 고딕" panose="020B0503020000020004" pitchFamily="50" charset="-127"/>
                    <a:cs typeface="+mn-cs"/>
                  </a:rPr>
                  <a:t>[0 – 700]</a:t>
                </a:r>
                <a:endParaRPr kumimoji="0" lang="ko-KR" alt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+mj-lt"/>
                  <a:ea typeface="맑은 고딕" panose="020B0503020000020004" pitchFamily="50" charset="-127"/>
                  <a:cs typeface="+mn-cs"/>
                </a:endParaRPr>
              </a:p>
            </p:txBody>
          </p:sp>
          <p:sp>
            <p:nvSpPr>
              <p:cNvPr id="221" name="TextBox 233">
                <a:extLst>
                  <a:ext uri="{FF2B5EF4-FFF2-40B4-BE49-F238E27FC236}">
                    <a16:creationId xmlns:a16="http://schemas.microsoft.com/office/drawing/2014/main" id="{319CD849-124C-5911-0F08-F525FBCD5E98}"/>
                  </a:ext>
                </a:extLst>
              </p:cNvPr>
              <p:cNvSpPr txBox="1"/>
              <p:nvPr/>
            </p:nvSpPr>
            <p:spPr>
              <a:xfrm>
                <a:off x="3262708" y="2826060"/>
                <a:ext cx="375925" cy="92333"/>
              </a:xfrm>
              <a:prstGeom prst="rect">
                <a:avLst/>
              </a:prstGeom>
              <a:solidFill>
                <a:sysClr val="window" lastClr="FFFFFF"/>
              </a:solidFill>
            </p:spPr>
            <p:txBody>
              <a:bodyPr wrap="square" lIns="0" tIns="0" rIns="0" bIns="0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+mj-lt"/>
                    <a:ea typeface="맑은 고딕" panose="020B0503020000020004" pitchFamily="50" charset="-127"/>
                    <a:cs typeface="+mn-cs"/>
                  </a:rPr>
                  <a:t>[0 – 700]</a:t>
                </a:r>
                <a:endParaRPr kumimoji="0" lang="ko-KR" alt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+mj-lt"/>
                  <a:ea typeface="맑은 고딕" panose="020B0503020000020004" pitchFamily="50" charset="-127"/>
                  <a:cs typeface="+mn-cs"/>
                </a:endParaRPr>
              </a:p>
            </p:txBody>
          </p:sp>
        </p:grpSp>
      </p:grpSp>
      <p:pic>
        <p:nvPicPr>
          <p:cNvPr id="9" name="그림 8">
            <a:extLst>
              <a:ext uri="{FF2B5EF4-FFF2-40B4-BE49-F238E27FC236}">
                <a16:creationId xmlns:a16="http://schemas.microsoft.com/office/drawing/2014/main" id="{CACB317D-37A7-E9C3-28EF-FA02480ACD99}"/>
              </a:ext>
            </a:extLst>
          </p:cNvPr>
          <p:cNvPicPr>
            <a:picLocks/>
          </p:cNvPicPr>
          <p:nvPr/>
        </p:nvPicPr>
        <p:blipFill rotWithShape="1">
          <a:blip r:embed="rId11"/>
          <a:srcRect r="80274"/>
          <a:stretch/>
        </p:blipFill>
        <p:spPr>
          <a:xfrm>
            <a:off x="5384971" y="1866956"/>
            <a:ext cx="72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6" name="TextBox 115"/>
          <p:cNvSpPr txBox="1"/>
          <p:nvPr/>
        </p:nvSpPr>
        <p:spPr bwMode="auto">
          <a:xfrm>
            <a:off x="-9067" y="45652"/>
            <a:ext cx="378498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altLang="ko-KR" b="1" dirty="0">
                <a:latin typeface="+mj-lt"/>
                <a:cs typeface="Arial" panose="020B0604020202020204" pitchFamily="34" charset="0"/>
              </a:rPr>
              <a:t>Additional file Figure S2</a:t>
            </a:r>
            <a:endParaRPr lang="ko-KR" altLang="en-US" b="1" dirty="0">
              <a:latin typeface="+mj-lt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534910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그룹 2">
            <a:extLst>
              <a:ext uri="{FF2B5EF4-FFF2-40B4-BE49-F238E27FC236}">
                <a16:creationId xmlns:a16="http://schemas.microsoft.com/office/drawing/2014/main" id="{B6192DEF-F526-4E23-81FB-49EBC84EDE0A}"/>
              </a:ext>
            </a:extLst>
          </p:cNvPr>
          <p:cNvGrpSpPr/>
          <p:nvPr/>
        </p:nvGrpSpPr>
        <p:grpSpPr>
          <a:xfrm>
            <a:off x="1375043" y="858510"/>
            <a:ext cx="3452174" cy="3647356"/>
            <a:chOff x="1375043" y="858510"/>
            <a:chExt cx="3452174" cy="3647356"/>
          </a:xfrm>
        </p:grpSpPr>
        <p:pic>
          <p:nvPicPr>
            <p:cNvPr id="175" name="그림 174"/>
            <p:cNvPicPr>
              <a:picLocks/>
            </p:cNvPicPr>
            <p:nvPr/>
          </p:nvPicPr>
          <p:blipFill rotWithShape="1">
            <a:blip r:embed="rId2"/>
            <a:srcRect r="80192"/>
            <a:stretch/>
          </p:blipFill>
          <p:spPr>
            <a:xfrm>
              <a:off x="1689685" y="1445885"/>
              <a:ext cx="720000" cy="2160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76" name="그림 175"/>
            <p:cNvPicPr>
              <a:picLocks/>
            </p:cNvPicPr>
            <p:nvPr/>
          </p:nvPicPr>
          <p:blipFill rotWithShape="1">
            <a:blip r:embed="rId2"/>
            <a:srcRect l="53610" r="26602"/>
            <a:stretch/>
          </p:blipFill>
          <p:spPr>
            <a:xfrm>
              <a:off x="3240236" y="1445885"/>
              <a:ext cx="720000" cy="2160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77" name="그림 176"/>
            <p:cNvPicPr>
              <a:picLocks/>
            </p:cNvPicPr>
            <p:nvPr/>
          </p:nvPicPr>
          <p:blipFill rotWithShape="1">
            <a:blip r:embed="rId2"/>
            <a:srcRect l="26825" r="53534"/>
            <a:stretch/>
          </p:blipFill>
          <p:spPr>
            <a:xfrm>
              <a:off x="2462114" y="1445885"/>
              <a:ext cx="720000" cy="2160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78" name="그림 177"/>
            <p:cNvPicPr>
              <a:picLocks/>
            </p:cNvPicPr>
            <p:nvPr/>
          </p:nvPicPr>
          <p:blipFill rotWithShape="1">
            <a:blip r:embed="rId2"/>
            <a:srcRect l="80309"/>
            <a:stretch/>
          </p:blipFill>
          <p:spPr>
            <a:xfrm>
              <a:off x="4033654" y="1445885"/>
              <a:ext cx="720000" cy="2160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79" name="TextBox 178"/>
            <p:cNvSpPr txBox="1"/>
            <p:nvPr/>
          </p:nvSpPr>
          <p:spPr>
            <a:xfrm rot="16200000">
              <a:off x="1033968" y="2459784"/>
              <a:ext cx="89759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cs typeface="Helvetica" panose="020B0604020202020204" pitchFamily="34" charset="0"/>
                </a:rPr>
                <a:t>Gene length</a:t>
              </a:r>
            </a:p>
          </p:txBody>
        </p:sp>
        <p:sp>
          <p:nvSpPr>
            <p:cNvPr id="180" name="이등변 삼각형 179"/>
            <p:cNvSpPr/>
            <p:nvPr/>
          </p:nvSpPr>
          <p:spPr>
            <a:xfrm>
              <a:off x="1581904" y="1473569"/>
              <a:ext cx="78937" cy="2160000"/>
            </a:xfrm>
            <a:prstGeom prst="triangle">
              <a:avLst>
                <a:gd name="adj" fmla="val 98484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2000" dirty="0"/>
            </a:p>
          </p:txBody>
        </p:sp>
        <p:pic>
          <p:nvPicPr>
            <p:cNvPr id="218" name="그림 217"/>
            <p:cNvPicPr>
              <a:picLocks/>
            </p:cNvPicPr>
            <p:nvPr/>
          </p:nvPicPr>
          <p:blipFill rotWithShape="1">
            <a:blip r:embed="rId3"/>
            <a:srcRect t="95814" b="2247"/>
            <a:stretch/>
          </p:blipFill>
          <p:spPr>
            <a:xfrm>
              <a:off x="4028458" y="3617200"/>
              <a:ext cx="720000" cy="48589"/>
            </a:xfrm>
            <a:prstGeom prst="rect">
              <a:avLst/>
            </a:prstGeom>
            <a:ln w="6350">
              <a:noFill/>
            </a:ln>
          </p:spPr>
        </p:pic>
        <p:sp>
          <p:nvSpPr>
            <p:cNvPr id="220" name="TextBox 219"/>
            <p:cNvSpPr txBox="1"/>
            <p:nvPr/>
          </p:nvSpPr>
          <p:spPr>
            <a:xfrm>
              <a:off x="4341305" y="3606676"/>
              <a:ext cx="46296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600" dirty="0">
                  <a:cs typeface="Arial" panose="020B0604020202020204" pitchFamily="34" charset="0"/>
                </a:rPr>
                <a:t>1500 bp</a:t>
              </a:r>
              <a:endParaRPr lang="ko-KR" altLang="en-US" sz="600" i="1" dirty="0">
                <a:cs typeface="Arial" panose="020B0604020202020204" pitchFamily="34" charset="0"/>
              </a:endParaRPr>
            </a:p>
          </p:txBody>
        </p:sp>
        <p:sp>
          <p:nvSpPr>
            <p:cNvPr id="221" name="TextBox 214"/>
            <p:cNvSpPr txBox="1"/>
            <p:nvPr/>
          </p:nvSpPr>
          <p:spPr>
            <a:xfrm>
              <a:off x="4214114" y="3677881"/>
              <a:ext cx="38863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700" dirty="0"/>
                <a:t>TSS</a:t>
              </a:r>
              <a:endParaRPr lang="ko-KR" altLang="en-US" sz="700" dirty="0"/>
            </a:p>
          </p:txBody>
        </p:sp>
        <p:sp>
          <p:nvSpPr>
            <p:cNvPr id="184" name="TextBox 183"/>
            <p:cNvSpPr txBox="1"/>
            <p:nvPr/>
          </p:nvSpPr>
          <p:spPr>
            <a:xfrm>
              <a:off x="4044760" y="1258871"/>
              <a:ext cx="71735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dirty="0">
                  <a:cs typeface="Helvetica" panose="020B0604020202020204" pitchFamily="34" charset="0"/>
                </a:rPr>
                <a:t>Ref2</a:t>
              </a:r>
            </a:p>
          </p:txBody>
        </p:sp>
        <p:sp>
          <p:nvSpPr>
            <p:cNvPr id="185" name="TextBox 184"/>
            <p:cNvSpPr txBox="1"/>
            <p:nvPr/>
          </p:nvSpPr>
          <p:spPr>
            <a:xfrm>
              <a:off x="3170288" y="1258871"/>
              <a:ext cx="89424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dirty="0">
                  <a:cs typeface="Helvetica" panose="020B0604020202020204" pitchFamily="34" charset="0"/>
                </a:rPr>
                <a:t>Pap1</a:t>
              </a:r>
              <a:endParaRPr lang="ko-KR" altLang="en-US" sz="800" i="1" dirty="0">
                <a:cs typeface="Helvetica" panose="020B0604020202020204" pitchFamily="34" charset="0"/>
              </a:endParaRPr>
            </a:p>
          </p:txBody>
        </p:sp>
        <p:pic>
          <p:nvPicPr>
            <p:cNvPr id="188" name="그림 187"/>
            <p:cNvPicPr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241542" y="3815074"/>
              <a:ext cx="237744" cy="4572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14" name="그림 213"/>
            <p:cNvPicPr>
              <a:picLocks/>
            </p:cNvPicPr>
            <p:nvPr/>
          </p:nvPicPr>
          <p:blipFill rotWithShape="1">
            <a:blip r:embed="rId3"/>
            <a:srcRect t="95814" b="2247"/>
            <a:stretch/>
          </p:blipFill>
          <p:spPr>
            <a:xfrm>
              <a:off x="3231406" y="3617200"/>
              <a:ext cx="720000" cy="48589"/>
            </a:xfrm>
            <a:prstGeom prst="rect">
              <a:avLst/>
            </a:prstGeom>
            <a:ln w="6350">
              <a:noFill/>
            </a:ln>
          </p:spPr>
        </p:pic>
        <p:sp>
          <p:nvSpPr>
            <p:cNvPr id="216" name="TextBox 215"/>
            <p:cNvSpPr txBox="1"/>
            <p:nvPr/>
          </p:nvSpPr>
          <p:spPr>
            <a:xfrm>
              <a:off x="3544253" y="3606676"/>
              <a:ext cx="46296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600" dirty="0">
                  <a:cs typeface="Arial" panose="020B0604020202020204" pitchFamily="34" charset="0"/>
                </a:rPr>
                <a:t>1500 bp</a:t>
              </a:r>
              <a:endParaRPr lang="ko-KR" altLang="en-US" sz="600" i="1" dirty="0">
                <a:cs typeface="Arial" panose="020B0604020202020204" pitchFamily="34" charset="0"/>
              </a:endParaRPr>
            </a:p>
          </p:txBody>
        </p:sp>
        <p:sp>
          <p:nvSpPr>
            <p:cNvPr id="217" name="TextBox 214"/>
            <p:cNvSpPr txBox="1"/>
            <p:nvPr/>
          </p:nvSpPr>
          <p:spPr>
            <a:xfrm>
              <a:off x="3417062" y="3677881"/>
              <a:ext cx="38863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700" dirty="0"/>
                <a:t>TSS</a:t>
              </a:r>
              <a:endParaRPr lang="ko-KR" altLang="en-US" sz="700" dirty="0"/>
            </a:p>
          </p:txBody>
        </p:sp>
        <p:pic>
          <p:nvPicPr>
            <p:cNvPr id="190" name="그림 189"/>
            <p:cNvPicPr>
              <a:picLocks/>
            </p:cNvPicPr>
            <p:nvPr/>
          </p:nvPicPr>
          <p:blipFill rotWithShape="1">
            <a:blip r:embed="rId3"/>
            <a:srcRect t="95814" b="2247"/>
            <a:stretch/>
          </p:blipFill>
          <p:spPr>
            <a:xfrm>
              <a:off x="1689685" y="3617200"/>
              <a:ext cx="720000" cy="48589"/>
            </a:xfrm>
            <a:prstGeom prst="rect">
              <a:avLst/>
            </a:prstGeom>
            <a:ln w="6350">
              <a:noFill/>
            </a:ln>
          </p:spPr>
        </p:pic>
        <p:sp>
          <p:nvSpPr>
            <p:cNvPr id="193" name="TextBox 192"/>
            <p:cNvSpPr txBox="1"/>
            <p:nvPr/>
          </p:nvSpPr>
          <p:spPr>
            <a:xfrm>
              <a:off x="1625789" y="1135761"/>
              <a:ext cx="83459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dirty="0">
                  <a:cs typeface="Arial" panose="020B0604020202020204" pitchFamily="34" charset="0"/>
                </a:rPr>
                <a:t>Swd2-6HA Δ</a:t>
              </a:r>
              <a:r>
                <a:rPr lang="en-US" altLang="ko-KR" sz="800" i="1" dirty="0">
                  <a:cs typeface="Arial" panose="020B0604020202020204" pitchFamily="34" charset="0"/>
                </a:rPr>
                <a:t>set1</a:t>
              </a:r>
              <a:endParaRPr lang="ko-KR" altLang="en-US" sz="800" i="1" dirty="0">
                <a:cs typeface="Arial" panose="020B0604020202020204" pitchFamily="34" charset="0"/>
              </a:endParaRPr>
            </a:p>
          </p:txBody>
        </p:sp>
        <p:sp>
          <p:nvSpPr>
            <p:cNvPr id="194" name="TextBox 193"/>
            <p:cNvSpPr txBox="1"/>
            <p:nvPr/>
          </p:nvSpPr>
          <p:spPr>
            <a:xfrm>
              <a:off x="1979138" y="3606676"/>
              <a:ext cx="46975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600" dirty="0">
                  <a:cs typeface="Arial" panose="020B0604020202020204" pitchFamily="34" charset="0"/>
                </a:rPr>
                <a:t>1500 bp</a:t>
              </a:r>
              <a:endParaRPr lang="ko-KR" altLang="en-US" sz="600" i="1" dirty="0">
                <a:cs typeface="Arial" panose="020B0604020202020204" pitchFamily="34" charset="0"/>
              </a:endParaRPr>
            </a:p>
          </p:txBody>
        </p:sp>
        <p:sp>
          <p:nvSpPr>
            <p:cNvPr id="195" name="TextBox 214"/>
            <p:cNvSpPr txBox="1"/>
            <p:nvPr/>
          </p:nvSpPr>
          <p:spPr>
            <a:xfrm>
              <a:off x="1883946" y="3677881"/>
              <a:ext cx="38863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700" dirty="0"/>
                <a:t>TSS</a:t>
              </a:r>
              <a:endParaRPr lang="ko-KR" altLang="en-US" sz="700" dirty="0"/>
            </a:p>
          </p:txBody>
        </p:sp>
        <p:pic>
          <p:nvPicPr>
            <p:cNvPr id="210" name="그림 209"/>
            <p:cNvPicPr>
              <a:picLocks/>
            </p:cNvPicPr>
            <p:nvPr/>
          </p:nvPicPr>
          <p:blipFill rotWithShape="1">
            <a:blip r:embed="rId3"/>
            <a:srcRect t="95814" b="2247"/>
            <a:stretch/>
          </p:blipFill>
          <p:spPr>
            <a:xfrm>
              <a:off x="2459697" y="3617200"/>
              <a:ext cx="720000" cy="48589"/>
            </a:xfrm>
            <a:prstGeom prst="rect">
              <a:avLst/>
            </a:prstGeom>
            <a:ln w="6350">
              <a:noFill/>
            </a:ln>
          </p:spPr>
        </p:pic>
        <p:sp>
          <p:nvSpPr>
            <p:cNvPr id="212" name="TextBox 211"/>
            <p:cNvSpPr txBox="1"/>
            <p:nvPr/>
          </p:nvSpPr>
          <p:spPr>
            <a:xfrm>
              <a:off x="2772544" y="3606676"/>
              <a:ext cx="46296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600" dirty="0">
                  <a:cs typeface="Arial" panose="020B0604020202020204" pitchFamily="34" charset="0"/>
                </a:rPr>
                <a:t>1500 bp</a:t>
              </a:r>
              <a:endParaRPr lang="ko-KR" altLang="en-US" sz="600" i="1" dirty="0">
                <a:cs typeface="Arial" panose="020B0604020202020204" pitchFamily="34" charset="0"/>
              </a:endParaRPr>
            </a:p>
          </p:txBody>
        </p:sp>
        <p:sp>
          <p:nvSpPr>
            <p:cNvPr id="213" name="TextBox 214"/>
            <p:cNvSpPr txBox="1"/>
            <p:nvPr/>
          </p:nvSpPr>
          <p:spPr>
            <a:xfrm>
              <a:off x="2645353" y="3677881"/>
              <a:ext cx="38863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700" dirty="0"/>
                <a:t>TSS</a:t>
              </a:r>
              <a:endParaRPr lang="ko-KR" altLang="en-US" sz="700" dirty="0"/>
            </a:p>
          </p:txBody>
        </p:sp>
        <p:sp>
          <p:nvSpPr>
            <p:cNvPr id="199" name="TextBox 198"/>
            <p:cNvSpPr txBox="1"/>
            <p:nvPr/>
          </p:nvSpPr>
          <p:spPr>
            <a:xfrm>
              <a:off x="2409624" y="1258871"/>
              <a:ext cx="83459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dirty="0">
                  <a:cs typeface="Arial" panose="020B0604020202020204" pitchFamily="34" charset="0"/>
                </a:rPr>
                <a:t>Cft1</a:t>
              </a:r>
              <a:endParaRPr lang="ko-KR" altLang="en-US" sz="800" i="1" dirty="0">
                <a:cs typeface="Arial" panose="020B0604020202020204" pitchFamily="34" charset="0"/>
              </a:endParaRPr>
            </a:p>
          </p:txBody>
        </p:sp>
        <p:pic>
          <p:nvPicPr>
            <p:cNvPr id="200" name="그림 199"/>
            <p:cNvPicPr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689685" y="3815074"/>
              <a:ext cx="237744" cy="4572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01" name="그림 200"/>
            <p:cNvPicPr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451774" y="3815074"/>
              <a:ext cx="237744" cy="4572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02" name="그림 201"/>
            <p:cNvPicPr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029540" y="3815074"/>
              <a:ext cx="237744" cy="4572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cxnSp>
          <p:nvCxnSpPr>
            <p:cNvPr id="203" name="직선 연결선 202"/>
            <p:cNvCxnSpPr/>
            <p:nvPr/>
          </p:nvCxnSpPr>
          <p:spPr>
            <a:xfrm>
              <a:off x="2487217" y="1258871"/>
              <a:ext cx="234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4" name="TextBox 203"/>
            <p:cNvSpPr txBox="1"/>
            <p:nvPr/>
          </p:nvSpPr>
          <p:spPr>
            <a:xfrm>
              <a:off x="2769564" y="858510"/>
              <a:ext cx="1689684" cy="438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algn="ctr" defTabSz="914400" latinLnBrk="1">
                <a:defRPr/>
              </a:pPr>
              <a:r>
                <a:rPr lang="en-US" altLang="ko-KR" sz="1200" b="1" dirty="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rPr>
                <a:t>CPF complex</a:t>
              </a:r>
            </a:p>
            <a:p>
              <a:pPr lvl="0" algn="ctr">
                <a:defRPr/>
              </a:pPr>
              <a:r>
                <a:rPr lang="en-US" altLang="ko-KR" sz="1000" dirty="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rPr>
                <a:t>(Data from GSE147927)</a:t>
              </a:r>
              <a:endParaRPr lang="ko-KR" altLang="en-US" sz="1000" dirty="0">
                <a:solidFill>
                  <a:prstClr val="black"/>
                </a:solidFill>
                <a:latin typeface="Calibri" panose="020F0502020204030204"/>
                <a:ea typeface="맑은 고딕" panose="020B0503020000020004" pitchFamily="50" charset="-127"/>
              </a:endParaRPr>
            </a:p>
          </p:txBody>
        </p:sp>
        <p:sp>
          <p:nvSpPr>
            <p:cNvPr id="205" name="TextBox 204"/>
            <p:cNvSpPr txBox="1"/>
            <p:nvPr/>
          </p:nvSpPr>
          <p:spPr>
            <a:xfrm>
              <a:off x="2392423" y="4090368"/>
              <a:ext cx="1590493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>
                  <a:cs typeface="Arial" panose="020B0604020202020204" pitchFamily="34" charset="0"/>
                </a:rPr>
                <a:t>Transcription </a:t>
              </a:r>
              <a:r>
                <a:rPr lang="en-US" altLang="ko-KR" sz="1000" b="1" dirty="0">
                  <a:cs typeface="Arial" panose="020B0604020202020204" pitchFamily="34" charset="0"/>
                </a:rPr>
                <a:t>start</a:t>
              </a:r>
              <a:r>
                <a:rPr lang="en-US" altLang="ko-KR" sz="1000" dirty="0">
                  <a:cs typeface="Arial" panose="020B0604020202020204" pitchFamily="34" charset="0"/>
                </a:rPr>
                <a:t> site</a:t>
              </a:r>
            </a:p>
            <a:p>
              <a:pPr algn="ctr"/>
              <a:r>
                <a:rPr lang="en-US" altLang="ko-KR" sz="1000" dirty="0">
                  <a:cs typeface="Arial" panose="020B0604020202020204" pitchFamily="34" charset="0"/>
                </a:rPr>
                <a:t>(TSS)</a:t>
              </a:r>
              <a:endParaRPr lang="ko-KR" altLang="en-US" sz="1000" dirty="0">
                <a:cs typeface="Arial" panose="020B0604020202020204" pitchFamily="34" charset="0"/>
              </a:endParaRPr>
            </a:p>
          </p:txBody>
        </p:sp>
        <p:cxnSp>
          <p:nvCxnSpPr>
            <p:cNvPr id="206" name="직선 화살표 연결선 205"/>
            <p:cNvCxnSpPr>
              <a:cxnSpLocks/>
            </p:cNvCxnSpPr>
            <p:nvPr/>
          </p:nvCxnSpPr>
          <p:spPr>
            <a:xfrm flipV="1">
              <a:off x="2048745" y="3897939"/>
              <a:ext cx="0" cy="229449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7" name="직선 화살표 연결선 206"/>
            <p:cNvCxnSpPr>
              <a:cxnSpLocks/>
            </p:cNvCxnSpPr>
            <p:nvPr/>
          </p:nvCxnSpPr>
          <p:spPr>
            <a:xfrm flipV="1">
              <a:off x="2810669" y="3897939"/>
              <a:ext cx="0" cy="229449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8" name="직선 화살표 연결선 207"/>
            <p:cNvCxnSpPr>
              <a:cxnSpLocks/>
            </p:cNvCxnSpPr>
            <p:nvPr/>
          </p:nvCxnSpPr>
          <p:spPr>
            <a:xfrm flipV="1">
              <a:off x="3582430" y="3897939"/>
              <a:ext cx="0" cy="229449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9" name="직선 화살표 연결선 208"/>
            <p:cNvCxnSpPr>
              <a:cxnSpLocks/>
            </p:cNvCxnSpPr>
            <p:nvPr/>
          </p:nvCxnSpPr>
          <p:spPr>
            <a:xfrm flipV="1">
              <a:off x="4380549" y="3897939"/>
              <a:ext cx="0" cy="229449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1" name="TextBox 90"/>
          <p:cNvSpPr txBox="1"/>
          <p:nvPr/>
        </p:nvSpPr>
        <p:spPr bwMode="auto">
          <a:xfrm>
            <a:off x="-3402" y="-18808"/>
            <a:ext cx="378498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altLang="ko-KR" b="1" dirty="0">
                <a:latin typeface="+mj-lt"/>
                <a:cs typeface="Arial" panose="020B0604020202020204" pitchFamily="34" charset="0"/>
              </a:rPr>
              <a:t>Additional file Figure S3</a:t>
            </a:r>
            <a:endParaRPr lang="ko-KR" altLang="en-US" b="1" dirty="0">
              <a:latin typeface="+mj-lt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128097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사용자 지정 1">
      <a:majorFont>
        <a:latin typeface="Arial"/>
        <a:ea typeface="맑은 고딕"/>
        <a:cs typeface=""/>
      </a:majorFont>
      <a:minorFont>
        <a:latin typeface="Arial"/>
        <a:ea typeface="맑은 고딕"/>
        <a:cs typeface="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0627</TotalTime>
  <Words>324</Words>
  <Application>Microsoft Office PowerPoint</Application>
  <PresentationFormat>A4 용지(210x297mm)</PresentationFormat>
  <Paragraphs>144</Paragraphs>
  <Slides>3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7" baseType="lpstr">
      <vt:lpstr>맑은 고딕</vt:lpstr>
      <vt:lpstr>Arial</vt:lpstr>
      <vt:lpstr>Calibri</vt:lpstr>
      <vt:lpstr>Office 테마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오 준수</dc:creator>
  <cp:lastModifiedBy>User</cp:lastModifiedBy>
  <cp:revision>1357</cp:revision>
  <cp:lastPrinted>2019-09-03T00:32:10Z</cp:lastPrinted>
  <dcterms:created xsi:type="dcterms:W3CDTF">2019-07-24T01:25:10Z</dcterms:created>
  <dcterms:modified xsi:type="dcterms:W3CDTF">2024-04-20T17:22:00Z</dcterms:modified>
</cp:coreProperties>
</file>